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Ex1.xml" ContentType="application/vnd.ms-office.chartex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1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2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61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680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Predomix\Patent%20and%20paper_Predomix\Paper\Paper%20VI_30%20Cancer_Cancer%20reports\NC%20PC%20DAT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G:\Predomix\Patent%20and%20paper_Predomix\Paper\Paper%20VI_30%20Cancer_Cancer%20reports\NC%20PC%20DATA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C:\Users\saqui\OneDrive\Desktop\Paper%20figure\Corrected%20figures%20raw%20data\MatOcp_cancers__sequential_6March24.xlsx" TargetMode="External"/><Relationship Id="rId4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Sheet3!$H$3</c:f>
              <c:strCache>
                <c:ptCount val="1"/>
                <c:pt idx="0">
                  <c:v>Result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3!$G$4:$G$133</c:f>
              <c:numCache>
                <c:formatCode>0.00</c:formatCode>
                <c:ptCount val="13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</c:numCache>
            </c:numRef>
          </c:xVal>
          <c:yVal>
            <c:numRef>
              <c:f>Sheet3!$H$4:$H$133</c:f>
              <c:numCache>
                <c:formatCode>General</c:formatCode>
                <c:ptCount val="130"/>
                <c:pt idx="0">
                  <c:v>-7.3638000000000003</c:v>
                </c:pt>
                <c:pt idx="1">
                  <c:v>-7.3891</c:v>
                </c:pt>
                <c:pt idx="2">
                  <c:v>-7.0114000000000001</c:v>
                </c:pt>
                <c:pt idx="3">
                  <c:v>-7.1009000000000002</c:v>
                </c:pt>
                <c:pt idx="4">
                  <c:v>-7.6581999999999999</c:v>
                </c:pt>
                <c:pt idx="5">
                  <c:v>-7.4782999999999999</c:v>
                </c:pt>
                <c:pt idx="6">
                  <c:v>-7.8432000000000004</c:v>
                </c:pt>
                <c:pt idx="7">
                  <c:v>-7.9987000000000004</c:v>
                </c:pt>
                <c:pt idx="8">
                  <c:v>-7.9454000000000002</c:v>
                </c:pt>
                <c:pt idx="9">
                  <c:v>-7.2404000000000002</c:v>
                </c:pt>
                <c:pt idx="10">
                  <c:v>-7.8132999999999999</c:v>
                </c:pt>
                <c:pt idx="11">
                  <c:v>-7.2698</c:v>
                </c:pt>
                <c:pt idx="12">
                  <c:v>-7.7455999999999996</c:v>
                </c:pt>
                <c:pt idx="13">
                  <c:v>-7.7183000000000002</c:v>
                </c:pt>
                <c:pt idx="14">
                  <c:v>-7.7731000000000003</c:v>
                </c:pt>
                <c:pt idx="15">
                  <c:v>-7.1989999999999998</c:v>
                </c:pt>
                <c:pt idx="16">
                  <c:v>-7.2187999999999999</c:v>
                </c:pt>
                <c:pt idx="17">
                  <c:v>-7.0605000000000002</c:v>
                </c:pt>
                <c:pt idx="18">
                  <c:v>-7.3566000000000003</c:v>
                </c:pt>
                <c:pt idx="19">
                  <c:v>-7.8028000000000004</c:v>
                </c:pt>
                <c:pt idx="20">
                  <c:v>-7.8985000000000003</c:v>
                </c:pt>
                <c:pt idx="21">
                  <c:v>-7.2065000000000001</c:v>
                </c:pt>
                <c:pt idx="22">
                  <c:v>-7.6684000000000001</c:v>
                </c:pt>
                <c:pt idx="23">
                  <c:v>-7.64</c:v>
                </c:pt>
                <c:pt idx="24">
                  <c:v>-7.2283999999999997</c:v>
                </c:pt>
                <c:pt idx="25">
                  <c:v>-7.5122</c:v>
                </c:pt>
                <c:pt idx="26">
                  <c:v>-7.7431999999999999</c:v>
                </c:pt>
                <c:pt idx="27">
                  <c:v>-7.9870000000000001</c:v>
                </c:pt>
                <c:pt idx="28">
                  <c:v>-7.4924999999999997</c:v>
                </c:pt>
                <c:pt idx="29">
                  <c:v>-7.0418000000000003</c:v>
                </c:pt>
                <c:pt idx="30">
                  <c:v>-7.4943999999999997</c:v>
                </c:pt>
                <c:pt idx="31">
                  <c:v>-7.6637000000000004</c:v>
                </c:pt>
                <c:pt idx="32">
                  <c:v>-7.0568</c:v>
                </c:pt>
                <c:pt idx="33">
                  <c:v>-7.6669999999999998</c:v>
                </c:pt>
                <c:pt idx="34">
                  <c:v>-7.6879999999999997</c:v>
                </c:pt>
                <c:pt idx="35">
                  <c:v>-7.8894000000000002</c:v>
                </c:pt>
                <c:pt idx="36">
                  <c:v>-7.4569999999999999</c:v>
                </c:pt>
                <c:pt idx="37">
                  <c:v>-7.6368</c:v>
                </c:pt>
                <c:pt idx="38">
                  <c:v>-7.9271000000000003</c:v>
                </c:pt>
                <c:pt idx="39">
                  <c:v>-7.5171999999999999</c:v>
                </c:pt>
                <c:pt idx="40">
                  <c:v>-7.4466000000000001</c:v>
                </c:pt>
                <c:pt idx="41">
                  <c:v>-7.7291999999999996</c:v>
                </c:pt>
                <c:pt idx="42">
                  <c:v>-7.8055000000000003</c:v>
                </c:pt>
                <c:pt idx="43">
                  <c:v>-7.9061000000000003</c:v>
                </c:pt>
                <c:pt idx="44">
                  <c:v>-7.4115000000000002</c:v>
                </c:pt>
                <c:pt idx="45">
                  <c:v>-7.9062999999999999</c:v>
                </c:pt>
                <c:pt idx="46">
                  <c:v>-7.0084</c:v>
                </c:pt>
                <c:pt idx="47">
                  <c:v>-7.1050000000000004</c:v>
                </c:pt>
                <c:pt idx="48">
                  <c:v>-7.1939000000000002</c:v>
                </c:pt>
                <c:pt idx="49">
                  <c:v>-7.2648000000000001</c:v>
                </c:pt>
                <c:pt idx="50">
                  <c:v>-7.8470000000000004</c:v>
                </c:pt>
                <c:pt idx="51">
                  <c:v>-7.1470000000000002</c:v>
                </c:pt>
                <c:pt idx="52">
                  <c:v>-7.9595000000000002</c:v>
                </c:pt>
                <c:pt idx="53">
                  <c:v>-7.2915000000000001</c:v>
                </c:pt>
                <c:pt idx="54">
                  <c:v>-7.0648999999999997</c:v>
                </c:pt>
                <c:pt idx="55">
                  <c:v>-7.7061999999999999</c:v>
                </c:pt>
                <c:pt idx="56">
                  <c:v>-7.9507000000000003</c:v>
                </c:pt>
                <c:pt idx="57">
                  <c:v>-7.8345000000000002</c:v>
                </c:pt>
                <c:pt idx="58">
                  <c:v>-7.6859000000000002</c:v>
                </c:pt>
                <c:pt idx="59">
                  <c:v>-7.1379999999999999</c:v>
                </c:pt>
                <c:pt idx="60">
                  <c:v>-7.4724000000000004</c:v>
                </c:pt>
                <c:pt idx="61">
                  <c:v>-7.4764999999999997</c:v>
                </c:pt>
                <c:pt idx="62">
                  <c:v>-7.3364000000000003</c:v>
                </c:pt>
                <c:pt idx="63">
                  <c:v>-7.8720999999999997</c:v>
                </c:pt>
                <c:pt idx="64">
                  <c:v>-7.8838999999999997</c:v>
                </c:pt>
                <c:pt idx="65">
                  <c:v>-7.7022000000000004</c:v>
                </c:pt>
                <c:pt idx="66">
                  <c:v>-7.5720000000000001</c:v>
                </c:pt>
                <c:pt idx="67">
                  <c:v>-7.6010999999999997</c:v>
                </c:pt>
                <c:pt idx="68">
                  <c:v>-7.3669000000000002</c:v>
                </c:pt>
                <c:pt idx="69">
                  <c:v>-7.1970999999999998</c:v>
                </c:pt>
                <c:pt idx="70">
                  <c:v>-7.5536000000000003</c:v>
                </c:pt>
                <c:pt idx="71">
                  <c:v>-7.4345999999999997</c:v>
                </c:pt>
                <c:pt idx="72">
                  <c:v>-7.8417000000000003</c:v>
                </c:pt>
                <c:pt idx="73">
                  <c:v>-7.7869999999999999</c:v>
                </c:pt>
                <c:pt idx="74">
                  <c:v>-7.6856</c:v>
                </c:pt>
                <c:pt idx="75">
                  <c:v>-7.9611999999999998</c:v>
                </c:pt>
                <c:pt idx="76">
                  <c:v>-7.7934000000000001</c:v>
                </c:pt>
                <c:pt idx="77">
                  <c:v>-7.9679000000000002</c:v>
                </c:pt>
                <c:pt idx="78">
                  <c:v>-7.9092000000000002</c:v>
                </c:pt>
                <c:pt idx="79">
                  <c:v>-7.6790000000000003</c:v>
                </c:pt>
                <c:pt idx="80">
                  <c:v>-7.6307</c:v>
                </c:pt>
                <c:pt idx="81">
                  <c:v>-7.5545999999999998</c:v>
                </c:pt>
                <c:pt idx="82">
                  <c:v>-7.0049000000000001</c:v>
                </c:pt>
                <c:pt idx="83">
                  <c:v>-7.6395</c:v>
                </c:pt>
                <c:pt idx="84">
                  <c:v>-7.8375000000000004</c:v>
                </c:pt>
                <c:pt idx="85">
                  <c:v>-7.8150000000000004</c:v>
                </c:pt>
                <c:pt idx="86">
                  <c:v>-7.5941000000000001</c:v>
                </c:pt>
                <c:pt idx="87">
                  <c:v>-7.5739999999999998</c:v>
                </c:pt>
                <c:pt idx="88">
                  <c:v>-7.2777000000000003</c:v>
                </c:pt>
                <c:pt idx="89">
                  <c:v>-7.9511000000000003</c:v>
                </c:pt>
                <c:pt idx="90">
                  <c:v>-7.3810000000000002</c:v>
                </c:pt>
                <c:pt idx="91">
                  <c:v>-7.9366000000000003</c:v>
                </c:pt>
                <c:pt idx="92">
                  <c:v>-7.8108000000000004</c:v>
                </c:pt>
                <c:pt idx="93">
                  <c:v>-7.8483999999999998</c:v>
                </c:pt>
                <c:pt idx="94">
                  <c:v>-7.3776999999999999</c:v>
                </c:pt>
                <c:pt idx="95">
                  <c:v>-7.2809999999999997</c:v>
                </c:pt>
                <c:pt idx="96">
                  <c:v>-7.7038000000000002</c:v>
                </c:pt>
                <c:pt idx="97">
                  <c:v>-7.8017000000000003</c:v>
                </c:pt>
                <c:pt idx="98">
                  <c:v>-7.1249000000000002</c:v>
                </c:pt>
                <c:pt idx="99">
                  <c:v>-7.2550999999999997</c:v>
                </c:pt>
                <c:pt idx="100">
                  <c:v>-7.7324999999999999</c:v>
                </c:pt>
                <c:pt idx="101">
                  <c:v>-7.7870999999999997</c:v>
                </c:pt>
                <c:pt idx="102">
                  <c:v>-7.0561999999999996</c:v>
                </c:pt>
                <c:pt idx="103">
                  <c:v>-7.1620999999999997</c:v>
                </c:pt>
                <c:pt idx="104">
                  <c:v>-7.0970000000000004</c:v>
                </c:pt>
                <c:pt idx="105">
                  <c:v>-7.4450000000000003</c:v>
                </c:pt>
                <c:pt idx="106">
                  <c:v>-7.0011000000000001</c:v>
                </c:pt>
                <c:pt idx="107">
                  <c:v>-7.5972</c:v>
                </c:pt>
                <c:pt idx="108">
                  <c:v>-7.3151999999999999</c:v>
                </c:pt>
                <c:pt idx="109">
                  <c:v>-7.1955999999999998</c:v>
                </c:pt>
                <c:pt idx="110">
                  <c:v>-7.8612000000000002</c:v>
                </c:pt>
                <c:pt idx="111">
                  <c:v>-7.3994</c:v>
                </c:pt>
                <c:pt idx="112">
                  <c:v>-7.6894999999999998</c:v>
                </c:pt>
                <c:pt idx="113">
                  <c:v>-7.4127999999999998</c:v>
                </c:pt>
                <c:pt idx="114">
                  <c:v>-7.8422999999999998</c:v>
                </c:pt>
                <c:pt idx="115">
                  <c:v>-7.7202999999999999</c:v>
                </c:pt>
                <c:pt idx="116">
                  <c:v>-7.7259000000000002</c:v>
                </c:pt>
                <c:pt idx="117">
                  <c:v>-7.1402000000000001</c:v>
                </c:pt>
                <c:pt idx="118">
                  <c:v>-7.4570999999999996</c:v>
                </c:pt>
                <c:pt idx="119">
                  <c:v>-7.6814999999999998</c:v>
                </c:pt>
                <c:pt idx="120">
                  <c:v>-7.5810000000000004</c:v>
                </c:pt>
                <c:pt idx="121">
                  <c:v>-7.8958000000000004</c:v>
                </c:pt>
                <c:pt idx="122">
                  <c:v>-7.7232000000000003</c:v>
                </c:pt>
                <c:pt idx="123">
                  <c:v>-7.4927000000000001</c:v>
                </c:pt>
                <c:pt idx="124">
                  <c:v>-7.9676999999999998</c:v>
                </c:pt>
                <c:pt idx="125">
                  <c:v>-7.1081000000000003</c:v>
                </c:pt>
                <c:pt idx="126">
                  <c:v>-7.7942</c:v>
                </c:pt>
                <c:pt idx="127">
                  <c:v>-7.3743999999999996</c:v>
                </c:pt>
                <c:pt idx="128">
                  <c:v>-7.3821000000000003</c:v>
                </c:pt>
                <c:pt idx="129">
                  <c:v>-7.9077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8587-C84D-80E3-823DB5ECD6BA}"/>
            </c:ext>
          </c:extLst>
        </c:ser>
        <c:ser>
          <c:idx val="1"/>
          <c:order val="1"/>
          <c:tx>
            <c:strRef>
              <c:f>Sheet3!$I$3</c:f>
              <c:strCache>
                <c:ptCount val="1"/>
                <c:pt idx="0">
                  <c:v>(+4SD)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3!$G$4:$G$133</c:f>
              <c:numCache>
                <c:formatCode>0.00</c:formatCode>
                <c:ptCount val="13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</c:numCache>
            </c:numRef>
          </c:xVal>
          <c:yVal>
            <c:numRef>
              <c:f>Sheet3!$I$4:$I$133</c:f>
              <c:numCache>
                <c:formatCode>General</c:formatCode>
                <c:ptCount val="130"/>
                <c:pt idx="0">
                  <c:v>-6.3980929925842878</c:v>
                </c:pt>
                <c:pt idx="1">
                  <c:v>-6.3980929925842878</c:v>
                </c:pt>
                <c:pt idx="2">
                  <c:v>-6.3980929925842878</c:v>
                </c:pt>
                <c:pt idx="3">
                  <c:v>-6.3980929925842878</c:v>
                </c:pt>
                <c:pt idx="4">
                  <c:v>-6.3980929925842878</c:v>
                </c:pt>
                <c:pt idx="5">
                  <c:v>-6.3980929925842878</c:v>
                </c:pt>
                <c:pt idx="6">
                  <c:v>-6.3980929925842878</c:v>
                </c:pt>
                <c:pt idx="7">
                  <c:v>-6.3980929925842878</c:v>
                </c:pt>
                <c:pt idx="8">
                  <c:v>-6.3980929925842878</c:v>
                </c:pt>
                <c:pt idx="9">
                  <c:v>-6.3980929925842878</c:v>
                </c:pt>
                <c:pt idx="10">
                  <c:v>-6.3980929925842878</c:v>
                </c:pt>
                <c:pt idx="11">
                  <c:v>-6.3980929925842878</c:v>
                </c:pt>
                <c:pt idx="12">
                  <c:v>-6.3980929925842878</c:v>
                </c:pt>
                <c:pt idx="13">
                  <c:v>-6.3980929925842878</c:v>
                </c:pt>
                <c:pt idx="14">
                  <c:v>-6.3980929925842878</c:v>
                </c:pt>
                <c:pt idx="15">
                  <c:v>-6.3980929925842878</c:v>
                </c:pt>
                <c:pt idx="16">
                  <c:v>-6.3980929925842878</c:v>
                </c:pt>
                <c:pt idx="17">
                  <c:v>-6.3980929925842878</c:v>
                </c:pt>
                <c:pt idx="18">
                  <c:v>-6.3980929925842878</c:v>
                </c:pt>
                <c:pt idx="19">
                  <c:v>-6.3980929925842878</c:v>
                </c:pt>
                <c:pt idx="20">
                  <c:v>-6.3980929925842878</c:v>
                </c:pt>
                <c:pt idx="21">
                  <c:v>-6.3980929925842878</c:v>
                </c:pt>
                <c:pt idx="22">
                  <c:v>-6.3980929925842878</c:v>
                </c:pt>
                <c:pt idx="23">
                  <c:v>-6.3980929925842878</c:v>
                </c:pt>
                <c:pt idx="24">
                  <c:v>-6.3980929925842878</c:v>
                </c:pt>
                <c:pt idx="25">
                  <c:v>-6.3980929925842878</c:v>
                </c:pt>
                <c:pt idx="26">
                  <c:v>-6.3980929925842878</c:v>
                </c:pt>
                <c:pt idx="27">
                  <c:v>-6.3980929925842878</c:v>
                </c:pt>
                <c:pt idx="28">
                  <c:v>-6.3980929925842878</c:v>
                </c:pt>
                <c:pt idx="29">
                  <c:v>-6.3980929925842878</c:v>
                </c:pt>
                <c:pt idx="30">
                  <c:v>-6.3980929925842878</c:v>
                </c:pt>
                <c:pt idx="31">
                  <c:v>-6.3980929925842878</c:v>
                </c:pt>
                <c:pt idx="32">
                  <c:v>-6.3980929925842878</c:v>
                </c:pt>
                <c:pt idx="33">
                  <c:v>-6.3980929925842878</c:v>
                </c:pt>
                <c:pt idx="34">
                  <c:v>-6.3980929925842878</c:v>
                </c:pt>
                <c:pt idx="35">
                  <c:v>-6.3980929925842878</c:v>
                </c:pt>
                <c:pt idx="36">
                  <c:v>-6.3980929925842878</c:v>
                </c:pt>
                <c:pt idx="37">
                  <c:v>-6.3980929925842878</c:v>
                </c:pt>
                <c:pt idx="38">
                  <c:v>-6.3980929925842878</c:v>
                </c:pt>
                <c:pt idx="39">
                  <c:v>-6.3980929925842878</c:v>
                </c:pt>
                <c:pt idx="40">
                  <c:v>-6.3980929925842878</c:v>
                </c:pt>
                <c:pt idx="41">
                  <c:v>-6.3980929925842878</c:v>
                </c:pt>
                <c:pt idx="42">
                  <c:v>-6.3980929925842878</c:v>
                </c:pt>
                <c:pt idx="43">
                  <c:v>-6.3980929925842878</c:v>
                </c:pt>
                <c:pt idx="44">
                  <c:v>-6.3980929925842878</c:v>
                </c:pt>
                <c:pt idx="45">
                  <c:v>-6.3980929925842878</c:v>
                </c:pt>
                <c:pt idx="46">
                  <c:v>-6.3980929925842878</c:v>
                </c:pt>
                <c:pt idx="47">
                  <c:v>-6.3980929925842878</c:v>
                </c:pt>
                <c:pt idx="48">
                  <c:v>-6.3980929925842878</c:v>
                </c:pt>
                <c:pt idx="49">
                  <c:v>-6.3980929925842878</c:v>
                </c:pt>
                <c:pt idx="50">
                  <c:v>-6.3980929925842878</c:v>
                </c:pt>
                <c:pt idx="51">
                  <c:v>-6.3980929925842878</c:v>
                </c:pt>
                <c:pt idx="52">
                  <c:v>-6.3980929925842878</c:v>
                </c:pt>
                <c:pt idx="53">
                  <c:v>-6.3980929925842878</c:v>
                </c:pt>
                <c:pt idx="54">
                  <c:v>-6.3980929925842878</c:v>
                </c:pt>
                <c:pt idx="55">
                  <c:v>-6.3980929925842878</c:v>
                </c:pt>
                <c:pt idx="56">
                  <c:v>-6.3980929925842878</c:v>
                </c:pt>
                <c:pt idx="57">
                  <c:v>-6.3980929925842878</c:v>
                </c:pt>
                <c:pt idx="58">
                  <c:v>-6.3980929925842878</c:v>
                </c:pt>
                <c:pt idx="59">
                  <c:v>-6.3980929925842878</c:v>
                </c:pt>
                <c:pt idx="60">
                  <c:v>-6.3980929925842878</c:v>
                </c:pt>
                <c:pt idx="61">
                  <c:v>-6.3980929925842878</c:v>
                </c:pt>
                <c:pt idx="62">
                  <c:v>-6.3980929925842878</c:v>
                </c:pt>
                <c:pt idx="63">
                  <c:v>-6.3980929925842878</c:v>
                </c:pt>
                <c:pt idx="64">
                  <c:v>-6.3980929925842878</c:v>
                </c:pt>
                <c:pt idx="65">
                  <c:v>-6.3980929925842878</c:v>
                </c:pt>
                <c:pt idx="66">
                  <c:v>-6.3980929925842878</c:v>
                </c:pt>
                <c:pt idx="67">
                  <c:v>-6.3980929925842878</c:v>
                </c:pt>
                <c:pt idx="68">
                  <c:v>-6.3980929925842878</c:v>
                </c:pt>
                <c:pt idx="69">
                  <c:v>-6.3980929925842878</c:v>
                </c:pt>
                <c:pt idx="70">
                  <c:v>-6.3980929925842878</c:v>
                </c:pt>
                <c:pt idx="71">
                  <c:v>-6.3980929925842878</c:v>
                </c:pt>
                <c:pt idx="72">
                  <c:v>-6.3980929925842878</c:v>
                </c:pt>
                <c:pt idx="73">
                  <c:v>-6.3980929925842878</c:v>
                </c:pt>
                <c:pt idx="74">
                  <c:v>-6.3980929925842878</c:v>
                </c:pt>
                <c:pt idx="75">
                  <c:v>-6.3980929925842878</c:v>
                </c:pt>
                <c:pt idx="76">
                  <c:v>-6.3980929925842878</c:v>
                </c:pt>
                <c:pt idx="77">
                  <c:v>-6.3980929925842878</c:v>
                </c:pt>
                <c:pt idx="78">
                  <c:v>-6.3980929925842878</c:v>
                </c:pt>
                <c:pt idx="79">
                  <c:v>-6.3980929925842878</c:v>
                </c:pt>
                <c:pt idx="80">
                  <c:v>-6.3980929925842878</c:v>
                </c:pt>
                <c:pt idx="81">
                  <c:v>-6.3980929925842878</c:v>
                </c:pt>
                <c:pt idx="82">
                  <c:v>-6.3980929925842878</c:v>
                </c:pt>
                <c:pt idx="83">
                  <c:v>-6.3980929925842878</c:v>
                </c:pt>
                <c:pt idx="84">
                  <c:v>-6.3980929925842878</c:v>
                </c:pt>
                <c:pt idx="85">
                  <c:v>-6.3980929925842878</c:v>
                </c:pt>
                <c:pt idx="86">
                  <c:v>-6.3980929925842878</c:v>
                </c:pt>
                <c:pt idx="87">
                  <c:v>-6.3980929925842878</c:v>
                </c:pt>
                <c:pt idx="88">
                  <c:v>-6.3980929925842878</c:v>
                </c:pt>
                <c:pt idx="89">
                  <c:v>-6.3980929925842878</c:v>
                </c:pt>
                <c:pt idx="90">
                  <c:v>-6.3980929925842878</c:v>
                </c:pt>
                <c:pt idx="91">
                  <c:v>-6.3980929925842878</c:v>
                </c:pt>
                <c:pt idx="92">
                  <c:v>-6.3980929925842878</c:v>
                </c:pt>
                <c:pt idx="93">
                  <c:v>-6.3980929925842878</c:v>
                </c:pt>
                <c:pt idx="94">
                  <c:v>-6.3980929925842878</c:v>
                </c:pt>
                <c:pt idx="95">
                  <c:v>-6.3980929925842878</c:v>
                </c:pt>
                <c:pt idx="96">
                  <c:v>-6.3980929925842878</c:v>
                </c:pt>
                <c:pt idx="97">
                  <c:v>-6.3980929925842878</c:v>
                </c:pt>
                <c:pt idx="98">
                  <c:v>-6.3980929925842878</c:v>
                </c:pt>
                <c:pt idx="99">
                  <c:v>-6.3980929925842878</c:v>
                </c:pt>
                <c:pt idx="100">
                  <c:v>-6.3980929925842878</c:v>
                </c:pt>
                <c:pt idx="101">
                  <c:v>-6.3980929925842878</c:v>
                </c:pt>
                <c:pt idx="102">
                  <c:v>-6.3980929925842878</c:v>
                </c:pt>
                <c:pt idx="103">
                  <c:v>-6.3980929925842878</c:v>
                </c:pt>
                <c:pt idx="104">
                  <c:v>-6.3980929925842878</c:v>
                </c:pt>
                <c:pt idx="105">
                  <c:v>-6.3980929925842878</c:v>
                </c:pt>
                <c:pt idx="106">
                  <c:v>-6.3980929925842878</c:v>
                </c:pt>
                <c:pt idx="107">
                  <c:v>-6.3980929925842878</c:v>
                </c:pt>
                <c:pt idx="108">
                  <c:v>-6.3980929925842878</c:v>
                </c:pt>
                <c:pt idx="109">
                  <c:v>-6.3980929925842878</c:v>
                </c:pt>
                <c:pt idx="110">
                  <c:v>-6.3980929925842878</c:v>
                </c:pt>
                <c:pt idx="111">
                  <c:v>-6.3980929925842878</c:v>
                </c:pt>
                <c:pt idx="112">
                  <c:v>-6.3980929925842878</c:v>
                </c:pt>
                <c:pt idx="113">
                  <c:v>-6.3980929925842878</c:v>
                </c:pt>
                <c:pt idx="114">
                  <c:v>-6.3980929925842878</c:v>
                </c:pt>
                <c:pt idx="115">
                  <c:v>-6.3980929925842878</c:v>
                </c:pt>
                <c:pt idx="116">
                  <c:v>-6.3980929925842878</c:v>
                </c:pt>
                <c:pt idx="117">
                  <c:v>-6.3980929925842878</c:v>
                </c:pt>
                <c:pt idx="118">
                  <c:v>-6.3980929925842878</c:v>
                </c:pt>
                <c:pt idx="119">
                  <c:v>-6.3980929925842878</c:v>
                </c:pt>
                <c:pt idx="120">
                  <c:v>-6.3980929925842878</c:v>
                </c:pt>
                <c:pt idx="121">
                  <c:v>-6.3980929925842878</c:v>
                </c:pt>
                <c:pt idx="122">
                  <c:v>-6.3980929925842878</c:v>
                </c:pt>
                <c:pt idx="123">
                  <c:v>-6.3980929925842878</c:v>
                </c:pt>
                <c:pt idx="124">
                  <c:v>-6.3980929925842878</c:v>
                </c:pt>
                <c:pt idx="125">
                  <c:v>-6.3980929925842878</c:v>
                </c:pt>
                <c:pt idx="126">
                  <c:v>-6.3980929925842878</c:v>
                </c:pt>
                <c:pt idx="127">
                  <c:v>-6.3980929925842878</c:v>
                </c:pt>
                <c:pt idx="128">
                  <c:v>-6.3980929925842878</c:v>
                </c:pt>
                <c:pt idx="129">
                  <c:v>-6.398092992584287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587-C84D-80E3-823DB5ECD6BA}"/>
            </c:ext>
          </c:extLst>
        </c:ser>
        <c:ser>
          <c:idx val="2"/>
          <c:order val="2"/>
          <c:tx>
            <c:strRef>
              <c:f>Sheet3!$J$3</c:f>
              <c:strCache>
                <c:ptCount val="1"/>
                <c:pt idx="0">
                  <c:v>(+3SD)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Sheet3!$G$4:$G$133</c:f>
              <c:numCache>
                <c:formatCode>0.00</c:formatCode>
                <c:ptCount val="13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</c:numCache>
            </c:numRef>
          </c:xVal>
          <c:yVal>
            <c:numRef>
              <c:f>Sheet3!$J$4:$J$133</c:f>
              <c:numCache>
                <c:formatCode>General</c:formatCode>
                <c:ptCount val="130"/>
                <c:pt idx="0">
                  <c:v>-6.6867343598228306</c:v>
                </c:pt>
                <c:pt idx="1">
                  <c:v>-6.6867343598228306</c:v>
                </c:pt>
                <c:pt idx="2">
                  <c:v>-6.6867343598228306</c:v>
                </c:pt>
                <c:pt idx="3">
                  <c:v>-6.6867343598228306</c:v>
                </c:pt>
                <c:pt idx="4">
                  <c:v>-6.6867343598228306</c:v>
                </c:pt>
                <c:pt idx="5">
                  <c:v>-6.6867343598228306</c:v>
                </c:pt>
                <c:pt idx="6">
                  <c:v>-6.6867343598228306</c:v>
                </c:pt>
                <c:pt idx="7">
                  <c:v>-6.6867343598228306</c:v>
                </c:pt>
                <c:pt idx="8">
                  <c:v>-6.6867343598228306</c:v>
                </c:pt>
                <c:pt idx="9">
                  <c:v>-6.6867343598228306</c:v>
                </c:pt>
                <c:pt idx="10">
                  <c:v>-6.6867343598228306</c:v>
                </c:pt>
                <c:pt idx="11">
                  <c:v>-6.6867343598228306</c:v>
                </c:pt>
                <c:pt idx="12">
                  <c:v>-6.6867343598228306</c:v>
                </c:pt>
                <c:pt idx="13">
                  <c:v>-6.6867343598228306</c:v>
                </c:pt>
                <c:pt idx="14">
                  <c:v>-6.6867343598228306</c:v>
                </c:pt>
                <c:pt idx="15">
                  <c:v>-6.6867343598228306</c:v>
                </c:pt>
                <c:pt idx="16">
                  <c:v>-6.6867343598228306</c:v>
                </c:pt>
                <c:pt idx="17">
                  <c:v>-6.6867343598228306</c:v>
                </c:pt>
                <c:pt idx="18">
                  <c:v>-6.6867343598228306</c:v>
                </c:pt>
                <c:pt idx="19">
                  <c:v>-6.6867343598228306</c:v>
                </c:pt>
                <c:pt idx="20">
                  <c:v>-6.6867343598228306</c:v>
                </c:pt>
                <c:pt idx="21">
                  <c:v>-6.6867343598228306</c:v>
                </c:pt>
                <c:pt idx="22">
                  <c:v>-6.6867343598228306</c:v>
                </c:pt>
                <c:pt idx="23">
                  <c:v>-6.6867343598228306</c:v>
                </c:pt>
                <c:pt idx="24">
                  <c:v>-6.6867343598228306</c:v>
                </c:pt>
                <c:pt idx="25">
                  <c:v>-6.6867343598228306</c:v>
                </c:pt>
                <c:pt idx="26">
                  <c:v>-6.6867343598228306</c:v>
                </c:pt>
                <c:pt idx="27">
                  <c:v>-6.6867343598228306</c:v>
                </c:pt>
                <c:pt idx="28">
                  <c:v>-6.6867343598228306</c:v>
                </c:pt>
                <c:pt idx="29">
                  <c:v>-6.6867343598228306</c:v>
                </c:pt>
                <c:pt idx="30">
                  <c:v>-6.6867343598228306</c:v>
                </c:pt>
                <c:pt idx="31">
                  <c:v>-6.6867343598228306</c:v>
                </c:pt>
                <c:pt idx="32">
                  <c:v>-6.6867343598228306</c:v>
                </c:pt>
                <c:pt idx="33">
                  <c:v>-6.6867343598228306</c:v>
                </c:pt>
                <c:pt idx="34">
                  <c:v>-6.6867343598228306</c:v>
                </c:pt>
                <c:pt idx="35">
                  <c:v>-6.6867343598228306</c:v>
                </c:pt>
                <c:pt idx="36">
                  <c:v>-6.6867343598228306</c:v>
                </c:pt>
                <c:pt idx="37">
                  <c:v>-6.6867343598228306</c:v>
                </c:pt>
                <c:pt idx="38">
                  <c:v>-6.6867343598228306</c:v>
                </c:pt>
                <c:pt idx="39">
                  <c:v>-6.6867343598228306</c:v>
                </c:pt>
                <c:pt idx="40">
                  <c:v>-6.6867343598228306</c:v>
                </c:pt>
                <c:pt idx="41">
                  <c:v>-6.6867343598228306</c:v>
                </c:pt>
                <c:pt idx="42">
                  <c:v>-6.6867343598228306</c:v>
                </c:pt>
                <c:pt idx="43">
                  <c:v>-6.6867343598228306</c:v>
                </c:pt>
                <c:pt idx="44">
                  <c:v>-6.6867343598228306</c:v>
                </c:pt>
                <c:pt idx="45">
                  <c:v>-6.6867343598228306</c:v>
                </c:pt>
                <c:pt idx="46">
                  <c:v>-6.6867343598228306</c:v>
                </c:pt>
                <c:pt idx="47">
                  <c:v>-6.6867343598228306</c:v>
                </c:pt>
                <c:pt idx="48">
                  <c:v>-6.6867343598228306</c:v>
                </c:pt>
                <c:pt idx="49">
                  <c:v>-6.6867343598228306</c:v>
                </c:pt>
                <c:pt idx="50">
                  <c:v>-6.6867343598228306</c:v>
                </c:pt>
                <c:pt idx="51">
                  <c:v>-6.6867343598228306</c:v>
                </c:pt>
                <c:pt idx="52">
                  <c:v>-6.6867343598228306</c:v>
                </c:pt>
                <c:pt idx="53">
                  <c:v>-6.6867343598228306</c:v>
                </c:pt>
                <c:pt idx="54">
                  <c:v>-6.6867343598228306</c:v>
                </c:pt>
                <c:pt idx="55">
                  <c:v>-6.6867343598228306</c:v>
                </c:pt>
                <c:pt idx="56">
                  <c:v>-6.6867343598228306</c:v>
                </c:pt>
                <c:pt idx="57">
                  <c:v>-6.6867343598228306</c:v>
                </c:pt>
                <c:pt idx="58">
                  <c:v>-6.6867343598228306</c:v>
                </c:pt>
                <c:pt idx="59">
                  <c:v>-6.6867343598228306</c:v>
                </c:pt>
                <c:pt idx="60">
                  <c:v>-6.6867343598228306</c:v>
                </c:pt>
                <c:pt idx="61">
                  <c:v>-6.6867343598228306</c:v>
                </c:pt>
                <c:pt idx="62">
                  <c:v>-6.6867343598228306</c:v>
                </c:pt>
                <c:pt idx="63">
                  <c:v>-6.6867343598228306</c:v>
                </c:pt>
                <c:pt idx="64">
                  <c:v>-6.6867343598228306</c:v>
                </c:pt>
                <c:pt idx="65">
                  <c:v>-6.6867343598228306</c:v>
                </c:pt>
                <c:pt idx="66">
                  <c:v>-6.6867343598228306</c:v>
                </c:pt>
                <c:pt idx="67">
                  <c:v>-6.6867343598228306</c:v>
                </c:pt>
                <c:pt idx="68">
                  <c:v>-6.6867343598228306</c:v>
                </c:pt>
                <c:pt idx="69">
                  <c:v>-6.6867343598228306</c:v>
                </c:pt>
                <c:pt idx="70">
                  <c:v>-6.6867343598228306</c:v>
                </c:pt>
                <c:pt idx="71">
                  <c:v>-6.6867343598228306</c:v>
                </c:pt>
                <c:pt idx="72">
                  <c:v>-6.6867343598228306</c:v>
                </c:pt>
                <c:pt idx="73">
                  <c:v>-6.6867343598228306</c:v>
                </c:pt>
                <c:pt idx="74">
                  <c:v>-6.6867343598228306</c:v>
                </c:pt>
                <c:pt idx="75">
                  <c:v>-6.6867343598228306</c:v>
                </c:pt>
                <c:pt idx="76">
                  <c:v>-6.6867343598228306</c:v>
                </c:pt>
                <c:pt idx="77">
                  <c:v>-6.6867343598228306</c:v>
                </c:pt>
                <c:pt idx="78">
                  <c:v>-6.6867343598228306</c:v>
                </c:pt>
                <c:pt idx="79">
                  <c:v>-6.6867343598228306</c:v>
                </c:pt>
                <c:pt idx="80">
                  <c:v>-6.6867343598228306</c:v>
                </c:pt>
                <c:pt idx="81">
                  <c:v>-6.6867343598228306</c:v>
                </c:pt>
                <c:pt idx="82">
                  <c:v>-6.6867343598228306</c:v>
                </c:pt>
                <c:pt idx="83">
                  <c:v>-6.6867343598228306</c:v>
                </c:pt>
                <c:pt idx="84">
                  <c:v>-6.6867343598228306</c:v>
                </c:pt>
                <c:pt idx="85">
                  <c:v>-6.6867343598228306</c:v>
                </c:pt>
                <c:pt idx="86">
                  <c:v>-6.6867343598228306</c:v>
                </c:pt>
                <c:pt idx="87">
                  <c:v>-6.6867343598228306</c:v>
                </c:pt>
                <c:pt idx="88">
                  <c:v>-6.6867343598228306</c:v>
                </c:pt>
                <c:pt idx="89">
                  <c:v>-6.6867343598228306</c:v>
                </c:pt>
                <c:pt idx="90">
                  <c:v>-6.6867343598228306</c:v>
                </c:pt>
                <c:pt idx="91">
                  <c:v>-6.6867343598228306</c:v>
                </c:pt>
                <c:pt idx="92">
                  <c:v>-6.6867343598228306</c:v>
                </c:pt>
                <c:pt idx="93">
                  <c:v>-6.6867343598228306</c:v>
                </c:pt>
                <c:pt idx="94">
                  <c:v>-6.6867343598228306</c:v>
                </c:pt>
                <c:pt idx="95">
                  <c:v>-6.6867343598228306</c:v>
                </c:pt>
                <c:pt idx="96">
                  <c:v>-6.6867343598228306</c:v>
                </c:pt>
                <c:pt idx="97">
                  <c:v>-6.6867343598228306</c:v>
                </c:pt>
                <c:pt idx="98">
                  <c:v>-6.6867343598228306</c:v>
                </c:pt>
                <c:pt idx="99">
                  <c:v>-6.6867343598228306</c:v>
                </c:pt>
                <c:pt idx="100">
                  <c:v>-6.6867343598228306</c:v>
                </c:pt>
                <c:pt idx="101">
                  <c:v>-6.6867343598228306</c:v>
                </c:pt>
                <c:pt idx="102">
                  <c:v>-6.6867343598228306</c:v>
                </c:pt>
                <c:pt idx="103">
                  <c:v>-6.6867343598228306</c:v>
                </c:pt>
                <c:pt idx="104">
                  <c:v>-6.6867343598228306</c:v>
                </c:pt>
                <c:pt idx="105">
                  <c:v>-6.6867343598228306</c:v>
                </c:pt>
                <c:pt idx="106">
                  <c:v>-6.6867343598228306</c:v>
                </c:pt>
                <c:pt idx="107">
                  <c:v>-6.6867343598228306</c:v>
                </c:pt>
                <c:pt idx="108">
                  <c:v>-6.6867343598228306</c:v>
                </c:pt>
                <c:pt idx="109">
                  <c:v>-6.6867343598228306</c:v>
                </c:pt>
                <c:pt idx="110">
                  <c:v>-6.6867343598228306</c:v>
                </c:pt>
                <c:pt idx="111">
                  <c:v>-6.6867343598228306</c:v>
                </c:pt>
                <c:pt idx="112">
                  <c:v>-6.6867343598228306</c:v>
                </c:pt>
                <c:pt idx="113">
                  <c:v>-6.6867343598228306</c:v>
                </c:pt>
                <c:pt idx="114">
                  <c:v>-6.6867343598228306</c:v>
                </c:pt>
                <c:pt idx="115">
                  <c:v>-6.6867343598228306</c:v>
                </c:pt>
                <c:pt idx="116">
                  <c:v>-6.6867343598228306</c:v>
                </c:pt>
                <c:pt idx="117">
                  <c:v>-6.6867343598228306</c:v>
                </c:pt>
                <c:pt idx="118">
                  <c:v>-6.6867343598228306</c:v>
                </c:pt>
                <c:pt idx="119">
                  <c:v>-6.6867343598228306</c:v>
                </c:pt>
                <c:pt idx="120">
                  <c:v>-6.6867343598228306</c:v>
                </c:pt>
                <c:pt idx="121">
                  <c:v>-6.6867343598228306</c:v>
                </c:pt>
                <c:pt idx="122">
                  <c:v>-6.6867343598228306</c:v>
                </c:pt>
                <c:pt idx="123">
                  <c:v>-6.6867343598228306</c:v>
                </c:pt>
                <c:pt idx="124">
                  <c:v>-6.6867343598228306</c:v>
                </c:pt>
                <c:pt idx="125">
                  <c:v>-6.6867343598228306</c:v>
                </c:pt>
                <c:pt idx="126">
                  <c:v>-6.6867343598228306</c:v>
                </c:pt>
                <c:pt idx="127">
                  <c:v>-6.6867343598228306</c:v>
                </c:pt>
                <c:pt idx="128">
                  <c:v>-6.6867343598228306</c:v>
                </c:pt>
                <c:pt idx="129">
                  <c:v>-6.686734359822830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8587-C84D-80E3-823DB5ECD6BA}"/>
            </c:ext>
          </c:extLst>
        </c:ser>
        <c:ser>
          <c:idx val="3"/>
          <c:order val="3"/>
          <c:tx>
            <c:strRef>
              <c:f>Sheet3!$K$3</c:f>
              <c:strCache>
                <c:ptCount val="1"/>
                <c:pt idx="0">
                  <c:v>(+2SD)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Sheet3!$G$4:$G$133</c:f>
              <c:numCache>
                <c:formatCode>0.00</c:formatCode>
                <c:ptCount val="13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</c:numCache>
            </c:numRef>
          </c:xVal>
          <c:yVal>
            <c:numRef>
              <c:f>Sheet3!$K$4:$K$133</c:f>
              <c:numCache>
                <c:formatCode>General</c:formatCode>
                <c:ptCount val="130"/>
                <c:pt idx="0">
                  <c:v>-6.9753757270613743</c:v>
                </c:pt>
                <c:pt idx="1">
                  <c:v>-6.9753757270613743</c:v>
                </c:pt>
                <c:pt idx="2">
                  <c:v>-6.9753757270613743</c:v>
                </c:pt>
                <c:pt idx="3">
                  <c:v>-6.9753757270613743</c:v>
                </c:pt>
                <c:pt idx="4">
                  <c:v>-6.9753757270613743</c:v>
                </c:pt>
                <c:pt idx="5">
                  <c:v>-6.9753757270613743</c:v>
                </c:pt>
                <c:pt idx="6">
                  <c:v>-6.9753757270613743</c:v>
                </c:pt>
                <c:pt idx="7">
                  <c:v>-6.9753757270613743</c:v>
                </c:pt>
                <c:pt idx="8">
                  <c:v>-6.9753757270613743</c:v>
                </c:pt>
                <c:pt idx="9">
                  <c:v>-6.9753757270613743</c:v>
                </c:pt>
                <c:pt idx="10">
                  <c:v>-6.9753757270613743</c:v>
                </c:pt>
                <c:pt idx="11">
                  <c:v>-6.9753757270613743</c:v>
                </c:pt>
                <c:pt idx="12">
                  <c:v>-6.9753757270613743</c:v>
                </c:pt>
                <c:pt idx="13">
                  <c:v>-6.9753757270613743</c:v>
                </c:pt>
                <c:pt idx="14">
                  <c:v>-6.9753757270613743</c:v>
                </c:pt>
                <c:pt idx="15">
                  <c:v>-6.9753757270613743</c:v>
                </c:pt>
                <c:pt idx="16">
                  <c:v>-6.9753757270613743</c:v>
                </c:pt>
                <c:pt idx="17">
                  <c:v>-6.9753757270613743</c:v>
                </c:pt>
                <c:pt idx="18">
                  <c:v>-6.9753757270613743</c:v>
                </c:pt>
                <c:pt idx="19">
                  <c:v>-6.9753757270613743</c:v>
                </c:pt>
                <c:pt idx="20">
                  <c:v>-6.9753757270613743</c:v>
                </c:pt>
                <c:pt idx="21">
                  <c:v>-6.9753757270613743</c:v>
                </c:pt>
                <c:pt idx="22">
                  <c:v>-6.9753757270613743</c:v>
                </c:pt>
                <c:pt idx="23">
                  <c:v>-6.9753757270613743</c:v>
                </c:pt>
                <c:pt idx="24">
                  <c:v>-6.9753757270613743</c:v>
                </c:pt>
                <c:pt idx="25">
                  <c:v>-6.9753757270613743</c:v>
                </c:pt>
                <c:pt idx="26">
                  <c:v>-6.9753757270613743</c:v>
                </c:pt>
                <c:pt idx="27">
                  <c:v>-6.9753757270613743</c:v>
                </c:pt>
                <c:pt idx="28">
                  <c:v>-6.9753757270613743</c:v>
                </c:pt>
                <c:pt idx="29">
                  <c:v>-6.9753757270613743</c:v>
                </c:pt>
                <c:pt idx="30">
                  <c:v>-6.9753757270613743</c:v>
                </c:pt>
                <c:pt idx="31">
                  <c:v>-6.9753757270613743</c:v>
                </c:pt>
                <c:pt idx="32">
                  <c:v>-6.9753757270613743</c:v>
                </c:pt>
                <c:pt idx="33">
                  <c:v>-6.9753757270613743</c:v>
                </c:pt>
                <c:pt idx="34">
                  <c:v>-6.9753757270613743</c:v>
                </c:pt>
                <c:pt idx="35">
                  <c:v>-6.9753757270613743</c:v>
                </c:pt>
                <c:pt idx="36">
                  <c:v>-6.9753757270613743</c:v>
                </c:pt>
                <c:pt idx="37">
                  <c:v>-6.9753757270613743</c:v>
                </c:pt>
                <c:pt idx="38">
                  <c:v>-6.9753757270613743</c:v>
                </c:pt>
                <c:pt idx="39">
                  <c:v>-6.9753757270613743</c:v>
                </c:pt>
                <c:pt idx="40">
                  <c:v>-6.9753757270613743</c:v>
                </c:pt>
                <c:pt idx="41">
                  <c:v>-6.9753757270613743</c:v>
                </c:pt>
                <c:pt idx="42">
                  <c:v>-6.9753757270613743</c:v>
                </c:pt>
                <c:pt idx="43">
                  <c:v>-6.9753757270613743</c:v>
                </c:pt>
                <c:pt idx="44">
                  <c:v>-6.9753757270613743</c:v>
                </c:pt>
                <c:pt idx="45">
                  <c:v>-6.9753757270613743</c:v>
                </c:pt>
                <c:pt idx="46">
                  <c:v>-6.9753757270613743</c:v>
                </c:pt>
                <c:pt idx="47">
                  <c:v>-6.9753757270613743</c:v>
                </c:pt>
                <c:pt idx="48">
                  <c:v>-6.9753757270613743</c:v>
                </c:pt>
                <c:pt idx="49">
                  <c:v>-6.9753757270613743</c:v>
                </c:pt>
                <c:pt idx="50">
                  <c:v>-6.9753757270613743</c:v>
                </c:pt>
                <c:pt idx="51">
                  <c:v>-6.9753757270613743</c:v>
                </c:pt>
                <c:pt idx="52">
                  <c:v>-6.9753757270613743</c:v>
                </c:pt>
                <c:pt idx="53">
                  <c:v>-6.9753757270613743</c:v>
                </c:pt>
                <c:pt idx="54">
                  <c:v>-6.9753757270613743</c:v>
                </c:pt>
                <c:pt idx="55">
                  <c:v>-6.9753757270613743</c:v>
                </c:pt>
                <c:pt idx="56">
                  <c:v>-6.9753757270613743</c:v>
                </c:pt>
                <c:pt idx="57">
                  <c:v>-6.9753757270613743</c:v>
                </c:pt>
                <c:pt idx="58">
                  <c:v>-6.9753757270613743</c:v>
                </c:pt>
                <c:pt idx="59">
                  <c:v>-6.9753757270613743</c:v>
                </c:pt>
                <c:pt idx="60">
                  <c:v>-6.9753757270613743</c:v>
                </c:pt>
                <c:pt idx="61">
                  <c:v>-6.9753757270613743</c:v>
                </c:pt>
                <c:pt idx="62">
                  <c:v>-6.9753757270613743</c:v>
                </c:pt>
                <c:pt idx="63">
                  <c:v>-6.9753757270613743</c:v>
                </c:pt>
                <c:pt idx="64">
                  <c:v>-6.9753757270613743</c:v>
                </c:pt>
                <c:pt idx="65">
                  <c:v>-6.9753757270613743</c:v>
                </c:pt>
                <c:pt idx="66">
                  <c:v>-6.9753757270613743</c:v>
                </c:pt>
                <c:pt idx="67">
                  <c:v>-6.9753757270613743</c:v>
                </c:pt>
                <c:pt idx="68">
                  <c:v>-6.9753757270613743</c:v>
                </c:pt>
                <c:pt idx="69">
                  <c:v>-6.9753757270613743</c:v>
                </c:pt>
                <c:pt idx="70">
                  <c:v>-6.9753757270613743</c:v>
                </c:pt>
                <c:pt idx="71">
                  <c:v>-6.9753757270613743</c:v>
                </c:pt>
                <c:pt idx="72">
                  <c:v>-6.9753757270613743</c:v>
                </c:pt>
                <c:pt idx="73">
                  <c:v>-6.9753757270613743</c:v>
                </c:pt>
                <c:pt idx="74">
                  <c:v>-6.9753757270613743</c:v>
                </c:pt>
                <c:pt idx="75">
                  <c:v>-6.9753757270613743</c:v>
                </c:pt>
                <c:pt idx="76">
                  <c:v>-6.9753757270613743</c:v>
                </c:pt>
                <c:pt idx="77">
                  <c:v>-6.9753757270613743</c:v>
                </c:pt>
                <c:pt idx="78">
                  <c:v>-6.9753757270613743</c:v>
                </c:pt>
                <c:pt idx="79">
                  <c:v>-6.9753757270613743</c:v>
                </c:pt>
                <c:pt idx="80">
                  <c:v>-6.9753757270613743</c:v>
                </c:pt>
                <c:pt idx="81">
                  <c:v>-6.9753757270613743</c:v>
                </c:pt>
                <c:pt idx="82">
                  <c:v>-6.9753757270613743</c:v>
                </c:pt>
                <c:pt idx="83">
                  <c:v>-6.9753757270613743</c:v>
                </c:pt>
                <c:pt idx="84">
                  <c:v>-6.9753757270613743</c:v>
                </c:pt>
                <c:pt idx="85">
                  <c:v>-6.9753757270613743</c:v>
                </c:pt>
                <c:pt idx="86">
                  <c:v>-6.9753757270613743</c:v>
                </c:pt>
                <c:pt idx="87">
                  <c:v>-6.9753757270613743</c:v>
                </c:pt>
                <c:pt idx="88">
                  <c:v>-6.9753757270613743</c:v>
                </c:pt>
                <c:pt idx="89">
                  <c:v>-6.9753757270613743</c:v>
                </c:pt>
                <c:pt idx="90">
                  <c:v>-6.9753757270613743</c:v>
                </c:pt>
                <c:pt idx="91">
                  <c:v>-6.9753757270613743</c:v>
                </c:pt>
                <c:pt idx="92">
                  <c:v>-6.9753757270613743</c:v>
                </c:pt>
                <c:pt idx="93">
                  <c:v>-6.9753757270613743</c:v>
                </c:pt>
                <c:pt idx="94">
                  <c:v>-6.9753757270613743</c:v>
                </c:pt>
                <c:pt idx="95">
                  <c:v>-6.9753757270613743</c:v>
                </c:pt>
                <c:pt idx="96">
                  <c:v>-6.9753757270613743</c:v>
                </c:pt>
                <c:pt idx="97">
                  <c:v>-6.9753757270613743</c:v>
                </c:pt>
                <c:pt idx="98">
                  <c:v>-6.9753757270613743</c:v>
                </c:pt>
                <c:pt idx="99">
                  <c:v>-6.9753757270613743</c:v>
                </c:pt>
                <c:pt idx="100">
                  <c:v>-6.9753757270613743</c:v>
                </c:pt>
                <c:pt idx="101">
                  <c:v>-6.9753757270613743</c:v>
                </c:pt>
                <c:pt idx="102">
                  <c:v>-6.9753757270613743</c:v>
                </c:pt>
                <c:pt idx="103">
                  <c:v>-6.9753757270613743</c:v>
                </c:pt>
                <c:pt idx="104">
                  <c:v>-6.9753757270613743</c:v>
                </c:pt>
                <c:pt idx="105">
                  <c:v>-6.9753757270613743</c:v>
                </c:pt>
                <c:pt idx="106">
                  <c:v>-6.9753757270613743</c:v>
                </c:pt>
                <c:pt idx="107">
                  <c:v>-6.9753757270613743</c:v>
                </c:pt>
                <c:pt idx="108">
                  <c:v>-6.9753757270613743</c:v>
                </c:pt>
                <c:pt idx="109">
                  <c:v>-6.9753757270613743</c:v>
                </c:pt>
                <c:pt idx="110">
                  <c:v>-6.9753757270613743</c:v>
                </c:pt>
                <c:pt idx="111">
                  <c:v>-6.9753757270613743</c:v>
                </c:pt>
                <c:pt idx="112">
                  <c:v>-6.9753757270613743</c:v>
                </c:pt>
                <c:pt idx="113">
                  <c:v>-6.9753757270613743</c:v>
                </c:pt>
                <c:pt idx="114">
                  <c:v>-6.9753757270613743</c:v>
                </c:pt>
                <c:pt idx="115">
                  <c:v>-6.9753757270613743</c:v>
                </c:pt>
                <c:pt idx="116">
                  <c:v>-6.9753757270613743</c:v>
                </c:pt>
                <c:pt idx="117">
                  <c:v>-6.9753757270613743</c:v>
                </c:pt>
                <c:pt idx="118">
                  <c:v>-6.9753757270613743</c:v>
                </c:pt>
                <c:pt idx="119">
                  <c:v>-6.9753757270613743</c:v>
                </c:pt>
                <c:pt idx="120">
                  <c:v>-6.9753757270613743</c:v>
                </c:pt>
                <c:pt idx="121">
                  <c:v>-6.9753757270613743</c:v>
                </c:pt>
                <c:pt idx="122">
                  <c:v>-6.9753757270613743</c:v>
                </c:pt>
                <c:pt idx="123">
                  <c:v>-6.9753757270613743</c:v>
                </c:pt>
                <c:pt idx="124">
                  <c:v>-6.9753757270613743</c:v>
                </c:pt>
                <c:pt idx="125">
                  <c:v>-6.9753757270613743</c:v>
                </c:pt>
                <c:pt idx="126">
                  <c:v>-6.9753757270613743</c:v>
                </c:pt>
                <c:pt idx="127">
                  <c:v>-6.9753757270613743</c:v>
                </c:pt>
                <c:pt idx="128">
                  <c:v>-6.9753757270613743</c:v>
                </c:pt>
                <c:pt idx="129">
                  <c:v>-6.975375727061374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8587-C84D-80E3-823DB5ECD6BA}"/>
            </c:ext>
          </c:extLst>
        </c:ser>
        <c:ser>
          <c:idx val="4"/>
          <c:order val="4"/>
          <c:tx>
            <c:strRef>
              <c:f>Sheet3!$L$3</c:f>
              <c:strCache>
                <c:ptCount val="1"/>
                <c:pt idx="0">
                  <c:v>(+1SD)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Sheet3!$G$4:$G$133</c:f>
              <c:numCache>
                <c:formatCode>0.00</c:formatCode>
                <c:ptCount val="13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</c:numCache>
            </c:numRef>
          </c:xVal>
          <c:yVal>
            <c:numRef>
              <c:f>Sheet3!$L$4:$L$133</c:f>
              <c:numCache>
                <c:formatCode>General</c:formatCode>
                <c:ptCount val="130"/>
                <c:pt idx="0">
                  <c:v>-7.264017094299918</c:v>
                </c:pt>
                <c:pt idx="1">
                  <c:v>-7.264017094299918</c:v>
                </c:pt>
                <c:pt idx="2">
                  <c:v>-7.264017094299918</c:v>
                </c:pt>
                <c:pt idx="3">
                  <c:v>-7.264017094299918</c:v>
                </c:pt>
                <c:pt idx="4">
                  <c:v>-7.264017094299918</c:v>
                </c:pt>
                <c:pt idx="5">
                  <c:v>-7.264017094299918</c:v>
                </c:pt>
                <c:pt idx="6">
                  <c:v>-7.264017094299918</c:v>
                </c:pt>
                <c:pt idx="7">
                  <c:v>-7.264017094299918</c:v>
                </c:pt>
                <c:pt idx="8">
                  <c:v>-7.264017094299918</c:v>
                </c:pt>
                <c:pt idx="9">
                  <c:v>-7.264017094299918</c:v>
                </c:pt>
                <c:pt idx="10">
                  <c:v>-7.264017094299918</c:v>
                </c:pt>
                <c:pt idx="11">
                  <c:v>-7.264017094299918</c:v>
                </c:pt>
                <c:pt idx="12">
                  <c:v>-7.264017094299918</c:v>
                </c:pt>
                <c:pt idx="13">
                  <c:v>-7.264017094299918</c:v>
                </c:pt>
                <c:pt idx="14">
                  <c:v>-7.264017094299918</c:v>
                </c:pt>
                <c:pt idx="15">
                  <c:v>-7.264017094299918</c:v>
                </c:pt>
                <c:pt idx="16">
                  <c:v>-7.264017094299918</c:v>
                </c:pt>
                <c:pt idx="17">
                  <c:v>-7.264017094299918</c:v>
                </c:pt>
                <c:pt idx="18">
                  <c:v>-7.264017094299918</c:v>
                </c:pt>
                <c:pt idx="19">
                  <c:v>-7.264017094299918</c:v>
                </c:pt>
                <c:pt idx="20">
                  <c:v>-7.264017094299918</c:v>
                </c:pt>
                <c:pt idx="21">
                  <c:v>-7.264017094299918</c:v>
                </c:pt>
                <c:pt idx="22">
                  <c:v>-7.264017094299918</c:v>
                </c:pt>
                <c:pt idx="23">
                  <c:v>-7.264017094299918</c:v>
                </c:pt>
                <c:pt idx="24">
                  <c:v>-7.264017094299918</c:v>
                </c:pt>
                <c:pt idx="25">
                  <c:v>-7.264017094299918</c:v>
                </c:pt>
                <c:pt idx="26">
                  <c:v>-7.264017094299918</c:v>
                </c:pt>
                <c:pt idx="27">
                  <c:v>-7.264017094299918</c:v>
                </c:pt>
                <c:pt idx="28">
                  <c:v>-7.264017094299918</c:v>
                </c:pt>
                <c:pt idx="29">
                  <c:v>-7.264017094299918</c:v>
                </c:pt>
                <c:pt idx="30">
                  <c:v>-7.264017094299918</c:v>
                </c:pt>
                <c:pt idx="31">
                  <c:v>-7.264017094299918</c:v>
                </c:pt>
                <c:pt idx="32">
                  <c:v>-7.264017094299918</c:v>
                </c:pt>
                <c:pt idx="33">
                  <c:v>-7.264017094299918</c:v>
                </c:pt>
                <c:pt idx="34">
                  <c:v>-7.264017094299918</c:v>
                </c:pt>
                <c:pt idx="35">
                  <c:v>-7.264017094299918</c:v>
                </c:pt>
                <c:pt idx="36">
                  <c:v>-7.264017094299918</c:v>
                </c:pt>
                <c:pt idx="37">
                  <c:v>-7.264017094299918</c:v>
                </c:pt>
                <c:pt idx="38">
                  <c:v>-7.264017094299918</c:v>
                </c:pt>
                <c:pt idx="39">
                  <c:v>-7.264017094299918</c:v>
                </c:pt>
                <c:pt idx="40">
                  <c:v>-7.264017094299918</c:v>
                </c:pt>
                <c:pt idx="41">
                  <c:v>-7.264017094299918</c:v>
                </c:pt>
                <c:pt idx="42">
                  <c:v>-7.264017094299918</c:v>
                </c:pt>
                <c:pt idx="43">
                  <c:v>-7.264017094299918</c:v>
                </c:pt>
                <c:pt idx="44">
                  <c:v>-7.264017094299918</c:v>
                </c:pt>
                <c:pt idx="45">
                  <c:v>-7.264017094299918</c:v>
                </c:pt>
                <c:pt idx="46">
                  <c:v>-7.264017094299918</c:v>
                </c:pt>
                <c:pt idx="47">
                  <c:v>-7.264017094299918</c:v>
                </c:pt>
                <c:pt idx="48">
                  <c:v>-7.264017094299918</c:v>
                </c:pt>
                <c:pt idx="49">
                  <c:v>-7.264017094299918</c:v>
                </c:pt>
                <c:pt idx="50">
                  <c:v>-7.264017094299918</c:v>
                </c:pt>
                <c:pt idx="51">
                  <c:v>-7.264017094299918</c:v>
                </c:pt>
                <c:pt idx="52">
                  <c:v>-7.264017094299918</c:v>
                </c:pt>
                <c:pt idx="53">
                  <c:v>-7.264017094299918</c:v>
                </c:pt>
                <c:pt idx="54">
                  <c:v>-7.264017094299918</c:v>
                </c:pt>
                <c:pt idx="55">
                  <c:v>-7.264017094299918</c:v>
                </c:pt>
                <c:pt idx="56">
                  <c:v>-7.264017094299918</c:v>
                </c:pt>
                <c:pt idx="57">
                  <c:v>-7.264017094299918</c:v>
                </c:pt>
                <c:pt idx="58">
                  <c:v>-7.264017094299918</c:v>
                </c:pt>
                <c:pt idx="59">
                  <c:v>-7.264017094299918</c:v>
                </c:pt>
                <c:pt idx="60">
                  <c:v>-7.264017094299918</c:v>
                </c:pt>
                <c:pt idx="61">
                  <c:v>-7.264017094299918</c:v>
                </c:pt>
                <c:pt idx="62">
                  <c:v>-7.264017094299918</c:v>
                </c:pt>
                <c:pt idx="63">
                  <c:v>-7.264017094299918</c:v>
                </c:pt>
                <c:pt idx="64">
                  <c:v>-7.264017094299918</c:v>
                </c:pt>
                <c:pt idx="65">
                  <c:v>-7.264017094299918</c:v>
                </c:pt>
                <c:pt idx="66">
                  <c:v>-7.264017094299918</c:v>
                </c:pt>
                <c:pt idx="67">
                  <c:v>-7.264017094299918</c:v>
                </c:pt>
                <c:pt idx="68">
                  <c:v>-7.264017094299918</c:v>
                </c:pt>
                <c:pt idx="69">
                  <c:v>-7.264017094299918</c:v>
                </c:pt>
                <c:pt idx="70">
                  <c:v>-7.264017094299918</c:v>
                </c:pt>
                <c:pt idx="71">
                  <c:v>-7.264017094299918</c:v>
                </c:pt>
                <c:pt idx="72">
                  <c:v>-7.264017094299918</c:v>
                </c:pt>
                <c:pt idx="73">
                  <c:v>-7.264017094299918</c:v>
                </c:pt>
                <c:pt idx="74">
                  <c:v>-7.264017094299918</c:v>
                </c:pt>
                <c:pt idx="75">
                  <c:v>-7.264017094299918</c:v>
                </c:pt>
                <c:pt idx="76">
                  <c:v>-7.264017094299918</c:v>
                </c:pt>
                <c:pt idx="77">
                  <c:v>-7.264017094299918</c:v>
                </c:pt>
                <c:pt idx="78">
                  <c:v>-7.264017094299918</c:v>
                </c:pt>
                <c:pt idx="79">
                  <c:v>-7.264017094299918</c:v>
                </c:pt>
                <c:pt idx="80">
                  <c:v>-7.264017094299918</c:v>
                </c:pt>
                <c:pt idx="81">
                  <c:v>-7.264017094299918</c:v>
                </c:pt>
                <c:pt idx="82">
                  <c:v>-7.264017094299918</c:v>
                </c:pt>
                <c:pt idx="83">
                  <c:v>-7.264017094299918</c:v>
                </c:pt>
                <c:pt idx="84">
                  <c:v>-7.264017094299918</c:v>
                </c:pt>
                <c:pt idx="85">
                  <c:v>-7.264017094299918</c:v>
                </c:pt>
                <c:pt idx="86">
                  <c:v>-7.264017094299918</c:v>
                </c:pt>
                <c:pt idx="87">
                  <c:v>-7.264017094299918</c:v>
                </c:pt>
                <c:pt idx="88">
                  <c:v>-7.264017094299918</c:v>
                </c:pt>
                <c:pt idx="89">
                  <c:v>-7.264017094299918</c:v>
                </c:pt>
                <c:pt idx="90">
                  <c:v>-7.264017094299918</c:v>
                </c:pt>
                <c:pt idx="91">
                  <c:v>-7.264017094299918</c:v>
                </c:pt>
                <c:pt idx="92">
                  <c:v>-7.264017094299918</c:v>
                </c:pt>
                <c:pt idx="93">
                  <c:v>-7.264017094299918</c:v>
                </c:pt>
                <c:pt idx="94">
                  <c:v>-7.264017094299918</c:v>
                </c:pt>
                <c:pt idx="95">
                  <c:v>-7.264017094299918</c:v>
                </c:pt>
                <c:pt idx="96">
                  <c:v>-7.264017094299918</c:v>
                </c:pt>
                <c:pt idx="97">
                  <c:v>-7.264017094299918</c:v>
                </c:pt>
                <c:pt idx="98">
                  <c:v>-7.264017094299918</c:v>
                </c:pt>
                <c:pt idx="99">
                  <c:v>-7.264017094299918</c:v>
                </c:pt>
                <c:pt idx="100">
                  <c:v>-7.264017094299918</c:v>
                </c:pt>
                <c:pt idx="101">
                  <c:v>-7.264017094299918</c:v>
                </c:pt>
                <c:pt idx="102">
                  <c:v>-7.264017094299918</c:v>
                </c:pt>
                <c:pt idx="103">
                  <c:v>-7.264017094299918</c:v>
                </c:pt>
                <c:pt idx="104">
                  <c:v>-7.264017094299918</c:v>
                </c:pt>
                <c:pt idx="105">
                  <c:v>-7.264017094299918</c:v>
                </c:pt>
                <c:pt idx="106">
                  <c:v>-7.264017094299918</c:v>
                </c:pt>
                <c:pt idx="107">
                  <c:v>-7.264017094299918</c:v>
                </c:pt>
                <c:pt idx="108">
                  <c:v>-7.264017094299918</c:v>
                </c:pt>
                <c:pt idx="109">
                  <c:v>-7.264017094299918</c:v>
                </c:pt>
                <c:pt idx="110">
                  <c:v>-7.264017094299918</c:v>
                </c:pt>
                <c:pt idx="111">
                  <c:v>-7.264017094299918</c:v>
                </c:pt>
                <c:pt idx="112">
                  <c:v>-7.264017094299918</c:v>
                </c:pt>
                <c:pt idx="113">
                  <c:v>-7.264017094299918</c:v>
                </c:pt>
                <c:pt idx="114">
                  <c:v>-7.264017094299918</c:v>
                </c:pt>
                <c:pt idx="115">
                  <c:v>-7.264017094299918</c:v>
                </c:pt>
                <c:pt idx="116">
                  <c:v>-7.264017094299918</c:v>
                </c:pt>
                <c:pt idx="117">
                  <c:v>-7.264017094299918</c:v>
                </c:pt>
                <c:pt idx="118">
                  <c:v>-7.264017094299918</c:v>
                </c:pt>
                <c:pt idx="119">
                  <c:v>-7.264017094299918</c:v>
                </c:pt>
                <c:pt idx="120">
                  <c:v>-7.264017094299918</c:v>
                </c:pt>
                <c:pt idx="121">
                  <c:v>-7.264017094299918</c:v>
                </c:pt>
                <c:pt idx="122">
                  <c:v>-7.264017094299918</c:v>
                </c:pt>
                <c:pt idx="123">
                  <c:v>-7.264017094299918</c:v>
                </c:pt>
                <c:pt idx="124">
                  <c:v>-7.264017094299918</c:v>
                </c:pt>
                <c:pt idx="125">
                  <c:v>-7.264017094299918</c:v>
                </c:pt>
                <c:pt idx="126">
                  <c:v>-7.264017094299918</c:v>
                </c:pt>
                <c:pt idx="127">
                  <c:v>-7.264017094299918</c:v>
                </c:pt>
                <c:pt idx="128">
                  <c:v>-7.264017094299918</c:v>
                </c:pt>
                <c:pt idx="129">
                  <c:v>-7.26401709429991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8587-C84D-80E3-823DB5ECD6BA}"/>
            </c:ext>
          </c:extLst>
        </c:ser>
        <c:ser>
          <c:idx val="5"/>
          <c:order val="5"/>
          <c:tx>
            <c:strRef>
              <c:f>Sheet3!$M$3</c:f>
              <c:strCache>
                <c:ptCount val="1"/>
                <c:pt idx="0">
                  <c:v>Mean</c:v>
                </c:pt>
              </c:strCache>
            </c:strRef>
          </c:tx>
          <c:spPr>
            <a:ln w="19050" cap="rnd">
              <a:solidFill>
                <a:srgbClr val="FF0000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  <a:prstDash val="sysDash"/>
              </a:ln>
              <a:effectLst/>
            </c:spPr>
          </c:marker>
          <c:xVal>
            <c:numRef>
              <c:f>Sheet3!$G$4:$G$133</c:f>
              <c:numCache>
                <c:formatCode>0.00</c:formatCode>
                <c:ptCount val="13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</c:numCache>
            </c:numRef>
          </c:xVal>
          <c:yVal>
            <c:numRef>
              <c:f>Sheet3!$M$4:$M$133</c:f>
              <c:numCache>
                <c:formatCode>General</c:formatCode>
                <c:ptCount val="130"/>
                <c:pt idx="0">
                  <c:v>-7.5526584615384618</c:v>
                </c:pt>
                <c:pt idx="1">
                  <c:v>-7.5526584615384618</c:v>
                </c:pt>
                <c:pt idx="2">
                  <c:v>-7.5526584615384618</c:v>
                </c:pt>
                <c:pt idx="3">
                  <c:v>-7.5526584615384618</c:v>
                </c:pt>
                <c:pt idx="4">
                  <c:v>-7.5526584615384618</c:v>
                </c:pt>
                <c:pt idx="5">
                  <c:v>-7.5526584615384618</c:v>
                </c:pt>
                <c:pt idx="6">
                  <c:v>-7.5526584615384618</c:v>
                </c:pt>
                <c:pt idx="7">
                  <c:v>-7.5526584615384618</c:v>
                </c:pt>
                <c:pt idx="8">
                  <c:v>-7.5526584615384618</c:v>
                </c:pt>
                <c:pt idx="9">
                  <c:v>-7.5526584615384618</c:v>
                </c:pt>
                <c:pt idx="10">
                  <c:v>-7.5526584615384618</c:v>
                </c:pt>
                <c:pt idx="11">
                  <c:v>-7.5526584615384618</c:v>
                </c:pt>
                <c:pt idx="12">
                  <c:v>-7.5526584615384618</c:v>
                </c:pt>
                <c:pt idx="13">
                  <c:v>-7.5526584615384618</c:v>
                </c:pt>
                <c:pt idx="14">
                  <c:v>-7.5526584615384618</c:v>
                </c:pt>
                <c:pt idx="15">
                  <c:v>-7.5526584615384618</c:v>
                </c:pt>
                <c:pt idx="16">
                  <c:v>-7.5526584615384618</c:v>
                </c:pt>
                <c:pt idx="17">
                  <c:v>-7.5526584615384618</c:v>
                </c:pt>
                <c:pt idx="18">
                  <c:v>-7.5526584615384618</c:v>
                </c:pt>
                <c:pt idx="19">
                  <c:v>-7.5526584615384618</c:v>
                </c:pt>
                <c:pt idx="20">
                  <c:v>-7.5526584615384618</c:v>
                </c:pt>
                <c:pt idx="21">
                  <c:v>-7.5526584615384618</c:v>
                </c:pt>
                <c:pt idx="22">
                  <c:v>-7.5526584615384618</c:v>
                </c:pt>
                <c:pt idx="23">
                  <c:v>-7.5526584615384618</c:v>
                </c:pt>
                <c:pt idx="24">
                  <c:v>-7.5526584615384618</c:v>
                </c:pt>
                <c:pt idx="25">
                  <c:v>-7.5526584615384618</c:v>
                </c:pt>
                <c:pt idx="26">
                  <c:v>-7.5526584615384618</c:v>
                </c:pt>
                <c:pt idx="27">
                  <c:v>-7.5526584615384618</c:v>
                </c:pt>
                <c:pt idx="28">
                  <c:v>-7.5526584615384618</c:v>
                </c:pt>
                <c:pt idx="29">
                  <c:v>-7.5526584615384618</c:v>
                </c:pt>
                <c:pt idx="30">
                  <c:v>-7.5526584615384618</c:v>
                </c:pt>
                <c:pt idx="31">
                  <c:v>-7.5526584615384618</c:v>
                </c:pt>
                <c:pt idx="32">
                  <c:v>-7.5526584615384618</c:v>
                </c:pt>
                <c:pt idx="33">
                  <c:v>-7.5526584615384618</c:v>
                </c:pt>
                <c:pt idx="34">
                  <c:v>-7.5526584615384618</c:v>
                </c:pt>
                <c:pt idx="35">
                  <c:v>-7.5526584615384618</c:v>
                </c:pt>
                <c:pt idx="36">
                  <c:v>-7.5526584615384618</c:v>
                </c:pt>
                <c:pt idx="37">
                  <c:v>-7.5526584615384618</c:v>
                </c:pt>
                <c:pt idx="38">
                  <c:v>-7.5526584615384618</c:v>
                </c:pt>
                <c:pt idx="39">
                  <c:v>-7.5526584615384618</c:v>
                </c:pt>
                <c:pt idx="40">
                  <c:v>-7.5526584615384618</c:v>
                </c:pt>
                <c:pt idx="41">
                  <c:v>-7.5526584615384618</c:v>
                </c:pt>
                <c:pt idx="42">
                  <c:v>-7.5526584615384618</c:v>
                </c:pt>
                <c:pt idx="43">
                  <c:v>-7.5526584615384618</c:v>
                </c:pt>
                <c:pt idx="44">
                  <c:v>-7.5526584615384618</c:v>
                </c:pt>
                <c:pt idx="45">
                  <c:v>-7.5526584615384618</c:v>
                </c:pt>
                <c:pt idx="46">
                  <c:v>-7.5526584615384618</c:v>
                </c:pt>
                <c:pt idx="47">
                  <c:v>-7.5526584615384618</c:v>
                </c:pt>
                <c:pt idx="48">
                  <c:v>-7.5526584615384618</c:v>
                </c:pt>
                <c:pt idx="49">
                  <c:v>-7.5526584615384618</c:v>
                </c:pt>
                <c:pt idx="50">
                  <c:v>-7.5526584615384618</c:v>
                </c:pt>
                <c:pt idx="51">
                  <c:v>-7.5526584615384618</c:v>
                </c:pt>
                <c:pt idx="52">
                  <c:v>-7.5526584615384618</c:v>
                </c:pt>
                <c:pt idx="53">
                  <c:v>-7.5526584615384618</c:v>
                </c:pt>
                <c:pt idx="54">
                  <c:v>-7.5526584615384618</c:v>
                </c:pt>
                <c:pt idx="55">
                  <c:v>-7.5526584615384618</c:v>
                </c:pt>
                <c:pt idx="56">
                  <c:v>-7.5526584615384618</c:v>
                </c:pt>
                <c:pt idx="57">
                  <c:v>-7.5526584615384618</c:v>
                </c:pt>
                <c:pt idx="58">
                  <c:v>-7.5526584615384618</c:v>
                </c:pt>
                <c:pt idx="59">
                  <c:v>-7.5526584615384618</c:v>
                </c:pt>
                <c:pt idx="60">
                  <c:v>-7.5526584615384618</c:v>
                </c:pt>
                <c:pt idx="61">
                  <c:v>-7.5526584615384618</c:v>
                </c:pt>
                <c:pt idx="62">
                  <c:v>-7.5526584615384618</c:v>
                </c:pt>
                <c:pt idx="63">
                  <c:v>-7.5526584615384618</c:v>
                </c:pt>
                <c:pt idx="64">
                  <c:v>-7.5526584615384618</c:v>
                </c:pt>
                <c:pt idx="65">
                  <c:v>-7.5526584615384618</c:v>
                </c:pt>
                <c:pt idx="66">
                  <c:v>-7.5526584615384618</c:v>
                </c:pt>
                <c:pt idx="67">
                  <c:v>-7.5526584615384618</c:v>
                </c:pt>
                <c:pt idx="68">
                  <c:v>-7.5526584615384618</c:v>
                </c:pt>
                <c:pt idx="69">
                  <c:v>-7.5526584615384618</c:v>
                </c:pt>
                <c:pt idx="70">
                  <c:v>-7.5526584615384618</c:v>
                </c:pt>
                <c:pt idx="71">
                  <c:v>-7.5526584615384618</c:v>
                </c:pt>
                <c:pt idx="72">
                  <c:v>-7.5526584615384618</c:v>
                </c:pt>
                <c:pt idx="73">
                  <c:v>-7.5526584615384618</c:v>
                </c:pt>
                <c:pt idx="74">
                  <c:v>-7.5526584615384618</c:v>
                </c:pt>
                <c:pt idx="75">
                  <c:v>-7.5526584615384618</c:v>
                </c:pt>
                <c:pt idx="76">
                  <c:v>-7.5526584615384618</c:v>
                </c:pt>
                <c:pt idx="77">
                  <c:v>-7.5526584615384618</c:v>
                </c:pt>
                <c:pt idx="78">
                  <c:v>-7.5526584615384618</c:v>
                </c:pt>
                <c:pt idx="79">
                  <c:v>-7.5526584615384618</c:v>
                </c:pt>
                <c:pt idx="80">
                  <c:v>-7.5526584615384618</c:v>
                </c:pt>
                <c:pt idx="81">
                  <c:v>-7.5526584615384618</c:v>
                </c:pt>
                <c:pt idx="82">
                  <c:v>-7.5526584615384618</c:v>
                </c:pt>
                <c:pt idx="83">
                  <c:v>-7.5526584615384618</c:v>
                </c:pt>
                <c:pt idx="84">
                  <c:v>-7.5526584615384618</c:v>
                </c:pt>
                <c:pt idx="85">
                  <c:v>-7.5526584615384618</c:v>
                </c:pt>
                <c:pt idx="86">
                  <c:v>-7.5526584615384618</c:v>
                </c:pt>
                <c:pt idx="87">
                  <c:v>-7.5526584615384618</c:v>
                </c:pt>
                <c:pt idx="88">
                  <c:v>-7.5526584615384618</c:v>
                </c:pt>
                <c:pt idx="89">
                  <c:v>-7.5526584615384618</c:v>
                </c:pt>
                <c:pt idx="90">
                  <c:v>-7.5526584615384618</c:v>
                </c:pt>
                <c:pt idx="91">
                  <c:v>-7.5526584615384618</c:v>
                </c:pt>
                <c:pt idx="92">
                  <c:v>-7.5526584615384618</c:v>
                </c:pt>
                <c:pt idx="93">
                  <c:v>-7.5526584615384618</c:v>
                </c:pt>
                <c:pt idx="94">
                  <c:v>-7.5526584615384618</c:v>
                </c:pt>
                <c:pt idx="95">
                  <c:v>-7.5526584615384618</c:v>
                </c:pt>
                <c:pt idx="96">
                  <c:v>-7.5526584615384618</c:v>
                </c:pt>
                <c:pt idx="97">
                  <c:v>-7.5526584615384618</c:v>
                </c:pt>
                <c:pt idx="98">
                  <c:v>-7.5526584615384618</c:v>
                </c:pt>
                <c:pt idx="99">
                  <c:v>-7.5526584615384618</c:v>
                </c:pt>
                <c:pt idx="100">
                  <c:v>-7.5526584615384618</c:v>
                </c:pt>
                <c:pt idx="101">
                  <c:v>-7.5526584615384618</c:v>
                </c:pt>
                <c:pt idx="102">
                  <c:v>-7.5526584615384618</c:v>
                </c:pt>
                <c:pt idx="103">
                  <c:v>-7.5526584615384618</c:v>
                </c:pt>
                <c:pt idx="104">
                  <c:v>-7.5526584615384618</c:v>
                </c:pt>
                <c:pt idx="105">
                  <c:v>-7.5526584615384618</c:v>
                </c:pt>
                <c:pt idx="106">
                  <c:v>-7.5526584615384618</c:v>
                </c:pt>
                <c:pt idx="107">
                  <c:v>-7.5526584615384618</c:v>
                </c:pt>
                <c:pt idx="108">
                  <c:v>-7.5526584615384618</c:v>
                </c:pt>
                <c:pt idx="109">
                  <c:v>-7.5526584615384618</c:v>
                </c:pt>
                <c:pt idx="110">
                  <c:v>-7.5526584615384618</c:v>
                </c:pt>
                <c:pt idx="111">
                  <c:v>-7.5526584615384618</c:v>
                </c:pt>
                <c:pt idx="112">
                  <c:v>-7.5526584615384618</c:v>
                </c:pt>
                <c:pt idx="113">
                  <c:v>-7.5526584615384618</c:v>
                </c:pt>
                <c:pt idx="114">
                  <c:v>-7.5526584615384618</c:v>
                </c:pt>
                <c:pt idx="115">
                  <c:v>-7.5526584615384618</c:v>
                </c:pt>
                <c:pt idx="116">
                  <c:v>-7.5526584615384618</c:v>
                </c:pt>
                <c:pt idx="117">
                  <c:v>-7.5526584615384618</c:v>
                </c:pt>
                <c:pt idx="118">
                  <c:v>-7.5526584615384618</c:v>
                </c:pt>
                <c:pt idx="119">
                  <c:v>-7.5526584615384618</c:v>
                </c:pt>
                <c:pt idx="120">
                  <c:v>-7.5526584615384618</c:v>
                </c:pt>
                <c:pt idx="121">
                  <c:v>-7.5526584615384618</c:v>
                </c:pt>
                <c:pt idx="122">
                  <c:v>-7.5526584615384618</c:v>
                </c:pt>
                <c:pt idx="123">
                  <c:v>-7.5526584615384618</c:v>
                </c:pt>
                <c:pt idx="124">
                  <c:v>-7.5526584615384618</c:v>
                </c:pt>
                <c:pt idx="125">
                  <c:v>-7.5526584615384618</c:v>
                </c:pt>
                <c:pt idx="126">
                  <c:v>-7.5526584615384618</c:v>
                </c:pt>
                <c:pt idx="127">
                  <c:v>-7.5526584615384618</c:v>
                </c:pt>
                <c:pt idx="128">
                  <c:v>-7.5526584615384618</c:v>
                </c:pt>
                <c:pt idx="129">
                  <c:v>-7.552658461538461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8587-C84D-80E3-823DB5ECD6BA}"/>
            </c:ext>
          </c:extLst>
        </c:ser>
        <c:ser>
          <c:idx val="6"/>
          <c:order val="6"/>
          <c:tx>
            <c:strRef>
              <c:f>Sheet3!$N$3</c:f>
              <c:strCache>
                <c:ptCount val="1"/>
                <c:pt idx="0">
                  <c:v>(-1SD)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Sheet3!$G$4:$G$133</c:f>
              <c:numCache>
                <c:formatCode>0.00</c:formatCode>
                <c:ptCount val="13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</c:numCache>
            </c:numRef>
          </c:xVal>
          <c:yVal>
            <c:numRef>
              <c:f>Sheet3!$N$4:$N$133</c:f>
              <c:numCache>
                <c:formatCode>General</c:formatCode>
                <c:ptCount val="130"/>
                <c:pt idx="0">
                  <c:v>-7.8412998287770055</c:v>
                </c:pt>
                <c:pt idx="1">
                  <c:v>-7.8412998287770055</c:v>
                </c:pt>
                <c:pt idx="2">
                  <c:v>-7.8412998287770055</c:v>
                </c:pt>
                <c:pt idx="3">
                  <c:v>-7.8412998287770055</c:v>
                </c:pt>
                <c:pt idx="4">
                  <c:v>-7.8412998287770055</c:v>
                </c:pt>
                <c:pt idx="5">
                  <c:v>-7.8412998287770055</c:v>
                </c:pt>
                <c:pt idx="6">
                  <c:v>-7.8412998287770055</c:v>
                </c:pt>
                <c:pt idx="7">
                  <c:v>-7.8412998287770055</c:v>
                </c:pt>
                <c:pt idx="8">
                  <c:v>-7.8412998287770055</c:v>
                </c:pt>
                <c:pt idx="9">
                  <c:v>-7.8412998287770055</c:v>
                </c:pt>
                <c:pt idx="10">
                  <c:v>-7.8412998287770055</c:v>
                </c:pt>
                <c:pt idx="11">
                  <c:v>-7.8412998287770055</c:v>
                </c:pt>
                <c:pt idx="12">
                  <c:v>-7.8412998287770055</c:v>
                </c:pt>
                <c:pt idx="13">
                  <c:v>-7.8412998287770055</c:v>
                </c:pt>
                <c:pt idx="14">
                  <c:v>-7.8412998287770055</c:v>
                </c:pt>
                <c:pt idx="15">
                  <c:v>-7.8412998287770055</c:v>
                </c:pt>
                <c:pt idx="16">
                  <c:v>-7.8412998287770055</c:v>
                </c:pt>
                <c:pt idx="17">
                  <c:v>-7.8412998287770055</c:v>
                </c:pt>
                <c:pt idx="18">
                  <c:v>-7.8412998287770055</c:v>
                </c:pt>
                <c:pt idx="19">
                  <c:v>-7.8412998287770055</c:v>
                </c:pt>
                <c:pt idx="20">
                  <c:v>-7.8412998287770055</c:v>
                </c:pt>
                <c:pt idx="21">
                  <c:v>-7.8412998287770055</c:v>
                </c:pt>
                <c:pt idx="22">
                  <c:v>-7.8412998287770055</c:v>
                </c:pt>
                <c:pt idx="23">
                  <c:v>-7.8412998287770055</c:v>
                </c:pt>
                <c:pt idx="24">
                  <c:v>-7.8412998287770055</c:v>
                </c:pt>
                <c:pt idx="25">
                  <c:v>-7.8412998287770055</c:v>
                </c:pt>
                <c:pt idx="26">
                  <c:v>-7.8412998287770055</c:v>
                </c:pt>
                <c:pt idx="27">
                  <c:v>-7.8412998287770055</c:v>
                </c:pt>
                <c:pt idx="28">
                  <c:v>-7.8412998287770055</c:v>
                </c:pt>
                <c:pt idx="29">
                  <c:v>-7.8412998287770055</c:v>
                </c:pt>
                <c:pt idx="30">
                  <c:v>-7.8412998287770055</c:v>
                </c:pt>
                <c:pt idx="31">
                  <c:v>-7.8412998287770055</c:v>
                </c:pt>
                <c:pt idx="32">
                  <c:v>-7.8412998287770055</c:v>
                </c:pt>
                <c:pt idx="33">
                  <c:v>-7.8412998287770055</c:v>
                </c:pt>
                <c:pt idx="34">
                  <c:v>-7.8412998287770055</c:v>
                </c:pt>
                <c:pt idx="35">
                  <c:v>-7.8412998287770055</c:v>
                </c:pt>
                <c:pt idx="36">
                  <c:v>-7.8412998287770055</c:v>
                </c:pt>
                <c:pt idx="37">
                  <c:v>-7.8412998287770055</c:v>
                </c:pt>
                <c:pt idx="38">
                  <c:v>-7.8412998287770055</c:v>
                </c:pt>
                <c:pt idx="39">
                  <c:v>-7.8412998287770055</c:v>
                </c:pt>
                <c:pt idx="40">
                  <c:v>-7.8412998287770055</c:v>
                </c:pt>
                <c:pt idx="41">
                  <c:v>-7.8412998287770055</c:v>
                </c:pt>
                <c:pt idx="42">
                  <c:v>-7.8412998287770055</c:v>
                </c:pt>
                <c:pt idx="43">
                  <c:v>-7.8412998287770055</c:v>
                </c:pt>
                <c:pt idx="44">
                  <c:v>-7.8412998287770055</c:v>
                </c:pt>
                <c:pt idx="45">
                  <c:v>-7.8412998287770055</c:v>
                </c:pt>
                <c:pt idx="46">
                  <c:v>-7.8412998287770055</c:v>
                </c:pt>
                <c:pt idx="47">
                  <c:v>-7.8412998287770055</c:v>
                </c:pt>
                <c:pt idx="48">
                  <c:v>-7.8412998287770055</c:v>
                </c:pt>
                <c:pt idx="49">
                  <c:v>-7.8412998287770055</c:v>
                </c:pt>
                <c:pt idx="50">
                  <c:v>-7.8412998287770055</c:v>
                </c:pt>
                <c:pt idx="51">
                  <c:v>-7.8412998287770055</c:v>
                </c:pt>
                <c:pt idx="52">
                  <c:v>-7.8412998287770055</c:v>
                </c:pt>
                <c:pt idx="53">
                  <c:v>-7.8412998287770055</c:v>
                </c:pt>
                <c:pt idx="54">
                  <c:v>-7.8412998287770055</c:v>
                </c:pt>
                <c:pt idx="55">
                  <c:v>-7.8412998287770055</c:v>
                </c:pt>
                <c:pt idx="56">
                  <c:v>-7.8412998287770055</c:v>
                </c:pt>
                <c:pt idx="57">
                  <c:v>-7.8412998287770055</c:v>
                </c:pt>
                <c:pt idx="58">
                  <c:v>-7.8412998287770055</c:v>
                </c:pt>
                <c:pt idx="59">
                  <c:v>-7.8412998287770055</c:v>
                </c:pt>
                <c:pt idx="60">
                  <c:v>-7.8412998287770055</c:v>
                </c:pt>
                <c:pt idx="61">
                  <c:v>-7.8412998287770055</c:v>
                </c:pt>
                <c:pt idx="62">
                  <c:v>-7.8412998287770055</c:v>
                </c:pt>
                <c:pt idx="63">
                  <c:v>-7.8412998287770055</c:v>
                </c:pt>
                <c:pt idx="64">
                  <c:v>-7.8412998287770055</c:v>
                </c:pt>
                <c:pt idx="65">
                  <c:v>-7.8412998287770055</c:v>
                </c:pt>
                <c:pt idx="66">
                  <c:v>-7.8412998287770055</c:v>
                </c:pt>
                <c:pt idx="67">
                  <c:v>-7.8412998287770055</c:v>
                </c:pt>
                <c:pt idx="68">
                  <c:v>-7.8412998287770055</c:v>
                </c:pt>
                <c:pt idx="69">
                  <c:v>-7.8412998287770055</c:v>
                </c:pt>
                <c:pt idx="70">
                  <c:v>-7.8412998287770055</c:v>
                </c:pt>
                <c:pt idx="71">
                  <c:v>-7.8412998287770055</c:v>
                </c:pt>
                <c:pt idx="72">
                  <c:v>-7.8412998287770055</c:v>
                </c:pt>
                <c:pt idx="73">
                  <c:v>-7.8412998287770055</c:v>
                </c:pt>
                <c:pt idx="74">
                  <c:v>-7.8412998287770055</c:v>
                </c:pt>
                <c:pt idx="75">
                  <c:v>-7.8412998287770055</c:v>
                </c:pt>
                <c:pt idx="76">
                  <c:v>-7.8412998287770055</c:v>
                </c:pt>
                <c:pt idx="77">
                  <c:v>-7.8412998287770055</c:v>
                </c:pt>
                <c:pt idx="78">
                  <c:v>-7.8412998287770055</c:v>
                </c:pt>
                <c:pt idx="79">
                  <c:v>-7.8412998287770055</c:v>
                </c:pt>
                <c:pt idx="80">
                  <c:v>-7.8412998287770055</c:v>
                </c:pt>
                <c:pt idx="81">
                  <c:v>-7.8412998287770055</c:v>
                </c:pt>
                <c:pt idx="82">
                  <c:v>-7.8412998287770055</c:v>
                </c:pt>
                <c:pt idx="83">
                  <c:v>-7.8412998287770055</c:v>
                </c:pt>
                <c:pt idx="84">
                  <c:v>-7.8412998287770055</c:v>
                </c:pt>
                <c:pt idx="85">
                  <c:v>-7.8412998287770055</c:v>
                </c:pt>
                <c:pt idx="86">
                  <c:v>-7.8412998287770055</c:v>
                </c:pt>
                <c:pt idx="87">
                  <c:v>-7.8412998287770055</c:v>
                </c:pt>
                <c:pt idx="88">
                  <c:v>-7.8412998287770055</c:v>
                </c:pt>
                <c:pt idx="89">
                  <c:v>-7.8412998287770055</c:v>
                </c:pt>
                <c:pt idx="90">
                  <c:v>-7.8412998287770055</c:v>
                </c:pt>
                <c:pt idx="91">
                  <c:v>-7.8412998287770055</c:v>
                </c:pt>
                <c:pt idx="92">
                  <c:v>-7.8412998287770055</c:v>
                </c:pt>
                <c:pt idx="93">
                  <c:v>-7.8412998287770055</c:v>
                </c:pt>
                <c:pt idx="94">
                  <c:v>-7.8412998287770055</c:v>
                </c:pt>
                <c:pt idx="95">
                  <c:v>-7.8412998287770055</c:v>
                </c:pt>
                <c:pt idx="96">
                  <c:v>-7.8412998287770055</c:v>
                </c:pt>
                <c:pt idx="97">
                  <c:v>-7.8412998287770055</c:v>
                </c:pt>
                <c:pt idx="98">
                  <c:v>-7.8412998287770055</c:v>
                </c:pt>
                <c:pt idx="99">
                  <c:v>-7.8412998287770055</c:v>
                </c:pt>
                <c:pt idx="100">
                  <c:v>-7.8412998287770055</c:v>
                </c:pt>
                <c:pt idx="101">
                  <c:v>-7.8412998287770055</c:v>
                </c:pt>
                <c:pt idx="102">
                  <c:v>-7.8412998287770055</c:v>
                </c:pt>
                <c:pt idx="103">
                  <c:v>-7.8412998287770055</c:v>
                </c:pt>
                <c:pt idx="104">
                  <c:v>-7.8412998287770055</c:v>
                </c:pt>
                <c:pt idx="105">
                  <c:v>-7.8412998287770055</c:v>
                </c:pt>
                <c:pt idx="106">
                  <c:v>-7.8412998287770055</c:v>
                </c:pt>
                <c:pt idx="107">
                  <c:v>-7.8412998287770055</c:v>
                </c:pt>
                <c:pt idx="108">
                  <c:v>-7.8412998287770055</c:v>
                </c:pt>
                <c:pt idx="109">
                  <c:v>-7.8412998287770055</c:v>
                </c:pt>
                <c:pt idx="110">
                  <c:v>-7.8412998287770055</c:v>
                </c:pt>
                <c:pt idx="111">
                  <c:v>-7.8412998287770055</c:v>
                </c:pt>
                <c:pt idx="112">
                  <c:v>-7.8412998287770055</c:v>
                </c:pt>
                <c:pt idx="113">
                  <c:v>-7.8412998287770055</c:v>
                </c:pt>
                <c:pt idx="114">
                  <c:v>-7.8412998287770055</c:v>
                </c:pt>
                <c:pt idx="115">
                  <c:v>-7.8412998287770055</c:v>
                </c:pt>
                <c:pt idx="116">
                  <c:v>-7.8412998287770055</c:v>
                </c:pt>
                <c:pt idx="117">
                  <c:v>-7.8412998287770055</c:v>
                </c:pt>
                <c:pt idx="118">
                  <c:v>-7.8412998287770055</c:v>
                </c:pt>
                <c:pt idx="119">
                  <c:v>-7.8412998287770055</c:v>
                </c:pt>
                <c:pt idx="120">
                  <c:v>-7.8412998287770055</c:v>
                </c:pt>
                <c:pt idx="121">
                  <c:v>-7.8412998287770055</c:v>
                </c:pt>
                <c:pt idx="122">
                  <c:v>-7.8412998287770055</c:v>
                </c:pt>
                <c:pt idx="123">
                  <c:v>-7.8412998287770055</c:v>
                </c:pt>
                <c:pt idx="124">
                  <c:v>-7.8412998287770055</c:v>
                </c:pt>
                <c:pt idx="125">
                  <c:v>-7.8412998287770055</c:v>
                </c:pt>
                <c:pt idx="126">
                  <c:v>-7.8412998287770055</c:v>
                </c:pt>
                <c:pt idx="127">
                  <c:v>-7.8412998287770055</c:v>
                </c:pt>
                <c:pt idx="128">
                  <c:v>-7.8412998287770055</c:v>
                </c:pt>
                <c:pt idx="129">
                  <c:v>-7.841299828777005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8587-C84D-80E3-823DB5ECD6BA}"/>
            </c:ext>
          </c:extLst>
        </c:ser>
        <c:ser>
          <c:idx val="7"/>
          <c:order val="7"/>
          <c:tx>
            <c:strRef>
              <c:f>Sheet3!$O$3</c:f>
              <c:strCache>
                <c:ptCount val="1"/>
                <c:pt idx="0">
                  <c:v>(-2SD)</c:v>
                </c:pt>
              </c:strCache>
            </c:strRef>
          </c:tx>
          <c:spPr>
            <a:ln w="19050" cap="rnd">
              <a:solidFill>
                <a:schemeClr val="accent4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accent4">
                    <a:lumMod val="60000"/>
                    <a:lumOff val="40000"/>
                  </a:schemeClr>
                </a:solidFill>
              </a:ln>
              <a:effectLst/>
            </c:spPr>
          </c:marker>
          <c:xVal>
            <c:numRef>
              <c:f>Sheet3!$G$4:$G$133</c:f>
              <c:numCache>
                <c:formatCode>0.00</c:formatCode>
                <c:ptCount val="13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</c:numCache>
            </c:numRef>
          </c:xVal>
          <c:yVal>
            <c:numRef>
              <c:f>Sheet3!$O$4:$O$133</c:f>
              <c:numCache>
                <c:formatCode>General</c:formatCode>
                <c:ptCount val="130"/>
                <c:pt idx="0">
                  <c:v>-8.1299411960155492</c:v>
                </c:pt>
                <c:pt idx="1">
                  <c:v>-8.1299411960155492</c:v>
                </c:pt>
                <c:pt idx="2">
                  <c:v>-8.1299411960155492</c:v>
                </c:pt>
                <c:pt idx="3">
                  <c:v>-8.1299411960155492</c:v>
                </c:pt>
                <c:pt idx="4">
                  <c:v>-8.1299411960155492</c:v>
                </c:pt>
                <c:pt idx="5">
                  <c:v>-8.1299411960155492</c:v>
                </c:pt>
                <c:pt idx="6">
                  <c:v>-8.1299411960155492</c:v>
                </c:pt>
                <c:pt idx="7">
                  <c:v>-8.1299411960155492</c:v>
                </c:pt>
                <c:pt idx="8">
                  <c:v>-8.1299411960155492</c:v>
                </c:pt>
                <c:pt idx="9">
                  <c:v>-8.1299411960155492</c:v>
                </c:pt>
                <c:pt idx="10">
                  <c:v>-8.1299411960155492</c:v>
                </c:pt>
                <c:pt idx="11">
                  <c:v>-8.1299411960155492</c:v>
                </c:pt>
                <c:pt idx="12">
                  <c:v>-8.1299411960155492</c:v>
                </c:pt>
                <c:pt idx="13">
                  <c:v>-8.1299411960155492</c:v>
                </c:pt>
                <c:pt idx="14">
                  <c:v>-8.1299411960155492</c:v>
                </c:pt>
                <c:pt idx="15">
                  <c:v>-8.1299411960155492</c:v>
                </c:pt>
                <c:pt idx="16">
                  <c:v>-8.1299411960155492</c:v>
                </c:pt>
                <c:pt idx="17">
                  <c:v>-8.1299411960155492</c:v>
                </c:pt>
                <c:pt idx="18">
                  <c:v>-8.1299411960155492</c:v>
                </c:pt>
                <c:pt idx="19">
                  <c:v>-8.1299411960155492</c:v>
                </c:pt>
                <c:pt idx="20">
                  <c:v>-8.1299411960155492</c:v>
                </c:pt>
                <c:pt idx="21">
                  <c:v>-8.1299411960155492</c:v>
                </c:pt>
                <c:pt idx="22">
                  <c:v>-8.1299411960155492</c:v>
                </c:pt>
                <c:pt idx="23">
                  <c:v>-8.1299411960155492</c:v>
                </c:pt>
                <c:pt idx="24">
                  <c:v>-8.1299411960155492</c:v>
                </c:pt>
                <c:pt idx="25">
                  <c:v>-8.1299411960155492</c:v>
                </c:pt>
                <c:pt idx="26">
                  <c:v>-8.1299411960155492</c:v>
                </c:pt>
                <c:pt idx="27">
                  <c:v>-8.1299411960155492</c:v>
                </c:pt>
                <c:pt idx="28">
                  <c:v>-8.1299411960155492</c:v>
                </c:pt>
                <c:pt idx="29">
                  <c:v>-8.1299411960155492</c:v>
                </c:pt>
                <c:pt idx="30">
                  <c:v>-8.1299411960155492</c:v>
                </c:pt>
                <c:pt idx="31">
                  <c:v>-8.1299411960155492</c:v>
                </c:pt>
                <c:pt idx="32">
                  <c:v>-8.1299411960155492</c:v>
                </c:pt>
                <c:pt idx="33">
                  <c:v>-8.1299411960155492</c:v>
                </c:pt>
                <c:pt idx="34">
                  <c:v>-8.1299411960155492</c:v>
                </c:pt>
                <c:pt idx="35">
                  <c:v>-8.1299411960155492</c:v>
                </c:pt>
                <c:pt idx="36">
                  <c:v>-8.1299411960155492</c:v>
                </c:pt>
                <c:pt idx="37">
                  <c:v>-8.1299411960155492</c:v>
                </c:pt>
                <c:pt idx="38">
                  <c:v>-8.1299411960155492</c:v>
                </c:pt>
                <c:pt idx="39">
                  <c:v>-8.1299411960155492</c:v>
                </c:pt>
                <c:pt idx="40">
                  <c:v>-8.1299411960155492</c:v>
                </c:pt>
                <c:pt idx="41">
                  <c:v>-8.1299411960155492</c:v>
                </c:pt>
                <c:pt idx="42">
                  <c:v>-8.1299411960155492</c:v>
                </c:pt>
                <c:pt idx="43">
                  <c:v>-8.1299411960155492</c:v>
                </c:pt>
                <c:pt idx="44">
                  <c:v>-8.1299411960155492</c:v>
                </c:pt>
                <c:pt idx="45">
                  <c:v>-8.1299411960155492</c:v>
                </c:pt>
                <c:pt idx="46">
                  <c:v>-8.1299411960155492</c:v>
                </c:pt>
                <c:pt idx="47">
                  <c:v>-8.1299411960155492</c:v>
                </c:pt>
                <c:pt idx="48">
                  <c:v>-8.1299411960155492</c:v>
                </c:pt>
                <c:pt idx="49">
                  <c:v>-8.1299411960155492</c:v>
                </c:pt>
                <c:pt idx="50">
                  <c:v>-8.1299411960155492</c:v>
                </c:pt>
                <c:pt idx="51">
                  <c:v>-8.1299411960155492</c:v>
                </c:pt>
                <c:pt idx="52">
                  <c:v>-8.1299411960155492</c:v>
                </c:pt>
                <c:pt idx="53">
                  <c:v>-8.1299411960155492</c:v>
                </c:pt>
                <c:pt idx="54">
                  <c:v>-8.1299411960155492</c:v>
                </c:pt>
                <c:pt idx="55">
                  <c:v>-8.1299411960155492</c:v>
                </c:pt>
                <c:pt idx="56">
                  <c:v>-8.1299411960155492</c:v>
                </c:pt>
                <c:pt idx="57">
                  <c:v>-8.1299411960155492</c:v>
                </c:pt>
                <c:pt idx="58">
                  <c:v>-8.1299411960155492</c:v>
                </c:pt>
                <c:pt idx="59">
                  <c:v>-8.1299411960155492</c:v>
                </c:pt>
                <c:pt idx="60">
                  <c:v>-8.1299411960155492</c:v>
                </c:pt>
                <c:pt idx="61">
                  <c:v>-8.1299411960155492</c:v>
                </c:pt>
                <c:pt idx="62">
                  <c:v>-8.1299411960155492</c:v>
                </c:pt>
                <c:pt idx="63">
                  <c:v>-8.1299411960155492</c:v>
                </c:pt>
                <c:pt idx="64">
                  <c:v>-8.1299411960155492</c:v>
                </c:pt>
                <c:pt idx="65">
                  <c:v>-8.1299411960155492</c:v>
                </c:pt>
                <c:pt idx="66">
                  <c:v>-8.1299411960155492</c:v>
                </c:pt>
                <c:pt idx="67">
                  <c:v>-8.1299411960155492</c:v>
                </c:pt>
                <c:pt idx="68">
                  <c:v>-8.1299411960155492</c:v>
                </c:pt>
                <c:pt idx="69">
                  <c:v>-8.1299411960155492</c:v>
                </c:pt>
                <c:pt idx="70">
                  <c:v>-8.1299411960155492</c:v>
                </c:pt>
                <c:pt idx="71">
                  <c:v>-8.1299411960155492</c:v>
                </c:pt>
                <c:pt idx="72">
                  <c:v>-8.1299411960155492</c:v>
                </c:pt>
                <c:pt idx="73">
                  <c:v>-8.1299411960155492</c:v>
                </c:pt>
                <c:pt idx="74">
                  <c:v>-8.1299411960155492</c:v>
                </c:pt>
                <c:pt idx="75">
                  <c:v>-8.1299411960155492</c:v>
                </c:pt>
                <c:pt idx="76">
                  <c:v>-8.1299411960155492</c:v>
                </c:pt>
                <c:pt idx="77">
                  <c:v>-8.1299411960155492</c:v>
                </c:pt>
                <c:pt idx="78">
                  <c:v>-8.1299411960155492</c:v>
                </c:pt>
                <c:pt idx="79">
                  <c:v>-8.1299411960155492</c:v>
                </c:pt>
                <c:pt idx="80">
                  <c:v>-8.1299411960155492</c:v>
                </c:pt>
                <c:pt idx="81">
                  <c:v>-8.1299411960155492</c:v>
                </c:pt>
                <c:pt idx="82">
                  <c:v>-8.1299411960155492</c:v>
                </c:pt>
                <c:pt idx="83">
                  <c:v>-8.1299411960155492</c:v>
                </c:pt>
                <c:pt idx="84">
                  <c:v>-8.1299411960155492</c:v>
                </c:pt>
                <c:pt idx="85">
                  <c:v>-8.1299411960155492</c:v>
                </c:pt>
                <c:pt idx="86">
                  <c:v>-8.1299411960155492</c:v>
                </c:pt>
                <c:pt idx="87">
                  <c:v>-8.1299411960155492</c:v>
                </c:pt>
                <c:pt idx="88">
                  <c:v>-8.1299411960155492</c:v>
                </c:pt>
                <c:pt idx="89">
                  <c:v>-8.1299411960155492</c:v>
                </c:pt>
                <c:pt idx="90">
                  <c:v>-8.1299411960155492</c:v>
                </c:pt>
                <c:pt idx="91">
                  <c:v>-8.1299411960155492</c:v>
                </c:pt>
                <c:pt idx="92">
                  <c:v>-8.1299411960155492</c:v>
                </c:pt>
                <c:pt idx="93">
                  <c:v>-8.1299411960155492</c:v>
                </c:pt>
                <c:pt idx="94">
                  <c:v>-8.1299411960155492</c:v>
                </c:pt>
                <c:pt idx="95">
                  <c:v>-8.1299411960155492</c:v>
                </c:pt>
                <c:pt idx="96">
                  <c:v>-8.1299411960155492</c:v>
                </c:pt>
                <c:pt idx="97">
                  <c:v>-8.1299411960155492</c:v>
                </c:pt>
                <c:pt idx="98">
                  <c:v>-8.1299411960155492</c:v>
                </c:pt>
                <c:pt idx="99">
                  <c:v>-8.1299411960155492</c:v>
                </c:pt>
                <c:pt idx="100">
                  <c:v>-8.1299411960155492</c:v>
                </c:pt>
                <c:pt idx="101">
                  <c:v>-8.1299411960155492</c:v>
                </c:pt>
                <c:pt idx="102">
                  <c:v>-8.1299411960155492</c:v>
                </c:pt>
                <c:pt idx="103">
                  <c:v>-8.1299411960155492</c:v>
                </c:pt>
                <c:pt idx="104">
                  <c:v>-8.1299411960155492</c:v>
                </c:pt>
                <c:pt idx="105">
                  <c:v>-8.1299411960155492</c:v>
                </c:pt>
                <c:pt idx="106">
                  <c:v>-8.1299411960155492</c:v>
                </c:pt>
                <c:pt idx="107">
                  <c:v>-8.1299411960155492</c:v>
                </c:pt>
                <c:pt idx="108">
                  <c:v>-8.1299411960155492</c:v>
                </c:pt>
                <c:pt idx="109">
                  <c:v>-8.1299411960155492</c:v>
                </c:pt>
                <c:pt idx="110">
                  <c:v>-8.1299411960155492</c:v>
                </c:pt>
                <c:pt idx="111">
                  <c:v>-8.1299411960155492</c:v>
                </c:pt>
                <c:pt idx="112">
                  <c:v>-8.1299411960155492</c:v>
                </c:pt>
                <c:pt idx="113">
                  <c:v>-8.1299411960155492</c:v>
                </c:pt>
                <c:pt idx="114">
                  <c:v>-8.1299411960155492</c:v>
                </c:pt>
                <c:pt idx="115">
                  <c:v>-8.1299411960155492</c:v>
                </c:pt>
                <c:pt idx="116">
                  <c:v>-8.1299411960155492</c:v>
                </c:pt>
                <c:pt idx="117">
                  <c:v>-8.1299411960155492</c:v>
                </c:pt>
                <c:pt idx="118">
                  <c:v>-8.1299411960155492</c:v>
                </c:pt>
                <c:pt idx="119">
                  <c:v>-8.1299411960155492</c:v>
                </c:pt>
                <c:pt idx="120">
                  <c:v>-8.1299411960155492</c:v>
                </c:pt>
                <c:pt idx="121">
                  <c:v>-8.1299411960155492</c:v>
                </c:pt>
                <c:pt idx="122">
                  <c:v>-8.1299411960155492</c:v>
                </c:pt>
                <c:pt idx="123">
                  <c:v>-8.1299411960155492</c:v>
                </c:pt>
                <c:pt idx="124">
                  <c:v>-8.1299411960155492</c:v>
                </c:pt>
                <c:pt idx="125">
                  <c:v>-8.1299411960155492</c:v>
                </c:pt>
                <c:pt idx="126">
                  <c:v>-8.1299411960155492</c:v>
                </c:pt>
                <c:pt idx="127">
                  <c:v>-8.1299411960155492</c:v>
                </c:pt>
                <c:pt idx="128">
                  <c:v>-8.1299411960155492</c:v>
                </c:pt>
                <c:pt idx="129">
                  <c:v>-8.129941196015549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8587-C84D-80E3-823DB5ECD6BA}"/>
            </c:ext>
          </c:extLst>
        </c:ser>
        <c:ser>
          <c:idx val="8"/>
          <c:order val="8"/>
          <c:tx>
            <c:strRef>
              <c:f>Sheet3!$P$3</c:f>
              <c:strCache>
                <c:ptCount val="1"/>
                <c:pt idx="0">
                  <c:v>(-3SD)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Sheet3!$G$4:$G$133</c:f>
              <c:numCache>
                <c:formatCode>0.00</c:formatCode>
                <c:ptCount val="13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</c:numCache>
            </c:numRef>
          </c:xVal>
          <c:yVal>
            <c:numRef>
              <c:f>Sheet3!$P$4:$P$133</c:f>
              <c:numCache>
                <c:formatCode>General</c:formatCode>
                <c:ptCount val="130"/>
                <c:pt idx="0">
                  <c:v>-8.4185825632540929</c:v>
                </c:pt>
                <c:pt idx="1">
                  <c:v>-8.4185825632540929</c:v>
                </c:pt>
                <c:pt idx="2">
                  <c:v>-8.4185825632540929</c:v>
                </c:pt>
                <c:pt idx="3">
                  <c:v>-8.4185825632540929</c:v>
                </c:pt>
                <c:pt idx="4">
                  <c:v>-8.4185825632540929</c:v>
                </c:pt>
                <c:pt idx="5">
                  <c:v>-8.4185825632540929</c:v>
                </c:pt>
                <c:pt idx="6">
                  <c:v>-8.4185825632540929</c:v>
                </c:pt>
                <c:pt idx="7">
                  <c:v>-8.4185825632540929</c:v>
                </c:pt>
                <c:pt idx="8">
                  <c:v>-8.4185825632540929</c:v>
                </c:pt>
                <c:pt idx="9">
                  <c:v>-8.4185825632540929</c:v>
                </c:pt>
                <c:pt idx="10">
                  <c:v>-8.4185825632540929</c:v>
                </c:pt>
                <c:pt idx="11">
                  <c:v>-8.4185825632540929</c:v>
                </c:pt>
                <c:pt idx="12">
                  <c:v>-8.4185825632540929</c:v>
                </c:pt>
                <c:pt idx="13">
                  <c:v>-8.4185825632540929</c:v>
                </c:pt>
                <c:pt idx="14">
                  <c:v>-8.4185825632540929</c:v>
                </c:pt>
                <c:pt idx="15">
                  <c:v>-8.4185825632540929</c:v>
                </c:pt>
                <c:pt idx="16">
                  <c:v>-8.4185825632540929</c:v>
                </c:pt>
                <c:pt idx="17">
                  <c:v>-8.4185825632540929</c:v>
                </c:pt>
                <c:pt idx="18">
                  <c:v>-8.4185825632540929</c:v>
                </c:pt>
                <c:pt idx="19">
                  <c:v>-8.4185825632540929</c:v>
                </c:pt>
                <c:pt idx="20">
                  <c:v>-8.4185825632540929</c:v>
                </c:pt>
                <c:pt idx="21">
                  <c:v>-8.4185825632540929</c:v>
                </c:pt>
                <c:pt idx="22">
                  <c:v>-8.4185825632540929</c:v>
                </c:pt>
                <c:pt idx="23">
                  <c:v>-8.4185825632540929</c:v>
                </c:pt>
                <c:pt idx="24">
                  <c:v>-8.4185825632540929</c:v>
                </c:pt>
                <c:pt idx="25">
                  <c:v>-8.4185825632540929</c:v>
                </c:pt>
                <c:pt idx="26">
                  <c:v>-8.4185825632540929</c:v>
                </c:pt>
                <c:pt idx="27">
                  <c:v>-8.4185825632540929</c:v>
                </c:pt>
                <c:pt idx="28">
                  <c:v>-8.4185825632540929</c:v>
                </c:pt>
                <c:pt idx="29">
                  <c:v>-8.4185825632540929</c:v>
                </c:pt>
                <c:pt idx="30">
                  <c:v>-8.4185825632540929</c:v>
                </c:pt>
                <c:pt idx="31">
                  <c:v>-8.4185825632540929</c:v>
                </c:pt>
                <c:pt idx="32">
                  <c:v>-8.4185825632540929</c:v>
                </c:pt>
                <c:pt idx="33">
                  <c:v>-8.4185825632540929</c:v>
                </c:pt>
                <c:pt idx="34">
                  <c:v>-8.4185825632540929</c:v>
                </c:pt>
                <c:pt idx="35">
                  <c:v>-8.4185825632540929</c:v>
                </c:pt>
                <c:pt idx="36">
                  <c:v>-8.4185825632540929</c:v>
                </c:pt>
                <c:pt idx="37">
                  <c:v>-8.4185825632540929</c:v>
                </c:pt>
                <c:pt idx="38">
                  <c:v>-8.4185825632540929</c:v>
                </c:pt>
                <c:pt idx="39">
                  <c:v>-8.4185825632540929</c:v>
                </c:pt>
                <c:pt idx="40">
                  <c:v>-8.4185825632540929</c:v>
                </c:pt>
                <c:pt idx="41">
                  <c:v>-8.4185825632540929</c:v>
                </c:pt>
                <c:pt idx="42">
                  <c:v>-8.4185825632540929</c:v>
                </c:pt>
                <c:pt idx="43">
                  <c:v>-8.4185825632540929</c:v>
                </c:pt>
                <c:pt idx="44">
                  <c:v>-8.4185825632540929</c:v>
                </c:pt>
                <c:pt idx="45">
                  <c:v>-8.4185825632540929</c:v>
                </c:pt>
                <c:pt idx="46">
                  <c:v>-8.4185825632540929</c:v>
                </c:pt>
                <c:pt idx="47">
                  <c:v>-8.4185825632540929</c:v>
                </c:pt>
                <c:pt idx="48">
                  <c:v>-8.4185825632540929</c:v>
                </c:pt>
                <c:pt idx="49">
                  <c:v>-8.4185825632540929</c:v>
                </c:pt>
                <c:pt idx="50">
                  <c:v>-8.4185825632540929</c:v>
                </c:pt>
                <c:pt idx="51">
                  <c:v>-8.4185825632540929</c:v>
                </c:pt>
                <c:pt idx="52">
                  <c:v>-8.4185825632540929</c:v>
                </c:pt>
                <c:pt idx="53">
                  <c:v>-8.4185825632540929</c:v>
                </c:pt>
                <c:pt idx="54">
                  <c:v>-8.4185825632540929</c:v>
                </c:pt>
                <c:pt idx="55">
                  <c:v>-8.4185825632540929</c:v>
                </c:pt>
                <c:pt idx="56">
                  <c:v>-8.4185825632540929</c:v>
                </c:pt>
                <c:pt idx="57">
                  <c:v>-8.4185825632540929</c:v>
                </c:pt>
                <c:pt idx="58">
                  <c:v>-8.4185825632540929</c:v>
                </c:pt>
                <c:pt idx="59">
                  <c:v>-8.4185825632540929</c:v>
                </c:pt>
                <c:pt idx="60">
                  <c:v>-8.4185825632540929</c:v>
                </c:pt>
                <c:pt idx="61">
                  <c:v>-8.4185825632540929</c:v>
                </c:pt>
                <c:pt idx="62">
                  <c:v>-8.4185825632540929</c:v>
                </c:pt>
                <c:pt idx="63">
                  <c:v>-8.4185825632540929</c:v>
                </c:pt>
                <c:pt idx="64">
                  <c:v>-8.4185825632540929</c:v>
                </c:pt>
                <c:pt idx="65">
                  <c:v>-8.4185825632540929</c:v>
                </c:pt>
                <c:pt idx="66">
                  <c:v>-8.4185825632540929</c:v>
                </c:pt>
                <c:pt idx="67">
                  <c:v>-8.4185825632540929</c:v>
                </c:pt>
                <c:pt idx="68">
                  <c:v>-8.4185825632540929</c:v>
                </c:pt>
                <c:pt idx="69">
                  <c:v>-8.4185825632540929</c:v>
                </c:pt>
                <c:pt idx="70">
                  <c:v>-8.4185825632540929</c:v>
                </c:pt>
                <c:pt idx="71">
                  <c:v>-8.4185825632540929</c:v>
                </c:pt>
                <c:pt idx="72">
                  <c:v>-8.4185825632540929</c:v>
                </c:pt>
                <c:pt idx="73">
                  <c:v>-8.4185825632540929</c:v>
                </c:pt>
                <c:pt idx="74">
                  <c:v>-8.4185825632540929</c:v>
                </c:pt>
                <c:pt idx="75">
                  <c:v>-8.4185825632540929</c:v>
                </c:pt>
                <c:pt idx="76">
                  <c:v>-8.4185825632540929</c:v>
                </c:pt>
                <c:pt idx="77">
                  <c:v>-8.4185825632540929</c:v>
                </c:pt>
                <c:pt idx="78">
                  <c:v>-8.4185825632540929</c:v>
                </c:pt>
                <c:pt idx="79">
                  <c:v>-8.4185825632540929</c:v>
                </c:pt>
                <c:pt idx="80">
                  <c:v>-8.4185825632540929</c:v>
                </c:pt>
                <c:pt idx="81">
                  <c:v>-8.4185825632540929</c:v>
                </c:pt>
                <c:pt idx="82">
                  <c:v>-8.4185825632540929</c:v>
                </c:pt>
                <c:pt idx="83">
                  <c:v>-8.4185825632540929</c:v>
                </c:pt>
                <c:pt idx="84">
                  <c:v>-8.4185825632540929</c:v>
                </c:pt>
                <c:pt idx="85">
                  <c:v>-8.4185825632540929</c:v>
                </c:pt>
                <c:pt idx="86">
                  <c:v>-8.4185825632540929</c:v>
                </c:pt>
                <c:pt idx="87">
                  <c:v>-8.4185825632540929</c:v>
                </c:pt>
                <c:pt idx="88">
                  <c:v>-8.4185825632540929</c:v>
                </c:pt>
                <c:pt idx="89">
                  <c:v>-8.4185825632540929</c:v>
                </c:pt>
                <c:pt idx="90">
                  <c:v>-8.4185825632540929</c:v>
                </c:pt>
                <c:pt idx="91">
                  <c:v>-8.4185825632540929</c:v>
                </c:pt>
                <c:pt idx="92">
                  <c:v>-8.4185825632540929</c:v>
                </c:pt>
                <c:pt idx="93">
                  <c:v>-8.4185825632540929</c:v>
                </c:pt>
                <c:pt idx="94">
                  <c:v>-8.4185825632540929</c:v>
                </c:pt>
                <c:pt idx="95">
                  <c:v>-8.4185825632540929</c:v>
                </c:pt>
                <c:pt idx="96">
                  <c:v>-8.4185825632540929</c:v>
                </c:pt>
                <c:pt idx="97">
                  <c:v>-8.4185825632540929</c:v>
                </c:pt>
                <c:pt idx="98">
                  <c:v>-8.4185825632540929</c:v>
                </c:pt>
                <c:pt idx="99">
                  <c:v>-8.4185825632540929</c:v>
                </c:pt>
                <c:pt idx="100">
                  <c:v>-8.4185825632540929</c:v>
                </c:pt>
                <c:pt idx="101">
                  <c:v>-8.4185825632540929</c:v>
                </c:pt>
                <c:pt idx="102">
                  <c:v>-8.4185825632540929</c:v>
                </c:pt>
                <c:pt idx="103">
                  <c:v>-8.4185825632540929</c:v>
                </c:pt>
                <c:pt idx="104">
                  <c:v>-8.4185825632540929</c:v>
                </c:pt>
                <c:pt idx="105">
                  <c:v>-8.4185825632540929</c:v>
                </c:pt>
                <c:pt idx="106">
                  <c:v>-8.4185825632540929</c:v>
                </c:pt>
                <c:pt idx="107">
                  <c:v>-8.4185825632540929</c:v>
                </c:pt>
                <c:pt idx="108">
                  <c:v>-8.4185825632540929</c:v>
                </c:pt>
                <c:pt idx="109">
                  <c:v>-8.4185825632540929</c:v>
                </c:pt>
                <c:pt idx="110">
                  <c:v>-8.4185825632540929</c:v>
                </c:pt>
                <c:pt idx="111">
                  <c:v>-8.4185825632540929</c:v>
                </c:pt>
                <c:pt idx="112">
                  <c:v>-8.4185825632540929</c:v>
                </c:pt>
                <c:pt idx="113">
                  <c:v>-8.4185825632540929</c:v>
                </c:pt>
                <c:pt idx="114">
                  <c:v>-8.4185825632540929</c:v>
                </c:pt>
                <c:pt idx="115">
                  <c:v>-8.4185825632540929</c:v>
                </c:pt>
                <c:pt idx="116">
                  <c:v>-8.4185825632540929</c:v>
                </c:pt>
                <c:pt idx="117">
                  <c:v>-8.4185825632540929</c:v>
                </c:pt>
                <c:pt idx="118">
                  <c:v>-8.4185825632540929</c:v>
                </c:pt>
                <c:pt idx="119">
                  <c:v>-8.4185825632540929</c:v>
                </c:pt>
                <c:pt idx="120">
                  <c:v>-8.4185825632540929</c:v>
                </c:pt>
                <c:pt idx="121">
                  <c:v>-8.4185825632540929</c:v>
                </c:pt>
                <c:pt idx="122">
                  <c:v>-8.4185825632540929</c:v>
                </c:pt>
                <c:pt idx="123">
                  <c:v>-8.4185825632540929</c:v>
                </c:pt>
                <c:pt idx="124">
                  <c:v>-8.4185825632540929</c:v>
                </c:pt>
                <c:pt idx="125">
                  <c:v>-8.4185825632540929</c:v>
                </c:pt>
                <c:pt idx="126">
                  <c:v>-8.4185825632540929</c:v>
                </c:pt>
                <c:pt idx="127">
                  <c:v>-8.4185825632540929</c:v>
                </c:pt>
                <c:pt idx="128">
                  <c:v>-8.4185825632540929</c:v>
                </c:pt>
                <c:pt idx="129">
                  <c:v>-8.418582563254092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8-8587-C84D-80E3-823DB5ECD6BA}"/>
            </c:ext>
          </c:extLst>
        </c:ser>
        <c:ser>
          <c:idx val="9"/>
          <c:order val="9"/>
          <c:tx>
            <c:strRef>
              <c:f>Sheet3!$Q$3</c:f>
              <c:strCache>
                <c:ptCount val="1"/>
                <c:pt idx="0">
                  <c:v>(-4SD)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3!$G$4:$G$133</c:f>
              <c:numCache>
                <c:formatCode>0.00</c:formatCode>
                <c:ptCount val="13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</c:numCache>
            </c:numRef>
          </c:xVal>
          <c:yVal>
            <c:numRef>
              <c:f>Sheet3!$Q$4:$Q$133</c:f>
              <c:numCache>
                <c:formatCode>General</c:formatCode>
                <c:ptCount val="130"/>
                <c:pt idx="0">
                  <c:v>-8.7072239304926367</c:v>
                </c:pt>
                <c:pt idx="1">
                  <c:v>-8.7072239304926367</c:v>
                </c:pt>
                <c:pt idx="2">
                  <c:v>-8.7072239304926367</c:v>
                </c:pt>
                <c:pt idx="3">
                  <c:v>-8.7072239304926367</c:v>
                </c:pt>
                <c:pt idx="4">
                  <c:v>-8.7072239304926367</c:v>
                </c:pt>
                <c:pt idx="5">
                  <c:v>-8.7072239304926367</c:v>
                </c:pt>
                <c:pt idx="6">
                  <c:v>-8.7072239304926367</c:v>
                </c:pt>
                <c:pt idx="7">
                  <c:v>-8.7072239304926367</c:v>
                </c:pt>
                <c:pt idx="8">
                  <c:v>-8.7072239304926367</c:v>
                </c:pt>
                <c:pt idx="9">
                  <c:v>-8.7072239304926367</c:v>
                </c:pt>
                <c:pt idx="10">
                  <c:v>-8.7072239304926367</c:v>
                </c:pt>
                <c:pt idx="11">
                  <c:v>-8.7072239304926367</c:v>
                </c:pt>
                <c:pt idx="12">
                  <c:v>-8.7072239304926367</c:v>
                </c:pt>
                <c:pt idx="13">
                  <c:v>-8.7072239304926367</c:v>
                </c:pt>
                <c:pt idx="14">
                  <c:v>-8.7072239304926367</c:v>
                </c:pt>
                <c:pt idx="15">
                  <c:v>-8.7072239304926367</c:v>
                </c:pt>
                <c:pt idx="16">
                  <c:v>-8.7072239304926367</c:v>
                </c:pt>
                <c:pt idx="17">
                  <c:v>-8.7072239304926367</c:v>
                </c:pt>
                <c:pt idx="18">
                  <c:v>-8.7072239304926367</c:v>
                </c:pt>
                <c:pt idx="19">
                  <c:v>-8.7072239304926367</c:v>
                </c:pt>
                <c:pt idx="20">
                  <c:v>-8.7072239304926367</c:v>
                </c:pt>
                <c:pt idx="21">
                  <c:v>-8.7072239304926367</c:v>
                </c:pt>
                <c:pt idx="22">
                  <c:v>-8.7072239304926367</c:v>
                </c:pt>
                <c:pt idx="23">
                  <c:v>-8.7072239304926367</c:v>
                </c:pt>
                <c:pt idx="24">
                  <c:v>-8.7072239304926367</c:v>
                </c:pt>
                <c:pt idx="25">
                  <c:v>-8.7072239304926367</c:v>
                </c:pt>
                <c:pt idx="26">
                  <c:v>-8.7072239304926367</c:v>
                </c:pt>
                <c:pt idx="27">
                  <c:v>-8.7072239304926367</c:v>
                </c:pt>
                <c:pt idx="28">
                  <c:v>-8.7072239304926367</c:v>
                </c:pt>
                <c:pt idx="29">
                  <c:v>-8.7072239304926367</c:v>
                </c:pt>
                <c:pt idx="30">
                  <c:v>-8.7072239304926367</c:v>
                </c:pt>
                <c:pt idx="31">
                  <c:v>-8.7072239304926367</c:v>
                </c:pt>
                <c:pt idx="32">
                  <c:v>-8.7072239304926367</c:v>
                </c:pt>
                <c:pt idx="33">
                  <c:v>-8.7072239304926367</c:v>
                </c:pt>
                <c:pt idx="34">
                  <c:v>-8.7072239304926367</c:v>
                </c:pt>
                <c:pt idx="35">
                  <c:v>-8.7072239304926367</c:v>
                </c:pt>
                <c:pt idx="36">
                  <c:v>-8.7072239304926367</c:v>
                </c:pt>
                <c:pt idx="37">
                  <c:v>-8.7072239304926367</c:v>
                </c:pt>
                <c:pt idx="38">
                  <c:v>-8.7072239304926367</c:v>
                </c:pt>
                <c:pt idx="39">
                  <c:v>-8.7072239304926367</c:v>
                </c:pt>
                <c:pt idx="40">
                  <c:v>-8.7072239304926367</c:v>
                </c:pt>
                <c:pt idx="41">
                  <c:v>-8.7072239304926367</c:v>
                </c:pt>
                <c:pt idx="42">
                  <c:v>-8.7072239304926367</c:v>
                </c:pt>
                <c:pt idx="43">
                  <c:v>-8.7072239304926367</c:v>
                </c:pt>
                <c:pt idx="44">
                  <c:v>-8.7072239304926367</c:v>
                </c:pt>
                <c:pt idx="45">
                  <c:v>-8.7072239304926367</c:v>
                </c:pt>
                <c:pt idx="46">
                  <c:v>-8.7072239304926367</c:v>
                </c:pt>
                <c:pt idx="47">
                  <c:v>-8.7072239304926367</c:v>
                </c:pt>
                <c:pt idx="48">
                  <c:v>-8.7072239304926367</c:v>
                </c:pt>
                <c:pt idx="49">
                  <c:v>-8.7072239304926367</c:v>
                </c:pt>
                <c:pt idx="50">
                  <c:v>-8.7072239304926367</c:v>
                </c:pt>
                <c:pt idx="51">
                  <c:v>-8.7072239304926367</c:v>
                </c:pt>
                <c:pt idx="52">
                  <c:v>-8.7072239304926367</c:v>
                </c:pt>
                <c:pt idx="53">
                  <c:v>-8.7072239304926367</c:v>
                </c:pt>
                <c:pt idx="54">
                  <c:v>-8.7072239304926367</c:v>
                </c:pt>
                <c:pt idx="55">
                  <c:v>-8.7072239304926367</c:v>
                </c:pt>
                <c:pt idx="56">
                  <c:v>-8.7072239304926367</c:v>
                </c:pt>
                <c:pt idx="57">
                  <c:v>-8.7072239304926367</c:v>
                </c:pt>
                <c:pt idx="58">
                  <c:v>-8.7072239304926367</c:v>
                </c:pt>
                <c:pt idx="59">
                  <c:v>-8.7072239304926367</c:v>
                </c:pt>
                <c:pt idx="60">
                  <c:v>-8.7072239304926367</c:v>
                </c:pt>
                <c:pt idx="61">
                  <c:v>-8.7072239304926367</c:v>
                </c:pt>
                <c:pt idx="62">
                  <c:v>-8.7072239304926367</c:v>
                </c:pt>
                <c:pt idx="63">
                  <c:v>-8.7072239304926367</c:v>
                </c:pt>
                <c:pt idx="64">
                  <c:v>-8.7072239304926367</c:v>
                </c:pt>
                <c:pt idx="65">
                  <c:v>-8.7072239304926367</c:v>
                </c:pt>
                <c:pt idx="66">
                  <c:v>-8.7072239304926367</c:v>
                </c:pt>
                <c:pt idx="67">
                  <c:v>-8.7072239304926367</c:v>
                </c:pt>
                <c:pt idx="68">
                  <c:v>-8.7072239304926367</c:v>
                </c:pt>
                <c:pt idx="69">
                  <c:v>-8.7072239304926367</c:v>
                </c:pt>
                <c:pt idx="70">
                  <c:v>-8.7072239304926367</c:v>
                </c:pt>
                <c:pt idx="71">
                  <c:v>-8.7072239304926367</c:v>
                </c:pt>
                <c:pt idx="72">
                  <c:v>-8.7072239304926367</c:v>
                </c:pt>
                <c:pt idx="73">
                  <c:v>-8.7072239304926367</c:v>
                </c:pt>
                <c:pt idx="74">
                  <c:v>-8.7072239304926367</c:v>
                </c:pt>
                <c:pt idx="75">
                  <c:v>-8.7072239304926367</c:v>
                </c:pt>
                <c:pt idx="76">
                  <c:v>-8.7072239304926367</c:v>
                </c:pt>
                <c:pt idx="77">
                  <c:v>-8.7072239304926367</c:v>
                </c:pt>
                <c:pt idx="78">
                  <c:v>-8.7072239304926367</c:v>
                </c:pt>
                <c:pt idx="79">
                  <c:v>-8.7072239304926367</c:v>
                </c:pt>
                <c:pt idx="80">
                  <c:v>-8.7072239304926367</c:v>
                </c:pt>
                <c:pt idx="81">
                  <c:v>-8.7072239304926367</c:v>
                </c:pt>
                <c:pt idx="82">
                  <c:v>-8.7072239304926367</c:v>
                </c:pt>
                <c:pt idx="83">
                  <c:v>-8.7072239304926367</c:v>
                </c:pt>
                <c:pt idx="84">
                  <c:v>-8.7072239304926367</c:v>
                </c:pt>
                <c:pt idx="85">
                  <c:v>-8.7072239304926367</c:v>
                </c:pt>
                <c:pt idx="86">
                  <c:v>-8.7072239304926367</c:v>
                </c:pt>
                <c:pt idx="87">
                  <c:v>-8.7072239304926367</c:v>
                </c:pt>
                <c:pt idx="88">
                  <c:v>-8.7072239304926367</c:v>
                </c:pt>
                <c:pt idx="89">
                  <c:v>-8.7072239304926367</c:v>
                </c:pt>
                <c:pt idx="90">
                  <c:v>-8.7072239304926367</c:v>
                </c:pt>
                <c:pt idx="91">
                  <c:v>-8.7072239304926367</c:v>
                </c:pt>
                <c:pt idx="92">
                  <c:v>-8.7072239304926367</c:v>
                </c:pt>
                <c:pt idx="93">
                  <c:v>-8.7072239304926367</c:v>
                </c:pt>
                <c:pt idx="94">
                  <c:v>-8.7072239304926367</c:v>
                </c:pt>
                <c:pt idx="95">
                  <c:v>-8.7072239304926367</c:v>
                </c:pt>
                <c:pt idx="96">
                  <c:v>-8.7072239304926367</c:v>
                </c:pt>
                <c:pt idx="97">
                  <c:v>-8.7072239304926367</c:v>
                </c:pt>
                <c:pt idx="98">
                  <c:v>-8.7072239304926367</c:v>
                </c:pt>
                <c:pt idx="99">
                  <c:v>-8.7072239304926367</c:v>
                </c:pt>
                <c:pt idx="100">
                  <c:v>-8.7072239304926367</c:v>
                </c:pt>
                <c:pt idx="101">
                  <c:v>-8.7072239304926367</c:v>
                </c:pt>
                <c:pt idx="102">
                  <c:v>-8.7072239304926367</c:v>
                </c:pt>
                <c:pt idx="103">
                  <c:v>-8.7072239304926367</c:v>
                </c:pt>
                <c:pt idx="104">
                  <c:v>-8.7072239304926367</c:v>
                </c:pt>
                <c:pt idx="105">
                  <c:v>-8.7072239304926367</c:v>
                </c:pt>
                <c:pt idx="106">
                  <c:v>-8.7072239304926367</c:v>
                </c:pt>
                <c:pt idx="107">
                  <c:v>-8.7072239304926367</c:v>
                </c:pt>
                <c:pt idx="108">
                  <c:v>-8.7072239304926367</c:v>
                </c:pt>
                <c:pt idx="109">
                  <c:v>-8.7072239304926367</c:v>
                </c:pt>
                <c:pt idx="110">
                  <c:v>-8.7072239304926367</c:v>
                </c:pt>
                <c:pt idx="111">
                  <c:v>-8.7072239304926367</c:v>
                </c:pt>
                <c:pt idx="112">
                  <c:v>-8.7072239304926367</c:v>
                </c:pt>
                <c:pt idx="113">
                  <c:v>-8.7072239304926367</c:v>
                </c:pt>
                <c:pt idx="114">
                  <c:v>-8.7072239304926367</c:v>
                </c:pt>
                <c:pt idx="115">
                  <c:v>-8.7072239304926367</c:v>
                </c:pt>
                <c:pt idx="116">
                  <c:v>-8.7072239304926367</c:v>
                </c:pt>
                <c:pt idx="117">
                  <c:v>-8.7072239304926367</c:v>
                </c:pt>
                <c:pt idx="118">
                  <c:v>-8.7072239304926367</c:v>
                </c:pt>
                <c:pt idx="119">
                  <c:v>-8.7072239304926367</c:v>
                </c:pt>
                <c:pt idx="120">
                  <c:v>-8.7072239304926367</c:v>
                </c:pt>
                <c:pt idx="121">
                  <c:v>-8.7072239304926367</c:v>
                </c:pt>
                <c:pt idx="122">
                  <c:v>-8.7072239304926367</c:v>
                </c:pt>
                <c:pt idx="123">
                  <c:v>-8.7072239304926367</c:v>
                </c:pt>
                <c:pt idx="124">
                  <c:v>-8.7072239304926367</c:v>
                </c:pt>
                <c:pt idx="125">
                  <c:v>-8.7072239304926367</c:v>
                </c:pt>
                <c:pt idx="126">
                  <c:v>-8.7072239304926367</c:v>
                </c:pt>
                <c:pt idx="127">
                  <c:v>-8.7072239304926367</c:v>
                </c:pt>
                <c:pt idx="128">
                  <c:v>-8.7072239304926367</c:v>
                </c:pt>
                <c:pt idx="129">
                  <c:v>-8.707223930492636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9-8587-C84D-80E3-823DB5ECD6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20600495"/>
        <c:axId val="1120599535"/>
      </c:scatterChart>
      <c:valAx>
        <c:axId val="1120600495"/>
        <c:scaling>
          <c:orientation val="minMax"/>
          <c:max val="130"/>
          <c:min val="0"/>
        </c:scaling>
        <c:delete val="0"/>
        <c:axPos val="b"/>
        <c:numFmt formatCode="0" sourceLinked="0"/>
        <c:majorTickMark val="out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20599535"/>
        <c:crosses val="autoZero"/>
        <c:crossBetween val="midCat"/>
        <c:majorUnit val="65"/>
      </c:valAx>
      <c:valAx>
        <c:axId val="1120599535"/>
        <c:scaling>
          <c:orientation val="minMax"/>
          <c:max val="-6"/>
          <c:min val="-9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20600495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Sheet2!$G$3</c:f>
              <c:strCache>
                <c:ptCount val="1"/>
                <c:pt idx="0">
                  <c:v>Result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2!$F$4:$F$133</c:f>
              <c:numCache>
                <c:formatCode>0.00</c:formatCode>
                <c:ptCount val="13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</c:numCache>
            </c:numRef>
          </c:xVal>
          <c:yVal>
            <c:numRef>
              <c:f>Sheet2!$G$4:$G$133</c:f>
              <c:numCache>
                <c:formatCode>General</c:formatCode>
                <c:ptCount val="130"/>
                <c:pt idx="0">
                  <c:v>7.2107999999999999</c:v>
                </c:pt>
                <c:pt idx="1">
                  <c:v>7.1458000000000004</c:v>
                </c:pt>
                <c:pt idx="2">
                  <c:v>7.2350000000000003</c:v>
                </c:pt>
                <c:pt idx="3">
                  <c:v>7.8189000000000002</c:v>
                </c:pt>
                <c:pt idx="4">
                  <c:v>7.9553000000000003</c:v>
                </c:pt>
                <c:pt idx="5">
                  <c:v>7.4912999999999998</c:v>
                </c:pt>
                <c:pt idx="6">
                  <c:v>7.1851000000000003</c:v>
                </c:pt>
                <c:pt idx="7">
                  <c:v>7.0197000000000003</c:v>
                </c:pt>
                <c:pt idx="8">
                  <c:v>7.2191000000000001</c:v>
                </c:pt>
                <c:pt idx="9">
                  <c:v>7.9541000000000004</c:v>
                </c:pt>
                <c:pt idx="10">
                  <c:v>7.8930999999999996</c:v>
                </c:pt>
                <c:pt idx="11">
                  <c:v>7.1702000000000004</c:v>
                </c:pt>
                <c:pt idx="12">
                  <c:v>7.9439000000000002</c:v>
                </c:pt>
                <c:pt idx="13">
                  <c:v>7.4974999999999996</c:v>
                </c:pt>
                <c:pt idx="14">
                  <c:v>7.5608000000000004</c:v>
                </c:pt>
                <c:pt idx="15">
                  <c:v>7.2481999999999998</c:v>
                </c:pt>
                <c:pt idx="16">
                  <c:v>7.8704999999999998</c:v>
                </c:pt>
                <c:pt idx="17">
                  <c:v>7.5974000000000004</c:v>
                </c:pt>
                <c:pt idx="18">
                  <c:v>7.6608999999999998</c:v>
                </c:pt>
                <c:pt idx="19">
                  <c:v>7.3433999999999999</c:v>
                </c:pt>
                <c:pt idx="20">
                  <c:v>7.2693000000000003</c:v>
                </c:pt>
                <c:pt idx="21">
                  <c:v>7.7737999999999996</c:v>
                </c:pt>
                <c:pt idx="22">
                  <c:v>7.0682</c:v>
                </c:pt>
                <c:pt idx="23">
                  <c:v>7.7328999999999999</c:v>
                </c:pt>
                <c:pt idx="24">
                  <c:v>7.4928999999999997</c:v>
                </c:pt>
                <c:pt idx="25">
                  <c:v>7.0414000000000003</c:v>
                </c:pt>
                <c:pt idx="26">
                  <c:v>7.9905999999999997</c:v>
                </c:pt>
                <c:pt idx="27">
                  <c:v>7.4797000000000002</c:v>
                </c:pt>
                <c:pt idx="28">
                  <c:v>7.6824000000000003</c:v>
                </c:pt>
                <c:pt idx="29">
                  <c:v>7.0335000000000001</c:v>
                </c:pt>
                <c:pt idx="30">
                  <c:v>7.2335000000000003</c:v>
                </c:pt>
                <c:pt idx="31">
                  <c:v>7.2713999999999999</c:v>
                </c:pt>
                <c:pt idx="32">
                  <c:v>7.2359999999999998</c:v>
                </c:pt>
                <c:pt idx="33">
                  <c:v>7.8141999999999996</c:v>
                </c:pt>
                <c:pt idx="34">
                  <c:v>7.9836</c:v>
                </c:pt>
                <c:pt idx="35">
                  <c:v>7.0381</c:v>
                </c:pt>
                <c:pt idx="36">
                  <c:v>7.6398999999999999</c:v>
                </c:pt>
                <c:pt idx="37">
                  <c:v>7.4696999999999996</c:v>
                </c:pt>
                <c:pt idx="38">
                  <c:v>7.1871</c:v>
                </c:pt>
                <c:pt idx="39">
                  <c:v>7.0041000000000002</c:v>
                </c:pt>
                <c:pt idx="40">
                  <c:v>7.2587999999999999</c:v>
                </c:pt>
                <c:pt idx="41">
                  <c:v>7.7023000000000001</c:v>
                </c:pt>
                <c:pt idx="42">
                  <c:v>7.4538000000000002</c:v>
                </c:pt>
                <c:pt idx="43">
                  <c:v>7.819</c:v>
                </c:pt>
                <c:pt idx="44">
                  <c:v>7.6273</c:v>
                </c:pt>
                <c:pt idx="45">
                  <c:v>7.0068999999999999</c:v>
                </c:pt>
                <c:pt idx="46">
                  <c:v>7.4501999999999997</c:v>
                </c:pt>
                <c:pt idx="47">
                  <c:v>7.1593</c:v>
                </c:pt>
                <c:pt idx="48">
                  <c:v>7.6306000000000003</c:v>
                </c:pt>
                <c:pt idx="49">
                  <c:v>7.6387999999999998</c:v>
                </c:pt>
                <c:pt idx="50">
                  <c:v>7.7828999999999997</c:v>
                </c:pt>
                <c:pt idx="51">
                  <c:v>7.9173</c:v>
                </c:pt>
                <c:pt idx="52">
                  <c:v>7.2043999999999997</c:v>
                </c:pt>
                <c:pt idx="53">
                  <c:v>7.2252999999999998</c:v>
                </c:pt>
                <c:pt idx="54">
                  <c:v>7.1351000000000004</c:v>
                </c:pt>
                <c:pt idx="55">
                  <c:v>7.1234999999999999</c:v>
                </c:pt>
                <c:pt idx="56">
                  <c:v>7.3318000000000003</c:v>
                </c:pt>
                <c:pt idx="57">
                  <c:v>7.8662000000000001</c:v>
                </c:pt>
                <c:pt idx="58">
                  <c:v>7.3659999999999997</c:v>
                </c:pt>
                <c:pt idx="59">
                  <c:v>7.8887999999999998</c:v>
                </c:pt>
                <c:pt idx="60">
                  <c:v>7.5598000000000001</c:v>
                </c:pt>
                <c:pt idx="61">
                  <c:v>7.5578000000000003</c:v>
                </c:pt>
                <c:pt idx="62">
                  <c:v>7.7724000000000002</c:v>
                </c:pt>
                <c:pt idx="63">
                  <c:v>7.1685999999999996</c:v>
                </c:pt>
                <c:pt idx="64">
                  <c:v>7.8966000000000003</c:v>
                </c:pt>
                <c:pt idx="65">
                  <c:v>7.2731000000000003</c:v>
                </c:pt>
                <c:pt idx="66">
                  <c:v>7.1666999999999996</c:v>
                </c:pt>
                <c:pt idx="67">
                  <c:v>7.1483999999999996</c:v>
                </c:pt>
                <c:pt idx="68">
                  <c:v>7.4066000000000001</c:v>
                </c:pt>
                <c:pt idx="69">
                  <c:v>7.6055999999999999</c:v>
                </c:pt>
                <c:pt idx="70">
                  <c:v>7.6234999999999999</c:v>
                </c:pt>
                <c:pt idx="71">
                  <c:v>7.9722</c:v>
                </c:pt>
                <c:pt idx="72">
                  <c:v>7.8845999999999998</c:v>
                </c:pt>
                <c:pt idx="73">
                  <c:v>7.5957999999999997</c:v>
                </c:pt>
                <c:pt idx="74">
                  <c:v>7.9528999999999996</c:v>
                </c:pt>
                <c:pt idx="75">
                  <c:v>7.3018000000000001</c:v>
                </c:pt>
                <c:pt idx="76">
                  <c:v>7.5693999999999999</c:v>
                </c:pt>
                <c:pt idx="77">
                  <c:v>7.7804000000000002</c:v>
                </c:pt>
                <c:pt idx="78">
                  <c:v>7.4462999999999999</c:v>
                </c:pt>
                <c:pt idx="79">
                  <c:v>7.9165000000000001</c:v>
                </c:pt>
                <c:pt idx="80">
                  <c:v>7.2537000000000003</c:v>
                </c:pt>
                <c:pt idx="81">
                  <c:v>7.1193999999999997</c:v>
                </c:pt>
                <c:pt idx="82">
                  <c:v>7.8548</c:v>
                </c:pt>
                <c:pt idx="83">
                  <c:v>7.3639999999999999</c:v>
                </c:pt>
                <c:pt idx="84">
                  <c:v>7.3276000000000003</c:v>
                </c:pt>
                <c:pt idx="85">
                  <c:v>7.3494999999999999</c:v>
                </c:pt>
                <c:pt idx="86">
                  <c:v>7.6660000000000004</c:v>
                </c:pt>
                <c:pt idx="87">
                  <c:v>7.0187999999999997</c:v>
                </c:pt>
                <c:pt idx="88">
                  <c:v>7.1570999999999998</c:v>
                </c:pt>
                <c:pt idx="89">
                  <c:v>7.0815999999999999</c:v>
                </c:pt>
                <c:pt idx="90">
                  <c:v>7.5468999999999999</c:v>
                </c:pt>
                <c:pt idx="91">
                  <c:v>7.7159000000000004</c:v>
                </c:pt>
                <c:pt idx="92">
                  <c:v>7.3667999999999996</c:v>
                </c:pt>
                <c:pt idx="93">
                  <c:v>7.7011000000000003</c:v>
                </c:pt>
                <c:pt idx="94">
                  <c:v>7.944</c:v>
                </c:pt>
                <c:pt idx="95">
                  <c:v>7.9318</c:v>
                </c:pt>
                <c:pt idx="96">
                  <c:v>7.4501999999999997</c:v>
                </c:pt>
                <c:pt idx="97">
                  <c:v>7.7187000000000001</c:v>
                </c:pt>
                <c:pt idx="98">
                  <c:v>7.8951000000000002</c:v>
                </c:pt>
                <c:pt idx="99">
                  <c:v>7.0430000000000001</c:v>
                </c:pt>
                <c:pt idx="100">
                  <c:v>7.1910999999999996</c:v>
                </c:pt>
                <c:pt idx="101">
                  <c:v>7.8066000000000004</c:v>
                </c:pt>
                <c:pt idx="102">
                  <c:v>7.8177000000000003</c:v>
                </c:pt>
                <c:pt idx="103">
                  <c:v>7.7827999999999999</c:v>
                </c:pt>
                <c:pt idx="104">
                  <c:v>7.1840000000000002</c:v>
                </c:pt>
                <c:pt idx="105">
                  <c:v>7.9535</c:v>
                </c:pt>
                <c:pt idx="106">
                  <c:v>7.7760999999999996</c:v>
                </c:pt>
                <c:pt idx="107">
                  <c:v>7.0448000000000004</c:v>
                </c:pt>
                <c:pt idx="108">
                  <c:v>7.3989000000000003</c:v>
                </c:pt>
                <c:pt idx="109">
                  <c:v>7.5846999999999998</c:v>
                </c:pt>
                <c:pt idx="110">
                  <c:v>7.4957000000000003</c:v>
                </c:pt>
                <c:pt idx="111">
                  <c:v>7.4409000000000001</c:v>
                </c:pt>
                <c:pt idx="112">
                  <c:v>7.0469999999999997</c:v>
                </c:pt>
                <c:pt idx="113">
                  <c:v>7.6662999999999997</c:v>
                </c:pt>
                <c:pt idx="114">
                  <c:v>7.5316999999999998</c:v>
                </c:pt>
                <c:pt idx="115">
                  <c:v>7.7766000000000002</c:v>
                </c:pt>
                <c:pt idx="116">
                  <c:v>7.7251000000000003</c:v>
                </c:pt>
                <c:pt idx="117">
                  <c:v>7.9641000000000002</c:v>
                </c:pt>
                <c:pt idx="118">
                  <c:v>7.1984000000000004</c:v>
                </c:pt>
                <c:pt idx="119">
                  <c:v>7.0646000000000004</c:v>
                </c:pt>
                <c:pt idx="120">
                  <c:v>7.2542</c:v>
                </c:pt>
                <c:pt idx="121">
                  <c:v>7.1025999999999998</c:v>
                </c:pt>
                <c:pt idx="122">
                  <c:v>7.9969000000000001</c:v>
                </c:pt>
                <c:pt idx="123">
                  <c:v>7.7043999999999997</c:v>
                </c:pt>
                <c:pt idx="124">
                  <c:v>7.1319999999999997</c:v>
                </c:pt>
                <c:pt idx="125">
                  <c:v>7.5281000000000002</c:v>
                </c:pt>
                <c:pt idx="126">
                  <c:v>7.1970000000000001</c:v>
                </c:pt>
                <c:pt idx="127">
                  <c:v>7.4352</c:v>
                </c:pt>
                <c:pt idx="128">
                  <c:v>7.6374000000000004</c:v>
                </c:pt>
                <c:pt idx="129">
                  <c:v>7.301700000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5035-4141-A122-8241DEEBFBF8}"/>
            </c:ext>
          </c:extLst>
        </c:ser>
        <c:ser>
          <c:idx val="1"/>
          <c:order val="1"/>
          <c:tx>
            <c:strRef>
              <c:f>Sheet2!$H$3</c:f>
              <c:strCache>
                <c:ptCount val="1"/>
                <c:pt idx="0">
                  <c:v>(+4SD)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2!$F$4:$F$133</c:f>
              <c:numCache>
                <c:formatCode>0.00</c:formatCode>
                <c:ptCount val="13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</c:numCache>
            </c:numRef>
          </c:xVal>
          <c:yVal>
            <c:numRef>
              <c:f>Sheet2!$H$4:$H$133</c:f>
              <c:numCache>
                <c:formatCode>General</c:formatCode>
                <c:ptCount val="130"/>
                <c:pt idx="0">
                  <c:v>8.7003718849349188</c:v>
                </c:pt>
                <c:pt idx="1">
                  <c:v>8.7003718849349188</c:v>
                </c:pt>
                <c:pt idx="2">
                  <c:v>8.7003718849349188</c:v>
                </c:pt>
                <c:pt idx="3">
                  <c:v>8.7003718849349188</c:v>
                </c:pt>
                <c:pt idx="4">
                  <c:v>8.7003718849349188</c:v>
                </c:pt>
                <c:pt idx="5">
                  <c:v>8.7003718849349188</c:v>
                </c:pt>
                <c:pt idx="6">
                  <c:v>8.7003718849349188</c:v>
                </c:pt>
                <c:pt idx="7">
                  <c:v>8.7003718849349188</c:v>
                </c:pt>
                <c:pt idx="8">
                  <c:v>8.7003718849349188</c:v>
                </c:pt>
                <c:pt idx="9">
                  <c:v>8.7003718849349188</c:v>
                </c:pt>
                <c:pt idx="10">
                  <c:v>8.7003718849349188</c:v>
                </c:pt>
                <c:pt idx="11">
                  <c:v>8.7003718849349188</c:v>
                </c:pt>
                <c:pt idx="12">
                  <c:v>8.7003718849349188</c:v>
                </c:pt>
                <c:pt idx="13">
                  <c:v>8.7003718849349188</c:v>
                </c:pt>
                <c:pt idx="14">
                  <c:v>8.7003718849349188</c:v>
                </c:pt>
                <c:pt idx="15">
                  <c:v>8.7003718849349188</c:v>
                </c:pt>
                <c:pt idx="16">
                  <c:v>8.7003718849349188</c:v>
                </c:pt>
                <c:pt idx="17">
                  <c:v>8.7003718849349188</c:v>
                </c:pt>
                <c:pt idx="18">
                  <c:v>8.7003718849349188</c:v>
                </c:pt>
                <c:pt idx="19">
                  <c:v>8.7003718849349188</c:v>
                </c:pt>
                <c:pt idx="20">
                  <c:v>8.7003718849349205</c:v>
                </c:pt>
                <c:pt idx="21">
                  <c:v>8.7003718849349205</c:v>
                </c:pt>
                <c:pt idx="22">
                  <c:v>8.7003718849349205</c:v>
                </c:pt>
                <c:pt idx="23">
                  <c:v>8.7003718849349205</c:v>
                </c:pt>
                <c:pt idx="24">
                  <c:v>8.7003718849349205</c:v>
                </c:pt>
                <c:pt idx="25">
                  <c:v>8.7003718849349205</c:v>
                </c:pt>
                <c:pt idx="26">
                  <c:v>8.7003718849349205</c:v>
                </c:pt>
                <c:pt idx="27">
                  <c:v>8.7003718849349205</c:v>
                </c:pt>
                <c:pt idx="28">
                  <c:v>8.7003718849349205</c:v>
                </c:pt>
                <c:pt idx="29">
                  <c:v>8.7003718849349205</c:v>
                </c:pt>
                <c:pt idx="30">
                  <c:v>8.7003718849349205</c:v>
                </c:pt>
                <c:pt idx="31">
                  <c:v>8.7003718849349205</c:v>
                </c:pt>
                <c:pt idx="32">
                  <c:v>8.7003718849349205</c:v>
                </c:pt>
                <c:pt idx="33">
                  <c:v>8.7003718849349205</c:v>
                </c:pt>
                <c:pt idx="34">
                  <c:v>8.7003718849349205</c:v>
                </c:pt>
                <c:pt idx="35">
                  <c:v>8.7003718849349205</c:v>
                </c:pt>
                <c:pt idx="36">
                  <c:v>8.7003718849349205</c:v>
                </c:pt>
                <c:pt idx="37">
                  <c:v>8.7003718849349205</c:v>
                </c:pt>
                <c:pt idx="38">
                  <c:v>8.7003718849349205</c:v>
                </c:pt>
                <c:pt idx="39">
                  <c:v>8.7003718849349205</c:v>
                </c:pt>
                <c:pt idx="40">
                  <c:v>8.7003718849349205</c:v>
                </c:pt>
                <c:pt idx="41">
                  <c:v>8.7003718849349205</c:v>
                </c:pt>
                <c:pt idx="42">
                  <c:v>8.7003718849349205</c:v>
                </c:pt>
                <c:pt idx="43">
                  <c:v>8.7003718849349205</c:v>
                </c:pt>
                <c:pt idx="44">
                  <c:v>8.7003718849349205</c:v>
                </c:pt>
                <c:pt idx="45">
                  <c:v>8.7003718849349205</c:v>
                </c:pt>
                <c:pt idx="46">
                  <c:v>8.7003718849349205</c:v>
                </c:pt>
                <c:pt idx="47">
                  <c:v>8.7003718849349205</c:v>
                </c:pt>
                <c:pt idx="48">
                  <c:v>8.7003718849349205</c:v>
                </c:pt>
                <c:pt idx="49">
                  <c:v>8.7003718849349205</c:v>
                </c:pt>
                <c:pt idx="50">
                  <c:v>8.7003718849349205</c:v>
                </c:pt>
                <c:pt idx="51">
                  <c:v>8.7003718849349205</c:v>
                </c:pt>
                <c:pt idx="52">
                  <c:v>8.7003718849349205</c:v>
                </c:pt>
                <c:pt idx="53">
                  <c:v>8.7003718849349205</c:v>
                </c:pt>
                <c:pt idx="54">
                  <c:v>8.7003718849349205</c:v>
                </c:pt>
                <c:pt idx="55">
                  <c:v>8.7003718849349205</c:v>
                </c:pt>
                <c:pt idx="56">
                  <c:v>8.7003718849349205</c:v>
                </c:pt>
                <c:pt idx="57">
                  <c:v>8.7003718849349205</c:v>
                </c:pt>
                <c:pt idx="58">
                  <c:v>8.7003718849349205</c:v>
                </c:pt>
                <c:pt idx="59">
                  <c:v>8.7003718849349205</c:v>
                </c:pt>
                <c:pt idx="60">
                  <c:v>8.7003718849349205</c:v>
                </c:pt>
                <c:pt idx="61">
                  <c:v>8.7003718849349205</c:v>
                </c:pt>
                <c:pt idx="62">
                  <c:v>8.7003718849349205</c:v>
                </c:pt>
                <c:pt idx="63">
                  <c:v>8.7003718849349205</c:v>
                </c:pt>
                <c:pt idx="64">
                  <c:v>8.7003718849349205</c:v>
                </c:pt>
                <c:pt idx="65">
                  <c:v>8.7003718849349205</c:v>
                </c:pt>
                <c:pt idx="66">
                  <c:v>8.7003718849349205</c:v>
                </c:pt>
                <c:pt idx="67">
                  <c:v>8.7003718849349205</c:v>
                </c:pt>
                <c:pt idx="68">
                  <c:v>8.7003718849349205</c:v>
                </c:pt>
                <c:pt idx="69">
                  <c:v>8.7003718849349205</c:v>
                </c:pt>
                <c:pt idx="70">
                  <c:v>8.7003718849349205</c:v>
                </c:pt>
                <c:pt idx="71">
                  <c:v>8.7003718849349205</c:v>
                </c:pt>
                <c:pt idx="72">
                  <c:v>8.7003718849349205</c:v>
                </c:pt>
                <c:pt idx="73">
                  <c:v>8.7003718849349205</c:v>
                </c:pt>
                <c:pt idx="74">
                  <c:v>8.7003718849349205</c:v>
                </c:pt>
                <c:pt idx="75">
                  <c:v>8.7003718849349205</c:v>
                </c:pt>
                <c:pt idx="76">
                  <c:v>8.7003718849349205</c:v>
                </c:pt>
                <c:pt idx="77">
                  <c:v>8.7003718849349205</c:v>
                </c:pt>
                <c:pt idx="78">
                  <c:v>8.7003718849349205</c:v>
                </c:pt>
                <c:pt idx="79">
                  <c:v>8.7003718849349205</c:v>
                </c:pt>
                <c:pt idx="80">
                  <c:v>8.7003718849349205</c:v>
                </c:pt>
                <c:pt idx="81">
                  <c:v>8.7003718849349205</c:v>
                </c:pt>
                <c:pt idx="82">
                  <c:v>8.7003718849349205</c:v>
                </c:pt>
                <c:pt idx="83">
                  <c:v>8.7003718849349205</c:v>
                </c:pt>
                <c:pt idx="84">
                  <c:v>8.7003718849349205</c:v>
                </c:pt>
                <c:pt idx="85">
                  <c:v>8.7003718849349205</c:v>
                </c:pt>
                <c:pt idx="86">
                  <c:v>8.7003718849349205</c:v>
                </c:pt>
                <c:pt idx="87">
                  <c:v>8.7003718849349205</c:v>
                </c:pt>
                <c:pt idx="88">
                  <c:v>8.7003718849349205</c:v>
                </c:pt>
                <c:pt idx="89">
                  <c:v>8.7003718849349205</c:v>
                </c:pt>
                <c:pt idx="90">
                  <c:v>8.7003718849349205</c:v>
                </c:pt>
                <c:pt idx="91">
                  <c:v>8.7003718849349205</c:v>
                </c:pt>
                <c:pt idx="92">
                  <c:v>8.7003718849349205</c:v>
                </c:pt>
                <c:pt idx="93">
                  <c:v>8.7003718849349205</c:v>
                </c:pt>
                <c:pt idx="94">
                  <c:v>8.7003718849349205</c:v>
                </c:pt>
                <c:pt idx="95">
                  <c:v>8.7003718849349205</c:v>
                </c:pt>
                <c:pt idx="96">
                  <c:v>8.7003718849349205</c:v>
                </c:pt>
                <c:pt idx="97">
                  <c:v>8.7003718849349205</c:v>
                </c:pt>
                <c:pt idx="98">
                  <c:v>8.7003718849349205</c:v>
                </c:pt>
                <c:pt idx="99">
                  <c:v>8.7003718849349205</c:v>
                </c:pt>
                <c:pt idx="100">
                  <c:v>8.7003718849349205</c:v>
                </c:pt>
                <c:pt idx="101">
                  <c:v>8.7003718849349205</c:v>
                </c:pt>
                <c:pt idx="102">
                  <c:v>8.7003718849349205</c:v>
                </c:pt>
                <c:pt idx="103">
                  <c:v>8.7003718849349205</c:v>
                </c:pt>
                <c:pt idx="104">
                  <c:v>8.7003718849349205</c:v>
                </c:pt>
                <c:pt idx="105">
                  <c:v>8.7003718849349205</c:v>
                </c:pt>
                <c:pt idx="106">
                  <c:v>8.7003718849349205</c:v>
                </c:pt>
                <c:pt idx="107">
                  <c:v>8.7003718849349205</c:v>
                </c:pt>
                <c:pt idx="108">
                  <c:v>8.7003718849349205</c:v>
                </c:pt>
                <c:pt idx="109">
                  <c:v>8.7003718849349205</c:v>
                </c:pt>
                <c:pt idx="110">
                  <c:v>8.7003718849349205</c:v>
                </c:pt>
                <c:pt idx="111">
                  <c:v>8.7003718849349205</c:v>
                </c:pt>
                <c:pt idx="112">
                  <c:v>8.7003718849349205</c:v>
                </c:pt>
                <c:pt idx="113">
                  <c:v>8.7003718849349205</c:v>
                </c:pt>
                <c:pt idx="114">
                  <c:v>8.7003718849349205</c:v>
                </c:pt>
                <c:pt idx="115">
                  <c:v>8.7003718849349205</c:v>
                </c:pt>
                <c:pt idx="116">
                  <c:v>8.7003718849349205</c:v>
                </c:pt>
                <c:pt idx="117">
                  <c:v>8.7003718849349205</c:v>
                </c:pt>
                <c:pt idx="118">
                  <c:v>8.7003718849349205</c:v>
                </c:pt>
                <c:pt idx="119">
                  <c:v>8.7003718849349205</c:v>
                </c:pt>
                <c:pt idx="120">
                  <c:v>8.7003718849349205</c:v>
                </c:pt>
                <c:pt idx="121">
                  <c:v>8.7003718849349205</c:v>
                </c:pt>
                <c:pt idx="122">
                  <c:v>8.7003718849349205</c:v>
                </c:pt>
                <c:pt idx="123">
                  <c:v>8.7003718849349205</c:v>
                </c:pt>
                <c:pt idx="124">
                  <c:v>8.7003718849349205</c:v>
                </c:pt>
                <c:pt idx="125">
                  <c:v>8.7003718849349205</c:v>
                </c:pt>
                <c:pt idx="126">
                  <c:v>8.7003718849349205</c:v>
                </c:pt>
                <c:pt idx="127">
                  <c:v>8.7003718849349205</c:v>
                </c:pt>
                <c:pt idx="128">
                  <c:v>8.7003718849349205</c:v>
                </c:pt>
                <c:pt idx="129">
                  <c:v>8.70037188493492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5035-4141-A122-8241DEEBFBF8}"/>
            </c:ext>
          </c:extLst>
        </c:ser>
        <c:ser>
          <c:idx val="2"/>
          <c:order val="2"/>
          <c:tx>
            <c:strRef>
              <c:f>Sheet2!$I$3</c:f>
              <c:strCache>
                <c:ptCount val="1"/>
                <c:pt idx="0">
                  <c:v>(+3SD)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Sheet2!$F$4:$F$133</c:f>
              <c:numCache>
                <c:formatCode>0.00</c:formatCode>
                <c:ptCount val="13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</c:numCache>
            </c:numRef>
          </c:xVal>
          <c:yVal>
            <c:numRef>
              <c:f>Sheet2!$I$4:$I$133</c:f>
              <c:numCache>
                <c:formatCode>General</c:formatCode>
                <c:ptCount val="130"/>
                <c:pt idx="0">
                  <c:v>8.398157182931957</c:v>
                </c:pt>
                <c:pt idx="1">
                  <c:v>8.398157182931957</c:v>
                </c:pt>
                <c:pt idx="2">
                  <c:v>8.398157182931957</c:v>
                </c:pt>
                <c:pt idx="3">
                  <c:v>8.398157182931957</c:v>
                </c:pt>
                <c:pt idx="4">
                  <c:v>8.398157182931957</c:v>
                </c:pt>
                <c:pt idx="5">
                  <c:v>8.398157182931957</c:v>
                </c:pt>
                <c:pt idx="6">
                  <c:v>8.398157182931957</c:v>
                </c:pt>
                <c:pt idx="7">
                  <c:v>8.398157182931957</c:v>
                </c:pt>
                <c:pt idx="8">
                  <c:v>8.398157182931957</c:v>
                </c:pt>
                <c:pt idx="9">
                  <c:v>8.398157182931957</c:v>
                </c:pt>
                <c:pt idx="10">
                  <c:v>8.398157182931957</c:v>
                </c:pt>
                <c:pt idx="11">
                  <c:v>8.398157182931957</c:v>
                </c:pt>
                <c:pt idx="12">
                  <c:v>8.398157182931957</c:v>
                </c:pt>
                <c:pt idx="13">
                  <c:v>8.398157182931957</c:v>
                </c:pt>
                <c:pt idx="14">
                  <c:v>8.398157182931957</c:v>
                </c:pt>
                <c:pt idx="15">
                  <c:v>8.398157182931957</c:v>
                </c:pt>
                <c:pt idx="16">
                  <c:v>8.398157182931957</c:v>
                </c:pt>
                <c:pt idx="17">
                  <c:v>8.398157182931957</c:v>
                </c:pt>
                <c:pt idx="18">
                  <c:v>8.398157182931957</c:v>
                </c:pt>
                <c:pt idx="19">
                  <c:v>8.398157182931957</c:v>
                </c:pt>
                <c:pt idx="20">
                  <c:v>8.398157182931957</c:v>
                </c:pt>
                <c:pt idx="21">
                  <c:v>8.398157182931957</c:v>
                </c:pt>
                <c:pt idx="22">
                  <c:v>8.398157182931957</c:v>
                </c:pt>
                <c:pt idx="23">
                  <c:v>8.398157182931957</c:v>
                </c:pt>
                <c:pt idx="24">
                  <c:v>8.398157182931957</c:v>
                </c:pt>
                <c:pt idx="25">
                  <c:v>8.398157182931957</c:v>
                </c:pt>
                <c:pt idx="26">
                  <c:v>8.398157182931957</c:v>
                </c:pt>
                <c:pt idx="27">
                  <c:v>8.398157182931957</c:v>
                </c:pt>
                <c:pt idx="28">
                  <c:v>8.398157182931957</c:v>
                </c:pt>
                <c:pt idx="29">
                  <c:v>8.398157182931957</c:v>
                </c:pt>
                <c:pt idx="30">
                  <c:v>8.398157182931957</c:v>
                </c:pt>
                <c:pt idx="31">
                  <c:v>8.398157182931957</c:v>
                </c:pt>
                <c:pt idx="32">
                  <c:v>8.398157182931957</c:v>
                </c:pt>
                <c:pt idx="33">
                  <c:v>8.398157182931957</c:v>
                </c:pt>
                <c:pt idx="34">
                  <c:v>8.398157182931957</c:v>
                </c:pt>
                <c:pt idx="35">
                  <c:v>8.398157182931957</c:v>
                </c:pt>
                <c:pt idx="36">
                  <c:v>8.398157182931957</c:v>
                </c:pt>
                <c:pt idx="37">
                  <c:v>8.398157182931957</c:v>
                </c:pt>
                <c:pt idx="38">
                  <c:v>8.398157182931957</c:v>
                </c:pt>
                <c:pt idx="39">
                  <c:v>8.398157182931957</c:v>
                </c:pt>
                <c:pt idx="40">
                  <c:v>8.398157182931957</c:v>
                </c:pt>
                <c:pt idx="41">
                  <c:v>8.398157182931957</c:v>
                </c:pt>
                <c:pt idx="42">
                  <c:v>8.398157182931957</c:v>
                </c:pt>
                <c:pt idx="43">
                  <c:v>8.398157182931957</c:v>
                </c:pt>
                <c:pt idx="44">
                  <c:v>8.398157182931957</c:v>
                </c:pt>
                <c:pt idx="45">
                  <c:v>8.398157182931957</c:v>
                </c:pt>
                <c:pt idx="46">
                  <c:v>8.398157182931957</c:v>
                </c:pt>
                <c:pt idx="47">
                  <c:v>8.398157182931957</c:v>
                </c:pt>
                <c:pt idx="48">
                  <c:v>8.398157182931957</c:v>
                </c:pt>
                <c:pt idx="49">
                  <c:v>8.398157182931957</c:v>
                </c:pt>
                <c:pt idx="50">
                  <c:v>8.398157182931957</c:v>
                </c:pt>
                <c:pt idx="51">
                  <c:v>8.398157182931957</c:v>
                </c:pt>
                <c:pt idx="52">
                  <c:v>8.398157182931957</c:v>
                </c:pt>
                <c:pt idx="53">
                  <c:v>8.398157182931957</c:v>
                </c:pt>
                <c:pt idx="54">
                  <c:v>8.398157182931957</c:v>
                </c:pt>
                <c:pt idx="55">
                  <c:v>8.398157182931957</c:v>
                </c:pt>
                <c:pt idx="56">
                  <c:v>8.398157182931957</c:v>
                </c:pt>
                <c:pt idx="57">
                  <c:v>8.398157182931957</c:v>
                </c:pt>
                <c:pt idx="58">
                  <c:v>8.398157182931957</c:v>
                </c:pt>
                <c:pt idx="59">
                  <c:v>8.398157182931957</c:v>
                </c:pt>
                <c:pt idx="60">
                  <c:v>8.398157182931957</c:v>
                </c:pt>
                <c:pt idx="61">
                  <c:v>8.398157182931957</c:v>
                </c:pt>
                <c:pt idx="62">
                  <c:v>8.398157182931957</c:v>
                </c:pt>
                <c:pt idx="63">
                  <c:v>8.398157182931957</c:v>
                </c:pt>
                <c:pt idx="64">
                  <c:v>8.398157182931957</c:v>
                </c:pt>
                <c:pt idx="65">
                  <c:v>8.398157182931957</c:v>
                </c:pt>
                <c:pt idx="66">
                  <c:v>8.398157182931957</c:v>
                </c:pt>
                <c:pt idx="67">
                  <c:v>8.398157182931957</c:v>
                </c:pt>
                <c:pt idx="68">
                  <c:v>8.398157182931957</c:v>
                </c:pt>
                <c:pt idx="69">
                  <c:v>8.398157182931957</c:v>
                </c:pt>
                <c:pt idx="70">
                  <c:v>8.398157182931957</c:v>
                </c:pt>
                <c:pt idx="71">
                  <c:v>8.398157182931957</c:v>
                </c:pt>
                <c:pt idx="72">
                  <c:v>8.398157182931957</c:v>
                </c:pt>
                <c:pt idx="73">
                  <c:v>8.398157182931957</c:v>
                </c:pt>
                <c:pt idx="74">
                  <c:v>8.398157182931957</c:v>
                </c:pt>
                <c:pt idx="75">
                  <c:v>8.398157182931957</c:v>
                </c:pt>
                <c:pt idx="76">
                  <c:v>8.398157182931957</c:v>
                </c:pt>
                <c:pt idx="77">
                  <c:v>8.398157182931957</c:v>
                </c:pt>
                <c:pt idx="78">
                  <c:v>8.398157182931957</c:v>
                </c:pt>
                <c:pt idx="79">
                  <c:v>8.398157182931957</c:v>
                </c:pt>
                <c:pt idx="80">
                  <c:v>8.398157182931957</c:v>
                </c:pt>
                <c:pt idx="81">
                  <c:v>8.398157182931957</c:v>
                </c:pt>
                <c:pt idx="82">
                  <c:v>8.398157182931957</c:v>
                </c:pt>
                <c:pt idx="83">
                  <c:v>8.398157182931957</c:v>
                </c:pt>
                <c:pt idx="84">
                  <c:v>8.398157182931957</c:v>
                </c:pt>
                <c:pt idx="85">
                  <c:v>8.398157182931957</c:v>
                </c:pt>
                <c:pt idx="86">
                  <c:v>8.398157182931957</c:v>
                </c:pt>
                <c:pt idx="87">
                  <c:v>8.398157182931957</c:v>
                </c:pt>
                <c:pt idx="88">
                  <c:v>8.398157182931957</c:v>
                </c:pt>
                <c:pt idx="89">
                  <c:v>8.398157182931957</c:v>
                </c:pt>
                <c:pt idx="90">
                  <c:v>8.398157182931957</c:v>
                </c:pt>
                <c:pt idx="91">
                  <c:v>8.398157182931957</c:v>
                </c:pt>
                <c:pt idx="92">
                  <c:v>8.398157182931957</c:v>
                </c:pt>
                <c:pt idx="93">
                  <c:v>8.398157182931957</c:v>
                </c:pt>
                <c:pt idx="94">
                  <c:v>8.398157182931957</c:v>
                </c:pt>
                <c:pt idx="95">
                  <c:v>8.398157182931957</c:v>
                </c:pt>
                <c:pt idx="96">
                  <c:v>8.398157182931957</c:v>
                </c:pt>
                <c:pt idx="97">
                  <c:v>8.398157182931957</c:v>
                </c:pt>
                <c:pt idx="98">
                  <c:v>8.398157182931957</c:v>
                </c:pt>
                <c:pt idx="99">
                  <c:v>8.398157182931957</c:v>
                </c:pt>
                <c:pt idx="100">
                  <c:v>8.398157182931957</c:v>
                </c:pt>
                <c:pt idx="101">
                  <c:v>8.398157182931957</c:v>
                </c:pt>
                <c:pt idx="102">
                  <c:v>8.398157182931957</c:v>
                </c:pt>
                <c:pt idx="103">
                  <c:v>8.398157182931957</c:v>
                </c:pt>
                <c:pt idx="104">
                  <c:v>8.398157182931957</c:v>
                </c:pt>
                <c:pt idx="105">
                  <c:v>8.398157182931957</c:v>
                </c:pt>
                <c:pt idx="106">
                  <c:v>8.398157182931957</c:v>
                </c:pt>
                <c:pt idx="107">
                  <c:v>8.398157182931957</c:v>
                </c:pt>
                <c:pt idx="108">
                  <c:v>8.398157182931957</c:v>
                </c:pt>
                <c:pt idx="109">
                  <c:v>8.398157182931957</c:v>
                </c:pt>
                <c:pt idx="110">
                  <c:v>8.398157182931957</c:v>
                </c:pt>
                <c:pt idx="111">
                  <c:v>8.398157182931957</c:v>
                </c:pt>
                <c:pt idx="112">
                  <c:v>8.398157182931957</c:v>
                </c:pt>
                <c:pt idx="113">
                  <c:v>8.398157182931957</c:v>
                </c:pt>
                <c:pt idx="114">
                  <c:v>8.398157182931957</c:v>
                </c:pt>
                <c:pt idx="115">
                  <c:v>8.398157182931957</c:v>
                </c:pt>
                <c:pt idx="116">
                  <c:v>8.398157182931957</c:v>
                </c:pt>
                <c:pt idx="117">
                  <c:v>8.398157182931957</c:v>
                </c:pt>
                <c:pt idx="118">
                  <c:v>8.398157182931957</c:v>
                </c:pt>
                <c:pt idx="119">
                  <c:v>8.398157182931957</c:v>
                </c:pt>
                <c:pt idx="120">
                  <c:v>8.398157182931957</c:v>
                </c:pt>
                <c:pt idx="121">
                  <c:v>8.398157182931957</c:v>
                </c:pt>
                <c:pt idx="122">
                  <c:v>8.398157182931957</c:v>
                </c:pt>
                <c:pt idx="123">
                  <c:v>8.398157182931957</c:v>
                </c:pt>
                <c:pt idx="124">
                  <c:v>8.398157182931957</c:v>
                </c:pt>
                <c:pt idx="125">
                  <c:v>8.398157182931957</c:v>
                </c:pt>
                <c:pt idx="126">
                  <c:v>8.398157182931957</c:v>
                </c:pt>
                <c:pt idx="127">
                  <c:v>8.398157182931957</c:v>
                </c:pt>
                <c:pt idx="128">
                  <c:v>8.398157182931957</c:v>
                </c:pt>
                <c:pt idx="129">
                  <c:v>8.39815718293195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5035-4141-A122-8241DEEBFBF8}"/>
            </c:ext>
          </c:extLst>
        </c:ser>
        <c:ser>
          <c:idx val="3"/>
          <c:order val="3"/>
          <c:tx>
            <c:strRef>
              <c:f>Sheet2!$J$3</c:f>
              <c:strCache>
                <c:ptCount val="1"/>
                <c:pt idx="0">
                  <c:v>(+2SD)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Sheet2!$F$4:$F$133</c:f>
              <c:numCache>
                <c:formatCode>0.00</c:formatCode>
                <c:ptCount val="13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</c:numCache>
            </c:numRef>
          </c:xVal>
          <c:yVal>
            <c:numRef>
              <c:f>Sheet2!$J$4:$J$133</c:f>
              <c:numCache>
                <c:formatCode>General</c:formatCode>
                <c:ptCount val="130"/>
                <c:pt idx="0">
                  <c:v>8.095942480928997</c:v>
                </c:pt>
                <c:pt idx="1">
                  <c:v>8.095942480928997</c:v>
                </c:pt>
                <c:pt idx="2">
                  <c:v>8.095942480928997</c:v>
                </c:pt>
                <c:pt idx="3">
                  <c:v>8.095942480928997</c:v>
                </c:pt>
                <c:pt idx="4">
                  <c:v>8.095942480928997</c:v>
                </c:pt>
                <c:pt idx="5">
                  <c:v>8.095942480928997</c:v>
                </c:pt>
                <c:pt idx="6">
                  <c:v>8.095942480928997</c:v>
                </c:pt>
                <c:pt idx="7">
                  <c:v>8.095942480928997</c:v>
                </c:pt>
                <c:pt idx="8">
                  <c:v>8.095942480928997</c:v>
                </c:pt>
                <c:pt idx="9">
                  <c:v>8.095942480928997</c:v>
                </c:pt>
                <c:pt idx="10">
                  <c:v>8.095942480928997</c:v>
                </c:pt>
                <c:pt idx="11">
                  <c:v>8.095942480928997</c:v>
                </c:pt>
                <c:pt idx="12">
                  <c:v>8.095942480928997</c:v>
                </c:pt>
                <c:pt idx="13">
                  <c:v>8.095942480928997</c:v>
                </c:pt>
                <c:pt idx="14">
                  <c:v>8.095942480928997</c:v>
                </c:pt>
                <c:pt idx="15">
                  <c:v>8.095942480928997</c:v>
                </c:pt>
                <c:pt idx="16">
                  <c:v>8.095942480928997</c:v>
                </c:pt>
                <c:pt idx="17">
                  <c:v>8.095942480928997</c:v>
                </c:pt>
                <c:pt idx="18">
                  <c:v>8.095942480928997</c:v>
                </c:pt>
                <c:pt idx="19">
                  <c:v>8.095942480928997</c:v>
                </c:pt>
                <c:pt idx="20">
                  <c:v>8.095942480928997</c:v>
                </c:pt>
                <c:pt idx="21">
                  <c:v>8.095942480928997</c:v>
                </c:pt>
                <c:pt idx="22">
                  <c:v>8.095942480928997</c:v>
                </c:pt>
                <c:pt idx="23">
                  <c:v>8.095942480928997</c:v>
                </c:pt>
                <c:pt idx="24">
                  <c:v>8.095942480928997</c:v>
                </c:pt>
                <c:pt idx="25">
                  <c:v>8.095942480928997</c:v>
                </c:pt>
                <c:pt idx="26">
                  <c:v>8.095942480928997</c:v>
                </c:pt>
                <c:pt idx="27">
                  <c:v>8.095942480928997</c:v>
                </c:pt>
                <c:pt idx="28">
                  <c:v>8.095942480928997</c:v>
                </c:pt>
                <c:pt idx="29">
                  <c:v>8.095942480928997</c:v>
                </c:pt>
                <c:pt idx="30">
                  <c:v>8.095942480928997</c:v>
                </c:pt>
                <c:pt idx="31">
                  <c:v>8.095942480928997</c:v>
                </c:pt>
                <c:pt idx="32">
                  <c:v>8.095942480928997</c:v>
                </c:pt>
                <c:pt idx="33">
                  <c:v>8.095942480928997</c:v>
                </c:pt>
                <c:pt idx="34">
                  <c:v>8.095942480928997</c:v>
                </c:pt>
                <c:pt idx="35">
                  <c:v>8.095942480928997</c:v>
                </c:pt>
                <c:pt idx="36">
                  <c:v>8.095942480928997</c:v>
                </c:pt>
                <c:pt idx="37">
                  <c:v>8.095942480928997</c:v>
                </c:pt>
                <c:pt idx="38">
                  <c:v>8.095942480928997</c:v>
                </c:pt>
                <c:pt idx="39">
                  <c:v>8.095942480928997</c:v>
                </c:pt>
                <c:pt idx="40">
                  <c:v>8.095942480928997</c:v>
                </c:pt>
                <c:pt idx="41">
                  <c:v>8.095942480928997</c:v>
                </c:pt>
                <c:pt idx="42">
                  <c:v>8.095942480928997</c:v>
                </c:pt>
                <c:pt idx="43">
                  <c:v>8.095942480928997</c:v>
                </c:pt>
                <c:pt idx="44">
                  <c:v>8.095942480928997</c:v>
                </c:pt>
                <c:pt idx="45">
                  <c:v>8.095942480928997</c:v>
                </c:pt>
                <c:pt idx="46">
                  <c:v>8.095942480928997</c:v>
                </c:pt>
                <c:pt idx="47">
                  <c:v>8.095942480928997</c:v>
                </c:pt>
                <c:pt idx="48">
                  <c:v>8.095942480928997</c:v>
                </c:pt>
                <c:pt idx="49">
                  <c:v>8.095942480928997</c:v>
                </c:pt>
                <c:pt idx="50">
                  <c:v>8.095942480928997</c:v>
                </c:pt>
                <c:pt idx="51">
                  <c:v>8.095942480928997</c:v>
                </c:pt>
                <c:pt idx="52">
                  <c:v>8.095942480928997</c:v>
                </c:pt>
                <c:pt idx="53">
                  <c:v>8.095942480928997</c:v>
                </c:pt>
                <c:pt idx="54">
                  <c:v>8.095942480928997</c:v>
                </c:pt>
                <c:pt idx="55">
                  <c:v>8.095942480928997</c:v>
                </c:pt>
                <c:pt idx="56">
                  <c:v>8.095942480928997</c:v>
                </c:pt>
                <c:pt idx="57">
                  <c:v>8.095942480928997</c:v>
                </c:pt>
                <c:pt idx="58">
                  <c:v>8.095942480928997</c:v>
                </c:pt>
                <c:pt idx="59">
                  <c:v>8.095942480928997</c:v>
                </c:pt>
                <c:pt idx="60">
                  <c:v>8.095942480928997</c:v>
                </c:pt>
                <c:pt idx="61">
                  <c:v>8.095942480928997</c:v>
                </c:pt>
                <c:pt idx="62">
                  <c:v>8.095942480928997</c:v>
                </c:pt>
                <c:pt idx="63">
                  <c:v>8.095942480928997</c:v>
                </c:pt>
                <c:pt idx="64">
                  <c:v>8.095942480928997</c:v>
                </c:pt>
                <c:pt idx="65">
                  <c:v>8.095942480928997</c:v>
                </c:pt>
                <c:pt idx="66">
                  <c:v>8.095942480928997</c:v>
                </c:pt>
                <c:pt idx="67">
                  <c:v>8.095942480928997</c:v>
                </c:pt>
                <c:pt idx="68">
                  <c:v>8.095942480928997</c:v>
                </c:pt>
                <c:pt idx="69">
                  <c:v>8.095942480928997</c:v>
                </c:pt>
                <c:pt idx="70">
                  <c:v>8.095942480928997</c:v>
                </c:pt>
                <c:pt idx="71">
                  <c:v>8.095942480928997</c:v>
                </c:pt>
                <c:pt idx="72">
                  <c:v>8.095942480928997</c:v>
                </c:pt>
                <c:pt idx="73">
                  <c:v>8.095942480928997</c:v>
                </c:pt>
                <c:pt idx="74">
                  <c:v>8.095942480928997</c:v>
                </c:pt>
                <c:pt idx="75">
                  <c:v>8.095942480928997</c:v>
                </c:pt>
                <c:pt idx="76">
                  <c:v>8.095942480928997</c:v>
                </c:pt>
                <c:pt idx="77">
                  <c:v>8.095942480928997</c:v>
                </c:pt>
                <c:pt idx="78">
                  <c:v>8.095942480928997</c:v>
                </c:pt>
                <c:pt idx="79">
                  <c:v>8.095942480928997</c:v>
                </c:pt>
                <c:pt idx="80">
                  <c:v>8.095942480928997</c:v>
                </c:pt>
                <c:pt idx="81">
                  <c:v>8.095942480928997</c:v>
                </c:pt>
                <c:pt idx="82">
                  <c:v>8.095942480928997</c:v>
                </c:pt>
                <c:pt idx="83">
                  <c:v>8.095942480928997</c:v>
                </c:pt>
                <c:pt idx="84">
                  <c:v>8.095942480928997</c:v>
                </c:pt>
                <c:pt idx="85">
                  <c:v>8.095942480928997</c:v>
                </c:pt>
                <c:pt idx="86">
                  <c:v>8.095942480928997</c:v>
                </c:pt>
                <c:pt idx="87">
                  <c:v>8.095942480928997</c:v>
                </c:pt>
                <c:pt idx="88">
                  <c:v>8.095942480928997</c:v>
                </c:pt>
                <c:pt idx="89">
                  <c:v>8.095942480928997</c:v>
                </c:pt>
                <c:pt idx="90">
                  <c:v>8.095942480928997</c:v>
                </c:pt>
                <c:pt idx="91">
                  <c:v>8.095942480928997</c:v>
                </c:pt>
                <c:pt idx="92">
                  <c:v>8.095942480928997</c:v>
                </c:pt>
                <c:pt idx="93">
                  <c:v>8.095942480928997</c:v>
                </c:pt>
                <c:pt idx="94">
                  <c:v>8.095942480928997</c:v>
                </c:pt>
                <c:pt idx="95">
                  <c:v>8.095942480928997</c:v>
                </c:pt>
                <c:pt idx="96">
                  <c:v>8.095942480928997</c:v>
                </c:pt>
                <c:pt idx="97">
                  <c:v>8.095942480928997</c:v>
                </c:pt>
                <c:pt idx="98">
                  <c:v>8.095942480928997</c:v>
                </c:pt>
                <c:pt idx="99">
                  <c:v>8.095942480928997</c:v>
                </c:pt>
                <c:pt idx="100">
                  <c:v>8.095942480928997</c:v>
                </c:pt>
                <c:pt idx="101">
                  <c:v>8.095942480928997</c:v>
                </c:pt>
                <c:pt idx="102">
                  <c:v>8.095942480928997</c:v>
                </c:pt>
                <c:pt idx="103">
                  <c:v>8.095942480928997</c:v>
                </c:pt>
                <c:pt idx="104">
                  <c:v>8.095942480928997</c:v>
                </c:pt>
                <c:pt idx="105">
                  <c:v>8.095942480928997</c:v>
                </c:pt>
                <c:pt idx="106">
                  <c:v>8.095942480928997</c:v>
                </c:pt>
                <c:pt idx="107">
                  <c:v>8.095942480928997</c:v>
                </c:pt>
                <c:pt idx="108">
                  <c:v>8.095942480928997</c:v>
                </c:pt>
                <c:pt idx="109">
                  <c:v>8.095942480928997</c:v>
                </c:pt>
                <c:pt idx="110">
                  <c:v>8.095942480928997</c:v>
                </c:pt>
                <c:pt idx="111">
                  <c:v>8.095942480928997</c:v>
                </c:pt>
                <c:pt idx="112">
                  <c:v>8.095942480928997</c:v>
                </c:pt>
                <c:pt idx="113">
                  <c:v>8.095942480928997</c:v>
                </c:pt>
                <c:pt idx="114">
                  <c:v>8.095942480928997</c:v>
                </c:pt>
                <c:pt idx="115">
                  <c:v>8.095942480928997</c:v>
                </c:pt>
                <c:pt idx="116">
                  <c:v>8.095942480928997</c:v>
                </c:pt>
                <c:pt idx="117">
                  <c:v>8.095942480928997</c:v>
                </c:pt>
                <c:pt idx="118">
                  <c:v>8.095942480928997</c:v>
                </c:pt>
                <c:pt idx="119">
                  <c:v>8.095942480928997</c:v>
                </c:pt>
                <c:pt idx="120">
                  <c:v>8.095942480928997</c:v>
                </c:pt>
                <c:pt idx="121">
                  <c:v>8.095942480928997</c:v>
                </c:pt>
                <c:pt idx="122">
                  <c:v>8.095942480928997</c:v>
                </c:pt>
                <c:pt idx="123">
                  <c:v>8.095942480928997</c:v>
                </c:pt>
                <c:pt idx="124">
                  <c:v>8.095942480928997</c:v>
                </c:pt>
                <c:pt idx="125">
                  <c:v>8.095942480928997</c:v>
                </c:pt>
                <c:pt idx="126">
                  <c:v>8.095942480928997</c:v>
                </c:pt>
                <c:pt idx="127">
                  <c:v>8.095942480928997</c:v>
                </c:pt>
                <c:pt idx="128">
                  <c:v>8.095942480928997</c:v>
                </c:pt>
                <c:pt idx="129">
                  <c:v>8.09594248092899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5035-4141-A122-8241DEEBFBF8}"/>
            </c:ext>
          </c:extLst>
        </c:ser>
        <c:ser>
          <c:idx val="4"/>
          <c:order val="4"/>
          <c:tx>
            <c:strRef>
              <c:f>Sheet2!$K$3</c:f>
              <c:strCache>
                <c:ptCount val="1"/>
                <c:pt idx="0">
                  <c:v>(+1SD)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Sheet2!$F$4:$F$133</c:f>
              <c:numCache>
                <c:formatCode>0.00</c:formatCode>
                <c:ptCount val="13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</c:numCache>
            </c:numRef>
          </c:xVal>
          <c:yVal>
            <c:numRef>
              <c:f>Sheet2!$K$4:$K$133</c:f>
              <c:numCache>
                <c:formatCode>General</c:formatCode>
                <c:ptCount val="130"/>
                <c:pt idx="0">
                  <c:v>7.7937277789260371</c:v>
                </c:pt>
                <c:pt idx="1">
                  <c:v>7.7937277789260371</c:v>
                </c:pt>
                <c:pt idx="2">
                  <c:v>7.7937277789260371</c:v>
                </c:pt>
                <c:pt idx="3">
                  <c:v>7.7937277789260371</c:v>
                </c:pt>
                <c:pt idx="4">
                  <c:v>7.7937277789260371</c:v>
                </c:pt>
                <c:pt idx="5">
                  <c:v>7.7937277789260371</c:v>
                </c:pt>
                <c:pt idx="6">
                  <c:v>7.7937277789260371</c:v>
                </c:pt>
                <c:pt idx="7">
                  <c:v>7.7937277789260371</c:v>
                </c:pt>
                <c:pt idx="8">
                  <c:v>7.7937277789260371</c:v>
                </c:pt>
                <c:pt idx="9">
                  <c:v>7.7937277789260371</c:v>
                </c:pt>
                <c:pt idx="10">
                  <c:v>7.7937277789260371</c:v>
                </c:pt>
                <c:pt idx="11">
                  <c:v>7.7937277789260371</c:v>
                </c:pt>
                <c:pt idx="12">
                  <c:v>7.7937277789260371</c:v>
                </c:pt>
                <c:pt idx="13">
                  <c:v>7.7937277789260371</c:v>
                </c:pt>
                <c:pt idx="14">
                  <c:v>7.7937277789260371</c:v>
                </c:pt>
                <c:pt idx="15">
                  <c:v>7.7937277789260371</c:v>
                </c:pt>
                <c:pt idx="16">
                  <c:v>7.7937277789260371</c:v>
                </c:pt>
                <c:pt idx="17">
                  <c:v>7.7937277789260371</c:v>
                </c:pt>
                <c:pt idx="18">
                  <c:v>7.7937277789260371</c:v>
                </c:pt>
                <c:pt idx="19">
                  <c:v>7.7937277789260371</c:v>
                </c:pt>
                <c:pt idx="20">
                  <c:v>7.7937277789260371</c:v>
                </c:pt>
                <c:pt idx="21">
                  <c:v>7.7937277789260371</c:v>
                </c:pt>
                <c:pt idx="22">
                  <c:v>7.7937277789260371</c:v>
                </c:pt>
                <c:pt idx="23">
                  <c:v>7.7937277789260371</c:v>
                </c:pt>
                <c:pt idx="24">
                  <c:v>7.7937277789260371</c:v>
                </c:pt>
                <c:pt idx="25">
                  <c:v>7.7937277789260371</c:v>
                </c:pt>
                <c:pt idx="26">
                  <c:v>7.7937277789260371</c:v>
                </c:pt>
                <c:pt idx="27">
                  <c:v>7.7937277789260371</c:v>
                </c:pt>
                <c:pt idx="28">
                  <c:v>7.7937277789260371</c:v>
                </c:pt>
                <c:pt idx="29">
                  <c:v>7.7937277789260371</c:v>
                </c:pt>
                <c:pt idx="30">
                  <c:v>7.7937277789260371</c:v>
                </c:pt>
                <c:pt idx="31">
                  <c:v>7.7937277789260371</c:v>
                </c:pt>
                <c:pt idx="32">
                  <c:v>7.7937277789260371</c:v>
                </c:pt>
                <c:pt idx="33">
                  <c:v>7.7937277789260371</c:v>
                </c:pt>
                <c:pt idx="34">
                  <c:v>7.7937277789260371</c:v>
                </c:pt>
                <c:pt idx="35">
                  <c:v>7.7937277789260371</c:v>
                </c:pt>
                <c:pt idx="36">
                  <c:v>7.7937277789260371</c:v>
                </c:pt>
                <c:pt idx="37">
                  <c:v>7.7937277789260371</c:v>
                </c:pt>
                <c:pt idx="38">
                  <c:v>7.7937277789260371</c:v>
                </c:pt>
                <c:pt idx="39">
                  <c:v>7.7937277789260371</c:v>
                </c:pt>
                <c:pt idx="40">
                  <c:v>7.7937277789260371</c:v>
                </c:pt>
                <c:pt idx="41">
                  <c:v>7.7937277789260371</c:v>
                </c:pt>
                <c:pt idx="42">
                  <c:v>7.7937277789260371</c:v>
                </c:pt>
                <c:pt idx="43">
                  <c:v>7.7937277789260371</c:v>
                </c:pt>
                <c:pt idx="44">
                  <c:v>7.7937277789260371</c:v>
                </c:pt>
                <c:pt idx="45">
                  <c:v>7.7937277789260371</c:v>
                </c:pt>
                <c:pt idx="46">
                  <c:v>7.7937277789260371</c:v>
                </c:pt>
                <c:pt idx="47">
                  <c:v>7.7937277789260371</c:v>
                </c:pt>
                <c:pt idx="48">
                  <c:v>7.7937277789260371</c:v>
                </c:pt>
                <c:pt idx="49">
                  <c:v>7.7937277789260371</c:v>
                </c:pt>
                <c:pt idx="50">
                  <c:v>7.7937277789260371</c:v>
                </c:pt>
                <c:pt idx="51">
                  <c:v>7.7937277789260371</c:v>
                </c:pt>
                <c:pt idx="52">
                  <c:v>7.7937277789260371</c:v>
                </c:pt>
                <c:pt idx="53">
                  <c:v>7.7937277789260371</c:v>
                </c:pt>
                <c:pt idx="54">
                  <c:v>7.7937277789260371</c:v>
                </c:pt>
                <c:pt idx="55">
                  <c:v>7.7937277789260371</c:v>
                </c:pt>
                <c:pt idx="56">
                  <c:v>7.7937277789260371</c:v>
                </c:pt>
                <c:pt idx="57">
                  <c:v>7.7937277789260371</c:v>
                </c:pt>
                <c:pt idx="58">
                  <c:v>7.7937277789260371</c:v>
                </c:pt>
                <c:pt idx="59">
                  <c:v>7.7937277789260371</c:v>
                </c:pt>
                <c:pt idx="60">
                  <c:v>7.7937277789260371</c:v>
                </c:pt>
                <c:pt idx="61">
                  <c:v>7.7937277789260371</c:v>
                </c:pt>
                <c:pt idx="62">
                  <c:v>7.7937277789260371</c:v>
                </c:pt>
                <c:pt idx="63">
                  <c:v>7.7937277789260371</c:v>
                </c:pt>
                <c:pt idx="64">
                  <c:v>7.7937277789260371</c:v>
                </c:pt>
                <c:pt idx="65">
                  <c:v>7.7937277789260371</c:v>
                </c:pt>
                <c:pt idx="66">
                  <c:v>7.7937277789260371</c:v>
                </c:pt>
                <c:pt idx="67">
                  <c:v>7.7937277789260371</c:v>
                </c:pt>
                <c:pt idx="68">
                  <c:v>7.7937277789260371</c:v>
                </c:pt>
                <c:pt idx="69">
                  <c:v>7.7937277789260371</c:v>
                </c:pt>
                <c:pt idx="70">
                  <c:v>7.7937277789260371</c:v>
                </c:pt>
                <c:pt idx="71">
                  <c:v>7.7937277789260371</c:v>
                </c:pt>
                <c:pt idx="72">
                  <c:v>7.7937277789260371</c:v>
                </c:pt>
                <c:pt idx="73">
                  <c:v>7.7937277789260371</c:v>
                </c:pt>
                <c:pt idx="74">
                  <c:v>7.7937277789260371</c:v>
                </c:pt>
                <c:pt idx="75">
                  <c:v>7.7937277789260371</c:v>
                </c:pt>
                <c:pt idx="76">
                  <c:v>7.7937277789260371</c:v>
                </c:pt>
                <c:pt idx="77">
                  <c:v>7.7937277789260371</c:v>
                </c:pt>
                <c:pt idx="78">
                  <c:v>7.7937277789260371</c:v>
                </c:pt>
                <c:pt idx="79">
                  <c:v>7.7937277789260371</c:v>
                </c:pt>
                <c:pt idx="80">
                  <c:v>7.7937277789260371</c:v>
                </c:pt>
                <c:pt idx="81">
                  <c:v>7.7937277789260371</c:v>
                </c:pt>
                <c:pt idx="82">
                  <c:v>7.7937277789260371</c:v>
                </c:pt>
                <c:pt idx="83">
                  <c:v>7.7937277789260371</c:v>
                </c:pt>
                <c:pt idx="84">
                  <c:v>7.7937277789260371</c:v>
                </c:pt>
                <c:pt idx="85">
                  <c:v>7.7937277789260371</c:v>
                </c:pt>
                <c:pt idx="86">
                  <c:v>7.7937277789260371</c:v>
                </c:pt>
                <c:pt idx="87">
                  <c:v>7.7937277789260371</c:v>
                </c:pt>
                <c:pt idx="88">
                  <c:v>7.7937277789260371</c:v>
                </c:pt>
                <c:pt idx="89">
                  <c:v>7.7937277789260371</c:v>
                </c:pt>
                <c:pt idx="90">
                  <c:v>7.7937277789260371</c:v>
                </c:pt>
                <c:pt idx="91">
                  <c:v>7.7937277789260371</c:v>
                </c:pt>
                <c:pt idx="92">
                  <c:v>7.7937277789260371</c:v>
                </c:pt>
                <c:pt idx="93">
                  <c:v>7.7937277789260371</c:v>
                </c:pt>
                <c:pt idx="94">
                  <c:v>7.7937277789260371</c:v>
                </c:pt>
                <c:pt idx="95">
                  <c:v>7.7937277789260371</c:v>
                </c:pt>
                <c:pt idx="96">
                  <c:v>7.7937277789260371</c:v>
                </c:pt>
                <c:pt idx="97">
                  <c:v>7.7937277789260371</c:v>
                </c:pt>
                <c:pt idx="98">
                  <c:v>7.7937277789260371</c:v>
                </c:pt>
                <c:pt idx="99">
                  <c:v>7.7937277789260371</c:v>
                </c:pt>
                <c:pt idx="100">
                  <c:v>7.7937277789260371</c:v>
                </c:pt>
                <c:pt idx="101">
                  <c:v>7.7937277789260371</c:v>
                </c:pt>
                <c:pt idx="102">
                  <c:v>7.7937277789260371</c:v>
                </c:pt>
                <c:pt idx="103">
                  <c:v>7.7937277789260371</c:v>
                </c:pt>
                <c:pt idx="104">
                  <c:v>7.7937277789260371</c:v>
                </c:pt>
                <c:pt idx="105">
                  <c:v>7.7937277789260371</c:v>
                </c:pt>
                <c:pt idx="106">
                  <c:v>7.7937277789260371</c:v>
                </c:pt>
                <c:pt idx="107">
                  <c:v>7.7937277789260371</c:v>
                </c:pt>
                <c:pt idx="108">
                  <c:v>7.7937277789260371</c:v>
                </c:pt>
                <c:pt idx="109">
                  <c:v>7.7937277789260371</c:v>
                </c:pt>
                <c:pt idx="110">
                  <c:v>7.7937277789260371</c:v>
                </c:pt>
                <c:pt idx="111">
                  <c:v>7.7937277789260371</c:v>
                </c:pt>
                <c:pt idx="112">
                  <c:v>7.7937277789260371</c:v>
                </c:pt>
                <c:pt idx="113">
                  <c:v>7.7937277789260371</c:v>
                </c:pt>
                <c:pt idx="114">
                  <c:v>7.7937277789260371</c:v>
                </c:pt>
                <c:pt idx="115">
                  <c:v>7.7937277789260371</c:v>
                </c:pt>
                <c:pt idx="116">
                  <c:v>7.7937277789260371</c:v>
                </c:pt>
                <c:pt idx="117">
                  <c:v>7.7937277789260371</c:v>
                </c:pt>
                <c:pt idx="118">
                  <c:v>7.7937277789260371</c:v>
                </c:pt>
                <c:pt idx="119">
                  <c:v>7.7937277789260371</c:v>
                </c:pt>
                <c:pt idx="120">
                  <c:v>7.7937277789260371</c:v>
                </c:pt>
                <c:pt idx="121">
                  <c:v>7.7937277789260371</c:v>
                </c:pt>
                <c:pt idx="122">
                  <c:v>7.7937277789260371</c:v>
                </c:pt>
                <c:pt idx="123">
                  <c:v>7.7937277789260371</c:v>
                </c:pt>
                <c:pt idx="124">
                  <c:v>7.7937277789260371</c:v>
                </c:pt>
                <c:pt idx="125">
                  <c:v>7.7937277789260371</c:v>
                </c:pt>
                <c:pt idx="126">
                  <c:v>7.7937277789260371</c:v>
                </c:pt>
                <c:pt idx="127">
                  <c:v>7.7937277789260371</c:v>
                </c:pt>
                <c:pt idx="128">
                  <c:v>7.7937277789260371</c:v>
                </c:pt>
                <c:pt idx="129">
                  <c:v>7.793727778926037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5035-4141-A122-8241DEEBFBF8}"/>
            </c:ext>
          </c:extLst>
        </c:ser>
        <c:ser>
          <c:idx val="5"/>
          <c:order val="5"/>
          <c:tx>
            <c:strRef>
              <c:f>Sheet2!$L$3</c:f>
              <c:strCache>
                <c:ptCount val="1"/>
                <c:pt idx="0">
                  <c:v>Mean</c:v>
                </c:pt>
              </c:strCache>
            </c:strRef>
          </c:tx>
          <c:spPr>
            <a:ln w="19050" cap="rnd">
              <a:solidFill>
                <a:srgbClr val="FF0000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  <a:prstDash val="sysDash"/>
              </a:ln>
              <a:effectLst/>
            </c:spPr>
          </c:marker>
          <c:xVal>
            <c:numRef>
              <c:f>Sheet2!$F$4:$F$133</c:f>
              <c:numCache>
                <c:formatCode>0.00</c:formatCode>
                <c:ptCount val="13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</c:numCache>
            </c:numRef>
          </c:xVal>
          <c:yVal>
            <c:numRef>
              <c:f>Sheet2!$L$4:$L$133</c:f>
              <c:numCache>
                <c:formatCode>General</c:formatCode>
                <c:ptCount val="130"/>
                <c:pt idx="0">
                  <c:v>7.4915130769230762</c:v>
                </c:pt>
                <c:pt idx="1">
                  <c:v>7.4915130769230762</c:v>
                </c:pt>
                <c:pt idx="2">
                  <c:v>7.4915130769230762</c:v>
                </c:pt>
                <c:pt idx="3">
                  <c:v>7.4915130769230762</c:v>
                </c:pt>
                <c:pt idx="4">
                  <c:v>7.4915130769230762</c:v>
                </c:pt>
                <c:pt idx="5">
                  <c:v>7.4915130769230762</c:v>
                </c:pt>
                <c:pt idx="6">
                  <c:v>7.4915130769230762</c:v>
                </c:pt>
                <c:pt idx="7">
                  <c:v>7.4915130769230762</c:v>
                </c:pt>
                <c:pt idx="8">
                  <c:v>7.4915130769230762</c:v>
                </c:pt>
                <c:pt idx="9">
                  <c:v>7.4915130769230762</c:v>
                </c:pt>
                <c:pt idx="10">
                  <c:v>7.4915130769230762</c:v>
                </c:pt>
                <c:pt idx="11">
                  <c:v>7.4915130769230762</c:v>
                </c:pt>
                <c:pt idx="12">
                  <c:v>7.4915130769230762</c:v>
                </c:pt>
                <c:pt idx="13">
                  <c:v>7.4915130769230762</c:v>
                </c:pt>
                <c:pt idx="14">
                  <c:v>7.4915130769230762</c:v>
                </c:pt>
                <c:pt idx="15">
                  <c:v>7.4915130769230762</c:v>
                </c:pt>
                <c:pt idx="16">
                  <c:v>7.4915130769230762</c:v>
                </c:pt>
                <c:pt idx="17">
                  <c:v>7.4915130769230762</c:v>
                </c:pt>
                <c:pt idx="18">
                  <c:v>7.4915130769230762</c:v>
                </c:pt>
                <c:pt idx="19">
                  <c:v>7.4915130769230762</c:v>
                </c:pt>
                <c:pt idx="20">
                  <c:v>7.4915130769230762</c:v>
                </c:pt>
                <c:pt idx="21">
                  <c:v>7.4915130769230762</c:v>
                </c:pt>
                <c:pt idx="22">
                  <c:v>7.4915130769230762</c:v>
                </c:pt>
                <c:pt idx="23">
                  <c:v>7.4915130769230762</c:v>
                </c:pt>
                <c:pt idx="24">
                  <c:v>7.4915130769230762</c:v>
                </c:pt>
                <c:pt idx="25">
                  <c:v>7.4915130769230762</c:v>
                </c:pt>
                <c:pt idx="26">
                  <c:v>7.4915130769230762</c:v>
                </c:pt>
                <c:pt idx="27">
                  <c:v>7.4915130769230762</c:v>
                </c:pt>
                <c:pt idx="28">
                  <c:v>7.4915130769230762</c:v>
                </c:pt>
                <c:pt idx="29">
                  <c:v>7.4915130769230762</c:v>
                </c:pt>
                <c:pt idx="30">
                  <c:v>7.4915130769230762</c:v>
                </c:pt>
                <c:pt idx="31">
                  <c:v>7.4915130769230762</c:v>
                </c:pt>
                <c:pt idx="32">
                  <c:v>7.4915130769230762</c:v>
                </c:pt>
                <c:pt idx="33">
                  <c:v>7.4915130769230762</c:v>
                </c:pt>
                <c:pt idx="34">
                  <c:v>7.4915130769230762</c:v>
                </c:pt>
                <c:pt idx="35">
                  <c:v>7.4915130769230762</c:v>
                </c:pt>
                <c:pt idx="36">
                  <c:v>7.4915130769230762</c:v>
                </c:pt>
                <c:pt idx="37">
                  <c:v>7.4915130769230762</c:v>
                </c:pt>
                <c:pt idx="38">
                  <c:v>7.4915130769230762</c:v>
                </c:pt>
                <c:pt idx="39">
                  <c:v>7.4915130769230762</c:v>
                </c:pt>
                <c:pt idx="40">
                  <c:v>7.4915130769230762</c:v>
                </c:pt>
                <c:pt idx="41">
                  <c:v>7.4915130769230762</c:v>
                </c:pt>
                <c:pt idx="42">
                  <c:v>7.4915130769230762</c:v>
                </c:pt>
                <c:pt idx="43">
                  <c:v>7.4915130769230762</c:v>
                </c:pt>
                <c:pt idx="44">
                  <c:v>7.4915130769230762</c:v>
                </c:pt>
                <c:pt idx="45">
                  <c:v>7.4915130769230762</c:v>
                </c:pt>
                <c:pt idx="46">
                  <c:v>7.4915130769230762</c:v>
                </c:pt>
                <c:pt idx="47">
                  <c:v>7.4915130769230762</c:v>
                </c:pt>
                <c:pt idx="48">
                  <c:v>7.4915130769230762</c:v>
                </c:pt>
                <c:pt idx="49">
                  <c:v>7.4915130769230762</c:v>
                </c:pt>
                <c:pt idx="50">
                  <c:v>7.4915130769230762</c:v>
                </c:pt>
                <c:pt idx="51">
                  <c:v>7.4915130769230762</c:v>
                </c:pt>
                <c:pt idx="52">
                  <c:v>7.4915130769230762</c:v>
                </c:pt>
                <c:pt idx="53">
                  <c:v>7.4915130769230762</c:v>
                </c:pt>
                <c:pt idx="54">
                  <c:v>7.4915130769230762</c:v>
                </c:pt>
                <c:pt idx="55">
                  <c:v>7.4915130769230762</c:v>
                </c:pt>
                <c:pt idx="56">
                  <c:v>7.4915130769230762</c:v>
                </c:pt>
                <c:pt idx="57">
                  <c:v>7.4915130769230762</c:v>
                </c:pt>
                <c:pt idx="58">
                  <c:v>7.4915130769230762</c:v>
                </c:pt>
                <c:pt idx="59">
                  <c:v>7.4915130769230762</c:v>
                </c:pt>
                <c:pt idx="60">
                  <c:v>7.4915130769230762</c:v>
                </c:pt>
                <c:pt idx="61">
                  <c:v>7.4915130769230762</c:v>
                </c:pt>
                <c:pt idx="62">
                  <c:v>7.4915130769230762</c:v>
                </c:pt>
                <c:pt idx="63">
                  <c:v>7.4915130769230762</c:v>
                </c:pt>
                <c:pt idx="64">
                  <c:v>7.4915130769230762</c:v>
                </c:pt>
                <c:pt idx="65">
                  <c:v>7.4915130769230762</c:v>
                </c:pt>
                <c:pt idx="66">
                  <c:v>7.4915130769230762</c:v>
                </c:pt>
                <c:pt idx="67">
                  <c:v>7.4915130769230762</c:v>
                </c:pt>
                <c:pt idx="68">
                  <c:v>7.4915130769230762</c:v>
                </c:pt>
                <c:pt idx="69">
                  <c:v>7.4915130769230762</c:v>
                </c:pt>
                <c:pt idx="70">
                  <c:v>7.4915130769230762</c:v>
                </c:pt>
                <c:pt idx="71">
                  <c:v>7.4915130769230762</c:v>
                </c:pt>
                <c:pt idx="72">
                  <c:v>7.4915130769230762</c:v>
                </c:pt>
                <c:pt idx="73">
                  <c:v>7.4915130769230762</c:v>
                </c:pt>
                <c:pt idx="74">
                  <c:v>7.4915130769230762</c:v>
                </c:pt>
                <c:pt idx="75">
                  <c:v>7.4915130769230762</c:v>
                </c:pt>
                <c:pt idx="76">
                  <c:v>7.4915130769230762</c:v>
                </c:pt>
                <c:pt idx="77">
                  <c:v>7.4915130769230762</c:v>
                </c:pt>
                <c:pt idx="78">
                  <c:v>7.4915130769230762</c:v>
                </c:pt>
                <c:pt idx="79">
                  <c:v>7.4915130769230762</c:v>
                </c:pt>
                <c:pt idx="80">
                  <c:v>7.4915130769230762</c:v>
                </c:pt>
                <c:pt idx="81">
                  <c:v>7.4915130769230762</c:v>
                </c:pt>
                <c:pt idx="82">
                  <c:v>7.4915130769230762</c:v>
                </c:pt>
                <c:pt idx="83">
                  <c:v>7.4915130769230762</c:v>
                </c:pt>
                <c:pt idx="84">
                  <c:v>7.4915130769230762</c:v>
                </c:pt>
                <c:pt idx="85">
                  <c:v>7.4915130769230762</c:v>
                </c:pt>
                <c:pt idx="86">
                  <c:v>7.4915130769230762</c:v>
                </c:pt>
                <c:pt idx="87">
                  <c:v>7.4915130769230762</c:v>
                </c:pt>
                <c:pt idx="88">
                  <c:v>7.4915130769230762</c:v>
                </c:pt>
                <c:pt idx="89">
                  <c:v>7.4915130769230762</c:v>
                </c:pt>
                <c:pt idx="90">
                  <c:v>7.4915130769230762</c:v>
                </c:pt>
                <c:pt idx="91">
                  <c:v>7.4915130769230762</c:v>
                </c:pt>
                <c:pt idx="92">
                  <c:v>7.4915130769230762</c:v>
                </c:pt>
                <c:pt idx="93">
                  <c:v>7.4915130769230762</c:v>
                </c:pt>
                <c:pt idx="94">
                  <c:v>7.4915130769230762</c:v>
                </c:pt>
                <c:pt idx="95">
                  <c:v>7.4915130769230762</c:v>
                </c:pt>
                <c:pt idx="96">
                  <c:v>7.4915130769230762</c:v>
                </c:pt>
                <c:pt idx="97">
                  <c:v>7.4915130769230762</c:v>
                </c:pt>
                <c:pt idx="98">
                  <c:v>7.4915130769230762</c:v>
                </c:pt>
                <c:pt idx="99">
                  <c:v>7.4915130769230762</c:v>
                </c:pt>
                <c:pt idx="100">
                  <c:v>7.4915130769230762</c:v>
                </c:pt>
                <c:pt idx="101">
                  <c:v>7.4915130769230762</c:v>
                </c:pt>
                <c:pt idx="102">
                  <c:v>7.4915130769230762</c:v>
                </c:pt>
                <c:pt idx="103">
                  <c:v>7.4915130769230762</c:v>
                </c:pt>
                <c:pt idx="104">
                  <c:v>7.4915130769230762</c:v>
                </c:pt>
                <c:pt idx="105">
                  <c:v>7.4915130769230762</c:v>
                </c:pt>
                <c:pt idx="106">
                  <c:v>7.4915130769230762</c:v>
                </c:pt>
                <c:pt idx="107">
                  <c:v>7.4915130769230762</c:v>
                </c:pt>
                <c:pt idx="108">
                  <c:v>7.4915130769230762</c:v>
                </c:pt>
                <c:pt idx="109">
                  <c:v>7.4915130769230762</c:v>
                </c:pt>
                <c:pt idx="110">
                  <c:v>7.4915130769230762</c:v>
                </c:pt>
                <c:pt idx="111">
                  <c:v>7.4915130769230762</c:v>
                </c:pt>
                <c:pt idx="112">
                  <c:v>7.4915130769230762</c:v>
                </c:pt>
                <c:pt idx="113">
                  <c:v>7.4915130769230762</c:v>
                </c:pt>
                <c:pt idx="114">
                  <c:v>7.4915130769230762</c:v>
                </c:pt>
                <c:pt idx="115">
                  <c:v>7.4915130769230762</c:v>
                </c:pt>
                <c:pt idx="116">
                  <c:v>7.4915130769230762</c:v>
                </c:pt>
                <c:pt idx="117">
                  <c:v>7.4915130769230762</c:v>
                </c:pt>
                <c:pt idx="118">
                  <c:v>7.4915130769230762</c:v>
                </c:pt>
                <c:pt idx="119">
                  <c:v>7.4915130769230762</c:v>
                </c:pt>
                <c:pt idx="120">
                  <c:v>7.4915130769230762</c:v>
                </c:pt>
                <c:pt idx="121">
                  <c:v>7.4915130769230762</c:v>
                </c:pt>
                <c:pt idx="122">
                  <c:v>7.4915130769230762</c:v>
                </c:pt>
                <c:pt idx="123">
                  <c:v>7.4915130769230762</c:v>
                </c:pt>
                <c:pt idx="124">
                  <c:v>7.4915130769230762</c:v>
                </c:pt>
                <c:pt idx="125">
                  <c:v>7.4915130769230762</c:v>
                </c:pt>
                <c:pt idx="126">
                  <c:v>7.4915130769230762</c:v>
                </c:pt>
                <c:pt idx="127">
                  <c:v>7.4915130769230762</c:v>
                </c:pt>
                <c:pt idx="128">
                  <c:v>7.4915130769230762</c:v>
                </c:pt>
                <c:pt idx="129">
                  <c:v>7.491513076923076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5035-4141-A122-8241DEEBFBF8}"/>
            </c:ext>
          </c:extLst>
        </c:ser>
        <c:ser>
          <c:idx val="6"/>
          <c:order val="6"/>
          <c:tx>
            <c:strRef>
              <c:f>Sheet2!$M$3</c:f>
              <c:strCache>
                <c:ptCount val="1"/>
                <c:pt idx="0">
                  <c:v>(-1SD)</c:v>
                </c:pt>
              </c:strCache>
            </c:strRef>
          </c:tx>
          <c:spPr>
            <a:ln w="19050" cap="rnd">
              <a:solidFill>
                <a:schemeClr val="accent5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>
                    <a:lumMod val="60000"/>
                    <a:lumOff val="40000"/>
                  </a:schemeClr>
                </a:solidFill>
              </a:ln>
              <a:effectLst/>
            </c:spPr>
          </c:marker>
          <c:xVal>
            <c:numRef>
              <c:f>Sheet2!$F$4:$F$133</c:f>
              <c:numCache>
                <c:formatCode>0.00</c:formatCode>
                <c:ptCount val="13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</c:numCache>
            </c:numRef>
          </c:xVal>
          <c:yVal>
            <c:numRef>
              <c:f>Sheet2!$M$4:$M$133</c:f>
              <c:numCache>
                <c:formatCode>General</c:formatCode>
                <c:ptCount val="130"/>
                <c:pt idx="0">
                  <c:v>7.1892983749201154</c:v>
                </c:pt>
                <c:pt idx="1">
                  <c:v>7.1892983749201154</c:v>
                </c:pt>
                <c:pt idx="2">
                  <c:v>7.1892983749201154</c:v>
                </c:pt>
                <c:pt idx="3">
                  <c:v>7.1892983749201154</c:v>
                </c:pt>
                <c:pt idx="4">
                  <c:v>7.1892983749201154</c:v>
                </c:pt>
                <c:pt idx="5">
                  <c:v>7.1892983749201154</c:v>
                </c:pt>
                <c:pt idx="6">
                  <c:v>7.1892983749201154</c:v>
                </c:pt>
                <c:pt idx="7">
                  <c:v>7.1892983749201154</c:v>
                </c:pt>
                <c:pt idx="8">
                  <c:v>7.1892983749201154</c:v>
                </c:pt>
                <c:pt idx="9">
                  <c:v>7.1892983749201154</c:v>
                </c:pt>
                <c:pt idx="10">
                  <c:v>7.1892983749201154</c:v>
                </c:pt>
                <c:pt idx="11">
                  <c:v>7.1892983749201154</c:v>
                </c:pt>
                <c:pt idx="12">
                  <c:v>7.1892983749201154</c:v>
                </c:pt>
                <c:pt idx="13">
                  <c:v>7.1892983749201154</c:v>
                </c:pt>
                <c:pt idx="14">
                  <c:v>7.1892983749201154</c:v>
                </c:pt>
                <c:pt idx="15">
                  <c:v>7.1892983749201154</c:v>
                </c:pt>
                <c:pt idx="16">
                  <c:v>7.1892983749201154</c:v>
                </c:pt>
                <c:pt idx="17">
                  <c:v>7.1892983749201154</c:v>
                </c:pt>
                <c:pt idx="18">
                  <c:v>7.1892983749201154</c:v>
                </c:pt>
                <c:pt idx="19">
                  <c:v>7.1892983749201154</c:v>
                </c:pt>
                <c:pt idx="20">
                  <c:v>7.1892983749201198</c:v>
                </c:pt>
                <c:pt idx="21">
                  <c:v>7.1892983749201198</c:v>
                </c:pt>
                <c:pt idx="22">
                  <c:v>7.1892983749201198</c:v>
                </c:pt>
                <c:pt idx="23">
                  <c:v>7.1892983749201198</c:v>
                </c:pt>
                <c:pt idx="24">
                  <c:v>7.1892983749201198</c:v>
                </c:pt>
                <c:pt idx="25">
                  <c:v>7.1892983749201198</c:v>
                </c:pt>
                <c:pt idx="26">
                  <c:v>7.1892983749201198</c:v>
                </c:pt>
                <c:pt idx="27">
                  <c:v>7.1892983749201198</c:v>
                </c:pt>
                <c:pt idx="28">
                  <c:v>7.1892983749201198</c:v>
                </c:pt>
                <c:pt idx="29">
                  <c:v>7.1892983749201198</c:v>
                </c:pt>
                <c:pt idx="30">
                  <c:v>7.1892983749201198</c:v>
                </c:pt>
                <c:pt idx="31">
                  <c:v>7.1892983749201198</c:v>
                </c:pt>
                <c:pt idx="32">
                  <c:v>7.1892983749201198</c:v>
                </c:pt>
                <c:pt idx="33">
                  <c:v>7.1892983749201198</c:v>
                </c:pt>
                <c:pt idx="34">
                  <c:v>7.1892983749201198</c:v>
                </c:pt>
                <c:pt idx="35">
                  <c:v>7.1892983749201198</c:v>
                </c:pt>
                <c:pt idx="36">
                  <c:v>7.1892983749201198</c:v>
                </c:pt>
                <c:pt idx="37">
                  <c:v>7.1892983749201198</c:v>
                </c:pt>
                <c:pt idx="38">
                  <c:v>7.1892983749201198</c:v>
                </c:pt>
                <c:pt idx="39">
                  <c:v>7.1892983749201198</c:v>
                </c:pt>
                <c:pt idx="40">
                  <c:v>7.1892983749201198</c:v>
                </c:pt>
                <c:pt idx="41">
                  <c:v>7.1892983749201198</c:v>
                </c:pt>
                <c:pt idx="42">
                  <c:v>7.1892983749201198</c:v>
                </c:pt>
                <c:pt idx="43">
                  <c:v>7.1892983749201198</c:v>
                </c:pt>
                <c:pt idx="44">
                  <c:v>7.1892983749201198</c:v>
                </c:pt>
                <c:pt idx="45">
                  <c:v>7.1892983749201198</c:v>
                </c:pt>
                <c:pt idx="46">
                  <c:v>7.1892983749201198</c:v>
                </c:pt>
                <c:pt idx="47">
                  <c:v>7.1892983749201198</c:v>
                </c:pt>
                <c:pt idx="48">
                  <c:v>7.1892983749201198</c:v>
                </c:pt>
                <c:pt idx="49">
                  <c:v>7.1892983749201198</c:v>
                </c:pt>
                <c:pt idx="50">
                  <c:v>7.1892983749201198</c:v>
                </c:pt>
                <c:pt idx="51">
                  <c:v>7.1892983749201198</c:v>
                </c:pt>
                <c:pt idx="52">
                  <c:v>7.1892983749201198</c:v>
                </c:pt>
                <c:pt idx="53">
                  <c:v>7.1892983749201198</c:v>
                </c:pt>
                <c:pt idx="54">
                  <c:v>7.1892983749201198</c:v>
                </c:pt>
                <c:pt idx="55">
                  <c:v>7.1892983749201198</c:v>
                </c:pt>
                <c:pt idx="56">
                  <c:v>7.1892983749201198</c:v>
                </c:pt>
                <c:pt idx="57">
                  <c:v>7.1892983749201198</c:v>
                </c:pt>
                <c:pt idx="58">
                  <c:v>7.1892983749201198</c:v>
                </c:pt>
                <c:pt idx="59">
                  <c:v>7.1892983749201198</c:v>
                </c:pt>
                <c:pt idx="60">
                  <c:v>7.1892983749201198</c:v>
                </c:pt>
                <c:pt idx="61">
                  <c:v>7.1892983749201198</c:v>
                </c:pt>
                <c:pt idx="62">
                  <c:v>7.1892983749201198</c:v>
                </c:pt>
                <c:pt idx="63">
                  <c:v>7.1892983749201198</c:v>
                </c:pt>
                <c:pt idx="64">
                  <c:v>7.1892983749201198</c:v>
                </c:pt>
                <c:pt idx="65">
                  <c:v>7.1892983749201198</c:v>
                </c:pt>
                <c:pt idx="66">
                  <c:v>7.1892983749201198</c:v>
                </c:pt>
                <c:pt idx="67">
                  <c:v>7.1892983749201198</c:v>
                </c:pt>
                <c:pt idx="68">
                  <c:v>7.1892983749201198</c:v>
                </c:pt>
                <c:pt idx="69">
                  <c:v>7.1892983749201198</c:v>
                </c:pt>
                <c:pt idx="70">
                  <c:v>7.1892983749201198</c:v>
                </c:pt>
                <c:pt idx="71">
                  <c:v>7.1892983749201198</c:v>
                </c:pt>
                <c:pt idx="72">
                  <c:v>7.1892983749201198</c:v>
                </c:pt>
                <c:pt idx="73">
                  <c:v>7.1892983749201198</c:v>
                </c:pt>
                <c:pt idx="74">
                  <c:v>7.1892983749201198</c:v>
                </c:pt>
                <c:pt idx="75">
                  <c:v>7.1892983749201198</c:v>
                </c:pt>
                <c:pt idx="76">
                  <c:v>7.1892983749201198</c:v>
                </c:pt>
                <c:pt idx="77">
                  <c:v>7.1892983749201198</c:v>
                </c:pt>
                <c:pt idx="78">
                  <c:v>7.1892983749201198</c:v>
                </c:pt>
                <c:pt idx="79">
                  <c:v>7.1892983749201198</c:v>
                </c:pt>
                <c:pt idx="80">
                  <c:v>7.1892983749201198</c:v>
                </c:pt>
                <c:pt idx="81">
                  <c:v>7.1892983749201198</c:v>
                </c:pt>
                <c:pt idx="82">
                  <c:v>7.1892983749201198</c:v>
                </c:pt>
                <c:pt idx="83">
                  <c:v>7.1892983749201198</c:v>
                </c:pt>
                <c:pt idx="84">
                  <c:v>7.1892983749201198</c:v>
                </c:pt>
                <c:pt idx="85">
                  <c:v>7.1892983749201198</c:v>
                </c:pt>
                <c:pt idx="86">
                  <c:v>7.1892983749201198</c:v>
                </c:pt>
                <c:pt idx="87">
                  <c:v>7.1892983749201198</c:v>
                </c:pt>
                <c:pt idx="88">
                  <c:v>7.1892983749201198</c:v>
                </c:pt>
                <c:pt idx="89">
                  <c:v>7.1892983749201198</c:v>
                </c:pt>
                <c:pt idx="90">
                  <c:v>7.1892983749201198</c:v>
                </c:pt>
                <c:pt idx="91">
                  <c:v>7.1892983749201198</c:v>
                </c:pt>
                <c:pt idx="92">
                  <c:v>7.1892983749201198</c:v>
                </c:pt>
                <c:pt idx="93">
                  <c:v>7.1892983749201198</c:v>
                </c:pt>
                <c:pt idx="94">
                  <c:v>7.1892983749201198</c:v>
                </c:pt>
                <c:pt idx="95">
                  <c:v>7.1892983749201198</c:v>
                </c:pt>
                <c:pt idx="96">
                  <c:v>7.1892983749201198</c:v>
                </c:pt>
                <c:pt idx="97">
                  <c:v>7.1892983749201198</c:v>
                </c:pt>
                <c:pt idx="98">
                  <c:v>7.1892983749201198</c:v>
                </c:pt>
                <c:pt idx="99">
                  <c:v>7.1892983749201198</c:v>
                </c:pt>
                <c:pt idx="100">
                  <c:v>7.1892983749201198</c:v>
                </c:pt>
                <c:pt idx="101">
                  <c:v>7.1892983749201198</c:v>
                </c:pt>
                <c:pt idx="102">
                  <c:v>7.1892983749201198</c:v>
                </c:pt>
                <c:pt idx="103">
                  <c:v>7.1892983749201198</c:v>
                </c:pt>
                <c:pt idx="104">
                  <c:v>7.1892983749201198</c:v>
                </c:pt>
                <c:pt idx="105">
                  <c:v>7.1892983749201198</c:v>
                </c:pt>
                <c:pt idx="106">
                  <c:v>7.1892983749201198</c:v>
                </c:pt>
                <c:pt idx="107">
                  <c:v>7.1892983749201198</c:v>
                </c:pt>
                <c:pt idx="108">
                  <c:v>7.1892983749201198</c:v>
                </c:pt>
                <c:pt idx="109">
                  <c:v>7.1892983749201198</c:v>
                </c:pt>
                <c:pt idx="110">
                  <c:v>7.1892983749201198</c:v>
                </c:pt>
                <c:pt idx="111">
                  <c:v>7.1892983749201198</c:v>
                </c:pt>
                <c:pt idx="112">
                  <c:v>7.1892983749201198</c:v>
                </c:pt>
                <c:pt idx="113">
                  <c:v>7.1892983749201198</c:v>
                </c:pt>
                <c:pt idx="114">
                  <c:v>7.1892983749201198</c:v>
                </c:pt>
                <c:pt idx="115">
                  <c:v>7.1892983749201198</c:v>
                </c:pt>
                <c:pt idx="116">
                  <c:v>7.1892983749201198</c:v>
                </c:pt>
                <c:pt idx="117">
                  <c:v>7.1892983749201198</c:v>
                </c:pt>
                <c:pt idx="118">
                  <c:v>7.1892983749201198</c:v>
                </c:pt>
                <c:pt idx="119">
                  <c:v>7.1892983749201198</c:v>
                </c:pt>
                <c:pt idx="120">
                  <c:v>7.1892983749201198</c:v>
                </c:pt>
                <c:pt idx="121">
                  <c:v>7.1892983749201198</c:v>
                </c:pt>
                <c:pt idx="122">
                  <c:v>7.1892983749201198</c:v>
                </c:pt>
                <c:pt idx="123">
                  <c:v>7.1892983749201198</c:v>
                </c:pt>
                <c:pt idx="124">
                  <c:v>7.1892983749201198</c:v>
                </c:pt>
                <c:pt idx="125">
                  <c:v>7.1892983749201198</c:v>
                </c:pt>
                <c:pt idx="126">
                  <c:v>7.1892983749201198</c:v>
                </c:pt>
                <c:pt idx="127">
                  <c:v>7.1892983749201198</c:v>
                </c:pt>
                <c:pt idx="128">
                  <c:v>7.1892983749201198</c:v>
                </c:pt>
                <c:pt idx="129">
                  <c:v>7.18929837492011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5035-4141-A122-8241DEEBFBF8}"/>
            </c:ext>
          </c:extLst>
        </c:ser>
        <c:ser>
          <c:idx val="7"/>
          <c:order val="7"/>
          <c:tx>
            <c:strRef>
              <c:f>Sheet2!$N$3</c:f>
              <c:strCache>
                <c:ptCount val="1"/>
                <c:pt idx="0">
                  <c:v>(-2SD)</c:v>
                </c:pt>
              </c:strCache>
            </c:strRef>
          </c:tx>
          <c:spPr>
            <a:ln w="19050" cap="rnd">
              <a:solidFill>
                <a:srgbClr val="00B0F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F0"/>
              </a:solidFill>
              <a:ln w="9525">
                <a:solidFill>
                  <a:srgbClr val="00B0F0"/>
                </a:solidFill>
              </a:ln>
              <a:effectLst/>
            </c:spPr>
          </c:marker>
          <c:xVal>
            <c:numRef>
              <c:f>Sheet2!$F$4:$F$133</c:f>
              <c:numCache>
                <c:formatCode>0.00</c:formatCode>
                <c:ptCount val="13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</c:numCache>
            </c:numRef>
          </c:xVal>
          <c:yVal>
            <c:numRef>
              <c:f>Sheet2!$N$4:$N$133</c:f>
              <c:numCache>
                <c:formatCode>General</c:formatCode>
                <c:ptCount val="130"/>
                <c:pt idx="0">
                  <c:v>6.8870836729171554</c:v>
                </c:pt>
                <c:pt idx="1">
                  <c:v>6.8870836729171554</c:v>
                </c:pt>
                <c:pt idx="2">
                  <c:v>6.8870836729171554</c:v>
                </c:pt>
                <c:pt idx="3">
                  <c:v>6.8870836729171554</c:v>
                </c:pt>
                <c:pt idx="4">
                  <c:v>6.8870836729171554</c:v>
                </c:pt>
                <c:pt idx="5">
                  <c:v>6.8870836729171554</c:v>
                </c:pt>
                <c:pt idx="6">
                  <c:v>6.8870836729171554</c:v>
                </c:pt>
                <c:pt idx="7">
                  <c:v>6.8870836729171554</c:v>
                </c:pt>
                <c:pt idx="8">
                  <c:v>6.8870836729171554</c:v>
                </c:pt>
                <c:pt idx="9">
                  <c:v>6.8870836729171554</c:v>
                </c:pt>
                <c:pt idx="10">
                  <c:v>6.8870836729171554</c:v>
                </c:pt>
                <c:pt idx="11">
                  <c:v>6.8870836729171554</c:v>
                </c:pt>
                <c:pt idx="12">
                  <c:v>6.8870836729171554</c:v>
                </c:pt>
                <c:pt idx="13">
                  <c:v>6.8870836729171554</c:v>
                </c:pt>
                <c:pt idx="14">
                  <c:v>6.8870836729171554</c:v>
                </c:pt>
                <c:pt idx="15">
                  <c:v>6.8870836729171554</c:v>
                </c:pt>
                <c:pt idx="16">
                  <c:v>6.8870836729171554</c:v>
                </c:pt>
                <c:pt idx="17">
                  <c:v>6.8870836729171554</c:v>
                </c:pt>
                <c:pt idx="18">
                  <c:v>6.8870836729171554</c:v>
                </c:pt>
                <c:pt idx="19">
                  <c:v>6.8870836729171554</c:v>
                </c:pt>
                <c:pt idx="20">
                  <c:v>6.8870836729171554</c:v>
                </c:pt>
                <c:pt idx="21">
                  <c:v>6.8870836729171554</c:v>
                </c:pt>
                <c:pt idx="22">
                  <c:v>6.8870836729171554</c:v>
                </c:pt>
                <c:pt idx="23">
                  <c:v>6.8870836729171554</c:v>
                </c:pt>
                <c:pt idx="24">
                  <c:v>6.8870836729171554</c:v>
                </c:pt>
                <c:pt idx="25">
                  <c:v>6.8870836729171554</c:v>
                </c:pt>
                <c:pt idx="26">
                  <c:v>6.8870836729171554</c:v>
                </c:pt>
                <c:pt idx="27">
                  <c:v>6.8870836729171554</c:v>
                </c:pt>
                <c:pt idx="28">
                  <c:v>6.8870836729171554</c:v>
                </c:pt>
                <c:pt idx="29">
                  <c:v>6.8870836729171554</c:v>
                </c:pt>
                <c:pt idx="30">
                  <c:v>6.8870836729171554</c:v>
                </c:pt>
                <c:pt idx="31">
                  <c:v>6.8870836729171554</c:v>
                </c:pt>
                <c:pt idx="32">
                  <c:v>6.8870836729171554</c:v>
                </c:pt>
                <c:pt idx="33">
                  <c:v>6.8870836729171554</c:v>
                </c:pt>
                <c:pt idx="34">
                  <c:v>6.8870836729171554</c:v>
                </c:pt>
                <c:pt idx="35">
                  <c:v>6.8870836729171554</c:v>
                </c:pt>
                <c:pt idx="36">
                  <c:v>6.8870836729171554</c:v>
                </c:pt>
                <c:pt idx="37">
                  <c:v>6.8870836729171554</c:v>
                </c:pt>
                <c:pt idx="38">
                  <c:v>6.8870836729171554</c:v>
                </c:pt>
                <c:pt idx="39">
                  <c:v>6.8870836729171554</c:v>
                </c:pt>
                <c:pt idx="40">
                  <c:v>6.8870836729171554</c:v>
                </c:pt>
                <c:pt idx="41">
                  <c:v>6.8870836729171554</c:v>
                </c:pt>
                <c:pt idx="42">
                  <c:v>6.8870836729171554</c:v>
                </c:pt>
                <c:pt idx="43">
                  <c:v>6.8870836729171554</c:v>
                </c:pt>
                <c:pt idx="44">
                  <c:v>6.8870836729171554</c:v>
                </c:pt>
                <c:pt idx="45">
                  <c:v>6.8870836729171554</c:v>
                </c:pt>
                <c:pt idx="46">
                  <c:v>6.8870836729171554</c:v>
                </c:pt>
                <c:pt idx="47">
                  <c:v>6.8870836729171554</c:v>
                </c:pt>
                <c:pt idx="48">
                  <c:v>6.8870836729171554</c:v>
                </c:pt>
                <c:pt idx="49">
                  <c:v>6.8870836729171554</c:v>
                </c:pt>
                <c:pt idx="50">
                  <c:v>6.8870836729171554</c:v>
                </c:pt>
                <c:pt idx="51">
                  <c:v>6.8870836729171554</c:v>
                </c:pt>
                <c:pt idx="52">
                  <c:v>6.8870836729171554</c:v>
                </c:pt>
                <c:pt idx="53">
                  <c:v>6.8870836729171554</c:v>
                </c:pt>
                <c:pt idx="54">
                  <c:v>6.8870836729171554</c:v>
                </c:pt>
                <c:pt idx="55">
                  <c:v>6.8870836729171554</c:v>
                </c:pt>
                <c:pt idx="56">
                  <c:v>6.8870836729171554</c:v>
                </c:pt>
                <c:pt idx="57">
                  <c:v>6.8870836729171554</c:v>
                </c:pt>
                <c:pt idx="58">
                  <c:v>6.8870836729171554</c:v>
                </c:pt>
                <c:pt idx="59">
                  <c:v>6.8870836729171554</c:v>
                </c:pt>
                <c:pt idx="60">
                  <c:v>6.8870836729171554</c:v>
                </c:pt>
                <c:pt idx="61">
                  <c:v>6.8870836729171554</c:v>
                </c:pt>
                <c:pt idx="62">
                  <c:v>6.8870836729171554</c:v>
                </c:pt>
                <c:pt idx="63">
                  <c:v>6.8870836729171554</c:v>
                </c:pt>
                <c:pt idx="64">
                  <c:v>6.8870836729171554</c:v>
                </c:pt>
                <c:pt idx="65">
                  <c:v>6.8870836729171554</c:v>
                </c:pt>
                <c:pt idx="66">
                  <c:v>6.8870836729171554</c:v>
                </c:pt>
                <c:pt idx="67">
                  <c:v>6.8870836729171554</c:v>
                </c:pt>
                <c:pt idx="68">
                  <c:v>6.8870836729171554</c:v>
                </c:pt>
                <c:pt idx="69">
                  <c:v>6.8870836729171554</c:v>
                </c:pt>
                <c:pt idx="70">
                  <c:v>6.8870836729171554</c:v>
                </c:pt>
                <c:pt idx="71">
                  <c:v>6.8870836729171554</c:v>
                </c:pt>
                <c:pt idx="72">
                  <c:v>6.8870836729171554</c:v>
                </c:pt>
                <c:pt idx="73">
                  <c:v>6.8870836729171554</c:v>
                </c:pt>
                <c:pt idx="74">
                  <c:v>6.8870836729171554</c:v>
                </c:pt>
                <c:pt idx="75">
                  <c:v>6.8870836729171554</c:v>
                </c:pt>
                <c:pt idx="76">
                  <c:v>6.8870836729171554</c:v>
                </c:pt>
                <c:pt idx="77">
                  <c:v>6.8870836729171554</c:v>
                </c:pt>
                <c:pt idx="78">
                  <c:v>6.8870836729171554</c:v>
                </c:pt>
                <c:pt idx="79">
                  <c:v>6.8870836729171554</c:v>
                </c:pt>
                <c:pt idx="80">
                  <c:v>6.8870836729171554</c:v>
                </c:pt>
                <c:pt idx="81">
                  <c:v>6.8870836729171554</c:v>
                </c:pt>
                <c:pt idx="82">
                  <c:v>6.8870836729171554</c:v>
                </c:pt>
                <c:pt idx="83">
                  <c:v>6.8870836729171554</c:v>
                </c:pt>
                <c:pt idx="84">
                  <c:v>6.8870836729171554</c:v>
                </c:pt>
                <c:pt idx="85">
                  <c:v>6.8870836729171554</c:v>
                </c:pt>
                <c:pt idx="86">
                  <c:v>6.8870836729171554</c:v>
                </c:pt>
                <c:pt idx="87">
                  <c:v>6.8870836729171554</c:v>
                </c:pt>
                <c:pt idx="88">
                  <c:v>6.8870836729171554</c:v>
                </c:pt>
                <c:pt idx="89">
                  <c:v>6.8870836729171554</c:v>
                </c:pt>
                <c:pt idx="90">
                  <c:v>6.8870836729171554</c:v>
                </c:pt>
                <c:pt idx="91">
                  <c:v>6.8870836729171554</c:v>
                </c:pt>
                <c:pt idx="92">
                  <c:v>6.8870836729171554</c:v>
                </c:pt>
                <c:pt idx="93">
                  <c:v>6.8870836729171554</c:v>
                </c:pt>
                <c:pt idx="94">
                  <c:v>6.8870836729171554</c:v>
                </c:pt>
                <c:pt idx="95">
                  <c:v>6.8870836729171554</c:v>
                </c:pt>
                <c:pt idx="96">
                  <c:v>6.8870836729171554</c:v>
                </c:pt>
                <c:pt idx="97">
                  <c:v>6.8870836729171554</c:v>
                </c:pt>
                <c:pt idx="98">
                  <c:v>6.8870836729171554</c:v>
                </c:pt>
                <c:pt idx="99">
                  <c:v>6.8870836729171554</c:v>
                </c:pt>
                <c:pt idx="100">
                  <c:v>6.8870836729171554</c:v>
                </c:pt>
                <c:pt idx="101">
                  <c:v>6.8870836729171554</c:v>
                </c:pt>
                <c:pt idx="102">
                  <c:v>6.8870836729171554</c:v>
                </c:pt>
                <c:pt idx="103">
                  <c:v>6.8870836729171554</c:v>
                </c:pt>
                <c:pt idx="104">
                  <c:v>6.8870836729171554</c:v>
                </c:pt>
                <c:pt idx="105">
                  <c:v>6.8870836729171554</c:v>
                </c:pt>
                <c:pt idx="106">
                  <c:v>6.8870836729171554</c:v>
                </c:pt>
                <c:pt idx="107">
                  <c:v>6.8870836729171554</c:v>
                </c:pt>
                <c:pt idx="108">
                  <c:v>6.8870836729171554</c:v>
                </c:pt>
                <c:pt idx="109">
                  <c:v>6.8870836729171554</c:v>
                </c:pt>
                <c:pt idx="110">
                  <c:v>6.8870836729171554</c:v>
                </c:pt>
                <c:pt idx="111">
                  <c:v>6.8870836729171554</c:v>
                </c:pt>
                <c:pt idx="112">
                  <c:v>6.8870836729171554</c:v>
                </c:pt>
                <c:pt idx="113">
                  <c:v>6.8870836729171554</c:v>
                </c:pt>
                <c:pt idx="114">
                  <c:v>6.8870836729171554</c:v>
                </c:pt>
                <c:pt idx="115">
                  <c:v>6.8870836729171554</c:v>
                </c:pt>
                <c:pt idx="116">
                  <c:v>6.8870836729171554</c:v>
                </c:pt>
                <c:pt idx="117">
                  <c:v>6.8870836729171554</c:v>
                </c:pt>
                <c:pt idx="118">
                  <c:v>6.8870836729171554</c:v>
                </c:pt>
                <c:pt idx="119">
                  <c:v>6.8870836729171554</c:v>
                </c:pt>
                <c:pt idx="120">
                  <c:v>6.8870836729171554</c:v>
                </c:pt>
                <c:pt idx="121">
                  <c:v>6.8870836729171554</c:v>
                </c:pt>
                <c:pt idx="122">
                  <c:v>6.8870836729171554</c:v>
                </c:pt>
                <c:pt idx="123">
                  <c:v>6.8870836729171554</c:v>
                </c:pt>
                <c:pt idx="124">
                  <c:v>6.8870836729171554</c:v>
                </c:pt>
                <c:pt idx="125">
                  <c:v>6.8870836729171554</c:v>
                </c:pt>
                <c:pt idx="126">
                  <c:v>6.8870836729171554</c:v>
                </c:pt>
                <c:pt idx="127">
                  <c:v>6.8870836729171554</c:v>
                </c:pt>
                <c:pt idx="128">
                  <c:v>6.8870836729171554</c:v>
                </c:pt>
                <c:pt idx="129">
                  <c:v>6.887083672917155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5035-4141-A122-8241DEEBFBF8}"/>
            </c:ext>
          </c:extLst>
        </c:ser>
        <c:ser>
          <c:idx val="8"/>
          <c:order val="8"/>
          <c:tx>
            <c:strRef>
              <c:f>Sheet2!$O$3</c:f>
              <c:strCache>
                <c:ptCount val="1"/>
                <c:pt idx="0">
                  <c:v>(-3SD)</c:v>
                </c:pt>
              </c:strCache>
            </c:strRef>
          </c:tx>
          <c:spPr>
            <a:ln w="19050" cap="rnd">
              <a:solidFill>
                <a:schemeClr val="accent3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>
                    <a:lumMod val="75000"/>
                  </a:schemeClr>
                </a:solidFill>
              </a:ln>
              <a:effectLst/>
            </c:spPr>
          </c:marker>
          <c:xVal>
            <c:numRef>
              <c:f>Sheet2!$F$4:$F$133</c:f>
              <c:numCache>
                <c:formatCode>0.00</c:formatCode>
                <c:ptCount val="13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</c:numCache>
            </c:numRef>
          </c:xVal>
          <c:yVal>
            <c:numRef>
              <c:f>Sheet2!$O$4:$O$133</c:f>
              <c:numCache>
                <c:formatCode>General</c:formatCode>
                <c:ptCount val="130"/>
                <c:pt idx="0">
                  <c:v>6.5848689709141945</c:v>
                </c:pt>
                <c:pt idx="1">
                  <c:v>6.5848689709141945</c:v>
                </c:pt>
                <c:pt idx="2">
                  <c:v>6.5848689709141945</c:v>
                </c:pt>
                <c:pt idx="3">
                  <c:v>6.5848689709141945</c:v>
                </c:pt>
                <c:pt idx="4">
                  <c:v>6.5848689709141945</c:v>
                </c:pt>
                <c:pt idx="5">
                  <c:v>6.5848689709141945</c:v>
                </c:pt>
                <c:pt idx="6">
                  <c:v>6.5848689709141945</c:v>
                </c:pt>
                <c:pt idx="7">
                  <c:v>6.5848689709141945</c:v>
                </c:pt>
                <c:pt idx="8">
                  <c:v>6.5848689709141945</c:v>
                </c:pt>
                <c:pt idx="9">
                  <c:v>6.5848689709141945</c:v>
                </c:pt>
                <c:pt idx="10">
                  <c:v>6.5848689709141945</c:v>
                </c:pt>
                <c:pt idx="11">
                  <c:v>6.5848689709141945</c:v>
                </c:pt>
                <c:pt idx="12">
                  <c:v>6.5848689709141945</c:v>
                </c:pt>
                <c:pt idx="13">
                  <c:v>6.5848689709141945</c:v>
                </c:pt>
                <c:pt idx="14">
                  <c:v>6.5848689709141945</c:v>
                </c:pt>
                <c:pt idx="15">
                  <c:v>6.5848689709141945</c:v>
                </c:pt>
                <c:pt idx="16">
                  <c:v>6.5848689709141945</c:v>
                </c:pt>
                <c:pt idx="17">
                  <c:v>6.5848689709141945</c:v>
                </c:pt>
                <c:pt idx="18">
                  <c:v>6.5848689709141945</c:v>
                </c:pt>
                <c:pt idx="19">
                  <c:v>6.5848689709141945</c:v>
                </c:pt>
                <c:pt idx="20">
                  <c:v>6.5848689709141945</c:v>
                </c:pt>
                <c:pt idx="21">
                  <c:v>6.5848689709141945</c:v>
                </c:pt>
                <c:pt idx="22">
                  <c:v>6.5848689709141945</c:v>
                </c:pt>
                <c:pt idx="23">
                  <c:v>6.5848689709141945</c:v>
                </c:pt>
                <c:pt idx="24">
                  <c:v>6.5848689709141945</c:v>
                </c:pt>
                <c:pt idx="25">
                  <c:v>6.5848689709141945</c:v>
                </c:pt>
                <c:pt idx="26">
                  <c:v>6.5848689709141945</c:v>
                </c:pt>
                <c:pt idx="27">
                  <c:v>6.5848689709141945</c:v>
                </c:pt>
                <c:pt idx="28">
                  <c:v>6.5848689709141945</c:v>
                </c:pt>
                <c:pt idx="29">
                  <c:v>6.5848689709141945</c:v>
                </c:pt>
                <c:pt idx="30">
                  <c:v>6.5848689709141945</c:v>
                </c:pt>
                <c:pt idx="31">
                  <c:v>6.5848689709141945</c:v>
                </c:pt>
                <c:pt idx="32">
                  <c:v>6.5848689709141945</c:v>
                </c:pt>
                <c:pt idx="33">
                  <c:v>6.5848689709141945</c:v>
                </c:pt>
                <c:pt idx="34">
                  <c:v>6.5848689709141945</c:v>
                </c:pt>
                <c:pt idx="35">
                  <c:v>6.5848689709141945</c:v>
                </c:pt>
                <c:pt idx="36">
                  <c:v>6.5848689709141945</c:v>
                </c:pt>
                <c:pt idx="37">
                  <c:v>6.5848689709141945</c:v>
                </c:pt>
                <c:pt idx="38">
                  <c:v>6.5848689709141945</c:v>
                </c:pt>
                <c:pt idx="39">
                  <c:v>6.5848689709141945</c:v>
                </c:pt>
                <c:pt idx="40">
                  <c:v>6.5848689709141945</c:v>
                </c:pt>
                <c:pt idx="41">
                  <c:v>6.5848689709141945</c:v>
                </c:pt>
                <c:pt idx="42">
                  <c:v>6.5848689709141945</c:v>
                </c:pt>
                <c:pt idx="43">
                  <c:v>6.5848689709141945</c:v>
                </c:pt>
                <c:pt idx="44">
                  <c:v>6.5848689709141945</c:v>
                </c:pt>
                <c:pt idx="45">
                  <c:v>6.5848689709141945</c:v>
                </c:pt>
                <c:pt idx="46">
                  <c:v>6.5848689709141945</c:v>
                </c:pt>
                <c:pt idx="47">
                  <c:v>6.5848689709141945</c:v>
                </c:pt>
                <c:pt idx="48">
                  <c:v>6.5848689709141945</c:v>
                </c:pt>
                <c:pt idx="49">
                  <c:v>6.5848689709141945</c:v>
                </c:pt>
                <c:pt idx="50">
                  <c:v>6.5848689709141945</c:v>
                </c:pt>
                <c:pt idx="51">
                  <c:v>6.5848689709141945</c:v>
                </c:pt>
                <c:pt idx="52">
                  <c:v>6.5848689709141945</c:v>
                </c:pt>
                <c:pt idx="53">
                  <c:v>6.5848689709141945</c:v>
                </c:pt>
                <c:pt idx="54">
                  <c:v>6.5848689709141945</c:v>
                </c:pt>
                <c:pt idx="55">
                  <c:v>6.5848689709141945</c:v>
                </c:pt>
                <c:pt idx="56">
                  <c:v>6.5848689709141945</c:v>
                </c:pt>
                <c:pt idx="57">
                  <c:v>6.5848689709141945</c:v>
                </c:pt>
                <c:pt idx="58">
                  <c:v>6.5848689709141945</c:v>
                </c:pt>
                <c:pt idx="59">
                  <c:v>6.5848689709141945</c:v>
                </c:pt>
                <c:pt idx="60">
                  <c:v>6.5848689709141945</c:v>
                </c:pt>
                <c:pt idx="61">
                  <c:v>6.5848689709141945</c:v>
                </c:pt>
                <c:pt idx="62">
                  <c:v>6.5848689709141945</c:v>
                </c:pt>
                <c:pt idx="63">
                  <c:v>6.5848689709141945</c:v>
                </c:pt>
                <c:pt idx="64">
                  <c:v>6.5848689709141945</c:v>
                </c:pt>
                <c:pt idx="65">
                  <c:v>6.5848689709141945</c:v>
                </c:pt>
                <c:pt idx="66">
                  <c:v>6.5848689709141945</c:v>
                </c:pt>
                <c:pt idx="67">
                  <c:v>6.5848689709141945</c:v>
                </c:pt>
                <c:pt idx="68">
                  <c:v>6.5848689709141945</c:v>
                </c:pt>
                <c:pt idx="69">
                  <c:v>6.5848689709141945</c:v>
                </c:pt>
                <c:pt idx="70">
                  <c:v>6.5848689709141945</c:v>
                </c:pt>
                <c:pt idx="71">
                  <c:v>6.5848689709141945</c:v>
                </c:pt>
                <c:pt idx="72">
                  <c:v>6.5848689709141945</c:v>
                </c:pt>
                <c:pt idx="73">
                  <c:v>6.5848689709141945</c:v>
                </c:pt>
                <c:pt idx="74">
                  <c:v>6.5848689709141945</c:v>
                </c:pt>
                <c:pt idx="75">
                  <c:v>6.5848689709141945</c:v>
                </c:pt>
                <c:pt idx="76">
                  <c:v>6.5848689709141945</c:v>
                </c:pt>
                <c:pt idx="77">
                  <c:v>6.5848689709141945</c:v>
                </c:pt>
                <c:pt idx="78">
                  <c:v>6.5848689709141945</c:v>
                </c:pt>
                <c:pt idx="79">
                  <c:v>6.5848689709141945</c:v>
                </c:pt>
                <c:pt idx="80">
                  <c:v>6.5848689709141945</c:v>
                </c:pt>
                <c:pt idx="81">
                  <c:v>6.5848689709141945</c:v>
                </c:pt>
                <c:pt idx="82">
                  <c:v>6.5848689709141945</c:v>
                </c:pt>
                <c:pt idx="83">
                  <c:v>6.5848689709141945</c:v>
                </c:pt>
                <c:pt idx="84">
                  <c:v>6.5848689709141945</c:v>
                </c:pt>
                <c:pt idx="85">
                  <c:v>6.5848689709141945</c:v>
                </c:pt>
                <c:pt idx="86">
                  <c:v>6.5848689709141945</c:v>
                </c:pt>
                <c:pt idx="87">
                  <c:v>6.5848689709141945</c:v>
                </c:pt>
                <c:pt idx="88">
                  <c:v>6.5848689709141945</c:v>
                </c:pt>
                <c:pt idx="89">
                  <c:v>6.5848689709141945</c:v>
                </c:pt>
                <c:pt idx="90">
                  <c:v>6.5848689709141945</c:v>
                </c:pt>
                <c:pt idx="91">
                  <c:v>6.5848689709141945</c:v>
                </c:pt>
                <c:pt idx="92">
                  <c:v>6.5848689709141945</c:v>
                </c:pt>
                <c:pt idx="93">
                  <c:v>6.5848689709141945</c:v>
                </c:pt>
                <c:pt idx="94">
                  <c:v>6.5848689709141945</c:v>
                </c:pt>
                <c:pt idx="95">
                  <c:v>6.5848689709141945</c:v>
                </c:pt>
                <c:pt idx="96">
                  <c:v>6.5848689709141945</c:v>
                </c:pt>
                <c:pt idx="97">
                  <c:v>6.5848689709141945</c:v>
                </c:pt>
                <c:pt idx="98">
                  <c:v>6.5848689709141945</c:v>
                </c:pt>
                <c:pt idx="99">
                  <c:v>6.5848689709141945</c:v>
                </c:pt>
                <c:pt idx="100">
                  <c:v>6.5848689709141945</c:v>
                </c:pt>
                <c:pt idx="101">
                  <c:v>6.5848689709141945</c:v>
                </c:pt>
                <c:pt idx="102">
                  <c:v>6.5848689709141945</c:v>
                </c:pt>
                <c:pt idx="103">
                  <c:v>6.5848689709141945</c:v>
                </c:pt>
                <c:pt idx="104">
                  <c:v>6.5848689709141945</c:v>
                </c:pt>
                <c:pt idx="105">
                  <c:v>6.5848689709141945</c:v>
                </c:pt>
                <c:pt idx="106">
                  <c:v>6.5848689709141945</c:v>
                </c:pt>
                <c:pt idx="107">
                  <c:v>6.5848689709141945</c:v>
                </c:pt>
                <c:pt idx="108">
                  <c:v>6.5848689709141945</c:v>
                </c:pt>
                <c:pt idx="109">
                  <c:v>6.5848689709141945</c:v>
                </c:pt>
                <c:pt idx="110">
                  <c:v>6.5848689709141945</c:v>
                </c:pt>
                <c:pt idx="111">
                  <c:v>6.5848689709141945</c:v>
                </c:pt>
                <c:pt idx="112">
                  <c:v>6.5848689709141945</c:v>
                </c:pt>
                <c:pt idx="113">
                  <c:v>6.5848689709141945</c:v>
                </c:pt>
                <c:pt idx="114">
                  <c:v>6.5848689709141945</c:v>
                </c:pt>
                <c:pt idx="115">
                  <c:v>6.5848689709141945</c:v>
                </c:pt>
                <c:pt idx="116">
                  <c:v>6.5848689709141945</c:v>
                </c:pt>
                <c:pt idx="117">
                  <c:v>6.5848689709141945</c:v>
                </c:pt>
                <c:pt idx="118">
                  <c:v>6.5848689709141945</c:v>
                </c:pt>
                <c:pt idx="119">
                  <c:v>6.5848689709141945</c:v>
                </c:pt>
                <c:pt idx="120">
                  <c:v>6.5848689709141945</c:v>
                </c:pt>
                <c:pt idx="121">
                  <c:v>6.5848689709141945</c:v>
                </c:pt>
                <c:pt idx="122">
                  <c:v>6.5848689709141945</c:v>
                </c:pt>
                <c:pt idx="123">
                  <c:v>6.5848689709141945</c:v>
                </c:pt>
                <c:pt idx="124">
                  <c:v>6.5848689709141945</c:v>
                </c:pt>
                <c:pt idx="125">
                  <c:v>6.5848689709141945</c:v>
                </c:pt>
                <c:pt idx="126">
                  <c:v>6.5848689709141945</c:v>
                </c:pt>
                <c:pt idx="127">
                  <c:v>6.5848689709141945</c:v>
                </c:pt>
                <c:pt idx="128">
                  <c:v>6.5848689709141945</c:v>
                </c:pt>
                <c:pt idx="129">
                  <c:v>6.584868970914194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8-5035-4141-A122-8241DEEBFBF8}"/>
            </c:ext>
          </c:extLst>
        </c:ser>
        <c:ser>
          <c:idx val="9"/>
          <c:order val="9"/>
          <c:tx>
            <c:strRef>
              <c:f>Sheet2!$P$3</c:f>
              <c:strCache>
                <c:ptCount val="1"/>
                <c:pt idx="0">
                  <c:v>(-4SD)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2!$F$4:$F$133</c:f>
              <c:numCache>
                <c:formatCode>0.00</c:formatCode>
                <c:ptCount val="13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  <c:pt idx="114">
                  <c:v>115</c:v>
                </c:pt>
                <c:pt idx="115">
                  <c:v>116</c:v>
                </c:pt>
                <c:pt idx="116">
                  <c:v>117</c:v>
                </c:pt>
                <c:pt idx="117">
                  <c:v>118</c:v>
                </c:pt>
                <c:pt idx="118">
                  <c:v>119</c:v>
                </c:pt>
                <c:pt idx="119">
                  <c:v>120</c:v>
                </c:pt>
                <c:pt idx="120">
                  <c:v>121</c:v>
                </c:pt>
                <c:pt idx="121">
                  <c:v>122</c:v>
                </c:pt>
                <c:pt idx="122">
                  <c:v>123</c:v>
                </c:pt>
                <c:pt idx="123">
                  <c:v>124</c:v>
                </c:pt>
                <c:pt idx="124">
                  <c:v>125</c:v>
                </c:pt>
                <c:pt idx="125">
                  <c:v>126</c:v>
                </c:pt>
                <c:pt idx="126">
                  <c:v>127</c:v>
                </c:pt>
                <c:pt idx="127">
                  <c:v>128</c:v>
                </c:pt>
                <c:pt idx="128">
                  <c:v>129</c:v>
                </c:pt>
                <c:pt idx="129">
                  <c:v>130</c:v>
                </c:pt>
              </c:numCache>
            </c:numRef>
          </c:xVal>
          <c:yVal>
            <c:numRef>
              <c:f>Sheet2!$P$4:$P$133</c:f>
              <c:numCache>
                <c:formatCode>General</c:formatCode>
                <c:ptCount val="130"/>
                <c:pt idx="0">
                  <c:v>6.2826542689112337</c:v>
                </c:pt>
                <c:pt idx="1">
                  <c:v>6.2826542689112337</c:v>
                </c:pt>
                <c:pt idx="2">
                  <c:v>6.2826542689112337</c:v>
                </c:pt>
                <c:pt idx="3">
                  <c:v>6.2826542689112337</c:v>
                </c:pt>
                <c:pt idx="4">
                  <c:v>6.2826542689112337</c:v>
                </c:pt>
                <c:pt idx="5">
                  <c:v>6.2826542689112337</c:v>
                </c:pt>
                <c:pt idx="6">
                  <c:v>6.2826542689112337</c:v>
                </c:pt>
                <c:pt idx="7">
                  <c:v>6.2826542689112337</c:v>
                </c:pt>
                <c:pt idx="8">
                  <c:v>6.2826542689112337</c:v>
                </c:pt>
                <c:pt idx="9">
                  <c:v>6.2826542689112337</c:v>
                </c:pt>
                <c:pt idx="10">
                  <c:v>6.2826542689112337</c:v>
                </c:pt>
                <c:pt idx="11">
                  <c:v>6.2826542689112337</c:v>
                </c:pt>
                <c:pt idx="12">
                  <c:v>6.2826542689112337</c:v>
                </c:pt>
                <c:pt idx="13">
                  <c:v>6.2826542689112337</c:v>
                </c:pt>
                <c:pt idx="14">
                  <c:v>6.2826542689112337</c:v>
                </c:pt>
                <c:pt idx="15">
                  <c:v>6.2826542689112337</c:v>
                </c:pt>
                <c:pt idx="16">
                  <c:v>6.2826542689112337</c:v>
                </c:pt>
                <c:pt idx="17">
                  <c:v>6.2826542689112337</c:v>
                </c:pt>
                <c:pt idx="18">
                  <c:v>6.2826542689112337</c:v>
                </c:pt>
                <c:pt idx="19">
                  <c:v>6.2826542689112337</c:v>
                </c:pt>
                <c:pt idx="20">
                  <c:v>6.2826542689112337</c:v>
                </c:pt>
                <c:pt idx="21">
                  <c:v>6.2826542689112337</c:v>
                </c:pt>
                <c:pt idx="22">
                  <c:v>6.2826542689112337</c:v>
                </c:pt>
                <c:pt idx="23">
                  <c:v>6.2826542689112337</c:v>
                </c:pt>
                <c:pt idx="24">
                  <c:v>6.2826542689112337</c:v>
                </c:pt>
                <c:pt idx="25">
                  <c:v>6.2826542689112337</c:v>
                </c:pt>
                <c:pt idx="26">
                  <c:v>6.2826542689112337</c:v>
                </c:pt>
                <c:pt idx="27">
                  <c:v>6.2826542689112337</c:v>
                </c:pt>
                <c:pt idx="28">
                  <c:v>6.2826542689112337</c:v>
                </c:pt>
                <c:pt idx="29">
                  <c:v>6.2826542689112337</c:v>
                </c:pt>
                <c:pt idx="30">
                  <c:v>6.2826542689112337</c:v>
                </c:pt>
                <c:pt idx="31">
                  <c:v>6.2826542689112337</c:v>
                </c:pt>
                <c:pt idx="32">
                  <c:v>6.2826542689112337</c:v>
                </c:pt>
                <c:pt idx="33">
                  <c:v>6.2826542689112337</c:v>
                </c:pt>
                <c:pt idx="34">
                  <c:v>6.2826542689112337</c:v>
                </c:pt>
                <c:pt idx="35">
                  <c:v>6.2826542689112337</c:v>
                </c:pt>
                <c:pt idx="36">
                  <c:v>6.2826542689112337</c:v>
                </c:pt>
                <c:pt idx="37">
                  <c:v>6.2826542689112337</c:v>
                </c:pt>
                <c:pt idx="38">
                  <c:v>6.2826542689112337</c:v>
                </c:pt>
                <c:pt idx="39">
                  <c:v>6.2826542689112337</c:v>
                </c:pt>
                <c:pt idx="40">
                  <c:v>6.2826542689112337</c:v>
                </c:pt>
                <c:pt idx="41">
                  <c:v>6.2826542689112337</c:v>
                </c:pt>
                <c:pt idx="42">
                  <c:v>6.2826542689112337</c:v>
                </c:pt>
                <c:pt idx="43">
                  <c:v>6.2826542689112337</c:v>
                </c:pt>
                <c:pt idx="44">
                  <c:v>6.2826542689112337</c:v>
                </c:pt>
                <c:pt idx="45">
                  <c:v>6.2826542689112337</c:v>
                </c:pt>
                <c:pt idx="46">
                  <c:v>6.2826542689112337</c:v>
                </c:pt>
                <c:pt idx="47">
                  <c:v>6.2826542689112337</c:v>
                </c:pt>
                <c:pt idx="48">
                  <c:v>6.2826542689112337</c:v>
                </c:pt>
                <c:pt idx="49">
                  <c:v>6.2826542689112337</c:v>
                </c:pt>
                <c:pt idx="50">
                  <c:v>6.2826542689112337</c:v>
                </c:pt>
                <c:pt idx="51">
                  <c:v>6.2826542689112337</c:v>
                </c:pt>
                <c:pt idx="52">
                  <c:v>6.2826542689112337</c:v>
                </c:pt>
                <c:pt idx="53">
                  <c:v>6.2826542689112337</c:v>
                </c:pt>
                <c:pt idx="54">
                  <c:v>6.2826542689112337</c:v>
                </c:pt>
                <c:pt idx="55">
                  <c:v>6.2826542689112337</c:v>
                </c:pt>
                <c:pt idx="56">
                  <c:v>6.2826542689112337</c:v>
                </c:pt>
                <c:pt idx="57">
                  <c:v>6.2826542689112337</c:v>
                </c:pt>
                <c:pt idx="58">
                  <c:v>6.2826542689112337</c:v>
                </c:pt>
                <c:pt idx="59">
                  <c:v>6.2826542689112337</c:v>
                </c:pt>
                <c:pt idx="60">
                  <c:v>6.2826542689112337</c:v>
                </c:pt>
                <c:pt idx="61">
                  <c:v>6.2826542689112337</c:v>
                </c:pt>
                <c:pt idx="62">
                  <c:v>6.2826542689112337</c:v>
                </c:pt>
                <c:pt idx="63">
                  <c:v>6.2826542689112337</c:v>
                </c:pt>
                <c:pt idx="64">
                  <c:v>6.2826542689112337</c:v>
                </c:pt>
                <c:pt idx="65">
                  <c:v>6.2826542689112337</c:v>
                </c:pt>
                <c:pt idx="66">
                  <c:v>6.2826542689112337</c:v>
                </c:pt>
                <c:pt idx="67">
                  <c:v>6.2826542689112337</c:v>
                </c:pt>
                <c:pt idx="68">
                  <c:v>6.2826542689112337</c:v>
                </c:pt>
                <c:pt idx="69">
                  <c:v>6.2826542689112337</c:v>
                </c:pt>
                <c:pt idx="70">
                  <c:v>6.2826542689112337</c:v>
                </c:pt>
                <c:pt idx="71">
                  <c:v>6.2826542689112337</c:v>
                </c:pt>
                <c:pt idx="72">
                  <c:v>6.2826542689112337</c:v>
                </c:pt>
                <c:pt idx="73">
                  <c:v>6.2826542689112337</c:v>
                </c:pt>
                <c:pt idx="74">
                  <c:v>6.2826542689112337</c:v>
                </c:pt>
                <c:pt idx="75">
                  <c:v>6.2826542689112337</c:v>
                </c:pt>
                <c:pt idx="76">
                  <c:v>6.2826542689112337</c:v>
                </c:pt>
                <c:pt idx="77">
                  <c:v>6.2826542689112337</c:v>
                </c:pt>
                <c:pt idx="78">
                  <c:v>6.2826542689112337</c:v>
                </c:pt>
                <c:pt idx="79">
                  <c:v>6.2826542689112337</c:v>
                </c:pt>
                <c:pt idx="80">
                  <c:v>6.2826542689112337</c:v>
                </c:pt>
                <c:pt idx="81">
                  <c:v>6.2826542689112337</c:v>
                </c:pt>
                <c:pt idx="82">
                  <c:v>6.2826542689112337</c:v>
                </c:pt>
                <c:pt idx="83">
                  <c:v>6.2826542689112337</c:v>
                </c:pt>
                <c:pt idx="84">
                  <c:v>6.2826542689112337</c:v>
                </c:pt>
                <c:pt idx="85">
                  <c:v>6.2826542689112337</c:v>
                </c:pt>
                <c:pt idx="86">
                  <c:v>6.2826542689112337</c:v>
                </c:pt>
                <c:pt idx="87">
                  <c:v>6.2826542689112337</c:v>
                </c:pt>
                <c:pt idx="88">
                  <c:v>6.2826542689112337</c:v>
                </c:pt>
                <c:pt idx="89">
                  <c:v>6.2826542689112337</c:v>
                </c:pt>
                <c:pt idx="90">
                  <c:v>6.2826542689112337</c:v>
                </c:pt>
                <c:pt idx="91">
                  <c:v>6.2826542689112337</c:v>
                </c:pt>
                <c:pt idx="92">
                  <c:v>6.2826542689112337</c:v>
                </c:pt>
                <c:pt idx="93">
                  <c:v>6.2826542689112337</c:v>
                </c:pt>
                <c:pt idx="94">
                  <c:v>6.2826542689112337</c:v>
                </c:pt>
                <c:pt idx="95">
                  <c:v>6.2826542689112337</c:v>
                </c:pt>
                <c:pt idx="96">
                  <c:v>6.2826542689112337</c:v>
                </c:pt>
                <c:pt idx="97">
                  <c:v>6.2826542689112337</c:v>
                </c:pt>
                <c:pt idx="98">
                  <c:v>6.2826542689112337</c:v>
                </c:pt>
                <c:pt idx="99">
                  <c:v>6.2826542689112337</c:v>
                </c:pt>
                <c:pt idx="100">
                  <c:v>6.2826542689112337</c:v>
                </c:pt>
                <c:pt idx="101">
                  <c:v>6.2826542689112337</c:v>
                </c:pt>
                <c:pt idx="102">
                  <c:v>6.2826542689112337</c:v>
                </c:pt>
                <c:pt idx="103">
                  <c:v>6.2826542689112337</c:v>
                </c:pt>
                <c:pt idx="104">
                  <c:v>6.2826542689112337</c:v>
                </c:pt>
                <c:pt idx="105">
                  <c:v>6.2826542689112337</c:v>
                </c:pt>
                <c:pt idx="106">
                  <c:v>6.2826542689112337</c:v>
                </c:pt>
                <c:pt idx="107">
                  <c:v>6.2826542689112337</c:v>
                </c:pt>
                <c:pt idx="108">
                  <c:v>6.2826542689112337</c:v>
                </c:pt>
                <c:pt idx="109">
                  <c:v>6.2826542689112337</c:v>
                </c:pt>
                <c:pt idx="110">
                  <c:v>6.2826542689112337</c:v>
                </c:pt>
                <c:pt idx="111">
                  <c:v>6.2826542689112337</c:v>
                </c:pt>
                <c:pt idx="112">
                  <c:v>6.2826542689112337</c:v>
                </c:pt>
                <c:pt idx="113">
                  <c:v>6.2826542689112337</c:v>
                </c:pt>
                <c:pt idx="114">
                  <c:v>6.2826542689112337</c:v>
                </c:pt>
                <c:pt idx="115">
                  <c:v>6.2826542689112337</c:v>
                </c:pt>
                <c:pt idx="116">
                  <c:v>6.2826542689112337</c:v>
                </c:pt>
                <c:pt idx="117">
                  <c:v>6.2826542689112337</c:v>
                </c:pt>
                <c:pt idx="118">
                  <c:v>6.2826542689112337</c:v>
                </c:pt>
                <c:pt idx="119">
                  <c:v>6.2826542689112337</c:v>
                </c:pt>
                <c:pt idx="120">
                  <c:v>6.2826542689112337</c:v>
                </c:pt>
                <c:pt idx="121">
                  <c:v>6.2826542689112337</c:v>
                </c:pt>
                <c:pt idx="122">
                  <c:v>6.2826542689112337</c:v>
                </c:pt>
                <c:pt idx="123">
                  <c:v>6.2826542689112337</c:v>
                </c:pt>
                <c:pt idx="124">
                  <c:v>6.2826542689112337</c:v>
                </c:pt>
                <c:pt idx="125">
                  <c:v>6.2826542689112337</c:v>
                </c:pt>
                <c:pt idx="126">
                  <c:v>6.2826542689112337</c:v>
                </c:pt>
                <c:pt idx="127">
                  <c:v>6.2826542689112337</c:v>
                </c:pt>
                <c:pt idx="128">
                  <c:v>6.2826542689112337</c:v>
                </c:pt>
                <c:pt idx="129">
                  <c:v>6.282654268911233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9-5035-4141-A122-8241DEEBFB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86814943"/>
        <c:axId val="1386812543"/>
      </c:scatterChart>
      <c:valAx>
        <c:axId val="1386814943"/>
        <c:scaling>
          <c:orientation val="minMax"/>
          <c:max val="130"/>
          <c:min val="0"/>
        </c:scaling>
        <c:delete val="0"/>
        <c:axPos val="b"/>
        <c:numFmt formatCode="0" sourceLinked="0"/>
        <c:majorTickMark val="out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86812543"/>
        <c:crosses val="autoZero"/>
        <c:crossBetween val="midCat"/>
        <c:majorUnit val="65"/>
      </c:valAx>
      <c:valAx>
        <c:axId val="1386812543"/>
        <c:scaling>
          <c:orientation val="minMax"/>
          <c:min val="6"/>
        </c:scaling>
        <c:delete val="0"/>
        <c:axPos val="r"/>
        <c:numFmt formatCode="General" sourceLinked="1"/>
        <c:majorTickMark val="out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86814943"/>
        <c:crosses val="max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Sheet1!$B$2:$B$6446</cx:f>
        <cx:lvl ptCount="6445">
          <cx:pt idx="0">Noc</cx:pt>
          <cx:pt idx="1">Noc</cx:pt>
          <cx:pt idx="2">Noc</cx:pt>
          <cx:pt idx="3">Noc</cx:pt>
          <cx:pt idx="4">Noc</cx:pt>
          <cx:pt idx="5">Noc</cx:pt>
          <cx:pt idx="6">Noc</cx:pt>
          <cx:pt idx="7">Noc</cx:pt>
          <cx:pt idx="8">Noc</cx:pt>
          <cx:pt idx="9">Noc</cx:pt>
          <cx:pt idx="10">Noc</cx:pt>
          <cx:pt idx="11">Noc</cx:pt>
          <cx:pt idx="12">Noc</cx:pt>
          <cx:pt idx="13">Noc</cx:pt>
          <cx:pt idx="14">Noc</cx:pt>
          <cx:pt idx="15">Noc</cx:pt>
          <cx:pt idx="16">Noc</cx:pt>
          <cx:pt idx="17">Noc</cx:pt>
          <cx:pt idx="18">Noc</cx:pt>
          <cx:pt idx="19">Noc</cx:pt>
          <cx:pt idx="20">Noc</cx:pt>
          <cx:pt idx="21">Noc</cx:pt>
          <cx:pt idx="22">Noc</cx:pt>
          <cx:pt idx="23">Noc</cx:pt>
          <cx:pt idx="24">Noc</cx:pt>
          <cx:pt idx="25">Noc</cx:pt>
          <cx:pt idx="26">Noc</cx:pt>
          <cx:pt idx="27">Noc</cx:pt>
          <cx:pt idx="28">Noc</cx:pt>
          <cx:pt idx="29">Noc</cx:pt>
          <cx:pt idx="30">Noc</cx:pt>
          <cx:pt idx="31">Noc</cx:pt>
          <cx:pt idx="32">Noc</cx:pt>
          <cx:pt idx="33">Noc</cx:pt>
          <cx:pt idx="34">Noc</cx:pt>
          <cx:pt idx="35">Noc</cx:pt>
          <cx:pt idx="36">Noc</cx:pt>
          <cx:pt idx="37">Noc</cx:pt>
          <cx:pt idx="38">Noc</cx:pt>
          <cx:pt idx="39">Noc</cx:pt>
          <cx:pt idx="40">Noc</cx:pt>
          <cx:pt idx="41">Noc</cx:pt>
          <cx:pt idx="42">Noc</cx:pt>
          <cx:pt idx="43">Noc</cx:pt>
          <cx:pt idx="44">Noc</cx:pt>
          <cx:pt idx="45">Noc</cx:pt>
          <cx:pt idx="46">Noc</cx:pt>
          <cx:pt idx="47">Noc</cx:pt>
          <cx:pt idx="48">Noc</cx:pt>
          <cx:pt idx="49">Noc</cx:pt>
          <cx:pt idx="50">Noc</cx:pt>
          <cx:pt idx="51">Noc</cx:pt>
          <cx:pt idx="52">Noc</cx:pt>
          <cx:pt idx="53">Noc</cx:pt>
          <cx:pt idx="54">Noc</cx:pt>
          <cx:pt idx="55">Noc</cx:pt>
          <cx:pt idx="56">Noc</cx:pt>
          <cx:pt idx="57">Noc</cx:pt>
          <cx:pt idx="58">Noc</cx:pt>
          <cx:pt idx="59">Noc</cx:pt>
          <cx:pt idx="60">Noc</cx:pt>
          <cx:pt idx="61">Noc</cx:pt>
          <cx:pt idx="62">Noc</cx:pt>
          <cx:pt idx="63">Noc</cx:pt>
          <cx:pt idx="64">Noc</cx:pt>
          <cx:pt idx="65">Noc</cx:pt>
          <cx:pt idx="66">Noc</cx:pt>
          <cx:pt idx="67">Noc</cx:pt>
          <cx:pt idx="68">Noc</cx:pt>
          <cx:pt idx="69">Noc</cx:pt>
          <cx:pt idx="70">Noc</cx:pt>
          <cx:pt idx="71">Noc</cx:pt>
          <cx:pt idx="72">Noc</cx:pt>
          <cx:pt idx="73">Noc</cx:pt>
          <cx:pt idx="74">Noc</cx:pt>
          <cx:pt idx="75">Noc</cx:pt>
          <cx:pt idx="76">Noc</cx:pt>
          <cx:pt idx="77">Noc</cx:pt>
          <cx:pt idx="78">Noc</cx:pt>
          <cx:pt idx="79">Noc</cx:pt>
          <cx:pt idx="80">Noc</cx:pt>
          <cx:pt idx="81">Noc</cx:pt>
          <cx:pt idx="82">Noc</cx:pt>
          <cx:pt idx="83">Noc</cx:pt>
          <cx:pt idx="84">Noc</cx:pt>
          <cx:pt idx="85">Noc</cx:pt>
          <cx:pt idx="86">Noc</cx:pt>
          <cx:pt idx="87">Noc</cx:pt>
          <cx:pt idx="88">Noc</cx:pt>
          <cx:pt idx="89">Noc</cx:pt>
          <cx:pt idx="90">Noc</cx:pt>
          <cx:pt idx="91">Noc</cx:pt>
          <cx:pt idx="92">Noc</cx:pt>
          <cx:pt idx="93">Noc</cx:pt>
          <cx:pt idx="94">Noc</cx:pt>
          <cx:pt idx="95">Noc</cx:pt>
          <cx:pt idx="96">Noc</cx:pt>
          <cx:pt idx="97">Noc</cx:pt>
          <cx:pt idx="98">Noc</cx:pt>
          <cx:pt idx="99">Noc</cx:pt>
          <cx:pt idx="100">Noc</cx:pt>
          <cx:pt idx="101">Noc</cx:pt>
          <cx:pt idx="102">Noc</cx:pt>
          <cx:pt idx="103">Noc</cx:pt>
          <cx:pt idx="104">Noc</cx:pt>
          <cx:pt idx="105">Noc</cx:pt>
          <cx:pt idx="106">Noc</cx:pt>
          <cx:pt idx="107">Noc</cx:pt>
          <cx:pt idx="108">Noc</cx:pt>
          <cx:pt idx="109">Noc</cx:pt>
          <cx:pt idx="110">Noc</cx:pt>
          <cx:pt idx="111">Noc</cx:pt>
          <cx:pt idx="112">Noc</cx:pt>
          <cx:pt idx="113">Noc</cx:pt>
          <cx:pt idx="114">Noc</cx:pt>
          <cx:pt idx="115">Noc</cx:pt>
          <cx:pt idx="116">Noc</cx:pt>
          <cx:pt idx="117">Noc</cx:pt>
          <cx:pt idx="118">Noc</cx:pt>
          <cx:pt idx="119">Noc</cx:pt>
          <cx:pt idx="120">Noc</cx:pt>
          <cx:pt idx="121">Noc</cx:pt>
          <cx:pt idx="122">Noc</cx:pt>
          <cx:pt idx="123">Noc</cx:pt>
          <cx:pt idx="124">Noc</cx:pt>
          <cx:pt idx="125">Noc</cx:pt>
          <cx:pt idx="126">Noc</cx:pt>
          <cx:pt idx="127">Noc</cx:pt>
          <cx:pt idx="128">Noc</cx:pt>
          <cx:pt idx="129">Noc</cx:pt>
          <cx:pt idx="130">Noc</cx:pt>
          <cx:pt idx="131">Noc</cx:pt>
          <cx:pt idx="132">Noc</cx:pt>
          <cx:pt idx="133">Noc</cx:pt>
          <cx:pt idx="134">Noc</cx:pt>
          <cx:pt idx="135">Noc</cx:pt>
          <cx:pt idx="136">Noc</cx:pt>
          <cx:pt idx="137">Noc</cx:pt>
          <cx:pt idx="138">Noc</cx:pt>
          <cx:pt idx="139">Noc</cx:pt>
          <cx:pt idx="140">Noc</cx:pt>
          <cx:pt idx="141">Noc</cx:pt>
          <cx:pt idx="142">Noc</cx:pt>
          <cx:pt idx="143">Noc</cx:pt>
          <cx:pt idx="144">Noc</cx:pt>
          <cx:pt idx="145">Noc</cx:pt>
          <cx:pt idx="146">Noc</cx:pt>
          <cx:pt idx="147">Noc</cx:pt>
          <cx:pt idx="148">Noc</cx:pt>
          <cx:pt idx="149">Noc</cx:pt>
          <cx:pt idx="150">Noc</cx:pt>
          <cx:pt idx="151">Noc</cx:pt>
          <cx:pt idx="152">Noc</cx:pt>
          <cx:pt idx="153">Noc</cx:pt>
          <cx:pt idx="154">Noc</cx:pt>
          <cx:pt idx="155">Noc</cx:pt>
          <cx:pt idx="156">Noc</cx:pt>
          <cx:pt idx="157">Noc</cx:pt>
          <cx:pt idx="158">Noc</cx:pt>
          <cx:pt idx="159">Noc</cx:pt>
          <cx:pt idx="160">Noc</cx:pt>
          <cx:pt idx="161">Noc</cx:pt>
          <cx:pt idx="162">Noc</cx:pt>
          <cx:pt idx="163">Noc</cx:pt>
          <cx:pt idx="164">Noc</cx:pt>
          <cx:pt idx="165">Noc</cx:pt>
          <cx:pt idx="166">Noc</cx:pt>
          <cx:pt idx="167">Noc</cx:pt>
          <cx:pt idx="168">Noc</cx:pt>
          <cx:pt idx="169">Noc</cx:pt>
          <cx:pt idx="170">Noc</cx:pt>
          <cx:pt idx="171">Noc</cx:pt>
          <cx:pt idx="172">Noc</cx:pt>
          <cx:pt idx="173">Noc</cx:pt>
          <cx:pt idx="174">Noc</cx:pt>
          <cx:pt idx="175">Noc</cx:pt>
          <cx:pt idx="176">Noc</cx:pt>
          <cx:pt idx="177">Noc</cx:pt>
          <cx:pt idx="178">Noc</cx:pt>
          <cx:pt idx="179">Noc</cx:pt>
          <cx:pt idx="180">Noc</cx:pt>
          <cx:pt idx="181">Noc</cx:pt>
          <cx:pt idx="182">Noc</cx:pt>
          <cx:pt idx="183">Noc</cx:pt>
          <cx:pt idx="184">Noc</cx:pt>
          <cx:pt idx="185">Noc</cx:pt>
          <cx:pt idx="186">Noc</cx:pt>
          <cx:pt idx="187">Noc</cx:pt>
          <cx:pt idx="188">Noc</cx:pt>
          <cx:pt idx="189">Noc</cx:pt>
          <cx:pt idx="190">Noc</cx:pt>
          <cx:pt idx="191">Noc</cx:pt>
          <cx:pt idx="192">Noc</cx:pt>
          <cx:pt idx="193">Noc</cx:pt>
          <cx:pt idx="194">Noc</cx:pt>
          <cx:pt idx="195">Noc</cx:pt>
          <cx:pt idx="196">Noc</cx:pt>
          <cx:pt idx="197">Noc</cx:pt>
          <cx:pt idx="198">Noc</cx:pt>
          <cx:pt idx="199">Noc</cx:pt>
          <cx:pt idx="200">Noc</cx:pt>
          <cx:pt idx="201">Noc</cx:pt>
          <cx:pt idx="202">Noc</cx:pt>
          <cx:pt idx="203">Noc</cx:pt>
          <cx:pt idx="204">Noc</cx:pt>
          <cx:pt idx="205">Noc</cx:pt>
          <cx:pt idx="206">Noc</cx:pt>
          <cx:pt idx="207">Noc</cx:pt>
          <cx:pt idx="208">Noc</cx:pt>
          <cx:pt idx="209">Noc</cx:pt>
          <cx:pt idx="210">Noc</cx:pt>
          <cx:pt idx="211">Noc</cx:pt>
          <cx:pt idx="212">Noc</cx:pt>
          <cx:pt idx="213">Noc</cx:pt>
          <cx:pt idx="214">Noc</cx:pt>
          <cx:pt idx="215">Noc</cx:pt>
          <cx:pt idx="216">Noc</cx:pt>
          <cx:pt idx="217">Noc</cx:pt>
          <cx:pt idx="218">Noc</cx:pt>
          <cx:pt idx="219">Noc</cx:pt>
          <cx:pt idx="220">Noc</cx:pt>
          <cx:pt idx="221">Noc</cx:pt>
          <cx:pt idx="222">Noc</cx:pt>
          <cx:pt idx="223">Noc</cx:pt>
          <cx:pt idx="224">Noc</cx:pt>
          <cx:pt idx="225">Noc</cx:pt>
          <cx:pt idx="226">Noc</cx:pt>
          <cx:pt idx="227">Noc</cx:pt>
          <cx:pt idx="228">Noc</cx:pt>
          <cx:pt idx="229">Noc</cx:pt>
          <cx:pt idx="230">Noc</cx:pt>
          <cx:pt idx="231">Noc</cx:pt>
          <cx:pt idx="232">Noc</cx:pt>
          <cx:pt idx="233">Noc</cx:pt>
          <cx:pt idx="234">Noc</cx:pt>
          <cx:pt idx="235">Noc</cx:pt>
          <cx:pt idx="236">Noc</cx:pt>
          <cx:pt idx="237">Noc</cx:pt>
          <cx:pt idx="238">Noc</cx:pt>
          <cx:pt idx="239">Noc</cx:pt>
          <cx:pt idx="240">Noc</cx:pt>
          <cx:pt idx="241">Noc</cx:pt>
          <cx:pt idx="242">Noc</cx:pt>
          <cx:pt idx="243">Noc</cx:pt>
          <cx:pt idx="244">Noc</cx:pt>
          <cx:pt idx="245">Noc</cx:pt>
          <cx:pt idx="246">Noc</cx:pt>
          <cx:pt idx="247">Noc</cx:pt>
          <cx:pt idx="248">Noc</cx:pt>
          <cx:pt idx="249">Noc</cx:pt>
          <cx:pt idx="250">Noc</cx:pt>
          <cx:pt idx="251">Noc</cx:pt>
          <cx:pt idx="252">Noc</cx:pt>
          <cx:pt idx="253">Noc</cx:pt>
          <cx:pt idx="254">Noc</cx:pt>
          <cx:pt idx="255">Noc</cx:pt>
          <cx:pt idx="256">Noc</cx:pt>
          <cx:pt idx="257">Noc</cx:pt>
          <cx:pt idx="258">Noc</cx:pt>
          <cx:pt idx="259">Noc</cx:pt>
          <cx:pt idx="260">Noc</cx:pt>
          <cx:pt idx="261">Noc</cx:pt>
          <cx:pt idx="262">Noc</cx:pt>
          <cx:pt idx="263">Noc</cx:pt>
          <cx:pt idx="264">Noc</cx:pt>
          <cx:pt idx="265">Noc</cx:pt>
          <cx:pt idx="266">Noc</cx:pt>
          <cx:pt idx="267">Noc</cx:pt>
          <cx:pt idx="268">Noc</cx:pt>
          <cx:pt idx="269">Noc</cx:pt>
          <cx:pt idx="270">Noc</cx:pt>
          <cx:pt idx="271">Noc</cx:pt>
          <cx:pt idx="272">Noc</cx:pt>
          <cx:pt idx="273">Noc</cx:pt>
          <cx:pt idx="274">Noc</cx:pt>
          <cx:pt idx="275">Noc</cx:pt>
          <cx:pt idx="276">Noc</cx:pt>
          <cx:pt idx="277">Noc</cx:pt>
          <cx:pt idx="278">Noc</cx:pt>
          <cx:pt idx="279">Noc</cx:pt>
          <cx:pt idx="280">Noc</cx:pt>
          <cx:pt idx="281">Noc</cx:pt>
          <cx:pt idx="282">Noc</cx:pt>
          <cx:pt idx="283">Noc</cx:pt>
          <cx:pt idx="284">Noc</cx:pt>
          <cx:pt idx="285">Noc</cx:pt>
          <cx:pt idx="286">Noc</cx:pt>
          <cx:pt idx="287">Noc</cx:pt>
          <cx:pt idx="288">Noc</cx:pt>
          <cx:pt idx="289">Noc</cx:pt>
          <cx:pt idx="290">Noc</cx:pt>
          <cx:pt idx="291">Noc</cx:pt>
          <cx:pt idx="292">Noc</cx:pt>
          <cx:pt idx="293">Noc</cx:pt>
          <cx:pt idx="294">Noc</cx:pt>
          <cx:pt idx="295">Noc</cx:pt>
          <cx:pt idx="296">Noc</cx:pt>
          <cx:pt idx="297">Noc</cx:pt>
          <cx:pt idx="298">Noc</cx:pt>
          <cx:pt idx="299">Noc</cx:pt>
          <cx:pt idx="300">Noc</cx:pt>
          <cx:pt idx="301">Noc</cx:pt>
          <cx:pt idx="302">Noc</cx:pt>
          <cx:pt idx="303">Noc</cx:pt>
          <cx:pt idx="304">Noc</cx:pt>
          <cx:pt idx="305">Noc</cx:pt>
          <cx:pt idx="306">Noc</cx:pt>
          <cx:pt idx="307">Noc</cx:pt>
          <cx:pt idx="308">Noc</cx:pt>
          <cx:pt idx="309">Noc</cx:pt>
          <cx:pt idx="310">Noc</cx:pt>
          <cx:pt idx="311">Noc</cx:pt>
          <cx:pt idx="312">Noc</cx:pt>
          <cx:pt idx="313">Noc</cx:pt>
          <cx:pt idx="314">Noc</cx:pt>
          <cx:pt idx="315">Noc</cx:pt>
          <cx:pt idx="316">Noc</cx:pt>
          <cx:pt idx="317">Noc</cx:pt>
          <cx:pt idx="318">Noc</cx:pt>
          <cx:pt idx="319">Noc</cx:pt>
          <cx:pt idx="320">Noc</cx:pt>
          <cx:pt idx="321">Noc</cx:pt>
          <cx:pt idx="322">Noc</cx:pt>
          <cx:pt idx="323">Noc</cx:pt>
          <cx:pt idx="324">Noc</cx:pt>
          <cx:pt idx="325">Noc</cx:pt>
          <cx:pt idx="326">Noc</cx:pt>
          <cx:pt idx="327">Noc</cx:pt>
          <cx:pt idx="328">Noc</cx:pt>
          <cx:pt idx="329">Noc</cx:pt>
          <cx:pt idx="330">Noc</cx:pt>
          <cx:pt idx="331">Noc</cx:pt>
          <cx:pt idx="332">Noc</cx:pt>
          <cx:pt idx="333">Noc</cx:pt>
          <cx:pt idx="334">Noc</cx:pt>
          <cx:pt idx="335">Noc</cx:pt>
          <cx:pt idx="336">Noc</cx:pt>
          <cx:pt idx="337">Noc</cx:pt>
          <cx:pt idx="338">Noc</cx:pt>
          <cx:pt idx="339">Noc</cx:pt>
          <cx:pt idx="340">Noc</cx:pt>
          <cx:pt idx="341">Noc</cx:pt>
          <cx:pt idx="342">Noc</cx:pt>
          <cx:pt idx="343">Noc</cx:pt>
          <cx:pt idx="344">Noc</cx:pt>
          <cx:pt idx="345">Noc</cx:pt>
          <cx:pt idx="346">Noc</cx:pt>
          <cx:pt idx="347">Noc</cx:pt>
          <cx:pt idx="348">Noc</cx:pt>
          <cx:pt idx="349">Noc</cx:pt>
          <cx:pt idx="350">Noc</cx:pt>
          <cx:pt idx="351">Noc</cx:pt>
          <cx:pt idx="352">Noc</cx:pt>
          <cx:pt idx="353">Noc</cx:pt>
          <cx:pt idx="354">Noc</cx:pt>
          <cx:pt idx="355">Noc</cx:pt>
          <cx:pt idx="356">Noc</cx:pt>
          <cx:pt idx="357">Noc</cx:pt>
          <cx:pt idx="358">Noc</cx:pt>
          <cx:pt idx="359">Noc</cx:pt>
          <cx:pt idx="360">Noc</cx:pt>
          <cx:pt idx="361">Noc</cx:pt>
          <cx:pt idx="362">Noc</cx:pt>
          <cx:pt idx="363">Noc</cx:pt>
          <cx:pt idx="364">Noc</cx:pt>
          <cx:pt idx="365">Noc</cx:pt>
          <cx:pt idx="366">Noc</cx:pt>
          <cx:pt idx="367">Noc</cx:pt>
          <cx:pt idx="368">Noc</cx:pt>
          <cx:pt idx="369">Noc</cx:pt>
          <cx:pt idx="370">Noc</cx:pt>
          <cx:pt idx="371">Noc</cx:pt>
          <cx:pt idx="372">Noc</cx:pt>
          <cx:pt idx="373">Noc</cx:pt>
          <cx:pt idx="374">Noc</cx:pt>
          <cx:pt idx="375">Noc</cx:pt>
          <cx:pt idx="376">Noc</cx:pt>
          <cx:pt idx="377">Noc</cx:pt>
          <cx:pt idx="378">Noc</cx:pt>
          <cx:pt idx="379">Noc</cx:pt>
          <cx:pt idx="380">Noc</cx:pt>
          <cx:pt idx="381">Noc</cx:pt>
          <cx:pt idx="382">Noc</cx:pt>
          <cx:pt idx="383">Noc</cx:pt>
          <cx:pt idx="384">Noc</cx:pt>
          <cx:pt idx="385">Noc</cx:pt>
          <cx:pt idx="386">Noc</cx:pt>
          <cx:pt idx="387">Noc</cx:pt>
          <cx:pt idx="388">Noc</cx:pt>
          <cx:pt idx="389">Noc</cx:pt>
          <cx:pt idx="390">Noc</cx:pt>
          <cx:pt idx="391">Noc</cx:pt>
          <cx:pt idx="392">Noc</cx:pt>
          <cx:pt idx="393">Noc</cx:pt>
          <cx:pt idx="394">Noc</cx:pt>
          <cx:pt idx="395">Noc</cx:pt>
          <cx:pt idx="396">Noc</cx:pt>
          <cx:pt idx="397">Noc</cx:pt>
          <cx:pt idx="398">Noc</cx:pt>
          <cx:pt idx="399">Noc</cx:pt>
          <cx:pt idx="400">Noc</cx:pt>
          <cx:pt idx="401">Noc</cx:pt>
          <cx:pt idx="402">Noc</cx:pt>
          <cx:pt idx="403">Noc</cx:pt>
          <cx:pt idx="404">Noc</cx:pt>
          <cx:pt idx="405">Noc</cx:pt>
          <cx:pt idx="406">Noc</cx:pt>
          <cx:pt idx="407">Noc</cx:pt>
          <cx:pt idx="408">Noc</cx:pt>
          <cx:pt idx="409">Noc</cx:pt>
          <cx:pt idx="410">Noc</cx:pt>
          <cx:pt idx="411">Noc</cx:pt>
          <cx:pt idx="412">Noc</cx:pt>
          <cx:pt idx="413">Noc</cx:pt>
          <cx:pt idx="414">Noc</cx:pt>
          <cx:pt idx="415">Noc</cx:pt>
          <cx:pt idx="416">Noc</cx:pt>
          <cx:pt idx="417">Noc</cx:pt>
          <cx:pt idx="418">Noc</cx:pt>
          <cx:pt idx="419">Noc</cx:pt>
          <cx:pt idx="420">Noc</cx:pt>
          <cx:pt idx="421">Noc</cx:pt>
          <cx:pt idx="422">Noc</cx:pt>
          <cx:pt idx="423">Noc</cx:pt>
          <cx:pt idx="424">Noc</cx:pt>
          <cx:pt idx="425">Noc</cx:pt>
          <cx:pt idx="426">Noc</cx:pt>
          <cx:pt idx="427">Noc</cx:pt>
          <cx:pt idx="428">Noc</cx:pt>
          <cx:pt idx="429">Noc</cx:pt>
          <cx:pt idx="430">Noc</cx:pt>
          <cx:pt idx="431">Noc</cx:pt>
          <cx:pt idx="432">Noc</cx:pt>
          <cx:pt idx="433">Noc</cx:pt>
          <cx:pt idx="434">Noc</cx:pt>
          <cx:pt idx="435">Noc</cx:pt>
          <cx:pt idx="436">Noc</cx:pt>
          <cx:pt idx="437">Noc</cx:pt>
          <cx:pt idx="438">Noc</cx:pt>
          <cx:pt idx="439">Noc</cx:pt>
          <cx:pt idx="440">Noc</cx:pt>
          <cx:pt idx="441">Noc</cx:pt>
          <cx:pt idx="442">Noc</cx:pt>
          <cx:pt idx="443">Noc</cx:pt>
          <cx:pt idx="444">Noc</cx:pt>
          <cx:pt idx="445">Noc</cx:pt>
          <cx:pt idx="446">Noc</cx:pt>
          <cx:pt idx="447">Noc</cx:pt>
          <cx:pt idx="448">Noc</cx:pt>
          <cx:pt idx="449">Noc</cx:pt>
          <cx:pt idx="450">Noc</cx:pt>
          <cx:pt idx="451">Noc</cx:pt>
          <cx:pt idx="452">Noc</cx:pt>
          <cx:pt idx="453">Noc</cx:pt>
          <cx:pt idx="454">Noc</cx:pt>
          <cx:pt idx="455">Noc</cx:pt>
          <cx:pt idx="456">Noc</cx:pt>
          <cx:pt idx="457">Noc</cx:pt>
          <cx:pt idx="458">Noc</cx:pt>
          <cx:pt idx="459">Noc</cx:pt>
          <cx:pt idx="460">Noc</cx:pt>
          <cx:pt idx="461">Noc</cx:pt>
          <cx:pt idx="462">Noc</cx:pt>
          <cx:pt idx="463">Noc</cx:pt>
          <cx:pt idx="464">Noc</cx:pt>
          <cx:pt idx="465">Noc</cx:pt>
          <cx:pt idx="466">Noc</cx:pt>
          <cx:pt idx="467">Noc</cx:pt>
          <cx:pt idx="468">Noc</cx:pt>
          <cx:pt idx="469">Noc</cx:pt>
          <cx:pt idx="470">Noc</cx:pt>
          <cx:pt idx="471">Noc</cx:pt>
          <cx:pt idx="472">Noc</cx:pt>
          <cx:pt idx="473">Noc</cx:pt>
          <cx:pt idx="474">Noc</cx:pt>
          <cx:pt idx="475">Noc</cx:pt>
          <cx:pt idx="476">Noc</cx:pt>
          <cx:pt idx="477">Noc</cx:pt>
          <cx:pt idx="478">Noc</cx:pt>
          <cx:pt idx="479">Noc</cx:pt>
          <cx:pt idx="480">Noc</cx:pt>
          <cx:pt idx="481">Noc</cx:pt>
          <cx:pt idx="482">Noc</cx:pt>
          <cx:pt idx="483">Noc</cx:pt>
          <cx:pt idx="484">Noc</cx:pt>
          <cx:pt idx="485">Noc</cx:pt>
          <cx:pt idx="486">Noc</cx:pt>
          <cx:pt idx="487">Noc</cx:pt>
          <cx:pt idx="488">Noc</cx:pt>
          <cx:pt idx="489">Noc</cx:pt>
          <cx:pt idx="490">Noc</cx:pt>
          <cx:pt idx="491">Noc</cx:pt>
          <cx:pt idx="492">Noc</cx:pt>
          <cx:pt idx="493">Noc</cx:pt>
          <cx:pt idx="494">Noc</cx:pt>
          <cx:pt idx="495">Noc</cx:pt>
          <cx:pt idx="496">Noc</cx:pt>
          <cx:pt idx="497">Noc</cx:pt>
          <cx:pt idx="498">Noc</cx:pt>
          <cx:pt idx="499">Noc</cx:pt>
          <cx:pt idx="500">Noc</cx:pt>
          <cx:pt idx="501">Noc</cx:pt>
          <cx:pt idx="502">Noc</cx:pt>
          <cx:pt idx="503">Noc</cx:pt>
          <cx:pt idx="504">Noc</cx:pt>
          <cx:pt idx="505">Noc</cx:pt>
          <cx:pt idx="506">Noc</cx:pt>
          <cx:pt idx="507">Noc</cx:pt>
          <cx:pt idx="508">Noc</cx:pt>
          <cx:pt idx="509">Noc</cx:pt>
          <cx:pt idx="510">Noc</cx:pt>
          <cx:pt idx="511">Noc</cx:pt>
          <cx:pt idx="512">Noc</cx:pt>
          <cx:pt idx="513">Noc</cx:pt>
          <cx:pt idx="514">Noc</cx:pt>
          <cx:pt idx="515">Noc</cx:pt>
          <cx:pt idx="516">Noc</cx:pt>
          <cx:pt idx="517">Noc</cx:pt>
          <cx:pt idx="518">Noc</cx:pt>
          <cx:pt idx="519">Noc</cx:pt>
          <cx:pt idx="520">Noc</cx:pt>
          <cx:pt idx="521">Noc</cx:pt>
          <cx:pt idx="522">Noc</cx:pt>
          <cx:pt idx="523">Noc</cx:pt>
          <cx:pt idx="524">Noc</cx:pt>
          <cx:pt idx="525">Noc</cx:pt>
          <cx:pt idx="526">Noc</cx:pt>
          <cx:pt idx="527">Noc</cx:pt>
          <cx:pt idx="528">Noc</cx:pt>
          <cx:pt idx="529">Noc</cx:pt>
          <cx:pt idx="530">Noc</cx:pt>
          <cx:pt idx="531">Noc</cx:pt>
          <cx:pt idx="532">Noc</cx:pt>
          <cx:pt idx="533">Noc</cx:pt>
          <cx:pt idx="534">Noc</cx:pt>
          <cx:pt idx="535">Noc</cx:pt>
          <cx:pt idx="536">Noc</cx:pt>
          <cx:pt idx="537">Noc</cx:pt>
          <cx:pt idx="538">Noc</cx:pt>
          <cx:pt idx="539">Noc</cx:pt>
          <cx:pt idx="540">Noc</cx:pt>
          <cx:pt idx="541">Noc</cx:pt>
          <cx:pt idx="542">Noc</cx:pt>
          <cx:pt idx="543">Noc</cx:pt>
          <cx:pt idx="544">Noc</cx:pt>
          <cx:pt idx="545">Noc</cx:pt>
          <cx:pt idx="546">Noc</cx:pt>
          <cx:pt idx="547">Noc</cx:pt>
          <cx:pt idx="548">Noc</cx:pt>
          <cx:pt idx="549">Noc</cx:pt>
          <cx:pt idx="550">Noc</cx:pt>
          <cx:pt idx="551">Noc</cx:pt>
          <cx:pt idx="552">Noc</cx:pt>
          <cx:pt idx="553">Noc</cx:pt>
          <cx:pt idx="554">Noc</cx:pt>
          <cx:pt idx="555">Noc</cx:pt>
          <cx:pt idx="556">Noc</cx:pt>
          <cx:pt idx="557">Noc</cx:pt>
          <cx:pt idx="558">Noc</cx:pt>
          <cx:pt idx="559">Noc</cx:pt>
          <cx:pt idx="560">Noc</cx:pt>
          <cx:pt idx="561">Noc</cx:pt>
          <cx:pt idx="562">Noc</cx:pt>
          <cx:pt idx="563">Noc</cx:pt>
          <cx:pt idx="564">Noc</cx:pt>
          <cx:pt idx="565">Noc</cx:pt>
          <cx:pt idx="566">Noc</cx:pt>
          <cx:pt idx="567">Noc</cx:pt>
          <cx:pt idx="568">Noc</cx:pt>
          <cx:pt idx="569">Noc</cx:pt>
          <cx:pt idx="570">Noc</cx:pt>
          <cx:pt idx="571">Noc</cx:pt>
          <cx:pt idx="572">Noc</cx:pt>
          <cx:pt idx="573">Noc</cx:pt>
          <cx:pt idx="574">Noc</cx:pt>
          <cx:pt idx="575">Noc</cx:pt>
          <cx:pt idx="576">Noc</cx:pt>
          <cx:pt idx="577">Noc</cx:pt>
          <cx:pt idx="578">Noc</cx:pt>
          <cx:pt idx="579">Noc</cx:pt>
          <cx:pt idx="580">Noc</cx:pt>
          <cx:pt idx="581">Noc</cx:pt>
          <cx:pt idx="582">Noc</cx:pt>
          <cx:pt idx="583">Noc</cx:pt>
          <cx:pt idx="584">Noc</cx:pt>
          <cx:pt idx="585">Noc</cx:pt>
          <cx:pt idx="586">Noc</cx:pt>
          <cx:pt idx="587">Noc</cx:pt>
          <cx:pt idx="588">Noc</cx:pt>
          <cx:pt idx="589">Noc</cx:pt>
          <cx:pt idx="590">Noc</cx:pt>
          <cx:pt idx="591">Noc</cx:pt>
          <cx:pt idx="592">Noc</cx:pt>
          <cx:pt idx="593">Noc</cx:pt>
          <cx:pt idx="594">Noc</cx:pt>
          <cx:pt idx="595">Noc</cx:pt>
          <cx:pt idx="596">Noc</cx:pt>
          <cx:pt idx="597">Noc</cx:pt>
          <cx:pt idx="598">Noc</cx:pt>
          <cx:pt idx="599">Noc</cx:pt>
          <cx:pt idx="600">Noc</cx:pt>
          <cx:pt idx="601">Noc</cx:pt>
          <cx:pt idx="602">Noc</cx:pt>
          <cx:pt idx="603">Noc</cx:pt>
          <cx:pt idx="604">Noc</cx:pt>
          <cx:pt idx="605">Noc</cx:pt>
          <cx:pt idx="606">Noc</cx:pt>
          <cx:pt idx="607">Noc</cx:pt>
          <cx:pt idx="608">Noc</cx:pt>
          <cx:pt idx="609">Noc</cx:pt>
          <cx:pt idx="610">Noc</cx:pt>
          <cx:pt idx="611">Noc</cx:pt>
          <cx:pt idx="612">Noc</cx:pt>
          <cx:pt idx="613">Noc</cx:pt>
          <cx:pt idx="614">Noc</cx:pt>
          <cx:pt idx="615">Noc</cx:pt>
          <cx:pt idx="616">Noc</cx:pt>
          <cx:pt idx="617">Noc</cx:pt>
          <cx:pt idx="618">Noc</cx:pt>
          <cx:pt idx="619">Noc</cx:pt>
          <cx:pt idx="620">Noc</cx:pt>
          <cx:pt idx="621">Noc</cx:pt>
          <cx:pt idx="622">Noc</cx:pt>
          <cx:pt idx="623">Noc</cx:pt>
          <cx:pt idx="624">Noc</cx:pt>
          <cx:pt idx="625">Noc</cx:pt>
          <cx:pt idx="626">Noc</cx:pt>
          <cx:pt idx="627">Noc</cx:pt>
          <cx:pt idx="628">Noc</cx:pt>
          <cx:pt idx="629">Noc</cx:pt>
          <cx:pt idx="630">Noc</cx:pt>
          <cx:pt idx="631">Noc</cx:pt>
          <cx:pt idx="632">Noc</cx:pt>
          <cx:pt idx="633">Noc</cx:pt>
          <cx:pt idx="634">Noc</cx:pt>
          <cx:pt idx="635">Noc</cx:pt>
          <cx:pt idx="636">Noc</cx:pt>
          <cx:pt idx="637">Noc</cx:pt>
          <cx:pt idx="638">Noc</cx:pt>
          <cx:pt idx="639">Noc</cx:pt>
          <cx:pt idx="640">Noc</cx:pt>
          <cx:pt idx="641">Noc</cx:pt>
          <cx:pt idx="642">Noc</cx:pt>
          <cx:pt idx="643">Noc</cx:pt>
          <cx:pt idx="644">Noc</cx:pt>
          <cx:pt idx="645">Noc</cx:pt>
          <cx:pt idx="646">Noc</cx:pt>
          <cx:pt idx="647">Noc</cx:pt>
          <cx:pt idx="648">Noc</cx:pt>
          <cx:pt idx="649">Noc</cx:pt>
          <cx:pt idx="650">Noc</cx:pt>
          <cx:pt idx="651">Noc</cx:pt>
          <cx:pt idx="652">Noc</cx:pt>
          <cx:pt idx="653">Noc</cx:pt>
          <cx:pt idx="654">Noc</cx:pt>
          <cx:pt idx="655">Noc</cx:pt>
          <cx:pt idx="656">Noc</cx:pt>
          <cx:pt idx="657">Noc</cx:pt>
          <cx:pt idx="658">Noc</cx:pt>
          <cx:pt idx="659">Noc</cx:pt>
          <cx:pt idx="660">Noc</cx:pt>
          <cx:pt idx="661">Noc</cx:pt>
          <cx:pt idx="662">Noc</cx:pt>
          <cx:pt idx="663">Noc</cx:pt>
          <cx:pt idx="664">Noc</cx:pt>
          <cx:pt idx="665">Noc</cx:pt>
          <cx:pt idx="666">Noc</cx:pt>
          <cx:pt idx="667">Noc</cx:pt>
          <cx:pt idx="668">Noc</cx:pt>
          <cx:pt idx="669">Noc</cx:pt>
          <cx:pt idx="670">Noc</cx:pt>
          <cx:pt idx="671">Noc</cx:pt>
          <cx:pt idx="672">Noc</cx:pt>
          <cx:pt idx="673">Noc</cx:pt>
          <cx:pt idx="674">Noc</cx:pt>
          <cx:pt idx="675">Noc</cx:pt>
          <cx:pt idx="676">Noc</cx:pt>
          <cx:pt idx="677">Noc</cx:pt>
          <cx:pt idx="678">Noc</cx:pt>
          <cx:pt idx="679">Noc</cx:pt>
          <cx:pt idx="680">Noc</cx:pt>
          <cx:pt idx="681">Noc</cx:pt>
          <cx:pt idx="682">Noc</cx:pt>
          <cx:pt idx="683">Noc</cx:pt>
          <cx:pt idx="684">Noc</cx:pt>
          <cx:pt idx="685">Noc</cx:pt>
          <cx:pt idx="686">Noc</cx:pt>
          <cx:pt idx="687">Noc</cx:pt>
          <cx:pt idx="688">Noc</cx:pt>
          <cx:pt idx="689">Noc</cx:pt>
          <cx:pt idx="690">Noc</cx:pt>
          <cx:pt idx="691">Noc</cx:pt>
          <cx:pt idx="692">Noc</cx:pt>
          <cx:pt idx="693">Noc</cx:pt>
          <cx:pt idx="694">Noc</cx:pt>
          <cx:pt idx="695">Noc</cx:pt>
          <cx:pt idx="696">Noc</cx:pt>
          <cx:pt idx="697">Noc</cx:pt>
          <cx:pt idx="698">Noc</cx:pt>
          <cx:pt idx="699">Noc</cx:pt>
          <cx:pt idx="700">Noc</cx:pt>
          <cx:pt idx="701">Noc</cx:pt>
          <cx:pt idx="702">Noc</cx:pt>
          <cx:pt idx="703">Noc</cx:pt>
          <cx:pt idx="704">Noc</cx:pt>
          <cx:pt idx="705">Noc</cx:pt>
          <cx:pt idx="706">Noc</cx:pt>
          <cx:pt idx="707">Noc</cx:pt>
          <cx:pt idx="708">Noc</cx:pt>
          <cx:pt idx="709">Noc</cx:pt>
          <cx:pt idx="710">Noc</cx:pt>
          <cx:pt idx="711">Noc</cx:pt>
          <cx:pt idx="712">Noc</cx:pt>
          <cx:pt idx="713">Noc</cx:pt>
          <cx:pt idx="714">Noc</cx:pt>
          <cx:pt idx="715">Noc</cx:pt>
          <cx:pt idx="716">Noc</cx:pt>
          <cx:pt idx="717">Noc</cx:pt>
          <cx:pt idx="718">Noc</cx:pt>
          <cx:pt idx="719">Noc</cx:pt>
          <cx:pt idx="720">Noc</cx:pt>
          <cx:pt idx="721">Noc</cx:pt>
          <cx:pt idx="722">Noc</cx:pt>
          <cx:pt idx="723">Noc</cx:pt>
          <cx:pt idx="724">Noc</cx:pt>
          <cx:pt idx="725">Noc</cx:pt>
          <cx:pt idx="726">Noc</cx:pt>
          <cx:pt idx="727">Noc</cx:pt>
          <cx:pt idx="728">Noc</cx:pt>
          <cx:pt idx="729">Noc</cx:pt>
          <cx:pt idx="730">Noc</cx:pt>
          <cx:pt idx="731">Noc</cx:pt>
          <cx:pt idx="732">Noc</cx:pt>
          <cx:pt idx="733">Noc</cx:pt>
          <cx:pt idx="734">Noc</cx:pt>
          <cx:pt idx="735">Noc</cx:pt>
          <cx:pt idx="736">Noc</cx:pt>
          <cx:pt idx="737">Noc</cx:pt>
          <cx:pt idx="738">Noc</cx:pt>
          <cx:pt idx="739">Noc</cx:pt>
          <cx:pt idx="740">Noc</cx:pt>
          <cx:pt idx="741">Noc</cx:pt>
          <cx:pt idx="742">Noc</cx:pt>
          <cx:pt idx="743">Noc</cx:pt>
          <cx:pt idx="744">Noc</cx:pt>
          <cx:pt idx="745">Noc</cx:pt>
          <cx:pt idx="746">Noc</cx:pt>
          <cx:pt idx="747">Noc</cx:pt>
          <cx:pt idx="748">Noc</cx:pt>
          <cx:pt idx="749">Noc</cx:pt>
          <cx:pt idx="750">Noc</cx:pt>
          <cx:pt idx="751">Noc</cx:pt>
          <cx:pt idx="752">Noc</cx:pt>
          <cx:pt idx="753">Noc</cx:pt>
          <cx:pt idx="754">Noc</cx:pt>
          <cx:pt idx="755">Noc</cx:pt>
          <cx:pt idx="756">Noc</cx:pt>
          <cx:pt idx="757">Noc</cx:pt>
          <cx:pt idx="758">Noc</cx:pt>
          <cx:pt idx="759">Noc</cx:pt>
          <cx:pt idx="760">Noc</cx:pt>
          <cx:pt idx="761">Noc</cx:pt>
          <cx:pt idx="762">Noc</cx:pt>
          <cx:pt idx="763">Noc</cx:pt>
          <cx:pt idx="764">Noc</cx:pt>
          <cx:pt idx="765">Noc</cx:pt>
          <cx:pt idx="766">Noc</cx:pt>
          <cx:pt idx="767">Noc</cx:pt>
          <cx:pt idx="768">Noc</cx:pt>
          <cx:pt idx="769">Noc</cx:pt>
          <cx:pt idx="770">Noc</cx:pt>
          <cx:pt idx="771">Noc</cx:pt>
          <cx:pt idx="772">Noc</cx:pt>
          <cx:pt idx="773">Noc</cx:pt>
          <cx:pt idx="774">Noc</cx:pt>
          <cx:pt idx="775">Noc</cx:pt>
          <cx:pt idx="776">Noc</cx:pt>
          <cx:pt idx="777">Noc</cx:pt>
          <cx:pt idx="778">Noc</cx:pt>
          <cx:pt idx="779">Noc</cx:pt>
          <cx:pt idx="780">Noc</cx:pt>
          <cx:pt idx="781">Noc</cx:pt>
          <cx:pt idx="782">Noc</cx:pt>
          <cx:pt idx="783">Noc</cx:pt>
          <cx:pt idx="784">Noc</cx:pt>
          <cx:pt idx="785">Noc</cx:pt>
          <cx:pt idx="786">Noc</cx:pt>
          <cx:pt idx="787">Noc</cx:pt>
          <cx:pt idx="788">Noc</cx:pt>
          <cx:pt idx="789">Noc</cx:pt>
          <cx:pt idx="790">Noc</cx:pt>
          <cx:pt idx="791">Noc</cx:pt>
          <cx:pt idx="792">Noc</cx:pt>
          <cx:pt idx="793">Noc</cx:pt>
          <cx:pt idx="794">Noc</cx:pt>
          <cx:pt idx="795">Noc</cx:pt>
          <cx:pt idx="796">Noc</cx:pt>
          <cx:pt idx="797">Noc</cx:pt>
          <cx:pt idx="798">Noc</cx:pt>
          <cx:pt idx="799">Noc</cx:pt>
          <cx:pt idx="800">Noc</cx:pt>
          <cx:pt idx="801">Noc</cx:pt>
          <cx:pt idx="802">Noc</cx:pt>
          <cx:pt idx="803">Noc</cx:pt>
          <cx:pt idx="804">Noc</cx:pt>
          <cx:pt idx="805">Noc</cx:pt>
          <cx:pt idx="806">Noc</cx:pt>
          <cx:pt idx="807">Noc</cx:pt>
          <cx:pt idx="808">Noc</cx:pt>
          <cx:pt idx="809">Noc</cx:pt>
          <cx:pt idx="810">Noc</cx:pt>
          <cx:pt idx="811">Noc</cx:pt>
          <cx:pt idx="812">Noc</cx:pt>
          <cx:pt idx="813">Noc</cx:pt>
          <cx:pt idx="814">Noc</cx:pt>
          <cx:pt idx="815">Noc</cx:pt>
          <cx:pt idx="816">Noc</cx:pt>
          <cx:pt idx="817">Noc</cx:pt>
          <cx:pt idx="818">Noc</cx:pt>
          <cx:pt idx="819">Noc</cx:pt>
          <cx:pt idx="820">Noc</cx:pt>
          <cx:pt idx="821">Noc</cx:pt>
          <cx:pt idx="822">Noc</cx:pt>
          <cx:pt idx="823">Noc</cx:pt>
          <cx:pt idx="824">Noc</cx:pt>
          <cx:pt idx="825">Noc</cx:pt>
          <cx:pt idx="826">Noc</cx:pt>
          <cx:pt idx="827">Noc</cx:pt>
          <cx:pt idx="828">Noc</cx:pt>
          <cx:pt idx="829">Noc</cx:pt>
          <cx:pt idx="830">Noc</cx:pt>
          <cx:pt idx="831">Noc</cx:pt>
          <cx:pt idx="832">Noc</cx:pt>
          <cx:pt idx="833">Noc</cx:pt>
          <cx:pt idx="834">Noc</cx:pt>
          <cx:pt idx="835">Noc</cx:pt>
          <cx:pt idx="836">Noc</cx:pt>
          <cx:pt idx="837">Noc</cx:pt>
          <cx:pt idx="838">Noc</cx:pt>
          <cx:pt idx="839">Noc</cx:pt>
          <cx:pt idx="840">Noc</cx:pt>
          <cx:pt idx="841">Noc</cx:pt>
          <cx:pt idx="842">Noc</cx:pt>
          <cx:pt idx="843">Noc</cx:pt>
          <cx:pt idx="844">Noc</cx:pt>
          <cx:pt idx="845">Noc</cx:pt>
          <cx:pt idx="846">Noc</cx:pt>
          <cx:pt idx="847">Noc</cx:pt>
          <cx:pt idx="848">Noc</cx:pt>
          <cx:pt idx="849">Noc</cx:pt>
          <cx:pt idx="850">Noc</cx:pt>
          <cx:pt idx="851">Noc</cx:pt>
          <cx:pt idx="852">Noc</cx:pt>
          <cx:pt idx="853">Noc</cx:pt>
          <cx:pt idx="854">Noc</cx:pt>
          <cx:pt idx="855">Noc</cx:pt>
          <cx:pt idx="856">Noc</cx:pt>
          <cx:pt idx="857">Noc</cx:pt>
          <cx:pt idx="858">Noc</cx:pt>
          <cx:pt idx="859">Noc</cx:pt>
          <cx:pt idx="860">Noc</cx:pt>
          <cx:pt idx="861">Noc</cx:pt>
          <cx:pt idx="862">Noc</cx:pt>
          <cx:pt idx="863">Noc</cx:pt>
          <cx:pt idx="864">Noc</cx:pt>
          <cx:pt idx="865">Noc</cx:pt>
          <cx:pt idx="866">Noc</cx:pt>
          <cx:pt idx="867">Noc</cx:pt>
          <cx:pt idx="868">Noc</cx:pt>
          <cx:pt idx="869">Noc</cx:pt>
          <cx:pt idx="870">Noc</cx:pt>
          <cx:pt idx="871">Noc</cx:pt>
          <cx:pt idx="872">Noc</cx:pt>
          <cx:pt idx="873">Noc</cx:pt>
          <cx:pt idx="874">Noc</cx:pt>
          <cx:pt idx="875">Noc</cx:pt>
          <cx:pt idx="876">Noc</cx:pt>
          <cx:pt idx="877">Noc</cx:pt>
          <cx:pt idx="878">Noc</cx:pt>
          <cx:pt idx="879">Noc</cx:pt>
          <cx:pt idx="880">Noc</cx:pt>
          <cx:pt idx="881">Noc</cx:pt>
          <cx:pt idx="882">Noc</cx:pt>
          <cx:pt idx="883">Noc</cx:pt>
          <cx:pt idx="884">Noc</cx:pt>
          <cx:pt idx="885">Noc</cx:pt>
          <cx:pt idx="886">Noc</cx:pt>
          <cx:pt idx="887">Noc</cx:pt>
          <cx:pt idx="888">Noc</cx:pt>
          <cx:pt idx="889">Noc</cx:pt>
          <cx:pt idx="890">Noc</cx:pt>
          <cx:pt idx="891">Noc</cx:pt>
          <cx:pt idx="892">Noc</cx:pt>
          <cx:pt idx="893">Noc</cx:pt>
          <cx:pt idx="894">Noc</cx:pt>
          <cx:pt idx="895">Noc</cx:pt>
          <cx:pt idx="896">Noc</cx:pt>
          <cx:pt idx="897">Noc</cx:pt>
          <cx:pt idx="898">Noc</cx:pt>
          <cx:pt idx="899">Noc</cx:pt>
          <cx:pt idx="900">Noc</cx:pt>
          <cx:pt idx="901">Noc</cx:pt>
          <cx:pt idx="902">Noc</cx:pt>
          <cx:pt idx="903">Noc</cx:pt>
          <cx:pt idx="904">Noc</cx:pt>
          <cx:pt idx="905">Noc</cx:pt>
          <cx:pt idx="906">Noc</cx:pt>
          <cx:pt idx="907">Noc</cx:pt>
          <cx:pt idx="908">Noc</cx:pt>
          <cx:pt idx="909">Noc</cx:pt>
          <cx:pt idx="910">Noc</cx:pt>
          <cx:pt idx="911">Noc</cx:pt>
          <cx:pt idx="912">Noc</cx:pt>
          <cx:pt idx="913">Noc</cx:pt>
          <cx:pt idx="914">Noc</cx:pt>
          <cx:pt idx="915">Noc</cx:pt>
          <cx:pt idx="916">Noc</cx:pt>
          <cx:pt idx="917">Noc</cx:pt>
          <cx:pt idx="918">Noc</cx:pt>
          <cx:pt idx="919">Noc</cx:pt>
          <cx:pt idx="920">Noc</cx:pt>
          <cx:pt idx="921">Noc</cx:pt>
          <cx:pt idx="922">Noc</cx:pt>
          <cx:pt idx="923">Noc</cx:pt>
          <cx:pt idx="924">Noc</cx:pt>
          <cx:pt idx="925">Noc</cx:pt>
          <cx:pt idx="926">Noc</cx:pt>
          <cx:pt idx="927">Noc</cx:pt>
          <cx:pt idx="928">Noc</cx:pt>
          <cx:pt idx="929">Noc</cx:pt>
          <cx:pt idx="930">Noc</cx:pt>
          <cx:pt idx="931">Noc</cx:pt>
          <cx:pt idx="932">Noc</cx:pt>
          <cx:pt idx="933">Noc</cx:pt>
          <cx:pt idx="934">Noc</cx:pt>
          <cx:pt idx="935">Noc</cx:pt>
          <cx:pt idx="936">Noc</cx:pt>
          <cx:pt idx="937">Noc</cx:pt>
          <cx:pt idx="938">Noc</cx:pt>
          <cx:pt idx="939">Noc</cx:pt>
          <cx:pt idx="940">Noc</cx:pt>
          <cx:pt idx="941">Noc</cx:pt>
          <cx:pt idx="942">Noc</cx:pt>
          <cx:pt idx="943">Noc</cx:pt>
          <cx:pt idx="944">Noc</cx:pt>
          <cx:pt idx="945">Noc</cx:pt>
          <cx:pt idx="946">Noc</cx:pt>
          <cx:pt idx="947">Noc</cx:pt>
          <cx:pt idx="948">Noc</cx:pt>
          <cx:pt idx="949">Noc</cx:pt>
          <cx:pt idx="950">Noc</cx:pt>
          <cx:pt idx="951">Noc</cx:pt>
          <cx:pt idx="952">Noc</cx:pt>
          <cx:pt idx="953">Noc</cx:pt>
          <cx:pt idx="954">Noc</cx:pt>
          <cx:pt idx="955">Noc</cx:pt>
          <cx:pt idx="956">Noc</cx:pt>
          <cx:pt idx="957">Noc</cx:pt>
          <cx:pt idx="958">Noc</cx:pt>
          <cx:pt idx="959">Noc</cx:pt>
          <cx:pt idx="960">Noc</cx:pt>
          <cx:pt idx="961">Noc</cx:pt>
          <cx:pt idx="962">Noc</cx:pt>
          <cx:pt idx="963">Noc</cx:pt>
          <cx:pt idx="964">Noc</cx:pt>
          <cx:pt idx="965">Noc</cx:pt>
          <cx:pt idx="966">Noc</cx:pt>
          <cx:pt idx="967">Noc</cx:pt>
          <cx:pt idx="968">Noc</cx:pt>
          <cx:pt idx="969">Noc</cx:pt>
          <cx:pt idx="970">Noc</cx:pt>
          <cx:pt idx="971">Noc</cx:pt>
          <cx:pt idx="972">Noc</cx:pt>
          <cx:pt idx="973">Noc</cx:pt>
          <cx:pt idx="974">Noc</cx:pt>
          <cx:pt idx="975">Noc</cx:pt>
          <cx:pt idx="976">Noc</cx:pt>
          <cx:pt idx="977">Noc</cx:pt>
          <cx:pt idx="978">Noc</cx:pt>
          <cx:pt idx="979">Noc</cx:pt>
          <cx:pt idx="980">Noc</cx:pt>
          <cx:pt idx="981">Noc</cx:pt>
          <cx:pt idx="982">Noc</cx:pt>
          <cx:pt idx="983">Noc</cx:pt>
          <cx:pt idx="984">Noc</cx:pt>
          <cx:pt idx="985">Noc</cx:pt>
          <cx:pt idx="986">Noc</cx:pt>
          <cx:pt idx="987">Noc</cx:pt>
          <cx:pt idx="988">Noc</cx:pt>
          <cx:pt idx="989">Noc</cx:pt>
          <cx:pt idx="990">Noc</cx:pt>
          <cx:pt idx="991">Noc</cx:pt>
          <cx:pt idx="992">Noc</cx:pt>
          <cx:pt idx="993">Noc</cx:pt>
          <cx:pt idx="994">Noc</cx:pt>
          <cx:pt idx="995">Noc</cx:pt>
          <cx:pt idx="996">Noc</cx:pt>
          <cx:pt idx="997">Noc</cx:pt>
          <cx:pt idx="998">Noc</cx:pt>
          <cx:pt idx="999">Noc</cx:pt>
          <cx:pt idx="1000">Noc</cx:pt>
          <cx:pt idx="1001">Noc</cx:pt>
          <cx:pt idx="1002">Noc</cx:pt>
          <cx:pt idx="1003">Noc</cx:pt>
          <cx:pt idx="1004">Noc</cx:pt>
          <cx:pt idx="1005">Noc</cx:pt>
          <cx:pt idx="1006">Noc</cx:pt>
          <cx:pt idx="1007">Noc</cx:pt>
          <cx:pt idx="1008">Noc</cx:pt>
          <cx:pt idx="1009">Noc</cx:pt>
          <cx:pt idx="1010">Noc</cx:pt>
          <cx:pt idx="1011">Noc</cx:pt>
          <cx:pt idx="1012">Noc</cx:pt>
          <cx:pt idx="1013">Noc</cx:pt>
          <cx:pt idx="1014">Noc</cx:pt>
          <cx:pt idx="1015">Noc</cx:pt>
          <cx:pt idx="1016">Noc</cx:pt>
          <cx:pt idx="1017">Noc</cx:pt>
          <cx:pt idx="1018">Noc</cx:pt>
          <cx:pt idx="1019">Noc</cx:pt>
          <cx:pt idx="1020">Noc</cx:pt>
          <cx:pt idx="1021">Noc</cx:pt>
          <cx:pt idx="1022">Noc</cx:pt>
          <cx:pt idx="1023">Noc</cx:pt>
          <cx:pt idx="1024">Noc</cx:pt>
          <cx:pt idx="1025">Noc</cx:pt>
          <cx:pt idx="1026">Noc</cx:pt>
          <cx:pt idx="1027">Noc</cx:pt>
          <cx:pt idx="1028">Noc</cx:pt>
          <cx:pt idx="1029">Noc</cx:pt>
          <cx:pt idx="1030">Noc</cx:pt>
          <cx:pt idx="1031">Noc</cx:pt>
          <cx:pt idx="1032">Noc</cx:pt>
          <cx:pt idx="1033">Noc</cx:pt>
          <cx:pt idx="1034">Noc</cx:pt>
          <cx:pt idx="1035">Noc</cx:pt>
          <cx:pt idx="1036">Noc</cx:pt>
          <cx:pt idx="1037">Noc</cx:pt>
          <cx:pt idx="1038">Noc</cx:pt>
          <cx:pt idx="1039">Noc</cx:pt>
          <cx:pt idx="1040">Noc</cx:pt>
          <cx:pt idx="1041">Noc</cx:pt>
          <cx:pt idx="1042">Noc</cx:pt>
          <cx:pt idx="1043">Noc</cx:pt>
          <cx:pt idx="1044">Noc</cx:pt>
          <cx:pt idx="1045">Noc</cx:pt>
          <cx:pt idx="1046">Noc</cx:pt>
          <cx:pt idx="1047">Noc</cx:pt>
          <cx:pt idx="1048">Noc</cx:pt>
          <cx:pt idx="1049">Noc</cx:pt>
          <cx:pt idx="1050">Noc</cx:pt>
          <cx:pt idx="1051">Noc</cx:pt>
          <cx:pt idx="1052">Noc</cx:pt>
          <cx:pt idx="1053">Noc</cx:pt>
          <cx:pt idx="1054">Noc</cx:pt>
          <cx:pt idx="1055">Noc</cx:pt>
          <cx:pt idx="1056">Noc</cx:pt>
          <cx:pt idx="1057">Noc</cx:pt>
          <cx:pt idx="1058">Noc</cx:pt>
          <cx:pt idx="1059">Noc</cx:pt>
          <cx:pt idx="1060">Noc</cx:pt>
          <cx:pt idx="1061">Noc</cx:pt>
          <cx:pt idx="1062">Noc</cx:pt>
          <cx:pt idx="1063">Noc</cx:pt>
          <cx:pt idx="1064">Noc</cx:pt>
          <cx:pt idx="1065">Noc</cx:pt>
          <cx:pt idx="1066">Noc</cx:pt>
          <cx:pt idx="1067">Noc</cx:pt>
          <cx:pt idx="1068">Noc</cx:pt>
          <cx:pt idx="1069">Noc</cx:pt>
          <cx:pt idx="1070">Noc</cx:pt>
          <cx:pt idx="1071">Noc</cx:pt>
          <cx:pt idx="1072">Noc</cx:pt>
          <cx:pt idx="1073">Noc</cx:pt>
          <cx:pt idx="1074">Noc</cx:pt>
          <cx:pt idx="1075">Noc</cx:pt>
          <cx:pt idx="1076">Noc</cx:pt>
          <cx:pt idx="1077">Noc</cx:pt>
          <cx:pt idx="1078">Noc</cx:pt>
          <cx:pt idx="1079">Noc</cx:pt>
          <cx:pt idx="1080">Noc</cx:pt>
          <cx:pt idx="1081">Noc</cx:pt>
          <cx:pt idx="1082">Noc</cx:pt>
          <cx:pt idx="1083">Noc</cx:pt>
          <cx:pt idx="1084">Noc</cx:pt>
          <cx:pt idx="1085">Noc</cx:pt>
          <cx:pt idx="1086">Noc</cx:pt>
          <cx:pt idx="1087">Noc</cx:pt>
          <cx:pt idx="1088">Noc</cx:pt>
          <cx:pt idx="1089">Noc</cx:pt>
          <cx:pt idx="1090">Noc</cx:pt>
          <cx:pt idx="1091">Noc</cx:pt>
          <cx:pt idx="1092">Noc</cx:pt>
          <cx:pt idx="1093">Noc</cx:pt>
          <cx:pt idx="1094">Noc</cx:pt>
          <cx:pt idx="1095">Noc</cx:pt>
          <cx:pt idx="1096">Noc</cx:pt>
          <cx:pt idx="1097">Noc</cx:pt>
          <cx:pt idx="1098">Noc</cx:pt>
          <cx:pt idx="1099">Noc</cx:pt>
          <cx:pt idx="1100">Noc</cx:pt>
          <cx:pt idx="1101">Noc</cx:pt>
          <cx:pt idx="1102">Noc</cx:pt>
          <cx:pt idx="1103">Noc</cx:pt>
          <cx:pt idx="1104">Noc</cx:pt>
          <cx:pt idx="1105">Noc</cx:pt>
          <cx:pt idx="1106">Noc</cx:pt>
          <cx:pt idx="1107">Noc</cx:pt>
          <cx:pt idx="1108">Noc</cx:pt>
          <cx:pt idx="1109">Noc</cx:pt>
          <cx:pt idx="1110">Noc</cx:pt>
          <cx:pt idx="1111">Noc</cx:pt>
          <cx:pt idx="1112">Noc</cx:pt>
          <cx:pt idx="1113">Noc</cx:pt>
          <cx:pt idx="1114">Noc</cx:pt>
          <cx:pt idx="1115">Noc</cx:pt>
          <cx:pt idx="1116">Noc</cx:pt>
          <cx:pt idx="1117">Noc</cx:pt>
          <cx:pt idx="1118">Noc</cx:pt>
          <cx:pt idx="1119">Noc</cx:pt>
          <cx:pt idx="1120">Noc</cx:pt>
          <cx:pt idx="1121">Noc</cx:pt>
          <cx:pt idx="1122">Noc</cx:pt>
          <cx:pt idx="1123">Noc</cx:pt>
          <cx:pt idx="1124">Noc</cx:pt>
          <cx:pt idx="1125">Noc</cx:pt>
          <cx:pt idx="1126">Noc</cx:pt>
          <cx:pt idx="1127">Noc</cx:pt>
          <cx:pt idx="1128">Noc</cx:pt>
          <cx:pt idx="1129">Noc</cx:pt>
          <cx:pt idx="1130">Noc</cx:pt>
          <cx:pt idx="1131">Noc</cx:pt>
          <cx:pt idx="1132">Noc</cx:pt>
          <cx:pt idx="1133">Noc</cx:pt>
          <cx:pt idx="1134">Noc</cx:pt>
          <cx:pt idx="1135">Noc</cx:pt>
          <cx:pt idx="1136">Noc</cx:pt>
          <cx:pt idx="1137">Noc</cx:pt>
          <cx:pt idx="1138">Noc</cx:pt>
          <cx:pt idx="1139">Noc</cx:pt>
          <cx:pt idx="1140">Noc</cx:pt>
          <cx:pt idx="1141">Noc</cx:pt>
          <cx:pt idx="1142">Noc</cx:pt>
          <cx:pt idx="1143">Noc</cx:pt>
          <cx:pt idx="1144">Noc</cx:pt>
          <cx:pt idx="1145">Noc</cx:pt>
          <cx:pt idx="1146">Noc</cx:pt>
          <cx:pt idx="1147">Noc</cx:pt>
          <cx:pt idx="1148">Noc</cx:pt>
          <cx:pt idx="1149">Noc</cx:pt>
          <cx:pt idx="1150">Noc</cx:pt>
          <cx:pt idx="1151">Noc</cx:pt>
          <cx:pt idx="1152">Noc</cx:pt>
          <cx:pt idx="1153">Noc</cx:pt>
          <cx:pt idx="1154">Noc</cx:pt>
          <cx:pt idx="1155">Noc</cx:pt>
          <cx:pt idx="1156">Noc</cx:pt>
          <cx:pt idx="1157">Noc</cx:pt>
          <cx:pt idx="1158">Noc</cx:pt>
          <cx:pt idx="1159">Noc</cx:pt>
          <cx:pt idx="1160">Noc</cx:pt>
          <cx:pt idx="1161">Noc</cx:pt>
          <cx:pt idx="1162">Noc</cx:pt>
          <cx:pt idx="1163">Noc</cx:pt>
          <cx:pt idx="1164">Noc</cx:pt>
          <cx:pt idx="1165">Noc</cx:pt>
          <cx:pt idx="1166">Noc</cx:pt>
          <cx:pt idx="1167">Noc</cx:pt>
          <cx:pt idx="1168">Noc</cx:pt>
          <cx:pt idx="1169">Noc</cx:pt>
          <cx:pt idx="1170">Noc</cx:pt>
          <cx:pt idx="1171">Noc</cx:pt>
          <cx:pt idx="1172">Noc</cx:pt>
          <cx:pt idx="1173">Noc</cx:pt>
          <cx:pt idx="1174">Noc</cx:pt>
          <cx:pt idx="1175">Noc</cx:pt>
          <cx:pt idx="1176">Noc</cx:pt>
          <cx:pt idx="1177">Noc</cx:pt>
          <cx:pt idx="1178">Noc</cx:pt>
          <cx:pt idx="1179">Noc</cx:pt>
          <cx:pt idx="1180">Noc</cx:pt>
          <cx:pt idx="1181">Noc</cx:pt>
          <cx:pt idx="1182">Noc</cx:pt>
          <cx:pt idx="1183">Noc</cx:pt>
          <cx:pt idx="1184">Noc</cx:pt>
          <cx:pt idx="1185">Noc</cx:pt>
          <cx:pt idx="1186">Noc</cx:pt>
          <cx:pt idx="1187">Noc</cx:pt>
          <cx:pt idx="1188">Noc</cx:pt>
          <cx:pt idx="1189">Noc</cx:pt>
          <cx:pt idx="1190">Noc</cx:pt>
          <cx:pt idx="1191">Noc</cx:pt>
          <cx:pt idx="1192">Noc</cx:pt>
          <cx:pt idx="1193">Noc</cx:pt>
          <cx:pt idx="1194">Noc</cx:pt>
          <cx:pt idx="1195">Noc</cx:pt>
          <cx:pt idx="1196">Noc</cx:pt>
          <cx:pt idx="1197">Noc</cx:pt>
          <cx:pt idx="1198">Noc</cx:pt>
          <cx:pt idx="1199">Noc</cx:pt>
          <cx:pt idx="1200">Noc</cx:pt>
          <cx:pt idx="1201">Noc</cx:pt>
          <cx:pt idx="1202">Noc</cx:pt>
          <cx:pt idx="1203">Noc</cx:pt>
          <cx:pt idx="1204">Noc</cx:pt>
          <cx:pt idx="1205">Noc</cx:pt>
          <cx:pt idx="1206">Noc</cx:pt>
          <cx:pt idx="1207">Noc</cx:pt>
          <cx:pt idx="1208">Noc</cx:pt>
          <cx:pt idx="1209">Noc</cx:pt>
          <cx:pt idx="1210">Noc</cx:pt>
          <cx:pt idx="1211">Noc</cx:pt>
          <cx:pt idx="1212">Noc</cx:pt>
          <cx:pt idx="1213">Noc</cx:pt>
          <cx:pt idx="1214">Noc</cx:pt>
          <cx:pt idx="1215">Noc</cx:pt>
          <cx:pt idx="1216">Noc</cx:pt>
          <cx:pt idx="1217">Noc</cx:pt>
          <cx:pt idx="1218">Noc</cx:pt>
          <cx:pt idx="1219">Noc</cx:pt>
          <cx:pt idx="1220">Noc</cx:pt>
          <cx:pt idx="1221">Noc</cx:pt>
          <cx:pt idx="1222">Noc</cx:pt>
          <cx:pt idx="1223">Noc</cx:pt>
          <cx:pt idx="1224">Noc</cx:pt>
          <cx:pt idx="1225">Noc</cx:pt>
          <cx:pt idx="1226">Noc</cx:pt>
          <cx:pt idx="1227">Noc</cx:pt>
          <cx:pt idx="1228">Noc</cx:pt>
          <cx:pt idx="1229">Noc</cx:pt>
          <cx:pt idx="1230">Noc</cx:pt>
          <cx:pt idx="1231">Noc</cx:pt>
          <cx:pt idx="1232">Noc</cx:pt>
          <cx:pt idx="1233">Noc</cx:pt>
          <cx:pt idx="1234">Noc</cx:pt>
          <cx:pt idx="1235">Noc</cx:pt>
          <cx:pt idx="1236">Noc</cx:pt>
          <cx:pt idx="1237">Noc</cx:pt>
          <cx:pt idx="1238">Noc</cx:pt>
          <cx:pt idx="1239">Noc</cx:pt>
          <cx:pt idx="1240">Noc</cx:pt>
          <cx:pt idx="1241">Noc</cx:pt>
          <cx:pt idx="1242">Noc</cx:pt>
          <cx:pt idx="1243">Noc</cx:pt>
          <cx:pt idx="1244">Noc</cx:pt>
          <cx:pt idx="1245">Noc</cx:pt>
          <cx:pt idx="1246">Noc</cx:pt>
          <cx:pt idx="1247">Noc</cx:pt>
          <cx:pt idx="1248">Noc</cx:pt>
          <cx:pt idx="1249">Noc</cx:pt>
          <cx:pt idx="1250">Noc</cx:pt>
          <cx:pt idx="1251">Noc</cx:pt>
          <cx:pt idx="1252">Noc</cx:pt>
          <cx:pt idx="1253">Noc</cx:pt>
          <cx:pt idx="1254">Noc</cx:pt>
          <cx:pt idx="1255">Noc</cx:pt>
          <cx:pt idx="1256">Noc</cx:pt>
          <cx:pt idx="1257">Noc</cx:pt>
          <cx:pt idx="1258">Noc</cx:pt>
          <cx:pt idx="1259">Noc</cx:pt>
          <cx:pt idx="1260">Noc</cx:pt>
          <cx:pt idx="1261">Noc</cx:pt>
          <cx:pt idx="1262">Noc</cx:pt>
          <cx:pt idx="1263">Noc</cx:pt>
          <cx:pt idx="1264">Noc</cx:pt>
          <cx:pt idx="1265">Noc</cx:pt>
          <cx:pt idx="1266">Noc</cx:pt>
          <cx:pt idx="1267">Noc</cx:pt>
          <cx:pt idx="1268">Noc</cx:pt>
          <cx:pt idx="1269">Noc</cx:pt>
          <cx:pt idx="1270">Noc</cx:pt>
          <cx:pt idx="1271">Noc</cx:pt>
          <cx:pt idx="1272">Noc</cx:pt>
          <cx:pt idx="1273">Noc</cx:pt>
          <cx:pt idx="1274">Noc</cx:pt>
          <cx:pt idx="1275">Noc</cx:pt>
          <cx:pt idx="1276">Noc</cx:pt>
          <cx:pt idx="1277">Noc</cx:pt>
          <cx:pt idx="1278">Noc</cx:pt>
          <cx:pt idx="1279">Noc</cx:pt>
          <cx:pt idx="1280">Noc</cx:pt>
          <cx:pt idx="1281">Noc</cx:pt>
          <cx:pt idx="1282">Noc</cx:pt>
          <cx:pt idx="1283">Noc</cx:pt>
          <cx:pt idx="1284">Noc</cx:pt>
          <cx:pt idx="1285">Noc</cx:pt>
          <cx:pt idx="1286">Noc</cx:pt>
          <cx:pt idx="1287">Noc</cx:pt>
          <cx:pt idx="1288">Noc</cx:pt>
          <cx:pt idx="1289">Noc</cx:pt>
          <cx:pt idx="1290">Noc</cx:pt>
          <cx:pt idx="1291">Noc</cx:pt>
          <cx:pt idx="1292">Noc</cx:pt>
          <cx:pt idx="1293">Noc</cx:pt>
          <cx:pt idx="1294">Noc</cx:pt>
          <cx:pt idx="1295">Noc</cx:pt>
          <cx:pt idx="1296">Noc</cx:pt>
          <cx:pt idx="1297">Noc</cx:pt>
          <cx:pt idx="1298">Noc</cx:pt>
          <cx:pt idx="1299">Noc</cx:pt>
          <cx:pt idx="1300">Noc</cx:pt>
          <cx:pt idx="1301">Noc</cx:pt>
          <cx:pt idx="1302">Noc</cx:pt>
          <cx:pt idx="1303">Noc</cx:pt>
          <cx:pt idx="1304">Noc</cx:pt>
          <cx:pt idx="1305">Noc</cx:pt>
          <cx:pt idx="1306">Noc</cx:pt>
          <cx:pt idx="1307">Noc</cx:pt>
          <cx:pt idx="1308">Noc</cx:pt>
          <cx:pt idx="1309">Noc</cx:pt>
          <cx:pt idx="1310">Noc</cx:pt>
          <cx:pt idx="1311">Noc</cx:pt>
          <cx:pt idx="1312">Noc</cx:pt>
          <cx:pt idx="1313">Noc</cx:pt>
          <cx:pt idx="1314">Noc</cx:pt>
          <cx:pt idx="1315">Noc</cx:pt>
          <cx:pt idx="1316">Noc</cx:pt>
          <cx:pt idx="1317">Noc</cx:pt>
          <cx:pt idx="1318">Noc</cx:pt>
          <cx:pt idx="1319">Noc</cx:pt>
          <cx:pt idx="1320">Noc</cx:pt>
          <cx:pt idx="1321">Noc</cx:pt>
          <cx:pt idx="1322">Noc</cx:pt>
          <cx:pt idx="1323">Noc</cx:pt>
          <cx:pt idx="1324">Noc</cx:pt>
          <cx:pt idx="1325">Noc</cx:pt>
          <cx:pt idx="1326">Noc</cx:pt>
          <cx:pt idx="1327">Noc</cx:pt>
          <cx:pt idx="1328">Noc</cx:pt>
          <cx:pt idx="1329">Noc</cx:pt>
          <cx:pt idx="1330">Noc</cx:pt>
          <cx:pt idx="1331">Noc</cx:pt>
          <cx:pt idx="1332">Noc</cx:pt>
          <cx:pt idx="1333">Noc</cx:pt>
          <cx:pt idx="1334">Noc</cx:pt>
          <cx:pt idx="1335">Noc</cx:pt>
          <cx:pt idx="1336">Noc</cx:pt>
          <cx:pt idx="1337">Noc</cx:pt>
          <cx:pt idx="1338">Noc</cx:pt>
          <cx:pt idx="1339">Noc</cx:pt>
          <cx:pt idx="1340">Noc</cx:pt>
          <cx:pt idx="1341">Noc</cx:pt>
          <cx:pt idx="1342">Noc</cx:pt>
          <cx:pt idx="1343">Noc</cx:pt>
          <cx:pt idx="1344">Noc</cx:pt>
          <cx:pt idx="1345">Noc</cx:pt>
          <cx:pt idx="1346">Noc</cx:pt>
          <cx:pt idx="1347">Noc</cx:pt>
          <cx:pt idx="1348">Noc</cx:pt>
          <cx:pt idx="1349">Noc</cx:pt>
          <cx:pt idx="1350">Noc</cx:pt>
          <cx:pt idx="1351">Noc</cx:pt>
          <cx:pt idx="1352">Noc</cx:pt>
          <cx:pt idx="1353">Noc</cx:pt>
          <cx:pt idx="1354">Noc</cx:pt>
          <cx:pt idx="1355">Noc</cx:pt>
          <cx:pt idx="1356">Noc</cx:pt>
          <cx:pt idx="1357">Noc</cx:pt>
          <cx:pt idx="1358">Noc</cx:pt>
          <cx:pt idx="1359">Noc</cx:pt>
          <cx:pt idx="1360">Noc</cx:pt>
          <cx:pt idx="1361">Noc</cx:pt>
          <cx:pt idx="1362">Noc</cx:pt>
          <cx:pt idx="1363">Noc</cx:pt>
          <cx:pt idx="1364">Noc</cx:pt>
          <cx:pt idx="1365">Noc</cx:pt>
          <cx:pt idx="1366">Noc</cx:pt>
          <cx:pt idx="1367">Noc</cx:pt>
          <cx:pt idx="1368">Noc</cx:pt>
          <cx:pt idx="1369">Noc</cx:pt>
          <cx:pt idx="1370">Noc</cx:pt>
          <cx:pt idx="1371">Noc</cx:pt>
          <cx:pt idx="1372">Noc</cx:pt>
          <cx:pt idx="1373">Noc</cx:pt>
          <cx:pt idx="1374">Noc</cx:pt>
          <cx:pt idx="1375">Noc</cx:pt>
          <cx:pt idx="1376">Noc</cx:pt>
          <cx:pt idx="1377">Noc</cx:pt>
          <cx:pt idx="1378">Noc</cx:pt>
          <cx:pt idx="1379">Noc</cx:pt>
          <cx:pt idx="1380">Noc</cx:pt>
          <cx:pt idx="1381">Noc</cx:pt>
          <cx:pt idx="1382">Noc</cx:pt>
          <cx:pt idx="1383">Noc</cx:pt>
          <cx:pt idx="1384">Noc</cx:pt>
          <cx:pt idx="1385">Noc</cx:pt>
          <cx:pt idx="1386">Noc</cx:pt>
          <cx:pt idx="1387">Noc</cx:pt>
          <cx:pt idx="1388">Noc</cx:pt>
          <cx:pt idx="1389">Noc</cx:pt>
          <cx:pt idx="1390">Noc</cx:pt>
          <cx:pt idx="1391">Noc</cx:pt>
          <cx:pt idx="1392">Noc</cx:pt>
          <cx:pt idx="1393">Noc</cx:pt>
          <cx:pt idx="1394">Noc</cx:pt>
          <cx:pt idx="1395">Noc</cx:pt>
          <cx:pt idx="1396">Noc</cx:pt>
          <cx:pt idx="1397">Noc</cx:pt>
          <cx:pt idx="1398">Noc</cx:pt>
          <cx:pt idx="1399">Noc</cx:pt>
          <cx:pt idx="1400">Noc</cx:pt>
          <cx:pt idx="1401">Noc</cx:pt>
          <cx:pt idx="1402">Noc</cx:pt>
          <cx:pt idx="1403">Noc</cx:pt>
          <cx:pt idx="1404">Noc</cx:pt>
          <cx:pt idx="1405">Noc</cx:pt>
          <cx:pt idx="1406">Noc</cx:pt>
          <cx:pt idx="1407">Noc</cx:pt>
          <cx:pt idx="1408">Noc</cx:pt>
          <cx:pt idx="1409">Noc</cx:pt>
          <cx:pt idx="1410">Noc</cx:pt>
          <cx:pt idx="1411">Noc</cx:pt>
          <cx:pt idx="1412">Noc</cx:pt>
          <cx:pt idx="1413">Noc</cx:pt>
          <cx:pt idx="1414">Noc</cx:pt>
          <cx:pt idx="1415">Noc</cx:pt>
          <cx:pt idx="1416">Noc</cx:pt>
          <cx:pt idx="1417">Noc</cx:pt>
          <cx:pt idx="1418">Noc</cx:pt>
          <cx:pt idx="1419">Noc</cx:pt>
          <cx:pt idx="1420">Noc</cx:pt>
          <cx:pt idx="1421">Noc</cx:pt>
          <cx:pt idx="1422">Noc</cx:pt>
          <cx:pt idx="1423">Noc</cx:pt>
          <cx:pt idx="1424">Noc</cx:pt>
          <cx:pt idx="1425">Noc</cx:pt>
          <cx:pt idx="1426">Noc</cx:pt>
          <cx:pt idx="1427">Noc</cx:pt>
          <cx:pt idx="1428">Noc</cx:pt>
          <cx:pt idx="1429">Noc</cx:pt>
          <cx:pt idx="1430">Noc</cx:pt>
          <cx:pt idx="1431">Noc</cx:pt>
          <cx:pt idx="1432">Noc</cx:pt>
          <cx:pt idx="1433">Noc</cx:pt>
          <cx:pt idx="1434">Noc</cx:pt>
          <cx:pt idx="1435">Noc</cx:pt>
          <cx:pt idx="1436">Noc</cx:pt>
          <cx:pt idx="1437">Noc</cx:pt>
          <cx:pt idx="1438">Noc</cx:pt>
          <cx:pt idx="1439">Noc</cx:pt>
          <cx:pt idx="1440">Noc</cx:pt>
          <cx:pt idx="1441">Noc</cx:pt>
          <cx:pt idx="1442">Noc</cx:pt>
          <cx:pt idx="1443">Noc</cx:pt>
          <cx:pt idx="1444">Noc</cx:pt>
          <cx:pt idx="1445">Noc</cx:pt>
          <cx:pt idx="1446">Noc</cx:pt>
          <cx:pt idx="1447">Noc</cx:pt>
          <cx:pt idx="1448">Noc</cx:pt>
          <cx:pt idx="1449">Noc</cx:pt>
          <cx:pt idx="1450">Noc</cx:pt>
          <cx:pt idx="1451">Noc</cx:pt>
          <cx:pt idx="1452">Noc</cx:pt>
          <cx:pt idx="1453">Noc</cx:pt>
          <cx:pt idx="1454">Noc</cx:pt>
          <cx:pt idx="1455">Noc</cx:pt>
          <cx:pt idx="1456">Noc</cx:pt>
          <cx:pt idx="1457">Noc</cx:pt>
          <cx:pt idx="1458">Noc</cx:pt>
          <cx:pt idx="1459">Noc</cx:pt>
          <cx:pt idx="1460">Noc</cx:pt>
          <cx:pt idx="1461">Noc</cx:pt>
          <cx:pt idx="1462">Noc</cx:pt>
          <cx:pt idx="1463">Noc</cx:pt>
          <cx:pt idx="1464">Noc</cx:pt>
          <cx:pt idx="1465">Noc</cx:pt>
          <cx:pt idx="1466">Noc</cx:pt>
          <cx:pt idx="1467">Noc</cx:pt>
          <cx:pt idx="1468">Noc</cx:pt>
          <cx:pt idx="1469">Noc</cx:pt>
          <cx:pt idx="1470">Noc</cx:pt>
          <cx:pt idx="1471">Noc</cx:pt>
          <cx:pt idx="1472">Noc</cx:pt>
          <cx:pt idx="1473">Noc</cx:pt>
          <cx:pt idx="1474">Noc</cx:pt>
          <cx:pt idx="1475">Noc</cx:pt>
          <cx:pt idx="1476">Noc</cx:pt>
          <cx:pt idx="1477">Noc</cx:pt>
          <cx:pt idx="1478">Noc</cx:pt>
          <cx:pt idx="1479">Noc</cx:pt>
          <cx:pt idx="1480">Noc</cx:pt>
          <cx:pt idx="1481">Noc</cx:pt>
          <cx:pt idx="1482">Noc</cx:pt>
          <cx:pt idx="1483">Noc</cx:pt>
          <cx:pt idx="1484">Noc</cx:pt>
          <cx:pt idx="1485">Noc</cx:pt>
          <cx:pt idx="1486">Noc</cx:pt>
          <cx:pt idx="1487">Noc</cx:pt>
          <cx:pt idx="1488">Noc</cx:pt>
          <cx:pt idx="1489">Noc</cx:pt>
          <cx:pt idx="1490">Noc</cx:pt>
          <cx:pt idx="1491">Noc</cx:pt>
          <cx:pt idx="1492">Noc</cx:pt>
          <cx:pt idx="1493">Noc</cx:pt>
          <cx:pt idx="1494">Noc</cx:pt>
          <cx:pt idx="1495">Noc</cx:pt>
          <cx:pt idx="1496">Noc</cx:pt>
          <cx:pt idx="1497">Noc</cx:pt>
          <cx:pt idx="1498">Noc</cx:pt>
          <cx:pt idx="1499">Noc</cx:pt>
          <cx:pt idx="1500">Noc</cx:pt>
          <cx:pt idx="1501">Noc</cx:pt>
          <cx:pt idx="1502">Noc</cx:pt>
          <cx:pt idx="1503">Noc</cx:pt>
          <cx:pt idx="1504">Noc</cx:pt>
          <cx:pt idx="1505">Noc</cx:pt>
          <cx:pt idx="1506">Noc</cx:pt>
          <cx:pt idx="1507">Noc</cx:pt>
          <cx:pt idx="1508">Noc</cx:pt>
          <cx:pt idx="1509">Noc</cx:pt>
          <cx:pt idx="1510">Noc</cx:pt>
          <cx:pt idx="1511">Noc</cx:pt>
          <cx:pt idx="1512">Noc</cx:pt>
          <cx:pt idx="1513">Noc</cx:pt>
          <cx:pt idx="1514">Noc</cx:pt>
          <cx:pt idx="1515">Noc</cx:pt>
          <cx:pt idx="1516">Noc</cx:pt>
          <cx:pt idx="1517">Noc</cx:pt>
          <cx:pt idx="1518">Noc</cx:pt>
          <cx:pt idx="1519">Noc</cx:pt>
          <cx:pt idx="1520">Noc</cx:pt>
          <cx:pt idx="1521">Noc</cx:pt>
          <cx:pt idx="1522">Noc</cx:pt>
          <cx:pt idx="1523">Noc</cx:pt>
          <cx:pt idx="1524">Noc</cx:pt>
          <cx:pt idx="1525">Noc</cx:pt>
          <cx:pt idx="1526">Noc</cx:pt>
          <cx:pt idx="1527">Noc</cx:pt>
          <cx:pt idx="1528">Noc</cx:pt>
          <cx:pt idx="1529">Noc</cx:pt>
          <cx:pt idx="1530">Noc</cx:pt>
          <cx:pt idx="1531">Noc</cx:pt>
          <cx:pt idx="1532">Noc</cx:pt>
          <cx:pt idx="1533">Noc</cx:pt>
          <cx:pt idx="1534">Noc</cx:pt>
          <cx:pt idx="1535">Noc</cx:pt>
          <cx:pt idx="1536">Noc</cx:pt>
          <cx:pt idx="1537">Noc</cx:pt>
          <cx:pt idx="1538">Noc</cx:pt>
          <cx:pt idx="1539">Noc</cx:pt>
          <cx:pt idx="1540">Noc</cx:pt>
          <cx:pt idx="1541">Noc</cx:pt>
          <cx:pt idx="1542">Noc</cx:pt>
          <cx:pt idx="1543">Noc</cx:pt>
          <cx:pt idx="1544">Noc</cx:pt>
          <cx:pt idx="1545">Noc</cx:pt>
          <cx:pt idx="1546">Noc</cx:pt>
          <cx:pt idx="1547">Noc</cx:pt>
          <cx:pt idx="1548">Noc</cx:pt>
          <cx:pt idx="1549">Noc</cx:pt>
          <cx:pt idx="1550">Noc</cx:pt>
          <cx:pt idx="1551">Noc</cx:pt>
          <cx:pt idx="1552">Noc</cx:pt>
          <cx:pt idx="1553">Noc</cx:pt>
          <cx:pt idx="1554">Noc</cx:pt>
          <cx:pt idx="1555">Noc</cx:pt>
          <cx:pt idx="1556">Noc</cx:pt>
          <cx:pt idx="1557">Noc</cx:pt>
          <cx:pt idx="1558">Noc</cx:pt>
          <cx:pt idx="1559">Noc</cx:pt>
          <cx:pt idx="1560">Noc</cx:pt>
          <cx:pt idx="1561">Noc</cx:pt>
          <cx:pt idx="1562">Noc</cx:pt>
          <cx:pt idx="1563">Noc</cx:pt>
          <cx:pt idx="1564">Noc</cx:pt>
          <cx:pt idx="1565">Noc</cx:pt>
          <cx:pt idx="1566">Noc</cx:pt>
          <cx:pt idx="1567">Noc</cx:pt>
          <cx:pt idx="1568">Noc</cx:pt>
          <cx:pt idx="1569">Noc</cx:pt>
          <cx:pt idx="1570">Noc</cx:pt>
          <cx:pt idx="1571">Noc</cx:pt>
          <cx:pt idx="1572">Noc</cx:pt>
          <cx:pt idx="1573">Noc</cx:pt>
          <cx:pt idx="1574">Noc</cx:pt>
          <cx:pt idx="1575">Noc</cx:pt>
          <cx:pt idx="1576">Noc</cx:pt>
          <cx:pt idx="1577">Noc</cx:pt>
          <cx:pt idx="1578">Noc</cx:pt>
          <cx:pt idx="1579">Noc</cx:pt>
          <cx:pt idx="1580">Noc</cx:pt>
          <cx:pt idx="1581">Noc</cx:pt>
          <cx:pt idx="1582">Noc</cx:pt>
          <cx:pt idx="1583">Noc</cx:pt>
          <cx:pt idx="1584">Noc</cx:pt>
          <cx:pt idx="1585">Noc</cx:pt>
          <cx:pt idx="1586">Noc</cx:pt>
          <cx:pt idx="1587">Noc</cx:pt>
          <cx:pt idx="1588">Noc</cx:pt>
          <cx:pt idx="1589">Noc</cx:pt>
          <cx:pt idx="1590">Noc</cx:pt>
          <cx:pt idx="1591">Noc</cx:pt>
          <cx:pt idx="1592">Noc</cx:pt>
          <cx:pt idx="1593">Noc</cx:pt>
          <cx:pt idx="1594">Noc</cx:pt>
          <cx:pt idx="1595">Noc</cx:pt>
          <cx:pt idx="1596">Noc</cx:pt>
          <cx:pt idx="1597">Noc</cx:pt>
          <cx:pt idx="1598">Noc</cx:pt>
          <cx:pt idx="1599">Noc</cx:pt>
          <cx:pt idx="1600">Noc</cx:pt>
          <cx:pt idx="1601">Noc</cx:pt>
          <cx:pt idx="1602">Noc</cx:pt>
          <cx:pt idx="1603">Noc</cx:pt>
          <cx:pt idx="1604">Noc</cx:pt>
          <cx:pt idx="1605">Noc</cx:pt>
          <cx:pt idx="1606">Noc</cx:pt>
          <cx:pt idx="1607">Noc</cx:pt>
          <cx:pt idx="1608">Noc</cx:pt>
          <cx:pt idx="1609">Noc</cx:pt>
          <cx:pt idx="1610">Noc</cx:pt>
          <cx:pt idx="1611">Noc</cx:pt>
          <cx:pt idx="1612">Noc</cx:pt>
          <cx:pt idx="1613">Noc</cx:pt>
          <cx:pt idx="1614">Noc</cx:pt>
          <cx:pt idx="1615">Noc</cx:pt>
          <cx:pt idx="1616">Noc</cx:pt>
          <cx:pt idx="1617">Noc</cx:pt>
          <cx:pt idx="1618">Noc</cx:pt>
          <cx:pt idx="1619">Noc</cx:pt>
          <cx:pt idx="1620">Noc</cx:pt>
          <cx:pt idx="1621">Noc</cx:pt>
          <cx:pt idx="1622">Noc</cx:pt>
          <cx:pt idx="1623">Noc</cx:pt>
          <cx:pt idx="1624">Noc</cx:pt>
          <cx:pt idx="1625">Noc</cx:pt>
          <cx:pt idx="1626">Noc</cx:pt>
          <cx:pt idx="1627">Noc</cx:pt>
          <cx:pt idx="1628">Noc</cx:pt>
          <cx:pt idx="1629">Noc</cx:pt>
          <cx:pt idx="1630">Noc</cx:pt>
          <cx:pt idx="1631">Noc</cx:pt>
          <cx:pt idx="1632">Noc</cx:pt>
          <cx:pt idx="1633">Noc</cx:pt>
          <cx:pt idx="1634">Noc</cx:pt>
          <cx:pt idx="1635">Noc</cx:pt>
          <cx:pt idx="1636">Noc</cx:pt>
          <cx:pt idx="1637">Noc</cx:pt>
          <cx:pt idx="1638">Noc</cx:pt>
          <cx:pt idx="1639">Noc</cx:pt>
          <cx:pt idx="1640">Noc</cx:pt>
          <cx:pt idx="1641">Noc</cx:pt>
          <cx:pt idx="1642">Noc</cx:pt>
          <cx:pt idx="1643">Noc</cx:pt>
          <cx:pt idx="1644">Noc</cx:pt>
          <cx:pt idx="1645">Noc</cx:pt>
          <cx:pt idx="1646">Noc</cx:pt>
          <cx:pt idx="1647">Noc</cx:pt>
          <cx:pt idx="1648">Noc</cx:pt>
          <cx:pt idx="1649">Noc</cx:pt>
          <cx:pt idx="1650">Noc</cx:pt>
          <cx:pt idx="1651">Noc</cx:pt>
          <cx:pt idx="1652">Noc</cx:pt>
          <cx:pt idx="1653">Noc</cx:pt>
          <cx:pt idx="1654">Noc</cx:pt>
          <cx:pt idx="1655">Noc</cx:pt>
          <cx:pt idx="1656">Noc</cx:pt>
          <cx:pt idx="1657">Noc</cx:pt>
          <cx:pt idx="1658">Noc</cx:pt>
          <cx:pt idx="1659">Noc</cx:pt>
          <cx:pt idx="1660">Noc</cx:pt>
          <cx:pt idx="1661">Noc</cx:pt>
          <cx:pt idx="1662">Noc</cx:pt>
          <cx:pt idx="1663">Noc</cx:pt>
          <cx:pt idx="1664">Noc</cx:pt>
          <cx:pt idx="1665">Noc</cx:pt>
          <cx:pt idx="1666">Noc</cx:pt>
          <cx:pt idx="1667">Noc</cx:pt>
          <cx:pt idx="1668">Noc</cx:pt>
          <cx:pt idx="1669">Noc</cx:pt>
          <cx:pt idx="1670">Noc</cx:pt>
          <cx:pt idx="1671">Noc</cx:pt>
          <cx:pt idx="1672">Noc</cx:pt>
          <cx:pt idx="1673">Noc</cx:pt>
          <cx:pt idx="1674">Noc</cx:pt>
          <cx:pt idx="1675">Noc</cx:pt>
          <cx:pt idx="1676">Noc</cx:pt>
          <cx:pt idx="1677">Noc</cx:pt>
          <cx:pt idx="1678">Noc</cx:pt>
          <cx:pt idx="1679">Noc</cx:pt>
          <cx:pt idx="1680">Noc</cx:pt>
          <cx:pt idx="1681">Noc</cx:pt>
          <cx:pt idx="1682">Noc</cx:pt>
          <cx:pt idx="1683">Noc</cx:pt>
          <cx:pt idx="1684">Noc</cx:pt>
          <cx:pt idx="1685">Noc</cx:pt>
          <cx:pt idx="1686">Noc</cx:pt>
          <cx:pt idx="1687">Noc</cx:pt>
          <cx:pt idx="1688">Noc</cx:pt>
          <cx:pt idx="1689">Noc</cx:pt>
          <cx:pt idx="1690">Noc</cx:pt>
          <cx:pt idx="1691">Noc</cx:pt>
          <cx:pt idx="1692">Noc</cx:pt>
          <cx:pt idx="1693">Noc</cx:pt>
          <cx:pt idx="1694">Noc</cx:pt>
          <cx:pt idx="1695">Noc</cx:pt>
          <cx:pt idx="1696">Noc</cx:pt>
          <cx:pt idx="1697">Noc</cx:pt>
          <cx:pt idx="1698">Noc</cx:pt>
          <cx:pt idx="1699">Noc</cx:pt>
          <cx:pt idx="1700">Noc</cx:pt>
          <cx:pt idx="1701">Noc</cx:pt>
          <cx:pt idx="1702">Noc</cx:pt>
          <cx:pt idx="1703">Noc</cx:pt>
          <cx:pt idx="1704">Noc</cx:pt>
          <cx:pt idx="1705">Noc</cx:pt>
          <cx:pt idx="1706">Noc</cx:pt>
          <cx:pt idx="1707">Noc</cx:pt>
          <cx:pt idx="1708">Noc</cx:pt>
          <cx:pt idx="1709">Noc</cx:pt>
          <cx:pt idx="1710">Noc</cx:pt>
          <cx:pt idx="1711">Noc</cx:pt>
          <cx:pt idx="1712">Noc</cx:pt>
          <cx:pt idx="1713">Noc</cx:pt>
          <cx:pt idx="1714">Noc</cx:pt>
          <cx:pt idx="1715">Noc</cx:pt>
          <cx:pt idx="1716">Noc</cx:pt>
          <cx:pt idx="1717">Noc</cx:pt>
          <cx:pt idx="1718">Noc</cx:pt>
          <cx:pt idx="1719">Noc</cx:pt>
          <cx:pt idx="1720">Noc</cx:pt>
          <cx:pt idx="1721">Noc</cx:pt>
          <cx:pt idx="1722">Noc</cx:pt>
          <cx:pt idx="1723">Noc</cx:pt>
          <cx:pt idx="1724">Noc</cx:pt>
          <cx:pt idx="1725">Noc</cx:pt>
          <cx:pt idx="1726">Noc</cx:pt>
          <cx:pt idx="1727">Noc</cx:pt>
          <cx:pt idx="1728">Noc</cx:pt>
          <cx:pt idx="1729">Noc</cx:pt>
          <cx:pt idx="1730">Noc</cx:pt>
          <cx:pt idx="1731">Noc</cx:pt>
          <cx:pt idx="1732">Noc</cx:pt>
          <cx:pt idx="1733">Noc</cx:pt>
          <cx:pt idx="1734">Noc</cx:pt>
          <cx:pt idx="1735">Noc</cx:pt>
          <cx:pt idx="1736">Noc</cx:pt>
          <cx:pt idx="1737">Noc</cx:pt>
          <cx:pt idx="1738">Noc</cx:pt>
          <cx:pt idx="1739">Noc</cx:pt>
          <cx:pt idx="1740">Noc</cx:pt>
          <cx:pt idx="1741">Noc</cx:pt>
          <cx:pt idx="1742">Noc</cx:pt>
          <cx:pt idx="1743">Noc</cx:pt>
          <cx:pt idx="1744">Noc</cx:pt>
          <cx:pt idx="1745">Noc</cx:pt>
          <cx:pt idx="1746">Noc</cx:pt>
          <cx:pt idx="1747">Noc</cx:pt>
          <cx:pt idx="1748">Noc</cx:pt>
          <cx:pt idx="1749">Noc</cx:pt>
          <cx:pt idx="1750">Noc</cx:pt>
          <cx:pt idx="1751">Noc</cx:pt>
          <cx:pt idx="1752">Noc</cx:pt>
          <cx:pt idx="1753">Noc</cx:pt>
          <cx:pt idx="1754">Noc</cx:pt>
          <cx:pt idx="1755">Noc</cx:pt>
          <cx:pt idx="1756">Noc</cx:pt>
          <cx:pt idx="1757">Noc</cx:pt>
          <cx:pt idx="1758">Noc</cx:pt>
          <cx:pt idx="1759">Noc</cx:pt>
          <cx:pt idx="1760">Noc</cx:pt>
          <cx:pt idx="1761">Noc</cx:pt>
          <cx:pt idx="1762">Noc</cx:pt>
          <cx:pt idx="1763">Noc</cx:pt>
          <cx:pt idx="1764">Noc</cx:pt>
          <cx:pt idx="1765">Noc</cx:pt>
          <cx:pt idx="1766">Noc</cx:pt>
          <cx:pt idx="1767">Noc</cx:pt>
          <cx:pt idx="1768">Noc</cx:pt>
          <cx:pt idx="1769">Noc</cx:pt>
          <cx:pt idx="1770">Noc</cx:pt>
          <cx:pt idx="1771">Noc</cx:pt>
          <cx:pt idx="1772">Noc</cx:pt>
          <cx:pt idx="1773">Noc</cx:pt>
          <cx:pt idx="1774">Noc</cx:pt>
          <cx:pt idx="1775">Noc</cx:pt>
          <cx:pt idx="1776">Noc</cx:pt>
          <cx:pt idx="1777">Noc</cx:pt>
          <cx:pt idx="1778">Noc</cx:pt>
          <cx:pt idx="1779">Noc</cx:pt>
          <cx:pt idx="1780">Noc</cx:pt>
          <cx:pt idx="1781">Noc</cx:pt>
          <cx:pt idx="1782">Noc</cx:pt>
          <cx:pt idx="1783">Noc</cx:pt>
          <cx:pt idx="1784">Noc</cx:pt>
          <cx:pt idx="1785">Noc</cx:pt>
          <cx:pt idx="1786">Noc</cx:pt>
          <cx:pt idx="1787">Noc</cx:pt>
          <cx:pt idx="1788">Noc</cx:pt>
          <cx:pt idx="1789">Noc</cx:pt>
          <cx:pt idx="1790">Noc</cx:pt>
          <cx:pt idx="1791">Noc</cx:pt>
          <cx:pt idx="1792">Noc</cx:pt>
          <cx:pt idx="1793">Noc</cx:pt>
          <cx:pt idx="1794">Noc</cx:pt>
          <cx:pt idx="1795">Noc</cx:pt>
          <cx:pt idx="1796">Noc</cx:pt>
          <cx:pt idx="1797">Noc</cx:pt>
          <cx:pt idx="1798">Noc</cx:pt>
          <cx:pt idx="1799">Noc</cx:pt>
          <cx:pt idx="1800">Noc</cx:pt>
          <cx:pt idx="1801">Noc</cx:pt>
          <cx:pt idx="1802">Noc</cx:pt>
          <cx:pt idx="1803">Noc</cx:pt>
          <cx:pt idx="1804">Noc</cx:pt>
          <cx:pt idx="1805">Noc</cx:pt>
          <cx:pt idx="1806">Noc</cx:pt>
          <cx:pt idx="1807">Noc</cx:pt>
          <cx:pt idx="1808">Noc</cx:pt>
          <cx:pt idx="1809">Noc</cx:pt>
          <cx:pt idx="1810">Noc</cx:pt>
          <cx:pt idx="1811">Noc</cx:pt>
          <cx:pt idx="1812">Noc</cx:pt>
          <cx:pt idx="1813">Noc</cx:pt>
          <cx:pt idx="1814">Noc</cx:pt>
          <cx:pt idx="1815">Noc</cx:pt>
          <cx:pt idx="1816">Noc</cx:pt>
          <cx:pt idx="1817">Noc</cx:pt>
          <cx:pt idx="1818">Noc</cx:pt>
          <cx:pt idx="1819">Noc</cx:pt>
          <cx:pt idx="1820">Noc</cx:pt>
          <cx:pt idx="1821">Noc</cx:pt>
          <cx:pt idx="1822">Noc</cx:pt>
          <cx:pt idx="1823">Noc</cx:pt>
          <cx:pt idx="1824">Noc</cx:pt>
          <cx:pt idx="1825">Noc</cx:pt>
          <cx:pt idx="1826">Noc</cx:pt>
          <cx:pt idx="1827">Noc</cx:pt>
          <cx:pt idx="1828">Noc</cx:pt>
          <cx:pt idx="1829">Noc</cx:pt>
          <cx:pt idx="1830">Noc</cx:pt>
          <cx:pt idx="1831">Noc</cx:pt>
          <cx:pt idx="1832">Noc</cx:pt>
          <cx:pt idx="1833">Noc</cx:pt>
          <cx:pt idx="1834">Noc</cx:pt>
          <cx:pt idx="1835">Noc</cx:pt>
          <cx:pt idx="1836">Noc</cx:pt>
          <cx:pt idx="1837">Noc</cx:pt>
          <cx:pt idx="1838">Noc</cx:pt>
          <cx:pt idx="1839">Noc</cx:pt>
          <cx:pt idx="1840">Noc</cx:pt>
          <cx:pt idx="1841">Noc</cx:pt>
          <cx:pt idx="1842">Noc</cx:pt>
          <cx:pt idx="1843">Noc</cx:pt>
          <cx:pt idx="1844">Noc</cx:pt>
          <cx:pt idx="1845">Noc</cx:pt>
          <cx:pt idx="1846">Noc</cx:pt>
          <cx:pt idx="1847">Noc</cx:pt>
          <cx:pt idx="1848">Noc</cx:pt>
          <cx:pt idx="1849">Noc</cx:pt>
          <cx:pt idx="1850">Noc</cx:pt>
          <cx:pt idx="1851">Noc</cx:pt>
          <cx:pt idx="1852">Noc</cx:pt>
          <cx:pt idx="1853">Noc</cx:pt>
          <cx:pt idx="1854">Noc</cx:pt>
          <cx:pt idx="1855">Noc</cx:pt>
          <cx:pt idx="1856">Noc</cx:pt>
          <cx:pt idx="1857">Noc</cx:pt>
          <cx:pt idx="1858">Noc</cx:pt>
          <cx:pt idx="1859">Noc</cx:pt>
          <cx:pt idx="1860">Noc</cx:pt>
          <cx:pt idx="1861">Noc</cx:pt>
          <cx:pt idx="1862">Noc</cx:pt>
          <cx:pt idx="1863">Noc</cx:pt>
          <cx:pt idx="1864">Noc</cx:pt>
          <cx:pt idx="1865">Noc</cx:pt>
          <cx:pt idx="1866">Noc</cx:pt>
          <cx:pt idx="1867">Noc</cx:pt>
          <cx:pt idx="1868">Noc</cx:pt>
          <cx:pt idx="1869">Noc</cx:pt>
          <cx:pt idx="1870">Noc</cx:pt>
          <cx:pt idx="1871">Noc</cx:pt>
          <cx:pt idx="1872">Noc</cx:pt>
          <cx:pt idx="1873">Noc</cx:pt>
          <cx:pt idx="1874">Noc</cx:pt>
          <cx:pt idx="1875">Noc</cx:pt>
          <cx:pt idx="1876">Noc</cx:pt>
          <cx:pt idx="1877">Noc</cx:pt>
          <cx:pt idx="1878">Noc</cx:pt>
          <cx:pt idx="1879">Noc</cx:pt>
          <cx:pt idx="1880">Noc</cx:pt>
          <cx:pt idx="1881">Noc</cx:pt>
          <cx:pt idx="1882">Noc</cx:pt>
          <cx:pt idx="1883">Noc</cx:pt>
          <cx:pt idx="1884">Noc</cx:pt>
          <cx:pt idx="1885">Noc</cx:pt>
          <cx:pt idx="1886">Noc</cx:pt>
          <cx:pt idx="1887">Noc</cx:pt>
          <cx:pt idx="1888">Noc</cx:pt>
          <cx:pt idx="1889">Noc</cx:pt>
          <cx:pt idx="1890">Noc</cx:pt>
          <cx:pt idx="1891">Noc</cx:pt>
          <cx:pt idx="1892">Noc</cx:pt>
          <cx:pt idx="1893">Noc</cx:pt>
          <cx:pt idx="1894">Noc</cx:pt>
          <cx:pt idx="1895">Noc</cx:pt>
          <cx:pt idx="1896">Noc</cx:pt>
          <cx:pt idx="1897">Noc</cx:pt>
          <cx:pt idx="1898">Noc</cx:pt>
          <cx:pt idx="1899">Noc</cx:pt>
          <cx:pt idx="1900">Noc</cx:pt>
          <cx:pt idx="1901">Noc</cx:pt>
          <cx:pt idx="1902">Noc</cx:pt>
          <cx:pt idx="1903">Noc</cx:pt>
          <cx:pt idx="1904">Noc</cx:pt>
          <cx:pt idx="1905">Noc</cx:pt>
          <cx:pt idx="1906">Noc</cx:pt>
          <cx:pt idx="1907">Noc</cx:pt>
          <cx:pt idx="1908">Noc</cx:pt>
          <cx:pt idx="1909">Noc</cx:pt>
          <cx:pt idx="1910">Noc</cx:pt>
          <cx:pt idx="1911">Noc</cx:pt>
          <cx:pt idx="1912">Noc</cx:pt>
          <cx:pt idx="1913">Noc</cx:pt>
          <cx:pt idx="1914">Noc</cx:pt>
          <cx:pt idx="1915">Noc</cx:pt>
          <cx:pt idx="1916">Noc</cx:pt>
          <cx:pt idx="1917">Noc</cx:pt>
          <cx:pt idx="1918">Noc</cx:pt>
          <cx:pt idx="1919">Noc</cx:pt>
          <cx:pt idx="1920">Noc</cx:pt>
          <cx:pt idx="1921">Noc</cx:pt>
          <cx:pt idx="1922">Noc</cx:pt>
          <cx:pt idx="1923">Noc</cx:pt>
          <cx:pt idx="1924">Noc</cx:pt>
          <cx:pt idx="1925">Noc</cx:pt>
          <cx:pt idx="1926">Noc</cx:pt>
          <cx:pt idx="1927">Noc</cx:pt>
          <cx:pt idx="1928">Noc</cx:pt>
          <cx:pt idx="1929">Noc</cx:pt>
          <cx:pt idx="1930">Noc</cx:pt>
          <cx:pt idx="1931">Noc</cx:pt>
          <cx:pt idx="1932">Noc</cx:pt>
          <cx:pt idx="1933">Noc</cx:pt>
          <cx:pt idx="1934">Noc</cx:pt>
          <cx:pt idx="1935">Noc</cx:pt>
          <cx:pt idx="1936">Noc</cx:pt>
          <cx:pt idx="1937">Noc</cx:pt>
          <cx:pt idx="1938">Noc</cx:pt>
          <cx:pt idx="1939">Noc</cx:pt>
          <cx:pt idx="1940">Noc</cx:pt>
          <cx:pt idx="1941">Noc</cx:pt>
          <cx:pt idx="1942">Noc</cx:pt>
          <cx:pt idx="1943">Noc</cx:pt>
          <cx:pt idx="1944">Noc</cx:pt>
          <cx:pt idx="1945">Noc</cx:pt>
          <cx:pt idx="1946">Noc</cx:pt>
          <cx:pt idx="1947">Noc</cx:pt>
          <cx:pt idx="1948">Noc</cx:pt>
          <cx:pt idx="1949">Noc</cx:pt>
          <cx:pt idx="1950">Noc</cx:pt>
          <cx:pt idx="1951">Noc</cx:pt>
          <cx:pt idx="1952">Noc</cx:pt>
          <cx:pt idx="1953">Noc</cx:pt>
          <cx:pt idx="1954">Noc</cx:pt>
          <cx:pt idx="1955">Noc</cx:pt>
          <cx:pt idx="1956">Noc</cx:pt>
          <cx:pt idx="1957">Noc</cx:pt>
          <cx:pt idx="1958">Noc</cx:pt>
          <cx:pt idx="1959">Noc</cx:pt>
          <cx:pt idx="1960">Noc</cx:pt>
          <cx:pt idx="1961">Noc</cx:pt>
          <cx:pt idx="1962">Noc</cx:pt>
          <cx:pt idx="1963">Noc</cx:pt>
          <cx:pt idx="1964">Noc</cx:pt>
          <cx:pt idx="1965">Noc</cx:pt>
          <cx:pt idx="1966">Noc</cx:pt>
          <cx:pt idx="1967">Noc</cx:pt>
          <cx:pt idx="1968">Noc</cx:pt>
          <cx:pt idx="1969">Noc</cx:pt>
          <cx:pt idx="1970">Noc</cx:pt>
          <cx:pt idx="1971">Noc</cx:pt>
          <cx:pt idx="1972">Noc</cx:pt>
          <cx:pt idx="1973">Noc</cx:pt>
          <cx:pt idx="1974">Noc</cx:pt>
          <cx:pt idx="1975">Noc</cx:pt>
          <cx:pt idx="1976">Noc</cx:pt>
          <cx:pt idx="1977">Noc</cx:pt>
          <cx:pt idx="1978">Noc</cx:pt>
          <cx:pt idx="1979">Noc</cx:pt>
          <cx:pt idx="1980">Noc</cx:pt>
          <cx:pt idx="1981">Noc</cx:pt>
          <cx:pt idx="1982">Noc</cx:pt>
          <cx:pt idx="1983">Noc</cx:pt>
          <cx:pt idx="1984">Noc</cx:pt>
          <cx:pt idx="1985">Noc</cx:pt>
          <cx:pt idx="1986">Noc</cx:pt>
          <cx:pt idx="1987">Noc</cx:pt>
          <cx:pt idx="1988">Noc</cx:pt>
          <cx:pt idx="1989">Noc</cx:pt>
          <cx:pt idx="1990">Noc</cx:pt>
          <cx:pt idx="1991">Noc</cx:pt>
          <cx:pt idx="1992">Noc</cx:pt>
          <cx:pt idx="1993">Noc</cx:pt>
          <cx:pt idx="1994">Noc</cx:pt>
          <cx:pt idx="1995">Noc</cx:pt>
          <cx:pt idx="1996">Noc</cx:pt>
          <cx:pt idx="1997">Noc</cx:pt>
          <cx:pt idx="1998">Noc</cx:pt>
          <cx:pt idx="1999">Noc</cx:pt>
          <cx:pt idx="2000">Noc</cx:pt>
          <cx:pt idx="2001">Noc</cx:pt>
          <cx:pt idx="2002">Noc</cx:pt>
          <cx:pt idx="2003">Noc</cx:pt>
          <cx:pt idx="2004">Noc</cx:pt>
          <cx:pt idx="2005">Noc</cx:pt>
          <cx:pt idx="2006">Noc</cx:pt>
          <cx:pt idx="2007">Noc</cx:pt>
          <cx:pt idx="2008">Noc</cx:pt>
          <cx:pt idx="2009">Noc</cx:pt>
          <cx:pt idx="2010">Noc</cx:pt>
          <cx:pt idx="2011">Noc</cx:pt>
          <cx:pt idx="2012">Noc</cx:pt>
          <cx:pt idx="2013">Noc</cx:pt>
          <cx:pt idx="2014">Noc</cx:pt>
          <cx:pt idx="2015">Noc</cx:pt>
          <cx:pt idx="2016">Noc</cx:pt>
          <cx:pt idx="2017">Noc</cx:pt>
          <cx:pt idx="2018">Noc</cx:pt>
          <cx:pt idx="2019">Noc</cx:pt>
          <cx:pt idx="2020">Noc</cx:pt>
          <cx:pt idx="2021">Noc</cx:pt>
          <cx:pt idx="2022">Noc</cx:pt>
          <cx:pt idx="2023">Noc</cx:pt>
          <cx:pt idx="2024">Noc</cx:pt>
          <cx:pt idx="2025">Noc</cx:pt>
          <cx:pt idx="2026">Noc</cx:pt>
          <cx:pt idx="2027">Noc</cx:pt>
          <cx:pt idx="2028">Noc</cx:pt>
          <cx:pt idx="2029">Noc</cx:pt>
          <cx:pt idx="2030">Noc</cx:pt>
          <cx:pt idx="2031">Noc</cx:pt>
          <cx:pt idx="2032">Noc</cx:pt>
          <cx:pt idx="2033">Noc</cx:pt>
          <cx:pt idx="2034">Noc</cx:pt>
          <cx:pt idx="2035">Noc</cx:pt>
          <cx:pt idx="2036">Noc</cx:pt>
          <cx:pt idx="2037">Noc</cx:pt>
          <cx:pt idx="2038">Noc</cx:pt>
          <cx:pt idx="2039">Noc</cx:pt>
          <cx:pt idx="2040">Noc</cx:pt>
          <cx:pt idx="2041">Noc</cx:pt>
          <cx:pt idx="2042">Noc</cx:pt>
          <cx:pt idx="2043">Noc</cx:pt>
          <cx:pt idx="2044">Noc</cx:pt>
          <cx:pt idx="2045">Noc</cx:pt>
          <cx:pt idx="2046">Noc</cx:pt>
          <cx:pt idx="2047">Noc</cx:pt>
          <cx:pt idx="2048">Noc</cx:pt>
          <cx:pt idx="2049">Noc</cx:pt>
          <cx:pt idx="2050">Noc</cx:pt>
          <cx:pt idx="2051">Noc</cx:pt>
          <cx:pt idx="2052">Noc</cx:pt>
          <cx:pt idx="2053">Noc</cx:pt>
          <cx:pt idx="2054">Noc</cx:pt>
          <cx:pt idx="2055">Noc</cx:pt>
          <cx:pt idx="2056">Noc</cx:pt>
          <cx:pt idx="2057">Noc</cx:pt>
          <cx:pt idx="2058">Noc</cx:pt>
          <cx:pt idx="2059">Noc</cx:pt>
          <cx:pt idx="2060">Noc</cx:pt>
          <cx:pt idx="2061">Noc</cx:pt>
          <cx:pt idx="2062">Noc</cx:pt>
          <cx:pt idx="2063">Noc</cx:pt>
          <cx:pt idx="2064">Noc</cx:pt>
          <cx:pt idx="2065">Noc</cx:pt>
          <cx:pt idx="2066">Noc</cx:pt>
          <cx:pt idx="2067">Noc</cx:pt>
          <cx:pt idx="2068">Noc</cx:pt>
          <cx:pt idx="2069">Noc</cx:pt>
          <cx:pt idx="2070">Noc</cx:pt>
          <cx:pt idx="2071">Noc</cx:pt>
          <cx:pt idx="2072">Noc</cx:pt>
          <cx:pt idx="2073">Noc</cx:pt>
          <cx:pt idx="2074">Noc</cx:pt>
          <cx:pt idx="2075">Noc</cx:pt>
          <cx:pt idx="2076">Noc</cx:pt>
          <cx:pt idx="2077">Noc</cx:pt>
          <cx:pt idx="2078">Noc</cx:pt>
          <cx:pt idx="2079">Noc</cx:pt>
          <cx:pt idx="2080">Noc</cx:pt>
          <cx:pt idx="2081">Noc</cx:pt>
          <cx:pt idx="2082">Noc</cx:pt>
          <cx:pt idx="2083">Noc</cx:pt>
          <cx:pt idx="2084">Noc</cx:pt>
          <cx:pt idx="2085">Noc</cx:pt>
          <cx:pt idx="2086">Noc</cx:pt>
          <cx:pt idx="2087">Noc</cx:pt>
          <cx:pt idx="2088">Noc</cx:pt>
          <cx:pt idx="2089">Noc</cx:pt>
          <cx:pt idx="2090">Noc</cx:pt>
          <cx:pt idx="2091">Noc</cx:pt>
          <cx:pt idx="2092">Noc</cx:pt>
          <cx:pt idx="2093">Noc</cx:pt>
          <cx:pt idx="2094">Noc</cx:pt>
          <cx:pt idx="2095">Noc</cx:pt>
          <cx:pt idx="2096">Noc</cx:pt>
          <cx:pt idx="2097">Noc</cx:pt>
          <cx:pt idx="2098">Noc</cx:pt>
          <cx:pt idx="2099">Noc</cx:pt>
          <cx:pt idx="2100">Noc</cx:pt>
          <cx:pt idx="2101">Noc</cx:pt>
          <cx:pt idx="2102">Noc</cx:pt>
          <cx:pt idx="2103">Noc</cx:pt>
          <cx:pt idx="2104">Noc</cx:pt>
          <cx:pt idx="2105">Noc</cx:pt>
          <cx:pt idx="2106">Noc</cx:pt>
          <cx:pt idx="2107">Noc</cx:pt>
          <cx:pt idx="2108">Noc</cx:pt>
          <cx:pt idx="2109">Noc</cx:pt>
          <cx:pt idx="2110">Noc</cx:pt>
          <cx:pt idx="2111">Noc</cx:pt>
          <cx:pt idx="2112">Noc</cx:pt>
          <cx:pt idx="2113">Noc</cx:pt>
          <cx:pt idx="2114">Noc</cx:pt>
          <cx:pt idx="2115">Noc</cx:pt>
          <cx:pt idx="2116">Noc</cx:pt>
          <cx:pt idx="2117">Noc</cx:pt>
          <cx:pt idx="2118">Noc</cx:pt>
          <cx:pt idx="2119">Noc</cx:pt>
          <cx:pt idx="2120">Noc</cx:pt>
          <cx:pt idx="2121">Noc</cx:pt>
          <cx:pt idx="2122">Noc</cx:pt>
          <cx:pt idx="2123">Noc</cx:pt>
          <cx:pt idx="2124">Noc</cx:pt>
          <cx:pt idx="2125">Noc</cx:pt>
          <cx:pt idx="2126">Noc</cx:pt>
          <cx:pt idx="2127">Noc</cx:pt>
          <cx:pt idx="2128">Noc</cx:pt>
          <cx:pt idx="2129">Noc</cx:pt>
          <cx:pt idx="2130">Noc</cx:pt>
          <cx:pt idx="2131">Noc</cx:pt>
          <cx:pt idx="2132">Noc</cx:pt>
          <cx:pt idx="2133">Noc</cx:pt>
          <cx:pt idx="2134">Noc</cx:pt>
          <cx:pt idx="2135">Noc</cx:pt>
          <cx:pt idx="2136">Noc</cx:pt>
          <cx:pt idx="2137">Noc</cx:pt>
          <cx:pt idx="2138">Noc</cx:pt>
          <cx:pt idx="2139">Noc</cx:pt>
          <cx:pt idx="2140">Noc</cx:pt>
          <cx:pt idx="2141">Noc</cx:pt>
          <cx:pt idx="2142">Noc</cx:pt>
          <cx:pt idx="2143">Noc</cx:pt>
          <cx:pt idx="2144">Noc</cx:pt>
          <cx:pt idx="2145">Noc</cx:pt>
          <cx:pt idx="2146">Noc</cx:pt>
          <cx:pt idx="2147">Noc</cx:pt>
          <cx:pt idx="2148">Noc</cx:pt>
          <cx:pt idx="2149">Noc</cx:pt>
          <cx:pt idx="2150">Noc</cx:pt>
          <cx:pt idx="2151">Noc</cx:pt>
          <cx:pt idx="2152">Noc</cx:pt>
          <cx:pt idx="2153">Noc</cx:pt>
          <cx:pt idx="2154">Noc</cx:pt>
          <cx:pt idx="2155">Noc</cx:pt>
          <cx:pt idx="2156">Noc</cx:pt>
          <cx:pt idx="2157">Noc</cx:pt>
          <cx:pt idx="2158">Noc</cx:pt>
          <cx:pt idx="2159">Noc</cx:pt>
          <cx:pt idx="2160">Noc</cx:pt>
          <cx:pt idx="2161">Noc</cx:pt>
          <cx:pt idx="2162">Noc</cx:pt>
          <cx:pt idx="2163">Noc</cx:pt>
          <cx:pt idx="2164">Noc</cx:pt>
          <cx:pt idx="2165">Noc</cx:pt>
          <cx:pt idx="2166">Noc</cx:pt>
          <cx:pt idx="2167">Noc</cx:pt>
          <cx:pt idx="2168">Noc</cx:pt>
          <cx:pt idx="2169">Noc</cx:pt>
          <cx:pt idx="2170">Noc</cx:pt>
          <cx:pt idx="2171">Noc</cx:pt>
          <cx:pt idx="2172">Noc</cx:pt>
          <cx:pt idx="2173">Noc</cx:pt>
          <cx:pt idx="2174">Noc</cx:pt>
          <cx:pt idx="2175">Noc</cx:pt>
          <cx:pt idx="2176">Noc</cx:pt>
          <cx:pt idx="2177">Noc</cx:pt>
          <cx:pt idx="2178">Noc</cx:pt>
          <cx:pt idx="2179">Noc</cx:pt>
          <cx:pt idx="2180">Noc</cx:pt>
          <cx:pt idx="2181">Noc</cx:pt>
          <cx:pt idx="2182">Noc</cx:pt>
          <cx:pt idx="2183">Noc</cx:pt>
          <cx:pt idx="2184">Noc</cx:pt>
          <cx:pt idx="2185">Noc</cx:pt>
          <cx:pt idx="2186">Noc</cx:pt>
          <cx:pt idx="2187">Noc</cx:pt>
          <cx:pt idx="2188">Noc</cx:pt>
          <cx:pt idx="2189">Noc</cx:pt>
          <cx:pt idx="2190">Noc</cx:pt>
          <cx:pt idx="2191">Noc</cx:pt>
          <cx:pt idx="2192">Noc</cx:pt>
          <cx:pt idx="2193">Noc</cx:pt>
          <cx:pt idx="2194">Noc</cx:pt>
          <cx:pt idx="2195">Noc</cx:pt>
          <cx:pt idx="2196">Noc</cx:pt>
          <cx:pt idx="2197">Noc</cx:pt>
          <cx:pt idx="2198">Noc</cx:pt>
          <cx:pt idx="2199">Noc</cx:pt>
          <cx:pt idx="2200">Noc</cx:pt>
          <cx:pt idx="2201">Noc</cx:pt>
          <cx:pt idx="2202">Noc</cx:pt>
          <cx:pt idx="2203">Noc</cx:pt>
          <cx:pt idx="2204">Noc</cx:pt>
          <cx:pt idx="2205">Noc</cx:pt>
          <cx:pt idx="2206">Noc</cx:pt>
          <cx:pt idx="2207">Noc</cx:pt>
          <cx:pt idx="2208">Noc</cx:pt>
          <cx:pt idx="2209">Noc</cx:pt>
          <cx:pt idx="2210">Noc</cx:pt>
          <cx:pt idx="2211">Noc</cx:pt>
          <cx:pt idx="2212">Noc</cx:pt>
          <cx:pt idx="2213">Noc</cx:pt>
          <cx:pt idx="2214">Noc</cx:pt>
          <cx:pt idx="2215">Noc</cx:pt>
          <cx:pt idx="2216">Noc</cx:pt>
          <cx:pt idx="2217">Noc</cx:pt>
          <cx:pt idx="2218">Noc</cx:pt>
          <cx:pt idx="2219">Noc</cx:pt>
          <cx:pt idx="2220">Noc</cx:pt>
          <cx:pt idx="2221">Noc</cx:pt>
          <cx:pt idx="2222">Noc</cx:pt>
          <cx:pt idx="2223">Noc</cx:pt>
          <cx:pt idx="2224">Noc</cx:pt>
          <cx:pt idx="2225">Noc</cx:pt>
          <cx:pt idx="2226">Noc</cx:pt>
          <cx:pt idx="2227">Noc</cx:pt>
          <cx:pt idx="2228">Noc</cx:pt>
          <cx:pt idx="2229">Noc</cx:pt>
          <cx:pt idx="2230">Noc</cx:pt>
          <cx:pt idx="2231">Noc</cx:pt>
          <cx:pt idx="2232">Noc</cx:pt>
          <cx:pt idx="2233">Noc</cx:pt>
          <cx:pt idx="2234">Noc</cx:pt>
          <cx:pt idx="2235">Noc</cx:pt>
          <cx:pt idx="2236">Noc</cx:pt>
          <cx:pt idx="2237">Noc</cx:pt>
          <cx:pt idx="2238">Noc</cx:pt>
          <cx:pt idx="2239">Noc</cx:pt>
          <cx:pt idx="2240">Noc</cx:pt>
          <cx:pt idx="2241">Noc</cx:pt>
          <cx:pt idx="2242">Noc</cx:pt>
          <cx:pt idx="2243">Noc</cx:pt>
          <cx:pt idx="2244">Noc</cx:pt>
          <cx:pt idx="2245">Noc</cx:pt>
          <cx:pt idx="2246">Noc</cx:pt>
          <cx:pt idx="2247">Noc</cx:pt>
          <cx:pt idx="2248">Noc</cx:pt>
          <cx:pt idx="2249">Noc</cx:pt>
          <cx:pt idx="2250">Noc</cx:pt>
          <cx:pt idx="2251">Noc</cx:pt>
          <cx:pt idx="2252">Noc</cx:pt>
          <cx:pt idx="2253">Noc</cx:pt>
          <cx:pt idx="2254">Noc</cx:pt>
          <cx:pt idx="2255">Noc</cx:pt>
          <cx:pt idx="2256">Noc</cx:pt>
          <cx:pt idx="2257">Noc</cx:pt>
          <cx:pt idx="2258">Noc</cx:pt>
          <cx:pt idx="2259">Noc</cx:pt>
          <cx:pt idx="2260">Noc</cx:pt>
          <cx:pt idx="2261">Noc</cx:pt>
          <cx:pt idx="2262">Noc</cx:pt>
          <cx:pt idx="2263">Noc</cx:pt>
          <cx:pt idx="2264">Noc</cx:pt>
          <cx:pt idx="2265">Noc</cx:pt>
          <cx:pt idx="2266">Noc</cx:pt>
          <cx:pt idx="2267">Noc</cx:pt>
          <cx:pt idx="2268">Noc</cx:pt>
          <cx:pt idx="2269">Noc</cx:pt>
          <cx:pt idx="2270">Noc</cx:pt>
          <cx:pt idx="2271">Noc</cx:pt>
          <cx:pt idx="2272">Noc</cx:pt>
          <cx:pt idx="2273">Noc</cx:pt>
          <cx:pt idx="2274">Noc</cx:pt>
          <cx:pt idx="2275">Noc</cx:pt>
          <cx:pt idx="2276">Noc</cx:pt>
          <cx:pt idx="2277">Noc</cx:pt>
          <cx:pt idx="2278">Noc</cx:pt>
          <cx:pt idx="2279">Noc</cx:pt>
          <cx:pt idx="2280">Noc</cx:pt>
          <cx:pt idx="2281">Noc</cx:pt>
          <cx:pt idx="2282">Noc</cx:pt>
          <cx:pt idx="2283">Noc</cx:pt>
          <cx:pt idx="2284">Noc</cx:pt>
          <cx:pt idx="2285">Noc</cx:pt>
          <cx:pt idx="2286">Noc</cx:pt>
          <cx:pt idx="2287">Noc</cx:pt>
          <cx:pt idx="2288">Noc</cx:pt>
          <cx:pt idx="2289">Noc</cx:pt>
          <cx:pt idx="2290">Noc</cx:pt>
          <cx:pt idx="2291">Noc</cx:pt>
          <cx:pt idx="2292">Noc</cx:pt>
          <cx:pt idx="2293">Noc</cx:pt>
          <cx:pt idx="2294">Noc</cx:pt>
          <cx:pt idx="2295">Noc</cx:pt>
          <cx:pt idx="2296">Noc</cx:pt>
          <cx:pt idx="2297">Noc</cx:pt>
          <cx:pt idx="2298">Noc</cx:pt>
          <cx:pt idx="2299">Noc</cx:pt>
          <cx:pt idx="2300">Noc</cx:pt>
          <cx:pt idx="2301">Noc</cx:pt>
          <cx:pt idx="2302">Noc</cx:pt>
          <cx:pt idx="2303">Noc</cx:pt>
          <cx:pt idx="2304">Noc</cx:pt>
          <cx:pt idx="2305">Noc</cx:pt>
          <cx:pt idx="2306">Noc</cx:pt>
          <cx:pt idx="2307">Noc</cx:pt>
          <cx:pt idx="2308">Noc</cx:pt>
          <cx:pt idx="2309">Noc</cx:pt>
          <cx:pt idx="2310">Noc</cx:pt>
          <cx:pt idx="2311">Noc</cx:pt>
          <cx:pt idx="2312">Noc</cx:pt>
          <cx:pt idx="2313">Noc</cx:pt>
          <cx:pt idx="2314">Noc</cx:pt>
          <cx:pt idx="2315">Noc</cx:pt>
          <cx:pt idx="2316">Noc</cx:pt>
          <cx:pt idx="2317">Noc</cx:pt>
          <cx:pt idx="2318">Noc</cx:pt>
          <cx:pt idx="2319">Noc</cx:pt>
          <cx:pt idx="2320">Noc</cx:pt>
          <cx:pt idx="2321">Noc</cx:pt>
          <cx:pt idx="2322">Noc</cx:pt>
          <cx:pt idx="2323">Noc</cx:pt>
          <cx:pt idx="2324">Noc</cx:pt>
          <cx:pt idx="2325">Noc</cx:pt>
          <cx:pt idx="2326">Noc</cx:pt>
          <cx:pt idx="2327">Noc</cx:pt>
          <cx:pt idx="2328">Noc</cx:pt>
          <cx:pt idx="2329">Noc</cx:pt>
          <cx:pt idx="2330">Noc</cx:pt>
          <cx:pt idx="2331">Noc</cx:pt>
          <cx:pt idx="2332">Noc</cx:pt>
          <cx:pt idx="2333">Noc</cx:pt>
          <cx:pt idx="2334">Noc</cx:pt>
          <cx:pt idx="2335">Noc</cx:pt>
          <cx:pt idx="2336">Noc</cx:pt>
          <cx:pt idx="2337">Noc</cx:pt>
          <cx:pt idx="2338">Noc</cx:pt>
          <cx:pt idx="2339">Noc</cx:pt>
          <cx:pt idx="2340">Noc</cx:pt>
          <cx:pt idx="2341">Noc</cx:pt>
          <cx:pt idx="2342">Noc</cx:pt>
          <cx:pt idx="2343">Noc</cx:pt>
          <cx:pt idx="2344">Noc</cx:pt>
          <cx:pt idx="2345">Noc</cx:pt>
          <cx:pt idx="2346">Noc</cx:pt>
          <cx:pt idx="2347">Noc</cx:pt>
          <cx:pt idx="2348">Noc</cx:pt>
          <cx:pt idx="2349">Noc</cx:pt>
          <cx:pt idx="2350">Noc</cx:pt>
          <cx:pt idx="2351">Noc</cx:pt>
          <cx:pt idx="2352">Noc</cx:pt>
          <cx:pt idx="2353">Noc</cx:pt>
          <cx:pt idx="2354">Noc</cx:pt>
          <cx:pt idx="2355">Noc</cx:pt>
          <cx:pt idx="2356">Noc</cx:pt>
          <cx:pt idx="2357">Noc</cx:pt>
          <cx:pt idx="2358">Noc</cx:pt>
          <cx:pt idx="2359">Noc</cx:pt>
          <cx:pt idx="2360">Noc</cx:pt>
          <cx:pt idx="2361">Noc</cx:pt>
          <cx:pt idx="2362">Noc</cx:pt>
          <cx:pt idx="2363">Noc</cx:pt>
          <cx:pt idx="2364">Noc</cx:pt>
          <cx:pt idx="2365">Noc</cx:pt>
          <cx:pt idx="2366">Noc</cx:pt>
          <cx:pt idx="2367">Noc</cx:pt>
          <cx:pt idx="2368">Noc</cx:pt>
          <cx:pt idx="2369">Noc</cx:pt>
          <cx:pt idx="2370">Noc</cx:pt>
          <cx:pt idx="2371">Noc</cx:pt>
          <cx:pt idx="2372">Noc</cx:pt>
          <cx:pt idx="2373">Noc</cx:pt>
          <cx:pt idx="2374">Noc</cx:pt>
          <cx:pt idx="2375">Noc</cx:pt>
          <cx:pt idx="2376">Noc</cx:pt>
          <cx:pt idx="2377">Noc</cx:pt>
          <cx:pt idx="2378">Noc</cx:pt>
          <cx:pt idx="2379">Noc</cx:pt>
          <cx:pt idx="2380">Noc</cx:pt>
          <cx:pt idx="2381">Noc</cx:pt>
          <cx:pt idx="2382">Noc</cx:pt>
          <cx:pt idx="2383">Noc</cx:pt>
          <cx:pt idx="2384">Noc</cx:pt>
          <cx:pt idx="2385">Noc</cx:pt>
          <cx:pt idx="2386">Noc</cx:pt>
          <cx:pt idx="2387">Noc</cx:pt>
          <cx:pt idx="2388">Noc</cx:pt>
          <cx:pt idx="2389">Noc</cx:pt>
          <cx:pt idx="2390">Noc</cx:pt>
          <cx:pt idx="2391">Noc</cx:pt>
          <cx:pt idx="2392">Noc</cx:pt>
          <cx:pt idx="2393">Noc</cx:pt>
          <cx:pt idx="2394">Noc</cx:pt>
          <cx:pt idx="2395">Noc</cx:pt>
          <cx:pt idx="2396">Noc</cx:pt>
          <cx:pt idx="2397">Noc</cx:pt>
          <cx:pt idx="2398">Noc</cx:pt>
          <cx:pt idx="2399">Noc</cx:pt>
          <cx:pt idx="2400">Noc</cx:pt>
          <cx:pt idx="2401">Noc</cx:pt>
          <cx:pt idx="2402">Noc</cx:pt>
          <cx:pt idx="2403">Noc</cx:pt>
          <cx:pt idx="2404">Noc</cx:pt>
          <cx:pt idx="2405">Noc</cx:pt>
          <cx:pt idx="2406">Noc</cx:pt>
          <cx:pt idx="2407">Noc</cx:pt>
          <cx:pt idx="2408">Noc</cx:pt>
          <cx:pt idx="2409">Noc</cx:pt>
          <cx:pt idx="2410">Noc</cx:pt>
          <cx:pt idx="2411">Noc</cx:pt>
          <cx:pt idx="2412">Noc</cx:pt>
          <cx:pt idx="2413">Noc</cx:pt>
          <cx:pt idx="2414">Noc</cx:pt>
          <cx:pt idx="2415">Noc</cx:pt>
          <cx:pt idx="2416">Noc</cx:pt>
          <cx:pt idx="2417">Noc</cx:pt>
          <cx:pt idx="2418">Noc</cx:pt>
          <cx:pt idx="2419">Noc</cx:pt>
          <cx:pt idx="2420">Noc</cx:pt>
          <cx:pt idx="2421">Noc</cx:pt>
          <cx:pt idx="2422">Noc</cx:pt>
          <cx:pt idx="2423">Noc</cx:pt>
          <cx:pt idx="2424">Noc</cx:pt>
          <cx:pt idx="2425">Noc</cx:pt>
          <cx:pt idx="2426">Noc</cx:pt>
          <cx:pt idx="2427">Noc</cx:pt>
          <cx:pt idx="2428">Noc</cx:pt>
          <cx:pt idx="2429">Noc</cx:pt>
          <cx:pt idx="2430">Noc</cx:pt>
          <cx:pt idx="2431">Noc</cx:pt>
          <cx:pt idx="2432">Noc</cx:pt>
          <cx:pt idx="2433">Noc</cx:pt>
          <cx:pt idx="2434">Noc</cx:pt>
          <cx:pt idx="2435">Noc</cx:pt>
          <cx:pt idx="2436">Noc</cx:pt>
          <cx:pt idx="2437">Noc</cx:pt>
          <cx:pt idx="2438">Noc</cx:pt>
          <cx:pt idx="2439">Noc</cx:pt>
          <cx:pt idx="2440">Noc</cx:pt>
          <cx:pt idx="2441">Noc</cx:pt>
          <cx:pt idx="2442">Noc</cx:pt>
          <cx:pt idx="2443">Noc</cx:pt>
          <cx:pt idx="2444">Noc</cx:pt>
          <cx:pt idx="2445">Noc</cx:pt>
          <cx:pt idx="2446">Noc</cx:pt>
          <cx:pt idx="2447">Noc</cx:pt>
          <cx:pt idx="2448">Noc</cx:pt>
          <cx:pt idx="2449">Noc</cx:pt>
          <cx:pt idx="2450">Noc</cx:pt>
          <cx:pt idx="2451">Noc</cx:pt>
          <cx:pt idx="2452">Noc</cx:pt>
          <cx:pt idx="2453">Noc</cx:pt>
          <cx:pt idx="2454">Noc</cx:pt>
          <cx:pt idx="2455">Noc</cx:pt>
          <cx:pt idx="2456">Noc</cx:pt>
          <cx:pt idx="2457">Noc</cx:pt>
          <cx:pt idx="2458">Noc</cx:pt>
          <cx:pt idx="2459">Noc</cx:pt>
          <cx:pt idx="2460">Noc</cx:pt>
          <cx:pt idx="2461">Noc</cx:pt>
          <cx:pt idx="2462">Noc</cx:pt>
          <cx:pt idx="2463">Noc</cx:pt>
          <cx:pt idx="2464">Noc</cx:pt>
          <cx:pt idx="2465">Noc</cx:pt>
          <cx:pt idx="2466">Noc</cx:pt>
          <cx:pt idx="2467">Noc</cx:pt>
          <cx:pt idx="2468">Noc</cx:pt>
          <cx:pt idx="2469">Noc</cx:pt>
          <cx:pt idx="2470">Noc</cx:pt>
          <cx:pt idx="2471">Noc</cx:pt>
          <cx:pt idx="2472">Noc</cx:pt>
          <cx:pt idx="2473">Noc</cx:pt>
          <cx:pt idx="2474">Noc</cx:pt>
          <cx:pt idx="2475">Noc</cx:pt>
          <cx:pt idx="2476">Noc</cx:pt>
          <cx:pt idx="2477">Noc</cx:pt>
          <cx:pt idx="2478">Noc</cx:pt>
          <cx:pt idx="2479">Noc</cx:pt>
          <cx:pt idx="2480">Noc</cx:pt>
          <cx:pt idx="2481">Noc</cx:pt>
          <cx:pt idx="2482">Noc</cx:pt>
          <cx:pt idx="2483">Noc</cx:pt>
          <cx:pt idx="2484">Noc</cx:pt>
          <cx:pt idx="2485">Noc</cx:pt>
          <cx:pt idx="2486">Noc</cx:pt>
          <cx:pt idx="2487">Noc</cx:pt>
          <cx:pt idx="2488">Noc</cx:pt>
          <cx:pt idx="2489">Noc</cx:pt>
          <cx:pt idx="2490">Noc</cx:pt>
          <cx:pt idx="2491">Noc</cx:pt>
          <cx:pt idx="2492">Noc</cx:pt>
          <cx:pt idx="2493">Noc</cx:pt>
          <cx:pt idx="2494">Noc</cx:pt>
          <cx:pt idx="2495">Noc</cx:pt>
          <cx:pt idx="2496">Noc</cx:pt>
          <cx:pt idx="2497">Noc</cx:pt>
          <cx:pt idx="2498">Noc</cx:pt>
          <cx:pt idx="2499">Noc</cx:pt>
          <cx:pt idx="2500">Noc</cx:pt>
          <cx:pt idx="2501">Noc</cx:pt>
          <cx:pt idx="2502">Noc</cx:pt>
          <cx:pt idx="2503">Noc</cx:pt>
          <cx:pt idx="2504">Noc</cx:pt>
          <cx:pt idx="2505">Noc</cx:pt>
          <cx:pt idx="2506">Noc</cx:pt>
          <cx:pt idx="2507">Noc</cx:pt>
          <cx:pt idx="2508">Noc</cx:pt>
          <cx:pt idx="2509">Noc</cx:pt>
          <cx:pt idx="2510">Noc</cx:pt>
          <cx:pt idx="2511">Noc</cx:pt>
          <cx:pt idx="2512">Noc</cx:pt>
          <cx:pt idx="2513">Noc</cx:pt>
          <cx:pt idx="2514">Noc</cx:pt>
          <cx:pt idx="2515">Noc</cx:pt>
          <cx:pt idx="2516">Noc</cx:pt>
          <cx:pt idx="2517">Noc</cx:pt>
          <cx:pt idx="2518">Noc</cx:pt>
          <cx:pt idx="2519">Noc</cx:pt>
          <cx:pt idx="2520">Noc</cx:pt>
          <cx:pt idx="2521">Noc</cx:pt>
          <cx:pt idx="2522">Noc</cx:pt>
          <cx:pt idx="2523">Noc</cx:pt>
          <cx:pt idx="2524">Noc</cx:pt>
          <cx:pt idx="2525">Noc</cx:pt>
          <cx:pt idx="2526">Noc</cx:pt>
          <cx:pt idx="2527">Noc</cx:pt>
          <cx:pt idx="2528">Noc</cx:pt>
          <cx:pt idx="2529">Noc</cx:pt>
          <cx:pt idx="2530">Noc</cx:pt>
          <cx:pt idx="2531">Noc</cx:pt>
          <cx:pt idx="2532">Noc</cx:pt>
          <cx:pt idx="2533">Noc</cx:pt>
          <cx:pt idx="2534">Noc</cx:pt>
          <cx:pt idx="2535">Noc</cx:pt>
          <cx:pt idx="2536">Noc</cx:pt>
          <cx:pt idx="2537">Noc</cx:pt>
          <cx:pt idx="2538">Noc</cx:pt>
          <cx:pt idx="2539">Noc</cx:pt>
          <cx:pt idx="2540">Noc</cx:pt>
          <cx:pt idx="2541">Noc</cx:pt>
          <cx:pt idx="2542">Noc</cx:pt>
          <cx:pt idx="2543">Noc</cx:pt>
          <cx:pt idx="2544">Noc</cx:pt>
          <cx:pt idx="2545">Noc</cx:pt>
          <cx:pt idx="2546">Noc</cx:pt>
          <cx:pt idx="2547">Noc</cx:pt>
          <cx:pt idx="2548">Noc</cx:pt>
          <cx:pt idx="2549">Noc</cx:pt>
          <cx:pt idx="2550">Noc</cx:pt>
          <cx:pt idx="2551">Noc</cx:pt>
          <cx:pt idx="2552">Noc</cx:pt>
          <cx:pt idx="2553">Noc</cx:pt>
          <cx:pt idx="2554">Noc</cx:pt>
          <cx:pt idx="2555">Noc</cx:pt>
          <cx:pt idx="2556">Noc</cx:pt>
          <cx:pt idx="2557">Noc</cx:pt>
          <cx:pt idx="2558">Noc</cx:pt>
          <cx:pt idx="2559">Noc</cx:pt>
          <cx:pt idx="2560">Noc</cx:pt>
          <cx:pt idx="2561">Noc</cx:pt>
          <cx:pt idx="2562">Noc</cx:pt>
          <cx:pt idx="2563">Noc</cx:pt>
          <cx:pt idx="2564">Noc</cx:pt>
          <cx:pt idx="2565">Noc</cx:pt>
          <cx:pt idx="2566">Noc</cx:pt>
          <cx:pt idx="2567">Noc</cx:pt>
          <cx:pt idx="2568">Noc</cx:pt>
          <cx:pt idx="2569">Noc</cx:pt>
          <cx:pt idx="2570">Noc</cx:pt>
          <cx:pt idx="2571">Noc</cx:pt>
          <cx:pt idx="2572">Noc</cx:pt>
          <cx:pt idx="2573">Noc</cx:pt>
          <cx:pt idx="2574">Noc</cx:pt>
          <cx:pt idx="2575">Noc</cx:pt>
          <cx:pt idx="2576">Noc</cx:pt>
          <cx:pt idx="2577">Noc</cx:pt>
          <cx:pt idx="2578">Noc</cx:pt>
          <cx:pt idx="2579">Noc</cx:pt>
          <cx:pt idx="2580">Noc</cx:pt>
          <cx:pt idx="2581">Noc</cx:pt>
          <cx:pt idx="2582">Noc</cx:pt>
          <cx:pt idx="2583">Noc</cx:pt>
          <cx:pt idx="2584">Noc</cx:pt>
          <cx:pt idx="2585">Noc</cx:pt>
          <cx:pt idx="2586">Noc</cx:pt>
          <cx:pt idx="2587">Noc</cx:pt>
          <cx:pt idx="2588">Noc</cx:pt>
          <cx:pt idx="2589">Noc</cx:pt>
          <cx:pt idx="2590">Noc</cx:pt>
          <cx:pt idx="2591">Noc</cx:pt>
          <cx:pt idx="2592">Noc</cx:pt>
          <cx:pt idx="2593">Noc</cx:pt>
          <cx:pt idx="2594">Noc</cx:pt>
          <cx:pt idx="2595">Noc</cx:pt>
          <cx:pt idx="2596">Noc</cx:pt>
          <cx:pt idx="2597">Noc</cx:pt>
          <cx:pt idx="2598">Noc</cx:pt>
          <cx:pt idx="2599">Noc</cx:pt>
          <cx:pt idx="2600">Noc</cx:pt>
          <cx:pt idx="2601">Noc</cx:pt>
          <cx:pt idx="2602">Noc</cx:pt>
          <cx:pt idx="2603">Noc</cx:pt>
          <cx:pt idx="2604">Noc</cx:pt>
          <cx:pt idx="2605">Noc</cx:pt>
          <cx:pt idx="2606">Noc</cx:pt>
          <cx:pt idx="2607">Noc</cx:pt>
          <cx:pt idx="2608">Noc</cx:pt>
          <cx:pt idx="2609">Noc</cx:pt>
          <cx:pt idx="2610">Noc</cx:pt>
          <cx:pt idx="2611">Noc</cx:pt>
          <cx:pt idx="2612">Noc</cx:pt>
          <cx:pt idx="2613">Noc</cx:pt>
          <cx:pt idx="2614">Noc</cx:pt>
          <cx:pt idx="2615">Noc</cx:pt>
          <cx:pt idx="2616">Noc</cx:pt>
          <cx:pt idx="2617">Noc</cx:pt>
          <cx:pt idx="2618">Noc</cx:pt>
          <cx:pt idx="2619">Noc</cx:pt>
          <cx:pt idx="2620">Noc</cx:pt>
          <cx:pt idx="2621">Noc</cx:pt>
          <cx:pt idx="2622">Noc</cx:pt>
          <cx:pt idx="2623">Noc</cx:pt>
          <cx:pt idx="2624">Noc</cx:pt>
          <cx:pt idx="2625">Noc</cx:pt>
          <cx:pt idx="2626">Noc</cx:pt>
          <cx:pt idx="2627">Noc</cx:pt>
          <cx:pt idx="2628">Noc</cx:pt>
          <cx:pt idx="2629">Noc</cx:pt>
          <cx:pt idx="2630">Noc</cx:pt>
          <cx:pt idx="2631">Noc</cx:pt>
          <cx:pt idx="2632">Noc</cx:pt>
          <cx:pt idx="2633">Noc</cx:pt>
          <cx:pt idx="2634">Noc</cx:pt>
          <cx:pt idx="2635">Noc</cx:pt>
          <cx:pt idx="2636">Noc</cx:pt>
          <cx:pt idx="2637">Noc</cx:pt>
          <cx:pt idx="2638">Noc</cx:pt>
          <cx:pt idx="2639">Noc</cx:pt>
          <cx:pt idx="2640">Noc</cx:pt>
          <cx:pt idx="2641">Noc</cx:pt>
          <cx:pt idx="2642">Noc</cx:pt>
          <cx:pt idx="2643">Noc</cx:pt>
          <cx:pt idx="2644">Noc</cx:pt>
          <cx:pt idx="2645">Noc</cx:pt>
          <cx:pt idx="2646">Noc</cx:pt>
          <cx:pt idx="2647">Noc</cx:pt>
          <cx:pt idx="2648">Noc</cx:pt>
          <cx:pt idx="2649">Noc</cx:pt>
          <cx:pt idx="2650">Noc</cx:pt>
          <cx:pt idx="2651">Noc</cx:pt>
          <cx:pt idx="2652">Noc</cx:pt>
          <cx:pt idx="2653">Noc</cx:pt>
          <cx:pt idx="2654">Noc</cx:pt>
          <cx:pt idx="2655">Noc</cx:pt>
          <cx:pt idx="2656">Noc</cx:pt>
          <cx:pt idx="2657">Noc</cx:pt>
          <cx:pt idx="2658">Noc</cx:pt>
          <cx:pt idx="2659">Noc</cx:pt>
          <cx:pt idx="2660">Noc</cx:pt>
          <cx:pt idx="2661">Noc</cx:pt>
          <cx:pt idx="2662">Noc</cx:pt>
          <cx:pt idx="2663">Noc</cx:pt>
          <cx:pt idx="2664">Noc</cx:pt>
          <cx:pt idx="2665">Noc</cx:pt>
          <cx:pt idx="2666">Noc</cx:pt>
          <cx:pt idx="2667">Noc</cx:pt>
          <cx:pt idx="2668">Noc</cx:pt>
          <cx:pt idx="2669">Noc</cx:pt>
          <cx:pt idx="2670">Noc</cx:pt>
          <cx:pt idx="2671">Noc</cx:pt>
          <cx:pt idx="2672">Noc</cx:pt>
          <cx:pt idx="2673">Noc</cx:pt>
          <cx:pt idx="2674">Noc</cx:pt>
          <cx:pt idx="2675">Noc</cx:pt>
          <cx:pt idx="2676">Noc</cx:pt>
          <cx:pt idx="2677">Noc</cx:pt>
          <cx:pt idx="2678">Noc</cx:pt>
          <cx:pt idx="2679">Noc</cx:pt>
          <cx:pt idx="2680">Noc</cx:pt>
          <cx:pt idx="2681">Noc</cx:pt>
          <cx:pt idx="2682">Noc</cx:pt>
          <cx:pt idx="2683">Noc</cx:pt>
          <cx:pt idx="2684">Noc</cx:pt>
          <cx:pt idx="2685">Noc</cx:pt>
          <cx:pt idx="2686">Noc</cx:pt>
          <cx:pt idx="2687">Noc</cx:pt>
          <cx:pt idx="2688">Noc</cx:pt>
          <cx:pt idx="2689">Noc</cx:pt>
          <cx:pt idx="2690">Noc</cx:pt>
          <cx:pt idx="2691">Noc</cx:pt>
          <cx:pt idx="2692">Noc</cx:pt>
          <cx:pt idx="2693">Noc</cx:pt>
          <cx:pt idx="2694">Noc</cx:pt>
          <cx:pt idx="2695">Noc</cx:pt>
          <cx:pt idx="2696">Noc</cx:pt>
          <cx:pt idx="2697">Noc</cx:pt>
          <cx:pt idx="2698">Noc</cx:pt>
          <cx:pt idx="2699">Noc</cx:pt>
          <cx:pt idx="2700">Noc</cx:pt>
          <cx:pt idx="2701">Noc</cx:pt>
          <cx:pt idx="2702">Noc</cx:pt>
          <cx:pt idx="2703">Noc</cx:pt>
          <cx:pt idx="2704">Noc</cx:pt>
          <cx:pt idx="2705">Noc</cx:pt>
          <cx:pt idx="2706">Noc</cx:pt>
          <cx:pt idx="2707">Noc</cx:pt>
          <cx:pt idx="2708">Noc</cx:pt>
          <cx:pt idx="2709">Noc</cx:pt>
          <cx:pt idx="2710">Noc</cx:pt>
          <cx:pt idx="2711">Noc</cx:pt>
          <cx:pt idx="2712">Noc</cx:pt>
          <cx:pt idx="2713">Noc</cx:pt>
          <cx:pt idx="2714">Noc</cx:pt>
          <cx:pt idx="2715">Noc</cx:pt>
          <cx:pt idx="2716">Noc</cx:pt>
          <cx:pt idx="2717">Noc</cx:pt>
          <cx:pt idx="2718">Noc</cx:pt>
          <cx:pt idx="2719">Noc</cx:pt>
          <cx:pt idx="2720">Noc</cx:pt>
          <cx:pt idx="2721">Noc</cx:pt>
          <cx:pt idx="2722">Noc</cx:pt>
          <cx:pt idx="2723">Noc</cx:pt>
          <cx:pt idx="2724">Noc</cx:pt>
          <cx:pt idx="2725">Noc</cx:pt>
          <cx:pt idx="2726">Noc</cx:pt>
          <cx:pt idx="2727">Noc</cx:pt>
          <cx:pt idx="2728">Noc</cx:pt>
          <cx:pt idx="2729">Noc</cx:pt>
          <cx:pt idx="2730">Noc</cx:pt>
          <cx:pt idx="2731">Noc</cx:pt>
          <cx:pt idx="2732">Noc</cx:pt>
          <cx:pt idx="2733">Noc</cx:pt>
          <cx:pt idx="2734">Noc</cx:pt>
          <cx:pt idx="2735">Noc</cx:pt>
          <cx:pt idx="2736">Noc</cx:pt>
          <cx:pt idx="2737">Noc</cx:pt>
          <cx:pt idx="2738">Noc</cx:pt>
          <cx:pt idx="2739">Noc</cx:pt>
          <cx:pt idx="2740">Noc</cx:pt>
          <cx:pt idx="2741">Noc</cx:pt>
          <cx:pt idx="2742">Noc</cx:pt>
          <cx:pt idx="2743">Noc</cx:pt>
          <cx:pt idx="2744">Noc</cx:pt>
          <cx:pt idx="2745">Noc</cx:pt>
          <cx:pt idx="2746">Noc</cx:pt>
          <cx:pt idx="2747">Noc</cx:pt>
          <cx:pt idx="2748">Noc</cx:pt>
          <cx:pt idx="2749">Noc</cx:pt>
          <cx:pt idx="2750">Noc</cx:pt>
          <cx:pt idx="2751">Noc</cx:pt>
          <cx:pt idx="2752">Noc</cx:pt>
          <cx:pt idx="2753">Noc</cx:pt>
          <cx:pt idx="2754">Noc</cx:pt>
          <cx:pt idx="2755">Noc</cx:pt>
          <cx:pt idx="2756">Noc</cx:pt>
          <cx:pt idx="2757">Noc</cx:pt>
          <cx:pt idx="2758">Noc</cx:pt>
          <cx:pt idx="2759">Noc</cx:pt>
          <cx:pt idx="2760">Noc</cx:pt>
          <cx:pt idx="2761">Noc</cx:pt>
          <cx:pt idx="2762">Noc</cx:pt>
          <cx:pt idx="2763">Noc</cx:pt>
          <cx:pt idx="2764">Noc</cx:pt>
          <cx:pt idx="2765">Noc</cx:pt>
          <cx:pt idx="2766">Noc</cx:pt>
          <cx:pt idx="2767">Noc</cx:pt>
          <cx:pt idx="2768">Noc</cx:pt>
          <cx:pt idx="2769">Noc</cx:pt>
          <cx:pt idx="2770">Noc</cx:pt>
          <cx:pt idx="2771">Noc</cx:pt>
          <cx:pt idx="2772">Noc</cx:pt>
          <cx:pt idx="2773">Noc</cx:pt>
          <cx:pt idx="2774">Noc</cx:pt>
          <cx:pt idx="2775">Noc</cx:pt>
          <cx:pt idx="2776">Noc</cx:pt>
          <cx:pt idx="2777">Noc</cx:pt>
          <cx:pt idx="2778">Noc</cx:pt>
          <cx:pt idx="2779">Noc</cx:pt>
          <cx:pt idx="2780">Noc</cx:pt>
          <cx:pt idx="2781">Noc</cx:pt>
          <cx:pt idx="2782">Noc</cx:pt>
          <cx:pt idx="2783">Noc</cx:pt>
          <cx:pt idx="2784">Noc</cx:pt>
          <cx:pt idx="2785">Noc</cx:pt>
          <cx:pt idx="2786">Noc</cx:pt>
          <cx:pt idx="2787">Noc</cx:pt>
          <cx:pt idx="2788">Noc</cx:pt>
          <cx:pt idx="2789">Noc</cx:pt>
          <cx:pt idx="2790">Noc</cx:pt>
          <cx:pt idx="2791">Noc</cx:pt>
          <cx:pt idx="2792">Noc</cx:pt>
          <cx:pt idx="2793">Noc</cx:pt>
          <cx:pt idx="2794">Noc</cx:pt>
          <cx:pt idx="2795">Noc</cx:pt>
          <cx:pt idx="2796">Noc</cx:pt>
          <cx:pt idx="2797">Noc</cx:pt>
          <cx:pt idx="2798">Noc</cx:pt>
          <cx:pt idx="2799">Noc</cx:pt>
          <cx:pt idx="2800">Noc</cx:pt>
          <cx:pt idx="2801">Noc</cx:pt>
          <cx:pt idx="2802">Noc</cx:pt>
          <cx:pt idx="2803">Noc</cx:pt>
          <cx:pt idx="2804">Noc</cx:pt>
          <cx:pt idx="2805">Noc</cx:pt>
          <cx:pt idx="2806">Noc</cx:pt>
          <cx:pt idx="2807">Noc</cx:pt>
          <cx:pt idx="2808">Noc</cx:pt>
          <cx:pt idx="2809">Noc</cx:pt>
          <cx:pt idx="2810">Noc</cx:pt>
          <cx:pt idx="2811">Noc</cx:pt>
          <cx:pt idx="2812">Noc</cx:pt>
          <cx:pt idx="2813">Noc</cx:pt>
          <cx:pt idx="2814">Noc</cx:pt>
          <cx:pt idx="2815">Noc</cx:pt>
          <cx:pt idx="2816">Noc</cx:pt>
          <cx:pt idx="2817">Noc</cx:pt>
          <cx:pt idx="2818">Noc</cx:pt>
          <cx:pt idx="2819">Noc</cx:pt>
          <cx:pt idx="2820">Noc</cx:pt>
          <cx:pt idx="2821">Noc</cx:pt>
          <cx:pt idx="2822">Noc</cx:pt>
          <cx:pt idx="2823">Noc</cx:pt>
          <cx:pt idx="2824">Noc</cx:pt>
          <cx:pt idx="2825">Noc</cx:pt>
          <cx:pt idx="2826">Noc</cx:pt>
          <cx:pt idx="2827">Noc</cx:pt>
          <cx:pt idx="2828">Noc</cx:pt>
          <cx:pt idx="2829">Noc</cx:pt>
          <cx:pt idx="2830">Noc</cx:pt>
          <cx:pt idx="2831">Noc</cx:pt>
          <cx:pt idx="2832">Noc</cx:pt>
          <cx:pt idx="2833">Noc</cx:pt>
          <cx:pt idx="2834">Noc</cx:pt>
          <cx:pt idx="2835">Noc</cx:pt>
          <cx:pt idx="2836">Noc</cx:pt>
          <cx:pt idx="2837">Noc</cx:pt>
          <cx:pt idx="2838">Noc</cx:pt>
          <cx:pt idx="2839">Noc</cx:pt>
          <cx:pt idx="2840">Noc</cx:pt>
          <cx:pt idx="2841">Noc</cx:pt>
          <cx:pt idx="2842">Noc</cx:pt>
          <cx:pt idx="2843">Noc</cx:pt>
          <cx:pt idx="2844">Noc</cx:pt>
          <cx:pt idx="2845">Noc</cx:pt>
          <cx:pt idx="2846">Noc</cx:pt>
          <cx:pt idx="2847">Noc</cx:pt>
          <cx:pt idx="2848">Noc</cx:pt>
          <cx:pt idx="2849">Noc</cx:pt>
          <cx:pt idx="2850">Noc</cx:pt>
          <cx:pt idx="2851">Noc</cx:pt>
          <cx:pt idx="2852">Noc</cx:pt>
          <cx:pt idx="2853">Noc</cx:pt>
          <cx:pt idx="2854">Noc</cx:pt>
          <cx:pt idx="2855">Noc</cx:pt>
          <cx:pt idx="2856">Noc</cx:pt>
          <cx:pt idx="2857">Noc</cx:pt>
          <cx:pt idx="2858">Noc</cx:pt>
          <cx:pt idx="2859">Noc</cx:pt>
          <cx:pt idx="2860">Noc</cx:pt>
          <cx:pt idx="2861">Noc</cx:pt>
          <cx:pt idx="2862">Noc</cx:pt>
          <cx:pt idx="2863">Noc</cx:pt>
          <cx:pt idx="2864">Noc</cx:pt>
          <cx:pt idx="2865">Noc</cx:pt>
          <cx:pt idx="2866">Noc</cx:pt>
          <cx:pt idx="2867">Noc</cx:pt>
          <cx:pt idx="2868">Noc</cx:pt>
          <cx:pt idx="2869">Noc</cx:pt>
          <cx:pt idx="2870">Noc</cx:pt>
          <cx:pt idx="2871">Noc</cx:pt>
          <cx:pt idx="2872">Noc</cx:pt>
          <cx:pt idx="2873">Noc</cx:pt>
          <cx:pt idx="2874">Noc</cx:pt>
          <cx:pt idx="2875">Noc</cx:pt>
          <cx:pt idx="2876">Noc</cx:pt>
          <cx:pt idx="2877">Noc</cx:pt>
          <cx:pt idx="2878">Noc</cx:pt>
          <cx:pt idx="2879">Noc</cx:pt>
          <cx:pt idx="2880">Noc</cx:pt>
          <cx:pt idx="2881">Noc</cx:pt>
          <cx:pt idx="2882">Noc</cx:pt>
          <cx:pt idx="2883">Noc</cx:pt>
          <cx:pt idx="2884">Noc</cx:pt>
          <cx:pt idx="2885">Noc</cx:pt>
          <cx:pt idx="2886">Noc</cx:pt>
          <cx:pt idx="2887">Noc</cx:pt>
          <cx:pt idx="2888">Noc</cx:pt>
          <cx:pt idx="2889">Noc</cx:pt>
          <cx:pt idx="2890">Noc</cx:pt>
          <cx:pt idx="2891">Noc</cx:pt>
          <cx:pt idx="2892">Noc</cx:pt>
          <cx:pt idx="2893">Noc</cx:pt>
          <cx:pt idx="2894">Noc</cx:pt>
          <cx:pt idx="2895">Noc</cx:pt>
          <cx:pt idx="2896">Noc</cx:pt>
          <cx:pt idx="2897">Noc</cx:pt>
          <cx:pt idx="2898">Noc</cx:pt>
          <cx:pt idx="2899">Noc</cx:pt>
          <cx:pt idx="2900">Noc</cx:pt>
          <cx:pt idx="2901">Noc</cx:pt>
          <cx:pt idx="2902">Noc</cx:pt>
          <cx:pt idx="2903">Noc</cx:pt>
          <cx:pt idx="2904">Noc</cx:pt>
          <cx:pt idx="2905">Noc</cx:pt>
          <cx:pt idx="2906">Noc</cx:pt>
          <cx:pt idx="2907">Noc</cx:pt>
          <cx:pt idx="2908">Noc</cx:pt>
          <cx:pt idx="2909">Noc</cx:pt>
          <cx:pt idx="2910">Noc</cx:pt>
          <cx:pt idx="2911">Noc</cx:pt>
          <cx:pt idx="2912">Noc</cx:pt>
          <cx:pt idx="2913">Noc</cx:pt>
          <cx:pt idx="2914">Noc</cx:pt>
          <cx:pt idx="2915">Noc</cx:pt>
          <cx:pt idx="2916">Noc</cx:pt>
          <cx:pt idx="2917">Noc</cx:pt>
          <cx:pt idx="2918">Noc</cx:pt>
          <cx:pt idx="2919">Noc</cx:pt>
          <cx:pt idx="2920">Noc</cx:pt>
          <cx:pt idx="2921">Noc</cx:pt>
          <cx:pt idx="2922">Noc</cx:pt>
          <cx:pt idx="2923">Noc</cx:pt>
          <cx:pt idx="2924">Noc</cx:pt>
          <cx:pt idx="2925">Noc</cx:pt>
          <cx:pt idx="2926">Noc</cx:pt>
          <cx:pt idx="2927">Noc</cx:pt>
          <cx:pt idx="2928">Noc</cx:pt>
          <cx:pt idx="2929">Noc</cx:pt>
          <cx:pt idx="2930">Noc</cx:pt>
          <cx:pt idx="2931">Noc</cx:pt>
          <cx:pt idx="2932">Noc</cx:pt>
          <cx:pt idx="2933">Noc</cx:pt>
          <cx:pt idx="2934">Noc</cx:pt>
          <cx:pt idx="2935">Noc</cx:pt>
          <cx:pt idx="2936">Noc</cx:pt>
          <cx:pt idx="2937">Noc</cx:pt>
          <cx:pt idx="2938">Noc</cx:pt>
          <cx:pt idx="2939">Noc</cx:pt>
          <cx:pt idx="2940">Noc</cx:pt>
          <cx:pt idx="2941">Noc</cx:pt>
          <cx:pt idx="2942">Noc</cx:pt>
          <cx:pt idx="2943">Noc</cx:pt>
          <cx:pt idx="2944">Noc</cx:pt>
          <cx:pt idx="2945">Noc</cx:pt>
          <cx:pt idx="2946">Noc</cx:pt>
          <cx:pt idx="2947">Noc</cx:pt>
          <cx:pt idx="2948">Noc</cx:pt>
          <cx:pt idx="2949">Noc</cx:pt>
          <cx:pt idx="2950">Noc</cx:pt>
          <cx:pt idx="2951">Noc</cx:pt>
          <cx:pt idx="2952">Noc</cx:pt>
          <cx:pt idx="2953">Noc</cx:pt>
          <cx:pt idx="2954">Noc</cx:pt>
          <cx:pt idx="2955">Noc</cx:pt>
          <cx:pt idx="2956">Noc</cx:pt>
          <cx:pt idx="2957">Noc</cx:pt>
          <cx:pt idx="2958">Noc</cx:pt>
          <cx:pt idx="2959">Noc</cx:pt>
          <cx:pt idx="2960">Noc</cx:pt>
          <cx:pt idx="2961">Noc</cx:pt>
          <cx:pt idx="2962">Noc</cx:pt>
          <cx:pt idx="2963">Noc</cx:pt>
          <cx:pt idx="2964">Noc</cx:pt>
          <cx:pt idx="2965">Noc</cx:pt>
          <cx:pt idx="2966">Noc</cx:pt>
          <cx:pt idx="2967">Noc</cx:pt>
          <cx:pt idx="2968">Noc</cx:pt>
          <cx:pt idx="2969">Noc</cx:pt>
          <cx:pt idx="2970">Noc</cx:pt>
          <cx:pt idx="2971">Noc</cx:pt>
          <cx:pt idx="2972">Noc</cx:pt>
          <cx:pt idx="2973">Noc</cx:pt>
          <cx:pt idx="2974">Noc</cx:pt>
          <cx:pt idx="2975">Noc</cx:pt>
          <cx:pt idx="2976">Noc</cx:pt>
          <cx:pt idx="2977">Noc</cx:pt>
          <cx:pt idx="2978">Noc</cx:pt>
          <cx:pt idx="2979">Noc</cx:pt>
          <cx:pt idx="2980">Noc</cx:pt>
          <cx:pt idx="2981">Noc</cx:pt>
          <cx:pt idx="2982">Noc</cx:pt>
          <cx:pt idx="2983">Noc</cx:pt>
          <cx:pt idx="2984">Noc</cx:pt>
          <cx:pt idx="2985">Noc</cx:pt>
          <cx:pt idx="2986">Noc</cx:pt>
          <cx:pt idx="2987">Noc</cx:pt>
          <cx:pt idx="2988">Noc</cx:pt>
          <cx:pt idx="2989">Noc</cx:pt>
          <cx:pt idx="2990">Noc</cx:pt>
          <cx:pt idx="2991">Noc</cx:pt>
          <cx:pt idx="2992">Noc</cx:pt>
          <cx:pt idx="2993">Noc</cx:pt>
          <cx:pt idx="2994">Noc</cx:pt>
          <cx:pt idx="2995">Noc</cx:pt>
          <cx:pt idx="2996">Noc</cx:pt>
          <cx:pt idx="2997">Noc</cx:pt>
          <cx:pt idx="2998">Noc</cx:pt>
          <cx:pt idx="2999">Noc</cx:pt>
          <cx:pt idx="3000">Noc</cx:pt>
          <cx:pt idx="3001">Noc</cx:pt>
          <cx:pt idx="3002">Noc</cx:pt>
          <cx:pt idx="3003">Noc</cx:pt>
          <cx:pt idx="3004">Noc</cx:pt>
          <cx:pt idx="3005">Noc</cx:pt>
          <cx:pt idx="3006">Noc</cx:pt>
          <cx:pt idx="3007">Noc</cx:pt>
          <cx:pt idx="3008">Noc</cx:pt>
          <cx:pt idx="3009">Noc</cx:pt>
          <cx:pt idx="3010">Noc</cx:pt>
          <cx:pt idx="3011">Noc</cx:pt>
          <cx:pt idx="3012">Noc</cx:pt>
          <cx:pt idx="3013">Noc</cx:pt>
          <cx:pt idx="3014">Noc</cx:pt>
          <cx:pt idx="3015">Noc</cx:pt>
          <cx:pt idx="3016">Noc</cx:pt>
          <cx:pt idx="3017">Noc</cx:pt>
          <cx:pt idx="3018">Noc</cx:pt>
          <cx:pt idx="3019">Noc</cx:pt>
          <cx:pt idx="3020">Noc</cx:pt>
          <cx:pt idx="3021">Noc</cx:pt>
          <cx:pt idx="3022">Noc</cx:pt>
          <cx:pt idx="3023">Noc</cx:pt>
          <cx:pt idx="3024">Noc</cx:pt>
          <cx:pt idx="3025">Noc</cx:pt>
          <cx:pt idx="3026">Noc</cx:pt>
          <cx:pt idx="3027">Noc</cx:pt>
          <cx:pt idx="3028">Noc</cx:pt>
          <cx:pt idx="3029">Noc</cx:pt>
          <cx:pt idx="3030">Noc</cx:pt>
          <cx:pt idx="3031">Noc</cx:pt>
          <cx:pt idx="3032">Noc</cx:pt>
          <cx:pt idx="3033">Noc</cx:pt>
          <cx:pt idx="3034">Noc</cx:pt>
          <cx:pt idx="3035">Noc</cx:pt>
          <cx:pt idx="3036">Noc</cx:pt>
          <cx:pt idx="3037">Noc</cx:pt>
          <cx:pt idx="3038">Noc</cx:pt>
          <cx:pt idx="3039">Noc</cx:pt>
          <cx:pt idx="3040">Noc</cx:pt>
          <cx:pt idx="3041">Noc</cx:pt>
          <cx:pt idx="3042">Noc</cx:pt>
          <cx:pt idx="3043">Noc</cx:pt>
          <cx:pt idx="3044">Noc</cx:pt>
          <cx:pt idx="3045">Noc</cx:pt>
          <cx:pt idx="3046">Noc</cx:pt>
          <cx:pt idx="3047">Noc</cx:pt>
          <cx:pt idx="3048">Noc</cx:pt>
          <cx:pt idx="3049">Noc</cx:pt>
          <cx:pt idx="3050">Noc</cx:pt>
          <cx:pt idx="3051">Noc</cx:pt>
          <cx:pt idx="3052">Noc</cx:pt>
          <cx:pt idx="3053">Noc</cx:pt>
          <cx:pt idx="3054">Noc</cx:pt>
          <cx:pt idx="3055">Noc</cx:pt>
          <cx:pt idx="3056">Noc</cx:pt>
          <cx:pt idx="3057">Noc</cx:pt>
          <cx:pt idx="3058">Noc</cx:pt>
          <cx:pt idx="3059">Noc</cx:pt>
          <cx:pt idx="3060">Noc</cx:pt>
          <cx:pt idx="3061">Noc</cx:pt>
          <cx:pt idx="3062">Noc</cx:pt>
          <cx:pt idx="3063">Noc</cx:pt>
          <cx:pt idx="3064">Noc</cx:pt>
          <cx:pt idx="3065">Noc</cx:pt>
          <cx:pt idx="3066">Noc</cx:pt>
          <cx:pt idx="3067">Noc</cx:pt>
          <cx:pt idx="3068">Noc</cx:pt>
          <cx:pt idx="3069">Noc</cx:pt>
          <cx:pt idx="3070">Noc</cx:pt>
          <cx:pt idx="3071">Noc</cx:pt>
          <cx:pt idx="3072">Noc</cx:pt>
          <cx:pt idx="3073">Noc</cx:pt>
          <cx:pt idx="3074">Noc</cx:pt>
          <cx:pt idx="3075">Noc</cx:pt>
          <cx:pt idx="3076">Noc</cx:pt>
          <cx:pt idx="3077">Noc</cx:pt>
          <cx:pt idx="3078">Noc</cx:pt>
          <cx:pt idx="3079">Noc</cx:pt>
          <cx:pt idx="3080">Noc</cx:pt>
          <cx:pt idx="3081">Noc</cx:pt>
          <cx:pt idx="3082">Noc</cx:pt>
          <cx:pt idx="3083">Noc</cx:pt>
          <cx:pt idx="3084">Noc</cx:pt>
          <cx:pt idx="3085">Noc</cx:pt>
          <cx:pt idx="3086">Noc</cx:pt>
          <cx:pt idx="3087">Noc</cx:pt>
          <cx:pt idx="3088">Noc</cx:pt>
          <cx:pt idx="3089">Noc</cx:pt>
          <cx:pt idx="3090">Noc</cx:pt>
          <cx:pt idx="3091">Noc</cx:pt>
          <cx:pt idx="3092">Noc</cx:pt>
          <cx:pt idx="3093">Noc</cx:pt>
          <cx:pt idx="3094">Noc</cx:pt>
          <cx:pt idx="3095">Noc</cx:pt>
          <cx:pt idx="3096">Noc</cx:pt>
          <cx:pt idx="3097">Noc</cx:pt>
          <cx:pt idx="3098">Noc</cx:pt>
          <cx:pt idx="3099">Noc</cx:pt>
          <cx:pt idx="3100">Noc</cx:pt>
          <cx:pt idx="3101">Noc</cx:pt>
          <cx:pt idx="3102">Noc</cx:pt>
          <cx:pt idx="3103">Noc</cx:pt>
          <cx:pt idx="3104">Noc</cx:pt>
          <cx:pt idx="3105">Noc</cx:pt>
          <cx:pt idx="3106">Noc</cx:pt>
          <cx:pt idx="3107">Noc</cx:pt>
          <cx:pt idx="3108">Noc</cx:pt>
          <cx:pt idx="3109">Noc</cx:pt>
          <cx:pt idx="3110">Noc</cx:pt>
          <cx:pt idx="3111">Noc</cx:pt>
          <cx:pt idx="3112">Noc</cx:pt>
          <cx:pt idx="3113">Noc</cx:pt>
          <cx:pt idx="3114">Noc</cx:pt>
          <cx:pt idx="3115">Noc</cx:pt>
          <cx:pt idx="3116">Noc</cx:pt>
          <cx:pt idx="3117">Noc</cx:pt>
          <cx:pt idx="3118">Noc</cx:pt>
          <cx:pt idx="3119">Noc</cx:pt>
          <cx:pt idx="3120">Noc</cx:pt>
          <cx:pt idx="3121">Noc</cx:pt>
          <cx:pt idx="3122">Noc</cx:pt>
          <cx:pt idx="3123">Noc</cx:pt>
          <cx:pt idx="3124">Noc</cx:pt>
          <cx:pt idx="3125">Noc</cx:pt>
          <cx:pt idx="3126">Noc</cx:pt>
          <cx:pt idx="3127">Noc</cx:pt>
          <cx:pt idx="3128">Noc</cx:pt>
          <cx:pt idx="3129">Noc</cx:pt>
          <cx:pt idx="3130">Noc</cx:pt>
          <cx:pt idx="3131">Noc</cx:pt>
          <cx:pt idx="3132">Noc</cx:pt>
          <cx:pt idx="3133">Noc</cx:pt>
          <cx:pt idx="3134">Noc</cx:pt>
          <cx:pt idx="3135">Noc</cx:pt>
          <cx:pt idx="3136">Noc</cx:pt>
          <cx:pt idx="3137">Noc</cx:pt>
          <cx:pt idx="3138">Noc</cx:pt>
          <cx:pt idx="3139">Noc</cx:pt>
          <cx:pt idx="3140">Noc</cx:pt>
          <cx:pt idx="3141">Noc</cx:pt>
          <cx:pt idx="3142">Noc</cx:pt>
          <cx:pt idx="3143">Noc</cx:pt>
          <cx:pt idx="3144">Noc</cx:pt>
          <cx:pt idx="3145">Noc</cx:pt>
          <cx:pt idx="3146">Noc</cx:pt>
          <cx:pt idx="3147">Noc</cx:pt>
          <cx:pt idx="3148">Noc</cx:pt>
          <cx:pt idx="3149">Noc</cx:pt>
          <cx:pt idx="3150">Noc</cx:pt>
          <cx:pt idx="3151">Noc</cx:pt>
          <cx:pt idx="3152">Noc</cx:pt>
          <cx:pt idx="3153">Noc</cx:pt>
          <cx:pt idx="3154">Noc</cx:pt>
          <cx:pt idx="3155">Noc</cx:pt>
          <cx:pt idx="3156">Noc</cx:pt>
          <cx:pt idx="3157">Noc</cx:pt>
          <cx:pt idx="3158">Noc</cx:pt>
          <cx:pt idx="3159">Noc</cx:pt>
          <cx:pt idx="3160">Noc</cx:pt>
          <cx:pt idx="3161">Noc</cx:pt>
          <cx:pt idx="3162">Noc</cx:pt>
          <cx:pt idx="3163">Noc</cx:pt>
          <cx:pt idx="3164">Noc</cx:pt>
          <cx:pt idx="3165">Noc</cx:pt>
          <cx:pt idx="3166">Noc</cx:pt>
          <cx:pt idx="3167">Noc</cx:pt>
          <cx:pt idx="3168">Noc</cx:pt>
          <cx:pt idx="3169">Noc</cx:pt>
          <cx:pt idx="3170">Noc</cx:pt>
          <cx:pt idx="3171">Noc</cx:pt>
          <cx:pt idx="3172">Noc</cx:pt>
          <cx:pt idx="3173">Noc</cx:pt>
          <cx:pt idx="3174">Noc</cx:pt>
          <cx:pt idx="3175">Noc</cx:pt>
          <cx:pt idx="3176">Noc</cx:pt>
          <cx:pt idx="3177">Noc</cx:pt>
          <cx:pt idx="3178">Noc</cx:pt>
          <cx:pt idx="3179">Noc</cx:pt>
          <cx:pt idx="3180">Noc</cx:pt>
          <cx:pt idx="3181">Noc</cx:pt>
          <cx:pt idx="3182">Noc</cx:pt>
          <cx:pt idx="3183">Noc</cx:pt>
          <cx:pt idx="3184">Noc</cx:pt>
          <cx:pt idx="3185">Noc</cx:pt>
          <cx:pt idx="3186">Noc</cx:pt>
          <cx:pt idx="3187">Noc</cx:pt>
          <cx:pt idx="3188">Noc</cx:pt>
          <cx:pt idx="3189">Noc</cx:pt>
          <cx:pt idx="3190">Noc</cx:pt>
          <cx:pt idx="3191">Noc</cx:pt>
          <cx:pt idx="3192">Noc</cx:pt>
          <cx:pt idx="3193">Noc</cx:pt>
          <cx:pt idx="3194">Noc</cx:pt>
          <cx:pt idx="3195">Noc</cx:pt>
          <cx:pt idx="3196">Noc</cx:pt>
          <cx:pt idx="3197">Noc</cx:pt>
          <cx:pt idx="3198">Noc</cx:pt>
          <cx:pt idx="3199">Noc</cx:pt>
          <cx:pt idx="3200">Noc</cx:pt>
          <cx:pt idx="3201">Noc</cx:pt>
          <cx:pt idx="3202">Noc</cx:pt>
          <cx:pt idx="3203">Noc</cx:pt>
          <cx:pt idx="3204">Noc</cx:pt>
          <cx:pt idx="3205">Noc</cx:pt>
          <cx:pt idx="3206">Noc</cx:pt>
          <cx:pt idx="3207">Noc</cx:pt>
          <cx:pt idx="3208">Noc</cx:pt>
          <cx:pt idx="3209">Noc</cx:pt>
          <cx:pt idx="3210">Noc</cx:pt>
          <cx:pt idx="3211">Noc</cx:pt>
          <cx:pt idx="3212">Noc</cx:pt>
          <cx:pt idx="3213">Noc</cx:pt>
          <cx:pt idx="3214">Noc</cx:pt>
          <cx:pt idx="3215">Noc</cx:pt>
          <cx:pt idx="3216">Noc</cx:pt>
          <cx:pt idx="3217">Noc</cx:pt>
          <cx:pt idx="3218">Noc</cx:pt>
          <cx:pt idx="3219">Noc</cx:pt>
          <cx:pt idx="3220">Noc</cx:pt>
          <cx:pt idx="3221">Noc</cx:pt>
          <cx:pt idx="3222">Noc</cx:pt>
          <cx:pt idx="3223">Noc</cx:pt>
          <cx:pt idx="3224">Noc</cx:pt>
          <cx:pt idx="3225">Noc</cx:pt>
          <cx:pt idx="3226">Noc</cx:pt>
          <cx:pt idx="3227">Noc</cx:pt>
          <cx:pt idx="3228">Noc</cx:pt>
          <cx:pt idx="3229">Noc</cx:pt>
          <cx:pt idx="3230">Noc</cx:pt>
          <cx:pt idx="3231">Noc</cx:pt>
          <cx:pt idx="3232">Noc</cx:pt>
          <cx:pt idx="3233">Noc</cx:pt>
          <cx:pt idx="3234">Noc</cx:pt>
          <cx:pt idx="3235">Noc</cx:pt>
          <cx:pt idx="3236">Noc</cx:pt>
          <cx:pt idx="3237">Noc</cx:pt>
          <cx:pt idx="3238">Noc</cx:pt>
          <cx:pt idx="3239">Noc</cx:pt>
          <cx:pt idx="3240">Noc</cx:pt>
          <cx:pt idx="3241">Noc</cx:pt>
          <cx:pt idx="3242">Noc</cx:pt>
          <cx:pt idx="3243">Noc</cx:pt>
          <cx:pt idx="3244">Noc</cx:pt>
          <cx:pt idx="3245">Noc</cx:pt>
          <cx:pt idx="3246">Noc</cx:pt>
          <cx:pt idx="3247">Noc</cx:pt>
          <cx:pt idx="3248">Noc</cx:pt>
          <cx:pt idx="3249">Noc</cx:pt>
          <cx:pt idx="3250">Noc</cx:pt>
          <cx:pt idx="3251">Noc</cx:pt>
          <cx:pt idx="3252">Noc</cx:pt>
          <cx:pt idx="3253">Noc</cx:pt>
          <cx:pt idx="3254">Noc</cx:pt>
          <cx:pt idx="3255">Noc</cx:pt>
          <cx:pt idx="3256">Noc</cx:pt>
          <cx:pt idx="3257">Noc</cx:pt>
          <cx:pt idx="3258">Noc</cx:pt>
          <cx:pt idx="3259">Noc</cx:pt>
          <cx:pt idx="3260">Noc</cx:pt>
          <cx:pt idx="3261">Noc</cx:pt>
          <cx:pt idx="3262">Noc</cx:pt>
          <cx:pt idx="3263">Noc</cx:pt>
          <cx:pt idx="3264">Noc</cx:pt>
          <cx:pt idx="3265">Noc</cx:pt>
          <cx:pt idx="3266">Noc</cx:pt>
          <cx:pt idx="3267">Noc</cx:pt>
          <cx:pt idx="3268">Noc</cx:pt>
          <cx:pt idx="3269">Noc</cx:pt>
          <cx:pt idx="3270">Noc</cx:pt>
          <cx:pt idx="3271">Noc</cx:pt>
          <cx:pt idx="3272">Noc</cx:pt>
          <cx:pt idx="3273">Noc</cx:pt>
          <cx:pt idx="3274">Noc</cx:pt>
          <cx:pt idx="3275">Noc</cx:pt>
          <cx:pt idx="3276">Noc</cx:pt>
          <cx:pt idx="3277">Noc</cx:pt>
          <cx:pt idx="3278">Noc</cx:pt>
          <cx:pt idx="3279">Noc</cx:pt>
          <cx:pt idx="3280">Noc</cx:pt>
          <cx:pt idx="3281">Noc</cx:pt>
          <cx:pt idx="3282">Noc</cx:pt>
          <cx:pt idx="3283">Noc</cx:pt>
          <cx:pt idx="3284">Noc</cx:pt>
          <cx:pt idx="3285">Noc</cx:pt>
          <cx:pt idx="3286">Noc</cx:pt>
          <cx:pt idx="3287">Noc</cx:pt>
          <cx:pt idx="3288">Noc</cx:pt>
          <cx:pt idx="3289">Noc</cx:pt>
          <cx:pt idx="3290">Noc</cx:pt>
          <cx:pt idx="3291">Noc</cx:pt>
          <cx:pt idx="3292">Noc</cx:pt>
          <cx:pt idx="3293">Noc</cx:pt>
          <cx:pt idx="3294">Noc</cx:pt>
          <cx:pt idx="3295">Noc</cx:pt>
          <cx:pt idx="3296">Noc</cx:pt>
          <cx:pt idx="3297">Noc</cx:pt>
          <cx:pt idx="3298">Noc</cx:pt>
          <cx:pt idx="3299">Noc</cx:pt>
          <cx:pt idx="3300">Noc</cx:pt>
          <cx:pt idx="3301">Noc</cx:pt>
          <cx:pt idx="3302">Noc</cx:pt>
          <cx:pt idx="3303">Noc</cx:pt>
          <cx:pt idx="3304">Noc</cx:pt>
          <cx:pt idx="3305">Noc</cx:pt>
          <cx:pt idx="3306">Noc</cx:pt>
          <cx:pt idx="3307">Noc</cx:pt>
          <cx:pt idx="3308">Noc</cx:pt>
          <cx:pt idx="3309">Noc</cx:pt>
          <cx:pt idx="3310">Noc</cx:pt>
          <cx:pt idx="3311">Noc</cx:pt>
          <cx:pt idx="3312">Noc</cx:pt>
          <cx:pt idx="3313">Noc</cx:pt>
          <cx:pt idx="3314">Noc</cx:pt>
          <cx:pt idx="3315">Noc</cx:pt>
          <cx:pt idx="3316">Noc</cx:pt>
          <cx:pt idx="3317">Noc</cx:pt>
          <cx:pt idx="3318">Noc</cx:pt>
          <cx:pt idx="3319">Noc</cx:pt>
          <cx:pt idx="3320">Noc</cx:pt>
          <cx:pt idx="3321">Noc</cx:pt>
          <cx:pt idx="3322">Noc</cx:pt>
          <cx:pt idx="3323">Noc</cx:pt>
          <cx:pt idx="3324">Noc</cx:pt>
          <cx:pt idx="3325">Noc</cx:pt>
          <cx:pt idx="3326">Noc</cx:pt>
          <cx:pt idx="3327">Noc</cx:pt>
          <cx:pt idx="3328">Noc</cx:pt>
          <cx:pt idx="3329">Noc</cx:pt>
          <cx:pt idx="3330">Noc</cx:pt>
          <cx:pt idx="3331">Noc</cx:pt>
          <cx:pt idx="3332">Noc</cx:pt>
          <cx:pt idx="3333">Noc</cx:pt>
          <cx:pt idx="3334">Noc</cx:pt>
          <cx:pt idx="3335">Noc</cx:pt>
          <cx:pt idx="3336">Noc</cx:pt>
          <cx:pt idx="3337">Noc</cx:pt>
          <cx:pt idx="3338">Noc</cx:pt>
          <cx:pt idx="3339">Noc</cx:pt>
          <cx:pt idx="3340">Noc</cx:pt>
          <cx:pt idx="3341">Noc</cx:pt>
          <cx:pt idx="3342">Noc</cx:pt>
          <cx:pt idx="3343">Noc</cx:pt>
          <cx:pt idx="3344">Noc</cx:pt>
          <cx:pt idx="3345">Noc</cx:pt>
          <cx:pt idx="3346">Noc</cx:pt>
          <cx:pt idx="3347">Noc</cx:pt>
          <cx:pt idx="3348">Noc</cx:pt>
          <cx:pt idx="3349">Noc</cx:pt>
          <cx:pt idx="3350">Noc</cx:pt>
          <cx:pt idx="3351">Noc</cx:pt>
          <cx:pt idx="3352">Noc</cx:pt>
          <cx:pt idx="3353">Noc</cx:pt>
          <cx:pt idx="3354">Noc</cx:pt>
          <cx:pt idx="3355">Noc</cx:pt>
          <cx:pt idx="3356">Noc</cx:pt>
          <cx:pt idx="3357">Noc</cx:pt>
          <cx:pt idx="3358">Noc</cx:pt>
          <cx:pt idx="3359">Noc</cx:pt>
          <cx:pt idx="3360">Noc</cx:pt>
          <cx:pt idx="3361">Noc</cx:pt>
          <cx:pt idx="3362">Noc</cx:pt>
          <cx:pt idx="3363">Noc</cx:pt>
          <cx:pt idx="3364">Noc</cx:pt>
          <cx:pt idx="3365">Noc</cx:pt>
          <cx:pt idx="3366">Noc</cx:pt>
          <cx:pt idx="3367">Noc</cx:pt>
          <cx:pt idx="3368">Noc</cx:pt>
          <cx:pt idx="3369">Noc</cx:pt>
          <cx:pt idx="3370">Noc</cx:pt>
          <cx:pt idx="3371">Noc</cx:pt>
          <cx:pt idx="3372">Noc</cx:pt>
          <cx:pt idx="3373">Noc</cx:pt>
          <cx:pt idx="3374">Noc</cx:pt>
          <cx:pt idx="3375">Noc</cx:pt>
          <cx:pt idx="3376">Noc</cx:pt>
          <cx:pt idx="3377">Noc</cx:pt>
          <cx:pt idx="3378">Noc</cx:pt>
          <cx:pt idx="3379">Noc</cx:pt>
          <cx:pt idx="3380">Noc</cx:pt>
          <cx:pt idx="3381">Noc</cx:pt>
          <cx:pt idx="3382">Noc</cx:pt>
          <cx:pt idx="3383">Noc</cx:pt>
          <cx:pt idx="3384">Noc</cx:pt>
          <cx:pt idx="3385">Noc</cx:pt>
          <cx:pt idx="3386">Noc</cx:pt>
          <cx:pt idx="3387">Noc</cx:pt>
          <cx:pt idx="3388">Noc</cx:pt>
          <cx:pt idx="3389">Noc</cx:pt>
          <cx:pt idx="3390">Noc</cx:pt>
          <cx:pt idx="3391">Noc</cx:pt>
          <cx:pt idx="3392">Noc</cx:pt>
          <cx:pt idx="3393">Noc</cx:pt>
          <cx:pt idx="3394">Noc</cx:pt>
          <cx:pt idx="3395">Noc</cx:pt>
          <cx:pt idx="3396">Noc</cx:pt>
          <cx:pt idx="3397">Noc</cx:pt>
          <cx:pt idx="3398">Noc</cx:pt>
          <cx:pt idx="3399">Noc</cx:pt>
          <cx:pt idx="3400">Noc</cx:pt>
          <cx:pt idx="3401">Noc</cx:pt>
          <cx:pt idx="3402">Noc</cx:pt>
          <cx:pt idx="3403">Noc</cx:pt>
          <cx:pt idx="3404">Noc</cx:pt>
          <cx:pt idx="3405">Noc</cx:pt>
          <cx:pt idx="3406">Noc</cx:pt>
          <cx:pt idx="3407">Noc</cx:pt>
          <cx:pt idx="3408">Noc</cx:pt>
          <cx:pt idx="3409">Noc</cx:pt>
          <cx:pt idx="3410">Noc</cx:pt>
          <cx:pt idx="3411">Noc</cx:pt>
          <cx:pt idx="3412">Noc</cx:pt>
          <cx:pt idx="3413">Noc</cx:pt>
          <cx:pt idx="3414">Noc</cx:pt>
          <cx:pt idx="3415">Noc</cx:pt>
          <cx:pt idx="3416">Noc</cx:pt>
          <cx:pt idx="3417">Noc</cx:pt>
          <cx:pt idx="3418">Noc</cx:pt>
          <cx:pt idx="3419">Noc</cx:pt>
          <cx:pt idx="3420">Noc</cx:pt>
          <cx:pt idx="3421">Noc</cx:pt>
          <cx:pt idx="3422">Noc</cx:pt>
          <cx:pt idx="3423">Noc</cx:pt>
          <cx:pt idx="3424">Noc</cx:pt>
          <cx:pt idx="3425">Noc</cx:pt>
          <cx:pt idx="3426">Noc</cx:pt>
          <cx:pt idx="3427">Noc</cx:pt>
          <cx:pt idx="3428">Noc</cx:pt>
          <cx:pt idx="3429">Noc</cx:pt>
          <cx:pt idx="3430">Noc</cx:pt>
          <cx:pt idx="3431">Noc</cx:pt>
          <cx:pt idx="3432">Noc</cx:pt>
          <cx:pt idx="3433">Noc</cx:pt>
          <cx:pt idx="3434">Noc</cx:pt>
          <cx:pt idx="3435">Noc</cx:pt>
          <cx:pt idx="3436">Noc</cx:pt>
          <cx:pt idx="3437">Noc</cx:pt>
          <cx:pt idx="3438">Noc</cx:pt>
          <cx:pt idx="3439">Noc</cx:pt>
          <cx:pt idx="3440">Noc</cx:pt>
          <cx:pt idx="3441">Noc</cx:pt>
          <cx:pt idx="3442">Noc</cx:pt>
          <cx:pt idx="3443">Noc</cx:pt>
          <cx:pt idx="3444">Noc</cx:pt>
          <cx:pt idx="3445">Noc</cx:pt>
          <cx:pt idx="3446">Noc</cx:pt>
          <cx:pt idx="3447">Noc</cx:pt>
          <cx:pt idx="3448">Noc</cx:pt>
          <cx:pt idx="3449">Noc</cx:pt>
          <cx:pt idx="3450">Noc</cx:pt>
          <cx:pt idx="3451">Noc</cx:pt>
          <cx:pt idx="3452">Noc</cx:pt>
          <cx:pt idx="3453">Noc</cx:pt>
          <cx:pt idx="3454">Noc</cx:pt>
          <cx:pt idx="3455">Noc</cx:pt>
          <cx:pt idx="3456">Noc</cx:pt>
          <cx:pt idx="3457">Noc</cx:pt>
          <cx:pt idx="3458">Noc</cx:pt>
          <cx:pt idx="3459">Noc</cx:pt>
          <cx:pt idx="3460">Noc</cx:pt>
          <cx:pt idx="3461">Noc</cx:pt>
          <cx:pt idx="3462">Noc</cx:pt>
          <cx:pt idx="3463">Noc</cx:pt>
          <cx:pt idx="3464">Noc</cx:pt>
          <cx:pt idx="3465">Noc</cx:pt>
          <cx:pt idx="3466">Noc</cx:pt>
          <cx:pt idx="3467">Noc</cx:pt>
          <cx:pt idx="3468">Noc</cx:pt>
          <cx:pt idx="3469">Noc</cx:pt>
          <cx:pt idx="3470">Noc</cx:pt>
          <cx:pt idx="3471">Noc</cx:pt>
          <cx:pt idx="3472">Noc</cx:pt>
          <cx:pt idx="3473">Noc</cx:pt>
          <cx:pt idx="3474">Noc</cx:pt>
          <cx:pt idx="3475">Noc</cx:pt>
          <cx:pt idx="3476">Noc</cx:pt>
          <cx:pt idx="3477">Noc</cx:pt>
          <cx:pt idx="3478">Noc</cx:pt>
          <cx:pt idx="3479">Noc</cx:pt>
          <cx:pt idx="3480">Noc</cx:pt>
          <cx:pt idx="3481">Noc</cx:pt>
          <cx:pt idx="3482">Noc</cx:pt>
          <cx:pt idx="3483">Noc</cx:pt>
          <cx:pt idx="3484">Noc</cx:pt>
          <cx:pt idx="3485">Noc</cx:pt>
          <cx:pt idx="3486">Noc</cx:pt>
          <cx:pt idx="3487">Noc</cx:pt>
          <cx:pt idx="3488">Noc</cx:pt>
          <cx:pt idx="3489">Noc</cx:pt>
          <cx:pt idx="3490">Noc</cx:pt>
          <cx:pt idx="3491">Noc</cx:pt>
          <cx:pt idx="3492">Noc</cx:pt>
          <cx:pt idx="3493">Noc</cx:pt>
          <cx:pt idx="3494">Noc</cx:pt>
          <cx:pt idx="3495">Noc</cx:pt>
          <cx:pt idx="3496">Noc</cx:pt>
          <cx:pt idx="3497">Noc</cx:pt>
          <cx:pt idx="3498">Noc</cx:pt>
          <cx:pt idx="3499">Noc</cx:pt>
          <cx:pt idx="3500">Noc</cx:pt>
          <cx:pt idx="3501">Noc</cx:pt>
          <cx:pt idx="3502">Noc</cx:pt>
          <cx:pt idx="3503">Noc</cx:pt>
          <cx:pt idx="3504">Noc</cx:pt>
          <cx:pt idx="3505">Noc</cx:pt>
          <cx:pt idx="3506">Noc</cx:pt>
          <cx:pt idx="3507">Noc</cx:pt>
          <cx:pt idx="3508">Noc</cx:pt>
          <cx:pt idx="3509">Noc</cx:pt>
          <cx:pt idx="3510">Noc</cx:pt>
          <cx:pt idx="3511">Noc</cx:pt>
          <cx:pt idx="3512">Noc</cx:pt>
          <cx:pt idx="3513">Noc</cx:pt>
          <cx:pt idx="3514">Noc</cx:pt>
          <cx:pt idx="3515">Noc</cx:pt>
          <cx:pt idx="3516">Noc</cx:pt>
          <cx:pt idx="3517">Noc</cx:pt>
          <cx:pt idx="3518">Noc</cx:pt>
          <cx:pt idx="3519">Noc</cx:pt>
          <cx:pt idx="3520">Noc</cx:pt>
          <cx:pt idx="3521">Noc</cx:pt>
          <cx:pt idx="3522">Noc</cx:pt>
          <cx:pt idx="3523">Noc</cx:pt>
          <cx:pt idx="3524">Noc</cx:pt>
          <cx:pt idx="3525">Noc</cx:pt>
          <cx:pt idx="3526">Noc</cx:pt>
          <cx:pt idx="3527">Noc</cx:pt>
          <cx:pt idx="3528">Noc</cx:pt>
          <cx:pt idx="3529">Noc</cx:pt>
          <cx:pt idx="3530">Noc</cx:pt>
          <cx:pt idx="3531">Noc</cx:pt>
          <cx:pt idx="3532">Noc</cx:pt>
          <cx:pt idx="3533">Noc</cx:pt>
          <cx:pt idx="3534">Noc</cx:pt>
          <cx:pt idx="3535">Noc</cx:pt>
          <cx:pt idx="3536">Noc</cx:pt>
          <cx:pt idx="3537">Noc</cx:pt>
          <cx:pt idx="3538">Noc</cx:pt>
          <cx:pt idx="3539">Noc</cx:pt>
          <cx:pt idx="3540">Noc</cx:pt>
          <cx:pt idx="3541">Noc</cx:pt>
          <cx:pt idx="3542">Noc</cx:pt>
          <cx:pt idx="3543">Noc</cx:pt>
          <cx:pt idx="3544">Noc</cx:pt>
          <cx:pt idx="3545">Noc</cx:pt>
          <cx:pt idx="3546">Noc</cx:pt>
          <cx:pt idx="3547">Noc</cx:pt>
          <cx:pt idx="3548">Noc</cx:pt>
          <cx:pt idx="3549">Noc</cx:pt>
          <cx:pt idx="3550">Noc</cx:pt>
          <cx:pt idx="3551">Noc</cx:pt>
          <cx:pt idx="3552">Noc</cx:pt>
          <cx:pt idx="3553">Noc</cx:pt>
          <cx:pt idx="3554">Noc</cx:pt>
          <cx:pt idx="3555">Noc</cx:pt>
          <cx:pt idx="3556">Noc</cx:pt>
          <cx:pt idx="3557">Noc</cx:pt>
          <cx:pt idx="3558">Noc</cx:pt>
          <cx:pt idx="3559">Noc</cx:pt>
          <cx:pt idx="3560">Noc</cx:pt>
          <cx:pt idx="3561">Noc</cx:pt>
          <cx:pt idx="3562">Noc</cx:pt>
          <cx:pt idx="3563">Noc</cx:pt>
          <cx:pt idx="3564">Noc</cx:pt>
          <cx:pt idx="3565">Noc</cx:pt>
          <cx:pt idx="3566">Noc</cx:pt>
          <cx:pt idx="3567">Noc</cx:pt>
          <cx:pt idx="3568">Noc</cx:pt>
          <cx:pt idx="3569">Noc</cx:pt>
          <cx:pt idx="3570">Noc</cx:pt>
          <cx:pt idx="3571">Noc</cx:pt>
          <cx:pt idx="3572">Noc</cx:pt>
          <cx:pt idx="3573">Noc</cx:pt>
          <cx:pt idx="3574">Noc</cx:pt>
          <cx:pt idx="3575">Noc</cx:pt>
          <cx:pt idx="3576">Noc</cx:pt>
          <cx:pt idx="3577">Noc</cx:pt>
          <cx:pt idx="3578">Noc</cx:pt>
          <cx:pt idx="3579">Noc</cx:pt>
          <cx:pt idx="3580">Noc</cx:pt>
          <cx:pt idx="3581">Noc</cx:pt>
          <cx:pt idx="3582">Noc</cx:pt>
          <cx:pt idx="3583">Noc</cx:pt>
          <cx:pt idx="3584">Noc</cx:pt>
          <cx:pt idx="3585">Noc</cx:pt>
          <cx:pt idx="3586">Noc</cx:pt>
          <cx:pt idx="3587">Noc</cx:pt>
          <cx:pt idx="3588">Noc</cx:pt>
          <cx:pt idx="3589">Noc</cx:pt>
          <cx:pt idx="3590">Noc</cx:pt>
          <cx:pt idx="3591">Noc</cx:pt>
          <cx:pt idx="3592">Noc</cx:pt>
          <cx:pt idx="3593">Noc</cx:pt>
          <cx:pt idx="3594">Noc</cx:pt>
          <cx:pt idx="3595">Noc</cx:pt>
          <cx:pt idx="3596">Noc</cx:pt>
          <cx:pt idx="3597">Noc</cx:pt>
          <cx:pt idx="3598">Noc</cx:pt>
          <cx:pt idx="3599">Noc</cx:pt>
          <cx:pt idx="3600">Noc</cx:pt>
          <cx:pt idx="3601">Noc</cx:pt>
          <cx:pt idx="3602">Noc</cx:pt>
          <cx:pt idx="3603">Noc</cx:pt>
          <cx:pt idx="3604">Noc</cx:pt>
          <cx:pt idx="3605">Noc</cx:pt>
          <cx:pt idx="3606">Noc</cx:pt>
          <cx:pt idx="3607">Noc</cx:pt>
          <cx:pt idx="3608">Noc</cx:pt>
          <cx:pt idx="3609">Noc</cx:pt>
          <cx:pt idx="3610">Noc</cx:pt>
          <cx:pt idx="3611">Noc</cx:pt>
          <cx:pt idx="3612">Noc</cx:pt>
          <cx:pt idx="3613">Noc</cx:pt>
          <cx:pt idx="3614">Br</cx:pt>
          <cx:pt idx="3615">Br</cx:pt>
          <cx:pt idx="3616">Br</cx:pt>
          <cx:pt idx="3617">Br</cx:pt>
          <cx:pt idx="3618">Br</cx:pt>
          <cx:pt idx="3619">Br</cx:pt>
          <cx:pt idx="3620">Br</cx:pt>
          <cx:pt idx="3621">Br</cx:pt>
          <cx:pt idx="3622">Br</cx:pt>
          <cx:pt idx="3623">Br</cx:pt>
          <cx:pt idx="3624">Br</cx:pt>
          <cx:pt idx="3625">Br</cx:pt>
          <cx:pt idx="3626">Br</cx:pt>
          <cx:pt idx="3627">Br</cx:pt>
          <cx:pt idx="3628">Br</cx:pt>
          <cx:pt idx="3629">Br</cx:pt>
          <cx:pt idx="3630">Br</cx:pt>
          <cx:pt idx="3631">Br</cx:pt>
          <cx:pt idx="3632">Br</cx:pt>
          <cx:pt idx="3633">Br</cx:pt>
          <cx:pt idx="3634">Br</cx:pt>
          <cx:pt idx="3635">Br</cx:pt>
          <cx:pt idx="3636">Br</cx:pt>
          <cx:pt idx="3637">Br</cx:pt>
          <cx:pt idx="3638">Br</cx:pt>
          <cx:pt idx="3639">Br</cx:pt>
          <cx:pt idx="3640">Br</cx:pt>
          <cx:pt idx="3641">Br</cx:pt>
          <cx:pt idx="3642">Br</cx:pt>
          <cx:pt idx="3643">Br</cx:pt>
          <cx:pt idx="3644">Br</cx:pt>
          <cx:pt idx="3645">Br</cx:pt>
          <cx:pt idx="3646">Br</cx:pt>
          <cx:pt idx="3647">Br</cx:pt>
          <cx:pt idx="3648">Br</cx:pt>
          <cx:pt idx="3649">Br</cx:pt>
          <cx:pt idx="3650">Br</cx:pt>
          <cx:pt idx="3651">Br</cx:pt>
          <cx:pt idx="3652">Br</cx:pt>
          <cx:pt idx="3653">Br</cx:pt>
          <cx:pt idx="3654">Br</cx:pt>
          <cx:pt idx="3655">Br</cx:pt>
          <cx:pt idx="3656">Br</cx:pt>
          <cx:pt idx="3657">Br</cx:pt>
          <cx:pt idx="3658">Br</cx:pt>
          <cx:pt idx="3659">Br</cx:pt>
          <cx:pt idx="3660">Br</cx:pt>
          <cx:pt idx="3661">Br</cx:pt>
          <cx:pt idx="3662">Br</cx:pt>
          <cx:pt idx="3663">Br</cx:pt>
          <cx:pt idx="3664">Br</cx:pt>
          <cx:pt idx="3665">Br</cx:pt>
          <cx:pt idx="3666">Br</cx:pt>
          <cx:pt idx="3667">Br</cx:pt>
          <cx:pt idx="3668">Br</cx:pt>
          <cx:pt idx="3669">Br</cx:pt>
          <cx:pt idx="3670">Br</cx:pt>
          <cx:pt idx="3671">Br</cx:pt>
          <cx:pt idx="3672">Br</cx:pt>
          <cx:pt idx="3673">Br</cx:pt>
          <cx:pt idx="3674">Br</cx:pt>
          <cx:pt idx="3675">Br</cx:pt>
          <cx:pt idx="3676">Br</cx:pt>
          <cx:pt idx="3677">Br</cx:pt>
          <cx:pt idx="3678">Br</cx:pt>
          <cx:pt idx="3679">Br</cx:pt>
          <cx:pt idx="3680">Br</cx:pt>
          <cx:pt idx="3681">Br</cx:pt>
          <cx:pt idx="3682">Br</cx:pt>
          <cx:pt idx="3683">Br</cx:pt>
          <cx:pt idx="3684">Br</cx:pt>
          <cx:pt idx="3685">Br</cx:pt>
          <cx:pt idx="3686">Br</cx:pt>
          <cx:pt idx="3687">Br</cx:pt>
          <cx:pt idx="3688">Br</cx:pt>
          <cx:pt idx="3689">Br</cx:pt>
          <cx:pt idx="3690">Br</cx:pt>
          <cx:pt idx="3691">Br</cx:pt>
          <cx:pt idx="3692">Br</cx:pt>
          <cx:pt idx="3693">Br</cx:pt>
          <cx:pt idx="3694">Br</cx:pt>
          <cx:pt idx="3695">Br</cx:pt>
          <cx:pt idx="3696">Br</cx:pt>
          <cx:pt idx="3697">Br</cx:pt>
          <cx:pt idx="3698">Br</cx:pt>
          <cx:pt idx="3699">Br</cx:pt>
          <cx:pt idx="3700">Br</cx:pt>
          <cx:pt idx="3701">Br</cx:pt>
          <cx:pt idx="3702">Br</cx:pt>
          <cx:pt idx="3703">Br</cx:pt>
          <cx:pt idx="3704">Br</cx:pt>
          <cx:pt idx="3705">Br</cx:pt>
          <cx:pt idx="3706">Br</cx:pt>
          <cx:pt idx="3707">Br</cx:pt>
          <cx:pt idx="3708">Br</cx:pt>
          <cx:pt idx="3709">Br</cx:pt>
          <cx:pt idx="3710">Br</cx:pt>
          <cx:pt idx="3711">Br</cx:pt>
          <cx:pt idx="3712">Br</cx:pt>
          <cx:pt idx="3713">Br</cx:pt>
          <cx:pt idx="3714">Br</cx:pt>
          <cx:pt idx="3715">Br</cx:pt>
          <cx:pt idx="3716">Br</cx:pt>
          <cx:pt idx="3717">Br</cx:pt>
          <cx:pt idx="3718">Br</cx:pt>
          <cx:pt idx="3719">Br</cx:pt>
          <cx:pt idx="3720">Br</cx:pt>
          <cx:pt idx="3721">Br</cx:pt>
          <cx:pt idx="3722">Br</cx:pt>
          <cx:pt idx="3723">Br</cx:pt>
          <cx:pt idx="3724">Br</cx:pt>
          <cx:pt idx="3725">Br</cx:pt>
          <cx:pt idx="3726">Br</cx:pt>
          <cx:pt idx="3727">Br</cx:pt>
          <cx:pt idx="3728">Br</cx:pt>
          <cx:pt idx="3729">Br</cx:pt>
          <cx:pt idx="3730">Br</cx:pt>
          <cx:pt idx="3731">Br</cx:pt>
          <cx:pt idx="3732">Br</cx:pt>
          <cx:pt idx="3733">Br</cx:pt>
          <cx:pt idx="3734">Br</cx:pt>
          <cx:pt idx="3735">Br</cx:pt>
          <cx:pt idx="3736">Br</cx:pt>
          <cx:pt idx="3737">Br</cx:pt>
          <cx:pt idx="3738">Br</cx:pt>
          <cx:pt idx="3739">Br</cx:pt>
          <cx:pt idx="3740">Br</cx:pt>
          <cx:pt idx="3741">Br</cx:pt>
          <cx:pt idx="3742">Br</cx:pt>
          <cx:pt idx="3743">Br</cx:pt>
          <cx:pt idx="3744">Br</cx:pt>
          <cx:pt idx="3745">Br</cx:pt>
          <cx:pt idx="3746">Br</cx:pt>
          <cx:pt idx="3747">Br</cx:pt>
          <cx:pt idx="3748">Br</cx:pt>
          <cx:pt idx="3749">Br</cx:pt>
          <cx:pt idx="3750">Br</cx:pt>
          <cx:pt idx="3751">Br</cx:pt>
          <cx:pt idx="3752">Br</cx:pt>
          <cx:pt idx="3753">Br</cx:pt>
          <cx:pt idx="3754">Br</cx:pt>
          <cx:pt idx="3755">Br</cx:pt>
          <cx:pt idx="3756">Br</cx:pt>
          <cx:pt idx="3757">Br</cx:pt>
          <cx:pt idx="3758">Br</cx:pt>
          <cx:pt idx="3759">Br</cx:pt>
          <cx:pt idx="3760">Br</cx:pt>
          <cx:pt idx="3761">Br</cx:pt>
          <cx:pt idx="3762">Br</cx:pt>
          <cx:pt idx="3763">Br</cx:pt>
          <cx:pt idx="3764">Br</cx:pt>
          <cx:pt idx="3765">Br</cx:pt>
          <cx:pt idx="3766">Br</cx:pt>
          <cx:pt idx="3767">Br</cx:pt>
          <cx:pt idx="3768">Br</cx:pt>
          <cx:pt idx="3769">Br</cx:pt>
          <cx:pt idx="3770">Br</cx:pt>
          <cx:pt idx="3771">Br</cx:pt>
          <cx:pt idx="3772">Br</cx:pt>
          <cx:pt idx="3773">Br</cx:pt>
          <cx:pt idx="3774">Br</cx:pt>
          <cx:pt idx="3775">Br</cx:pt>
          <cx:pt idx="3776">Br</cx:pt>
          <cx:pt idx="3777">Br</cx:pt>
          <cx:pt idx="3778">Br</cx:pt>
          <cx:pt idx="3779">Br</cx:pt>
          <cx:pt idx="3780">Br</cx:pt>
          <cx:pt idx="3781">Br</cx:pt>
          <cx:pt idx="3782">Br</cx:pt>
          <cx:pt idx="3783">Br</cx:pt>
          <cx:pt idx="3784">Br</cx:pt>
          <cx:pt idx="3785">Br</cx:pt>
          <cx:pt idx="3786">Br</cx:pt>
          <cx:pt idx="3787">Br</cx:pt>
          <cx:pt idx="3788">Br</cx:pt>
          <cx:pt idx="3789">Br</cx:pt>
          <cx:pt idx="3790">Br</cx:pt>
          <cx:pt idx="3791">Br</cx:pt>
          <cx:pt idx="3792">Br</cx:pt>
          <cx:pt idx="3793">Br</cx:pt>
          <cx:pt idx="3794">Br</cx:pt>
          <cx:pt idx="3795">Br</cx:pt>
          <cx:pt idx="3796">Br</cx:pt>
          <cx:pt idx="3797">Br</cx:pt>
          <cx:pt idx="3798">Br</cx:pt>
          <cx:pt idx="3799">Br</cx:pt>
          <cx:pt idx="3800">Br</cx:pt>
          <cx:pt idx="3801">Br</cx:pt>
          <cx:pt idx="3802">Br</cx:pt>
          <cx:pt idx="3803">Br</cx:pt>
          <cx:pt idx="3804">Br</cx:pt>
          <cx:pt idx="3805">Br</cx:pt>
          <cx:pt idx="3806">Br</cx:pt>
          <cx:pt idx="3807">Br</cx:pt>
          <cx:pt idx="3808">Br</cx:pt>
          <cx:pt idx="3809">Br</cx:pt>
          <cx:pt idx="3810">Br</cx:pt>
          <cx:pt idx="3811">Br</cx:pt>
          <cx:pt idx="3812">Br</cx:pt>
          <cx:pt idx="3813">Br</cx:pt>
          <cx:pt idx="3814">Br</cx:pt>
          <cx:pt idx="3815">Br</cx:pt>
          <cx:pt idx="3816">Br</cx:pt>
          <cx:pt idx="3817">Br</cx:pt>
          <cx:pt idx="3818">Br</cx:pt>
          <cx:pt idx="3819">Br</cx:pt>
          <cx:pt idx="3820">Br</cx:pt>
          <cx:pt idx="3821">Br</cx:pt>
          <cx:pt idx="3822">Br</cx:pt>
          <cx:pt idx="3823">Br</cx:pt>
          <cx:pt idx="3824">Br</cx:pt>
          <cx:pt idx="3825">Br</cx:pt>
          <cx:pt idx="3826">Br</cx:pt>
          <cx:pt idx="3827">Br</cx:pt>
          <cx:pt idx="3828">Br</cx:pt>
          <cx:pt idx="3829">Br</cx:pt>
          <cx:pt idx="3830">Br</cx:pt>
          <cx:pt idx="3831">Br</cx:pt>
          <cx:pt idx="3832">Br</cx:pt>
          <cx:pt idx="3833">Br</cx:pt>
          <cx:pt idx="3834">Br</cx:pt>
          <cx:pt idx="3835">Br</cx:pt>
          <cx:pt idx="3836">Br</cx:pt>
          <cx:pt idx="3837">Br</cx:pt>
          <cx:pt idx="3838">Br</cx:pt>
          <cx:pt idx="3839">Br</cx:pt>
          <cx:pt idx="3840">Br</cx:pt>
          <cx:pt idx="3841">Br</cx:pt>
          <cx:pt idx="3842">Br</cx:pt>
          <cx:pt idx="3843">Br</cx:pt>
          <cx:pt idx="3844">Br</cx:pt>
          <cx:pt idx="3845">Br</cx:pt>
          <cx:pt idx="3846">Br</cx:pt>
          <cx:pt idx="3847">Br</cx:pt>
          <cx:pt idx="3848">Br</cx:pt>
          <cx:pt idx="3849">Br</cx:pt>
          <cx:pt idx="3850">Br</cx:pt>
          <cx:pt idx="3851">Br</cx:pt>
          <cx:pt idx="3852">Br</cx:pt>
          <cx:pt idx="3853">Br</cx:pt>
          <cx:pt idx="3854">Br</cx:pt>
          <cx:pt idx="3855">Br</cx:pt>
          <cx:pt idx="3856">Br</cx:pt>
          <cx:pt idx="3857">Br</cx:pt>
          <cx:pt idx="3858">Br</cx:pt>
          <cx:pt idx="3859">Br</cx:pt>
          <cx:pt idx="3860">Br</cx:pt>
          <cx:pt idx="3861">Br</cx:pt>
          <cx:pt idx="3862">Br</cx:pt>
          <cx:pt idx="3863">Br</cx:pt>
          <cx:pt idx="3864">Br</cx:pt>
          <cx:pt idx="3865">Br</cx:pt>
          <cx:pt idx="3866">Br</cx:pt>
          <cx:pt idx="3867">Br</cx:pt>
          <cx:pt idx="3868">Br</cx:pt>
          <cx:pt idx="3869">Br</cx:pt>
          <cx:pt idx="3870">Br</cx:pt>
          <cx:pt idx="3871">Br</cx:pt>
          <cx:pt idx="3872">Br</cx:pt>
          <cx:pt idx="3873">Br</cx:pt>
          <cx:pt idx="3874">Br</cx:pt>
          <cx:pt idx="3875">Br</cx:pt>
          <cx:pt idx="3876">Endo</cx:pt>
          <cx:pt idx="3877">Endo</cx:pt>
          <cx:pt idx="3878">Endo</cx:pt>
          <cx:pt idx="3879">Endo</cx:pt>
          <cx:pt idx="3880">Endo</cx:pt>
          <cx:pt idx="3881">Endo</cx:pt>
          <cx:pt idx="3882">Endo</cx:pt>
          <cx:pt idx="3883">Endo</cx:pt>
          <cx:pt idx="3884">Endo</cx:pt>
          <cx:pt idx="3885">Endo</cx:pt>
          <cx:pt idx="3886">Endo</cx:pt>
          <cx:pt idx="3887">Endo</cx:pt>
          <cx:pt idx="3888">Endo</cx:pt>
          <cx:pt idx="3889">Endo</cx:pt>
          <cx:pt idx="3890">Endo</cx:pt>
          <cx:pt idx="3891">Endo</cx:pt>
          <cx:pt idx="3892">Endo</cx:pt>
          <cx:pt idx="3893">Endo</cx:pt>
          <cx:pt idx="3894">Endo</cx:pt>
          <cx:pt idx="3895">Endo</cx:pt>
          <cx:pt idx="3896">Endo</cx:pt>
          <cx:pt idx="3897">Endo</cx:pt>
          <cx:pt idx="3898">Endo</cx:pt>
          <cx:pt idx="3899">Endo</cx:pt>
          <cx:pt idx="3900">Endo</cx:pt>
          <cx:pt idx="3901">Endo</cx:pt>
          <cx:pt idx="3902">Endo</cx:pt>
          <cx:pt idx="3903">Endo</cx:pt>
          <cx:pt idx="3904">Endo</cx:pt>
          <cx:pt idx="3905">Endo</cx:pt>
          <cx:pt idx="3906">Endo</cx:pt>
          <cx:pt idx="3907">Endo</cx:pt>
          <cx:pt idx="3908">Endo</cx:pt>
          <cx:pt idx="3909">Endo</cx:pt>
          <cx:pt idx="3910">Endo</cx:pt>
          <cx:pt idx="3911">Endo</cx:pt>
          <cx:pt idx="3912">Endo</cx:pt>
          <cx:pt idx="3913">Endo</cx:pt>
          <cx:pt idx="3914">Endo</cx:pt>
          <cx:pt idx="3915">Endo</cx:pt>
          <cx:pt idx="3916">Endo</cx:pt>
          <cx:pt idx="3917">Endo</cx:pt>
          <cx:pt idx="3918">Endo</cx:pt>
          <cx:pt idx="3919">Endo</cx:pt>
          <cx:pt idx="3920">Endo</cx:pt>
          <cx:pt idx="3921">Endo</cx:pt>
          <cx:pt idx="3922">Endo</cx:pt>
          <cx:pt idx="3923">Endo</cx:pt>
          <cx:pt idx="3924">Endo</cx:pt>
          <cx:pt idx="3925">Endo</cx:pt>
          <cx:pt idx="3926">Endo</cx:pt>
          <cx:pt idx="3927">Endo</cx:pt>
          <cx:pt idx="3928">Endo</cx:pt>
          <cx:pt idx="3929">Endo</cx:pt>
          <cx:pt idx="3930">Endo</cx:pt>
          <cx:pt idx="3931">Endo</cx:pt>
          <cx:pt idx="3932">Endo</cx:pt>
          <cx:pt idx="3933">Endo</cx:pt>
          <cx:pt idx="3934">Endo</cx:pt>
          <cx:pt idx="3935">Endo</cx:pt>
          <cx:pt idx="3936">Endo</cx:pt>
          <cx:pt idx="3937">Endo</cx:pt>
          <cx:pt idx="3938">Endo</cx:pt>
          <cx:pt idx="3939">Endo</cx:pt>
          <cx:pt idx="3940">Endo</cx:pt>
          <cx:pt idx="3941">Endo</cx:pt>
          <cx:pt idx="3942">Endo</cx:pt>
          <cx:pt idx="3943">Endo</cx:pt>
          <cx:pt idx="3944">Endo</cx:pt>
          <cx:pt idx="3945">Endo</cx:pt>
          <cx:pt idx="3946">Cv</cx:pt>
          <cx:pt idx="3947">Cv</cx:pt>
          <cx:pt idx="3948">Cv</cx:pt>
          <cx:pt idx="3949">Cv</cx:pt>
          <cx:pt idx="3950">Cv</cx:pt>
          <cx:pt idx="3951">Cv</cx:pt>
          <cx:pt idx="3952">Cv</cx:pt>
          <cx:pt idx="3953">Cv</cx:pt>
          <cx:pt idx="3954">Cv</cx:pt>
          <cx:pt idx="3955">Cv</cx:pt>
          <cx:pt idx="3956">Cv</cx:pt>
          <cx:pt idx="3957">Cv</cx:pt>
          <cx:pt idx="3958">Cv</cx:pt>
          <cx:pt idx="3959">Cv</cx:pt>
          <cx:pt idx="3960">Cv</cx:pt>
          <cx:pt idx="3961">Cv</cx:pt>
          <cx:pt idx="3962">Cv</cx:pt>
          <cx:pt idx="3963">Cv</cx:pt>
          <cx:pt idx="3964">Cv</cx:pt>
          <cx:pt idx="3965">Cv</cx:pt>
          <cx:pt idx="3966">Cv</cx:pt>
          <cx:pt idx="3967">Cv</cx:pt>
          <cx:pt idx="3968">Cv</cx:pt>
          <cx:pt idx="3969">Cv</cx:pt>
          <cx:pt idx="3970">Cv</cx:pt>
          <cx:pt idx="3971">Cv</cx:pt>
          <cx:pt idx="3972">Cv</cx:pt>
          <cx:pt idx="3973">Cv</cx:pt>
          <cx:pt idx="3974">Cv</cx:pt>
          <cx:pt idx="3975">Cv</cx:pt>
          <cx:pt idx="3976">Cv</cx:pt>
          <cx:pt idx="3977">Cv</cx:pt>
          <cx:pt idx="3978">Cv</cx:pt>
          <cx:pt idx="3979">Cv</cx:pt>
          <cx:pt idx="3980">Cv</cx:pt>
          <cx:pt idx="3981">Cv</cx:pt>
          <cx:pt idx="3982">Cv</cx:pt>
          <cx:pt idx="3983">Cv</cx:pt>
          <cx:pt idx="3984">Cv</cx:pt>
          <cx:pt idx="3985">Cv</cx:pt>
          <cx:pt idx="3986">Cv</cx:pt>
          <cx:pt idx="3987">Cv</cx:pt>
          <cx:pt idx="3988">Cv</cx:pt>
          <cx:pt idx="3989">Cv</cx:pt>
          <cx:pt idx="3990">Cv</cx:pt>
          <cx:pt idx="3991">Cv</cx:pt>
          <cx:pt idx="3992">Cv</cx:pt>
          <cx:pt idx="3993">Cv</cx:pt>
          <cx:pt idx="3994">Cv</cx:pt>
          <cx:pt idx="3995">Cv</cx:pt>
          <cx:pt idx="3996">Cv</cx:pt>
          <cx:pt idx="3997">Cv</cx:pt>
          <cx:pt idx="3998">Cv</cx:pt>
          <cx:pt idx="3999">Cv</cx:pt>
          <cx:pt idx="4000">Cv</cx:pt>
          <cx:pt idx="4001">Cv</cx:pt>
          <cx:pt idx="4002">Cv</cx:pt>
          <cx:pt idx="4003">Cv</cx:pt>
          <cx:pt idx="4004">Cv</cx:pt>
          <cx:pt idx="4005">Cv</cx:pt>
          <cx:pt idx="4006">Cv</cx:pt>
          <cx:pt idx="4007">Cv</cx:pt>
          <cx:pt idx="4008">Cv</cx:pt>
          <cx:pt idx="4009">Cv</cx:pt>
          <cx:pt idx="4010">Cv</cx:pt>
          <cx:pt idx="4011">Cv</cx:pt>
          <cx:pt idx="4012">Cv</cx:pt>
          <cx:pt idx="4013">Cv</cx:pt>
          <cx:pt idx="4014">Cv</cx:pt>
          <cx:pt idx="4015">Cv</cx:pt>
          <cx:pt idx="4016">Cv</cx:pt>
          <cx:pt idx="4017">Cv</cx:pt>
          <cx:pt idx="4018">Cv</cx:pt>
          <cx:pt idx="4019">Cv</cx:pt>
          <cx:pt idx="4020">Cv</cx:pt>
          <cx:pt idx="4021">Cv</cx:pt>
          <cx:pt idx="4022">Cv</cx:pt>
          <cx:pt idx="4023">Cv</cx:pt>
          <cx:pt idx="4024">Cv</cx:pt>
          <cx:pt idx="4025">Cv</cx:pt>
          <cx:pt idx="4026">Cv</cx:pt>
          <cx:pt idx="4027">Cv</cx:pt>
          <cx:pt idx="4028">Cv</cx:pt>
          <cx:pt idx="4029">Cv</cx:pt>
          <cx:pt idx="4030">Cv</cx:pt>
          <cx:pt idx="4031">Cv</cx:pt>
          <cx:pt idx="4032">Cv</cx:pt>
          <cx:pt idx="4033">Cv</cx:pt>
          <cx:pt idx="4034">Cv</cx:pt>
          <cx:pt idx="4035">Cv</cx:pt>
          <cx:pt idx="4036">Cv</cx:pt>
          <cx:pt idx="4037">Cv</cx:pt>
          <cx:pt idx="4038">Cv</cx:pt>
          <cx:pt idx="4039">Cv</cx:pt>
          <cx:pt idx="4040">Cv</cx:pt>
          <cx:pt idx="4041">Cv</cx:pt>
          <cx:pt idx="4042">Cv</cx:pt>
          <cx:pt idx="4043">Cv</cx:pt>
          <cx:pt idx="4044">Cv</cx:pt>
          <cx:pt idx="4045">Cv</cx:pt>
          <cx:pt idx="4046">Cv</cx:pt>
          <cx:pt idx="4047">Cv</cx:pt>
          <cx:pt idx="4048">Cv</cx:pt>
          <cx:pt idx="4049">Cv</cx:pt>
          <cx:pt idx="4050">Cv</cx:pt>
          <cx:pt idx="4051">Cv</cx:pt>
          <cx:pt idx="4052">Cv</cx:pt>
          <cx:pt idx="4053">Cv</cx:pt>
          <cx:pt idx="4054">Cv</cx:pt>
          <cx:pt idx="4055">Cv</cx:pt>
          <cx:pt idx="4056">Cv</cx:pt>
          <cx:pt idx="4057">Cv</cx:pt>
          <cx:pt idx="4058">Cv</cx:pt>
          <cx:pt idx="4059">Cv</cx:pt>
          <cx:pt idx="4060">Cv</cx:pt>
          <cx:pt idx="4061">Cv</cx:pt>
          <cx:pt idx="4062">Cv</cx:pt>
          <cx:pt idx="4063">Cv</cx:pt>
          <cx:pt idx="4064">Cv</cx:pt>
          <cx:pt idx="4065">Cv</cx:pt>
          <cx:pt idx="4066">Cv</cx:pt>
          <cx:pt idx="4067">Cv</cx:pt>
          <cx:pt idx="4068">Cv</cx:pt>
          <cx:pt idx="4069">Cv</cx:pt>
          <cx:pt idx="4070">Cv</cx:pt>
          <cx:pt idx="4071">Cv</cx:pt>
          <cx:pt idx="4072">Cv</cx:pt>
          <cx:pt idx="4073">Cv</cx:pt>
          <cx:pt idx="4074">Cv</cx:pt>
          <cx:pt idx="4075">Cv</cx:pt>
          <cx:pt idx="4076">Cv</cx:pt>
          <cx:pt idx="4077">Cv</cx:pt>
          <cx:pt idx="4078">Cv</cx:pt>
          <cx:pt idx="4079">Cv</cx:pt>
          <cx:pt idx="4080">Cv</cx:pt>
          <cx:pt idx="4081">Cv</cx:pt>
          <cx:pt idx="4082">Cv</cx:pt>
          <cx:pt idx="4083">Ov</cx:pt>
          <cx:pt idx="4084">Ov</cx:pt>
          <cx:pt idx="4085">Ov</cx:pt>
          <cx:pt idx="4086">Ov</cx:pt>
          <cx:pt idx="4087">Ov</cx:pt>
          <cx:pt idx="4088">Ov</cx:pt>
          <cx:pt idx="4089">Ov</cx:pt>
          <cx:pt idx="4090">Ov</cx:pt>
          <cx:pt idx="4091">Ov</cx:pt>
          <cx:pt idx="4092">Ov</cx:pt>
          <cx:pt idx="4093">Ov</cx:pt>
          <cx:pt idx="4094">Ov</cx:pt>
          <cx:pt idx="4095">Ov</cx:pt>
          <cx:pt idx="4096">Ov</cx:pt>
          <cx:pt idx="4097">Ov</cx:pt>
          <cx:pt idx="4098">Ov</cx:pt>
          <cx:pt idx="4099">Ov</cx:pt>
          <cx:pt idx="4100">Ov</cx:pt>
          <cx:pt idx="4101">Ov</cx:pt>
          <cx:pt idx="4102">Ov</cx:pt>
          <cx:pt idx="4103">Ov</cx:pt>
          <cx:pt idx="4104">Ov</cx:pt>
          <cx:pt idx="4105">Ov</cx:pt>
          <cx:pt idx="4106">Ov</cx:pt>
          <cx:pt idx="4107">Ov</cx:pt>
          <cx:pt idx="4108">Ov</cx:pt>
          <cx:pt idx="4109">Ov</cx:pt>
          <cx:pt idx="4110">Ov</cx:pt>
          <cx:pt idx="4111">Ov</cx:pt>
          <cx:pt idx="4112">Ov</cx:pt>
          <cx:pt idx="4113">Ov</cx:pt>
          <cx:pt idx="4114">Ov</cx:pt>
          <cx:pt idx="4115">Ov</cx:pt>
          <cx:pt idx="4116">Ov</cx:pt>
          <cx:pt idx="4117">Ov</cx:pt>
          <cx:pt idx="4118">Ov</cx:pt>
          <cx:pt idx="4119">Ov</cx:pt>
          <cx:pt idx="4120">Ov</cx:pt>
          <cx:pt idx="4121">Ov</cx:pt>
          <cx:pt idx="4122">Ov</cx:pt>
          <cx:pt idx="4123">Ov</cx:pt>
          <cx:pt idx="4124">Ov</cx:pt>
          <cx:pt idx="4125">Ov</cx:pt>
          <cx:pt idx="4126">Ov</cx:pt>
          <cx:pt idx="4127">Ov</cx:pt>
          <cx:pt idx="4128">Ov</cx:pt>
          <cx:pt idx="4129">Ov</cx:pt>
          <cx:pt idx="4130">Ov</cx:pt>
          <cx:pt idx="4131">Ov</cx:pt>
          <cx:pt idx="4132">Ov</cx:pt>
          <cx:pt idx="4133">Ov</cx:pt>
          <cx:pt idx="4134">Ov</cx:pt>
          <cx:pt idx="4135">Ov</cx:pt>
          <cx:pt idx="4136">Ov</cx:pt>
          <cx:pt idx="4137">Ov</cx:pt>
          <cx:pt idx="4138">Ov</cx:pt>
          <cx:pt idx="4139">Ov</cx:pt>
          <cx:pt idx="4140">Ov</cx:pt>
          <cx:pt idx="4141">Ov</cx:pt>
          <cx:pt idx="4142">Ov</cx:pt>
          <cx:pt idx="4143">Ov</cx:pt>
          <cx:pt idx="4144">Ov</cx:pt>
          <cx:pt idx="4145">Ov</cx:pt>
          <cx:pt idx="4146">Ov</cx:pt>
          <cx:pt idx="4147">Ov</cx:pt>
          <cx:pt idx="4148">Ov</cx:pt>
          <cx:pt idx="4149">Ov</cx:pt>
          <cx:pt idx="4150">Ov</cx:pt>
          <cx:pt idx="4151">Ov</cx:pt>
          <cx:pt idx="4152">Ov</cx:pt>
          <cx:pt idx="4153">Ov</cx:pt>
          <cx:pt idx="4154">Ov</cx:pt>
          <cx:pt idx="4155">Ov</cx:pt>
          <cx:pt idx="4156">Ov</cx:pt>
          <cx:pt idx="4157">Ov</cx:pt>
          <cx:pt idx="4158">Ov</cx:pt>
          <cx:pt idx="4159">Ov</cx:pt>
          <cx:pt idx="4160">Ov</cx:pt>
          <cx:pt idx="4161">Ov</cx:pt>
          <cx:pt idx="4162">Ov</cx:pt>
          <cx:pt idx="4163">Ov</cx:pt>
          <cx:pt idx="4164">Ov</cx:pt>
          <cx:pt idx="4165">Ov</cx:pt>
          <cx:pt idx="4166">Ov</cx:pt>
          <cx:pt idx="4167">Ov</cx:pt>
          <cx:pt idx="4168">Ov</cx:pt>
          <cx:pt idx="4169">Ov</cx:pt>
          <cx:pt idx="4170">Ov</cx:pt>
          <cx:pt idx="4171">Ov</cx:pt>
          <cx:pt idx="4172">Ov</cx:pt>
          <cx:pt idx="4173">Ov</cx:pt>
          <cx:pt idx="4174">Ov</cx:pt>
          <cx:pt idx="4175">Ov</cx:pt>
          <cx:pt idx="4176">Ov</cx:pt>
          <cx:pt idx="4177">Ov</cx:pt>
          <cx:pt idx="4178">Ov</cx:pt>
          <cx:pt idx="4179">Ov</cx:pt>
          <cx:pt idx="4180">Ov</cx:pt>
          <cx:pt idx="4181">Ov</cx:pt>
          <cx:pt idx="4182">Ov</cx:pt>
          <cx:pt idx="4183">Ov</cx:pt>
          <cx:pt idx="4184">Ov</cx:pt>
          <cx:pt idx="4185">Ov</cx:pt>
          <cx:pt idx="4186">Ov</cx:pt>
          <cx:pt idx="4187">Ov</cx:pt>
          <cx:pt idx="4188">Ov</cx:pt>
          <cx:pt idx="4189">Ov</cx:pt>
          <cx:pt idx="4190">Ov</cx:pt>
          <cx:pt idx="4191">Ov</cx:pt>
          <cx:pt idx="4192">Ov</cx:pt>
          <cx:pt idx="4193">Ov</cx:pt>
          <cx:pt idx="4194">Ov</cx:pt>
          <cx:pt idx="4195">Ov</cx:pt>
          <cx:pt idx="4196">Ov</cx:pt>
          <cx:pt idx="4197">Ov</cx:pt>
          <cx:pt idx="4198">Ov</cx:pt>
          <cx:pt idx="4199">Ov</cx:pt>
          <cx:pt idx="4200">Ov</cx:pt>
          <cx:pt idx="4201">Ov</cx:pt>
          <cx:pt idx="4202">Ov</cx:pt>
          <cx:pt idx="4203">Ov</cx:pt>
          <cx:pt idx="4204">Ov</cx:pt>
          <cx:pt idx="4205">Ov</cx:pt>
          <cx:pt idx="4206">Ov</cx:pt>
          <cx:pt idx="4207">Ov</cx:pt>
          <cx:pt idx="4208">Ov</cx:pt>
          <cx:pt idx="4209">Ov</cx:pt>
          <cx:pt idx="4210">Ov</cx:pt>
          <cx:pt idx="4211">Ov</cx:pt>
          <cx:pt idx="4212">Ov</cx:pt>
          <cx:pt idx="4213">Ov</cx:pt>
          <cx:pt idx="4214">Ov</cx:pt>
          <cx:pt idx="4215">Ov</cx:pt>
          <cx:pt idx="4216">Ov</cx:pt>
          <cx:pt idx="4217">Ov</cx:pt>
          <cx:pt idx="4218">Ov</cx:pt>
          <cx:pt idx="4219">Ov</cx:pt>
          <cx:pt idx="4220">Ov</cx:pt>
          <cx:pt idx="4221">Ov</cx:pt>
          <cx:pt idx="4222">Ov</cx:pt>
          <cx:pt idx="4223">Ov</cx:pt>
          <cx:pt idx="4224">Ov</cx:pt>
          <cx:pt idx="4225">Ov</cx:pt>
          <cx:pt idx="4226">Ov</cx:pt>
          <cx:pt idx="4227">Ov</cx:pt>
          <cx:pt idx="4228">Ov</cx:pt>
          <cx:pt idx="4229">Ov</cx:pt>
          <cx:pt idx="4230">Ov</cx:pt>
          <cx:pt idx="4231">Ov</cx:pt>
          <cx:pt idx="4232">Ov</cx:pt>
          <cx:pt idx="4233">Ov</cx:pt>
          <cx:pt idx="4234">Ov</cx:pt>
          <cx:pt idx="4235">Ov</cx:pt>
          <cx:pt idx="4236">Ov</cx:pt>
          <cx:pt idx="4237">Ov</cx:pt>
          <cx:pt idx="4238">Lung</cx:pt>
          <cx:pt idx="4239">Lung</cx:pt>
          <cx:pt idx="4240">Lung</cx:pt>
          <cx:pt idx="4241">Lung</cx:pt>
          <cx:pt idx="4242">Lung</cx:pt>
          <cx:pt idx="4243">Lung</cx:pt>
          <cx:pt idx="4244">Lung</cx:pt>
          <cx:pt idx="4245">Lung</cx:pt>
          <cx:pt idx="4246">Lung</cx:pt>
          <cx:pt idx="4247">Lung</cx:pt>
          <cx:pt idx="4248">Lung</cx:pt>
          <cx:pt idx="4249">Lung</cx:pt>
          <cx:pt idx="4250">Lung</cx:pt>
          <cx:pt idx="4251">Lung</cx:pt>
          <cx:pt idx="4252">Lung</cx:pt>
          <cx:pt idx="4253">Lung</cx:pt>
          <cx:pt idx="4254">Lung</cx:pt>
          <cx:pt idx="4255">Lung</cx:pt>
          <cx:pt idx="4256">Lung</cx:pt>
          <cx:pt idx="4257">Lung</cx:pt>
          <cx:pt idx="4258">Lung</cx:pt>
          <cx:pt idx="4259">Lung</cx:pt>
          <cx:pt idx="4260">Lung</cx:pt>
          <cx:pt idx="4261">Lung</cx:pt>
          <cx:pt idx="4262">Lung</cx:pt>
          <cx:pt idx="4263">Lung</cx:pt>
          <cx:pt idx="4264">Lung</cx:pt>
          <cx:pt idx="4265">Lung</cx:pt>
          <cx:pt idx="4266">Lung</cx:pt>
          <cx:pt idx="4267">Lung</cx:pt>
          <cx:pt idx="4268">Lung</cx:pt>
          <cx:pt idx="4269">Lung</cx:pt>
          <cx:pt idx="4270">Lung</cx:pt>
          <cx:pt idx="4271">Lung</cx:pt>
          <cx:pt idx="4272">Lung</cx:pt>
          <cx:pt idx="4273">Lung</cx:pt>
          <cx:pt idx="4274">Lung</cx:pt>
          <cx:pt idx="4275">Lung</cx:pt>
          <cx:pt idx="4276">Lung</cx:pt>
          <cx:pt idx="4277">Lung</cx:pt>
          <cx:pt idx="4278">Lung</cx:pt>
          <cx:pt idx="4279">Lung</cx:pt>
          <cx:pt idx="4280">Lung</cx:pt>
          <cx:pt idx="4281">Lung</cx:pt>
          <cx:pt idx="4282">Lung</cx:pt>
          <cx:pt idx="4283">Lung</cx:pt>
          <cx:pt idx="4284">Lung</cx:pt>
          <cx:pt idx="4285">Lung</cx:pt>
          <cx:pt idx="4286">Lung</cx:pt>
          <cx:pt idx="4287">Lung</cx:pt>
          <cx:pt idx="4288">Lung</cx:pt>
          <cx:pt idx="4289">Lung</cx:pt>
          <cx:pt idx="4290">Lung</cx:pt>
          <cx:pt idx="4291">Lung</cx:pt>
          <cx:pt idx="4292">Lung</cx:pt>
          <cx:pt idx="4293">Lung</cx:pt>
          <cx:pt idx="4294">Lung</cx:pt>
          <cx:pt idx="4295">Lung</cx:pt>
          <cx:pt idx="4296">Lung</cx:pt>
          <cx:pt idx="4297">Lung</cx:pt>
          <cx:pt idx="4298">Lung</cx:pt>
          <cx:pt idx="4299">Lung</cx:pt>
          <cx:pt idx="4300">Lung</cx:pt>
          <cx:pt idx="4301">Lung</cx:pt>
          <cx:pt idx="4302">Lung</cx:pt>
          <cx:pt idx="4303">Lung</cx:pt>
          <cx:pt idx="4304">Lung</cx:pt>
          <cx:pt idx="4305">Lung</cx:pt>
          <cx:pt idx="4306">Lung</cx:pt>
          <cx:pt idx="4307">Lung</cx:pt>
          <cx:pt idx="4308">Lung</cx:pt>
          <cx:pt idx="4309">Lung</cx:pt>
          <cx:pt idx="4310">Lung</cx:pt>
          <cx:pt idx="4311">Lung</cx:pt>
          <cx:pt idx="4312">Lung</cx:pt>
          <cx:pt idx="4313">Lung</cx:pt>
          <cx:pt idx="4314">Lung</cx:pt>
          <cx:pt idx="4315">Lung</cx:pt>
          <cx:pt idx="4316">Lung</cx:pt>
          <cx:pt idx="4317">Lung</cx:pt>
          <cx:pt idx="4318">Lung</cx:pt>
          <cx:pt idx="4319">Lung</cx:pt>
          <cx:pt idx="4320">Lung</cx:pt>
          <cx:pt idx="4321">Lung</cx:pt>
          <cx:pt idx="4322">Lung</cx:pt>
          <cx:pt idx="4323">Lung</cx:pt>
          <cx:pt idx="4324">Lung</cx:pt>
          <cx:pt idx="4325">Lung</cx:pt>
          <cx:pt idx="4326">Lung</cx:pt>
          <cx:pt idx="4327">Lung</cx:pt>
          <cx:pt idx="4328">Lung</cx:pt>
          <cx:pt idx="4329">Lung</cx:pt>
          <cx:pt idx="4330">Lung</cx:pt>
          <cx:pt idx="4331">Lung</cx:pt>
          <cx:pt idx="4332">Lung</cx:pt>
          <cx:pt idx="4333">Lung</cx:pt>
          <cx:pt idx="4334">Lung</cx:pt>
          <cx:pt idx="4335">Lung</cx:pt>
          <cx:pt idx="4336">Lung</cx:pt>
          <cx:pt idx="4337">Lung</cx:pt>
          <cx:pt idx="4338">Lung</cx:pt>
          <cx:pt idx="4339">Lung</cx:pt>
          <cx:pt idx="4340">Lung</cx:pt>
          <cx:pt idx="4341">Lung</cx:pt>
          <cx:pt idx="4342">Lung</cx:pt>
          <cx:pt idx="4343">Lung</cx:pt>
          <cx:pt idx="4344">Lung</cx:pt>
          <cx:pt idx="4345">Lung</cx:pt>
          <cx:pt idx="4346">Lung</cx:pt>
          <cx:pt idx="4347">Lung</cx:pt>
          <cx:pt idx="4348">Lung</cx:pt>
          <cx:pt idx="4349">Lung</cx:pt>
          <cx:pt idx="4350">Lung</cx:pt>
          <cx:pt idx="4351">Lung</cx:pt>
          <cx:pt idx="4352">Lung</cx:pt>
          <cx:pt idx="4353">Lung</cx:pt>
          <cx:pt idx="4354">Lung</cx:pt>
          <cx:pt idx="4355">Lung</cx:pt>
          <cx:pt idx="4356">Lung</cx:pt>
          <cx:pt idx="4357">Lung</cx:pt>
          <cx:pt idx="4358">Lung</cx:pt>
          <cx:pt idx="4359">Lung</cx:pt>
          <cx:pt idx="4360">Lung</cx:pt>
          <cx:pt idx="4361">Lung</cx:pt>
          <cx:pt idx="4362">Lung</cx:pt>
          <cx:pt idx="4363">Lung</cx:pt>
          <cx:pt idx="4364">Lung</cx:pt>
          <cx:pt idx="4365">Lung</cx:pt>
          <cx:pt idx="4366">Lung</cx:pt>
          <cx:pt idx="4367">Lung</cx:pt>
          <cx:pt idx="4368">Lung</cx:pt>
          <cx:pt idx="4369">Lung</cx:pt>
          <cx:pt idx="4370">Lung</cx:pt>
          <cx:pt idx="4371">Lung</cx:pt>
          <cx:pt idx="4372">Lung</cx:pt>
          <cx:pt idx="4373">Lung</cx:pt>
          <cx:pt idx="4374">Lung</cx:pt>
          <cx:pt idx="4375">Lung</cx:pt>
          <cx:pt idx="4376">Lung</cx:pt>
          <cx:pt idx="4377">Lung</cx:pt>
          <cx:pt idx="4378">Lung</cx:pt>
          <cx:pt idx="4379">Lung</cx:pt>
          <cx:pt idx="4380">Lung</cx:pt>
          <cx:pt idx="4381">Lung</cx:pt>
          <cx:pt idx="4382">Lung</cx:pt>
          <cx:pt idx="4383">Lung</cx:pt>
          <cx:pt idx="4384">Lung</cx:pt>
          <cx:pt idx="4385">Lung</cx:pt>
          <cx:pt idx="4386">Lung</cx:pt>
          <cx:pt idx="4387">Lung</cx:pt>
          <cx:pt idx="4388">Lung</cx:pt>
          <cx:pt idx="4389">Lung</cx:pt>
          <cx:pt idx="4390">Lung</cx:pt>
          <cx:pt idx="4391">Lung</cx:pt>
          <cx:pt idx="4392">Lung</cx:pt>
          <cx:pt idx="4393">Lung</cx:pt>
          <cx:pt idx="4394">Lung</cx:pt>
          <cx:pt idx="4395">Lung</cx:pt>
          <cx:pt idx="4396">Lung</cx:pt>
          <cx:pt idx="4397">Lung</cx:pt>
          <cx:pt idx="4398">Lung</cx:pt>
          <cx:pt idx="4399">Lung</cx:pt>
          <cx:pt idx="4400">Lung</cx:pt>
          <cx:pt idx="4401">Lung</cx:pt>
          <cx:pt idx="4402">Lung</cx:pt>
          <cx:pt idx="4403">Lung</cx:pt>
          <cx:pt idx="4404">Lung</cx:pt>
          <cx:pt idx="4405">Lung</cx:pt>
          <cx:pt idx="4406">Lung</cx:pt>
          <cx:pt idx="4407">Lung</cx:pt>
          <cx:pt idx="4408">Lung</cx:pt>
          <cx:pt idx="4409">Lung</cx:pt>
          <cx:pt idx="4410">Lung</cx:pt>
          <cx:pt idx="4411">Lung</cx:pt>
          <cx:pt idx="4412">Lung</cx:pt>
          <cx:pt idx="4413">Lung</cx:pt>
          <cx:pt idx="4414">Lung</cx:pt>
          <cx:pt idx="4415">Lung</cx:pt>
          <cx:pt idx="4416">Lung</cx:pt>
          <cx:pt idx="4417">Lung</cx:pt>
          <cx:pt idx="4418">Lung</cx:pt>
          <cx:pt idx="4419">Lung</cx:pt>
          <cx:pt idx="4420">Lung</cx:pt>
          <cx:pt idx="4421">Lung</cx:pt>
          <cx:pt idx="4422">Lung</cx:pt>
          <cx:pt idx="4423">Lung</cx:pt>
          <cx:pt idx="4424">Lung</cx:pt>
          <cx:pt idx="4425">Lung</cx:pt>
          <cx:pt idx="4426">Lung</cx:pt>
          <cx:pt idx="4427">Lung</cx:pt>
          <cx:pt idx="4428">Lung</cx:pt>
          <cx:pt idx="4429">Lung</cx:pt>
          <cx:pt idx="4430">Lung</cx:pt>
          <cx:pt idx="4431">Lung</cx:pt>
          <cx:pt idx="4432">Lung</cx:pt>
          <cx:pt idx="4433">Lung</cx:pt>
          <cx:pt idx="4434">Lung</cx:pt>
          <cx:pt idx="4435">Lung</cx:pt>
          <cx:pt idx="4436">Lung</cx:pt>
          <cx:pt idx="4437">Lung</cx:pt>
          <cx:pt idx="4438">Lung</cx:pt>
          <cx:pt idx="4439">Lung</cx:pt>
          <cx:pt idx="4440">Lung</cx:pt>
          <cx:pt idx="4441">Lung</cx:pt>
          <cx:pt idx="4442">Lung</cx:pt>
          <cx:pt idx="4443">Lung</cx:pt>
          <cx:pt idx="4444">Lung</cx:pt>
          <cx:pt idx="4445">Lung</cx:pt>
          <cx:pt idx="4446">Lung</cx:pt>
          <cx:pt idx="4447">Lung</cx:pt>
          <cx:pt idx="4448">Lung</cx:pt>
          <cx:pt idx="4449">Lung</cx:pt>
          <cx:pt idx="4450">Lung</cx:pt>
          <cx:pt idx="4451">Lung</cx:pt>
          <cx:pt idx="4452">Lung</cx:pt>
          <cx:pt idx="4453">Lung</cx:pt>
          <cx:pt idx="4454">Lung</cx:pt>
          <cx:pt idx="4455">Lung</cx:pt>
          <cx:pt idx="4456">Lung</cx:pt>
          <cx:pt idx="4457">Lung</cx:pt>
          <cx:pt idx="4458">Lung</cx:pt>
          <cx:pt idx="4459">Lung</cx:pt>
          <cx:pt idx="4460">Lung</cx:pt>
          <cx:pt idx="4461">Lung</cx:pt>
          <cx:pt idx="4462">Lung</cx:pt>
          <cx:pt idx="4463">Lung</cx:pt>
          <cx:pt idx="4464">AML</cx:pt>
          <cx:pt idx="4465">AML</cx:pt>
          <cx:pt idx="4466">AML</cx:pt>
          <cx:pt idx="4467">AML</cx:pt>
          <cx:pt idx="4468">AML</cx:pt>
          <cx:pt idx="4469">AML</cx:pt>
          <cx:pt idx="4470">AML</cx:pt>
          <cx:pt idx="4471">AML</cx:pt>
          <cx:pt idx="4472">AML</cx:pt>
          <cx:pt idx="4473">AML</cx:pt>
          <cx:pt idx="4474">AML</cx:pt>
          <cx:pt idx="4475">AML</cx:pt>
          <cx:pt idx="4476">AML</cx:pt>
          <cx:pt idx="4477">AML</cx:pt>
          <cx:pt idx="4478">AML</cx:pt>
          <cx:pt idx="4479">AML</cx:pt>
          <cx:pt idx="4480">AML</cx:pt>
          <cx:pt idx="4481">AML</cx:pt>
          <cx:pt idx="4482">AML</cx:pt>
          <cx:pt idx="4483">AML</cx:pt>
          <cx:pt idx="4484">AML</cx:pt>
          <cx:pt idx="4485">AML</cx:pt>
          <cx:pt idx="4486">AML</cx:pt>
          <cx:pt idx="4487">AML</cx:pt>
          <cx:pt idx="4488">AML</cx:pt>
          <cx:pt idx="4489">AML</cx:pt>
          <cx:pt idx="4490">AML</cx:pt>
          <cx:pt idx="4491">AML</cx:pt>
          <cx:pt idx="4492">AML</cx:pt>
          <cx:pt idx="4493">AML</cx:pt>
          <cx:pt idx="4494">AML</cx:pt>
          <cx:pt idx="4495">AML</cx:pt>
          <cx:pt idx="4496">AML</cx:pt>
          <cx:pt idx="4497">AML</cx:pt>
          <cx:pt idx="4498">AML</cx:pt>
          <cx:pt idx="4499">AML</cx:pt>
          <cx:pt idx="4500">AML</cx:pt>
          <cx:pt idx="4501">AML</cx:pt>
          <cx:pt idx="4502">AML</cx:pt>
          <cx:pt idx="4503">AML</cx:pt>
          <cx:pt idx="4504">AML</cx:pt>
          <cx:pt idx="4505">AML</cx:pt>
          <cx:pt idx="4506">AML</cx:pt>
          <cx:pt idx="4507">AML</cx:pt>
          <cx:pt idx="4508">AML</cx:pt>
          <cx:pt idx="4509">AML</cx:pt>
          <cx:pt idx="4510">AML</cx:pt>
          <cx:pt idx="4511">AML</cx:pt>
          <cx:pt idx="4512">AML</cx:pt>
          <cx:pt idx="4513">AML</cx:pt>
          <cx:pt idx="4514">AML</cx:pt>
          <cx:pt idx="4515">AML</cx:pt>
          <cx:pt idx="4516">AML</cx:pt>
          <cx:pt idx="4517">AML</cx:pt>
          <cx:pt idx="4518">AML</cx:pt>
          <cx:pt idx="4519">AML</cx:pt>
          <cx:pt idx="4520">AML</cx:pt>
          <cx:pt idx="4521">AML</cx:pt>
          <cx:pt idx="4522">AML</cx:pt>
          <cx:pt idx="4523">AML</cx:pt>
          <cx:pt idx="4524">AML</cx:pt>
          <cx:pt idx="4525">AML</cx:pt>
          <cx:pt idx="4526">AML</cx:pt>
          <cx:pt idx="4527">AML</cx:pt>
          <cx:pt idx="4528">AML</cx:pt>
          <cx:pt idx="4529">AML</cx:pt>
          <cx:pt idx="4530">AML</cx:pt>
          <cx:pt idx="4531">AML</cx:pt>
          <cx:pt idx="4532">AML</cx:pt>
          <cx:pt idx="4533">AML</cx:pt>
          <cx:pt idx="4534">AML</cx:pt>
          <cx:pt idx="4535">AML</cx:pt>
          <cx:pt idx="4536">AML</cx:pt>
          <cx:pt idx="4537">AML</cx:pt>
          <cx:pt idx="4538">AML</cx:pt>
          <cx:pt idx="4539">AML</cx:pt>
          <cx:pt idx="4540">AML</cx:pt>
          <cx:pt idx="4541">AML</cx:pt>
          <cx:pt idx="4542">AML</cx:pt>
          <cx:pt idx="4543">AML</cx:pt>
          <cx:pt idx="4544">AML</cx:pt>
          <cx:pt idx="4545">AML</cx:pt>
          <cx:pt idx="4546">AML</cx:pt>
          <cx:pt idx="4547">AML</cx:pt>
          <cx:pt idx="4548">AML</cx:pt>
          <cx:pt idx="4549">AML</cx:pt>
          <cx:pt idx="4550">Thy</cx:pt>
          <cx:pt idx="4551">Thy</cx:pt>
          <cx:pt idx="4552">Thy</cx:pt>
          <cx:pt idx="4553">Thy</cx:pt>
          <cx:pt idx="4554">Thy</cx:pt>
          <cx:pt idx="4555">Thy</cx:pt>
          <cx:pt idx="4556">Thy</cx:pt>
          <cx:pt idx="4557">Thy</cx:pt>
          <cx:pt idx="4558">Thy</cx:pt>
          <cx:pt idx="4559">Thy</cx:pt>
          <cx:pt idx="4560">Thy</cx:pt>
          <cx:pt idx="4561">Thy</cx:pt>
          <cx:pt idx="4562">Thy</cx:pt>
          <cx:pt idx="4563">Thy</cx:pt>
          <cx:pt idx="4564">Thy</cx:pt>
          <cx:pt idx="4565">Thy</cx:pt>
          <cx:pt idx="4566">Thy</cx:pt>
          <cx:pt idx="4567">Thy</cx:pt>
          <cx:pt idx="4568">Thy</cx:pt>
          <cx:pt idx="4569">Thy</cx:pt>
          <cx:pt idx="4570">Thy</cx:pt>
          <cx:pt idx="4571">Thy</cx:pt>
          <cx:pt idx="4572">Thy</cx:pt>
          <cx:pt idx="4573">Thy</cx:pt>
          <cx:pt idx="4574">Thy</cx:pt>
          <cx:pt idx="4575">Thy</cx:pt>
          <cx:pt idx="4576">Thy</cx:pt>
          <cx:pt idx="4577">Thy</cx:pt>
          <cx:pt idx="4578">Thy</cx:pt>
          <cx:pt idx="4579">Thy</cx:pt>
          <cx:pt idx="4580">Thy</cx:pt>
          <cx:pt idx="4581">Thy</cx:pt>
          <cx:pt idx="4582">Thy</cx:pt>
          <cx:pt idx="4583">Thy</cx:pt>
          <cx:pt idx="4584">Thy</cx:pt>
          <cx:pt idx="4585">Thy</cx:pt>
          <cx:pt idx="4586">Thy</cx:pt>
          <cx:pt idx="4587">Thy</cx:pt>
          <cx:pt idx="4588">Thy</cx:pt>
          <cx:pt idx="4589">Thy</cx:pt>
          <cx:pt idx="4590">Thy</cx:pt>
          <cx:pt idx="4591">Thy</cx:pt>
          <cx:pt idx="4592">Thy</cx:pt>
          <cx:pt idx="4593">Thy</cx:pt>
          <cx:pt idx="4594">Thy</cx:pt>
          <cx:pt idx="4595">Thy</cx:pt>
          <cx:pt idx="4596">Thy</cx:pt>
          <cx:pt idx="4597">Thy</cx:pt>
          <cx:pt idx="4598">Thy</cx:pt>
          <cx:pt idx="4599">Thy</cx:pt>
          <cx:pt idx="4600">Thy</cx:pt>
          <cx:pt idx="4601">Thy</cx:pt>
          <cx:pt idx="4602">Thy</cx:pt>
          <cx:pt idx="4603">Thy</cx:pt>
          <cx:pt idx="4604">Thy</cx:pt>
          <cx:pt idx="4605">Thy</cx:pt>
          <cx:pt idx="4606">Thy</cx:pt>
          <cx:pt idx="4607">Thy</cx:pt>
          <cx:pt idx="4608">Thy</cx:pt>
          <cx:pt idx="4609">Thy</cx:pt>
          <cx:pt idx="4610">Thy</cx:pt>
          <cx:pt idx="4611">Thy</cx:pt>
          <cx:pt idx="4612">Thy</cx:pt>
          <cx:pt idx="4613">Thy</cx:pt>
          <cx:pt idx="4614">Thy</cx:pt>
          <cx:pt idx="4615">Thy</cx:pt>
          <cx:pt idx="4616">Thy</cx:pt>
          <cx:pt idx="4617">Thy</cx:pt>
          <cx:pt idx="4618">Thy</cx:pt>
          <cx:pt idx="4619">Thy</cx:pt>
          <cx:pt idx="4620">Thy</cx:pt>
          <cx:pt idx="4621">Thy</cx:pt>
          <cx:pt idx="4622">Thy</cx:pt>
          <cx:pt idx="4623">Thy</cx:pt>
          <cx:pt idx="4624">Thy</cx:pt>
          <cx:pt idx="4625">Thy</cx:pt>
          <cx:pt idx="4626">Thy</cx:pt>
          <cx:pt idx="4627">Thy</cx:pt>
          <cx:pt idx="4628">Thy</cx:pt>
          <cx:pt idx="4629">Thy</cx:pt>
          <cx:pt idx="4630">Thy</cx:pt>
          <cx:pt idx="4631">Thy</cx:pt>
          <cx:pt idx="4632">Thy</cx:pt>
          <cx:pt idx="4633">Thy</cx:pt>
          <cx:pt idx="4634">Thy</cx:pt>
          <cx:pt idx="4635">Thy</cx:pt>
          <cx:pt idx="4636">Thy</cx:pt>
          <cx:pt idx="4637">Thy</cx:pt>
          <cx:pt idx="4638">Thy</cx:pt>
          <cx:pt idx="4639">Thy</cx:pt>
          <cx:pt idx="4640">Thy</cx:pt>
          <cx:pt idx="4641">Thy</cx:pt>
          <cx:pt idx="4642">Thy</cx:pt>
          <cx:pt idx="4643">Thy</cx:pt>
          <cx:pt idx="4644">Thy</cx:pt>
          <cx:pt idx="4645">Thy</cx:pt>
          <cx:pt idx="4646">Thy</cx:pt>
          <cx:pt idx="4647">Thy</cx:pt>
          <cx:pt idx="4648">Thy</cx:pt>
          <cx:pt idx="4649">Mel</cx:pt>
          <cx:pt idx="4650">Mel</cx:pt>
          <cx:pt idx="4651">Mel</cx:pt>
          <cx:pt idx="4652">Mel</cx:pt>
          <cx:pt idx="4653">Mel</cx:pt>
          <cx:pt idx="4654">Mel</cx:pt>
          <cx:pt idx="4655">Mel</cx:pt>
          <cx:pt idx="4656">Mel</cx:pt>
          <cx:pt idx="4657">Mel</cx:pt>
          <cx:pt idx="4658">Mel</cx:pt>
          <cx:pt idx="4659">Mel</cx:pt>
          <cx:pt idx="4660">Mel</cx:pt>
          <cx:pt idx="4661">Mel</cx:pt>
          <cx:pt idx="4662">Mel</cx:pt>
          <cx:pt idx="4663">Mel</cx:pt>
          <cx:pt idx="4664">Mel</cx:pt>
          <cx:pt idx="4665">Mel</cx:pt>
          <cx:pt idx="4666">Mel</cx:pt>
          <cx:pt idx="4667">Mel</cx:pt>
          <cx:pt idx="4668">Mel</cx:pt>
          <cx:pt idx="4669">Mel</cx:pt>
          <cx:pt idx="4670">Mel</cx:pt>
          <cx:pt idx="4671">Mel</cx:pt>
          <cx:pt idx="4672">Mel</cx:pt>
          <cx:pt idx="4673">Mel</cx:pt>
          <cx:pt idx="4674">Mel</cx:pt>
          <cx:pt idx="4675">Mel</cx:pt>
          <cx:pt idx="4676">Mel</cx:pt>
          <cx:pt idx="4677">Mel</cx:pt>
          <cx:pt idx="4678">Mel</cx:pt>
          <cx:pt idx="4679">Mel</cx:pt>
          <cx:pt idx="4680">Mel</cx:pt>
          <cx:pt idx="4681">Mel</cx:pt>
          <cx:pt idx="4682">Mel</cx:pt>
          <cx:pt idx="4683">Mel</cx:pt>
          <cx:pt idx="4684">Mel</cx:pt>
          <cx:pt idx="4685">Mel</cx:pt>
          <cx:pt idx="4686">Mel</cx:pt>
          <cx:pt idx="4687">Mel</cx:pt>
          <cx:pt idx="4688">Mel</cx:pt>
          <cx:pt idx="4689">Mel</cx:pt>
          <cx:pt idx="4690">Mel</cx:pt>
          <cx:pt idx="4691">Mel</cx:pt>
          <cx:pt idx="4692">Mel</cx:pt>
          <cx:pt idx="4693">Mel</cx:pt>
          <cx:pt idx="4694">Mel</cx:pt>
          <cx:pt idx="4695">Mel</cx:pt>
          <cx:pt idx="4696">Mel</cx:pt>
          <cx:pt idx="4697">Mel</cx:pt>
          <cx:pt idx="4698">Mel</cx:pt>
          <cx:pt idx="4699">Mel</cx:pt>
          <cx:pt idx="4700">Mel</cx:pt>
          <cx:pt idx="4701">Mel</cx:pt>
          <cx:pt idx="4702">Mel</cx:pt>
          <cx:pt idx="4703">Mel</cx:pt>
          <cx:pt idx="4704">Mel</cx:pt>
          <cx:pt idx="4705">Mel</cx:pt>
          <cx:pt idx="4706">Mel</cx:pt>
          <cx:pt idx="4707">Mel</cx:pt>
          <cx:pt idx="4708">Mel</cx:pt>
          <cx:pt idx="4709">Mel</cx:pt>
          <cx:pt idx="4710">Mel</cx:pt>
          <cx:pt idx="4711">Mel</cx:pt>
          <cx:pt idx="4712">Mel</cx:pt>
          <cx:pt idx="4713">Mel</cx:pt>
          <cx:pt idx="4714">Colo</cx:pt>
          <cx:pt idx="4715">Colo</cx:pt>
          <cx:pt idx="4716">Colo</cx:pt>
          <cx:pt idx="4717">Colo</cx:pt>
          <cx:pt idx="4718">Colo</cx:pt>
          <cx:pt idx="4719">Colo</cx:pt>
          <cx:pt idx="4720">Colo</cx:pt>
          <cx:pt idx="4721">Colo</cx:pt>
          <cx:pt idx="4722">Colo</cx:pt>
          <cx:pt idx="4723">Colo</cx:pt>
          <cx:pt idx="4724">Colo</cx:pt>
          <cx:pt idx="4725">Colo</cx:pt>
          <cx:pt idx="4726">Colo</cx:pt>
          <cx:pt idx="4727">Colo</cx:pt>
          <cx:pt idx="4728">Colo</cx:pt>
          <cx:pt idx="4729">Colo</cx:pt>
          <cx:pt idx="4730">Colo</cx:pt>
          <cx:pt idx="4731">Colo</cx:pt>
          <cx:pt idx="4732">Colo</cx:pt>
          <cx:pt idx="4733">Colo</cx:pt>
          <cx:pt idx="4734">Colo</cx:pt>
          <cx:pt idx="4735">Colo</cx:pt>
          <cx:pt idx="4736">Colo</cx:pt>
          <cx:pt idx="4737">Colo</cx:pt>
          <cx:pt idx="4738">Colo</cx:pt>
          <cx:pt idx="4739">Colo</cx:pt>
          <cx:pt idx="4740">Colo</cx:pt>
          <cx:pt idx="4741">Colo</cx:pt>
          <cx:pt idx="4742">Colo</cx:pt>
          <cx:pt idx="4743">Colo</cx:pt>
          <cx:pt idx="4744">Colo</cx:pt>
          <cx:pt idx="4745">Colo</cx:pt>
          <cx:pt idx="4746">Colo</cx:pt>
          <cx:pt idx="4747">Colo</cx:pt>
          <cx:pt idx="4748">Colo</cx:pt>
          <cx:pt idx="4749">Colo</cx:pt>
          <cx:pt idx="4750">Colo</cx:pt>
          <cx:pt idx="4751">Colo</cx:pt>
          <cx:pt idx="4752">Colo</cx:pt>
          <cx:pt idx="4753">Colo</cx:pt>
          <cx:pt idx="4754">Colo</cx:pt>
          <cx:pt idx="4755">Colo</cx:pt>
          <cx:pt idx="4756">Colo</cx:pt>
          <cx:pt idx="4757">Colo</cx:pt>
          <cx:pt idx="4758">Colo</cx:pt>
          <cx:pt idx="4759">Colo</cx:pt>
          <cx:pt idx="4760">Colo</cx:pt>
          <cx:pt idx="4761">Colo</cx:pt>
          <cx:pt idx="4762">Colo</cx:pt>
          <cx:pt idx="4763">Colo</cx:pt>
          <cx:pt idx="4764">Colo</cx:pt>
          <cx:pt idx="4765">Colo</cx:pt>
          <cx:pt idx="4766">Colo</cx:pt>
          <cx:pt idx="4767">Colo</cx:pt>
          <cx:pt idx="4768">Colo</cx:pt>
          <cx:pt idx="4769">Colo</cx:pt>
          <cx:pt idx="4770">Colo</cx:pt>
          <cx:pt idx="4771">Colo</cx:pt>
          <cx:pt idx="4772">Colo</cx:pt>
          <cx:pt idx="4773">Colo</cx:pt>
          <cx:pt idx="4774">Colo</cx:pt>
          <cx:pt idx="4775">Colo</cx:pt>
          <cx:pt idx="4776">Colo</cx:pt>
          <cx:pt idx="4777">Colo</cx:pt>
          <cx:pt idx="4778">Colo</cx:pt>
          <cx:pt idx="4779">Colo</cx:pt>
          <cx:pt idx="4780">Colo</cx:pt>
          <cx:pt idx="4781">Colo</cx:pt>
          <cx:pt idx="4782">Colo</cx:pt>
          <cx:pt idx="4783">Colo</cx:pt>
          <cx:pt idx="4784">Colo</cx:pt>
          <cx:pt idx="4785">Colo</cx:pt>
          <cx:pt idx="4786">Colo</cx:pt>
          <cx:pt idx="4787">Colo</cx:pt>
          <cx:pt idx="4788">Colo</cx:pt>
          <cx:pt idx="4789">Colo</cx:pt>
          <cx:pt idx="4790">Colo</cx:pt>
          <cx:pt idx="4791">Colo</cx:pt>
          <cx:pt idx="4792">Colo</cx:pt>
          <cx:pt idx="4793">Colo</cx:pt>
          <cx:pt idx="4794">Colo</cx:pt>
          <cx:pt idx="4795">Colo</cx:pt>
          <cx:pt idx="4796">Colo</cx:pt>
          <cx:pt idx="4797">Colo</cx:pt>
          <cx:pt idx="4798">Colo</cx:pt>
          <cx:pt idx="4799">Colo</cx:pt>
          <cx:pt idx="4800">Colo</cx:pt>
          <cx:pt idx="4801">Colo</cx:pt>
          <cx:pt idx="4802">Colo</cx:pt>
          <cx:pt idx="4803">Colo</cx:pt>
          <cx:pt idx="4804">Colo</cx:pt>
          <cx:pt idx="4805">Colo</cx:pt>
          <cx:pt idx="4806">Colo</cx:pt>
          <cx:pt idx="4807">Colo</cx:pt>
          <cx:pt idx="4808">Colo</cx:pt>
          <cx:pt idx="4809">Colo</cx:pt>
          <cx:pt idx="4810">Colo</cx:pt>
          <cx:pt idx="4811">Colo</cx:pt>
          <cx:pt idx="4812">Colo</cx:pt>
          <cx:pt idx="4813">Colo</cx:pt>
          <cx:pt idx="4814">Colo</cx:pt>
          <cx:pt idx="4815">Colo</cx:pt>
          <cx:pt idx="4816">Colo</cx:pt>
          <cx:pt idx="4817">Colo</cx:pt>
          <cx:pt idx="4818">Colo</cx:pt>
          <cx:pt idx="4819">Colo</cx:pt>
          <cx:pt idx="4820">Colo</cx:pt>
          <cx:pt idx="4821">Colo</cx:pt>
          <cx:pt idx="4822">Colo</cx:pt>
          <cx:pt idx="4823">Colo</cx:pt>
          <cx:pt idx="4824">Colo</cx:pt>
          <cx:pt idx="4825">Colo</cx:pt>
          <cx:pt idx="4826">Colo</cx:pt>
          <cx:pt idx="4827">Colo</cx:pt>
          <cx:pt idx="4828">Colo</cx:pt>
          <cx:pt idx="4829">Colo</cx:pt>
          <cx:pt idx="4830">Colo</cx:pt>
          <cx:pt idx="4831">Colo</cx:pt>
          <cx:pt idx="4832">Colo</cx:pt>
          <cx:pt idx="4833">Colo</cx:pt>
          <cx:pt idx="4834">Colo</cx:pt>
          <cx:pt idx="4835">Colo</cx:pt>
          <cx:pt idx="4836">Colo</cx:pt>
          <cx:pt idx="4837">Colo</cx:pt>
          <cx:pt idx="4838">Colo</cx:pt>
          <cx:pt idx="4839">Colo</cx:pt>
          <cx:pt idx="4840">Colo</cx:pt>
          <cx:pt idx="4841">Colo</cx:pt>
          <cx:pt idx="4842">Colo</cx:pt>
          <cx:pt idx="4843">Colo</cx:pt>
          <cx:pt idx="4844">Colo</cx:pt>
          <cx:pt idx="4845">Colo</cx:pt>
          <cx:pt idx="4846">Colo</cx:pt>
          <cx:pt idx="4847">Colo</cx:pt>
          <cx:pt idx="4848">Colo</cx:pt>
          <cx:pt idx="4849">Colo</cx:pt>
          <cx:pt idx="4850">Colo</cx:pt>
          <cx:pt idx="4851">Colo</cx:pt>
          <cx:pt idx="4852">Colo</cx:pt>
          <cx:pt idx="4853">Colo</cx:pt>
          <cx:pt idx="4854">Colo</cx:pt>
          <cx:pt idx="4855">Colo</cx:pt>
          <cx:pt idx="4856">Colo</cx:pt>
          <cx:pt idx="4857">Colo</cx:pt>
          <cx:pt idx="4858">Colo</cx:pt>
          <cx:pt idx="4859">Colo</cx:pt>
          <cx:pt idx="4860">Colo</cx:pt>
          <cx:pt idx="4861">Colo</cx:pt>
          <cx:pt idx="4862">Colo</cx:pt>
          <cx:pt idx="4863">Colo</cx:pt>
          <cx:pt idx="4864">Colo</cx:pt>
          <cx:pt idx="4865">Colo</cx:pt>
          <cx:pt idx="4866">Colo</cx:pt>
          <cx:pt idx="4867">Colo</cx:pt>
          <cx:pt idx="4868">Colo</cx:pt>
          <cx:pt idx="4869">Colo</cx:pt>
          <cx:pt idx="4870">Colo</cx:pt>
          <cx:pt idx="4871">Colo</cx:pt>
          <cx:pt idx="4872">Colo</cx:pt>
          <cx:pt idx="4873">Colo</cx:pt>
          <cx:pt idx="4874">Colo</cx:pt>
          <cx:pt idx="4875">Colo</cx:pt>
          <cx:pt idx="4876">Colo</cx:pt>
          <cx:pt idx="4877">Colo</cx:pt>
          <cx:pt idx="4878">Colo</cx:pt>
          <cx:pt idx="4879">Colo</cx:pt>
          <cx:pt idx="4880">Colo</cx:pt>
          <cx:pt idx="4881">Colo</cx:pt>
          <cx:pt idx="4882">Colo</cx:pt>
          <cx:pt idx="4883">Colo</cx:pt>
          <cx:pt idx="4884">Colo</cx:pt>
          <cx:pt idx="4885">Colo</cx:pt>
          <cx:pt idx="4886">Colo</cx:pt>
          <cx:pt idx="4887">Colo</cx:pt>
          <cx:pt idx="4888">Colo</cx:pt>
          <cx:pt idx="4889">Colo</cx:pt>
          <cx:pt idx="4890">Colo</cx:pt>
          <cx:pt idx="4891">Colo</cx:pt>
          <cx:pt idx="4892">Colo</cx:pt>
          <cx:pt idx="4893">Colo</cx:pt>
          <cx:pt idx="4894">Colo</cx:pt>
          <cx:pt idx="4895">Colo</cx:pt>
          <cx:pt idx="4896">Colo</cx:pt>
          <cx:pt idx="4897">Colo</cx:pt>
          <cx:pt idx="4898">Colo</cx:pt>
          <cx:pt idx="4899">Colo</cx:pt>
          <cx:pt idx="4900">Colo</cx:pt>
          <cx:pt idx="4901">Colo</cx:pt>
          <cx:pt idx="4902">Colo</cx:pt>
          <cx:pt idx="4903">Colo</cx:pt>
          <cx:pt idx="4904">Colo</cx:pt>
          <cx:pt idx="4905">Colo</cx:pt>
          <cx:pt idx="4906">Colo</cx:pt>
          <cx:pt idx="4907">Colo</cx:pt>
          <cx:pt idx="4908">Colo</cx:pt>
          <cx:pt idx="4909">Colo</cx:pt>
          <cx:pt idx="4910">Colo</cx:pt>
          <cx:pt idx="4911">Colo</cx:pt>
          <cx:pt idx="4912">Colo</cx:pt>
          <cx:pt idx="4913">Colo</cx:pt>
          <cx:pt idx="4914">Colo</cx:pt>
          <cx:pt idx="4915">Colo</cx:pt>
          <cx:pt idx="4916">Colo</cx:pt>
          <cx:pt idx="4917">Colo</cx:pt>
          <cx:pt idx="4918">Colo</cx:pt>
          <cx:pt idx="4919">Colo</cx:pt>
          <cx:pt idx="4920">Colo</cx:pt>
          <cx:pt idx="4921">Colo</cx:pt>
          <cx:pt idx="4922">Colo</cx:pt>
          <cx:pt idx="4923">Kdy</cx:pt>
          <cx:pt idx="4924">Kdy</cx:pt>
          <cx:pt idx="4925">Kdy</cx:pt>
          <cx:pt idx="4926">Kdy</cx:pt>
          <cx:pt idx="4927">Kdy</cx:pt>
          <cx:pt idx="4928">Kdy</cx:pt>
          <cx:pt idx="4929">Kdy</cx:pt>
          <cx:pt idx="4930">Kdy</cx:pt>
          <cx:pt idx="4931">Kdy</cx:pt>
          <cx:pt idx="4932">Kdy</cx:pt>
          <cx:pt idx="4933">Kdy</cx:pt>
          <cx:pt idx="4934">Kdy</cx:pt>
          <cx:pt idx="4935">Kdy</cx:pt>
          <cx:pt idx="4936">Kdy</cx:pt>
          <cx:pt idx="4937">Kdy</cx:pt>
          <cx:pt idx="4938">Kdy</cx:pt>
          <cx:pt idx="4939">Kdy</cx:pt>
          <cx:pt idx="4940">Kdy</cx:pt>
          <cx:pt idx="4941">Kdy</cx:pt>
          <cx:pt idx="4942">Kdy</cx:pt>
          <cx:pt idx="4943">Kdy</cx:pt>
          <cx:pt idx="4944">Kdy</cx:pt>
          <cx:pt idx="4945">Kdy</cx:pt>
          <cx:pt idx="4946">Kdy</cx:pt>
          <cx:pt idx="4947">Kdy</cx:pt>
          <cx:pt idx="4948">Kdy</cx:pt>
          <cx:pt idx="4949">Kdy</cx:pt>
          <cx:pt idx="4950">Kdy</cx:pt>
          <cx:pt idx="4951">Kdy</cx:pt>
          <cx:pt idx="4952">Kdy</cx:pt>
          <cx:pt idx="4953">Kdy</cx:pt>
          <cx:pt idx="4954">Kdy</cx:pt>
          <cx:pt idx="4955">Kdy</cx:pt>
          <cx:pt idx="4956">Kdy</cx:pt>
          <cx:pt idx="4957">Kdy</cx:pt>
          <cx:pt idx="4958">Kdy</cx:pt>
          <cx:pt idx="4959">Kdy</cx:pt>
          <cx:pt idx="4960">Kdy</cx:pt>
          <cx:pt idx="4961">Kdy</cx:pt>
          <cx:pt idx="4962">Kdy</cx:pt>
          <cx:pt idx="4963">Kdy</cx:pt>
          <cx:pt idx="4964">Kdy</cx:pt>
          <cx:pt idx="4965">Kdy</cx:pt>
          <cx:pt idx="4966">Kdy</cx:pt>
          <cx:pt idx="4967">Kdy</cx:pt>
          <cx:pt idx="4968">Kdy</cx:pt>
          <cx:pt idx="4969">Kdy</cx:pt>
          <cx:pt idx="4970">Kdy</cx:pt>
          <cx:pt idx="4971">Kdy</cx:pt>
          <cx:pt idx="4972">Kdy</cx:pt>
          <cx:pt idx="4973">Kdy</cx:pt>
          <cx:pt idx="4974">Kdy</cx:pt>
          <cx:pt idx="4975">Kdy</cx:pt>
          <cx:pt idx="4976">Kdy</cx:pt>
          <cx:pt idx="4977">Kdy</cx:pt>
          <cx:pt idx="4978">Kdy</cx:pt>
          <cx:pt idx="4979">NHL</cx:pt>
          <cx:pt idx="4980">NHL</cx:pt>
          <cx:pt idx="4981">NHL</cx:pt>
          <cx:pt idx="4982">NHL</cx:pt>
          <cx:pt idx="4983">NHL</cx:pt>
          <cx:pt idx="4984">NHL</cx:pt>
          <cx:pt idx="4985">NHL</cx:pt>
          <cx:pt idx="4986">NHL</cx:pt>
          <cx:pt idx="4987">NHL</cx:pt>
          <cx:pt idx="4988">NHL</cx:pt>
          <cx:pt idx="4989">NHL</cx:pt>
          <cx:pt idx="4990">NHL</cx:pt>
          <cx:pt idx="4991">NHL</cx:pt>
          <cx:pt idx="4992">NHL</cx:pt>
          <cx:pt idx="4993">NHL</cx:pt>
          <cx:pt idx="4994">NHL</cx:pt>
          <cx:pt idx="4995">NHL</cx:pt>
          <cx:pt idx="4996">NHL</cx:pt>
          <cx:pt idx="4997">NHL</cx:pt>
          <cx:pt idx="4998">NHL</cx:pt>
          <cx:pt idx="4999">NHL</cx:pt>
          <cx:pt idx="5000">NHL</cx:pt>
          <cx:pt idx="5001">NHL</cx:pt>
          <cx:pt idx="5002">NHL</cx:pt>
          <cx:pt idx="5003">NHL</cx:pt>
          <cx:pt idx="5004">NHL</cx:pt>
          <cx:pt idx="5005">NHL</cx:pt>
          <cx:pt idx="5006">NHL</cx:pt>
          <cx:pt idx="5007">NHL</cx:pt>
          <cx:pt idx="5008">NHL</cx:pt>
          <cx:pt idx="5009">NHL</cx:pt>
          <cx:pt idx="5010">NHL</cx:pt>
          <cx:pt idx="5011">NHL</cx:pt>
          <cx:pt idx="5012">NHL</cx:pt>
          <cx:pt idx="5013">NHL</cx:pt>
          <cx:pt idx="5014">NHL</cx:pt>
          <cx:pt idx="5015">NHL</cx:pt>
          <cx:pt idx="5016">NHL</cx:pt>
          <cx:pt idx="5017">NHL</cx:pt>
          <cx:pt idx="5018">NHL</cx:pt>
          <cx:pt idx="5019">NHL</cx:pt>
          <cx:pt idx="5020">NHL</cx:pt>
          <cx:pt idx="5021">NHL</cx:pt>
          <cx:pt idx="5022">NHL</cx:pt>
          <cx:pt idx="5023">NHL</cx:pt>
          <cx:pt idx="5024">NHL</cx:pt>
          <cx:pt idx="5025">NHL</cx:pt>
          <cx:pt idx="5026">Panc</cx:pt>
          <cx:pt idx="5027">Panc</cx:pt>
          <cx:pt idx="5028">Panc</cx:pt>
          <cx:pt idx="5029">Panc</cx:pt>
          <cx:pt idx="5030">Panc</cx:pt>
          <cx:pt idx="5031">Panc</cx:pt>
          <cx:pt idx="5032">Panc</cx:pt>
          <cx:pt idx="5033">Panc</cx:pt>
          <cx:pt idx="5034">Panc</cx:pt>
          <cx:pt idx="5035">Panc</cx:pt>
          <cx:pt idx="5036">Panc</cx:pt>
          <cx:pt idx="5037">Panc</cx:pt>
          <cx:pt idx="5038">Panc</cx:pt>
          <cx:pt idx="5039">Panc</cx:pt>
          <cx:pt idx="5040">Panc</cx:pt>
          <cx:pt idx="5041">Panc</cx:pt>
          <cx:pt idx="5042">Panc</cx:pt>
          <cx:pt idx="5043">Panc</cx:pt>
          <cx:pt idx="5044">Panc</cx:pt>
          <cx:pt idx="5045">Panc</cx:pt>
          <cx:pt idx="5046">Panc</cx:pt>
          <cx:pt idx="5047">Panc</cx:pt>
          <cx:pt idx="5048">Panc</cx:pt>
          <cx:pt idx="5049">Panc</cx:pt>
          <cx:pt idx="5050">Panc</cx:pt>
          <cx:pt idx="5051">Panc</cx:pt>
          <cx:pt idx="5052">Panc</cx:pt>
          <cx:pt idx="5053">Panc</cx:pt>
          <cx:pt idx="5054">Panc</cx:pt>
          <cx:pt idx="5055">Panc</cx:pt>
          <cx:pt idx="5056">Panc</cx:pt>
          <cx:pt idx="5057">Panc</cx:pt>
          <cx:pt idx="5058">Panc</cx:pt>
          <cx:pt idx="5059">Panc</cx:pt>
          <cx:pt idx="5060">Panc</cx:pt>
          <cx:pt idx="5061">Panc</cx:pt>
          <cx:pt idx="5062">Panc</cx:pt>
          <cx:pt idx="5063">Panc</cx:pt>
          <cx:pt idx="5064">Panc</cx:pt>
          <cx:pt idx="5065">Panc</cx:pt>
          <cx:pt idx="5066">Panc</cx:pt>
          <cx:pt idx="5067">Panc</cx:pt>
          <cx:pt idx="5068">Panc</cx:pt>
          <cx:pt idx="5069">Panc</cx:pt>
          <cx:pt idx="5070">Panc</cx:pt>
          <cx:pt idx="5071">Panc</cx:pt>
          <cx:pt idx="5072">Panc</cx:pt>
          <cx:pt idx="5073">Panc</cx:pt>
          <cx:pt idx="5074">Panc</cx:pt>
          <cx:pt idx="5075">Panc</cx:pt>
          <cx:pt idx="5076">Panc</cx:pt>
          <cx:pt idx="5077">Panc</cx:pt>
          <cx:pt idx="5078">Panc</cx:pt>
          <cx:pt idx="5079">Panc</cx:pt>
          <cx:pt idx="5080">Panc</cx:pt>
          <cx:pt idx="5081">Panc</cx:pt>
          <cx:pt idx="5082">Panc</cx:pt>
          <cx:pt idx="5083">Panc</cx:pt>
          <cx:pt idx="5084">Panc</cx:pt>
          <cx:pt idx="5085">Liv</cx:pt>
          <cx:pt idx="5086">Liv</cx:pt>
          <cx:pt idx="5087">Liv</cx:pt>
          <cx:pt idx="5088">Liv</cx:pt>
          <cx:pt idx="5089">Liv</cx:pt>
          <cx:pt idx="5090">Liv</cx:pt>
          <cx:pt idx="5091">Liv</cx:pt>
          <cx:pt idx="5092">Liv</cx:pt>
          <cx:pt idx="5093">Liv</cx:pt>
          <cx:pt idx="5094">Liv</cx:pt>
          <cx:pt idx="5095">Liv</cx:pt>
          <cx:pt idx="5096">Liv</cx:pt>
          <cx:pt idx="5097">Liv</cx:pt>
          <cx:pt idx="5098">Liv</cx:pt>
          <cx:pt idx="5099">Liv</cx:pt>
          <cx:pt idx="5100">Liv</cx:pt>
          <cx:pt idx="5101">Liv</cx:pt>
          <cx:pt idx="5102">Liv</cx:pt>
          <cx:pt idx="5103">Liv</cx:pt>
          <cx:pt idx="5104">Liv</cx:pt>
          <cx:pt idx="5105">Liv</cx:pt>
          <cx:pt idx="5106">Liv</cx:pt>
          <cx:pt idx="5107">Liv</cx:pt>
          <cx:pt idx="5108">Liv</cx:pt>
          <cx:pt idx="5109">Liv</cx:pt>
          <cx:pt idx="5110">Liv</cx:pt>
          <cx:pt idx="5111">Liv</cx:pt>
          <cx:pt idx="5112">Liv</cx:pt>
          <cx:pt idx="5113">Liv</cx:pt>
          <cx:pt idx="5114">Liv</cx:pt>
          <cx:pt idx="5115">Liv</cx:pt>
          <cx:pt idx="5116">Liv</cx:pt>
          <cx:pt idx="5117">Liv</cx:pt>
          <cx:pt idx="5118">Liv</cx:pt>
          <cx:pt idx="5119">Liv</cx:pt>
          <cx:pt idx="5120">Liv</cx:pt>
          <cx:pt idx="5121">Liv</cx:pt>
          <cx:pt idx="5122">Liv</cx:pt>
          <cx:pt idx="5123">Liv</cx:pt>
          <cx:pt idx="5124">Liv</cx:pt>
          <cx:pt idx="5125">Liv</cx:pt>
          <cx:pt idx="5126">Liv</cx:pt>
          <cx:pt idx="5127">Liv</cx:pt>
          <cx:pt idx="5128">Liv</cx:pt>
          <cx:pt idx="5129">Liv</cx:pt>
          <cx:pt idx="5130">Liv</cx:pt>
          <cx:pt idx="5131">Liv</cx:pt>
          <cx:pt idx="5132">Liv</cx:pt>
          <cx:pt idx="5133">Liv</cx:pt>
          <cx:pt idx="5134">Liv</cx:pt>
          <cx:pt idx="5135">Liv</cx:pt>
          <cx:pt idx="5136">Liv</cx:pt>
          <cx:pt idx="5137">Liv</cx:pt>
          <cx:pt idx="5138">Liv</cx:pt>
          <cx:pt idx="5139">Liv</cx:pt>
          <cx:pt idx="5140">Liv</cx:pt>
          <cx:pt idx="5141">Liv</cx:pt>
          <cx:pt idx="5142">Liv</cx:pt>
          <cx:pt idx="5143">Liv</cx:pt>
          <cx:pt idx="5144">Liv</cx:pt>
          <cx:pt idx="5145">Liv</cx:pt>
          <cx:pt idx="5146">Liv</cx:pt>
          <cx:pt idx="5147">Liv</cx:pt>
          <cx:pt idx="5148">Liv</cx:pt>
          <cx:pt idx="5149">Liv</cx:pt>
          <cx:pt idx="5150">Liv</cx:pt>
          <cx:pt idx="5151">Liv</cx:pt>
          <cx:pt idx="5152">Liv</cx:pt>
          <cx:pt idx="5153">Liv</cx:pt>
          <cx:pt idx="5154">Liv</cx:pt>
          <cx:pt idx="5155">Liv</cx:pt>
          <cx:pt idx="5156">Liv</cx:pt>
          <cx:pt idx="5157">Liv</cx:pt>
          <cx:pt idx="5158">Liv</cx:pt>
          <cx:pt idx="5159">Liv</cx:pt>
          <cx:pt idx="5160">Liv</cx:pt>
          <cx:pt idx="5161">Liv</cx:pt>
          <cx:pt idx="5162">Liv</cx:pt>
          <cx:pt idx="5163">Liv</cx:pt>
          <cx:pt idx="5164">Liv</cx:pt>
          <cx:pt idx="5165">Liv</cx:pt>
          <cx:pt idx="5166">Liv</cx:pt>
          <cx:pt idx="5167">Liv</cx:pt>
          <cx:pt idx="5168">Liv</cx:pt>
          <cx:pt idx="5169">Liv</cx:pt>
          <cx:pt idx="5170">Liv</cx:pt>
          <cx:pt idx="5171">Liv</cx:pt>
          <cx:pt idx="5172">Liv</cx:pt>
          <cx:pt idx="5173">Liv</cx:pt>
          <cx:pt idx="5174">Liv</cx:pt>
          <cx:pt idx="5175">Liv</cx:pt>
          <cx:pt idx="5176">Liv</cx:pt>
          <cx:pt idx="5177">Liv</cx:pt>
          <cx:pt idx="5178">Liv</cx:pt>
          <cx:pt idx="5179">Liv</cx:pt>
          <cx:pt idx="5180">Liv</cx:pt>
          <cx:pt idx="5181">Liv</cx:pt>
          <cx:pt idx="5182">Liv</cx:pt>
          <cx:pt idx="5183">Liv</cx:pt>
          <cx:pt idx="5184">Liv</cx:pt>
          <cx:pt idx="5185">Liv</cx:pt>
          <cx:pt idx="5186">Liv</cx:pt>
          <cx:pt idx="5187">Liv</cx:pt>
          <cx:pt idx="5188">Liv</cx:pt>
          <cx:pt idx="5189">Liv</cx:pt>
          <cx:pt idx="5190">Liv</cx:pt>
          <cx:pt idx="5191">Liv</cx:pt>
          <cx:pt idx="5192">Liv</cx:pt>
          <cx:pt idx="5193">Liv</cx:pt>
          <cx:pt idx="5194">Liv</cx:pt>
          <cx:pt idx="5195">Liv</cx:pt>
          <cx:pt idx="5196">Liv</cx:pt>
          <cx:pt idx="5197">Liv</cx:pt>
          <cx:pt idx="5198">Gst</cx:pt>
          <cx:pt idx="5199">Gst</cx:pt>
          <cx:pt idx="5200">Gst</cx:pt>
          <cx:pt idx="5201">Gst</cx:pt>
          <cx:pt idx="5202">Gst</cx:pt>
          <cx:pt idx="5203">Gst</cx:pt>
          <cx:pt idx="5204">Gst</cx:pt>
          <cx:pt idx="5205">Gst</cx:pt>
          <cx:pt idx="5206">Gst</cx:pt>
          <cx:pt idx="5207">Gst</cx:pt>
          <cx:pt idx="5208">Gst</cx:pt>
          <cx:pt idx="5209">Gst</cx:pt>
          <cx:pt idx="5210">Gst</cx:pt>
          <cx:pt idx="5211">Gst</cx:pt>
          <cx:pt idx="5212">Gst</cx:pt>
          <cx:pt idx="5213">Gst</cx:pt>
          <cx:pt idx="5214">Gst</cx:pt>
          <cx:pt idx="5215">Gst</cx:pt>
          <cx:pt idx="5216">Gst</cx:pt>
          <cx:pt idx="5217">Gst</cx:pt>
          <cx:pt idx="5218">Gst</cx:pt>
          <cx:pt idx="5219">Gst</cx:pt>
          <cx:pt idx="5220">Gst</cx:pt>
          <cx:pt idx="5221">Gst</cx:pt>
          <cx:pt idx="5222">Gst</cx:pt>
          <cx:pt idx="5223">Gst</cx:pt>
          <cx:pt idx="5224">Gst</cx:pt>
          <cx:pt idx="5225">Gst</cx:pt>
          <cx:pt idx="5226">Gst</cx:pt>
          <cx:pt idx="5227">Gst</cx:pt>
          <cx:pt idx="5228">Gst</cx:pt>
          <cx:pt idx="5229">Gst</cx:pt>
          <cx:pt idx="5230">Gst</cx:pt>
          <cx:pt idx="5231">Gst</cx:pt>
          <cx:pt idx="5232">Gst</cx:pt>
          <cx:pt idx="5233">Gst</cx:pt>
          <cx:pt idx="5234">Gst</cx:pt>
          <cx:pt idx="5235">Gst</cx:pt>
          <cx:pt idx="5236">Gst</cx:pt>
          <cx:pt idx="5237">Gst</cx:pt>
          <cx:pt idx="5238">Gst</cx:pt>
          <cx:pt idx="5239">Gst</cx:pt>
          <cx:pt idx="5240">Gst</cx:pt>
          <cx:pt idx="5241">Gst</cx:pt>
          <cx:pt idx="5242">Gst</cx:pt>
          <cx:pt idx="5243">Gst</cx:pt>
          <cx:pt idx="5244">Gst</cx:pt>
          <cx:pt idx="5245">Gst</cx:pt>
          <cx:pt idx="5246">Gst</cx:pt>
          <cx:pt idx="5247">Gst</cx:pt>
          <cx:pt idx="5248">Gst</cx:pt>
          <cx:pt idx="5249">Gst</cx:pt>
          <cx:pt idx="5250">Gst</cx:pt>
          <cx:pt idx="5251">Gst</cx:pt>
          <cx:pt idx="5252">Gst</cx:pt>
          <cx:pt idx="5253">Gst</cx:pt>
          <cx:pt idx="5254">Gst</cx:pt>
          <cx:pt idx="5255">Gst</cx:pt>
          <cx:pt idx="5256">Gst</cx:pt>
          <cx:pt idx="5257">Gst</cx:pt>
          <cx:pt idx="5258">Gst</cx:pt>
          <cx:pt idx="5259">Gst</cx:pt>
          <cx:pt idx="5260">Gst</cx:pt>
          <cx:pt idx="5261">Gst</cx:pt>
          <cx:pt idx="5262">Gst</cx:pt>
          <cx:pt idx="5263">Gst</cx:pt>
          <cx:pt idx="5264">Gst</cx:pt>
          <cx:pt idx="5265">Gst</cx:pt>
          <cx:pt idx="5266">Gst</cx:pt>
          <cx:pt idx="5267">Gst</cx:pt>
          <cx:pt idx="5268">Gst</cx:pt>
          <cx:pt idx="5269">Gst</cx:pt>
          <cx:pt idx="5270">Gst</cx:pt>
          <cx:pt idx="5271">Gst</cx:pt>
          <cx:pt idx="5272">Gst</cx:pt>
          <cx:pt idx="5273">Gst</cx:pt>
          <cx:pt idx="5274">Gst</cx:pt>
          <cx:pt idx="5275">Gst</cx:pt>
          <cx:pt idx="5276">Gst</cx:pt>
          <cx:pt idx="5277">Gst</cx:pt>
          <cx:pt idx="5278">Gst</cx:pt>
          <cx:pt idx="5279">Gst</cx:pt>
          <cx:pt idx="5280">Gst</cx:pt>
          <cx:pt idx="5281">Gst</cx:pt>
          <cx:pt idx="5282">Gst</cx:pt>
          <cx:pt idx="5283">Gst</cx:pt>
          <cx:pt idx="5284">Gst</cx:pt>
          <cx:pt idx="5285">Gst</cx:pt>
          <cx:pt idx="5286">Gst</cx:pt>
          <cx:pt idx="5287">Gst</cx:pt>
          <cx:pt idx="5288">Gst</cx:pt>
          <cx:pt idx="5289">Gst</cx:pt>
          <cx:pt idx="5290">Gst</cx:pt>
          <cx:pt idx="5291">Gst</cx:pt>
          <cx:pt idx="5292">Gst</cx:pt>
          <cx:pt idx="5293">Gst</cx:pt>
          <cx:pt idx="5294">Gst</cx:pt>
          <cx:pt idx="5295">Gst</cx:pt>
          <cx:pt idx="5296">Gst</cx:pt>
          <cx:pt idx="5297">Gst</cx:pt>
          <cx:pt idx="5298">Gst</cx:pt>
          <cx:pt idx="5299">Gst</cx:pt>
          <cx:pt idx="5300">Gst</cx:pt>
          <cx:pt idx="5301">Gst</cx:pt>
          <cx:pt idx="5302">Gst</cx:pt>
          <cx:pt idx="5303">Gst</cx:pt>
          <cx:pt idx="5304">Gst</cx:pt>
          <cx:pt idx="5305">Gst</cx:pt>
          <cx:pt idx="5306">Gst</cx:pt>
          <cx:pt idx="5307">Gst</cx:pt>
          <cx:pt idx="5308">Gst</cx:pt>
          <cx:pt idx="5309">Gst</cx:pt>
          <cx:pt idx="5310">Gst</cx:pt>
          <cx:pt idx="5311">Gst</cx:pt>
          <cx:pt idx="5312">Gst</cx:pt>
          <cx:pt idx="5313">Gst</cx:pt>
          <cx:pt idx="5314">Gst</cx:pt>
          <cx:pt idx="5315">Gst</cx:pt>
          <cx:pt idx="5316">Gst</cx:pt>
          <cx:pt idx="5317">Gst</cx:pt>
          <cx:pt idx="5318">Gst</cx:pt>
          <cx:pt idx="5319">Gst</cx:pt>
          <cx:pt idx="5320">Gst</cx:pt>
          <cx:pt idx="5321">Gst</cx:pt>
          <cx:pt idx="5322">Gst</cx:pt>
          <cx:pt idx="5323">Gst</cx:pt>
          <cx:pt idx="5324">Gst</cx:pt>
          <cx:pt idx="5325">Gst</cx:pt>
          <cx:pt idx="5326">Gst</cx:pt>
          <cx:pt idx="5327">Gst</cx:pt>
          <cx:pt idx="5328">Gst</cx:pt>
          <cx:pt idx="5329">Gst</cx:pt>
          <cx:pt idx="5330">Gst</cx:pt>
          <cx:pt idx="5331">Gst</cx:pt>
          <cx:pt idx="5332">Gst</cx:pt>
          <cx:pt idx="5333">Gst</cx:pt>
          <cx:pt idx="5334">Gst</cx:pt>
          <cx:pt idx="5335">Gst</cx:pt>
          <cx:pt idx="5336">Gst</cx:pt>
          <cx:pt idx="5337">Gst</cx:pt>
          <cx:pt idx="5338">Gst</cx:pt>
          <cx:pt idx="5339">Gst</cx:pt>
          <cx:pt idx="5340">Gst</cx:pt>
          <cx:pt idx="5341">Gst</cx:pt>
          <cx:pt idx="5342">Gst</cx:pt>
          <cx:pt idx="5343">Gst</cx:pt>
          <cx:pt idx="5344">Gst</cx:pt>
          <cx:pt idx="5345">Gst</cx:pt>
          <cx:pt idx="5346">Gst</cx:pt>
          <cx:pt idx="5347">Gst</cx:pt>
          <cx:pt idx="5348">Gst</cx:pt>
          <cx:pt idx="5349">Gst</cx:pt>
          <cx:pt idx="5350">Gst</cx:pt>
          <cx:pt idx="5351">Gst</cx:pt>
          <cx:pt idx="5352">Gst</cx:pt>
          <cx:pt idx="5353">Gst</cx:pt>
          <cx:pt idx="5354">Gst</cx:pt>
          <cx:pt idx="5355">Gst</cx:pt>
          <cx:pt idx="5356">Gst</cx:pt>
          <cx:pt idx="5357">Gst</cx:pt>
          <cx:pt idx="5358">Gst</cx:pt>
          <cx:pt idx="5359">Gst</cx:pt>
          <cx:pt idx="5360">Gst</cx:pt>
          <cx:pt idx="5361">Gst</cx:pt>
          <cx:pt idx="5362">Gst</cx:pt>
          <cx:pt idx="5363">Gst</cx:pt>
          <cx:pt idx="5364">Gst</cx:pt>
          <cx:pt idx="5365">Gst</cx:pt>
          <cx:pt idx="5366">Gst</cx:pt>
          <cx:pt idx="5367">Gst</cx:pt>
          <cx:pt idx="5368">Gst</cx:pt>
          <cx:pt idx="5369">Gst</cx:pt>
          <cx:pt idx="5370">Gst</cx:pt>
          <cx:pt idx="5371">Gst</cx:pt>
          <cx:pt idx="5372">Gst</cx:pt>
          <cx:pt idx="5373">Gst</cx:pt>
          <cx:pt idx="5374">Gst</cx:pt>
          <cx:pt idx="5375">Gst</cx:pt>
          <cx:pt idx="5376">Gst</cx:pt>
          <cx:pt idx="5377">Gst</cx:pt>
          <cx:pt idx="5378">Gst</cx:pt>
          <cx:pt idx="5379">Gst</cx:pt>
          <cx:pt idx="5380">Gst</cx:pt>
          <cx:pt idx="5381">Gst</cx:pt>
          <cx:pt idx="5382">Gst</cx:pt>
          <cx:pt idx="5383">Gst</cx:pt>
          <cx:pt idx="5384">Gst</cx:pt>
          <cx:pt idx="5385">Gst</cx:pt>
          <cx:pt idx="5386">Gst</cx:pt>
          <cx:pt idx="5387">Gst</cx:pt>
          <cx:pt idx="5388">Gst</cx:pt>
          <cx:pt idx="5389">Gst</cx:pt>
          <cx:pt idx="5390">Gst</cx:pt>
          <cx:pt idx="5391">Gst</cx:pt>
          <cx:pt idx="5392">H&amp;N</cx:pt>
          <cx:pt idx="5393">H&amp;N</cx:pt>
          <cx:pt idx="5394">H&amp;N</cx:pt>
          <cx:pt idx="5395">H&amp;N</cx:pt>
          <cx:pt idx="5396">H&amp;N</cx:pt>
          <cx:pt idx="5397">H&amp;N</cx:pt>
          <cx:pt idx="5398">H&amp;N</cx:pt>
          <cx:pt idx="5399">H&amp;N</cx:pt>
          <cx:pt idx="5400">H&amp;N</cx:pt>
          <cx:pt idx="5401">H&amp;N</cx:pt>
          <cx:pt idx="5402">H&amp;N</cx:pt>
          <cx:pt idx="5403">H&amp;N</cx:pt>
          <cx:pt idx="5404">H&amp;N</cx:pt>
          <cx:pt idx="5405">H&amp;N</cx:pt>
          <cx:pt idx="5406">H&amp;N</cx:pt>
          <cx:pt idx="5407">H&amp;N</cx:pt>
          <cx:pt idx="5408">H&amp;N</cx:pt>
          <cx:pt idx="5409">H&amp;N</cx:pt>
          <cx:pt idx="5410">H&amp;N</cx:pt>
          <cx:pt idx="5411">H&amp;N</cx:pt>
          <cx:pt idx="5412">H&amp;N</cx:pt>
          <cx:pt idx="5413">H&amp;N</cx:pt>
          <cx:pt idx="5414">H&amp;N</cx:pt>
          <cx:pt idx="5415">H&amp;N</cx:pt>
          <cx:pt idx="5416">H&amp;N</cx:pt>
          <cx:pt idx="5417">H&amp;N</cx:pt>
          <cx:pt idx="5418">H&amp;N</cx:pt>
          <cx:pt idx="5419">H&amp;N</cx:pt>
          <cx:pt idx="5420">H&amp;N</cx:pt>
          <cx:pt idx="5421">H&amp;N</cx:pt>
          <cx:pt idx="5422">H&amp;N</cx:pt>
          <cx:pt idx="5423">H&amp;N</cx:pt>
          <cx:pt idx="5424">H&amp;N</cx:pt>
          <cx:pt idx="5425">H&amp;N</cx:pt>
          <cx:pt idx="5426">H&amp;N</cx:pt>
          <cx:pt idx="5427">H&amp;N</cx:pt>
          <cx:pt idx="5428">H&amp;N</cx:pt>
          <cx:pt idx="5429">H&amp;N</cx:pt>
          <cx:pt idx="5430">H&amp;N</cx:pt>
          <cx:pt idx="5431">H&amp;N</cx:pt>
          <cx:pt idx="5432">H&amp;N</cx:pt>
          <cx:pt idx="5433">H&amp;N</cx:pt>
          <cx:pt idx="5434">H&amp;N</cx:pt>
          <cx:pt idx="5435">H&amp;N</cx:pt>
          <cx:pt idx="5436">H&amp;N</cx:pt>
          <cx:pt idx="5437">H&amp;N</cx:pt>
          <cx:pt idx="5438">H&amp;N</cx:pt>
          <cx:pt idx="5439">H&amp;N</cx:pt>
          <cx:pt idx="5440">H&amp;N</cx:pt>
          <cx:pt idx="5441">H&amp;N</cx:pt>
          <cx:pt idx="5442">H&amp;N</cx:pt>
          <cx:pt idx="5443">H&amp;N</cx:pt>
          <cx:pt idx="5444">H&amp;N</cx:pt>
          <cx:pt idx="5445">H&amp;N</cx:pt>
          <cx:pt idx="5446">H&amp;N</cx:pt>
          <cx:pt idx="5447">H&amp;N</cx:pt>
          <cx:pt idx="5448">H&amp;N</cx:pt>
          <cx:pt idx="5449">H&amp;N</cx:pt>
          <cx:pt idx="5450">H&amp;N</cx:pt>
          <cx:pt idx="5451">H&amp;N</cx:pt>
          <cx:pt idx="5452">H&amp;N</cx:pt>
          <cx:pt idx="5453">H&amp;N</cx:pt>
          <cx:pt idx="5454">H&amp;N</cx:pt>
          <cx:pt idx="5455">H&amp;N</cx:pt>
          <cx:pt idx="5456">H&amp;N</cx:pt>
          <cx:pt idx="5457">H&amp;N</cx:pt>
          <cx:pt idx="5458">H&amp;N</cx:pt>
          <cx:pt idx="5459">H&amp;N</cx:pt>
          <cx:pt idx="5460">H&amp;N</cx:pt>
          <cx:pt idx="5461">H&amp;N</cx:pt>
          <cx:pt idx="5462">H&amp;N</cx:pt>
          <cx:pt idx="5463">H&amp;N</cx:pt>
          <cx:pt idx="5464">H&amp;N</cx:pt>
          <cx:pt idx="5465">H&amp;N</cx:pt>
          <cx:pt idx="5466">H&amp;N</cx:pt>
          <cx:pt idx="5467">H&amp;N</cx:pt>
          <cx:pt idx="5468">H&amp;N</cx:pt>
          <cx:pt idx="5469">H&amp;N</cx:pt>
          <cx:pt idx="5470">H&amp;N</cx:pt>
          <cx:pt idx="5471">H&amp;N</cx:pt>
          <cx:pt idx="5472">H&amp;N</cx:pt>
          <cx:pt idx="5473">H&amp;N</cx:pt>
          <cx:pt idx="5474">H&amp;N</cx:pt>
          <cx:pt idx="5475">H&amp;N</cx:pt>
          <cx:pt idx="5476">H&amp;N</cx:pt>
          <cx:pt idx="5477">H&amp;N</cx:pt>
          <cx:pt idx="5478">H&amp;N</cx:pt>
          <cx:pt idx="5479">H&amp;N</cx:pt>
          <cx:pt idx="5480">H&amp;N</cx:pt>
          <cx:pt idx="5481">H&amp;N</cx:pt>
          <cx:pt idx="5482">H&amp;N</cx:pt>
          <cx:pt idx="5483">H&amp;N</cx:pt>
          <cx:pt idx="5484">H&amp;N</cx:pt>
          <cx:pt idx="5485">H&amp;N</cx:pt>
          <cx:pt idx="5486">H&amp;N</cx:pt>
          <cx:pt idx="5487">H&amp;N</cx:pt>
          <cx:pt idx="5488">H&amp;N</cx:pt>
          <cx:pt idx="5489">H&amp;N</cx:pt>
          <cx:pt idx="5490">H&amp;N</cx:pt>
          <cx:pt idx="5491">H&amp;N</cx:pt>
          <cx:pt idx="5492">H&amp;N</cx:pt>
          <cx:pt idx="5493">H&amp;N</cx:pt>
          <cx:pt idx="5494">H&amp;N</cx:pt>
          <cx:pt idx="5495">H&amp;N</cx:pt>
          <cx:pt idx="5496">H&amp;N</cx:pt>
          <cx:pt idx="5497">H&amp;N</cx:pt>
          <cx:pt idx="5498">H&amp;N</cx:pt>
          <cx:pt idx="5499">H&amp;N</cx:pt>
          <cx:pt idx="5500">H&amp;N</cx:pt>
          <cx:pt idx="5501">H&amp;N</cx:pt>
          <cx:pt idx="5502">H&amp;N</cx:pt>
          <cx:pt idx="5503">H&amp;N</cx:pt>
          <cx:pt idx="5504">H&amp;N</cx:pt>
          <cx:pt idx="5505">H&amp;N</cx:pt>
          <cx:pt idx="5506">H&amp;N</cx:pt>
          <cx:pt idx="5507">H&amp;N</cx:pt>
          <cx:pt idx="5508">H&amp;N</cx:pt>
          <cx:pt idx="5509">H&amp;N</cx:pt>
          <cx:pt idx="5510">H&amp;N</cx:pt>
          <cx:pt idx="5511">H&amp;N</cx:pt>
          <cx:pt idx="5512">H&amp;N</cx:pt>
          <cx:pt idx="5513">H&amp;N</cx:pt>
          <cx:pt idx="5514">H&amp;N</cx:pt>
          <cx:pt idx="5515">H&amp;N</cx:pt>
          <cx:pt idx="5516">H&amp;N</cx:pt>
          <cx:pt idx="5517">H&amp;N</cx:pt>
          <cx:pt idx="5518">H&amp;N</cx:pt>
          <cx:pt idx="5519">H&amp;N</cx:pt>
          <cx:pt idx="5520">H&amp;N</cx:pt>
          <cx:pt idx="5521">H&amp;N</cx:pt>
          <cx:pt idx="5522">H&amp;N</cx:pt>
          <cx:pt idx="5523">H&amp;N</cx:pt>
          <cx:pt idx="5524">H&amp;N</cx:pt>
          <cx:pt idx="5525">H&amp;N</cx:pt>
          <cx:pt idx="5526">H&amp;N</cx:pt>
          <cx:pt idx="5527">H&amp;N</cx:pt>
          <cx:pt idx="5528">H&amp;N</cx:pt>
          <cx:pt idx="5529">H&amp;N</cx:pt>
          <cx:pt idx="5530">H&amp;N</cx:pt>
          <cx:pt idx="5531">H&amp;N</cx:pt>
          <cx:pt idx="5532">H&amp;N</cx:pt>
          <cx:pt idx="5533">H&amp;N</cx:pt>
          <cx:pt idx="5534">H&amp;N</cx:pt>
          <cx:pt idx="5535">H&amp;N</cx:pt>
          <cx:pt idx="5536">H&amp;N</cx:pt>
          <cx:pt idx="5537">H&amp;N</cx:pt>
          <cx:pt idx="5538">H&amp;N</cx:pt>
          <cx:pt idx="5539">H&amp;N</cx:pt>
          <cx:pt idx="5540">H&amp;N</cx:pt>
          <cx:pt idx="5541">H&amp;N</cx:pt>
          <cx:pt idx="5542">H&amp;N</cx:pt>
          <cx:pt idx="5543">H&amp;N</cx:pt>
          <cx:pt idx="5544">H&amp;N</cx:pt>
          <cx:pt idx="5545">H&amp;N</cx:pt>
          <cx:pt idx="5546">H&amp;N</cx:pt>
          <cx:pt idx="5547">H&amp;N</cx:pt>
          <cx:pt idx="5548">H&amp;N</cx:pt>
          <cx:pt idx="5549">H&amp;N</cx:pt>
          <cx:pt idx="5550">H&amp;N</cx:pt>
          <cx:pt idx="5551">H&amp;N</cx:pt>
          <cx:pt idx="5552">H&amp;N</cx:pt>
          <cx:pt idx="5553">H&amp;N</cx:pt>
          <cx:pt idx="5554">H&amp;N</cx:pt>
          <cx:pt idx="5555">H&amp;N</cx:pt>
          <cx:pt idx="5556">H&amp;N</cx:pt>
          <cx:pt idx="5557">H&amp;N</cx:pt>
          <cx:pt idx="5558">H&amp;N</cx:pt>
          <cx:pt idx="5559">H&amp;N</cx:pt>
          <cx:pt idx="5560">H&amp;N</cx:pt>
          <cx:pt idx="5561">H&amp;N</cx:pt>
          <cx:pt idx="5562">H&amp;N</cx:pt>
          <cx:pt idx="5563">H&amp;N</cx:pt>
          <cx:pt idx="5564">H&amp;N</cx:pt>
          <cx:pt idx="5565">H&amp;N</cx:pt>
          <cx:pt idx="5566">H&amp;N</cx:pt>
          <cx:pt idx="5567">H&amp;N</cx:pt>
          <cx:pt idx="5568">H&amp;N</cx:pt>
          <cx:pt idx="5569">H&amp;N</cx:pt>
          <cx:pt idx="5570">H&amp;N</cx:pt>
          <cx:pt idx="5571">H&amp;N</cx:pt>
          <cx:pt idx="5572">H&amp;N</cx:pt>
          <cx:pt idx="5573">H&amp;N</cx:pt>
          <cx:pt idx="5574">H&amp;N</cx:pt>
          <cx:pt idx="5575">H&amp;N</cx:pt>
          <cx:pt idx="5576">H&amp;N</cx:pt>
          <cx:pt idx="5577">H&amp;N</cx:pt>
          <cx:pt idx="5578">H&amp;N</cx:pt>
          <cx:pt idx="5579">H&amp;N</cx:pt>
          <cx:pt idx="5580">H&amp;N</cx:pt>
          <cx:pt idx="5581">H&amp;N</cx:pt>
          <cx:pt idx="5582">H&amp;N</cx:pt>
          <cx:pt idx="5583">H&amp;N</cx:pt>
          <cx:pt idx="5584">H&amp;N</cx:pt>
          <cx:pt idx="5585">H&amp;N</cx:pt>
          <cx:pt idx="5586">H&amp;N</cx:pt>
          <cx:pt idx="5587">H&amp;N</cx:pt>
          <cx:pt idx="5588">H&amp;N</cx:pt>
          <cx:pt idx="5589">H&amp;N</cx:pt>
          <cx:pt idx="5590">H&amp;N</cx:pt>
          <cx:pt idx="5591">H&amp;N</cx:pt>
          <cx:pt idx="5592">H&amp;N</cx:pt>
          <cx:pt idx="5593">H&amp;N</cx:pt>
          <cx:pt idx="5594">H&amp;N</cx:pt>
          <cx:pt idx="5595">H&amp;N</cx:pt>
          <cx:pt idx="5596">H&amp;N</cx:pt>
          <cx:pt idx="5597">H&amp;N</cx:pt>
          <cx:pt idx="5598">H&amp;N</cx:pt>
          <cx:pt idx="5599">H&amp;N</cx:pt>
          <cx:pt idx="5600">H&amp;N</cx:pt>
          <cx:pt idx="5601">H&amp;N</cx:pt>
          <cx:pt idx="5602">H&amp;N</cx:pt>
          <cx:pt idx="5603">H&amp;N</cx:pt>
          <cx:pt idx="5604">H&amp;N</cx:pt>
          <cx:pt idx="5605">H&amp;N</cx:pt>
          <cx:pt idx="5606">H&amp;N</cx:pt>
          <cx:pt idx="5607">H&amp;N</cx:pt>
          <cx:pt idx="5608">H&amp;N</cx:pt>
          <cx:pt idx="5609">H&amp;N</cx:pt>
          <cx:pt idx="5610">H&amp;N</cx:pt>
          <cx:pt idx="5611">H&amp;N</cx:pt>
          <cx:pt idx="5612">H&amp;N</cx:pt>
          <cx:pt idx="5613">H&amp;N</cx:pt>
          <cx:pt idx="5614">H&amp;N</cx:pt>
          <cx:pt idx="5615">H&amp;N</cx:pt>
          <cx:pt idx="5616">H&amp;N</cx:pt>
          <cx:pt idx="5617">H&amp;N</cx:pt>
          <cx:pt idx="5618">H&amp;N</cx:pt>
          <cx:pt idx="5619">H&amp;N</cx:pt>
          <cx:pt idx="5620">H&amp;N</cx:pt>
          <cx:pt idx="5621">H&amp;N</cx:pt>
          <cx:pt idx="5622">H&amp;N</cx:pt>
          <cx:pt idx="5623">H&amp;N</cx:pt>
          <cx:pt idx="5624">H&amp;N</cx:pt>
          <cx:pt idx="5625">H&amp;N</cx:pt>
          <cx:pt idx="5626">H&amp;N</cx:pt>
          <cx:pt idx="5627">H&amp;N</cx:pt>
          <cx:pt idx="5628">H&amp;N</cx:pt>
          <cx:pt idx="5629">H&amp;N</cx:pt>
          <cx:pt idx="5630">H&amp;N</cx:pt>
          <cx:pt idx="5631">H&amp;N</cx:pt>
          <cx:pt idx="5632">H&amp;N</cx:pt>
          <cx:pt idx="5633">H&amp;N</cx:pt>
          <cx:pt idx="5634">H&amp;N</cx:pt>
          <cx:pt idx="5635">H&amp;N</cx:pt>
          <cx:pt idx="5636">H&amp;N</cx:pt>
          <cx:pt idx="5637">H&amp;N</cx:pt>
          <cx:pt idx="5638">H&amp;N</cx:pt>
          <cx:pt idx="5639">H&amp;N</cx:pt>
          <cx:pt idx="5640">H&amp;N</cx:pt>
          <cx:pt idx="5641">H&amp;N</cx:pt>
          <cx:pt idx="5642">H&amp;N</cx:pt>
          <cx:pt idx="5643">H&amp;N</cx:pt>
          <cx:pt idx="5644">H&amp;N</cx:pt>
          <cx:pt idx="5645">H&amp;N</cx:pt>
          <cx:pt idx="5646">H&amp;N</cx:pt>
          <cx:pt idx="5647">H&amp;N</cx:pt>
          <cx:pt idx="5648">H&amp;N</cx:pt>
          <cx:pt idx="5649">H&amp;N</cx:pt>
          <cx:pt idx="5650">H&amp;N</cx:pt>
          <cx:pt idx="5651">H&amp;N</cx:pt>
          <cx:pt idx="5652">H&amp;N</cx:pt>
          <cx:pt idx="5653">H&amp;N</cx:pt>
          <cx:pt idx="5654">H&amp;N</cx:pt>
          <cx:pt idx="5655">H&amp;N</cx:pt>
          <cx:pt idx="5656">H&amp;N</cx:pt>
          <cx:pt idx="5657">H&amp;N</cx:pt>
          <cx:pt idx="5658">H&amp;N</cx:pt>
          <cx:pt idx="5659">H&amp;N</cx:pt>
          <cx:pt idx="5660">H&amp;N</cx:pt>
          <cx:pt idx="5661">H&amp;N</cx:pt>
          <cx:pt idx="5662">H&amp;N</cx:pt>
          <cx:pt idx="5663">H&amp;N</cx:pt>
          <cx:pt idx="5664">H&amp;N</cx:pt>
          <cx:pt idx="5665">H&amp;N</cx:pt>
          <cx:pt idx="5666">H&amp;N</cx:pt>
          <cx:pt idx="5667">H&amp;N</cx:pt>
          <cx:pt idx="5668">H&amp;N</cx:pt>
          <cx:pt idx="5669">H&amp;N</cx:pt>
          <cx:pt idx="5670">H&amp;N</cx:pt>
          <cx:pt idx="5671">H&amp;N</cx:pt>
          <cx:pt idx="5672">H&amp;N</cx:pt>
          <cx:pt idx="5673">H&amp;N</cx:pt>
          <cx:pt idx="5674">H&amp;N</cx:pt>
          <cx:pt idx="5675">H&amp;N</cx:pt>
          <cx:pt idx="5676">H&amp;N</cx:pt>
          <cx:pt idx="5677">H&amp;N</cx:pt>
          <cx:pt idx="5678">H&amp;N</cx:pt>
          <cx:pt idx="5679">H&amp;N</cx:pt>
          <cx:pt idx="5680">H&amp;N</cx:pt>
          <cx:pt idx="5681">H&amp;N</cx:pt>
          <cx:pt idx="5682">H&amp;N</cx:pt>
          <cx:pt idx="5683">H&amp;N</cx:pt>
          <cx:pt idx="5684">H&amp;N</cx:pt>
          <cx:pt idx="5685">H&amp;N</cx:pt>
          <cx:pt idx="5686">H&amp;N</cx:pt>
          <cx:pt idx="5687">H&amp;N</cx:pt>
          <cx:pt idx="5688">H&amp;N</cx:pt>
          <cx:pt idx="5689">H&amp;N</cx:pt>
          <cx:pt idx="5690">H&amp;N</cx:pt>
          <cx:pt idx="5691">H&amp;N</cx:pt>
          <cx:pt idx="5692">H&amp;N</cx:pt>
          <cx:pt idx="5693">H&amp;N</cx:pt>
          <cx:pt idx="5694">H&amp;N</cx:pt>
          <cx:pt idx="5695">H&amp;N</cx:pt>
          <cx:pt idx="5696">H&amp;N</cx:pt>
          <cx:pt idx="5697">H&amp;N</cx:pt>
          <cx:pt idx="5698">H&amp;N</cx:pt>
          <cx:pt idx="5699">H&amp;N</cx:pt>
          <cx:pt idx="5700">H&amp;N</cx:pt>
          <cx:pt idx="5701">H&amp;N</cx:pt>
          <cx:pt idx="5702">H&amp;N</cx:pt>
          <cx:pt idx="5703">H&amp;N</cx:pt>
          <cx:pt idx="5704">H&amp;N</cx:pt>
          <cx:pt idx="5705">H&amp;N</cx:pt>
          <cx:pt idx="5706">H&amp;N</cx:pt>
          <cx:pt idx="5707">H&amp;N</cx:pt>
          <cx:pt idx="5708">H&amp;N</cx:pt>
          <cx:pt idx="5709">H&amp;N</cx:pt>
          <cx:pt idx="5710">H&amp;N</cx:pt>
          <cx:pt idx="5711">H&amp;N</cx:pt>
          <cx:pt idx="5712">H&amp;N</cx:pt>
          <cx:pt idx="5713">H&amp;N</cx:pt>
          <cx:pt idx="5714">H&amp;N</cx:pt>
          <cx:pt idx="5715">H&amp;N</cx:pt>
          <cx:pt idx="5716">H&amp;N</cx:pt>
          <cx:pt idx="5717">H&amp;N</cx:pt>
          <cx:pt idx="5718">H&amp;N</cx:pt>
          <cx:pt idx="5719">H&amp;N</cx:pt>
          <cx:pt idx="5720">H&amp;N</cx:pt>
          <cx:pt idx="5721">H&amp;N</cx:pt>
          <cx:pt idx="5722">H&amp;N</cx:pt>
          <cx:pt idx="5723">H&amp;N</cx:pt>
          <cx:pt idx="5724">H&amp;N</cx:pt>
          <cx:pt idx="5725">H&amp;N</cx:pt>
          <cx:pt idx="5726">H&amp;N</cx:pt>
          <cx:pt idx="5727">H&amp;N</cx:pt>
          <cx:pt idx="5728">H&amp;N</cx:pt>
          <cx:pt idx="5729">H&amp;N</cx:pt>
          <cx:pt idx="5730">H&amp;N</cx:pt>
          <cx:pt idx="5731">H&amp;N</cx:pt>
          <cx:pt idx="5732">H&amp;N</cx:pt>
          <cx:pt idx="5733">H&amp;N</cx:pt>
          <cx:pt idx="5734">H&amp;N</cx:pt>
          <cx:pt idx="5735">H&amp;N</cx:pt>
          <cx:pt idx="5736">H&amp;N</cx:pt>
          <cx:pt idx="5737">H&amp;N</cx:pt>
          <cx:pt idx="5738">H&amp;N</cx:pt>
          <cx:pt idx="5739">H&amp;N</cx:pt>
          <cx:pt idx="5740">H&amp;N</cx:pt>
          <cx:pt idx="5741">H&amp;N</cx:pt>
          <cx:pt idx="5742">H&amp;N</cx:pt>
          <cx:pt idx="5743">H&amp;N</cx:pt>
          <cx:pt idx="5744">H&amp;N</cx:pt>
          <cx:pt idx="5745">H&amp;N</cx:pt>
          <cx:pt idx="5746">H&amp;N</cx:pt>
          <cx:pt idx="5747">H&amp;N</cx:pt>
          <cx:pt idx="5748">H&amp;N</cx:pt>
          <cx:pt idx="5749">H&amp;N</cx:pt>
          <cx:pt idx="5750">H&amp;N</cx:pt>
          <cx:pt idx="5751">H&amp;N</cx:pt>
          <cx:pt idx="5752">H&amp;N</cx:pt>
          <cx:pt idx="5753">H&amp;N</cx:pt>
          <cx:pt idx="5754">H&amp;N</cx:pt>
          <cx:pt idx="5755">H&amp;N</cx:pt>
          <cx:pt idx="5756">H&amp;N</cx:pt>
          <cx:pt idx="5757">H&amp;N</cx:pt>
          <cx:pt idx="5758">H&amp;N</cx:pt>
          <cx:pt idx="5759">H&amp;N</cx:pt>
          <cx:pt idx="5760">H&amp;N</cx:pt>
          <cx:pt idx="5761">H&amp;N</cx:pt>
          <cx:pt idx="5762">H&amp;N</cx:pt>
          <cx:pt idx="5763">H&amp;N</cx:pt>
          <cx:pt idx="5764">H&amp;N</cx:pt>
          <cx:pt idx="5765">H&amp;N</cx:pt>
          <cx:pt idx="5766">H&amp;N</cx:pt>
          <cx:pt idx="5767">H&amp;N</cx:pt>
          <cx:pt idx="5768">H&amp;N</cx:pt>
          <cx:pt idx="5769">H&amp;N</cx:pt>
          <cx:pt idx="5770">H&amp;N</cx:pt>
          <cx:pt idx="5771">H&amp;N</cx:pt>
          <cx:pt idx="5772">H&amp;N</cx:pt>
          <cx:pt idx="5773">H&amp;N</cx:pt>
          <cx:pt idx="5774">H&amp;N</cx:pt>
          <cx:pt idx="5775">H&amp;N</cx:pt>
          <cx:pt idx="5776">H&amp;N</cx:pt>
          <cx:pt idx="5777">H&amp;N</cx:pt>
          <cx:pt idx="5778">H&amp;N</cx:pt>
          <cx:pt idx="5779">H&amp;N</cx:pt>
          <cx:pt idx="5780">H&amp;N</cx:pt>
          <cx:pt idx="5781">H&amp;N</cx:pt>
          <cx:pt idx="5782">H&amp;N</cx:pt>
          <cx:pt idx="5783">H&amp;N</cx:pt>
          <cx:pt idx="5784">H&amp;N</cx:pt>
          <cx:pt idx="5785">H&amp;N</cx:pt>
          <cx:pt idx="5786">H&amp;N</cx:pt>
          <cx:pt idx="5787">H&amp;N</cx:pt>
          <cx:pt idx="5788">H&amp;N</cx:pt>
          <cx:pt idx="5789">H&amp;N</cx:pt>
          <cx:pt idx="5790">H&amp;N</cx:pt>
          <cx:pt idx="5791">H&amp;N</cx:pt>
          <cx:pt idx="5792">H&amp;N</cx:pt>
          <cx:pt idx="5793">H&amp;N</cx:pt>
          <cx:pt idx="5794">H&amp;N</cx:pt>
          <cx:pt idx="5795">H&amp;N</cx:pt>
          <cx:pt idx="5796">H&amp;N</cx:pt>
          <cx:pt idx="5797">H&amp;N</cx:pt>
          <cx:pt idx="5798">H&amp;N</cx:pt>
          <cx:pt idx="5799">H&amp;N</cx:pt>
          <cx:pt idx="5800">H&amp;N</cx:pt>
          <cx:pt idx="5801">H&amp;N</cx:pt>
          <cx:pt idx="5802">H&amp;N</cx:pt>
          <cx:pt idx="5803">H&amp;N</cx:pt>
          <cx:pt idx="5804">H&amp;N</cx:pt>
          <cx:pt idx="5805">H&amp;N</cx:pt>
          <cx:pt idx="5806">H&amp;N</cx:pt>
          <cx:pt idx="5807">H&amp;N</cx:pt>
          <cx:pt idx="5808">H&amp;N</cx:pt>
          <cx:pt idx="5809">H&amp;N</cx:pt>
          <cx:pt idx="5810">H&amp;N</cx:pt>
          <cx:pt idx="5811">H&amp;N</cx:pt>
          <cx:pt idx="5812">H&amp;N</cx:pt>
          <cx:pt idx="5813">H&amp;N</cx:pt>
          <cx:pt idx="5814">H&amp;N</cx:pt>
          <cx:pt idx="5815">H&amp;N</cx:pt>
          <cx:pt idx="5816">H&amp;N</cx:pt>
          <cx:pt idx="5817">H&amp;N</cx:pt>
          <cx:pt idx="5818">H&amp;N</cx:pt>
          <cx:pt idx="5819">H&amp;N</cx:pt>
          <cx:pt idx="5820">H&amp;N</cx:pt>
          <cx:pt idx="5821">H&amp;N</cx:pt>
          <cx:pt idx="5822">H&amp;N</cx:pt>
          <cx:pt idx="5823">H&amp;N</cx:pt>
          <cx:pt idx="5824">H&amp;N</cx:pt>
          <cx:pt idx="5825">H&amp;N</cx:pt>
          <cx:pt idx="5826">H&amp;N</cx:pt>
          <cx:pt idx="5827">H&amp;N</cx:pt>
          <cx:pt idx="5828">H&amp;N</cx:pt>
          <cx:pt idx="5829">H&amp;N</cx:pt>
          <cx:pt idx="5830">H&amp;N</cx:pt>
          <cx:pt idx="5831">H&amp;N</cx:pt>
          <cx:pt idx="5832">H&amp;N</cx:pt>
          <cx:pt idx="5833">H&amp;N</cx:pt>
          <cx:pt idx="5834">H&amp;N</cx:pt>
          <cx:pt idx="5835">H&amp;N</cx:pt>
          <cx:pt idx="5836">H&amp;N</cx:pt>
          <cx:pt idx="5837">H&amp;N</cx:pt>
          <cx:pt idx="5838">H&amp;N</cx:pt>
          <cx:pt idx="5839">H&amp;N</cx:pt>
          <cx:pt idx="5840">H&amp;N</cx:pt>
          <cx:pt idx="5841">H&amp;N</cx:pt>
          <cx:pt idx="5842">H&amp;N</cx:pt>
          <cx:pt idx="5843">H&amp;N</cx:pt>
          <cx:pt idx="5844">H&amp;N</cx:pt>
          <cx:pt idx="5845">H&amp;N</cx:pt>
          <cx:pt idx="5846">H&amp;N</cx:pt>
          <cx:pt idx="5847">H&amp;N</cx:pt>
          <cx:pt idx="5848">H&amp;N</cx:pt>
          <cx:pt idx="5849">H&amp;N</cx:pt>
          <cx:pt idx="5850">H&amp;N</cx:pt>
          <cx:pt idx="5851">H&amp;N</cx:pt>
          <cx:pt idx="5852">H&amp;N</cx:pt>
          <cx:pt idx="5853">H&amp;N</cx:pt>
          <cx:pt idx="5854">H&amp;N</cx:pt>
          <cx:pt idx="5855">H&amp;N</cx:pt>
          <cx:pt idx="5856">H&amp;N</cx:pt>
          <cx:pt idx="5857">H&amp;N</cx:pt>
          <cx:pt idx="5858">H&amp;N</cx:pt>
          <cx:pt idx="5859">H&amp;N</cx:pt>
          <cx:pt idx="5860">H&amp;N</cx:pt>
          <cx:pt idx="5861">H&amp;N</cx:pt>
          <cx:pt idx="5862">H&amp;N</cx:pt>
          <cx:pt idx="5863">H&amp;N</cx:pt>
          <cx:pt idx="5864">H&amp;N</cx:pt>
          <cx:pt idx="5865">H&amp;N</cx:pt>
          <cx:pt idx="5866">H&amp;N</cx:pt>
          <cx:pt idx="5867">H&amp;N</cx:pt>
          <cx:pt idx="5868">H&amp;N</cx:pt>
          <cx:pt idx="5869">H&amp;N</cx:pt>
          <cx:pt idx="5870">H&amp;N</cx:pt>
          <cx:pt idx="5871">H&amp;N</cx:pt>
          <cx:pt idx="5872">H&amp;N</cx:pt>
          <cx:pt idx="5873">H&amp;N</cx:pt>
          <cx:pt idx="5874">H&amp;N</cx:pt>
          <cx:pt idx="5875">H&amp;N</cx:pt>
          <cx:pt idx="5876">H&amp;N</cx:pt>
          <cx:pt idx="5877">H&amp;N</cx:pt>
          <cx:pt idx="5878">H&amp;N</cx:pt>
          <cx:pt idx="5879">H&amp;N</cx:pt>
          <cx:pt idx="5880">H&amp;N</cx:pt>
          <cx:pt idx="5881">H&amp;N</cx:pt>
          <cx:pt idx="5882">H&amp;N</cx:pt>
          <cx:pt idx="5883">H&amp;N</cx:pt>
          <cx:pt idx="5884">H&amp;N</cx:pt>
          <cx:pt idx="5885">H&amp;N</cx:pt>
          <cx:pt idx="5886">H&amp;N</cx:pt>
          <cx:pt idx="5887">H&amp;N</cx:pt>
          <cx:pt idx="5888">H&amp;N</cx:pt>
          <cx:pt idx="5889">H&amp;N</cx:pt>
          <cx:pt idx="5890">H&amp;N</cx:pt>
          <cx:pt idx="5891">H&amp;N</cx:pt>
          <cx:pt idx="5892">H&amp;N</cx:pt>
          <cx:pt idx="5893">H&amp;N</cx:pt>
          <cx:pt idx="5894">H&amp;N</cx:pt>
          <cx:pt idx="5895">H&amp;N</cx:pt>
          <cx:pt idx="5896">H&amp;N</cx:pt>
          <cx:pt idx="5897">H&amp;N</cx:pt>
          <cx:pt idx="5898">H&amp;N</cx:pt>
          <cx:pt idx="5899">H&amp;N</cx:pt>
          <cx:pt idx="5900">H&amp;N</cx:pt>
          <cx:pt idx="5901">H&amp;N</cx:pt>
          <cx:pt idx="5902">H&amp;N</cx:pt>
          <cx:pt idx="5903">H&amp;N</cx:pt>
          <cx:pt idx="5904">H&amp;N</cx:pt>
          <cx:pt idx="5905">H&amp;N</cx:pt>
          <cx:pt idx="5906">H&amp;N</cx:pt>
          <cx:pt idx="5907">H&amp;N</cx:pt>
          <cx:pt idx="5908">H&amp;N</cx:pt>
          <cx:pt idx="5909">H&amp;N</cx:pt>
          <cx:pt idx="5910">H&amp;N</cx:pt>
          <cx:pt idx="5911">H&amp;N</cx:pt>
          <cx:pt idx="5912">H&amp;N</cx:pt>
          <cx:pt idx="5913">H&amp;N</cx:pt>
          <cx:pt idx="5914">H&amp;N</cx:pt>
          <cx:pt idx="5915">H&amp;N</cx:pt>
          <cx:pt idx="5916">H&amp;N</cx:pt>
          <cx:pt idx="5917">H&amp;N</cx:pt>
          <cx:pt idx="5918">H&amp;N</cx:pt>
          <cx:pt idx="5919">H&amp;N</cx:pt>
          <cx:pt idx="5920">H&amp;N</cx:pt>
          <cx:pt idx="5921">H&amp;N</cx:pt>
          <cx:pt idx="5922">H&amp;N</cx:pt>
          <cx:pt idx="5923">H&amp;N</cx:pt>
          <cx:pt idx="5924">H&amp;N</cx:pt>
          <cx:pt idx="5925">H&amp;N</cx:pt>
          <cx:pt idx="5926">H&amp;N</cx:pt>
          <cx:pt idx="5927">H&amp;N</cx:pt>
          <cx:pt idx="5928">H&amp;N</cx:pt>
          <cx:pt idx="5929">H&amp;N</cx:pt>
          <cx:pt idx="5930">H&amp;N</cx:pt>
          <cx:pt idx="5931">H&amp;N</cx:pt>
          <cx:pt idx="5932">H&amp;N</cx:pt>
          <cx:pt idx="5933">H&amp;N</cx:pt>
          <cx:pt idx="5934">H&amp;N</cx:pt>
          <cx:pt idx="5935">H&amp;N</cx:pt>
          <cx:pt idx="5936">H&amp;N</cx:pt>
          <cx:pt idx="5937">H&amp;N</cx:pt>
          <cx:pt idx="5938">H&amp;N</cx:pt>
          <cx:pt idx="5939">H&amp;N</cx:pt>
          <cx:pt idx="5940">H&amp;N</cx:pt>
          <cx:pt idx="5941">H&amp;N</cx:pt>
          <cx:pt idx="5942">Osp</cx:pt>
          <cx:pt idx="5943">Osp</cx:pt>
          <cx:pt idx="5944">Osp</cx:pt>
          <cx:pt idx="5945">Osp</cx:pt>
          <cx:pt idx="5946">Osp</cx:pt>
          <cx:pt idx="5947">Osp</cx:pt>
          <cx:pt idx="5948">Osp</cx:pt>
          <cx:pt idx="5949">Osp</cx:pt>
          <cx:pt idx="5950">Osp</cx:pt>
          <cx:pt idx="5951">Osp</cx:pt>
          <cx:pt idx="5952">Osp</cx:pt>
          <cx:pt idx="5953">Osp</cx:pt>
          <cx:pt idx="5954">Osp</cx:pt>
          <cx:pt idx="5955">Osp</cx:pt>
          <cx:pt idx="5956">Osp</cx:pt>
          <cx:pt idx="5957">Osp</cx:pt>
          <cx:pt idx="5958">Osp</cx:pt>
          <cx:pt idx="5959">Osp</cx:pt>
          <cx:pt idx="5960">Osp</cx:pt>
          <cx:pt idx="5961">Osp</cx:pt>
          <cx:pt idx="5962">Osp</cx:pt>
          <cx:pt idx="5963">Osp</cx:pt>
          <cx:pt idx="5964">Osp</cx:pt>
          <cx:pt idx="5965">Osp</cx:pt>
          <cx:pt idx="5966">Osp</cx:pt>
          <cx:pt idx="5967">Osp</cx:pt>
          <cx:pt idx="5968">Osp</cx:pt>
          <cx:pt idx="5969">Osp</cx:pt>
          <cx:pt idx="5970">Osp</cx:pt>
          <cx:pt idx="5971">Osp</cx:pt>
          <cx:pt idx="5972">Osp</cx:pt>
          <cx:pt idx="5973">Osp</cx:pt>
          <cx:pt idx="5974">Osp</cx:pt>
          <cx:pt idx="5975">Osp</cx:pt>
          <cx:pt idx="5976">Osp</cx:pt>
          <cx:pt idx="5977">Osp</cx:pt>
          <cx:pt idx="5978">Osp</cx:pt>
          <cx:pt idx="5979">Osp</cx:pt>
          <cx:pt idx="5980">Osp</cx:pt>
          <cx:pt idx="5981">Osp</cx:pt>
          <cx:pt idx="5982">Osp</cx:pt>
          <cx:pt idx="5983">Osp</cx:pt>
          <cx:pt idx="5984">Osp</cx:pt>
          <cx:pt idx="5985">Osp</cx:pt>
          <cx:pt idx="5986">Osp</cx:pt>
          <cx:pt idx="5987">Osp</cx:pt>
          <cx:pt idx="5988">Osp</cx:pt>
          <cx:pt idx="5989">Osp</cx:pt>
          <cx:pt idx="5990">Osp</cx:pt>
          <cx:pt idx="5991">Osp</cx:pt>
          <cx:pt idx="5992">Osp</cx:pt>
          <cx:pt idx="5993">Osp</cx:pt>
          <cx:pt idx="5994">Osp</cx:pt>
          <cx:pt idx="5995">Osp</cx:pt>
          <cx:pt idx="5996">Osp</cx:pt>
          <cx:pt idx="5997">Osp</cx:pt>
          <cx:pt idx="5998">Osp</cx:pt>
          <cx:pt idx="5999">Osp</cx:pt>
          <cx:pt idx="6000">Osp</cx:pt>
          <cx:pt idx="6001">Osp</cx:pt>
          <cx:pt idx="6002">Osp</cx:pt>
          <cx:pt idx="6003">Osp</cx:pt>
          <cx:pt idx="6004">Osp</cx:pt>
          <cx:pt idx="6005">Osp</cx:pt>
          <cx:pt idx="6006">Osp</cx:pt>
          <cx:pt idx="6007">Osp</cx:pt>
          <cx:pt idx="6008">Osp</cx:pt>
          <cx:pt idx="6009">Osp</cx:pt>
          <cx:pt idx="6010">Osp</cx:pt>
          <cx:pt idx="6011">Osp</cx:pt>
          <cx:pt idx="6012">Osp</cx:pt>
          <cx:pt idx="6013">Osp</cx:pt>
          <cx:pt idx="6014">Osp</cx:pt>
          <cx:pt idx="6015">Osp</cx:pt>
          <cx:pt idx="6016">Osp</cx:pt>
          <cx:pt idx="6017">Osp</cx:pt>
          <cx:pt idx="6018">Osp</cx:pt>
          <cx:pt idx="6019">Osp</cx:pt>
          <cx:pt idx="6020">Osp</cx:pt>
          <cx:pt idx="6021">Osp</cx:pt>
          <cx:pt idx="6022">Osp</cx:pt>
          <cx:pt idx="6023">Osp</cx:pt>
          <cx:pt idx="6024">Osp</cx:pt>
          <cx:pt idx="6025">Osp</cx:pt>
          <cx:pt idx="6026">Osp</cx:pt>
          <cx:pt idx="6027">Osp</cx:pt>
          <cx:pt idx="6028">Osp</cx:pt>
          <cx:pt idx="6029">Osp</cx:pt>
          <cx:pt idx="6030">Osp</cx:pt>
          <cx:pt idx="6031">Osp</cx:pt>
          <cx:pt idx="6032">Osp</cx:pt>
          <cx:pt idx="6033">Osp</cx:pt>
          <cx:pt idx="6034">Osp</cx:pt>
          <cx:pt idx="6035">Osp</cx:pt>
          <cx:pt idx="6036">Osp</cx:pt>
          <cx:pt idx="6037">Osp</cx:pt>
          <cx:pt idx="6038">Osp</cx:pt>
          <cx:pt idx="6039">Osp</cx:pt>
          <cx:pt idx="6040">Osp</cx:pt>
          <cx:pt idx="6041">Osp</cx:pt>
          <cx:pt idx="6042">Osp</cx:pt>
          <cx:pt idx="6043">Osp</cx:pt>
          <cx:pt idx="6044">Osp</cx:pt>
          <cx:pt idx="6045">Osp</cx:pt>
          <cx:pt idx="6046">Osp</cx:pt>
          <cx:pt idx="6047">Osp</cx:pt>
          <cx:pt idx="6048">Osp</cx:pt>
          <cx:pt idx="6049">Osp</cx:pt>
          <cx:pt idx="6050">Osp</cx:pt>
          <cx:pt idx="6051">Osp</cx:pt>
          <cx:pt idx="6052">Osp</cx:pt>
          <cx:pt idx="6053">Osp</cx:pt>
          <cx:pt idx="6054">Osp</cx:pt>
          <cx:pt idx="6055">Osp</cx:pt>
          <cx:pt idx="6056">Osp</cx:pt>
          <cx:pt idx="6057">Osp</cx:pt>
          <cx:pt idx="6058">Osp</cx:pt>
          <cx:pt idx="6059">Osp</cx:pt>
          <cx:pt idx="6060">Osp</cx:pt>
          <cx:pt idx="6061">Osp</cx:pt>
          <cx:pt idx="6062">Osp</cx:pt>
          <cx:pt idx="6063">Osp</cx:pt>
          <cx:pt idx="6064">Osp</cx:pt>
          <cx:pt idx="6065">Osp</cx:pt>
          <cx:pt idx="6066">Osp</cx:pt>
          <cx:pt idx="6067">Osp</cx:pt>
          <cx:pt idx="6068">Osp</cx:pt>
          <cx:pt idx="6069">Osp</cx:pt>
          <cx:pt idx="6070">Osp</cx:pt>
          <cx:pt idx="6071">Osp</cx:pt>
          <cx:pt idx="6072">Osp</cx:pt>
          <cx:pt idx="6073">Osp</cx:pt>
          <cx:pt idx="6074">Osp</cx:pt>
          <cx:pt idx="6075">Osp</cx:pt>
          <cx:pt idx="6076">Osp</cx:pt>
          <cx:pt idx="6077">Osp</cx:pt>
          <cx:pt idx="6078">Osp</cx:pt>
          <cx:pt idx="6079">Osp</cx:pt>
          <cx:pt idx="6080">Osp</cx:pt>
          <cx:pt idx="6081">Osp</cx:pt>
          <cx:pt idx="6082">Osp</cx:pt>
          <cx:pt idx="6083">Osp</cx:pt>
          <cx:pt idx="6084">Osp</cx:pt>
          <cx:pt idx="6085">Bld</cx:pt>
          <cx:pt idx="6086">Bld</cx:pt>
          <cx:pt idx="6087">Bld</cx:pt>
          <cx:pt idx="6088">Bld</cx:pt>
          <cx:pt idx="6089">Bld</cx:pt>
          <cx:pt idx="6090">Bld</cx:pt>
          <cx:pt idx="6091">Bld</cx:pt>
          <cx:pt idx="6092">Bld</cx:pt>
          <cx:pt idx="6093">Bld</cx:pt>
          <cx:pt idx="6094">Bld</cx:pt>
          <cx:pt idx="6095">Bld</cx:pt>
          <cx:pt idx="6096">Bld</cx:pt>
          <cx:pt idx="6097">Bld</cx:pt>
          <cx:pt idx="6098">Bld</cx:pt>
          <cx:pt idx="6099">Bld</cx:pt>
          <cx:pt idx="6100">Bld</cx:pt>
          <cx:pt idx="6101">Bld</cx:pt>
          <cx:pt idx="6102">Bld</cx:pt>
          <cx:pt idx="6103">Bld</cx:pt>
          <cx:pt idx="6104">Bld</cx:pt>
          <cx:pt idx="6105">Bld</cx:pt>
          <cx:pt idx="6106">Bld</cx:pt>
          <cx:pt idx="6107">Bld</cx:pt>
          <cx:pt idx="6108">Bld</cx:pt>
          <cx:pt idx="6109">Bld</cx:pt>
          <cx:pt idx="6110">Bld</cx:pt>
          <cx:pt idx="6111">Bld</cx:pt>
          <cx:pt idx="6112">Bld</cx:pt>
          <cx:pt idx="6113">Bld</cx:pt>
          <cx:pt idx="6114">Bld</cx:pt>
          <cx:pt idx="6115">Bld</cx:pt>
          <cx:pt idx="6116">Bld</cx:pt>
          <cx:pt idx="6117">Brn</cx:pt>
          <cx:pt idx="6118">Brn</cx:pt>
          <cx:pt idx="6119">Brn</cx:pt>
          <cx:pt idx="6120">Brn</cx:pt>
          <cx:pt idx="6121">Brn</cx:pt>
          <cx:pt idx="6122">Brn</cx:pt>
          <cx:pt idx="6123">Brn</cx:pt>
          <cx:pt idx="6124">Brn</cx:pt>
          <cx:pt idx="6125">Brn</cx:pt>
          <cx:pt idx="6126">Brn</cx:pt>
          <cx:pt idx="6127">Brn</cx:pt>
          <cx:pt idx="6128">Brn</cx:pt>
          <cx:pt idx="6129">Brn</cx:pt>
          <cx:pt idx="6130">Brn</cx:pt>
          <cx:pt idx="6131">Brn</cx:pt>
          <cx:pt idx="6132">Brn</cx:pt>
          <cx:pt idx="6133">Brn</cx:pt>
          <cx:pt idx="6134">Brn</cx:pt>
          <cx:pt idx="6135">Brn</cx:pt>
          <cx:pt idx="6136">Brn</cx:pt>
          <cx:pt idx="6137">Brn</cx:pt>
          <cx:pt idx="6138">Brn</cx:pt>
          <cx:pt idx="6139">Brn</cx:pt>
          <cx:pt idx="6140">Brn</cx:pt>
          <cx:pt idx="6141">Brn</cx:pt>
          <cx:pt idx="6142">Brn</cx:pt>
          <cx:pt idx="6143">Brn</cx:pt>
          <cx:pt idx="6144">Brn</cx:pt>
          <cx:pt idx="6145">Brn</cx:pt>
          <cx:pt idx="6146">Brn</cx:pt>
          <cx:pt idx="6147">Brn</cx:pt>
          <cx:pt idx="6148">Brn</cx:pt>
          <cx:pt idx="6149">Brn</cx:pt>
          <cx:pt idx="6150">Brn</cx:pt>
          <cx:pt idx="6151">Brn</cx:pt>
          <cx:pt idx="6152">Brn</cx:pt>
          <cx:pt idx="6153">Brn</cx:pt>
          <cx:pt idx="6154">Brn</cx:pt>
          <cx:pt idx="6155">Brn</cx:pt>
          <cx:pt idx="6156">Brn</cx:pt>
          <cx:pt idx="6157">Brn</cx:pt>
          <cx:pt idx="6158">Brn</cx:pt>
          <cx:pt idx="6159">MMy</cx:pt>
          <cx:pt idx="6160">MMy</cx:pt>
          <cx:pt idx="6161">MMy</cx:pt>
          <cx:pt idx="6162">MMy</cx:pt>
          <cx:pt idx="6163">MMy</cx:pt>
          <cx:pt idx="6164">MMy</cx:pt>
          <cx:pt idx="6165">MMy</cx:pt>
          <cx:pt idx="6166">MMy</cx:pt>
          <cx:pt idx="6167">MMy</cx:pt>
          <cx:pt idx="6168">MMy</cx:pt>
          <cx:pt idx="6169">MMy</cx:pt>
          <cx:pt idx="6170">MMy</cx:pt>
          <cx:pt idx="6171">MMy</cx:pt>
          <cx:pt idx="6172">MMy</cx:pt>
          <cx:pt idx="6173">MMy</cx:pt>
          <cx:pt idx="6174">MMy</cx:pt>
          <cx:pt idx="6175">MMy</cx:pt>
          <cx:pt idx="6176">MMy</cx:pt>
          <cx:pt idx="6177">GB</cx:pt>
          <cx:pt idx="6178">GB</cx:pt>
          <cx:pt idx="6179">GB</cx:pt>
          <cx:pt idx="6180">GB</cx:pt>
          <cx:pt idx="6181">GB</cx:pt>
          <cx:pt idx="6182">GB</cx:pt>
          <cx:pt idx="6183">GB</cx:pt>
          <cx:pt idx="6184">GB</cx:pt>
          <cx:pt idx="6185">GB</cx:pt>
          <cx:pt idx="6186">GB</cx:pt>
          <cx:pt idx="6187">GB</cx:pt>
          <cx:pt idx="6188">GB</cx:pt>
          <cx:pt idx="6189">GB</cx:pt>
          <cx:pt idx="6190">GB</cx:pt>
          <cx:pt idx="6191">GB</cx:pt>
          <cx:pt idx="6192">GB</cx:pt>
          <cx:pt idx="6193">GB</cx:pt>
          <cx:pt idx="6194">GB</cx:pt>
          <cx:pt idx="6195">GB</cx:pt>
          <cx:pt idx="6196">GB</cx:pt>
          <cx:pt idx="6197">GB</cx:pt>
          <cx:pt idx="6198">GB</cx:pt>
          <cx:pt idx="6199">GB</cx:pt>
          <cx:pt idx="6200">GB</cx:pt>
          <cx:pt idx="6201">GB</cx:pt>
          <cx:pt idx="6202">GB</cx:pt>
          <cx:pt idx="6203">GB</cx:pt>
          <cx:pt idx="6204">GB</cx:pt>
          <cx:pt idx="6205">GB</cx:pt>
          <cx:pt idx="6206">GB</cx:pt>
          <cx:pt idx="6207">GB</cx:pt>
          <cx:pt idx="6208">GB</cx:pt>
          <cx:pt idx="6209">GB</cx:pt>
          <cx:pt idx="6210">GB</cx:pt>
          <cx:pt idx="6211">GB</cx:pt>
          <cx:pt idx="6212">Sarc</cx:pt>
          <cx:pt idx="6213">Sarc</cx:pt>
          <cx:pt idx="6214">Sarc</cx:pt>
          <cx:pt idx="6215">Sarc</cx:pt>
          <cx:pt idx="6216">Sarc</cx:pt>
          <cx:pt idx="6217">Sarc</cx:pt>
          <cx:pt idx="6218">Sarc</cx:pt>
          <cx:pt idx="6219">Sarc</cx:pt>
          <cx:pt idx="6220">Sarc</cx:pt>
          <cx:pt idx="6221">Sarc</cx:pt>
          <cx:pt idx="6222">Sarc</cx:pt>
          <cx:pt idx="6223">Sarc</cx:pt>
          <cx:pt idx="6224">Sarc</cx:pt>
          <cx:pt idx="6225">Sarc</cx:pt>
          <cx:pt idx="6226">Sarc</cx:pt>
          <cx:pt idx="6227">Sarc</cx:pt>
          <cx:pt idx="6228">Sarc</cx:pt>
          <cx:pt idx="6229">Sarc</cx:pt>
          <cx:pt idx="6230">Sarc</cx:pt>
          <cx:pt idx="6231">Sarc</cx:pt>
          <cx:pt idx="6232">Sarc</cx:pt>
          <cx:pt idx="6233">Sarc</cx:pt>
          <cx:pt idx="6234">Sarc</cx:pt>
          <cx:pt idx="6235">Sarc</cx:pt>
          <cx:pt idx="6236">Sarc</cx:pt>
          <cx:pt idx="6237">Sarc</cx:pt>
          <cx:pt idx="6238">Sarc</cx:pt>
          <cx:pt idx="6239">Sarc</cx:pt>
          <cx:pt idx="6240">Sarc</cx:pt>
          <cx:pt idx="6241">Sarc</cx:pt>
          <cx:pt idx="6242">Sarc</cx:pt>
          <cx:pt idx="6243">Sarc</cx:pt>
          <cx:pt idx="6244">Sarc</cx:pt>
          <cx:pt idx="6245">Sarc</cx:pt>
          <cx:pt idx="6246">Sarc</cx:pt>
          <cx:pt idx="6247">Sarc</cx:pt>
          <cx:pt idx="6248">Sarc</cx:pt>
          <cx:pt idx="6249">Sarc</cx:pt>
          <cx:pt idx="6250">Sarc</cx:pt>
          <cx:pt idx="6251">Sarc</cx:pt>
          <cx:pt idx="6252">Sarc</cx:pt>
          <cx:pt idx="6253">Sarc</cx:pt>
          <cx:pt idx="6254">Sarc</cx:pt>
          <cx:pt idx="6255">Sarc</cx:pt>
          <cx:pt idx="6256">Sarc</cx:pt>
          <cx:pt idx="6257">Prost</cx:pt>
          <cx:pt idx="6258">Prost</cx:pt>
          <cx:pt idx="6259">Prost</cx:pt>
          <cx:pt idx="6260">Prost</cx:pt>
          <cx:pt idx="6261">Prost</cx:pt>
          <cx:pt idx="6262">Prost</cx:pt>
          <cx:pt idx="6263">Prost</cx:pt>
          <cx:pt idx="6264">Prost</cx:pt>
          <cx:pt idx="6265">Prost</cx:pt>
          <cx:pt idx="6266">Prost</cx:pt>
          <cx:pt idx="6267">Prost</cx:pt>
          <cx:pt idx="6268">Prost</cx:pt>
          <cx:pt idx="6269">Prost</cx:pt>
          <cx:pt idx="6270">Prost</cx:pt>
          <cx:pt idx="6271">Prost</cx:pt>
          <cx:pt idx="6272">Prost</cx:pt>
          <cx:pt idx="6273">Prost</cx:pt>
          <cx:pt idx="6274">Prost</cx:pt>
          <cx:pt idx="6275">Prost</cx:pt>
          <cx:pt idx="6276">Prost</cx:pt>
          <cx:pt idx="6277">Prost</cx:pt>
          <cx:pt idx="6278">Prost</cx:pt>
          <cx:pt idx="6279">Prost</cx:pt>
          <cx:pt idx="6280">Prost</cx:pt>
          <cx:pt idx="6281">Prost</cx:pt>
          <cx:pt idx="6282">Prost</cx:pt>
          <cx:pt idx="6283">Prost</cx:pt>
          <cx:pt idx="6284">Prost</cx:pt>
          <cx:pt idx="6285">Prost</cx:pt>
          <cx:pt idx="6286">Prost</cx:pt>
          <cx:pt idx="6287">Prost</cx:pt>
          <cx:pt idx="6288">Prost</cx:pt>
          <cx:pt idx="6289">Prost</cx:pt>
          <cx:pt idx="6290">Prost</cx:pt>
          <cx:pt idx="6291">Prost</cx:pt>
          <cx:pt idx="6292">Prost</cx:pt>
          <cx:pt idx="6293">Prost</cx:pt>
          <cx:pt idx="6294">Prost</cx:pt>
          <cx:pt idx="6295">Prost</cx:pt>
          <cx:pt idx="6296">Prost</cx:pt>
          <cx:pt idx="6297">Prost</cx:pt>
          <cx:pt idx="6298">Prost</cx:pt>
          <cx:pt idx="6299">Prost</cx:pt>
          <cx:pt idx="6300">Prost</cx:pt>
          <cx:pt idx="6301">Prost</cx:pt>
          <cx:pt idx="6302">Prost</cx:pt>
          <cx:pt idx="6303">Prost</cx:pt>
          <cx:pt idx="6304">Prost</cx:pt>
          <cx:pt idx="6305">Prost</cx:pt>
          <cx:pt idx="6306">Prost</cx:pt>
          <cx:pt idx="6307">Prost</cx:pt>
          <cx:pt idx="6308">Prost</cx:pt>
          <cx:pt idx="6309">Prost</cx:pt>
          <cx:pt idx="6310">Prost</cx:pt>
          <cx:pt idx="6311">Prost</cx:pt>
          <cx:pt idx="6312">Prost</cx:pt>
          <cx:pt idx="6313">Prost</cx:pt>
          <cx:pt idx="6314">Prost</cx:pt>
          <cx:pt idx="6315">Prost</cx:pt>
          <cx:pt idx="6316">Prost</cx:pt>
          <cx:pt idx="6317">Prost</cx:pt>
          <cx:pt idx="6318">Prost</cx:pt>
          <cx:pt idx="6319">Prost</cx:pt>
          <cx:pt idx="6320">Prost</cx:pt>
          <cx:pt idx="6321">Prost</cx:pt>
          <cx:pt idx="6322">Prost</cx:pt>
          <cx:pt idx="6323">Prost</cx:pt>
          <cx:pt idx="6324">Prost</cx:pt>
          <cx:pt idx="6325">Prost</cx:pt>
          <cx:pt idx="6326">Prost</cx:pt>
          <cx:pt idx="6327">Prost</cx:pt>
          <cx:pt idx="6328">Prost</cx:pt>
          <cx:pt idx="6329">Prost</cx:pt>
          <cx:pt idx="6330">Prost</cx:pt>
          <cx:pt idx="6331">Prost</cx:pt>
          <cx:pt idx="6332">Prost</cx:pt>
          <cx:pt idx="6333">Prost</cx:pt>
          <cx:pt idx="6334">Prost</cx:pt>
          <cx:pt idx="6335">Prost</cx:pt>
          <cx:pt idx="6336">Prost</cx:pt>
          <cx:pt idx="6337">Prost</cx:pt>
          <cx:pt idx="6338">Prost</cx:pt>
          <cx:pt idx="6339">Prost</cx:pt>
          <cx:pt idx="6340">Prost</cx:pt>
          <cx:pt idx="6341">Prost</cx:pt>
          <cx:pt idx="6342">Prost</cx:pt>
          <cx:pt idx="6343">Prost</cx:pt>
          <cx:pt idx="6344">Prost</cx:pt>
          <cx:pt idx="6345">Prost</cx:pt>
          <cx:pt idx="6346">Prost</cx:pt>
          <cx:pt idx="6347">Prost</cx:pt>
          <cx:pt idx="6348">Prost</cx:pt>
          <cx:pt idx="6349">Prost</cx:pt>
          <cx:pt idx="6350">Prost</cx:pt>
          <cx:pt idx="6351">Prost</cx:pt>
          <cx:pt idx="6352">Prost</cx:pt>
          <cx:pt idx="6353">Prost</cx:pt>
          <cx:pt idx="6354">Prost</cx:pt>
          <cx:pt idx="6355">Prost</cx:pt>
          <cx:pt idx="6356">Prost</cx:pt>
          <cx:pt idx="6357">Prost</cx:pt>
          <cx:pt idx="6358">Prost</cx:pt>
          <cx:pt idx="6359">Prost</cx:pt>
          <cx:pt idx="6360">Prost</cx:pt>
          <cx:pt idx="6361">Prost</cx:pt>
          <cx:pt idx="6362">Prost</cx:pt>
          <cx:pt idx="6363">Prost</cx:pt>
          <cx:pt idx="6364">Prost</cx:pt>
          <cx:pt idx="6365">Prost</cx:pt>
          <cx:pt idx="6366">Prost</cx:pt>
          <cx:pt idx="6367">Prost</cx:pt>
          <cx:pt idx="6368">Prost</cx:pt>
          <cx:pt idx="6369">Prost</cx:pt>
          <cx:pt idx="6370">Prost</cx:pt>
          <cx:pt idx="6371">Prost</cx:pt>
          <cx:pt idx="6372">Prost</cx:pt>
          <cx:pt idx="6373">Prost</cx:pt>
          <cx:pt idx="6374">Prost</cx:pt>
          <cx:pt idx="6375">Prost</cx:pt>
          <cx:pt idx="6376">Prost</cx:pt>
          <cx:pt idx="6377">Prost</cx:pt>
          <cx:pt idx="6378">Prost</cx:pt>
          <cx:pt idx="6379">Tstr</cx:pt>
          <cx:pt idx="6380">Tstr</cx:pt>
          <cx:pt idx="6381">Tstr</cx:pt>
          <cx:pt idx="6382">Tstr</cx:pt>
          <cx:pt idx="6383">Vulval</cx:pt>
          <cx:pt idx="6384">Vulval</cx:pt>
          <cx:pt idx="6385">Vulval</cx:pt>
          <cx:pt idx="6386">Vulval</cx:pt>
          <cx:pt idx="6387">Vulval</cx:pt>
          <cx:pt idx="6388">Anal</cx:pt>
          <cx:pt idx="6389">Anal</cx:pt>
          <cx:pt idx="6390">Anal</cx:pt>
          <cx:pt idx="6391">Anal</cx:pt>
          <cx:pt idx="6392">Anal</cx:pt>
          <cx:pt idx="6393">Anal</cx:pt>
          <cx:pt idx="6394">Anal</cx:pt>
          <cx:pt idx="6395">Anal</cx:pt>
          <cx:pt idx="6396">Anal</cx:pt>
          <cx:pt idx="6397">Vgnl</cx:pt>
          <cx:pt idx="6398">Vgnl</cx:pt>
          <cx:pt idx="6399">Penile</cx:pt>
          <cx:pt idx="6400">Penile</cx:pt>
          <cx:pt idx="6401">Penile</cx:pt>
          <cx:pt idx="6402">Penile</cx:pt>
          <cx:pt idx="6403">Penile</cx:pt>
          <cx:pt idx="6404">Penile</cx:pt>
          <cx:pt idx="6405">Penile</cx:pt>
          <cx:pt idx="6406">Penile</cx:pt>
          <cx:pt idx="6407">Penile</cx:pt>
          <cx:pt idx="6408">Penile</cx:pt>
          <cx:pt idx="6409">Penile</cx:pt>
          <cx:pt idx="6410">Penile</cx:pt>
          <cx:pt idx="6411">Penile</cx:pt>
          <cx:pt idx="6412">Penile</cx:pt>
          <cx:pt idx="6413">Penile</cx:pt>
          <cx:pt idx="6414">Penile</cx:pt>
          <cx:pt idx="6415">Penile</cx:pt>
          <cx:pt idx="6416">Penile</cx:pt>
          <cx:pt idx="6417">Unk.Pr</cx:pt>
          <cx:pt idx="6418">Unk.Pr</cx:pt>
          <cx:pt idx="6419">Unk.Pr</cx:pt>
          <cx:pt idx="6420">Unk.Pr</cx:pt>
          <cx:pt idx="6421">Unk.Pr</cx:pt>
          <cx:pt idx="6422">Unk.Pr</cx:pt>
          <cx:pt idx="6423">GCT</cx:pt>
          <cx:pt idx="6424">GCT</cx:pt>
          <cx:pt idx="6425">GCT</cx:pt>
          <cx:pt idx="6426">GCT</cx:pt>
          <cx:pt idx="6427">GCT</cx:pt>
          <cx:pt idx="6428">GCT</cx:pt>
          <cx:pt idx="6429">GCT</cx:pt>
          <cx:pt idx="6430">GCT</cx:pt>
          <cx:pt idx="6431">GCT</cx:pt>
          <cx:pt idx="6432">GCT</cx:pt>
          <cx:pt idx="6433">GCT</cx:pt>
          <cx:pt idx="6434">GCT</cx:pt>
          <cx:pt idx="6435">GCT</cx:pt>
          <cx:pt idx="6436">GCT</cx:pt>
          <cx:pt idx="6437">SCC</cx:pt>
          <cx:pt idx="6438">SCC</cx:pt>
          <cx:pt idx="6439">SCC</cx:pt>
          <cx:pt idx="6440">SCC</cx:pt>
          <cx:pt idx="6441">SCC</cx:pt>
          <cx:pt idx="6442">SCC</cx:pt>
          <cx:pt idx="6443">SCC</cx:pt>
          <cx:pt idx="6444">SCC</cx:pt>
        </cx:lvl>
      </cx:strDim>
      <cx:numDim type="val">
        <cx:f>Sheet1!$C$2:$C$6446</cx:f>
        <cx:lvl ptCount="6445" formatCode="General">
          <cx:pt idx="0">2485</cx:pt>
          <cx:pt idx="1">2509</cx:pt>
          <cx:pt idx="2">2571</cx:pt>
          <cx:pt idx="3">2400</cx:pt>
          <cx:pt idx="4">2634</cx:pt>
          <cx:pt idx="5">2527</cx:pt>
          <cx:pt idx="6">2513</cx:pt>
          <cx:pt idx="7">2660</cx:pt>
          <cx:pt idx="8">3085</cx:pt>
          <cx:pt idx="9">3301</cx:pt>
          <cx:pt idx="10">3212</cx:pt>
          <cx:pt idx="11">3393</cx:pt>
          <cx:pt idx="12">3048</cx:pt>
          <cx:pt idx="13">3311</cx:pt>
          <cx:pt idx="14">3085</cx:pt>
          <cx:pt idx="15">3346</cx:pt>
          <cx:pt idx="16">3013</cx:pt>
          <cx:pt idx="17">2684</cx:pt>
          <cx:pt idx="18">3037</cx:pt>
          <cx:pt idx="19">3589</cx:pt>
          <cx:pt idx="20">3058</cx:pt>
          <cx:pt idx="21">3474</cx:pt>
          <cx:pt idx="22">2855</cx:pt>
          <cx:pt idx="23">3191</cx:pt>
          <cx:pt idx="24">3554</cx:pt>
          <cx:pt idx="25">3453</cx:pt>
          <cx:pt idx="26">3423</cx:pt>
          <cx:pt idx="27">3159</cx:pt>
          <cx:pt idx="28">3123</cx:pt>
          <cx:pt idx="29">3072</cx:pt>
          <cx:pt idx="30">3271</cx:pt>
          <cx:pt idx="31">2961</cx:pt>
          <cx:pt idx="32">3003</cx:pt>
          <cx:pt idx="33">2719</cx:pt>
          <cx:pt idx="34">2980</cx:pt>
          <cx:pt idx="35">2638</cx:pt>
          <cx:pt idx="36">3279</cx:pt>
          <cx:pt idx="37">3407</cx:pt>
          <cx:pt idx="38">2939</cx:pt>
          <cx:pt idx="39">3258</cx:pt>
          <cx:pt idx="40">3242</cx:pt>
          <cx:pt idx="41">2904</cx:pt>
          <cx:pt idx="42">3092</cx:pt>
          <cx:pt idx="43">2743</cx:pt>
          <cx:pt idx="44">3333</cx:pt>
          <cx:pt idx="45">2791</cx:pt>
          <cx:pt idx="46">2782</cx:pt>
          <cx:pt idx="47">3148</cx:pt>
          <cx:pt idx="48">3064</cx:pt>
          <cx:pt idx="49">2943</cx:pt>
          <cx:pt idx="50">3719</cx:pt>
          <cx:pt idx="51">3158</cx:pt>
          <cx:pt idx="52">3207</cx:pt>
          <cx:pt idx="53">3015</cx:pt>
          <cx:pt idx="54">2900</cx:pt>
          <cx:pt idx="55">2796</cx:pt>
          <cx:pt idx="56">2926</cx:pt>
          <cx:pt idx="57">3096</cx:pt>
          <cx:pt idx="58">3297</cx:pt>
          <cx:pt idx="59">3159</cx:pt>
          <cx:pt idx="60">3347</cx:pt>
          <cx:pt idx="61">2984</cx:pt>
          <cx:pt idx="62">3503</cx:pt>
          <cx:pt idx="63">3266</cx:pt>
          <cx:pt idx="64">3536</cx:pt>
          <cx:pt idx="65">2991</cx:pt>
          <cx:pt idx="66">3202</cx:pt>
          <cx:pt idx="67">3285</cx:pt>
          <cx:pt idx="68">2968</cx:pt>
          <cx:pt idx="69">3240</cx:pt>
          <cx:pt idx="70">3012</cx:pt>
          <cx:pt idx="71">3244</cx:pt>
          <cx:pt idx="72">3440</cx:pt>
          <cx:pt idx="73">3495</cx:pt>
          <cx:pt idx="74">3421</cx:pt>
          <cx:pt idx="75">3274</cx:pt>
          <cx:pt idx="76">3075</cx:pt>
          <cx:pt idx="77">3127</cx:pt>
          <cx:pt idx="78">3471</cx:pt>
          <cx:pt idx="79">2915</cx:pt>
          <cx:pt idx="80">3260</cx:pt>
          <cx:pt idx="81">2975</cx:pt>
          <cx:pt idx="82">3423</cx:pt>
          <cx:pt idx="83">3199</cx:pt>
          <cx:pt idx="84">3410</cx:pt>
          <cx:pt idx="85">3308</cx:pt>
          <cx:pt idx="86">3198</cx:pt>
          <cx:pt idx="87">2861</cx:pt>
          <cx:pt idx="88">3322</cx:pt>
          <cx:pt idx="89">2947</cx:pt>
          <cx:pt idx="90">3157</cx:pt>
          <cx:pt idx="91">3073</cx:pt>
          <cx:pt idx="92">3516</cx:pt>
          <cx:pt idx="93">3510</cx:pt>
          <cx:pt idx="94">3287</cx:pt>
          <cx:pt idx="95">2843</cx:pt>
          <cx:pt idx="96">3035</cx:pt>
          <cx:pt idx="97">3170</cx:pt>
          <cx:pt idx="98">3195</cx:pt>
          <cx:pt idx="99">3268</cx:pt>
          <cx:pt idx="100">3433</cx:pt>
          <cx:pt idx="101">3081</cx:pt>
          <cx:pt idx="102">3156</cx:pt>
          <cx:pt idx="103">3138</cx:pt>
          <cx:pt idx="104">3186</cx:pt>
          <cx:pt idx="105">3395</cx:pt>
          <cx:pt idx="106">3063</cx:pt>
          <cx:pt idx="107">3392</cx:pt>
          <cx:pt idx="108">2859</cx:pt>
          <cx:pt idx="109">3033</cx:pt>
          <cx:pt idx="110">2861</cx:pt>
          <cx:pt idx="111">2877</cx:pt>
          <cx:pt idx="112">3231</cx:pt>
          <cx:pt idx="113">3093</cx:pt>
          <cx:pt idx="114">3151</cx:pt>
          <cx:pt idx="115">2895</cx:pt>
          <cx:pt idx="116">3122</cx:pt>
          <cx:pt idx="117">3283</cx:pt>
          <cx:pt idx="118">3168</cx:pt>
          <cx:pt idx="119">3100</cx:pt>
          <cx:pt idx="120">3062</cx:pt>
          <cx:pt idx="121">3296</cx:pt>
          <cx:pt idx="122">2777</cx:pt>
          <cx:pt idx="123">2897</cx:pt>
          <cx:pt idx="124">2968</cx:pt>
          <cx:pt idx="125">3162</cx:pt>
          <cx:pt idx="126">3378</cx:pt>
          <cx:pt idx="127">2860</cx:pt>
          <cx:pt idx="128">2975</cx:pt>
          <cx:pt idx="129">2802</cx:pt>
          <cx:pt idx="130">3462</cx:pt>
          <cx:pt idx="131">3122</cx:pt>
          <cx:pt idx="132">3212</cx:pt>
          <cx:pt idx="133">3134</cx:pt>
          <cx:pt idx="134">3264</cx:pt>
          <cx:pt idx="135">3544</cx:pt>
          <cx:pt idx="136">3318</cx:pt>
          <cx:pt idx="137">3246</cx:pt>
          <cx:pt idx="138">3007</cx:pt>
          <cx:pt idx="139">3295</cx:pt>
          <cx:pt idx="140">3140</cx:pt>
          <cx:pt idx="141">2959</cx:pt>
          <cx:pt idx="142">3340</cx:pt>
          <cx:pt idx="143">3032</cx:pt>
          <cx:pt idx="144">3566</cx:pt>
          <cx:pt idx="145">3128</cx:pt>
          <cx:pt idx="146">3018</cx:pt>
          <cx:pt idx="147">3007</cx:pt>
          <cx:pt idx="148">3376</cx:pt>
          <cx:pt idx="149">3171</cx:pt>
          <cx:pt idx="150">2660</cx:pt>
          <cx:pt idx="151">2701</cx:pt>
          <cx:pt idx="152">3008</cx:pt>
          <cx:pt idx="153">3306</cx:pt>
          <cx:pt idx="154">2835</cx:pt>
          <cx:pt idx="155">3293</cx:pt>
          <cx:pt idx="156">2900</cx:pt>
          <cx:pt idx="157">3098</cx:pt>
          <cx:pt idx="158">2976</cx:pt>
          <cx:pt idx="159">2970</cx:pt>
          <cx:pt idx="160">2751</cx:pt>
          <cx:pt idx="161">2913</cx:pt>
          <cx:pt idx="162">2683</cx:pt>
          <cx:pt idx="163">3331</cx:pt>
          <cx:pt idx="164">2612</cx:pt>
          <cx:pt idx="165">3028</cx:pt>
          <cx:pt idx="166">3060</cx:pt>
          <cx:pt idx="167">3150</cx:pt>
          <cx:pt idx="168">2547</cx:pt>
          <cx:pt idx="169">2873</cx:pt>
          <cx:pt idx="170">3120</cx:pt>
          <cx:pt idx="171">2872</cx:pt>
          <cx:pt idx="172">3104</cx:pt>
          <cx:pt idx="173">2921</cx:pt>
          <cx:pt idx="174">3314</cx:pt>
          <cx:pt idx="175">2771</cx:pt>
          <cx:pt idx="176">3029</cx:pt>
          <cx:pt idx="177">2855</cx:pt>
          <cx:pt idx="178">2759</cx:pt>
          <cx:pt idx="179">2804</cx:pt>
          <cx:pt idx="180">3161</cx:pt>
          <cx:pt idx="181">3116</cx:pt>
          <cx:pt idx="182">2922</cx:pt>
          <cx:pt idx="183">3113</cx:pt>
          <cx:pt idx="184">2516</cx:pt>
          <cx:pt idx="185">2651</cx:pt>
          <cx:pt idx="186">2380</cx:pt>
          <cx:pt idx="187">2574</cx:pt>
          <cx:pt idx="188">3320</cx:pt>
          <cx:pt idx="189">3203</cx:pt>
          <cx:pt idx="190">3046</cx:pt>
          <cx:pt idx="191">2959</cx:pt>
          <cx:pt idx="192">3126</cx:pt>
          <cx:pt idx="193">2797</cx:pt>
          <cx:pt idx="194">2807</cx:pt>
          <cx:pt idx="195">2411</cx:pt>
          <cx:pt idx="196">2547</cx:pt>
          <cx:pt idx="197">2480</cx:pt>
          <cx:pt idx="198">2720</cx:pt>
          <cx:pt idx="199">2922</cx:pt>
          <cx:pt idx="200">2806</cx:pt>
          <cx:pt idx="201">2810</cx:pt>
          <cx:pt idx="202">2873</cx:pt>
          <cx:pt idx="203">2773</cx:pt>
          <cx:pt idx="204">2658</cx:pt>
          <cx:pt idx="205">2899</cx:pt>
          <cx:pt idx="206">2626</cx:pt>
          <cx:pt idx="207">2623</cx:pt>
          <cx:pt idx="208">2737</cx:pt>
          <cx:pt idx="209">2775</cx:pt>
          <cx:pt idx="210">2660</cx:pt>
          <cx:pt idx="211">2623</cx:pt>
          <cx:pt idx="212">2687</cx:pt>
          <cx:pt idx="213">2827</cx:pt>
          <cx:pt idx="214">2588</cx:pt>
          <cx:pt idx="215">3067</cx:pt>
          <cx:pt idx="216">2513</cx:pt>
          <cx:pt idx="217">2535</cx:pt>
          <cx:pt idx="218">2577</cx:pt>
          <cx:pt idx="219">2678</cx:pt>
          <cx:pt idx="220">2714</cx:pt>
          <cx:pt idx="221">3039</cx:pt>
          <cx:pt idx="222">2897</cx:pt>
          <cx:pt idx="223">3037</cx:pt>
          <cx:pt idx="224">3146</cx:pt>
          <cx:pt idx="225">3290</cx:pt>
          <cx:pt idx="226">2941</cx:pt>
          <cx:pt idx="227">2704</cx:pt>
          <cx:pt idx="228">3223</cx:pt>
          <cx:pt idx="229">3067</cx:pt>
          <cx:pt idx="230">2586</cx:pt>
          <cx:pt idx="231">3007</cx:pt>
          <cx:pt idx="232">2677</cx:pt>
          <cx:pt idx="233">2844</cx:pt>
          <cx:pt idx="234">2896</cx:pt>
          <cx:pt idx="235">2728</cx:pt>
          <cx:pt idx="236">2699</cx:pt>
          <cx:pt idx="237">3102</cx:pt>
          <cx:pt idx="238">2986</cx:pt>
          <cx:pt idx="239">2658</cx:pt>
          <cx:pt idx="240">2808</cx:pt>
          <cx:pt idx="241">2924</cx:pt>
          <cx:pt idx="242">3014</cx:pt>
          <cx:pt idx="243">2737</cx:pt>
          <cx:pt idx="244">2804</cx:pt>
          <cx:pt idx="245">3158</cx:pt>
          <cx:pt idx="246">3068</cx:pt>
          <cx:pt idx="247">2659</cx:pt>
          <cx:pt idx="248">2719</cx:pt>
          <cx:pt idx="249">2919</cx:pt>
          <cx:pt idx="250">3064</cx:pt>
          <cx:pt idx="251">3139</cx:pt>
          <cx:pt idx="252">2632</cx:pt>
          <cx:pt idx="253">2873</cx:pt>
          <cx:pt idx="254">3126</cx:pt>
          <cx:pt idx="255">3024</cx:pt>
          <cx:pt idx="256">2680</cx:pt>
          <cx:pt idx="257">2877</cx:pt>
          <cx:pt idx="258">3291</cx:pt>
          <cx:pt idx="259">3164</cx:pt>
          <cx:pt idx="260">3047</cx:pt>
          <cx:pt idx="261">2838</cx:pt>
          <cx:pt idx="262">2727</cx:pt>
          <cx:pt idx="263">3042</cx:pt>
          <cx:pt idx="264">3311</cx:pt>
          <cx:pt idx="265">3091</cx:pt>
          <cx:pt idx="266">3025</cx:pt>
          <cx:pt idx="267">3126</cx:pt>
          <cx:pt idx="268">2560</cx:pt>
          <cx:pt idx="269">2465</cx:pt>
          <cx:pt idx="270">2571</cx:pt>
          <cx:pt idx="271">2827</cx:pt>
          <cx:pt idx="272">2907</cx:pt>
          <cx:pt idx="273">3035</cx:pt>
          <cx:pt idx="274">2709</cx:pt>
          <cx:pt idx="275">3041</cx:pt>
          <cx:pt idx="276">2996</cx:pt>
          <cx:pt idx="277">3186</cx:pt>
          <cx:pt idx="278">2778</cx:pt>
          <cx:pt idx="279">2816</cx:pt>
          <cx:pt idx="280">3050</cx:pt>
          <cx:pt idx="281">2937</cx:pt>
          <cx:pt idx="282">2487</cx:pt>
          <cx:pt idx="283">2995</cx:pt>
          <cx:pt idx="284">2701</cx:pt>
          <cx:pt idx="285">2825</cx:pt>
          <cx:pt idx="286">2899</cx:pt>
          <cx:pt idx="287">2413</cx:pt>
          <cx:pt idx="288">2814</cx:pt>
          <cx:pt idx="289">2873</cx:pt>
          <cx:pt idx="290">3113</cx:pt>
          <cx:pt idx="291">2768</cx:pt>
          <cx:pt idx="292">2596</cx:pt>
          <cx:pt idx="293">2862</cx:pt>
          <cx:pt idx="294">3026</cx:pt>
          <cx:pt idx="295">3235</cx:pt>
          <cx:pt idx="296">3088</cx:pt>
          <cx:pt idx="297">2668</cx:pt>
          <cx:pt idx="298">2896</cx:pt>
          <cx:pt idx="299">2864</cx:pt>
          <cx:pt idx="300">3217</cx:pt>
          <cx:pt idx="301">3266</cx:pt>
          <cx:pt idx="302">3204</cx:pt>
          <cx:pt idx="303">2700</cx:pt>
          <cx:pt idx="304">2765</cx:pt>
          <cx:pt idx="305">3007</cx:pt>
          <cx:pt idx="306">2939</cx:pt>
          <cx:pt idx="307">3020</cx:pt>
          <cx:pt idx="308">3128</cx:pt>
          <cx:pt idx="309">3012</cx:pt>
          <cx:pt idx="310">2677</cx:pt>
          <cx:pt idx="311">2453</cx:pt>
          <cx:pt idx="312">3329</cx:pt>
          <cx:pt idx="313">2861</cx:pt>
          <cx:pt idx="314">3096</cx:pt>
          <cx:pt idx="315">2840</cx:pt>
          <cx:pt idx="316">2789</cx:pt>
          <cx:pt idx="317">2713</cx:pt>
          <cx:pt idx="318">3048</cx:pt>
          <cx:pt idx="319">2894</cx:pt>
          <cx:pt idx="320">2817</cx:pt>
          <cx:pt idx="321">3172</cx:pt>
          <cx:pt idx="322">2997</cx:pt>
          <cx:pt idx="323">2970</cx:pt>
          <cx:pt idx="324">2831</cx:pt>
          <cx:pt idx="325">3006</cx:pt>
          <cx:pt idx="326">3238</cx:pt>
          <cx:pt idx="327">2596</cx:pt>
          <cx:pt idx="328">2685</cx:pt>
          <cx:pt idx="329">2744</cx:pt>
          <cx:pt idx="330">3240</cx:pt>
          <cx:pt idx="331">2679</cx:pt>
          <cx:pt idx="332">2571</cx:pt>
          <cx:pt idx="333">3189</cx:pt>
          <cx:pt idx="334">3468</cx:pt>
          <cx:pt idx="335">3100</cx:pt>
          <cx:pt idx="336">3047</cx:pt>
          <cx:pt idx="337">2923</cx:pt>
          <cx:pt idx="338">2778</cx:pt>
          <cx:pt idx="339">2827</cx:pt>
          <cx:pt idx="340">2966</cx:pt>
          <cx:pt idx="341">3546</cx:pt>
          <cx:pt idx="342">3029</cx:pt>
          <cx:pt idx="343">2990</cx:pt>
          <cx:pt idx="344">2874</cx:pt>
          <cx:pt idx="345">2934</cx:pt>
          <cx:pt idx="346">2809</cx:pt>
          <cx:pt idx="347">2993</cx:pt>
          <cx:pt idx="348">3254</cx:pt>
          <cx:pt idx="349">3103</cx:pt>
          <cx:pt idx="350">3022</cx:pt>
          <cx:pt idx="351">3101</cx:pt>
          <cx:pt idx="352">2933</cx:pt>
          <cx:pt idx="353">3289</cx:pt>
          <cx:pt idx="354">2838</cx:pt>
          <cx:pt idx="355">3194</cx:pt>
          <cx:pt idx="356">3040</cx:pt>
          <cx:pt idx="357">2822</cx:pt>
          <cx:pt idx="358">3228</cx:pt>
          <cx:pt idx="359">2772</cx:pt>
          <cx:pt idx="360">2952</cx:pt>
          <cx:pt idx="361">2723</cx:pt>
          <cx:pt idx="362">2855</cx:pt>
          <cx:pt idx="363">3214</cx:pt>
          <cx:pt idx="364">3009</cx:pt>
          <cx:pt idx="365">3226</cx:pt>
          <cx:pt idx="366">3132</cx:pt>
          <cx:pt idx="367">3429</cx:pt>
          <cx:pt idx="368">2711</cx:pt>
          <cx:pt idx="369">3334</cx:pt>
          <cx:pt idx="370">3248</cx:pt>
          <cx:pt idx="371">3053</cx:pt>
          <cx:pt idx="372">3310</cx:pt>
          <cx:pt idx="373">2985</cx:pt>
          <cx:pt idx="374">3167</cx:pt>
          <cx:pt idx="375">2893</cx:pt>
          <cx:pt idx="376">3351</cx:pt>
          <cx:pt idx="377">3496</cx:pt>
          <cx:pt idx="378">3081</cx:pt>
          <cx:pt idx="379">3322</cx:pt>
          <cx:pt idx="380">2956</cx:pt>
          <cx:pt idx="381">3298</cx:pt>
          <cx:pt idx="382">3127</cx:pt>
          <cx:pt idx="383">2914</cx:pt>
          <cx:pt idx="384">2964</cx:pt>
          <cx:pt idx="385">3196</cx:pt>
          <cx:pt idx="386">2913</cx:pt>
          <cx:pt idx="387">3127</cx:pt>
          <cx:pt idx="388">3326</cx:pt>
          <cx:pt idx="389">3338</cx:pt>
          <cx:pt idx="390">2791</cx:pt>
          <cx:pt idx="391">2761</cx:pt>
          <cx:pt idx="392">2946</cx:pt>
          <cx:pt idx="393">2957</cx:pt>
          <cx:pt idx="394">2953</cx:pt>
          <cx:pt idx="395">2868</cx:pt>
          <cx:pt idx="396">3019</cx:pt>
          <cx:pt idx="397">2988</cx:pt>
          <cx:pt idx="398">2845</cx:pt>
          <cx:pt idx="399">2786</cx:pt>
          <cx:pt idx="400">2902</cx:pt>
          <cx:pt idx="401">2693</cx:pt>
          <cx:pt idx="402">3229</cx:pt>
          <cx:pt idx="403">3219</cx:pt>
          <cx:pt idx="404">3301</cx:pt>
          <cx:pt idx="405">3030</cx:pt>
          <cx:pt idx="406">3324</cx:pt>
          <cx:pt idx="407">3190</cx:pt>
          <cx:pt idx="408">3156</cx:pt>
          <cx:pt idx="409">3148</cx:pt>
          <cx:pt idx="410">3392</cx:pt>
          <cx:pt idx="411">2919</cx:pt>
          <cx:pt idx="412">3392</cx:pt>
          <cx:pt idx="413">3244</cx:pt>
          <cx:pt idx="414">3034</cx:pt>
          <cx:pt idx="415">3128</cx:pt>
          <cx:pt idx="416">3172</cx:pt>
          <cx:pt idx="417">2854</cx:pt>
          <cx:pt idx="418">3195</cx:pt>
          <cx:pt idx="419">3198</cx:pt>
          <cx:pt idx="420">2920</cx:pt>
          <cx:pt idx="421">2930</cx:pt>
          <cx:pt idx="422">2964</cx:pt>
          <cx:pt idx="423">3302</cx:pt>
          <cx:pt idx="424">3193</cx:pt>
          <cx:pt idx="425">3380</cx:pt>
          <cx:pt idx="426">2759</cx:pt>
          <cx:pt idx="427">2770</cx:pt>
          <cx:pt idx="428">3242</cx:pt>
          <cx:pt idx="429">3035</cx:pt>
          <cx:pt idx="430">2977</cx:pt>
          <cx:pt idx="431">3338</cx:pt>
          <cx:pt idx="432">1992</cx:pt>
          <cx:pt idx="433">3237</cx:pt>
          <cx:pt idx="434">2782</cx:pt>
          <cx:pt idx="435">3178</cx:pt>
          <cx:pt idx="436">3199</cx:pt>
          <cx:pt idx="437">3185</cx:pt>
          <cx:pt idx="438">3417</cx:pt>
          <cx:pt idx="439">3055</cx:pt>
          <cx:pt idx="440">3230</cx:pt>
          <cx:pt idx="441">2740</cx:pt>
          <cx:pt idx="442">3056</cx:pt>
          <cx:pt idx="443">3125</cx:pt>
          <cx:pt idx="444">3198</cx:pt>
          <cx:pt idx="445">3228</cx:pt>
          <cx:pt idx="446">3246</cx:pt>
          <cx:pt idx="447">3167</cx:pt>
          <cx:pt idx="448">3181</cx:pt>
          <cx:pt idx="449">3162</cx:pt>
          <cx:pt idx="450">3262</cx:pt>
          <cx:pt idx="451">3369</cx:pt>
          <cx:pt idx="452">3098</cx:pt>
          <cx:pt idx="453">3151</cx:pt>
          <cx:pt idx="454">3020</cx:pt>
          <cx:pt idx="455">3212</cx:pt>
          <cx:pt idx="456">3240</cx:pt>
          <cx:pt idx="457">3358</cx:pt>
          <cx:pt idx="458">3034</cx:pt>
          <cx:pt idx="459">2979</cx:pt>
          <cx:pt idx="460">3457</cx:pt>
          <cx:pt idx="461">3217</cx:pt>
          <cx:pt idx="462">3287</cx:pt>
          <cx:pt idx="463">2967</cx:pt>
          <cx:pt idx="464">3151</cx:pt>
          <cx:pt idx="465">2673</cx:pt>
          <cx:pt idx="466">3197</cx:pt>
          <cx:pt idx="467">3154</cx:pt>
          <cx:pt idx="468">2953</cx:pt>
          <cx:pt idx="469">3188</cx:pt>
          <cx:pt idx="470">2805</cx:pt>
          <cx:pt idx="471">3304</cx:pt>
          <cx:pt idx="472">2878</cx:pt>
          <cx:pt idx="473">3021</cx:pt>
          <cx:pt idx="474">2676</cx:pt>
          <cx:pt idx="475">2741</cx:pt>
          <cx:pt idx="476">3038</cx:pt>
          <cx:pt idx="477">3118</cx:pt>
          <cx:pt idx="478">2749</cx:pt>
          <cx:pt idx="479">3219</cx:pt>
          <cx:pt idx="480">2889</cx:pt>
          <cx:pt idx="481">2696</cx:pt>
          <cx:pt idx="482">3012</cx:pt>
          <cx:pt idx="483">2742</cx:pt>
          <cx:pt idx="484">2945</cx:pt>
          <cx:pt idx="485">2900</cx:pt>
          <cx:pt idx="486">2700</cx:pt>
          <cx:pt idx="487">2719</cx:pt>
          <cx:pt idx="488">2576</cx:pt>
          <cx:pt idx="489">2710</cx:pt>
          <cx:pt idx="490">2694</cx:pt>
          <cx:pt idx="491">2783</cx:pt>
          <cx:pt idx="492">2606</cx:pt>
          <cx:pt idx="493">2864</cx:pt>
          <cx:pt idx="494">3082</cx:pt>
          <cx:pt idx="495">3422</cx:pt>
          <cx:pt idx="496">2770</cx:pt>
          <cx:pt idx="497">2716</cx:pt>
          <cx:pt idx="498">2527</cx:pt>
          <cx:pt idx="499">2685</cx:pt>
          <cx:pt idx="500">3042</cx:pt>
          <cx:pt idx="501">3038</cx:pt>
          <cx:pt idx="502">2501</cx:pt>
          <cx:pt idx="503">2755</cx:pt>
          <cx:pt idx="504">2697</cx:pt>
          <cx:pt idx="505">3182</cx:pt>
          <cx:pt idx="506">2724</cx:pt>
          <cx:pt idx="507">2934</cx:pt>
          <cx:pt idx="508">2514</cx:pt>
          <cx:pt idx="509">2992</cx:pt>
          <cx:pt idx="510">3191</cx:pt>
          <cx:pt idx="511">3202</cx:pt>
          <cx:pt idx="512">3031</cx:pt>
          <cx:pt idx="513">2905</cx:pt>
          <cx:pt idx="514">3057</cx:pt>
          <cx:pt idx="515">2909</cx:pt>
          <cx:pt idx="516">3001</cx:pt>
          <cx:pt idx="517">2874</cx:pt>
          <cx:pt idx="518">3148</cx:pt>
          <cx:pt idx="519">3000</cx:pt>
          <cx:pt idx="520">3320</cx:pt>
          <cx:pt idx="521">2731</cx:pt>
          <cx:pt idx="522">3212</cx:pt>
          <cx:pt idx="523">3115</cx:pt>
          <cx:pt idx="524">3101</cx:pt>
          <cx:pt idx="525">3211</cx:pt>
          <cx:pt idx="526">3462</cx:pt>
          <cx:pt idx="527">3183</cx:pt>
          <cx:pt idx="528">3183</cx:pt>
          <cx:pt idx="529">2962</cx:pt>
          <cx:pt idx="530">2755</cx:pt>
          <cx:pt idx="531">3015</cx:pt>
          <cx:pt idx="532">2575</cx:pt>
          <cx:pt idx="533">3194</cx:pt>
          <cx:pt idx="534">3411</cx:pt>
          <cx:pt idx="535">3098</cx:pt>
          <cx:pt idx="536">2979</cx:pt>
          <cx:pt idx="537">2722</cx:pt>
          <cx:pt idx="538">2748</cx:pt>
          <cx:pt idx="539">3209</cx:pt>
          <cx:pt idx="540">3142</cx:pt>
          <cx:pt idx="541">2599</cx:pt>
          <cx:pt idx="542">3127</cx:pt>
          <cx:pt idx="543">2832</cx:pt>
          <cx:pt idx="544">2752</cx:pt>
          <cx:pt idx="545">3022</cx:pt>
          <cx:pt idx="546">2714</cx:pt>
          <cx:pt idx="547">2751</cx:pt>
          <cx:pt idx="548">2481</cx:pt>
          <cx:pt idx="549">3013</cx:pt>
          <cx:pt idx="550">3235</cx:pt>
          <cx:pt idx="551">2996</cx:pt>
          <cx:pt idx="552">2923</cx:pt>
          <cx:pt idx="553">2757</cx:pt>
          <cx:pt idx="554">2415</cx:pt>
          <cx:pt idx="555">2887</cx:pt>
          <cx:pt idx="556">3024</cx:pt>
          <cx:pt idx="557">2835</cx:pt>
          <cx:pt idx="558">2854</cx:pt>
          <cx:pt idx="559">2900</cx:pt>
          <cx:pt idx="560">2403</cx:pt>
          <cx:pt idx="561">2777</cx:pt>
          <cx:pt idx="562">2626</cx:pt>
          <cx:pt idx="563">2872</cx:pt>
          <cx:pt idx="564">2635</cx:pt>
          <cx:pt idx="565">2618</cx:pt>
          <cx:pt idx="566">3006</cx:pt>
          <cx:pt idx="567">2712</cx:pt>
          <cx:pt idx="568">2705</cx:pt>
          <cx:pt idx="569">2523</cx:pt>
          <cx:pt idx="570">2707</cx:pt>
          <cx:pt idx="571">2924</cx:pt>
          <cx:pt idx="572">2819</cx:pt>
          <cx:pt idx="573">2935</cx:pt>
          <cx:pt idx="574">3111</cx:pt>
          <cx:pt idx="575">2770</cx:pt>
          <cx:pt idx="576">2970</cx:pt>
          <cx:pt idx="577">2678</cx:pt>
          <cx:pt idx="578">2974</cx:pt>
          <cx:pt idx="579">2929</cx:pt>
          <cx:pt idx="580">2724</cx:pt>
          <cx:pt idx="581">2295</cx:pt>
          <cx:pt idx="582">2995</cx:pt>
          <cx:pt idx="583">2685</cx:pt>
          <cx:pt idx="584">2889</cx:pt>
          <cx:pt idx="585">2810</cx:pt>
          <cx:pt idx="586">2855</cx:pt>
          <cx:pt idx="587">2509</cx:pt>
          <cx:pt idx="588">2560</cx:pt>
          <cx:pt idx="589">2851</cx:pt>
          <cx:pt idx="590">2787</cx:pt>
          <cx:pt idx="591">2523</cx:pt>
          <cx:pt idx="592">2620</cx:pt>
          <cx:pt idx="593">2428</cx:pt>
          <cx:pt idx="594">3064</cx:pt>
          <cx:pt idx="595">2785</cx:pt>
          <cx:pt idx="596">2693</cx:pt>
          <cx:pt idx="597">2642</cx:pt>
          <cx:pt idx="598">2297</cx:pt>
          <cx:pt idx="599">2708</cx:pt>
          <cx:pt idx="600">2697</cx:pt>
          <cx:pt idx="601">2616</cx:pt>
          <cx:pt idx="602">2610</cx:pt>
          <cx:pt idx="603">2624</cx:pt>
          <cx:pt idx="604">2784</cx:pt>
          <cx:pt idx="605">2724</cx:pt>
          <cx:pt idx="606">2599</cx:pt>
          <cx:pt idx="607">2645</cx:pt>
          <cx:pt idx="608">2610</cx:pt>
          <cx:pt idx="609">3018</cx:pt>
          <cx:pt idx="610">2562</cx:pt>
          <cx:pt idx="611">2680</cx:pt>
          <cx:pt idx="612">2562</cx:pt>
          <cx:pt idx="613">3140</cx:pt>
          <cx:pt idx="614">2640</cx:pt>
          <cx:pt idx="615">2842</cx:pt>
          <cx:pt idx="616">2721</cx:pt>
          <cx:pt idx="617">2892</cx:pt>
          <cx:pt idx="618">3065</cx:pt>
          <cx:pt idx="619">3308</cx:pt>
          <cx:pt idx="620">3318</cx:pt>
          <cx:pt idx="621">2740</cx:pt>
          <cx:pt idx="622">3078</cx:pt>
          <cx:pt idx="623">3497</cx:pt>
          <cx:pt idx="624">2838</cx:pt>
          <cx:pt idx="625">2735</cx:pt>
          <cx:pt idx="626">3013</cx:pt>
          <cx:pt idx="627">3571</cx:pt>
          <cx:pt idx="628">2915</cx:pt>
          <cx:pt idx="629">3453</cx:pt>
          <cx:pt idx="630">3596</cx:pt>
          <cx:pt idx="631">3344</cx:pt>
          <cx:pt idx="632">3020</cx:pt>
          <cx:pt idx="633">3307</cx:pt>
          <cx:pt idx="634">3527</cx:pt>
          <cx:pt idx="635">2997</cx:pt>
          <cx:pt idx="636">3507</cx:pt>
          <cx:pt idx="637">2949</cx:pt>
          <cx:pt idx="638">2783</cx:pt>
          <cx:pt idx="639">3036</cx:pt>
          <cx:pt idx="640">3268</cx:pt>
          <cx:pt idx="641">3288</cx:pt>
          <cx:pt idx="642">3117</cx:pt>
          <cx:pt idx="643">3152</cx:pt>
          <cx:pt idx="644">3096</cx:pt>
          <cx:pt idx="645">3127</cx:pt>
          <cx:pt idx="646">3470</cx:pt>
          <cx:pt idx="647">2977</cx:pt>
          <cx:pt idx="648">3066</cx:pt>
          <cx:pt idx="649">2871</cx:pt>
          <cx:pt idx="650">3047</cx:pt>
          <cx:pt idx="651">2849</cx:pt>
          <cx:pt idx="652">3175</cx:pt>
          <cx:pt idx="653">3088</cx:pt>
          <cx:pt idx="654">3170</cx:pt>
          <cx:pt idx="655">3236</cx:pt>
          <cx:pt idx="656">3098</cx:pt>
          <cx:pt idx="657">3121</cx:pt>
          <cx:pt idx="658">3252</cx:pt>
          <cx:pt idx="659">3020</cx:pt>
          <cx:pt idx="660">3390</cx:pt>
          <cx:pt idx="661">2969</cx:pt>
          <cx:pt idx="662">2999</cx:pt>
          <cx:pt idx="663">3126</cx:pt>
          <cx:pt idx="664">3210</cx:pt>
          <cx:pt idx="665">3133</cx:pt>
          <cx:pt idx="666">3127</cx:pt>
          <cx:pt idx="667">3212</cx:pt>
          <cx:pt idx="668">3324</cx:pt>
          <cx:pt idx="669">3133</cx:pt>
          <cx:pt idx="670">3439</cx:pt>
          <cx:pt idx="671">3138</cx:pt>
          <cx:pt idx="672">2796</cx:pt>
          <cx:pt idx="673">3065</cx:pt>
          <cx:pt idx="674">3428</cx:pt>
          <cx:pt idx="675">3310</cx:pt>
          <cx:pt idx="676">2975</cx:pt>
          <cx:pt idx="677">3139</cx:pt>
          <cx:pt idx="678">3268</cx:pt>
          <cx:pt idx="679">3303</cx:pt>
          <cx:pt idx="680">3258</cx:pt>
          <cx:pt idx="681">3455</cx:pt>
          <cx:pt idx="682">3376</cx:pt>
          <cx:pt idx="683">3357</cx:pt>
          <cx:pt idx="684">2876</cx:pt>
          <cx:pt idx="685">3319</cx:pt>
          <cx:pt idx="686">3574</cx:pt>
          <cx:pt idx="687">3434</cx:pt>
          <cx:pt idx="688">3637</cx:pt>
          <cx:pt idx="689">3631</cx:pt>
          <cx:pt idx="690">3416</cx:pt>
          <cx:pt idx="691">3156</cx:pt>
          <cx:pt idx="692">3351</cx:pt>
          <cx:pt idx="693">3140</cx:pt>
          <cx:pt idx="694">3359</cx:pt>
          <cx:pt idx="695">2929</cx:pt>
          <cx:pt idx="696">2935</cx:pt>
          <cx:pt idx="697">3276</cx:pt>
          <cx:pt idx="698">3398</cx:pt>
          <cx:pt idx="699">3244</cx:pt>
          <cx:pt idx="700">3467</cx:pt>
          <cx:pt idx="701">3272</cx:pt>
          <cx:pt idx="702">3283</cx:pt>
          <cx:pt idx="703">3050</cx:pt>
          <cx:pt idx="704">3228</cx:pt>
          <cx:pt idx="705">3045</cx:pt>
          <cx:pt idx="706">2803</cx:pt>
          <cx:pt idx="707">3249</cx:pt>
          <cx:pt idx="708">3167</cx:pt>
          <cx:pt idx="709">3334</cx:pt>
          <cx:pt idx="710">3167</cx:pt>
          <cx:pt idx="711">2860</cx:pt>
          <cx:pt idx="712">3032</cx:pt>
          <cx:pt idx="713">3080</cx:pt>
          <cx:pt idx="714">3193</cx:pt>
          <cx:pt idx="715">3559</cx:pt>
          <cx:pt idx="716">3056</cx:pt>
          <cx:pt idx="717">2776</cx:pt>
          <cx:pt idx="718">3001</cx:pt>
          <cx:pt idx="719">3182</cx:pt>
          <cx:pt idx="720">3111</cx:pt>
          <cx:pt idx="721">3468</cx:pt>
          <cx:pt idx="722">3152</cx:pt>
          <cx:pt idx="723">2851</cx:pt>
          <cx:pt idx="724">2876</cx:pt>
          <cx:pt idx="725">3377</cx:pt>
          <cx:pt idx="726">3294</cx:pt>
          <cx:pt idx="727">3467</cx:pt>
          <cx:pt idx="728">3048</cx:pt>
          <cx:pt idx="729">2920</cx:pt>
          <cx:pt idx="730">3381</cx:pt>
          <cx:pt idx="731">3373</cx:pt>
          <cx:pt idx="732">3184</cx:pt>
          <cx:pt idx="733">3089</cx:pt>
          <cx:pt idx="734">3325</cx:pt>
          <cx:pt idx="735">2892</cx:pt>
          <cx:pt idx="736">3010</cx:pt>
          <cx:pt idx="737">2991</cx:pt>
          <cx:pt idx="738">2987</cx:pt>
          <cx:pt idx="739">3038</cx:pt>
          <cx:pt idx="740">3362</cx:pt>
          <cx:pt idx="741">3251</cx:pt>
          <cx:pt idx="742">3017</cx:pt>
          <cx:pt idx="743">3251</cx:pt>
          <cx:pt idx="744">2908</cx:pt>
          <cx:pt idx="745">2843</cx:pt>
          <cx:pt idx="746">3363</cx:pt>
          <cx:pt idx="747">3177</cx:pt>
          <cx:pt idx="748">3203</cx:pt>
          <cx:pt idx="749">3263</cx:pt>
          <cx:pt idx="750">3461</cx:pt>
          <cx:pt idx="751">3202</cx:pt>
          <cx:pt idx="752">3631</cx:pt>
          <cx:pt idx="753">3098</cx:pt>
          <cx:pt idx="754">3181</cx:pt>
          <cx:pt idx="755">3043</cx:pt>
          <cx:pt idx="756">3340</cx:pt>
          <cx:pt idx="757">3276</cx:pt>
          <cx:pt idx="758">2816</cx:pt>
          <cx:pt idx="759">2984</cx:pt>
          <cx:pt idx="760">3012</cx:pt>
          <cx:pt idx="761">3100</cx:pt>
          <cx:pt idx="762">3047</cx:pt>
          <cx:pt idx="763">3336</cx:pt>
          <cx:pt idx="764">2812</cx:pt>
          <cx:pt idx="765">3282</cx:pt>
          <cx:pt idx="766">2981</cx:pt>
          <cx:pt idx="767">3235</cx:pt>
          <cx:pt idx="768">3204</cx:pt>
          <cx:pt idx="769">3242</cx:pt>
          <cx:pt idx="770">3289</cx:pt>
          <cx:pt idx="771">3301</cx:pt>
          <cx:pt idx="772">3228</cx:pt>
          <cx:pt idx="773">3276</cx:pt>
          <cx:pt idx="774">2687</cx:pt>
          <cx:pt idx="775">2915</cx:pt>
          <cx:pt idx="776">3278</cx:pt>
          <cx:pt idx="777">2858</cx:pt>
          <cx:pt idx="778">2829</cx:pt>
          <cx:pt idx="779">3126</cx:pt>
          <cx:pt idx="780">3084</cx:pt>
          <cx:pt idx="781">3263</cx:pt>
          <cx:pt idx="782">2979</cx:pt>
          <cx:pt idx="783">2931</cx:pt>
          <cx:pt idx="784">3126</cx:pt>
          <cx:pt idx="785">2997</cx:pt>
          <cx:pt idx="786">2837</cx:pt>
          <cx:pt idx="787">3231</cx:pt>
          <cx:pt idx="788">3073</cx:pt>
          <cx:pt idx="789">3032</cx:pt>
          <cx:pt idx="790">3331</cx:pt>
          <cx:pt idx="791">2822</cx:pt>
          <cx:pt idx="792">2772</cx:pt>
          <cx:pt idx="793">2537</cx:pt>
          <cx:pt idx="794">2833</cx:pt>
          <cx:pt idx="795">2249</cx:pt>
          <cx:pt idx="796">2690</cx:pt>
          <cx:pt idx="797">2543</cx:pt>
          <cx:pt idx="798">3322</cx:pt>
          <cx:pt idx="799">3093</cx:pt>
          <cx:pt idx="800">3243</cx:pt>
          <cx:pt idx="801">3168</cx:pt>
          <cx:pt idx="802">3306</cx:pt>
          <cx:pt idx="803">2700</cx:pt>
          <cx:pt idx="804">2528</cx:pt>
          <cx:pt idx="805">2614</cx:pt>
          <cx:pt idx="806">2343</cx:pt>
          <cx:pt idx="807">2483</cx:pt>
          <cx:pt idx="808">3010</cx:pt>
          <cx:pt idx="809">2442</cx:pt>
          <cx:pt idx="810">2900</cx:pt>
          <cx:pt idx="811">2417</cx:pt>
          <cx:pt idx="812">2996</cx:pt>
          <cx:pt idx="813">2428</cx:pt>
          <cx:pt idx="814">2276</cx:pt>
          <cx:pt idx="815">2710</cx:pt>
          <cx:pt idx="816">2671</cx:pt>
          <cx:pt idx="817">2660</cx:pt>
          <cx:pt idx="818">2488</cx:pt>
          <cx:pt idx="819">2509</cx:pt>
          <cx:pt idx="820">2589</cx:pt>
          <cx:pt idx="821">2628</cx:pt>
          <cx:pt idx="822">2925</cx:pt>
          <cx:pt idx="823">3079</cx:pt>
          <cx:pt idx="824">3004</cx:pt>
          <cx:pt idx="825">2304</cx:pt>
          <cx:pt idx="826">2485</cx:pt>
          <cx:pt idx="827">2789</cx:pt>
          <cx:pt idx="828">2609</cx:pt>
          <cx:pt idx="829">2550</cx:pt>
          <cx:pt idx="830">2537</cx:pt>
          <cx:pt idx="831">2258</cx:pt>
          <cx:pt idx="832">2450</cx:pt>
          <cx:pt idx="833">2522</cx:pt>
          <cx:pt idx="834">2281</cx:pt>
          <cx:pt idx="835">2276</cx:pt>
          <cx:pt idx="836">2578</cx:pt>
          <cx:pt idx="837">2563</cx:pt>
          <cx:pt idx="838">2871</cx:pt>
          <cx:pt idx="839">2374</cx:pt>
          <cx:pt idx="840">2370</cx:pt>
          <cx:pt idx="841">2754</cx:pt>
          <cx:pt idx="842">2864</cx:pt>
          <cx:pt idx="843">2616</cx:pt>
          <cx:pt idx="844">2837</cx:pt>
          <cx:pt idx="845">2410</cx:pt>
          <cx:pt idx="846">2400</cx:pt>
          <cx:pt idx="847">2660</cx:pt>
          <cx:pt idx="848">2863</cx:pt>
          <cx:pt idx="849">2776</cx:pt>
          <cx:pt idx="850">2455</cx:pt>
          <cx:pt idx="851">2701</cx:pt>
          <cx:pt idx="852">2557</cx:pt>
          <cx:pt idx="853">2572</cx:pt>
          <cx:pt idx="854">2867</cx:pt>
          <cx:pt idx="855">2672</cx:pt>
          <cx:pt idx="856">2622</cx:pt>
          <cx:pt idx="857">2398</cx:pt>
          <cx:pt idx="858">2729</cx:pt>
          <cx:pt idx="859">2379</cx:pt>
          <cx:pt idx="860">3014</cx:pt>
          <cx:pt idx="861">2924</cx:pt>
          <cx:pt idx="862">3157</cx:pt>
          <cx:pt idx="863">2863</cx:pt>
          <cx:pt idx="864">2370</cx:pt>
          <cx:pt idx="865">2588</cx:pt>
          <cx:pt idx="866">2550</cx:pt>
          <cx:pt idx="867">2886</cx:pt>
          <cx:pt idx="868">2672</cx:pt>
          <cx:pt idx="869">2510</cx:pt>
          <cx:pt idx="870">2531</cx:pt>
          <cx:pt idx="871">2620</cx:pt>
          <cx:pt idx="872">2403</cx:pt>
          <cx:pt idx="873">2608</cx:pt>
          <cx:pt idx="874">2542</cx:pt>
          <cx:pt idx="875">2325</cx:pt>
          <cx:pt idx="876">2639</cx:pt>
          <cx:pt idx="877">2467</cx:pt>
          <cx:pt idx="878">2588</cx:pt>
          <cx:pt idx="879">2628</cx:pt>
          <cx:pt idx="880">2540</cx:pt>
          <cx:pt idx="881">2723</cx:pt>
          <cx:pt idx="882">2675</cx:pt>
          <cx:pt idx="883">2441</cx:pt>
          <cx:pt idx="884">2602</cx:pt>
          <cx:pt idx="885">2867</cx:pt>
          <cx:pt idx="886">2384</cx:pt>
          <cx:pt idx="887">2311</cx:pt>
          <cx:pt idx="888">2506</cx:pt>
          <cx:pt idx="889">2409</cx:pt>
          <cx:pt idx="890">2737</cx:pt>
          <cx:pt idx="891">2310</cx:pt>
          <cx:pt idx="892">2792</cx:pt>
          <cx:pt idx="893">2736</cx:pt>
          <cx:pt idx="894">2802</cx:pt>
          <cx:pt idx="895">2312</cx:pt>
          <cx:pt idx="896">2641</cx:pt>
          <cx:pt idx="897">2451</cx:pt>
          <cx:pt idx="898">2389</cx:pt>
          <cx:pt idx="899">2559</cx:pt>
          <cx:pt idx="900">2490</cx:pt>
          <cx:pt idx="901">2509</cx:pt>
          <cx:pt idx="902">2508</cx:pt>
          <cx:pt idx="903">2641</cx:pt>
          <cx:pt idx="904">2814</cx:pt>
          <cx:pt idx="905">2721</cx:pt>
          <cx:pt idx="906">2800</cx:pt>
          <cx:pt idx="907">2235</cx:pt>
          <cx:pt idx="908">2596</cx:pt>
          <cx:pt idx="909">2292</cx:pt>
          <cx:pt idx="910">2169</cx:pt>
          <cx:pt idx="911">2678</cx:pt>
          <cx:pt idx="912">2732</cx:pt>
          <cx:pt idx="913">2202</cx:pt>
          <cx:pt idx="914">2706</cx:pt>
          <cx:pt idx="915">2711</cx:pt>
          <cx:pt idx="916">2166</cx:pt>
          <cx:pt idx="917">2071</cx:pt>
          <cx:pt idx="918">2815</cx:pt>
          <cx:pt idx="919">2889</cx:pt>
          <cx:pt idx="920">2556</cx:pt>
          <cx:pt idx="921">3023</cx:pt>
          <cx:pt idx="922">2890</cx:pt>
          <cx:pt idx="923">3043</cx:pt>
          <cx:pt idx="924">2552</cx:pt>
          <cx:pt idx="925">3056</cx:pt>
          <cx:pt idx="926">3270</cx:pt>
          <cx:pt idx="927">2958</cx:pt>
          <cx:pt idx="928">2756</cx:pt>
          <cx:pt idx="929">2848</cx:pt>
          <cx:pt idx="930">2908</cx:pt>
          <cx:pt idx="931">3055</cx:pt>
          <cx:pt idx="932">2563</cx:pt>
          <cx:pt idx="933">3035</cx:pt>
          <cx:pt idx="934">2946</cx:pt>
          <cx:pt idx="935">2557</cx:pt>
          <cx:pt idx="936">2679</cx:pt>
          <cx:pt idx="937">2985</cx:pt>
          <cx:pt idx="938">2901</cx:pt>
          <cx:pt idx="939">2887</cx:pt>
          <cx:pt idx="940">3053</cx:pt>
          <cx:pt idx="941">2709</cx:pt>
          <cx:pt idx="942">3112</cx:pt>
          <cx:pt idx="943">2872</cx:pt>
          <cx:pt idx="944">3094</cx:pt>
          <cx:pt idx="945">2687</cx:pt>
          <cx:pt idx="946">2846</cx:pt>
          <cx:pt idx="947">2744</cx:pt>
          <cx:pt idx="948">3252</cx:pt>
          <cx:pt idx="949">3021</cx:pt>
          <cx:pt idx="950">3041</cx:pt>
          <cx:pt idx="951">2990</cx:pt>
          <cx:pt idx="952">2971</cx:pt>
          <cx:pt idx="953">2867</cx:pt>
          <cx:pt idx="954">2855</cx:pt>
          <cx:pt idx="955">3098</cx:pt>
          <cx:pt idx="956">2775</cx:pt>
          <cx:pt idx="957">2386</cx:pt>
          <cx:pt idx="958">2361</cx:pt>
          <cx:pt idx="959">2534</cx:pt>
          <cx:pt idx="960">2608</cx:pt>
          <cx:pt idx="961">2569</cx:pt>
          <cx:pt idx="962">2473</cx:pt>
          <cx:pt idx="963">2873</cx:pt>
          <cx:pt idx="964">2292</cx:pt>
          <cx:pt idx="965">2694</cx:pt>
          <cx:pt idx="966">2510</cx:pt>
          <cx:pt idx="967">2851</cx:pt>
          <cx:pt idx="968">2982</cx:pt>
          <cx:pt idx="969">2583</cx:pt>
          <cx:pt idx="970">2787</cx:pt>
          <cx:pt idx="971">2548</cx:pt>
          <cx:pt idx="972">2767</cx:pt>
          <cx:pt idx="973">2483</cx:pt>
          <cx:pt idx="974">2239</cx:pt>
          <cx:pt idx="975">2749</cx:pt>
          <cx:pt idx="976">2873</cx:pt>
          <cx:pt idx="977">2506</cx:pt>
          <cx:pt idx="978">2442</cx:pt>
          <cx:pt idx="979">2569</cx:pt>
          <cx:pt idx="980">2616</cx:pt>
          <cx:pt idx="981">2469</cx:pt>
          <cx:pt idx="982">2492</cx:pt>
          <cx:pt idx="983">2555</cx:pt>
          <cx:pt idx="984">2560</cx:pt>
          <cx:pt idx="985">2561</cx:pt>
          <cx:pt idx="986">2725</cx:pt>
          <cx:pt idx="987">2749</cx:pt>
          <cx:pt idx="988">2530</cx:pt>
          <cx:pt idx="989">2246</cx:pt>
          <cx:pt idx="990">2650</cx:pt>
          <cx:pt idx="991">2404</cx:pt>
          <cx:pt idx="992">2525</cx:pt>
          <cx:pt idx="993">2305</cx:pt>
          <cx:pt idx="994">2774</cx:pt>
          <cx:pt idx="995">2649</cx:pt>
          <cx:pt idx="996">2702</cx:pt>
          <cx:pt idx="997">2437</cx:pt>
          <cx:pt idx="998">2564</cx:pt>
          <cx:pt idx="999">2751</cx:pt>
          <cx:pt idx="1000">2739</cx:pt>
          <cx:pt idx="1001">2354</cx:pt>
          <cx:pt idx="1002">2591</cx:pt>
          <cx:pt idx="1003">2952</cx:pt>
          <cx:pt idx="1004">2866</cx:pt>
          <cx:pt idx="1005">2522</cx:pt>
          <cx:pt idx="1006">2759</cx:pt>
          <cx:pt idx="1007">2618</cx:pt>
          <cx:pt idx="1008">2566</cx:pt>
          <cx:pt idx="1009">2287</cx:pt>
          <cx:pt idx="1010">2580</cx:pt>
          <cx:pt idx="1011">2675</cx:pt>
          <cx:pt idx="1012">2344</cx:pt>
          <cx:pt idx="1013">2465</cx:pt>
          <cx:pt idx="1014">2680</cx:pt>
          <cx:pt idx="1015">2300</cx:pt>
          <cx:pt idx="1016">2349</cx:pt>
          <cx:pt idx="1017">2787</cx:pt>
          <cx:pt idx="1018">2510</cx:pt>
          <cx:pt idx="1019">2475</cx:pt>
          <cx:pt idx="1020">2714</cx:pt>
          <cx:pt idx="1021">2630</cx:pt>
          <cx:pt idx="1022">2489</cx:pt>
          <cx:pt idx="1023">2720</cx:pt>
          <cx:pt idx="1024">2486</cx:pt>
          <cx:pt idx="1025">2266</cx:pt>
          <cx:pt idx="1026">2474</cx:pt>
          <cx:pt idx="1027">2488</cx:pt>
          <cx:pt idx="1028">2333</cx:pt>
          <cx:pt idx="1029">2548</cx:pt>
          <cx:pt idx="1030">2456</cx:pt>
          <cx:pt idx="1031">2992</cx:pt>
          <cx:pt idx="1032">2517</cx:pt>
          <cx:pt idx="1033">2628</cx:pt>
          <cx:pt idx="1034">2564</cx:pt>
          <cx:pt idx="1035">2819</cx:pt>
          <cx:pt idx="1036">2888</cx:pt>
          <cx:pt idx="1037">2837</cx:pt>
          <cx:pt idx="1038">2970</cx:pt>
          <cx:pt idx="1039">2790</cx:pt>
          <cx:pt idx="1040">3130</cx:pt>
          <cx:pt idx="1041">2483</cx:pt>
          <cx:pt idx="1042">2547</cx:pt>
          <cx:pt idx="1043">2538</cx:pt>
          <cx:pt idx="1044">3069</cx:pt>
          <cx:pt idx="1045">2781</cx:pt>
          <cx:pt idx="1046">2280</cx:pt>
          <cx:pt idx="1047">2969</cx:pt>
          <cx:pt idx="1048">2593</cx:pt>
          <cx:pt idx="1049">2559</cx:pt>
          <cx:pt idx="1050">2921</cx:pt>
          <cx:pt idx="1051">2615</cx:pt>
          <cx:pt idx="1052">2183</cx:pt>
          <cx:pt idx="1053">2750</cx:pt>
          <cx:pt idx="1054">2641</cx:pt>
          <cx:pt idx="1055">2578</cx:pt>
          <cx:pt idx="1056">2850</cx:pt>
          <cx:pt idx="1057">2840</cx:pt>
          <cx:pt idx="1058">2611</cx:pt>
          <cx:pt idx="1059">2596</cx:pt>
          <cx:pt idx="1060">2472</cx:pt>
          <cx:pt idx="1061">2569</cx:pt>
          <cx:pt idx="1062">2550</cx:pt>
          <cx:pt idx="1063">2890</cx:pt>
          <cx:pt idx="1064">2292</cx:pt>
          <cx:pt idx="1065">2521</cx:pt>
          <cx:pt idx="1066">2550</cx:pt>
          <cx:pt idx="1067">2661</cx:pt>
          <cx:pt idx="1068">2262</cx:pt>
          <cx:pt idx="1069">2691</cx:pt>
          <cx:pt idx="1070">2551</cx:pt>
          <cx:pt idx="1071">2564</cx:pt>
          <cx:pt idx="1072">2468</cx:pt>
          <cx:pt idx="1073">2254</cx:pt>
          <cx:pt idx="1074">2858</cx:pt>
          <cx:pt idx="1075">2349</cx:pt>
          <cx:pt idx="1076">2496</cx:pt>
          <cx:pt idx="1077">2798</cx:pt>
          <cx:pt idx="1078">2596</cx:pt>
          <cx:pt idx="1079">2246</cx:pt>
          <cx:pt idx="1080">2350</cx:pt>
          <cx:pt idx="1081">2400</cx:pt>
          <cx:pt idx="1082">2448</cx:pt>
          <cx:pt idx="1083">2824</cx:pt>
          <cx:pt idx="1084">2803</cx:pt>
          <cx:pt idx="1085">2293</cx:pt>
          <cx:pt idx="1086">2317</cx:pt>
          <cx:pt idx="1087">2642</cx:pt>
          <cx:pt idx="1088">2665</cx:pt>
          <cx:pt idx="1089">2541</cx:pt>
          <cx:pt idx="1090">2266</cx:pt>
          <cx:pt idx="1091">2360</cx:pt>
          <cx:pt idx="1092">2781</cx:pt>
          <cx:pt idx="1093">2807</cx:pt>
          <cx:pt idx="1094">2644</cx:pt>
          <cx:pt idx="1095">2632</cx:pt>
          <cx:pt idx="1096">2238</cx:pt>
          <cx:pt idx="1097">2616</cx:pt>
          <cx:pt idx="1098">2282</cx:pt>
          <cx:pt idx="1099">2493</cx:pt>
          <cx:pt idx="1100">2398</cx:pt>
          <cx:pt idx="1101">3133</cx:pt>
          <cx:pt idx="1102">3089</cx:pt>
          <cx:pt idx="1103">3158</cx:pt>
          <cx:pt idx="1104">2727</cx:pt>
          <cx:pt idx="1105">3122</cx:pt>
          <cx:pt idx="1106">2736</cx:pt>
          <cx:pt idx="1107">3250</cx:pt>
          <cx:pt idx="1108">3066</cx:pt>
          <cx:pt idx="1109">2830</cx:pt>
          <cx:pt idx="1110">2570</cx:pt>
          <cx:pt idx="1111">2987</cx:pt>
          <cx:pt idx="1112">2804</cx:pt>
          <cx:pt idx="1113">2717</cx:pt>
          <cx:pt idx="1114">3031</cx:pt>
          <cx:pt idx="1115">2879</cx:pt>
          <cx:pt idx="1116">3207</cx:pt>
          <cx:pt idx="1117">3316</cx:pt>
          <cx:pt idx="1118">2789</cx:pt>
          <cx:pt idx="1119">2790</cx:pt>
          <cx:pt idx="1120">3099</cx:pt>
          <cx:pt idx="1121">2876</cx:pt>
          <cx:pt idx="1122">2724</cx:pt>
          <cx:pt idx="1123">3272</cx:pt>
          <cx:pt idx="1124">2659</cx:pt>
          <cx:pt idx="1125">2851</cx:pt>
          <cx:pt idx="1126">2783</cx:pt>
          <cx:pt idx="1127">2823</cx:pt>
          <cx:pt idx="1128">2860</cx:pt>
          <cx:pt idx="1129">3313</cx:pt>
          <cx:pt idx="1130">3255</cx:pt>
          <cx:pt idx="1131">2737</cx:pt>
          <cx:pt idx="1132">3029</cx:pt>
          <cx:pt idx="1133">2787</cx:pt>
          <cx:pt idx="1134">3115</cx:pt>
          <cx:pt idx="1135">3050</cx:pt>
          <cx:pt idx="1136">2929</cx:pt>
          <cx:pt idx="1137">2929</cx:pt>
          <cx:pt idx="1138">3013</cx:pt>
          <cx:pt idx="1139">3143</cx:pt>
          <cx:pt idx="1140">3094</cx:pt>
          <cx:pt idx="1141">3156</cx:pt>
          <cx:pt idx="1142">3262</cx:pt>
          <cx:pt idx="1143">2868</cx:pt>
          <cx:pt idx="1144">2674</cx:pt>
          <cx:pt idx="1145">3183</cx:pt>
          <cx:pt idx="1146">2958</cx:pt>
          <cx:pt idx="1147">2585</cx:pt>
          <cx:pt idx="1148">3038</cx:pt>
          <cx:pt idx="1149">3070</cx:pt>
          <cx:pt idx="1150">2632</cx:pt>
          <cx:pt idx="1151">3011</cx:pt>
          <cx:pt idx="1152">2736</cx:pt>
          <cx:pt idx="1153">2825</cx:pt>
          <cx:pt idx="1154">2861</cx:pt>
          <cx:pt idx="1155">2883</cx:pt>
          <cx:pt idx="1156">2818</cx:pt>
          <cx:pt idx="1157">3241</cx:pt>
          <cx:pt idx="1158">3156</cx:pt>
          <cx:pt idx="1159">2833</cx:pt>
          <cx:pt idx="1160">2783</cx:pt>
          <cx:pt idx="1161">3171</cx:pt>
          <cx:pt idx="1162">3102</cx:pt>
          <cx:pt idx="1163">2761</cx:pt>
          <cx:pt idx="1164">3150</cx:pt>
          <cx:pt idx="1165">3219</cx:pt>
          <cx:pt idx="1166">3197</cx:pt>
          <cx:pt idx="1167">2794</cx:pt>
          <cx:pt idx="1168">2842</cx:pt>
          <cx:pt idx="1169">3022</cx:pt>
          <cx:pt idx="1170">3188</cx:pt>
          <cx:pt idx="1171">3085</cx:pt>
          <cx:pt idx="1172">2951</cx:pt>
          <cx:pt idx="1173">3054</cx:pt>
          <cx:pt idx="1174">3232</cx:pt>
          <cx:pt idx="1175">3161</cx:pt>
          <cx:pt idx="1176">2702</cx:pt>
          <cx:pt idx="1177">2630</cx:pt>
          <cx:pt idx="1178">2956</cx:pt>
          <cx:pt idx="1179">2795</cx:pt>
          <cx:pt idx="1180">3044</cx:pt>
          <cx:pt idx="1181">3217</cx:pt>
          <cx:pt idx="1182">3217</cx:pt>
          <cx:pt idx="1183">3264</cx:pt>
          <cx:pt idx="1184">3250</cx:pt>
          <cx:pt idx="1185">3425</cx:pt>
          <cx:pt idx="1186">2987</cx:pt>
          <cx:pt idx="1187">2923</cx:pt>
          <cx:pt idx="1188">3040</cx:pt>
          <cx:pt idx="1189">2832</cx:pt>
          <cx:pt idx="1190">2875</cx:pt>
          <cx:pt idx="1191">2840</cx:pt>
          <cx:pt idx="1192">2982</cx:pt>
          <cx:pt idx="1193">2817</cx:pt>
          <cx:pt idx="1194">3149</cx:pt>
          <cx:pt idx="1195">3243</cx:pt>
          <cx:pt idx="1196">3303</cx:pt>
          <cx:pt idx="1197">3161</cx:pt>
          <cx:pt idx="1198">2673</cx:pt>
          <cx:pt idx="1199">3157</cx:pt>
          <cx:pt idx="1200">3127</cx:pt>
          <cx:pt idx="1201">3252</cx:pt>
          <cx:pt idx="1202">2687</cx:pt>
          <cx:pt idx="1203">2959</cx:pt>
          <cx:pt idx="1204">2976</cx:pt>
          <cx:pt idx="1205">3067</cx:pt>
          <cx:pt idx="1206">3090</cx:pt>
          <cx:pt idx="1207">3236</cx:pt>
          <cx:pt idx="1208">3476</cx:pt>
          <cx:pt idx="1209">3187</cx:pt>
          <cx:pt idx="1210">2913</cx:pt>
          <cx:pt idx="1211">2987</cx:pt>
          <cx:pt idx="1212">3199</cx:pt>
          <cx:pt idx="1213">2936</cx:pt>
          <cx:pt idx="1214">3287</cx:pt>
          <cx:pt idx="1215">2767</cx:pt>
          <cx:pt idx="1216">2842</cx:pt>
          <cx:pt idx="1217">3270</cx:pt>
          <cx:pt idx="1218">3032</cx:pt>
          <cx:pt idx="1219">3373</cx:pt>
          <cx:pt idx="1220">2969</cx:pt>
          <cx:pt idx="1221">3138</cx:pt>
          <cx:pt idx="1222">2853</cx:pt>
          <cx:pt idx="1223">3165</cx:pt>
          <cx:pt idx="1224">2743</cx:pt>
          <cx:pt idx="1225">3004</cx:pt>
          <cx:pt idx="1226">3161</cx:pt>
          <cx:pt idx="1227">2876</cx:pt>
          <cx:pt idx="1228">2755</cx:pt>
          <cx:pt idx="1229">3341</cx:pt>
          <cx:pt idx="1230">3012</cx:pt>
          <cx:pt idx="1231">2927</cx:pt>
          <cx:pt idx="1232">3089</cx:pt>
          <cx:pt idx="1233">2948</cx:pt>
          <cx:pt idx="1234">2676</cx:pt>
          <cx:pt idx="1235">3096</cx:pt>
          <cx:pt idx="1236">3151</cx:pt>
          <cx:pt idx="1237">2603</cx:pt>
          <cx:pt idx="1238">2831</cx:pt>
          <cx:pt idx="1239">2795</cx:pt>
          <cx:pt idx="1240">2987</cx:pt>
          <cx:pt idx="1241">3104</cx:pt>
          <cx:pt idx="1242">2940</cx:pt>
          <cx:pt idx="1243">3029</cx:pt>
          <cx:pt idx="1244">2900</cx:pt>
          <cx:pt idx="1245">2344</cx:pt>
          <cx:pt idx="1246">2492</cx:pt>
          <cx:pt idx="1247">2387</cx:pt>
          <cx:pt idx="1248">2521</cx:pt>
          <cx:pt idx="1249">2676</cx:pt>
          <cx:pt idx="1250">2867</cx:pt>
          <cx:pt idx="1251">2578</cx:pt>
          <cx:pt idx="1252">2547</cx:pt>
          <cx:pt idx="1253">2235</cx:pt>
          <cx:pt idx="1254">2418</cx:pt>
          <cx:pt idx="1255">2560</cx:pt>
          <cx:pt idx="1256">2876</cx:pt>
          <cx:pt idx="1257">2566</cx:pt>
          <cx:pt idx="1258">2261</cx:pt>
          <cx:pt idx="1259">2449</cx:pt>
          <cx:pt idx="1260">2336</cx:pt>
          <cx:pt idx="1261">2477</cx:pt>
          <cx:pt idx="1262">2516</cx:pt>
          <cx:pt idx="1263">2588</cx:pt>
          <cx:pt idx="1264">2262</cx:pt>
          <cx:pt idx="1265">2359</cx:pt>
          <cx:pt idx="1266">2944</cx:pt>
          <cx:pt idx="1267">2748</cx:pt>
          <cx:pt idx="1268">2610</cx:pt>
          <cx:pt idx="1269">2855</cx:pt>
          <cx:pt idx="1270">2434</cx:pt>
          <cx:pt idx="1271">2327</cx:pt>
          <cx:pt idx="1272">2284</cx:pt>
          <cx:pt idx="1273">2483</cx:pt>
          <cx:pt idx="1274">2499</cx:pt>
          <cx:pt idx="1275">2753</cx:pt>
          <cx:pt idx="1276">2944</cx:pt>
          <cx:pt idx="1277">2709</cx:pt>
          <cx:pt idx="1278">2931</cx:pt>
          <cx:pt idx="1279">2233</cx:pt>
          <cx:pt idx="1280">2746</cx:pt>
          <cx:pt idx="1281">2477</cx:pt>
          <cx:pt idx="1282">2119</cx:pt>
          <cx:pt idx="1283">1807</cx:pt>
          <cx:pt idx="1284">2646</cx:pt>
          <cx:pt idx="1285">2635</cx:pt>
          <cx:pt idx="1286">2735</cx:pt>
          <cx:pt idx="1287">1883</cx:pt>
          <cx:pt idx="1288">2505</cx:pt>
          <cx:pt idx="1289">3105</cx:pt>
          <cx:pt idx="1290">2731</cx:pt>
          <cx:pt idx="1291">2793</cx:pt>
          <cx:pt idx="1292">2536</cx:pt>
          <cx:pt idx="1293">2632</cx:pt>
          <cx:pt idx="1294">2543</cx:pt>
          <cx:pt idx="1295">2996</cx:pt>
          <cx:pt idx="1296">2623</cx:pt>
          <cx:pt idx="1297">2665</cx:pt>
          <cx:pt idx="1298">2627</cx:pt>
          <cx:pt idx="1299">3133</cx:pt>
          <cx:pt idx="1300">2658</cx:pt>
          <cx:pt idx="1301">2976</cx:pt>
          <cx:pt idx="1302">2922</cx:pt>
          <cx:pt idx="1303">2995</cx:pt>
          <cx:pt idx="1304">2581</cx:pt>
          <cx:pt idx="1305">2766</cx:pt>
          <cx:pt idx="1306">3093</cx:pt>
          <cx:pt idx="1307">2698</cx:pt>
          <cx:pt idx="1308">2880</cx:pt>
          <cx:pt idx="1309">3032</cx:pt>
          <cx:pt idx="1310">2604</cx:pt>
          <cx:pt idx="1311">3145</cx:pt>
          <cx:pt idx="1312">2592</cx:pt>
          <cx:pt idx="1313">2911</cx:pt>
          <cx:pt idx="1314">2912</cx:pt>
          <cx:pt idx="1315">3163</cx:pt>
          <cx:pt idx="1316">2611</cx:pt>
          <cx:pt idx="1317">3181</cx:pt>
          <cx:pt idx="1318">2997</cx:pt>
          <cx:pt idx="1319">2639</cx:pt>
          <cx:pt idx="1320">2658</cx:pt>
          <cx:pt idx="1321">2941</cx:pt>
          <cx:pt idx="1322">2910</cx:pt>
          <cx:pt idx="1323">2694</cx:pt>
          <cx:pt idx="1324">2981</cx:pt>
          <cx:pt idx="1325">2805</cx:pt>
          <cx:pt idx="1326">3007</cx:pt>
          <cx:pt idx="1327">2062</cx:pt>
          <cx:pt idx="1328">2902</cx:pt>
          <cx:pt idx="1329">2381</cx:pt>
          <cx:pt idx="1330">2861</cx:pt>
          <cx:pt idx="1331">2750</cx:pt>
          <cx:pt idx="1332">2618</cx:pt>
          <cx:pt idx="1333">3075</cx:pt>
          <cx:pt idx="1334">2770</cx:pt>
          <cx:pt idx="1335">2981</cx:pt>
          <cx:pt idx="1336">2907</cx:pt>
          <cx:pt idx="1337">2446</cx:pt>
          <cx:pt idx="1338">2838</cx:pt>
          <cx:pt idx="1339">1997</cx:pt>
          <cx:pt idx="1340">2753</cx:pt>
          <cx:pt idx="1341">2732</cx:pt>
          <cx:pt idx="1342">2744</cx:pt>
          <cx:pt idx="1343">2884</cx:pt>
          <cx:pt idx="1344">2774</cx:pt>
          <cx:pt idx="1345">2970</cx:pt>
          <cx:pt idx="1346">3173</cx:pt>
          <cx:pt idx="1347">3088</cx:pt>
          <cx:pt idx="1348">3033</cx:pt>
          <cx:pt idx="1349">2903</cx:pt>
          <cx:pt idx="1350">2899</cx:pt>
          <cx:pt idx="1351">2833</cx:pt>
          <cx:pt idx="1352">2817</cx:pt>
          <cx:pt idx="1353">2912</cx:pt>
          <cx:pt idx="1354">2673</cx:pt>
          <cx:pt idx="1355">2843</cx:pt>
          <cx:pt idx="1356">2877</cx:pt>
          <cx:pt idx="1357">3377</cx:pt>
          <cx:pt idx="1358">3004</cx:pt>
          <cx:pt idx="1359">3174</cx:pt>
          <cx:pt idx="1360">3180</cx:pt>
          <cx:pt idx="1361">3334</cx:pt>
          <cx:pt idx="1362">2922</cx:pt>
          <cx:pt idx="1363">2983</cx:pt>
          <cx:pt idx="1364">2716</cx:pt>
          <cx:pt idx="1365">3081</cx:pt>
          <cx:pt idx="1366">3136</cx:pt>
          <cx:pt idx="1367">3137</cx:pt>
          <cx:pt idx="1368">3239</cx:pt>
          <cx:pt idx="1369">2984</cx:pt>
          <cx:pt idx="1370">2723</cx:pt>
          <cx:pt idx="1371">3022</cx:pt>
          <cx:pt idx="1372">3226</cx:pt>
          <cx:pt idx="1373">2839</cx:pt>
          <cx:pt idx="1374">2844</cx:pt>
          <cx:pt idx="1375">3072</cx:pt>
          <cx:pt idx="1376">3114</cx:pt>
          <cx:pt idx="1377">2777</cx:pt>
          <cx:pt idx="1378">2909</cx:pt>
          <cx:pt idx="1379">2803</cx:pt>
          <cx:pt idx="1380">3396</cx:pt>
          <cx:pt idx="1381">3258</cx:pt>
          <cx:pt idx="1382">3335</cx:pt>
          <cx:pt idx="1383">3003</cx:pt>
          <cx:pt idx="1384">3165</cx:pt>
          <cx:pt idx="1385">3169</cx:pt>
          <cx:pt idx="1386">3296</cx:pt>
          <cx:pt idx="1387">2992</cx:pt>
          <cx:pt idx="1388">3283</cx:pt>
          <cx:pt idx="1389">3350</cx:pt>
          <cx:pt idx="1390">2987</cx:pt>
          <cx:pt idx="1391">3005</cx:pt>
          <cx:pt idx="1392">3066</cx:pt>
          <cx:pt idx="1393">2912</cx:pt>
          <cx:pt idx="1394">3243</cx:pt>
          <cx:pt idx="1395">3071</cx:pt>
          <cx:pt idx="1396">3352</cx:pt>
          <cx:pt idx="1397">3330</cx:pt>
          <cx:pt idx="1398">2979</cx:pt>
          <cx:pt idx="1399">2900</cx:pt>
          <cx:pt idx="1400">3295</cx:pt>
          <cx:pt idx="1401">3158</cx:pt>
          <cx:pt idx="1402">3000</cx:pt>
          <cx:pt idx="1403">2965</cx:pt>
          <cx:pt idx="1404">2963</cx:pt>
          <cx:pt idx="1405">2899</cx:pt>
          <cx:pt idx="1406">3176</cx:pt>
          <cx:pt idx="1407">3141</cx:pt>
          <cx:pt idx="1408">2869</cx:pt>
          <cx:pt idx="1409">3410</cx:pt>
          <cx:pt idx="1410">2869</cx:pt>
          <cx:pt idx="1411">2921</cx:pt>
          <cx:pt idx="1412">3145</cx:pt>
          <cx:pt idx="1413">3344</cx:pt>
          <cx:pt idx="1414">3015</cx:pt>
          <cx:pt idx="1415">3284</cx:pt>
          <cx:pt idx="1416">3383</cx:pt>
          <cx:pt idx="1417">3286</cx:pt>
          <cx:pt idx="1418">3013</cx:pt>
          <cx:pt idx="1419">2988</cx:pt>
          <cx:pt idx="1420">3227</cx:pt>
          <cx:pt idx="1421">3247</cx:pt>
          <cx:pt idx="1422">3318</cx:pt>
          <cx:pt idx="1423">3171</cx:pt>
          <cx:pt idx="1424">3164</cx:pt>
          <cx:pt idx="1425">3033</cx:pt>
          <cx:pt idx="1426">3192</cx:pt>
          <cx:pt idx="1427">3160</cx:pt>
          <cx:pt idx="1428">2985</cx:pt>
          <cx:pt idx="1429">2742</cx:pt>
          <cx:pt idx="1430">3116</cx:pt>
          <cx:pt idx="1431">2698</cx:pt>
          <cx:pt idx="1432">3237</cx:pt>
          <cx:pt idx="1433">2828</cx:pt>
          <cx:pt idx="1434">2767</cx:pt>
          <cx:pt idx="1435">3307</cx:pt>
          <cx:pt idx="1436">3068</cx:pt>
          <cx:pt idx="1437">3205</cx:pt>
          <cx:pt idx="1438">2817</cx:pt>
          <cx:pt idx="1439">3145</cx:pt>
          <cx:pt idx="1440">3098</cx:pt>
          <cx:pt idx="1441">3298</cx:pt>
          <cx:pt idx="1442">3087</cx:pt>
          <cx:pt idx="1443">3204</cx:pt>
          <cx:pt idx="1444">3412</cx:pt>
          <cx:pt idx="1445">2772</cx:pt>
          <cx:pt idx="1446">2714</cx:pt>
          <cx:pt idx="1447">2873</cx:pt>
          <cx:pt idx="1448">3159</cx:pt>
          <cx:pt idx="1449">3338</cx:pt>
          <cx:pt idx="1450">3046</cx:pt>
          <cx:pt idx="1451">3322</cx:pt>
          <cx:pt idx="1452">3011</cx:pt>
          <cx:pt idx="1453">3250</cx:pt>
          <cx:pt idx="1454">3208</cx:pt>
          <cx:pt idx="1455">3140</cx:pt>
          <cx:pt idx="1456">2764</cx:pt>
          <cx:pt idx="1457">2927</cx:pt>
          <cx:pt idx="1458">2981</cx:pt>
          <cx:pt idx="1459">3163</cx:pt>
          <cx:pt idx="1460">2804</cx:pt>
          <cx:pt idx="1461">3187</cx:pt>
          <cx:pt idx="1462">3008</cx:pt>
          <cx:pt idx="1463">2404</cx:pt>
          <cx:pt idx="1464">3031</cx:pt>
          <cx:pt idx="1465">2917</cx:pt>
          <cx:pt idx="1466">3194</cx:pt>
          <cx:pt idx="1467">2862</cx:pt>
          <cx:pt idx="1468">3063</cx:pt>
          <cx:pt idx="1469">3101</cx:pt>
          <cx:pt idx="1470">2925</cx:pt>
          <cx:pt idx="1471">3247</cx:pt>
          <cx:pt idx="1472">3098</cx:pt>
          <cx:pt idx="1473">3198</cx:pt>
          <cx:pt idx="1474">2892</cx:pt>
          <cx:pt idx="1475">2729</cx:pt>
          <cx:pt idx="1476">3263</cx:pt>
          <cx:pt idx="1477">2829</cx:pt>
          <cx:pt idx="1478">3003</cx:pt>
          <cx:pt idx="1479">2617</cx:pt>
          <cx:pt idx="1480">2907</cx:pt>
          <cx:pt idx="1481">3083</cx:pt>
          <cx:pt idx="1482">2907</cx:pt>
          <cx:pt idx="1483">2953</cx:pt>
          <cx:pt idx="1484">3156</cx:pt>
          <cx:pt idx="1485">2828</cx:pt>
          <cx:pt idx="1486">3103</cx:pt>
          <cx:pt idx="1487">3095</cx:pt>
          <cx:pt idx="1488">3072</cx:pt>
          <cx:pt idx="1489">3167</cx:pt>
          <cx:pt idx="1490">2892</cx:pt>
          <cx:pt idx="1491">3168</cx:pt>
          <cx:pt idx="1492">3143</cx:pt>
          <cx:pt idx="1493">3301</cx:pt>
          <cx:pt idx="1494">3105</cx:pt>
          <cx:pt idx="1495">3147</cx:pt>
          <cx:pt idx="1496">2901</cx:pt>
          <cx:pt idx="1497">3326</cx:pt>
          <cx:pt idx="1498">3193</cx:pt>
          <cx:pt idx="1499">3166</cx:pt>
          <cx:pt idx="1500">2669</cx:pt>
          <cx:pt idx="1501">2669</cx:pt>
          <cx:pt idx="1502">2872</cx:pt>
          <cx:pt idx="1503">2955</cx:pt>
          <cx:pt idx="1504">2781</cx:pt>
          <cx:pt idx="1505">2979</cx:pt>
          <cx:pt idx="1506">2900</cx:pt>
          <cx:pt idx="1507">3189</cx:pt>
          <cx:pt idx="1508">3063</cx:pt>
          <cx:pt idx="1509">2994</cx:pt>
          <cx:pt idx="1510">2717</cx:pt>
          <cx:pt idx="1511">3093</cx:pt>
          <cx:pt idx="1512">3275</cx:pt>
          <cx:pt idx="1513">2880</cx:pt>
          <cx:pt idx="1514">3050</cx:pt>
          <cx:pt idx="1515">2976</cx:pt>
          <cx:pt idx="1516">3227</cx:pt>
          <cx:pt idx="1517">2640</cx:pt>
          <cx:pt idx="1518">3204</cx:pt>
          <cx:pt idx="1519">2929</cx:pt>
          <cx:pt idx="1520">3039</cx:pt>
          <cx:pt idx="1521">3166</cx:pt>
          <cx:pt idx="1522">3145</cx:pt>
          <cx:pt idx="1523">2740</cx:pt>
          <cx:pt idx="1524">2811</cx:pt>
          <cx:pt idx="1525">3042</cx:pt>
          <cx:pt idx="1526">2835</cx:pt>
          <cx:pt idx="1527">3297</cx:pt>
          <cx:pt idx="1528">2982</cx:pt>
          <cx:pt idx="1529">2930</cx:pt>
          <cx:pt idx="1530">2692</cx:pt>
          <cx:pt idx="1531">2632</cx:pt>
          <cx:pt idx="1532">2929</cx:pt>
          <cx:pt idx="1533">2896</cx:pt>
          <cx:pt idx="1534">2736</cx:pt>
          <cx:pt idx="1535">3090</cx:pt>
          <cx:pt idx="1536">2955</cx:pt>
          <cx:pt idx="1537">3043</cx:pt>
          <cx:pt idx="1538">2619</cx:pt>
          <cx:pt idx="1539">2972</cx:pt>
          <cx:pt idx="1540">2961</cx:pt>
          <cx:pt idx="1541">2965</cx:pt>
          <cx:pt idx="1542">2894</cx:pt>
          <cx:pt idx="1543">2998</cx:pt>
          <cx:pt idx="1544">2953</cx:pt>
          <cx:pt idx="1545">2519</cx:pt>
          <cx:pt idx="1546">2105</cx:pt>
          <cx:pt idx="1547">2782</cx:pt>
          <cx:pt idx="1548">2766</cx:pt>
          <cx:pt idx="1549">2150</cx:pt>
          <cx:pt idx="1550">2283</cx:pt>
          <cx:pt idx="1551">2783</cx:pt>
          <cx:pt idx="1552">2636</cx:pt>
          <cx:pt idx="1553">2542</cx:pt>
          <cx:pt idx="1554">2518</cx:pt>
          <cx:pt idx="1555">2646</cx:pt>
          <cx:pt idx="1556">2533</cx:pt>
          <cx:pt idx="1557">2667</cx:pt>
          <cx:pt idx="1558">2425</cx:pt>
          <cx:pt idx="1559">2777</cx:pt>
          <cx:pt idx="1560">2573</cx:pt>
          <cx:pt idx="1561">2934</cx:pt>
          <cx:pt idx="1562">2707</cx:pt>
          <cx:pt idx="1563">2676</cx:pt>
          <cx:pt idx="1564">2567</cx:pt>
          <cx:pt idx="1565">2713</cx:pt>
          <cx:pt idx="1566">2861</cx:pt>
          <cx:pt idx="1567">2497</cx:pt>
          <cx:pt idx="1568">2585</cx:pt>
          <cx:pt idx="1569">2829</cx:pt>
          <cx:pt idx="1570">2688</cx:pt>
          <cx:pt idx="1571">2288</cx:pt>
          <cx:pt idx="1572">2429</cx:pt>
          <cx:pt idx="1573">2869</cx:pt>
          <cx:pt idx="1574">2788</cx:pt>
          <cx:pt idx="1575">2849</cx:pt>
          <cx:pt idx="1576">2342</cx:pt>
          <cx:pt idx="1577">2579</cx:pt>
          <cx:pt idx="1578">2534</cx:pt>
          <cx:pt idx="1579">2737</cx:pt>
          <cx:pt idx="1580">2732</cx:pt>
          <cx:pt idx="1581">2853</cx:pt>
          <cx:pt idx="1582">2624</cx:pt>
          <cx:pt idx="1583">2574</cx:pt>
          <cx:pt idx="1584">2616</cx:pt>
          <cx:pt idx="1585">2374</cx:pt>
          <cx:pt idx="1586">2523</cx:pt>
          <cx:pt idx="1587">2946</cx:pt>
          <cx:pt idx="1588">2951</cx:pt>
          <cx:pt idx="1589">2940</cx:pt>
          <cx:pt idx="1590">2602</cx:pt>
          <cx:pt idx="1591">2889</cx:pt>
          <cx:pt idx="1592">2812</cx:pt>
          <cx:pt idx="1593">2563</cx:pt>
          <cx:pt idx="1594">2450</cx:pt>
          <cx:pt idx="1595">2647</cx:pt>
          <cx:pt idx="1596">2850</cx:pt>
          <cx:pt idx="1597">2812</cx:pt>
          <cx:pt idx="1598">2724</cx:pt>
          <cx:pt idx="1599">2952</cx:pt>
          <cx:pt idx="1600">2874</cx:pt>
          <cx:pt idx="1601">2504</cx:pt>
          <cx:pt idx="1602">2501</cx:pt>
          <cx:pt idx="1603">2512</cx:pt>
          <cx:pt idx="1604">2725</cx:pt>
          <cx:pt idx="1605">2778</cx:pt>
          <cx:pt idx="1606">2664</cx:pt>
          <cx:pt idx="1607">2722</cx:pt>
          <cx:pt idx="1608">2928</cx:pt>
          <cx:pt idx="1609">2368</cx:pt>
          <cx:pt idx="1610">2740</cx:pt>
          <cx:pt idx="1611">3098</cx:pt>
          <cx:pt idx="1612">2950</cx:pt>
          <cx:pt idx="1613">2486</cx:pt>
          <cx:pt idx="1614">2766</cx:pt>
          <cx:pt idx="1615">2634</cx:pt>
          <cx:pt idx="1616">2309</cx:pt>
          <cx:pt idx="1617">2685</cx:pt>
          <cx:pt idx="1618">2428</cx:pt>
          <cx:pt idx="1619">2775</cx:pt>
          <cx:pt idx="1620">2369</cx:pt>
          <cx:pt idx="1621">2353</cx:pt>
          <cx:pt idx="1622">2730</cx:pt>
          <cx:pt idx="1623">2713</cx:pt>
          <cx:pt idx="1624">2257</cx:pt>
          <cx:pt idx="1625">2507</cx:pt>
          <cx:pt idx="1626">2581</cx:pt>
          <cx:pt idx="1627">2805</cx:pt>
          <cx:pt idx="1628">2351</cx:pt>
          <cx:pt idx="1629">2411</cx:pt>
          <cx:pt idx="1630">2536</cx:pt>
          <cx:pt idx="1631">2640</cx:pt>
          <cx:pt idx="1632">2605</cx:pt>
          <cx:pt idx="1633">2709</cx:pt>
          <cx:pt idx="1634">2604</cx:pt>
          <cx:pt idx="1635">2422</cx:pt>
          <cx:pt idx="1636">2402</cx:pt>
          <cx:pt idx="1637">2411</cx:pt>
          <cx:pt idx="1638">2696</cx:pt>
          <cx:pt idx="1639">2902</cx:pt>
          <cx:pt idx="1640">2562</cx:pt>
          <cx:pt idx="1641">2775</cx:pt>
          <cx:pt idx="1642">2572</cx:pt>
          <cx:pt idx="1643">2578</cx:pt>
          <cx:pt idx="1644">2845</cx:pt>
          <cx:pt idx="1645">3117</cx:pt>
          <cx:pt idx="1646">3062</cx:pt>
          <cx:pt idx="1647">2543</cx:pt>
          <cx:pt idx="1648">2906</cx:pt>
          <cx:pt idx="1649">2635</cx:pt>
          <cx:pt idx="1650">2982</cx:pt>
          <cx:pt idx="1651">2623</cx:pt>
          <cx:pt idx="1652">2828</cx:pt>
          <cx:pt idx="1653">2581</cx:pt>
          <cx:pt idx="1654">2732</cx:pt>
          <cx:pt idx="1655">2994</cx:pt>
          <cx:pt idx="1656">2968</cx:pt>
          <cx:pt idx="1657">3106</cx:pt>
          <cx:pt idx="1658">2934</cx:pt>
          <cx:pt idx="1659">2727</cx:pt>
          <cx:pt idx="1660">3320</cx:pt>
          <cx:pt idx="1661">3108</cx:pt>
          <cx:pt idx="1662">3234</cx:pt>
          <cx:pt idx="1663">2827</cx:pt>
          <cx:pt idx="1664">3465</cx:pt>
          <cx:pt idx="1665">3308</cx:pt>
          <cx:pt idx="1666">2905</cx:pt>
          <cx:pt idx="1667">3146</cx:pt>
          <cx:pt idx="1668">3197</cx:pt>
          <cx:pt idx="1669">3007</cx:pt>
          <cx:pt idx="1670">3243</cx:pt>
          <cx:pt idx="1671">3101</cx:pt>
          <cx:pt idx="1672">2627</cx:pt>
          <cx:pt idx="1673">3151</cx:pt>
          <cx:pt idx="1674">2868</cx:pt>
          <cx:pt idx="1675">3065</cx:pt>
          <cx:pt idx="1676">3229</cx:pt>
          <cx:pt idx="1677">2697</cx:pt>
          <cx:pt idx="1678">3171</cx:pt>
          <cx:pt idx="1679">3403</cx:pt>
          <cx:pt idx="1680">2876</cx:pt>
          <cx:pt idx="1681">3243</cx:pt>
          <cx:pt idx="1682">3330</cx:pt>
          <cx:pt idx="1683">3044</cx:pt>
          <cx:pt idx="1684">3101</cx:pt>
          <cx:pt idx="1685">3164</cx:pt>
          <cx:pt idx="1686">3401</cx:pt>
          <cx:pt idx="1687">2975</cx:pt>
          <cx:pt idx="1688">3089</cx:pt>
          <cx:pt idx="1689">3375</cx:pt>
          <cx:pt idx="1690">3433</cx:pt>
          <cx:pt idx="1691">3162</cx:pt>
          <cx:pt idx="1692">3334</cx:pt>
          <cx:pt idx="1693">2835</cx:pt>
          <cx:pt idx="1694">2791</cx:pt>
          <cx:pt idx="1695">3124</cx:pt>
          <cx:pt idx="1696">2987</cx:pt>
          <cx:pt idx="1697">2902</cx:pt>
          <cx:pt idx="1698">3094</cx:pt>
          <cx:pt idx="1699">2898</cx:pt>
          <cx:pt idx="1700">3257</cx:pt>
          <cx:pt idx="1701">3333</cx:pt>
          <cx:pt idx="1702">3409</cx:pt>
          <cx:pt idx="1703">3374</cx:pt>
          <cx:pt idx="1704">3385</cx:pt>
          <cx:pt idx="1705">2978</cx:pt>
          <cx:pt idx="1706">3106</cx:pt>
          <cx:pt idx="1707">2998</cx:pt>
          <cx:pt idx="1708">3454</cx:pt>
          <cx:pt idx="1709">2832</cx:pt>
          <cx:pt idx="1710">3011</cx:pt>
          <cx:pt idx="1711">3113</cx:pt>
          <cx:pt idx="1712">3027</cx:pt>
          <cx:pt idx="1713">3410</cx:pt>
          <cx:pt idx="1714">3304</cx:pt>
          <cx:pt idx="1715">3434</cx:pt>
          <cx:pt idx="1716">2930</cx:pt>
          <cx:pt idx="1717">3068</cx:pt>
          <cx:pt idx="1718">2951</cx:pt>
          <cx:pt idx="1719">3286</cx:pt>
          <cx:pt idx="1720">3150</cx:pt>
          <cx:pt idx="1721">3169</cx:pt>
          <cx:pt idx="1722">3123</cx:pt>
          <cx:pt idx="1723">3294</cx:pt>
          <cx:pt idx="1724">2833</cx:pt>
          <cx:pt idx="1725">3434</cx:pt>
          <cx:pt idx="1726">3162</cx:pt>
          <cx:pt idx="1727">3159</cx:pt>
          <cx:pt idx="1728">3131</cx:pt>
          <cx:pt idx="1729">3308</cx:pt>
          <cx:pt idx="1730">3452</cx:pt>
          <cx:pt idx="1731">3052</cx:pt>
          <cx:pt idx="1732">3225</cx:pt>
          <cx:pt idx="1733">3169</cx:pt>
          <cx:pt idx="1734">2839</cx:pt>
          <cx:pt idx="1735">3035</cx:pt>
          <cx:pt idx="1736">3405</cx:pt>
          <cx:pt idx="1737">2854</cx:pt>
          <cx:pt idx="1738">2798</cx:pt>
          <cx:pt idx="1739">3297</cx:pt>
          <cx:pt idx="1740">3186</cx:pt>
          <cx:pt idx="1741">2933</cx:pt>
          <cx:pt idx="1742">2990</cx:pt>
          <cx:pt idx="1743">2762</cx:pt>
          <cx:pt idx="1744">2719</cx:pt>
          <cx:pt idx="1745">2585</cx:pt>
          <cx:pt idx="1746">3169</cx:pt>
          <cx:pt idx="1747">2900</cx:pt>
          <cx:pt idx="1748">2870</cx:pt>
          <cx:pt idx="1749">2664</cx:pt>
          <cx:pt idx="1750">3033</cx:pt>
          <cx:pt idx="1751">2687</cx:pt>
          <cx:pt idx="1752">2746</cx:pt>
          <cx:pt idx="1753">2738</cx:pt>
          <cx:pt idx="1754">3100</cx:pt>
          <cx:pt idx="1755">2964</cx:pt>
          <cx:pt idx="1756">2963</cx:pt>
          <cx:pt idx="1757">2899</cx:pt>
          <cx:pt idx="1758">3061</cx:pt>
          <cx:pt idx="1759">2960</cx:pt>
          <cx:pt idx="1760">3128</cx:pt>
          <cx:pt idx="1761">2945</cx:pt>
          <cx:pt idx="1762">2704</cx:pt>
          <cx:pt idx="1763">2904</cx:pt>
          <cx:pt idx="1764">2991</cx:pt>
          <cx:pt idx="1765">2952</cx:pt>
          <cx:pt idx="1766">2867</cx:pt>
          <cx:pt idx="1767">2109</cx:pt>
          <cx:pt idx="1768">2167</cx:pt>
          <cx:pt idx="1769">2371</cx:pt>
          <cx:pt idx="1770">2379</cx:pt>
          <cx:pt idx="1771">2381</cx:pt>
          <cx:pt idx="1772">2515</cx:pt>
          <cx:pt idx="1773">2087</cx:pt>
          <cx:pt idx="1774">2756</cx:pt>
          <cx:pt idx="1775">2515</cx:pt>
          <cx:pt idx="1776">2377</cx:pt>
          <cx:pt idx="1777">2532</cx:pt>
          <cx:pt idx="1778">2779</cx:pt>
          <cx:pt idx="1779">2429</cx:pt>
          <cx:pt idx="1780">2188</cx:pt>
          <cx:pt idx="1781">2446</cx:pt>
          <cx:pt idx="1782">2345</cx:pt>
          <cx:pt idx="1783">2643</cx:pt>
          <cx:pt idx="1784">2447</cx:pt>
          <cx:pt idx="1785">2485</cx:pt>
          <cx:pt idx="1786">2860</cx:pt>
          <cx:pt idx="1787">2308</cx:pt>
          <cx:pt idx="1788">2312</cx:pt>
          <cx:pt idx="1789">2156</cx:pt>
          <cx:pt idx="1790">2148</cx:pt>
          <cx:pt idx="1791">2603</cx:pt>
          <cx:pt idx="1792">2820</cx:pt>
          <cx:pt idx="1793">2522</cx:pt>
          <cx:pt idx="1794">2496</cx:pt>
          <cx:pt idx="1795">2367</cx:pt>
          <cx:pt idx="1796">2510</cx:pt>
          <cx:pt idx="1797">2629</cx:pt>
          <cx:pt idx="1798">2137</cx:pt>
          <cx:pt idx="1799">2402</cx:pt>
          <cx:pt idx="1800">2315</cx:pt>
          <cx:pt idx="1801">2058</cx:pt>
          <cx:pt idx="1802">2725</cx:pt>
          <cx:pt idx="1803">2507</cx:pt>
          <cx:pt idx="1804">2430</cx:pt>
          <cx:pt idx="1805">2437</cx:pt>
          <cx:pt idx="1806">2795</cx:pt>
          <cx:pt idx="1807">3065</cx:pt>
          <cx:pt idx="1808">2808</cx:pt>
          <cx:pt idx="1809">2531</cx:pt>
          <cx:pt idx="1810">2555</cx:pt>
          <cx:pt idx="1811">2755</cx:pt>
          <cx:pt idx="1812">2784</cx:pt>
          <cx:pt idx="1813">2770</cx:pt>
          <cx:pt idx="1814">2588</cx:pt>
          <cx:pt idx="1815">2420</cx:pt>
          <cx:pt idx="1816">2426</cx:pt>
          <cx:pt idx="1817">2727</cx:pt>
          <cx:pt idx="1818">3036</cx:pt>
          <cx:pt idx="1819">2516</cx:pt>
          <cx:pt idx="1820">2556</cx:pt>
          <cx:pt idx="1821">2462</cx:pt>
          <cx:pt idx="1822">3204</cx:pt>
          <cx:pt idx="1823">2318</cx:pt>
          <cx:pt idx="1824">2174</cx:pt>
          <cx:pt idx="1825">2513</cx:pt>
          <cx:pt idx="1826">2306</cx:pt>
          <cx:pt idx="1827">2681</cx:pt>
          <cx:pt idx="1828">2793</cx:pt>
          <cx:pt idx="1829">2488</cx:pt>
          <cx:pt idx="1830">2698</cx:pt>
          <cx:pt idx="1831">2774</cx:pt>
          <cx:pt idx="1832">2426</cx:pt>
          <cx:pt idx="1833">2605</cx:pt>
          <cx:pt idx="1834">2589</cx:pt>
          <cx:pt idx="1835">2925</cx:pt>
          <cx:pt idx="1836">2436</cx:pt>
          <cx:pt idx="1837">3071</cx:pt>
          <cx:pt idx="1838">2353</cx:pt>
          <cx:pt idx="1839">2959</cx:pt>
          <cx:pt idx="1840">2481</cx:pt>
          <cx:pt idx="1841">2856</cx:pt>
          <cx:pt idx="1842">2468</cx:pt>
          <cx:pt idx="1843">2481</cx:pt>
          <cx:pt idx="1844">2811</cx:pt>
          <cx:pt idx="1845">2563</cx:pt>
          <cx:pt idx="1846">2569</cx:pt>
          <cx:pt idx="1847">2741</cx:pt>
          <cx:pt idx="1848">2831</cx:pt>
          <cx:pt idx="1849">2435</cx:pt>
          <cx:pt idx="1850">2659</cx:pt>
          <cx:pt idx="1851">3085</cx:pt>
          <cx:pt idx="1852">2491</cx:pt>
          <cx:pt idx="1853">2748</cx:pt>
          <cx:pt idx="1854">2912</cx:pt>
          <cx:pt idx="1855">2675</cx:pt>
          <cx:pt idx="1856">2564</cx:pt>
          <cx:pt idx="1857">2927</cx:pt>
          <cx:pt idx="1858">2562</cx:pt>
          <cx:pt idx="1859">2488</cx:pt>
          <cx:pt idx="1860">2461</cx:pt>
          <cx:pt idx="1861">2621</cx:pt>
          <cx:pt idx="1862">2916</cx:pt>
          <cx:pt idx="1863">2349</cx:pt>
          <cx:pt idx="1864">2801</cx:pt>
          <cx:pt idx="1865">2817</cx:pt>
          <cx:pt idx="1866">2488</cx:pt>
          <cx:pt idx="1867">2284</cx:pt>
          <cx:pt idx="1868">2548</cx:pt>
          <cx:pt idx="1869">2325</cx:pt>
          <cx:pt idx="1870">2515</cx:pt>
          <cx:pt idx="1871">2921</cx:pt>
          <cx:pt idx="1872">2930</cx:pt>
          <cx:pt idx="1873">2381</cx:pt>
          <cx:pt idx="1874">2456</cx:pt>
          <cx:pt idx="1875">2655</cx:pt>
          <cx:pt idx="1876">2796</cx:pt>
          <cx:pt idx="1877">2690</cx:pt>
          <cx:pt idx="1878">2852</cx:pt>
          <cx:pt idx="1879">2809</cx:pt>
          <cx:pt idx="1880">2699</cx:pt>
          <cx:pt idx="1881">2646</cx:pt>
          <cx:pt idx="1882">2238</cx:pt>
          <cx:pt idx="1883">2400</cx:pt>
          <cx:pt idx="1884">2223</cx:pt>
          <cx:pt idx="1885">2805</cx:pt>
          <cx:pt idx="1886">2441</cx:pt>
          <cx:pt idx="1887">2524</cx:pt>
          <cx:pt idx="1888">2738</cx:pt>
          <cx:pt idx="1889">2209</cx:pt>
          <cx:pt idx="1890">2408</cx:pt>
          <cx:pt idx="1891">2374</cx:pt>
          <cx:pt idx="1892">2681</cx:pt>
          <cx:pt idx="1893">2676</cx:pt>
          <cx:pt idx="1894">2581</cx:pt>
          <cx:pt idx="1895">2215</cx:pt>
          <cx:pt idx="1896">2853</cx:pt>
          <cx:pt idx="1897">2453</cx:pt>
          <cx:pt idx="1898">2504</cx:pt>
          <cx:pt idx="1899">2445</cx:pt>
          <cx:pt idx="1900">2566</cx:pt>
          <cx:pt idx="1901">2624</cx:pt>
          <cx:pt idx="1902">2676</cx:pt>
          <cx:pt idx="1903">2599</cx:pt>
          <cx:pt idx="1904">2536</cx:pt>
          <cx:pt idx="1905">2475</cx:pt>
          <cx:pt idx="1906">2681</cx:pt>
          <cx:pt idx="1907">2632</cx:pt>
          <cx:pt idx="1908">2509</cx:pt>
          <cx:pt idx="1909">2833</cx:pt>
          <cx:pt idx="1910">2795</cx:pt>
          <cx:pt idx="1911">2817</cx:pt>
          <cx:pt idx="1912">2846</cx:pt>
          <cx:pt idx="1913">2820</cx:pt>
          <cx:pt idx="1914">2348</cx:pt>
          <cx:pt idx="1915">2992</cx:pt>
          <cx:pt idx="1916">2585</cx:pt>
          <cx:pt idx="1917">2736</cx:pt>
          <cx:pt idx="1918">2443</cx:pt>
          <cx:pt idx="1919">2962</cx:pt>
          <cx:pt idx="1920">2645</cx:pt>
          <cx:pt idx="1921">2171</cx:pt>
          <cx:pt idx="1922">2383</cx:pt>
          <cx:pt idx="1923">2298</cx:pt>
          <cx:pt idx="1924">2709</cx:pt>
          <cx:pt idx="1925">2523</cx:pt>
          <cx:pt idx="1926">2837</cx:pt>
          <cx:pt idx="1927">2548</cx:pt>
          <cx:pt idx="1928">2476</cx:pt>
          <cx:pt idx="1929">2606</cx:pt>
          <cx:pt idx="1930">3064</cx:pt>
          <cx:pt idx="1931">2706</cx:pt>
          <cx:pt idx="1932">2475</cx:pt>
          <cx:pt idx="1933">2280</cx:pt>
          <cx:pt idx="1934">2140</cx:pt>
          <cx:pt idx="1935">2686</cx:pt>
          <cx:pt idx="1936">2211</cx:pt>
          <cx:pt idx="1937">2421</cx:pt>
          <cx:pt idx="1938">2845</cx:pt>
          <cx:pt idx="1939">3115</cx:pt>
          <cx:pt idx="1940">2753</cx:pt>
          <cx:pt idx="1941">2980</cx:pt>
          <cx:pt idx="1942">2917</cx:pt>
          <cx:pt idx="1943">3106</cx:pt>
          <cx:pt idx="1944">2843</cx:pt>
          <cx:pt idx="1945">2892</cx:pt>
          <cx:pt idx="1946">2877</cx:pt>
          <cx:pt idx="1947">2940</cx:pt>
          <cx:pt idx="1948">2687</cx:pt>
          <cx:pt idx="1949">3022</cx:pt>
          <cx:pt idx="1950">2618</cx:pt>
          <cx:pt idx="1951">2597</cx:pt>
          <cx:pt idx="1952">2874</cx:pt>
          <cx:pt idx="1953">2792</cx:pt>
          <cx:pt idx="1954">2748</cx:pt>
          <cx:pt idx="1955">2709</cx:pt>
          <cx:pt idx="1956">2876</cx:pt>
          <cx:pt idx="1957">2430</cx:pt>
          <cx:pt idx="1958">2491</cx:pt>
          <cx:pt idx="1959">3013</cx:pt>
          <cx:pt idx="1960">2992</cx:pt>
          <cx:pt idx="1961">3087</cx:pt>
          <cx:pt idx="1962">2749</cx:pt>
          <cx:pt idx="1963">2527</cx:pt>
          <cx:pt idx="1964">2634</cx:pt>
          <cx:pt idx="1965">2773</cx:pt>
          <cx:pt idx="1966">2622</cx:pt>
          <cx:pt idx="1967">2495</cx:pt>
          <cx:pt idx="1968">2522</cx:pt>
          <cx:pt idx="1969">2302</cx:pt>
          <cx:pt idx="1970">2179</cx:pt>
          <cx:pt idx="1971">2383</cx:pt>
          <cx:pt idx="1972">2325</cx:pt>
          <cx:pt idx="1973">2718</cx:pt>
          <cx:pt idx="1974">2902</cx:pt>
          <cx:pt idx="1975">2443</cx:pt>
          <cx:pt idx="1976">2223</cx:pt>
          <cx:pt idx="1977">2605</cx:pt>
          <cx:pt idx="1978">2452</cx:pt>
          <cx:pt idx="1979">2288</cx:pt>
          <cx:pt idx="1980">2425</cx:pt>
          <cx:pt idx="1981">2501</cx:pt>
          <cx:pt idx="1982">2769</cx:pt>
          <cx:pt idx="1983">2950</cx:pt>
          <cx:pt idx="1984">2524</cx:pt>
          <cx:pt idx="1985">2681</cx:pt>
          <cx:pt idx="1986">2474</cx:pt>
          <cx:pt idx="1987">2457</cx:pt>
          <cx:pt idx="1988">2501</cx:pt>
          <cx:pt idx="1989">2837</cx:pt>
          <cx:pt idx="1990">2524</cx:pt>
          <cx:pt idx="1991">2850</cx:pt>
          <cx:pt idx="1992">2805</cx:pt>
          <cx:pt idx="1993">2624</cx:pt>
          <cx:pt idx="1994">2987</cx:pt>
          <cx:pt idx="1995">2597</cx:pt>
          <cx:pt idx="1996">2585</cx:pt>
          <cx:pt idx="1997">2687</cx:pt>
          <cx:pt idx="1998">2813</cx:pt>
          <cx:pt idx="1999">2787</cx:pt>
          <cx:pt idx="2000">2782</cx:pt>
          <cx:pt idx="2001">2629</cx:pt>
          <cx:pt idx="2002">2407</cx:pt>
          <cx:pt idx="2003">2677</cx:pt>
          <cx:pt idx="2004">2330</cx:pt>
          <cx:pt idx="2005">2603</cx:pt>
          <cx:pt idx="2006">2597</cx:pt>
          <cx:pt idx="2007">2366</cx:pt>
          <cx:pt idx="2008">2491</cx:pt>
          <cx:pt idx="2009">2391</cx:pt>
          <cx:pt idx="2010">2164</cx:pt>
          <cx:pt idx="2011">2070</cx:pt>
          <cx:pt idx="2012">2493</cx:pt>
          <cx:pt idx="2013">2777</cx:pt>
          <cx:pt idx="2014">2450</cx:pt>
          <cx:pt idx="2015">2501</cx:pt>
          <cx:pt idx="2016">2545</cx:pt>
          <cx:pt idx="2017">2315</cx:pt>
          <cx:pt idx="2018">2604</cx:pt>
          <cx:pt idx="2019">2941</cx:pt>
          <cx:pt idx="2020">2353</cx:pt>
          <cx:pt idx="2021">2893</cx:pt>
          <cx:pt idx="2022">2255</cx:pt>
          <cx:pt idx="2023">2789</cx:pt>
          <cx:pt idx="2024">2549</cx:pt>
          <cx:pt idx="2025">2675</cx:pt>
          <cx:pt idx="2026">2514</cx:pt>
          <cx:pt idx="2027">2186</cx:pt>
          <cx:pt idx="2028">2564</cx:pt>
          <cx:pt idx="2029">2690</cx:pt>
          <cx:pt idx="2030">2232</cx:pt>
          <cx:pt idx="2031">2252</cx:pt>
          <cx:pt idx="2032">2581</cx:pt>
          <cx:pt idx="2033">2294</cx:pt>
          <cx:pt idx="2034">2304</cx:pt>
          <cx:pt idx="2035">2496</cx:pt>
          <cx:pt idx="2036">2318</cx:pt>
          <cx:pt idx="2037">2340</cx:pt>
          <cx:pt idx="2038">2551</cx:pt>
          <cx:pt idx="2039">2439</cx:pt>
          <cx:pt idx="2040">2627</cx:pt>
          <cx:pt idx="2041">2501</cx:pt>
          <cx:pt idx="2042">2810</cx:pt>
          <cx:pt idx="2043">2561</cx:pt>
          <cx:pt idx="2044">2929</cx:pt>
          <cx:pt idx="2045">2927</cx:pt>
          <cx:pt idx="2046">2382</cx:pt>
          <cx:pt idx="2047">2974</cx:pt>
          <cx:pt idx="2048">2287</cx:pt>
          <cx:pt idx="2049">2293</cx:pt>
          <cx:pt idx="2050">2426</cx:pt>
          <cx:pt idx="2051">2337</cx:pt>
          <cx:pt idx="2052">2481</cx:pt>
          <cx:pt idx="2053">2635</cx:pt>
          <cx:pt idx="2054">2235</cx:pt>
          <cx:pt idx="2055">2239</cx:pt>
          <cx:pt idx="2056">2324</cx:pt>
          <cx:pt idx="2057">2649</cx:pt>
          <cx:pt idx="2058">2543</cx:pt>
          <cx:pt idx="2059">2095</cx:pt>
          <cx:pt idx="2060">2175</cx:pt>
          <cx:pt idx="2061">2438</cx:pt>
          <cx:pt idx="2062">2279</cx:pt>
          <cx:pt idx="2063">2563</cx:pt>
          <cx:pt idx="2064">2743</cx:pt>
          <cx:pt idx="2065">2642</cx:pt>
          <cx:pt idx="2066">2533</cx:pt>
          <cx:pt idx="2067">2592</cx:pt>
          <cx:pt idx="2068">2725</cx:pt>
          <cx:pt idx="2069">2280</cx:pt>
          <cx:pt idx="2070">2588</cx:pt>
          <cx:pt idx="2071">2255</cx:pt>
          <cx:pt idx="2072">2908</cx:pt>
          <cx:pt idx="2073">2744</cx:pt>
          <cx:pt idx="2074">2842</cx:pt>
          <cx:pt idx="2075">2744</cx:pt>
          <cx:pt idx="2076">2462</cx:pt>
          <cx:pt idx="2077">2744</cx:pt>
          <cx:pt idx="2078">2492</cx:pt>
          <cx:pt idx="2079">2562</cx:pt>
          <cx:pt idx="2080">2859</cx:pt>
          <cx:pt idx="2081">2472</cx:pt>
          <cx:pt idx="2082">2471</cx:pt>
          <cx:pt idx="2083">2545</cx:pt>
          <cx:pt idx="2084">2520</cx:pt>
          <cx:pt idx="2085">2616</cx:pt>
          <cx:pt idx="2086">2675</cx:pt>
          <cx:pt idx="2087">2459</cx:pt>
          <cx:pt idx="2088">2572</cx:pt>
          <cx:pt idx="2089">2812</cx:pt>
          <cx:pt idx="2090">2176</cx:pt>
          <cx:pt idx="2091">2394</cx:pt>
          <cx:pt idx="2092">2577</cx:pt>
          <cx:pt idx="2093">2643</cx:pt>
          <cx:pt idx="2094">2534</cx:pt>
          <cx:pt idx="2095">2726</cx:pt>
          <cx:pt idx="2096">2701</cx:pt>
          <cx:pt idx="2097">2858</cx:pt>
          <cx:pt idx="2098">2823</cx:pt>
          <cx:pt idx="2099">2528</cx:pt>
          <cx:pt idx="2100">2605</cx:pt>
          <cx:pt idx="2101">2565</cx:pt>
          <cx:pt idx="2102">2703</cx:pt>
          <cx:pt idx="2103">2321</cx:pt>
          <cx:pt idx="2104">2340</cx:pt>
          <cx:pt idx="2105">2685</cx:pt>
          <cx:pt idx="2106">2471</cx:pt>
          <cx:pt idx="2107">3159</cx:pt>
          <cx:pt idx="2108">2660</cx:pt>
          <cx:pt idx="2109">2753</cx:pt>
          <cx:pt idx="2110">2624</cx:pt>
          <cx:pt idx="2111">2410</cx:pt>
          <cx:pt idx="2112">2179</cx:pt>
          <cx:pt idx="2113">2502</cx:pt>
          <cx:pt idx="2114">2397</cx:pt>
          <cx:pt idx="2115">2454</cx:pt>
          <cx:pt idx="2116">2569</cx:pt>
          <cx:pt idx="2117">2537</cx:pt>
          <cx:pt idx="2118">2076</cx:pt>
          <cx:pt idx="2119">2328</cx:pt>
          <cx:pt idx="2120">2231</cx:pt>
          <cx:pt idx="2121">2072</cx:pt>
          <cx:pt idx="2122">2404</cx:pt>
          <cx:pt idx="2123">2317</cx:pt>
          <cx:pt idx="2124">1935</cx:pt>
          <cx:pt idx="2125">2655</cx:pt>
          <cx:pt idx="2126">2239</cx:pt>
          <cx:pt idx="2127">2161</cx:pt>
          <cx:pt idx="2128">2416</cx:pt>
          <cx:pt idx="2129">2484</cx:pt>
          <cx:pt idx="2130">2234</cx:pt>
          <cx:pt idx="2131">2266</cx:pt>
          <cx:pt idx="2132">2250</cx:pt>
          <cx:pt idx="2133">2436</cx:pt>
          <cx:pt idx="2134">2400</cx:pt>
          <cx:pt idx="2135">2108</cx:pt>
          <cx:pt idx="2136">2079</cx:pt>
          <cx:pt idx="2137">2311</cx:pt>
          <cx:pt idx="2138">2261</cx:pt>
          <cx:pt idx="2139">2702</cx:pt>
          <cx:pt idx="2140">2248</cx:pt>
          <cx:pt idx="2141">1847</cx:pt>
          <cx:pt idx="2142">2275</cx:pt>
          <cx:pt idx="2143">2409</cx:pt>
          <cx:pt idx="2144">2481</cx:pt>
          <cx:pt idx="2145">2243</cx:pt>
          <cx:pt idx="2146">2175</cx:pt>
          <cx:pt idx="2147">2496</cx:pt>
          <cx:pt idx="2148">2015</cx:pt>
          <cx:pt idx="2149">2777</cx:pt>
          <cx:pt idx="2150">2523</cx:pt>
          <cx:pt idx="2151">2339</cx:pt>
          <cx:pt idx="2152">2217</cx:pt>
          <cx:pt idx="2153">2773</cx:pt>
          <cx:pt idx="2154">2235</cx:pt>
          <cx:pt idx="2155">2260</cx:pt>
          <cx:pt idx="2156">2324</cx:pt>
          <cx:pt idx="2157">2245</cx:pt>
          <cx:pt idx="2158">2277</cx:pt>
          <cx:pt idx="2159">2039</cx:pt>
          <cx:pt idx="2160">1960</cx:pt>
          <cx:pt idx="2161">2526</cx:pt>
          <cx:pt idx="2162">2332</cx:pt>
          <cx:pt idx="2163">2570</cx:pt>
          <cx:pt idx="2164">2402</cx:pt>
          <cx:pt idx="2165">2429</cx:pt>
          <cx:pt idx="2166">2384</cx:pt>
          <cx:pt idx="2167">2391</cx:pt>
          <cx:pt idx="2168">2922</cx:pt>
          <cx:pt idx="2169">2923</cx:pt>
          <cx:pt idx="2170">2504</cx:pt>
          <cx:pt idx="2171">2760</cx:pt>
          <cx:pt idx="2172">2459</cx:pt>
          <cx:pt idx="2173">2454</cx:pt>
          <cx:pt idx="2174">3000</cx:pt>
          <cx:pt idx="2175">2192</cx:pt>
          <cx:pt idx="2176">2890</cx:pt>
          <cx:pt idx="2177">2540</cx:pt>
          <cx:pt idx="2178">2344</cx:pt>
          <cx:pt idx="2179">2525</cx:pt>
          <cx:pt idx="2180">2813</cx:pt>
          <cx:pt idx="2181">2655</cx:pt>
          <cx:pt idx="2182">2267</cx:pt>
          <cx:pt idx="2183">2860</cx:pt>
          <cx:pt idx="2184">2406</cx:pt>
          <cx:pt idx="2185">2657</cx:pt>
          <cx:pt idx="2186">2573</cx:pt>
          <cx:pt idx="2187">2960</cx:pt>
          <cx:pt idx="2188">2703</cx:pt>
          <cx:pt idx="2189">2452</cx:pt>
          <cx:pt idx="2190">2628</cx:pt>
          <cx:pt idx="2191">2850</cx:pt>
          <cx:pt idx="2192">2693</cx:pt>
          <cx:pt idx="2193">2600</cx:pt>
          <cx:pt idx="2194">2423</cx:pt>
          <cx:pt idx="2195">2984</cx:pt>
          <cx:pt idx="2196">2756</cx:pt>
          <cx:pt idx="2197">2951</cx:pt>
          <cx:pt idx="2198">2696</cx:pt>
          <cx:pt idx="2199">3056</cx:pt>
          <cx:pt idx="2200">2515</cx:pt>
          <cx:pt idx="2201">2646</cx:pt>
          <cx:pt idx="2202">2832</cx:pt>
          <cx:pt idx="2203">3027</cx:pt>
          <cx:pt idx="2204">2508</cx:pt>
          <cx:pt idx="2205">2902</cx:pt>
          <cx:pt idx="2206">2678</cx:pt>
          <cx:pt idx="2207">2855</cx:pt>
          <cx:pt idx="2208">2456</cx:pt>
          <cx:pt idx="2209">2280</cx:pt>
          <cx:pt idx="2210">2988</cx:pt>
          <cx:pt idx="2211">2769</cx:pt>
          <cx:pt idx="2212">2762</cx:pt>
          <cx:pt idx="2213">2785</cx:pt>
          <cx:pt idx="2214">2518</cx:pt>
          <cx:pt idx="2215">2625</cx:pt>
          <cx:pt idx="2216">2480</cx:pt>
          <cx:pt idx="2217">2736</cx:pt>
          <cx:pt idx="2218">2597</cx:pt>
          <cx:pt idx="2219">2934</cx:pt>
          <cx:pt idx="2220">2600</cx:pt>
          <cx:pt idx="2221">2595</cx:pt>
          <cx:pt idx="2222">2485</cx:pt>
          <cx:pt idx="2223">2497</cx:pt>
          <cx:pt idx="2224">2709</cx:pt>
          <cx:pt idx="2225">2752</cx:pt>
          <cx:pt idx="2226">2709</cx:pt>
          <cx:pt idx="2227">2377</cx:pt>
          <cx:pt idx="2228">2638</cx:pt>
          <cx:pt idx="2229">2800</cx:pt>
          <cx:pt idx="2230">2754</cx:pt>
          <cx:pt idx="2231">2617</cx:pt>
          <cx:pt idx="2232">2566</cx:pt>
          <cx:pt idx="2233">2844</cx:pt>
          <cx:pt idx="2234">2815</cx:pt>
          <cx:pt idx="2235">2835</cx:pt>
          <cx:pt idx="2236">2598</cx:pt>
          <cx:pt idx="2237">2419</cx:pt>
          <cx:pt idx="2238">2181</cx:pt>
          <cx:pt idx="2239">2549</cx:pt>
          <cx:pt idx="2240">2336</cx:pt>
          <cx:pt idx="2241">2710</cx:pt>
          <cx:pt idx="2242">2746</cx:pt>
          <cx:pt idx="2243">2723</cx:pt>
          <cx:pt idx="2244">2720</cx:pt>
          <cx:pt idx="2245">2449</cx:pt>
          <cx:pt idx="2246">2793</cx:pt>
          <cx:pt idx="2247">2803</cx:pt>
          <cx:pt idx="2248">2824</cx:pt>
          <cx:pt idx="2249">2365</cx:pt>
          <cx:pt idx="2250">2798</cx:pt>
          <cx:pt idx="2251">2702</cx:pt>
          <cx:pt idx="2252">2528</cx:pt>
          <cx:pt idx="2253">2584</cx:pt>
          <cx:pt idx="2254">2860</cx:pt>
          <cx:pt idx="2255">2646</cx:pt>
          <cx:pt idx="2256">2835</cx:pt>
          <cx:pt idx="2257">2926</cx:pt>
          <cx:pt idx="2258">2910</cx:pt>
          <cx:pt idx="2259">2776</cx:pt>
          <cx:pt idx="2260">2745</cx:pt>
          <cx:pt idx="2261">2565</cx:pt>
          <cx:pt idx="2262">2794</cx:pt>
          <cx:pt idx="2263">2490</cx:pt>
          <cx:pt idx="2264">2420</cx:pt>
          <cx:pt idx="2265">2315</cx:pt>
          <cx:pt idx="2266">2916</cx:pt>
          <cx:pt idx="2267">2972</cx:pt>
          <cx:pt idx="2268">2781</cx:pt>
          <cx:pt idx="2269">2890</cx:pt>
          <cx:pt idx="2270">3391</cx:pt>
          <cx:pt idx="2271">2586</cx:pt>
          <cx:pt idx="2272">2501</cx:pt>
          <cx:pt idx="2273">2838</cx:pt>
          <cx:pt idx="2274">3087</cx:pt>
          <cx:pt idx="2275">3309</cx:pt>
          <cx:pt idx="2276">2977</cx:pt>
          <cx:pt idx="2277">2912</cx:pt>
          <cx:pt idx="2278">2651</cx:pt>
          <cx:pt idx="2279">2491</cx:pt>
          <cx:pt idx="2280">2451</cx:pt>
          <cx:pt idx="2281">2801</cx:pt>
          <cx:pt idx="2282">2553</cx:pt>
          <cx:pt idx="2283">2549</cx:pt>
          <cx:pt idx="2284">2804</cx:pt>
          <cx:pt idx="2285">2816</cx:pt>
          <cx:pt idx="2286">2547</cx:pt>
          <cx:pt idx="2287">3124</cx:pt>
          <cx:pt idx="2288">3179</cx:pt>
          <cx:pt idx="2289">2795</cx:pt>
          <cx:pt idx="2290">3127</cx:pt>
          <cx:pt idx="2291">2963</cx:pt>
          <cx:pt idx="2292">3041</cx:pt>
          <cx:pt idx="2293">2509</cx:pt>
          <cx:pt idx="2294">2948</cx:pt>
          <cx:pt idx="2295">2401</cx:pt>
          <cx:pt idx="2296">2794</cx:pt>
          <cx:pt idx="2297">2695</cx:pt>
          <cx:pt idx="2298">3071</cx:pt>
          <cx:pt idx="2299">2974</cx:pt>
          <cx:pt idx="2300">2438</cx:pt>
          <cx:pt idx="2301">2848</cx:pt>
          <cx:pt idx="2302">2670</cx:pt>
          <cx:pt idx="2303">2894</cx:pt>
          <cx:pt idx="2304">2795</cx:pt>
          <cx:pt idx="2305">2631</cx:pt>
          <cx:pt idx="2306">2898</cx:pt>
          <cx:pt idx="2307">2820</cx:pt>
          <cx:pt idx="2308">3110</cx:pt>
          <cx:pt idx="2309">3221</cx:pt>
          <cx:pt idx="2310">3032</cx:pt>
          <cx:pt idx="2311">3141</cx:pt>
          <cx:pt idx="2312">2839</cx:pt>
          <cx:pt idx="2313">2740</cx:pt>
          <cx:pt idx="2314">3398</cx:pt>
          <cx:pt idx="2315">2902</cx:pt>
          <cx:pt idx="2316">2484</cx:pt>
          <cx:pt idx="2317">2558</cx:pt>
          <cx:pt idx="2318">3150</cx:pt>
          <cx:pt idx="2319">2883</cx:pt>
          <cx:pt idx="2320">2828</cx:pt>
          <cx:pt idx="2321">2741</cx:pt>
          <cx:pt idx="2322">2864</cx:pt>
          <cx:pt idx="2323">3260</cx:pt>
          <cx:pt idx="2324">2831</cx:pt>
          <cx:pt idx="2325">2681</cx:pt>
          <cx:pt idx="2326">3271</cx:pt>
          <cx:pt idx="2327">2956</cx:pt>
          <cx:pt idx="2328">3213</cx:pt>
          <cx:pt idx="2329">3143</cx:pt>
          <cx:pt idx="2330">2983</cx:pt>
          <cx:pt idx="2331">3007</cx:pt>
          <cx:pt idx="2332">2614</cx:pt>
          <cx:pt idx="2333">2911</cx:pt>
          <cx:pt idx="2334">2517</cx:pt>
          <cx:pt idx="2335">2874</cx:pt>
          <cx:pt idx="2336">2585</cx:pt>
          <cx:pt idx="2337">3010</cx:pt>
          <cx:pt idx="2338">2832</cx:pt>
          <cx:pt idx="2339">2722</cx:pt>
          <cx:pt idx="2340">2935</cx:pt>
          <cx:pt idx="2341">2983</cx:pt>
          <cx:pt idx="2342">2548</cx:pt>
          <cx:pt idx="2343">2397</cx:pt>
          <cx:pt idx="2344">2732</cx:pt>
          <cx:pt idx="2345">2698</cx:pt>
          <cx:pt idx="2346">2901</cx:pt>
          <cx:pt idx="2347">2479</cx:pt>
          <cx:pt idx="2348">2821</cx:pt>
          <cx:pt idx="2349">2716</cx:pt>
          <cx:pt idx="2350">2465</cx:pt>
          <cx:pt idx="2351">2249</cx:pt>
          <cx:pt idx="2352">2828</cx:pt>
          <cx:pt idx="2353">2416</cx:pt>
          <cx:pt idx="2354">2900</cx:pt>
          <cx:pt idx="2355">2650</cx:pt>
          <cx:pt idx="2356">2379</cx:pt>
          <cx:pt idx="2357">2439</cx:pt>
          <cx:pt idx="2358">2913</cx:pt>
          <cx:pt idx="2359">2288</cx:pt>
          <cx:pt idx="2360">2424</cx:pt>
          <cx:pt idx="2361">2854</cx:pt>
          <cx:pt idx="2362">2617</cx:pt>
          <cx:pt idx="2363">3117</cx:pt>
          <cx:pt idx="2364">2540</cx:pt>
          <cx:pt idx="2365">2779</cx:pt>
          <cx:pt idx="2366">3043</cx:pt>
          <cx:pt idx="2367">2896</cx:pt>
          <cx:pt idx="2368">2901</cx:pt>
          <cx:pt idx="2369">2812</cx:pt>
          <cx:pt idx="2370">2963</cx:pt>
          <cx:pt idx="2371">2637</cx:pt>
          <cx:pt idx="2372">2670</cx:pt>
          <cx:pt idx="2373">2891</cx:pt>
          <cx:pt idx="2374">3097</cx:pt>
          <cx:pt idx="2375">2620</cx:pt>
          <cx:pt idx="2376">2783</cx:pt>
          <cx:pt idx="2377">2720</cx:pt>
          <cx:pt idx="2378">2906</cx:pt>
          <cx:pt idx="2379">2685</cx:pt>
          <cx:pt idx="2380">2604</cx:pt>
          <cx:pt idx="2381">2638</cx:pt>
          <cx:pt idx="2382">2631</cx:pt>
          <cx:pt idx="2383">2721</cx:pt>
          <cx:pt idx="2384">2910</cx:pt>
          <cx:pt idx="2385">2395</cx:pt>
          <cx:pt idx="2386">2442</cx:pt>
          <cx:pt idx="2387">2765</cx:pt>
          <cx:pt idx="2388">2209</cx:pt>
          <cx:pt idx="2389">2844</cx:pt>
          <cx:pt idx="2390">2389</cx:pt>
          <cx:pt idx="2391">3032</cx:pt>
          <cx:pt idx="2392">2468</cx:pt>
          <cx:pt idx="2393">2249</cx:pt>
          <cx:pt idx="2394">2786</cx:pt>
          <cx:pt idx="2395">2422</cx:pt>
          <cx:pt idx="2396">2355</cx:pt>
          <cx:pt idx="2397">2659</cx:pt>
          <cx:pt idx="2398">2435</cx:pt>
          <cx:pt idx="2399">2557</cx:pt>
          <cx:pt idx="2400">2621</cx:pt>
          <cx:pt idx="2401">2453</cx:pt>
          <cx:pt idx="2402">2383</cx:pt>
          <cx:pt idx="2403">2659</cx:pt>
          <cx:pt idx="2404">2565</cx:pt>
          <cx:pt idx="2405">2483</cx:pt>
          <cx:pt idx="2406">2443</cx:pt>
          <cx:pt idx="2407">2609</cx:pt>
          <cx:pt idx="2408">2700</cx:pt>
          <cx:pt idx="2409">2567</cx:pt>
          <cx:pt idx="2410">2390</cx:pt>
          <cx:pt idx="2411">2863</cx:pt>
          <cx:pt idx="2412">2681</cx:pt>
          <cx:pt idx="2413">2815</cx:pt>
          <cx:pt idx="2414">2451</cx:pt>
          <cx:pt idx="2415">2398</cx:pt>
          <cx:pt idx="2416">2511</cx:pt>
          <cx:pt idx="2417">2516</cx:pt>
          <cx:pt idx="2418">2579</cx:pt>
          <cx:pt idx="2419">2694</cx:pt>
          <cx:pt idx="2420">2391</cx:pt>
          <cx:pt idx="2421">2251</cx:pt>
          <cx:pt idx="2422">2630</cx:pt>
          <cx:pt idx="2423">2247</cx:pt>
          <cx:pt idx="2424">2343</cx:pt>
          <cx:pt idx="2425">2578</cx:pt>
          <cx:pt idx="2426">2510</cx:pt>
          <cx:pt idx="2427">2264</cx:pt>
          <cx:pt idx="2428">2655</cx:pt>
          <cx:pt idx="2429">2901</cx:pt>
          <cx:pt idx="2430">2132</cx:pt>
          <cx:pt idx="2431">2525</cx:pt>
          <cx:pt idx="2432">2716</cx:pt>
          <cx:pt idx="2433">3022</cx:pt>
          <cx:pt idx="2434">2884</cx:pt>
          <cx:pt idx="2435">2782</cx:pt>
          <cx:pt idx="2436">2502</cx:pt>
          <cx:pt idx="2437">2743</cx:pt>
          <cx:pt idx="2438">2571</cx:pt>
          <cx:pt idx="2439">2633</cx:pt>
          <cx:pt idx="2440">2429</cx:pt>
          <cx:pt idx="2441">2270</cx:pt>
          <cx:pt idx="2442">2906</cx:pt>
          <cx:pt idx="2443">2851</cx:pt>
          <cx:pt idx="2444">2137</cx:pt>
          <cx:pt idx="2445">2648</cx:pt>
          <cx:pt idx="2446">2259</cx:pt>
          <cx:pt idx="2447">2282</cx:pt>
          <cx:pt idx="2448">2668</cx:pt>
          <cx:pt idx="2449">2451</cx:pt>
          <cx:pt idx="2450">2446</cx:pt>
          <cx:pt idx="2451">2405</cx:pt>
          <cx:pt idx="2452">2525</cx:pt>
          <cx:pt idx="2453">2406</cx:pt>
          <cx:pt idx="2454">2543</cx:pt>
          <cx:pt idx="2455">2392</cx:pt>
          <cx:pt idx="2456">2820</cx:pt>
          <cx:pt idx="2457">2783</cx:pt>
          <cx:pt idx="2458">2428</cx:pt>
          <cx:pt idx="2459">2350</cx:pt>
          <cx:pt idx="2460">2645</cx:pt>
          <cx:pt idx="2461">2514</cx:pt>
          <cx:pt idx="2462">2825</cx:pt>
          <cx:pt idx="2463">2917</cx:pt>
          <cx:pt idx="2464">2309</cx:pt>
          <cx:pt idx="2465">2620</cx:pt>
          <cx:pt idx="2466">2619</cx:pt>
          <cx:pt idx="2467">2528</cx:pt>
          <cx:pt idx="2468">2781</cx:pt>
          <cx:pt idx="2469">2348</cx:pt>
          <cx:pt idx="2470">2762</cx:pt>
          <cx:pt idx="2471">2559</cx:pt>
          <cx:pt idx="2472">2582</cx:pt>
          <cx:pt idx="2473">2871</cx:pt>
          <cx:pt idx="2474">2604</cx:pt>
          <cx:pt idx="2475">3205</cx:pt>
          <cx:pt idx="2476">2574</cx:pt>
          <cx:pt idx="2477">2218</cx:pt>
          <cx:pt idx="2478">2678</cx:pt>
          <cx:pt idx="2479">2261</cx:pt>
          <cx:pt idx="2480">2488</cx:pt>
          <cx:pt idx="2481">2838</cx:pt>
          <cx:pt idx="2482">2860</cx:pt>
          <cx:pt idx="2483">2391</cx:pt>
          <cx:pt idx="2484">2466</cx:pt>
          <cx:pt idx="2485">2704</cx:pt>
          <cx:pt idx="2486">2539</cx:pt>
          <cx:pt idx="2487">2167</cx:pt>
          <cx:pt idx="2488">2912</cx:pt>
          <cx:pt idx="2489">2557</cx:pt>
          <cx:pt idx="2490">3116</cx:pt>
          <cx:pt idx="2491">2679</cx:pt>
          <cx:pt idx="2492">2498</cx:pt>
          <cx:pt idx="2493">2471</cx:pt>
          <cx:pt idx="2494">2507</cx:pt>
          <cx:pt idx="2495">2764</cx:pt>
          <cx:pt idx="2496">2451</cx:pt>
          <cx:pt idx="2497">2836</cx:pt>
          <cx:pt idx="2498">2254</cx:pt>
          <cx:pt idx="2499">2844</cx:pt>
          <cx:pt idx="2500">2510</cx:pt>
          <cx:pt idx="2501">2922</cx:pt>
          <cx:pt idx="2502">2817</cx:pt>
          <cx:pt idx="2503">2114</cx:pt>
          <cx:pt idx="2504">2932</cx:pt>
          <cx:pt idx="2505">2249</cx:pt>
          <cx:pt idx="2506">2821</cx:pt>
          <cx:pt idx="2507">2693</cx:pt>
          <cx:pt idx="2508">2456</cx:pt>
          <cx:pt idx="2509">2338</cx:pt>
          <cx:pt idx="2510">2988</cx:pt>
          <cx:pt idx="2511">2585</cx:pt>
          <cx:pt idx="2512">2436</cx:pt>
          <cx:pt idx="2513">2586</cx:pt>
          <cx:pt idx="2514">2518</cx:pt>
          <cx:pt idx="2515">2660</cx:pt>
          <cx:pt idx="2516">2731</cx:pt>
          <cx:pt idx="2517">2579</cx:pt>
          <cx:pt idx="2518">2410</cx:pt>
          <cx:pt idx="2519">2802</cx:pt>
          <cx:pt idx="2520">2907</cx:pt>
          <cx:pt idx="2521">2592</cx:pt>
          <cx:pt idx="2522">2547</cx:pt>
          <cx:pt idx="2523">2637</cx:pt>
          <cx:pt idx="2524">2710</cx:pt>
          <cx:pt idx="2525">2128</cx:pt>
          <cx:pt idx="2526">2191</cx:pt>
          <cx:pt idx="2527">2699</cx:pt>
          <cx:pt idx="2528">2808</cx:pt>
          <cx:pt idx="2529">2693</cx:pt>
          <cx:pt idx="2530">2836</cx:pt>
          <cx:pt idx="2531">2212</cx:pt>
          <cx:pt idx="2532">2512</cx:pt>
          <cx:pt idx="2533">2674</cx:pt>
          <cx:pt idx="2534">2428</cx:pt>
          <cx:pt idx="2535">2619</cx:pt>
          <cx:pt idx="2536">2593</cx:pt>
          <cx:pt idx="2537">2423</cx:pt>
          <cx:pt idx="2538">2633</cx:pt>
          <cx:pt idx="2539">2547</cx:pt>
          <cx:pt idx="2540">2115</cx:pt>
          <cx:pt idx="2541">2557</cx:pt>
          <cx:pt idx="2542">3022</cx:pt>
          <cx:pt idx="2543">2344</cx:pt>
          <cx:pt idx="2544">2289</cx:pt>
          <cx:pt idx="2545">2273</cx:pt>
          <cx:pt idx="2546">2434</cx:pt>
          <cx:pt idx="2547">2867</cx:pt>
          <cx:pt idx="2548">3041</cx:pt>
          <cx:pt idx="2549">2775</cx:pt>
          <cx:pt idx="2550">2517</cx:pt>
          <cx:pt idx="2551">2340</cx:pt>
          <cx:pt idx="2552">2326</cx:pt>
          <cx:pt idx="2553">2474</cx:pt>
          <cx:pt idx="2554">2611</cx:pt>
          <cx:pt idx="2555">2272</cx:pt>
          <cx:pt idx="2556">2303</cx:pt>
          <cx:pt idx="2557">2741</cx:pt>
          <cx:pt idx="2558">2654</cx:pt>
          <cx:pt idx="2559">2542</cx:pt>
          <cx:pt idx="2560">2804</cx:pt>
          <cx:pt idx="2561">2924</cx:pt>
          <cx:pt idx="2562">2446</cx:pt>
          <cx:pt idx="2563">2400</cx:pt>
          <cx:pt idx="2564">2396</cx:pt>
          <cx:pt idx="2565">2766</cx:pt>
          <cx:pt idx="2566">2861</cx:pt>
          <cx:pt idx="2567">2936</cx:pt>
          <cx:pt idx="2568">2639</cx:pt>
          <cx:pt idx="2569">2720</cx:pt>
          <cx:pt idx="2570">2444</cx:pt>
          <cx:pt idx="2571">2290</cx:pt>
          <cx:pt idx="2572">2661</cx:pt>
          <cx:pt idx="2573">2938</cx:pt>
          <cx:pt idx="2574">2572</cx:pt>
          <cx:pt idx="2575">3001</cx:pt>
          <cx:pt idx="2576">2836</cx:pt>
          <cx:pt idx="2577">2774</cx:pt>
          <cx:pt idx="2578">2555</cx:pt>
          <cx:pt idx="2579">3008</cx:pt>
          <cx:pt idx="2580">2520</cx:pt>
          <cx:pt idx="2581">2771</cx:pt>
          <cx:pt idx="2582">2553</cx:pt>
          <cx:pt idx="2583">2447</cx:pt>
          <cx:pt idx="2584">2586</cx:pt>
          <cx:pt idx="2585">2496</cx:pt>
          <cx:pt idx="2586">2312</cx:pt>
          <cx:pt idx="2587">2554</cx:pt>
          <cx:pt idx="2588">2639</cx:pt>
          <cx:pt idx="2589">2543</cx:pt>
          <cx:pt idx="2590">2881</cx:pt>
          <cx:pt idx="2591">2578</cx:pt>
          <cx:pt idx="2592">2743</cx:pt>
          <cx:pt idx="2593">2692</cx:pt>
          <cx:pt idx="2594">2779</cx:pt>
          <cx:pt idx="2595">2586</cx:pt>
          <cx:pt idx="2596">2735</cx:pt>
          <cx:pt idx="2597">2231</cx:pt>
          <cx:pt idx="2598">2861</cx:pt>
          <cx:pt idx="2599">2607</cx:pt>
          <cx:pt idx="2600">2681</cx:pt>
          <cx:pt idx="2601">2490</cx:pt>
          <cx:pt idx="2602">2922</cx:pt>
          <cx:pt idx="2603">3038</cx:pt>
          <cx:pt idx="2604">2822</cx:pt>
          <cx:pt idx="2605">2275</cx:pt>
          <cx:pt idx="2606">2446</cx:pt>
          <cx:pt idx="2607">2788</cx:pt>
          <cx:pt idx="2608">2576</cx:pt>
          <cx:pt idx="2609">2339</cx:pt>
          <cx:pt idx="2610">2534</cx:pt>
          <cx:pt idx="2611">2332</cx:pt>
          <cx:pt idx="2612">2379</cx:pt>
          <cx:pt idx="2613">2479</cx:pt>
          <cx:pt idx="2614">2540</cx:pt>
          <cx:pt idx="2615">2514</cx:pt>
          <cx:pt idx="2616">2661</cx:pt>
          <cx:pt idx="2617">2339</cx:pt>
          <cx:pt idx="2618">2208</cx:pt>
          <cx:pt idx="2619">2679</cx:pt>
          <cx:pt idx="2620">2860</cx:pt>
          <cx:pt idx="2621">2588</cx:pt>
          <cx:pt idx="2622">2561</cx:pt>
          <cx:pt idx="2623">2503</cx:pt>
          <cx:pt idx="2624">2349</cx:pt>
          <cx:pt idx="2625">2417</cx:pt>
          <cx:pt idx="2626">2158</cx:pt>
          <cx:pt idx="2627">2695</cx:pt>
          <cx:pt idx="2628">2467</cx:pt>
          <cx:pt idx="2629">2533</cx:pt>
          <cx:pt idx="2630">2364</cx:pt>
          <cx:pt idx="2631">2443</cx:pt>
          <cx:pt idx="2632">2966</cx:pt>
          <cx:pt idx="2633">2193</cx:pt>
          <cx:pt idx="2634">2535</cx:pt>
          <cx:pt idx="2635">2704</cx:pt>
          <cx:pt idx="2636">2867</cx:pt>
          <cx:pt idx="2637">2478</cx:pt>
          <cx:pt idx="2638">2191</cx:pt>
          <cx:pt idx="2639">2590</cx:pt>
          <cx:pt idx="2640">2682</cx:pt>
          <cx:pt idx="2641">2618</cx:pt>
          <cx:pt idx="2642">2229</cx:pt>
          <cx:pt idx="2643">2076</cx:pt>
          <cx:pt idx="2644">2669</cx:pt>
          <cx:pt idx="2645">2202</cx:pt>
          <cx:pt idx="2646">2192</cx:pt>
          <cx:pt idx="2647">2511</cx:pt>
          <cx:pt idx="2648">2724</cx:pt>
          <cx:pt idx="2649">2665</cx:pt>
          <cx:pt idx="2650">2415</cx:pt>
          <cx:pt idx="2651">2520</cx:pt>
          <cx:pt idx="2652">2391</cx:pt>
          <cx:pt idx="2653">2163</cx:pt>
          <cx:pt idx="2654">2400</cx:pt>
          <cx:pt idx="2655">2432</cx:pt>
          <cx:pt idx="2656">2541</cx:pt>
          <cx:pt idx="2657">2216</cx:pt>
          <cx:pt idx="2658">2123</cx:pt>
          <cx:pt idx="2659">2720</cx:pt>
          <cx:pt idx="2660">2424</cx:pt>
          <cx:pt idx="2661">2677</cx:pt>
          <cx:pt idx="2662">2722</cx:pt>
          <cx:pt idx="2663">2309</cx:pt>
          <cx:pt idx="2664">2199</cx:pt>
          <cx:pt idx="2665">2783</cx:pt>
          <cx:pt idx="2666">2457</cx:pt>
          <cx:pt idx="2667">2323</cx:pt>
          <cx:pt idx="2668">2445</cx:pt>
          <cx:pt idx="2669">2382</cx:pt>
          <cx:pt idx="2670">2626</cx:pt>
          <cx:pt idx="2671">2428</cx:pt>
          <cx:pt idx="2672">2695</cx:pt>
          <cx:pt idx="2673">2578</cx:pt>
          <cx:pt idx="2674">2174</cx:pt>
          <cx:pt idx="2675">2511</cx:pt>
          <cx:pt idx="2676">2375</cx:pt>
          <cx:pt idx="2677">2749</cx:pt>
          <cx:pt idx="2678">2594</cx:pt>
          <cx:pt idx="2679">2440</cx:pt>
          <cx:pt idx="2680">2552</cx:pt>
          <cx:pt idx="2681">2899</cx:pt>
          <cx:pt idx="2682">2728</cx:pt>
          <cx:pt idx="2683">2892</cx:pt>
          <cx:pt idx="2684">2429</cx:pt>
          <cx:pt idx="2685">2854</cx:pt>
          <cx:pt idx="2686">2491</cx:pt>
          <cx:pt idx="2687">2523</cx:pt>
          <cx:pt idx="2688">2724</cx:pt>
          <cx:pt idx="2689">2801</cx:pt>
          <cx:pt idx="2690">2485</cx:pt>
          <cx:pt idx="2691">2704</cx:pt>
          <cx:pt idx="2692">3073</cx:pt>
          <cx:pt idx="2693">2733</cx:pt>
          <cx:pt idx="2694">2362</cx:pt>
          <cx:pt idx="2695">2759</cx:pt>
          <cx:pt idx="2696">2586</cx:pt>
          <cx:pt idx="2697">2336</cx:pt>
          <cx:pt idx="2698">2784</cx:pt>
          <cx:pt idx="2699">2706</cx:pt>
          <cx:pt idx="2700">2255</cx:pt>
          <cx:pt idx="2701">2409</cx:pt>
          <cx:pt idx="2702">2815</cx:pt>
          <cx:pt idx="2703">2569</cx:pt>
          <cx:pt idx="2704">2449</cx:pt>
          <cx:pt idx="2705">2306</cx:pt>
          <cx:pt idx="2706">2450</cx:pt>
          <cx:pt idx="2707">2819</cx:pt>
          <cx:pt idx="2708">2779</cx:pt>
          <cx:pt idx="2709">2492</cx:pt>
          <cx:pt idx="2710">2947</cx:pt>
          <cx:pt idx="2711">2790</cx:pt>
          <cx:pt idx="2712">2926</cx:pt>
          <cx:pt idx="2713">2647</cx:pt>
          <cx:pt idx="2714">2878</cx:pt>
          <cx:pt idx="2715">3144</cx:pt>
          <cx:pt idx="2716">3212</cx:pt>
          <cx:pt idx="2717">2724</cx:pt>
          <cx:pt idx="2718">2851</cx:pt>
          <cx:pt idx="2719">2579</cx:pt>
          <cx:pt idx="2720">2545</cx:pt>
          <cx:pt idx="2721">2954</cx:pt>
          <cx:pt idx="2722">2742</cx:pt>
          <cx:pt idx="2723">2791</cx:pt>
          <cx:pt idx="2724">3036</cx:pt>
          <cx:pt idx="2725">3056</cx:pt>
          <cx:pt idx="2726">2904</cx:pt>
          <cx:pt idx="2727">2691</cx:pt>
          <cx:pt idx="2728">2503</cx:pt>
          <cx:pt idx="2729">3036</cx:pt>
          <cx:pt idx="2730">2474</cx:pt>
          <cx:pt idx="2731">2834</cx:pt>
          <cx:pt idx="2732">2820</cx:pt>
          <cx:pt idx="2733">2565</cx:pt>
          <cx:pt idx="2734">2798</cx:pt>
          <cx:pt idx="2735">2806</cx:pt>
          <cx:pt idx="2736">2748</cx:pt>
          <cx:pt idx="2737">2783</cx:pt>
          <cx:pt idx="2738">2812</cx:pt>
          <cx:pt idx="2739">2776</cx:pt>
          <cx:pt idx="2740">2665</cx:pt>
          <cx:pt idx="2741">2505</cx:pt>
          <cx:pt idx="2742">2411</cx:pt>
          <cx:pt idx="2743">2511</cx:pt>
          <cx:pt idx="2744">2718</cx:pt>
          <cx:pt idx="2745">3123</cx:pt>
          <cx:pt idx="2746">2956</cx:pt>
          <cx:pt idx="2747">2943</cx:pt>
          <cx:pt idx="2748">2570</cx:pt>
          <cx:pt idx="2749">2681</cx:pt>
          <cx:pt idx="2750">3139</cx:pt>
          <cx:pt idx="2751">2461</cx:pt>
          <cx:pt idx="2752">2651</cx:pt>
          <cx:pt idx="2753">2524</cx:pt>
          <cx:pt idx="2754">3058</cx:pt>
          <cx:pt idx="2755">2613</cx:pt>
          <cx:pt idx="2756">2493</cx:pt>
          <cx:pt idx="2757">2467</cx:pt>
          <cx:pt idx="2758">2909</cx:pt>
          <cx:pt idx="2759">2693</cx:pt>
          <cx:pt idx="2760">2427</cx:pt>
          <cx:pt idx="2761">2471</cx:pt>
          <cx:pt idx="2762">2749</cx:pt>
          <cx:pt idx="2763">3024</cx:pt>
          <cx:pt idx="2764">2496</cx:pt>
          <cx:pt idx="2765">2466</cx:pt>
          <cx:pt idx="2766">2778</cx:pt>
          <cx:pt idx="2767">2614</cx:pt>
          <cx:pt idx="2768">2696</cx:pt>
          <cx:pt idx="2769">2653</cx:pt>
          <cx:pt idx="2770">3013</cx:pt>
          <cx:pt idx="2771">2978</cx:pt>
          <cx:pt idx="2772">2637</cx:pt>
          <cx:pt idx="2773">2981</cx:pt>
          <cx:pt idx="2774">2710</cx:pt>
          <cx:pt idx="2775">2748</cx:pt>
          <cx:pt idx="2776">2823</cx:pt>
          <cx:pt idx="2777">2615</cx:pt>
          <cx:pt idx="2778">2690</cx:pt>
          <cx:pt idx="2779">2978</cx:pt>
          <cx:pt idx="2780">2268</cx:pt>
          <cx:pt idx="2781">2492</cx:pt>
          <cx:pt idx="2782">2955</cx:pt>
          <cx:pt idx="2783">3062</cx:pt>
          <cx:pt idx="2784">2661</cx:pt>
          <cx:pt idx="2785">2882</cx:pt>
          <cx:pt idx="2786">2893</cx:pt>
          <cx:pt idx="2787">2732</cx:pt>
          <cx:pt idx="2788">2811</cx:pt>
          <cx:pt idx="2789">2664</cx:pt>
          <cx:pt idx="2790">2957</cx:pt>
          <cx:pt idx="2791">2307</cx:pt>
          <cx:pt idx="2792">2770</cx:pt>
          <cx:pt idx="2793">2794</cx:pt>
          <cx:pt idx="2794">2546</cx:pt>
          <cx:pt idx="2795">2463</cx:pt>
          <cx:pt idx="2796">2318</cx:pt>
          <cx:pt idx="2797">2785</cx:pt>
          <cx:pt idx="2798">2622</cx:pt>
          <cx:pt idx="2799">2345</cx:pt>
          <cx:pt idx="2800">2372</cx:pt>
          <cx:pt idx="2801">2637</cx:pt>
          <cx:pt idx="2802">2720</cx:pt>
          <cx:pt idx="2803">2623</cx:pt>
          <cx:pt idx="2804">2549</cx:pt>
          <cx:pt idx="2805">2445</cx:pt>
          <cx:pt idx="2806">2615</cx:pt>
          <cx:pt idx="2807">2916</cx:pt>
          <cx:pt idx="2808">2717</cx:pt>
          <cx:pt idx="2809">2690</cx:pt>
          <cx:pt idx="2810">2678</cx:pt>
          <cx:pt idx="2811">2552</cx:pt>
          <cx:pt idx="2812">2704</cx:pt>
          <cx:pt idx="2813">2516</cx:pt>
          <cx:pt idx="2814">2849</cx:pt>
          <cx:pt idx="2815">2604</cx:pt>
          <cx:pt idx="2816">2859</cx:pt>
          <cx:pt idx="2817">2599</cx:pt>
          <cx:pt idx="2818">2737</cx:pt>
          <cx:pt idx="2819">2455</cx:pt>
          <cx:pt idx="2820">2287</cx:pt>
          <cx:pt idx="2821">2563</cx:pt>
          <cx:pt idx="2822">2781</cx:pt>
          <cx:pt idx="2823">2647</cx:pt>
          <cx:pt idx="2824">2438</cx:pt>
          <cx:pt idx="2825">2559</cx:pt>
          <cx:pt idx="2826">2657</cx:pt>
          <cx:pt idx="2827">2583</cx:pt>
          <cx:pt idx="2828">2723</cx:pt>
          <cx:pt idx="2829">3023</cx:pt>
          <cx:pt idx="2830">2406</cx:pt>
          <cx:pt idx="2831">2655</cx:pt>
          <cx:pt idx="2832">2372</cx:pt>
          <cx:pt idx="2833">2818</cx:pt>
          <cx:pt idx="2834">2516</cx:pt>
          <cx:pt idx="2835">2518</cx:pt>
          <cx:pt idx="2836">2958</cx:pt>
          <cx:pt idx="2837">2398</cx:pt>
          <cx:pt idx="2838">2158</cx:pt>
          <cx:pt idx="2839">2812</cx:pt>
          <cx:pt idx="2840">2367</cx:pt>
          <cx:pt idx="2841">2439</cx:pt>
          <cx:pt idx="2842">2577</cx:pt>
          <cx:pt idx="2843">2573</cx:pt>
          <cx:pt idx="2844">2544</cx:pt>
          <cx:pt idx="2845">2371</cx:pt>
          <cx:pt idx="2846">2599</cx:pt>
          <cx:pt idx="2847">2062</cx:pt>
          <cx:pt idx="2848">2534</cx:pt>
          <cx:pt idx="2849">2505</cx:pt>
          <cx:pt idx="2850">2230</cx:pt>
          <cx:pt idx="2851">2763</cx:pt>
          <cx:pt idx="2852">2294</cx:pt>
          <cx:pt idx="2853">2483</cx:pt>
          <cx:pt idx="2854">2596</cx:pt>
          <cx:pt idx="2855">3027</cx:pt>
          <cx:pt idx="2856">2594</cx:pt>
          <cx:pt idx="2857">2680</cx:pt>
          <cx:pt idx="2858">3026</cx:pt>
          <cx:pt idx="2859">2544</cx:pt>
          <cx:pt idx="2860">2228</cx:pt>
          <cx:pt idx="2861">2454</cx:pt>
          <cx:pt idx="2862">2973</cx:pt>
          <cx:pt idx="2863">2826</cx:pt>
          <cx:pt idx="2864">2618</cx:pt>
          <cx:pt idx="2865">2746</cx:pt>
          <cx:pt idx="2866">2475</cx:pt>
          <cx:pt idx="2867">2757</cx:pt>
          <cx:pt idx="2868">2611</cx:pt>
          <cx:pt idx="2869">2356</cx:pt>
          <cx:pt idx="2870">2485</cx:pt>
          <cx:pt idx="2871">2308</cx:pt>
          <cx:pt idx="2872">2722</cx:pt>
          <cx:pt idx="2873">2595</cx:pt>
          <cx:pt idx="2874">2491</cx:pt>
          <cx:pt idx="2875">2657</cx:pt>
          <cx:pt idx="2876">3000</cx:pt>
          <cx:pt idx="2877">2882</cx:pt>
          <cx:pt idx="2878">2789</cx:pt>
          <cx:pt idx="2879">2650</cx:pt>
          <cx:pt idx="2880">2687</cx:pt>
          <cx:pt idx="2881">2783</cx:pt>
          <cx:pt idx="2882">2518</cx:pt>
          <cx:pt idx="2883">2651</cx:pt>
          <cx:pt idx="2884">2787</cx:pt>
          <cx:pt idx="2885">2866</cx:pt>
          <cx:pt idx="2886">2251</cx:pt>
          <cx:pt idx="2887">2595</cx:pt>
          <cx:pt idx="2888">2738</cx:pt>
          <cx:pt idx="2889">2622</cx:pt>
          <cx:pt idx="2890">2615</cx:pt>
          <cx:pt idx="2891">2440</cx:pt>
          <cx:pt idx="2892">2505</cx:pt>
          <cx:pt idx="2893">2801</cx:pt>
          <cx:pt idx="2894">2770</cx:pt>
          <cx:pt idx="2895">2339</cx:pt>
          <cx:pt idx="2896">2721</cx:pt>
          <cx:pt idx="2897">2904</cx:pt>
          <cx:pt idx="2898">2957</cx:pt>
          <cx:pt idx="2899">2830</cx:pt>
          <cx:pt idx="2900">2915</cx:pt>
          <cx:pt idx="2901">2789</cx:pt>
          <cx:pt idx="2902">2635</cx:pt>
          <cx:pt idx="2903">2487</cx:pt>
          <cx:pt idx="2904">2296</cx:pt>
          <cx:pt idx="2905">2753</cx:pt>
          <cx:pt idx="2906">2229</cx:pt>
          <cx:pt idx="2907">2632</cx:pt>
          <cx:pt idx="2908">2458</cx:pt>
          <cx:pt idx="2909">2857</cx:pt>
          <cx:pt idx="2910">2523</cx:pt>
          <cx:pt idx="2911">2504</cx:pt>
          <cx:pt idx="2912">3012</cx:pt>
          <cx:pt idx="2913">2732</cx:pt>
          <cx:pt idx="2914">2514</cx:pt>
          <cx:pt idx="2915">2697</cx:pt>
          <cx:pt idx="2916">2339</cx:pt>
          <cx:pt idx="2917">2452</cx:pt>
          <cx:pt idx="2918">2527</cx:pt>
          <cx:pt idx="2919">2353</cx:pt>
          <cx:pt idx="2920">2207</cx:pt>
          <cx:pt idx="2921">2543</cx:pt>
          <cx:pt idx="2922">2523</cx:pt>
          <cx:pt idx="2923">2722</cx:pt>
          <cx:pt idx="2924">2360</cx:pt>
          <cx:pt idx="2925">2743</cx:pt>
          <cx:pt idx="2926">2974</cx:pt>
          <cx:pt idx="2927">2604</cx:pt>
          <cx:pt idx="2928">2722</cx:pt>
          <cx:pt idx="2929">2444</cx:pt>
          <cx:pt idx="2930">2325</cx:pt>
          <cx:pt idx="2931">2467</cx:pt>
          <cx:pt idx="2932">2623</cx:pt>
          <cx:pt idx="2933">2640</cx:pt>
          <cx:pt idx="2934">2355</cx:pt>
          <cx:pt idx="2935">2290</cx:pt>
          <cx:pt idx="2936">2470</cx:pt>
          <cx:pt idx="2937">2640</cx:pt>
          <cx:pt idx="2938">2840</cx:pt>
          <cx:pt idx="2939">2758</cx:pt>
          <cx:pt idx="2940">2779</cx:pt>
          <cx:pt idx="2941">2646</cx:pt>
          <cx:pt idx="2942">2388</cx:pt>
          <cx:pt idx="2943">2837</cx:pt>
          <cx:pt idx="2944">2885</cx:pt>
          <cx:pt idx="2945">3007</cx:pt>
          <cx:pt idx="2946">3067</cx:pt>
          <cx:pt idx="2947">2299</cx:pt>
          <cx:pt idx="2948">2478</cx:pt>
          <cx:pt idx="2949">2903</cx:pt>
          <cx:pt idx="2950">2328</cx:pt>
          <cx:pt idx="2951">2739</cx:pt>
          <cx:pt idx="2952">2779</cx:pt>
          <cx:pt idx="2953">2792</cx:pt>
          <cx:pt idx="2954">2835</cx:pt>
          <cx:pt idx="2955">2251</cx:pt>
          <cx:pt idx="2956">3051</cx:pt>
          <cx:pt idx="2957">2385</cx:pt>
          <cx:pt idx="2958">2929</cx:pt>
          <cx:pt idx="2959">2420</cx:pt>
          <cx:pt idx="2960">2511</cx:pt>
          <cx:pt idx="2961">2614</cx:pt>
          <cx:pt idx="2962">2569</cx:pt>
          <cx:pt idx="2963">2922</cx:pt>
          <cx:pt idx="2964">2389</cx:pt>
          <cx:pt idx="2965">2861</cx:pt>
          <cx:pt idx="2966">2610</cx:pt>
          <cx:pt idx="2967">2530</cx:pt>
          <cx:pt idx="2968">2846</cx:pt>
          <cx:pt idx="2969">2664</cx:pt>
          <cx:pt idx="2970">2705</cx:pt>
          <cx:pt idx="2971">2611</cx:pt>
          <cx:pt idx="2972">2438</cx:pt>
          <cx:pt idx="2973">2860</cx:pt>
          <cx:pt idx="2974">2714</cx:pt>
          <cx:pt idx="2975">2720</cx:pt>
          <cx:pt idx="2976">2554</cx:pt>
          <cx:pt idx="2977">2922</cx:pt>
          <cx:pt idx="2978">2836</cx:pt>
          <cx:pt idx="2979">2957</cx:pt>
          <cx:pt idx="2980">2369</cx:pt>
          <cx:pt idx="2981">2692</cx:pt>
          <cx:pt idx="2982">2364</cx:pt>
          <cx:pt idx="2983">2731</cx:pt>
          <cx:pt idx="2984">2697</cx:pt>
          <cx:pt idx="2985">2731</cx:pt>
          <cx:pt idx="2986">2553</cx:pt>
          <cx:pt idx="2987">2624</cx:pt>
          <cx:pt idx="2988">2513</cx:pt>
          <cx:pt idx="2989">3029</cx:pt>
          <cx:pt idx="2990">2581</cx:pt>
          <cx:pt idx="2991">2649</cx:pt>
          <cx:pt idx="2992">2574</cx:pt>
          <cx:pt idx="2993">2611</cx:pt>
          <cx:pt idx="2994">2922</cx:pt>
          <cx:pt idx="2995">3190</cx:pt>
          <cx:pt idx="2996">3164</cx:pt>
          <cx:pt idx="2997">2874</cx:pt>
          <cx:pt idx="2998">3001</cx:pt>
          <cx:pt idx="2999">2576</cx:pt>
          <cx:pt idx="3000">2635</cx:pt>
          <cx:pt idx="3001">2735</cx:pt>
          <cx:pt idx="3002">2353</cx:pt>
          <cx:pt idx="3003">2469</cx:pt>
          <cx:pt idx="3004">2670</cx:pt>
          <cx:pt idx="3005">2357</cx:pt>
          <cx:pt idx="3006">2787</cx:pt>
          <cx:pt idx="3007">2796</cx:pt>
          <cx:pt idx="3008">2776</cx:pt>
          <cx:pt idx="3009">2688</cx:pt>
          <cx:pt idx="3010">3039</cx:pt>
          <cx:pt idx="3011">2601</cx:pt>
          <cx:pt idx="3012">2737</cx:pt>
          <cx:pt idx="3013">2831</cx:pt>
          <cx:pt idx="3014">2776</cx:pt>
          <cx:pt idx="3015">2471</cx:pt>
          <cx:pt idx="3016">2742</cx:pt>
          <cx:pt idx="3017">2652</cx:pt>
          <cx:pt idx="3018">2799</cx:pt>
          <cx:pt idx="3019">3100</cx:pt>
          <cx:pt idx="3020">2308</cx:pt>
          <cx:pt idx="3021">2881</cx:pt>
          <cx:pt idx="3022">2804</cx:pt>
          <cx:pt idx="3023">3170</cx:pt>
          <cx:pt idx="3024">2744</cx:pt>
          <cx:pt idx="3025">2597</cx:pt>
          <cx:pt idx="3026">3042</cx:pt>
          <cx:pt idx="3027">2886</cx:pt>
          <cx:pt idx="3028">2623</cx:pt>
          <cx:pt idx="3029">2631</cx:pt>
          <cx:pt idx="3030">2519</cx:pt>
          <cx:pt idx="3031">2989</cx:pt>
          <cx:pt idx="3032">2515</cx:pt>
          <cx:pt idx="3033">2629</cx:pt>
          <cx:pt idx="3034">3254</cx:pt>
          <cx:pt idx="3035">2736</cx:pt>
          <cx:pt idx="3036">3135</cx:pt>
          <cx:pt idx="3037">2862</cx:pt>
          <cx:pt idx="3038">2912</cx:pt>
          <cx:pt idx="3039">2598</cx:pt>
          <cx:pt idx="3040">2289</cx:pt>
          <cx:pt idx="3041">2539</cx:pt>
          <cx:pt idx="3042">2865</cx:pt>
          <cx:pt idx="3043">2467</cx:pt>
          <cx:pt idx="3044">2445</cx:pt>
          <cx:pt idx="3045">2498</cx:pt>
          <cx:pt idx="3046">2737</cx:pt>
          <cx:pt idx="3047">2935</cx:pt>
          <cx:pt idx="3048">2858</cx:pt>
          <cx:pt idx="3049">2105</cx:pt>
          <cx:pt idx="3050">2468</cx:pt>
          <cx:pt idx="3051">2894</cx:pt>
          <cx:pt idx="3052">2761</cx:pt>
          <cx:pt idx="3053">2768</cx:pt>
          <cx:pt idx="3054">2434</cx:pt>
          <cx:pt idx="3055">2617</cx:pt>
          <cx:pt idx="3056">2616</cx:pt>
          <cx:pt idx="3057">2474</cx:pt>
          <cx:pt idx="3058">2569</cx:pt>
          <cx:pt idx="3059">2626</cx:pt>
          <cx:pt idx="3060">2637</cx:pt>
          <cx:pt idx="3061">2676</cx:pt>
          <cx:pt idx="3062">2741</cx:pt>
          <cx:pt idx="3063">2757</cx:pt>
          <cx:pt idx="3064">2522</cx:pt>
          <cx:pt idx="3065">2724</cx:pt>
          <cx:pt idx="3066">2657</cx:pt>
          <cx:pt idx="3067">2713</cx:pt>
          <cx:pt idx="3068">2821</cx:pt>
          <cx:pt idx="3069">2828</cx:pt>
          <cx:pt idx="3070">2807</cx:pt>
          <cx:pt idx="3071">2501</cx:pt>
          <cx:pt idx="3072">2878</cx:pt>
          <cx:pt idx="3073">2162</cx:pt>
          <cx:pt idx="3074">2667</cx:pt>
          <cx:pt idx="3075">2612</cx:pt>
          <cx:pt idx="3076">2221</cx:pt>
          <cx:pt idx="3077">2641</cx:pt>
          <cx:pt idx="3078">2201</cx:pt>
          <cx:pt idx="3079">2931</cx:pt>
          <cx:pt idx="3080">2714</cx:pt>
          <cx:pt idx="3081">2855</cx:pt>
          <cx:pt idx="3082">2621</cx:pt>
          <cx:pt idx="3083">2516</cx:pt>
          <cx:pt idx="3084">2451</cx:pt>
          <cx:pt idx="3085">2377</cx:pt>
          <cx:pt idx="3086">2573</cx:pt>
          <cx:pt idx="3087">2428</cx:pt>
          <cx:pt idx="3088">2424</cx:pt>
          <cx:pt idx="3089">2656</cx:pt>
          <cx:pt idx="3090">2229</cx:pt>
          <cx:pt idx="3091">2306</cx:pt>
          <cx:pt idx="3092">2987</cx:pt>
          <cx:pt idx="3093">2296</cx:pt>
          <cx:pt idx="3094">2584</cx:pt>
          <cx:pt idx="3095">2243</cx:pt>
          <cx:pt idx="3096">2282</cx:pt>
          <cx:pt idx="3097">2493</cx:pt>
          <cx:pt idx="3098">2502</cx:pt>
          <cx:pt idx="3099">2768</cx:pt>
          <cx:pt idx="3100">2241</cx:pt>
          <cx:pt idx="3101">2503</cx:pt>
          <cx:pt idx="3102">2788</cx:pt>
          <cx:pt idx="3103">2794</cx:pt>
          <cx:pt idx="3104">2001</cx:pt>
          <cx:pt idx="3105">2509</cx:pt>
          <cx:pt idx="3106">2420</cx:pt>
          <cx:pt idx="3107">2752</cx:pt>
          <cx:pt idx="3108">2646</cx:pt>
          <cx:pt idx="3109">2744</cx:pt>
          <cx:pt idx="3110">2746</cx:pt>
          <cx:pt idx="3111">2837</cx:pt>
          <cx:pt idx="3112">2933</cx:pt>
          <cx:pt idx="3113">2903</cx:pt>
          <cx:pt idx="3114">2512</cx:pt>
          <cx:pt idx="3115">2299</cx:pt>
          <cx:pt idx="3116">2766</cx:pt>
          <cx:pt idx="3117">2966</cx:pt>
          <cx:pt idx="3118">2741</cx:pt>
          <cx:pt idx="3119">2690</cx:pt>
          <cx:pt idx="3120">2536</cx:pt>
          <cx:pt idx="3121">2447</cx:pt>
          <cx:pt idx="3122">2642</cx:pt>
          <cx:pt idx="3123">2713</cx:pt>
          <cx:pt idx="3124">2882</cx:pt>
          <cx:pt idx="3125">2518</cx:pt>
          <cx:pt idx="3126">2792</cx:pt>
          <cx:pt idx="3127">2733</cx:pt>
          <cx:pt idx="3128">2814</cx:pt>
          <cx:pt idx="3129">2593</cx:pt>
          <cx:pt idx="3130">2500</cx:pt>
          <cx:pt idx="3131">2596</cx:pt>
          <cx:pt idx="3132">2924</cx:pt>
          <cx:pt idx="3133">2771</cx:pt>
          <cx:pt idx="3134">2912</cx:pt>
          <cx:pt idx="3135">2702</cx:pt>
          <cx:pt idx="3136">2718</cx:pt>
          <cx:pt idx="3137">2727</cx:pt>
          <cx:pt idx="3138">2475</cx:pt>
          <cx:pt idx="3139">2897</cx:pt>
          <cx:pt idx="3140">2467</cx:pt>
          <cx:pt idx="3141">2156</cx:pt>
          <cx:pt idx="3142">2471</cx:pt>
          <cx:pt idx="3143">2523</cx:pt>
          <cx:pt idx="3144">3001</cx:pt>
          <cx:pt idx="3145">2906</cx:pt>
          <cx:pt idx="3146">2552</cx:pt>
          <cx:pt idx="3147">2865</cx:pt>
          <cx:pt idx="3148">3018</cx:pt>
          <cx:pt idx="3149">3313</cx:pt>
          <cx:pt idx="3150">3239</cx:pt>
          <cx:pt idx="3151">2636</cx:pt>
          <cx:pt idx="3152">2892</cx:pt>
          <cx:pt idx="3153">2808</cx:pt>
          <cx:pt idx="3154">3052</cx:pt>
          <cx:pt idx="3155">2741</cx:pt>
          <cx:pt idx="3156">2968</cx:pt>
          <cx:pt idx="3157">2468</cx:pt>
          <cx:pt idx="3158">2888</cx:pt>
          <cx:pt idx="3159">2935</cx:pt>
          <cx:pt idx="3160">2660</cx:pt>
          <cx:pt idx="3161">2866</cx:pt>
          <cx:pt idx="3162">2740</cx:pt>
          <cx:pt idx="3163">2351</cx:pt>
          <cx:pt idx="3164">2370</cx:pt>
          <cx:pt idx="3165">2264</cx:pt>
          <cx:pt idx="3166">2139</cx:pt>
          <cx:pt idx="3167">2221</cx:pt>
          <cx:pt idx="3168">2752</cx:pt>
          <cx:pt idx="3169">2429</cx:pt>
          <cx:pt idx="3170">2570</cx:pt>
          <cx:pt idx="3171">2557</cx:pt>
          <cx:pt idx="3172">2709</cx:pt>
          <cx:pt idx="3173">2734</cx:pt>
          <cx:pt idx="3174">2559</cx:pt>
          <cx:pt idx="3175">2509</cx:pt>
          <cx:pt idx="3176">2484</cx:pt>
          <cx:pt idx="3177">3235</cx:pt>
          <cx:pt idx="3178">2988</cx:pt>
          <cx:pt idx="3179">2756</cx:pt>
          <cx:pt idx="3180">2716</cx:pt>
          <cx:pt idx="3181">3201</cx:pt>
          <cx:pt idx="3182">2944</cx:pt>
          <cx:pt idx="3183">3234</cx:pt>
          <cx:pt idx="3184">2856</cx:pt>
          <cx:pt idx="3185">2496</cx:pt>
          <cx:pt idx="3186">2707</cx:pt>
          <cx:pt idx="3187">2535</cx:pt>
          <cx:pt idx="3188">3017</cx:pt>
          <cx:pt idx="3189">2450</cx:pt>
          <cx:pt idx="3190">2879</cx:pt>
          <cx:pt idx="3191">2866</cx:pt>
          <cx:pt idx="3192">2967</cx:pt>
          <cx:pt idx="3193">2396</cx:pt>
          <cx:pt idx="3194">3206</cx:pt>
          <cx:pt idx="3195">2456</cx:pt>
          <cx:pt idx="3196">2929</cx:pt>
          <cx:pt idx="3197">2691</cx:pt>
          <cx:pt idx="3198">2832</cx:pt>
          <cx:pt idx="3199">2531</cx:pt>
          <cx:pt idx="3200">2358</cx:pt>
          <cx:pt idx="3201">2526</cx:pt>
          <cx:pt idx="3202">2476</cx:pt>
          <cx:pt idx="3203">2468</cx:pt>
          <cx:pt idx="3204">2793</cx:pt>
          <cx:pt idx="3205">2904</cx:pt>
          <cx:pt idx="3206">2772</cx:pt>
          <cx:pt idx="3207">2536</cx:pt>
          <cx:pt idx="3208">2587</cx:pt>
          <cx:pt idx="3209">2675</cx:pt>
          <cx:pt idx="3210">2830</cx:pt>
          <cx:pt idx="3211">2455</cx:pt>
          <cx:pt idx="3212">2897</cx:pt>
          <cx:pt idx="3213">2938</cx:pt>
          <cx:pt idx="3214">2981</cx:pt>
          <cx:pt idx="3215">2592</cx:pt>
          <cx:pt idx="3216">2867</cx:pt>
          <cx:pt idx="3217">3013</cx:pt>
          <cx:pt idx="3218">2791</cx:pt>
          <cx:pt idx="3219">3192</cx:pt>
          <cx:pt idx="3220">2472</cx:pt>
          <cx:pt idx="3221">3171</cx:pt>
          <cx:pt idx="3222">2519</cx:pt>
          <cx:pt idx="3223">2752</cx:pt>
          <cx:pt idx="3224">2581</cx:pt>
          <cx:pt idx="3225">2785</cx:pt>
          <cx:pt idx="3226">2907</cx:pt>
          <cx:pt idx="3227">2859</cx:pt>
          <cx:pt idx="3228">2869</cx:pt>
          <cx:pt idx="3229">2634</cx:pt>
          <cx:pt idx="3230">2574</cx:pt>
          <cx:pt idx="3231">2645</cx:pt>
          <cx:pt idx="3232">2635</cx:pt>
          <cx:pt idx="3233">2745</cx:pt>
          <cx:pt idx="3234">3035</cx:pt>
          <cx:pt idx="3235">3042</cx:pt>
          <cx:pt idx="3236">3063</cx:pt>
          <cx:pt idx="3237">2680</cx:pt>
          <cx:pt idx="3238">2852</cx:pt>
          <cx:pt idx="3239">2780</cx:pt>
          <cx:pt idx="3240">2724</cx:pt>
          <cx:pt idx="3241">2855</cx:pt>
          <cx:pt idx="3242">2646</cx:pt>
          <cx:pt idx="3243">2532</cx:pt>
          <cx:pt idx="3244">3015</cx:pt>
          <cx:pt idx="3245">2709</cx:pt>
          <cx:pt idx="3246">3174</cx:pt>
          <cx:pt idx="3247">3088</cx:pt>
          <cx:pt idx="3248">3185</cx:pt>
          <cx:pt idx="3249">2720</cx:pt>
          <cx:pt idx="3250">2896</cx:pt>
          <cx:pt idx="3251">2820</cx:pt>
          <cx:pt idx="3252">2951</cx:pt>
          <cx:pt idx="3253">3064</cx:pt>
          <cx:pt idx="3254">2778</cx:pt>
          <cx:pt idx="3255">3073</cx:pt>
          <cx:pt idx="3256">3142</cx:pt>
          <cx:pt idx="3257">2929</cx:pt>
          <cx:pt idx="3258">3024</cx:pt>
          <cx:pt idx="3259">3295</cx:pt>
          <cx:pt idx="3260">3038</cx:pt>
          <cx:pt idx="3261">3050</cx:pt>
          <cx:pt idx="3262">2631</cx:pt>
          <cx:pt idx="3263">2469</cx:pt>
          <cx:pt idx="3264">2542</cx:pt>
          <cx:pt idx="3265">2616</cx:pt>
          <cx:pt idx="3266">2825</cx:pt>
          <cx:pt idx="3267">2843</cx:pt>
          <cx:pt idx="3268">2376</cx:pt>
          <cx:pt idx="3269">2973</cx:pt>
          <cx:pt idx="3270">2797</cx:pt>
          <cx:pt idx="3271">2597</cx:pt>
          <cx:pt idx="3272">3069</cx:pt>
          <cx:pt idx="3273">3189</cx:pt>
          <cx:pt idx="3274">3033</cx:pt>
          <cx:pt idx="3275">2893</cx:pt>
          <cx:pt idx="3276">2750</cx:pt>
          <cx:pt idx="3277">3045</cx:pt>
          <cx:pt idx="3278">2795</cx:pt>
          <cx:pt idx="3279">2610</cx:pt>
          <cx:pt idx="3280">3106</cx:pt>
          <cx:pt idx="3281">3318</cx:pt>
          <cx:pt idx="3282">2800</cx:pt>
          <cx:pt idx="3283">2566</cx:pt>
          <cx:pt idx="3284">2846</cx:pt>
          <cx:pt idx="3285">2633</cx:pt>
          <cx:pt idx="3286">2784</cx:pt>
          <cx:pt idx="3287">2595</cx:pt>
          <cx:pt idx="3288">2870</cx:pt>
          <cx:pt idx="3289">2661</cx:pt>
          <cx:pt idx="3290">2546</cx:pt>
          <cx:pt idx="3291">2809</cx:pt>
          <cx:pt idx="3292">2987</cx:pt>
          <cx:pt idx="3293">2782</cx:pt>
          <cx:pt idx="3294">2878</cx:pt>
          <cx:pt idx="3295">3018</cx:pt>
          <cx:pt idx="3296">3014</cx:pt>
          <cx:pt idx="3297">2771</cx:pt>
          <cx:pt idx="3298">3284</cx:pt>
          <cx:pt idx="3299">2909</cx:pt>
          <cx:pt idx="3300">3242</cx:pt>
          <cx:pt idx="3301">2724</cx:pt>
          <cx:pt idx="3302">2815</cx:pt>
          <cx:pt idx="3303">3018</cx:pt>
          <cx:pt idx="3304">3036</cx:pt>
          <cx:pt idx="3305">2969</cx:pt>
          <cx:pt idx="3306">2883</cx:pt>
          <cx:pt idx="3307">2887</cx:pt>
          <cx:pt idx="3308">2838</cx:pt>
          <cx:pt idx="3309">2580</cx:pt>
          <cx:pt idx="3310">2996</cx:pt>
          <cx:pt idx="3311">2747</cx:pt>
          <cx:pt idx="3312">2723</cx:pt>
          <cx:pt idx="3313">2958</cx:pt>
          <cx:pt idx="3314">3080</cx:pt>
          <cx:pt idx="3315">3055</cx:pt>
          <cx:pt idx="3316">2875</cx:pt>
          <cx:pt idx="3317">3496</cx:pt>
          <cx:pt idx="3318">2976</cx:pt>
          <cx:pt idx="3319">2781</cx:pt>
          <cx:pt idx="3320">2957</cx:pt>
          <cx:pt idx="3321">2906</cx:pt>
          <cx:pt idx="3322">3118</cx:pt>
          <cx:pt idx="3323">2885</cx:pt>
          <cx:pt idx="3324">3223</cx:pt>
          <cx:pt idx="3325">2761</cx:pt>
          <cx:pt idx="3326">3101</cx:pt>
          <cx:pt idx="3327">3054</cx:pt>
          <cx:pt idx="3328">2732</cx:pt>
          <cx:pt idx="3329">3022</cx:pt>
          <cx:pt idx="3330">2833</cx:pt>
          <cx:pt idx="3331">2709</cx:pt>
          <cx:pt idx="3332">2886</cx:pt>
          <cx:pt idx="3333">2969</cx:pt>
          <cx:pt idx="3334">3038</cx:pt>
          <cx:pt idx="3335">2851</cx:pt>
          <cx:pt idx="3336">3214</cx:pt>
          <cx:pt idx="3337">2987</cx:pt>
          <cx:pt idx="3338">3083</cx:pt>
          <cx:pt idx="3339">3052</cx:pt>
          <cx:pt idx="3340">2972</cx:pt>
          <cx:pt idx="3341">3310</cx:pt>
          <cx:pt idx="3342">2921</cx:pt>
          <cx:pt idx="3343">2974</cx:pt>
          <cx:pt idx="3344">3019</cx:pt>
          <cx:pt idx="3345">3177</cx:pt>
          <cx:pt idx="3346">3251</cx:pt>
          <cx:pt idx="3347">3029</cx:pt>
          <cx:pt idx="3348">2902</cx:pt>
          <cx:pt idx="3349">2601</cx:pt>
          <cx:pt idx="3350">2917</cx:pt>
          <cx:pt idx="3351">3201</cx:pt>
          <cx:pt idx="3352">2763</cx:pt>
          <cx:pt idx="3353">3265</cx:pt>
          <cx:pt idx="3354">3365</cx:pt>
          <cx:pt idx="3355">3123</cx:pt>
          <cx:pt idx="3356">3214</cx:pt>
          <cx:pt idx="3357">3215</cx:pt>
          <cx:pt idx="3358">2747</cx:pt>
          <cx:pt idx="3359">3074</cx:pt>
          <cx:pt idx="3360">3086</cx:pt>
          <cx:pt idx="3361">2624</cx:pt>
          <cx:pt idx="3362">3167</cx:pt>
          <cx:pt idx="3363">3000</cx:pt>
          <cx:pt idx="3364">2636</cx:pt>
          <cx:pt idx="3365">2813</cx:pt>
          <cx:pt idx="3366">3256</cx:pt>
          <cx:pt idx="3367">2963</cx:pt>
          <cx:pt idx="3368">3451</cx:pt>
          <cx:pt idx="3369">3515</cx:pt>
          <cx:pt idx="3370">3332</cx:pt>
          <cx:pt idx="3371">2931</cx:pt>
          <cx:pt idx="3372">3491</cx:pt>
          <cx:pt idx="3373">3085</cx:pt>
          <cx:pt idx="3374">3261</cx:pt>
          <cx:pt idx="3375">2847</cx:pt>
          <cx:pt idx="3376">3287</cx:pt>
          <cx:pt idx="3377">2929</cx:pt>
          <cx:pt idx="3378">3371</cx:pt>
          <cx:pt idx="3379">3442</cx:pt>
          <cx:pt idx="3380">3110</cx:pt>
          <cx:pt idx="3381">2989</cx:pt>
          <cx:pt idx="3382">3356</cx:pt>
          <cx:pt idx="3383">3305</cx:pt>
          <cx:pt idx="3384">2955</cx:pt>
          <cx:pt idx="3385">3103</cx:pt>
          <cx:pt idx="3386">3064</cx:pt>
          <cx:pt idx="3387">3138</cx:pt>
          <cx:pt idx="3388">2702</cx:pt>
          <cx:pt idx="3389">3267</cx:pt>
          <cx:pt idx="3390">2744</cx:pt>
          <cx:pt idx="3391">3057</cx:pt>
          <cx:pt idx="3392">3224</cx:pt>
          <cx:pt idx="3393">3021</cx:pt>
          <cx:pt idx="3394">3374</cx:pt>
          <cx:pt idx="3395">3220</cx:pt>
          <cx:pt idx="3396">2968</cx:pt>
          <cx:pt idx="3397">2801</cx:pt>
          <cx:pt idx="3398">3315</cx:pt>
          <cx:pt idx="3399">3332</cx:pt>
          <cx:pt idx="3400">3313</cx:pt>
          <cx:pt idx="3401">3182</cx:pt>
          <cx:pt idx="3402">2834</cx:pt>
          <cx:pt idx="3403">2720</cx:pt>
          <cx:pt idx="3404">2990</cx:pt>
          <cx:pt idx="3405">2891</cx:pt>
          <cx:pt idx="3406">3303</cx:pt>
          <cx:pt idx="3407">3145</cx:pt>
          <cx:pt idx="3408">3151</cx:pt>
          <cx:pt idx="3409">2757</cx:pt>
          <cx:pt idx="3410">3181</cx:pt>
          <cx:pt idx="3411">2773</cx:pt>
          <cx:pt idx="3412">3317</cx:pt>
          <cx:pt idx="3413">3093</cx:pt>
          <cx:pt idx="3414">3072</cx:pt>
          <cx:pt idx="3415">2906</cx:pt>
          <cx:pt idx="3416">3073</cx:pt>
          <cx:pt idx="3417">3458</cx:pt>
          <cx:pt idx="3418">2944</cx:pt>
          <cx:pt idx="3419">3216</cx:pt>
          <cx:pt idx="3420">3162</cx:pt>
          <cx:pt idx="3421">3258</cx:pt>
          <cx:pt idx="3422">3092</cx:pt>
          <cx:pt idx="3423">2922</cx:pt>
          <cx:pt idx="3424">2558</cx:pt>
          <cx:pt idx="3425">2806</cx:pt>
          <cx:pt idx="3426">3129</cx:pt>
          <cx:pt idx="3427">3245</cx:pt>
          <cx:pt idx="3428">3036</cx:pt>
          <cx:pt idx="3429">2622</cx:pt>
          <cx:pt idx="3430">2999</cx:pt>
          <cx:pt idx="3431">2885</cx:pt>
          <cx:pt idx="3432">3128</cx:pt>
          <cx:pt idx="3433">2912</cx:pt>
          <cx:pt idx="3434">2931</cx:pt>
          <cx:pt idx="3435">3054</cx:pt>
          <cx:pt idx="3436">3194</cx:pt>
          <cx:pt idx="3437">3039</cx:pt>
          <cx:pt idx="3438">3245</cx:pt>
          <cx:pt idx="3439">2894</cx:pt>
          <cx:pt idx="3440">2887</cx:pt>
          <cx:pt idx="3441">2828</cx:pt>
          <cx:pt idx="3442">2911</cx:pt>
          <cx:pt idx="3443">3250</cx:pt>
          <cx:pt idx="3444">2867</cx:pt>
          <cx:pt idx="3445">2785</cx:pt>
          <cx:pt idx="3446">3358</cx:pt>
          <cx:pt idx="3447">3220</cx:pt>
          <cx:pt idx="3448">2860</cx:pt>
          <cx:pt idx="3449">2627</cx:pt>
          <cx:pt idx="3450">3309</cx:pt>
          <cx:pt idx="3451">3102</cx:pt>
          <cx:pt idx="3452">2848</cx:pt>
          <cx:pt idx="3453">2710</cx:pt>
          <cx:pt idx="3454">2822</cx:pt>
          <cx:pt idx="3455">3165</cx:pt>
          <cx:pt idx="3456">2733</cx:pt>
          <cx:pt idx="3457">2991</cx:pt>
          <cx:pt idx="3458">2885</cx:pt>
          <cx:pt idx="3459">3307</cx:pt>
          <cx:pt idx="3460">3274</cx:pt>
          <cx:pt idx="3461">2945</cx:pt>
          <cx:pt idx="3462">3190</cx:pt>
          <cx:pt idx="3463">3147</cx:pt>
          <cx:pt idx="3464">3437</cx:pt>
          <cx:pt idx="3465">3297</cx:pt>
          <cx:pt idx="3466">2945</cx:pt>
          <cx:pt idx="3467">3007</cx:pt>
          <cx:pt idx="3468">3197</cx:pt>
          <cx:pt idx="3469">3052</cx:pt>
          <cx:pt idx="3470">2806</cx:pt>
          <cx:pt idx="3471">3081</cx:pt>
          <cx:pt idx="3472">3152</cx:pt>
          <cx:pt idx="3473">2774</cx:pt>
          <cx:pt idx="3474">3203</cx:pt>
          <cx:pt idx="3475">2948</cx:pt>
          <cx:pt idx="3476">2832</cx:pt>
          <cx:pt idx="3477">2960</cx:pt>
          <cx:pt idx="3478">2795</cx:pt>
          <cx:pt idx="3479">3262</cx:pt>
          <cx:pt idx="3480">2635</cx:pt>
          <cx:pt idx="3481">3046</cx:pt>
          <cx:pt idx="3482">2728</cx:pt>
          <cx:pt idx="3483">2804</cx:pt>
          <cx:pt idx="3484">2674</cx:pt>
          <cx:pt idx="3485">2957</cx:pt>
          <cx:pt idx="3486">2843</cx:pt>
          <cx:pt idx="3487">2935</cx:pt>
          <cx:pt idx="3488">2678</cx:pt>
          <cx:pt idx="3489">2851</cx:pt>
          <cx:pt idx="3490">2669</cx:pt>
          <cx:pt idx="3491">2557</cx:pt>
          <cx:pt idx="3492">2678</cx:pt>
          <cx:pt idx="3493">2397</cx:pt>
          <cx:pt idx="3494">2511</cx:pt>
          <cx:pt idx="3495">2891</cx:pt>
          <cx:pt idx="3496">3063</cx:pt>
          <cx:pt idx="3497">3074</cx:pt>
          <cx:pt idx="3498">2762</cx:pt>
          <cx:pt idx="3499">3041</cx:pt>
          <cx:pt idx="3500">3069</cx:pt>
          <cx:pt idx="3501">2788</cx:pt>
          <cx:pt idx="3502">2812</cx:pt>
          <cx:pt idx="3503">3034</cx:pt>
          <cx:pt idx="3504">2704</cx:pt>
          <cx:pt idx="3505">2629</cx:pt>
          <cx:pt idx="3506">2840</cx:pt>
          <cx:pt idx="3507">3147</cx:pt>
          <cx:pt idx="3508">2611</cx:pt>
          <cx:pt idx="3509">2713</cx:pt>
          <cx:pt idx="3510">3006</cx:pt>
          <cx:pt idx="3511">2696</cx:pt>
          <cx:pt idx="3512">2655</cx:pt>
          <cx:pt idx="3513">3034</cx:pt>
          <cx:pt idx="3514">3063</cx:pt>
          <cx:pt idx="3515">2685</cx:pt>
          <cx:pt idx="3516">2859</cx:pt>
          <cx:pt idx="3517">2944</cx:pt>
          <cx:pt idx="3518">2829</cx:pt>
          <cx:pt idx="3519">3288</cx:pt>
          <cx:pt idx="3520">2856</cx:pt>
          <cx:pt idx="3521">3015</cx:pt>
          <cx:pt idx="3522">3192</cx:pt>
          <cx:pt idx="3523">3185</cx:pt>
          <cx:pt idx="3524">2874</cx:pt>
          <cx:pt idx="3525">2875</cx:pt>
          <cx:pt idx="3526">3256</cx:pt>
          <cx:pt idx="3527">3035</cx:pt>
          <cx:pt idx="3528">3006</cx:pt>
          <cx:pt idx="3529">3359</cx:pt>
          <cx:pt idx="3530">3162</cx:pt>
          <cx:pt idx="3531">3084</cx:pt>
          <cx:pt idx="3532">2995</cx:pt>
          <cx:pt idx="3533">3222</cx:pt>
          <cx:pt idx="3534">2820</cx:pt>
          <cx:pt idx="3535">2894</cx:pt>
          <cx:pt idx="3536">2862</cx:pt>
          <cx:pt idx="3537">3176</cx:pt>
          <cx:pt idx="3538">3287</cx:pt>
          <cx:pt idx="3539">2950</cx:pt>
          <cx:pt idx="3540">3165</cx:pt>
          <cx:pt idx="3541">3130</cx:pt>
          <cx:pt idx="3542">3190</cx:pt>
          <cx:pt idx="3543">2772</cx:pt>
          <cx:pt idx="3544">2557</cx:pt>
          <cx:pt idx="3545">3009</cx:pt>
          <cx:pt idx="3546">2698</cx:pt>
          <cx:pt idx="3547">2819</cx:pt>
          <cx:pt idx="3548">2989</cx:pt>
          <cx:pt idx="3549">3102</cx:pt>
          <cx:pt idx="3550">2679</cx:pt>
          <cx:pt idx="3551">2629</cx:pt>
          <cx:pt idx="3552">3317</cx:pt>
          <cx:pt idx="3553">2279</cx:pt>
          <cx:pt idx="3554">2934</cx:pt>
          <cx:pt idx="3555">2882</cx:pt>
          <cx:pt idx="3556">2882</cx:pt>
          <cx:pt idx="3557">2559</cx:pt>
          <cx:pt idx="3558">2684</cx:pt>
          <cx:pt idx="3559">2842</cx:pt>
          <cx:pt idx="3560">2893</cx:pt>
          <cx:pt idx="3561">2593</cx:pt>
          <cx:pt idx="3562">2616</cx:pt>
          <cx:pt idx="3563">2839</cx:pt>
          <cx:pt idx="3564">2613</cx:pt>
          <cx:pt idx="3565">2810</cx:pt>
          <cx:pt idx="3566">2722</cx:pt>
          <cx:pt idx="3567">2573</cx:pt>
          <cx:pt idx="3568">2746</cx:pt>
          <cx:pt idx="3569">2665</cx:pt>
          <cx:pt idx="3570">2754</cx:pt>
          <cx:pt idx="3571">3165</cx:pt>
          <cx:pt idx="3572">2924</cx:pt>
          <cx:pt idx="3573">2386</cx:pt>
          <cx:pt idx="3574">2270</cx:pt>
          <cx:pt idx="3575">2409</cx:pt>
          <cx:pt idx="3576">2526</cx:pt>
          <cx:pt idx="3577">2330</cx:pt>
          <cx:pt idx="3578">2476</cx:pt>
          <cx:pt idx="3579">2093</cx:pt>
          <cx:pt idx="3580">2935</cx:pt>
          <cx:pt idx="3581">2308</cx:pt>
          <cx:pt idx="3582">2724</cx:pt>
          <cx:pt idx="3583">2562</cx:pt>
          <cx:pt idx="3584">2459</cx:pt>
          <cx:pt idx="3585">2628</cx:pt>
          <cx:pt idx="3586">2755</cx:pt>
          <cx:pt idx="3587">2693</cx:pt>
          <cx:pt idx="3588">2892</cx:pt>
          <cx:pt idx="3589">2730</cx:pt>
          <cx:pt idx="3590">2928</cx:pt>
          <cx:pt idx="3591">2668</cx:pt>
          <cx:pt idx="3592">2500</cx:pt>
          <cx:pt idx="3593">2984</cx:pt>
          <cx:pt idx="3594">2597</cx:pt>
          <cx:pt idx="3595">2404</cx:pt>
          <cx:pt idx="3596">2827</cx:pt>
          <cx:pt idx="3597">2640</cx:pt>
          <cx:pt idx="3598">2444</cx:pt>
          <cx:pt idx="3599">3169</cx:pt>
          <cx:pt idx="3600">2890</cx:pt>
          <cx:pt idx="3601">2815</cx:pt>
          <cx:pt idx="3602">2454</cx:pt>
          <cx:pt idx="3603">2630</cx:pt>
          <cx:pt idx="3604">2650</cx:pt>
          <cx:pt idx="3605">2585</cx:pt>
          <cx:pt idx="3606">2483</cx:pt>
          <cx:pt idx="3607">2943</cx:pt>
          <cx:pt idx="3608">2214</cx:pt>
          <cx:pt idx="3609">2674</cx:pt>
          <cx:pt idx="3610">2547</cx:pt>
          <cx:pt idx="3611">3027</cx:pt>
          <cx:pt idx="3612">2754</cx:pt>
          <cx:pt idx="3613">2643</cx:pt>
          <cx:pt idx="3614">2765</cx:pt>
          <cx:pt idx="3615">2871</cx:pt>
          <cx:pt idx="3616">2644</cx:pt>
          <cx:pt idx="3617">2829</cx:pt>
          <cx:pt idx="3618">2368</cx:pt>
          <cx:pt idx="3619">2403</cx:pt>
          <cx:pt idx="3620">2745</cx:pt>
          <cx:pt idx="3621">2836</cx:pt>
          <cx:pt idx="3622">2438</cx:pt>
          <cx:pt idx="3623">2892</cx:pt>
          <cx:pt idx="3624">2562</cx:pt>
          <cx:pt idx="3625">2906</cx:pt>
          <cx:pt idx="3626">2554</cx:pt>
          <cx:pt idx="3627">2830</cx:pt>
          <cx:pt idx="3628">2811</cx:pt>
          <cx:pt idx="3629">2935</cx:pt>
          <cx:pt idx="3630">2780</cx:pt>
          <cx:pt idx="3631">2854</cx:pt>
          <cx:pt idx="3632">2520</cx:pt>
          <cx:pt idx="3633">2428</cx:pt>
          <cx:pt idx="3634">3145</cx:pt>
          <cx:pt idx="3635">2312</cx:pt>
          <cx:pt idx="3636">2833</cx:pt>
          <cx:pt idx="3637">3060</cx:pt>
          <cx:pt idx="3638">2723</cx:pt>
          <cx:pt idx="3639">2722</cx:pt>
          <cx:pt idx="3640">2546</cx:pt>
          <cx:pt idx="3641">2277</cx:pt>
          <cx:pt idx="3642">2427</cx:pt>
          <cx:pt idx="3643">2394</cx:pt>
          <cx:pt idx="3644">2515</cx:pt>
          <cx:pt idx="3645">2649</cx:pt>
          <cx:pt idx="3646">2775</cx:pt>
          <cx:pt idx="3647">2517</cx:pt>
          <cx:pt idx="3648">2671</cx:pt>
          <cx:pt idx="3649">2813</cx:pt>
          <cx:pt idx="3650">2546</cx:pt>
          <cx:pt idx="3651">2719</cx:pt>
          <cx:pt idx="3652">2453</cx:pt>
          <cx:pt idx="3653">2408</cx:pt>
          <cx:pt idx="3654">2622</cx:pt>
          <cx:pt idx="3655">2771</cx:pt>
          <cx:pt idx="3656">2301</cx:pt>
          <cx:pt idx="3657">2211</cx:pt>
          <cx:pt idx="3658">2903</cx:pt>
          <cx:pt idx="3659">2725</cx:pt>
          <cx:pt idx="3660">2392</cx:pt>
          <cx:pt idx="3661">2576</cx:pt>
          <cx:pt idx="3662">2731</cx:pt>
          <cx:pt idx="3663">3030</cx:pt>
          <cx:pt idx="3664">2285</cx:pt>
          <cx:pt idx="3665">2288</cx:pt>
          <cx:pt idx="3666">2531</cx:pt>
          <cx:pt idx="3667">2745</cx:pt>
          <cx:pt idx="3668">2453</cx:pt>
          <cx:pt idx="3669">2544</cx:pt>
          <cx:pt idx="3670">3035</cx:pt>
          <cx:pt idx="3671">2575</cx:pt>
          <cx:pt idx="3672">2689</cx:pt>
          <cx:pt idx="3673">2788</cx:pt>
          <cx:pt idx="3674">2600</cx:pt>
          <cx:pt idx="3675">2632</cx:pt>
          <cx:pt idx="3676">2757</cx:pt>
          <cx:pt idx="3677">2343</cx:pt>
          <cx:pt idx="3678">2332</cx:pt>
          <cx:pt idx="3679">2656</cx:pt>
          <cx:pt idx="3680">2760</cx:pt>
          <cx:pt idx="3681">2777</cx:pt>
          <cx:pt idx="3682">2329</cx:pt>
          <cx:pt idx="3683">2705</cx:pt>
          <cx:pt idx="3684">2756</cx:pt>
          <cx:pt idx="3685">2555</cx:pt>
          <cx:pt idx="3686">2452</cx:pt>
          <cx:pt idx="3687">2687</cx:pt>
          <cx:pt idx="3688">2479</cx:pt>
          <cx:pt idx="3689">2666</cx:pt>
          <cx:pt idx="3690">2328</cx:pt>
          <cx:pt idx="3691">2581</cx:pt>
          <cx:pt idx="3692">2441</cx:pt>
          <cx:pt idx="3693">2682</cx:pt>
          <cx:pt idx="3694">2755</cx:pt>
          <cx:pt idx="3695">2604</cx:pt>
          <cx:pt idx="3696">2449</cx:pt>
          <cx:pt idx="3697">2175</cx:pt>
          <cx:pt idx="3698">2417</cx:pt>
          <cx:pt idx="3699">2523</cx:pt>
          <cx:pt idx="3700">2555</cx:pt>
          <cx:pt idx="3701">2417</cx:pt>
          <cx:pt idx="3702">2803</cx:pt>
          <cx:pt idx="3703">2437</cx:pt>
          <cx:pt idx="3704">2822</cx:pt>
          <cx:pt idx="3705">2278</cx:pt>
          <cx:pt idx="3706">2547</cx:pt>
          <cx:pt idx="3707">2495</cx:pt>
          <cx:pt idx="3708">2572</cx:pt>
          <cx:pt idx="3709">2809</cx:pt>
          <cx:pt idx="3710">2498</cx:pt>
          <cx:pt idx="3711">2268</cx:pt>
          <cx:pt idx="3712">2556</cx:pt>
          <cx:pt idx="3713">2289</cx:pt>
          <cx:pt idx="3714">2555</cx:pt>
          <cx:pt idx="3715">2190</cx:pt>
          <cx:pt idx="3716">2523</cx:pt>
          <cx:pt idx="3717">2667</cx:pt>
          <cx:pt idx="3718">2603</cx:pt>
          <cx:pt idx="3719">2170</cx:pt>
          <cx:pt idx="3720">2364</cx:pt>
          <cx:pt idx="3721">2309</cx:pt>
          <cx:pt idx="3722">2149</cx:pt>
          <cx:pt idx="3723">2053</cx:pt>
          <cx:pt idx="3724">2155</cx:pt>
          <cx:pt idx="3725">2473</cx:pt>
          <cx:pt idx="3726">2393</cx:pt>
          <cx:pt idx="3727">2410</cx:pt>
          <cx:pt idx="3728">2580</cx:pt>
          <cx:pt idx="3729">2208</cx:pt>
          <cx:pt idx="3730">2580</cx:pt>
          <cx:pt idx="3731">2292</cx:pt>
          <cx:pt idx="3732">2253</cx:pt>
          <cx:pt idx="3733">2713</cx:pt>
          <cx:pt idx="3734">2268</cx:pt>
          <cx:pt idx="3735">2592</cx:pt>
          <cx:pt idx="3736">2436</cx:pt>
          <cx:pt idx="3737">2443</cx:pt>
          <cx:pt idx="3738">2744</cx:pt>
          <cx:pt idx="3739">2491</cx:pt>
          <cx:pt idx="3740">2554</cx:pt>
          <cx:pt idx="3741">2777</cx:pt>
          <cx:pt idx="3742">2350</cx:pt>
          <cx:pt idx="3743">2689</cx:pt>
          <cx:pt idx="3744">2192</cx:pt>
          <cx:pt idx="3745">2056</cx:pt>
          <cx:pt idx="3746">2528</cx:pt>
          <cx:pt idx="3747">2260</cx:pt>
          <cx:pt idx="3748">2157</cx:pt>
          <cx:pt idx="3749">2180</cx:pt>
          <cx:pt idx="3750">2484</cx:pt>
          <cx:pt idx="3751">2287</cx:pt>
          <cx:pt idx="3752">2499</cx:pt>
          <cx:pt idx="3753">2056</cx:pt>
          <cx:pt idx="3754">2303</cx:pt>
          <cx:pt idx="3755">2177</cx:pt>
          <cx:pt idx="3756">2318</cx:pt>
          <cx:pt idx="3757">2286</cx:pt>
          <cx:pt idx="3758">2130</cx:pt>
          <cx:pt idx="3759">1978</cx:pt>
          <cx:pt idx="3760">1873</cx:pt>
          <cx:pt idx="3761">2148</cx:pt>
          <cx:pt idx="3762">1935</cx:pt>
          <cx:pt idx="3763">2182</cx:pt>
          <cx:pt idx="3764">2011</cx:pt>
          <cx:pt idx="3765">1926</cx:pt>
          <cx:pt idx="3766">2104</cx:pt>
          <cx:pt idx="3767">2348</cx:pt>
          <cx:pt idx="3768">2332</cx:pt>
          <cx:pt idx="3769">2074</cx:pt>
          <cx:pt idx="3770">2457</cx:pt>
          <cx:pt idx="3771">2220</cx:pt>
          <cx:pt idx="3772">2256</cx:pt>
          <cx:pt idx="3773">2298</cx:pt>
          <cx:pt idx="3774">2071</cx:pt>
          <cx:pt idx="3775">2493</cx:pt>
          <cx:pt idx="3776">2223</cx:pt>
          <cx:pt idx="3777">2167</cx:pt>
          <cx:pt idx="3778">2308</cx:pt>
          <cx:pt idx="3779">2254</cx:pt>
          <cx:pt idx="3780">2119</cx:pt>
          <cx:pt idx="3781">1937</cx:pt>
          <cx:pt idx="3782">2037</cx:pt>
          <cx:pt idx="3783">2032</cx:pt>
          <cx:pt idx="3784">1978</cx:pt>
          <cx:pt idx="3785">2314</cx:pt>
          <cx:pt idx="3786">2385</cx:pt>
          <cx:pt idx="3787">2613</cx:pt>
          <cx:pt idx="3788">2199</cx:pt>
          <cx:pt idx="3789">2234</cx:pt>
          <cx:pt idx="3790">2454</cx:pt>
          <cx:pt idx="3791">2512</cx:pt>
          <cx:pt idx="3792">2242</cx:pt>
          <cx:pt idx="3793">2397</cx:pt>
          <cx:pt idx="3794">2354</cx:pt>
          <cx:pt idx="3795">2530</cx:pt>
          <cx:pt idx="3796">2357</cx:pt>
          <cx:pt idx="3797">2192</cx:pt>
          <cx:pt idx="3798">2229</cx:pt>
          <cx:pt idx="3799">2583</cx:pt>
          <cx:pt idx="3800">2667</cx:pt>
          <cx:pt idx="3801">2423</cx:pt>
          <cx:pt idx="3802">2104</cx:pt>
          <cx:pt idx="3803">2086</cx:pt>
          <cx:pt idx="3804">2400</cx:pt>
          <cx:pt idx="3805">2647</cx:pt>
          <cx:pt idx="3806">2501</cx:pt>
          <cx:pt idx="3807">2425</cx:pt>
          <cx:pt idx="3808">2780</cx:pt>
          <cx:pt idx="3809">2383</cx:pt>
          <cx:pt idx="3810">3050</cx:pt>
          <cx:pt idx="3811">2177</cx:pt>
          <cx:pt idx="3812">2507</cx:pt>
          <cx:pt idx="3813">2741</cx:pt>
          <cx:pt idx="3814">2399</cx:pt>
          <cx:pt idx="3815">2456</cx:pt>
          <cx:pt idx="3816">2280</cx:pt>
          <cx:pt idx="3817">2379</cx:pt>
          <cx:pt idx="3818">2084</cx:pt>
          <cx:pt idx="3819">2311</cx:pt>
          <cx:pt idx="3820">2071</cx:pt>
          <cx:pt idx="3821">2477</cx:pt>
          <cx:pt idx="3822">2780</cx:pt>
          <cx:pt idx="3823">2291</cx:pt>
          <cx:pt idx="3824">2448</cx:pt>
          <cx:pt idx="3825">2805</cx:pt>
          <cx:pt idx="3826">2240</cx:pt>
          <cx:pt idx="3827">2603</cx:pt>
          <cx:pt idx="3828">2482</cx:pt>
          <cx:pt idx="3829">2383</cx:pt>
          <cx:pt idx="3830">2880</cx:pt>
          <cx:pt idx="3831">2548</cx:pt>
          <cx:pt idx="3832">2791</cx:pt>
          <cx:pt idx="3833">2299</cx:pt>
          <cx:pt idx="3834">3339</cx:pt>
          <cx:pt idx="3835">2646</cx:pt>
          <cx:pt idx="3836">2356</cx:pt>
          <cx:pt idx="3837">2192</cx:pt>
          <cx:pt idx="3838">2733</cx:pt>
          <cx:pt idx="3839">1977</cx:pt>
          <cx:pt idx="3840">2785</cx:pt>
          <cx:pt idx="3841">2997</cx:pt>
          <cx:pt idx="3842">3259</cx:pt>
          <cx:pt idx="3843">3236</cx:pt>
          <cx:pt idx="3844">2484</cx:pt>
          <cx:pt idx="3845">2602</cx:pt>
          <cx:pt idx="3846">3406</cx:pt>
          <cx:pt idx="3847">3193</cx:pt>
          <cx:pt idx="3848">3410</cx:pt>
          <cx:pt idx="3849">3079</cx:pt>
          <cx:pt idx="3850">2738</cx:pt>
          <cx:pt idx="3851">3314</cx:pt>
          <cx:pt idx="3852">2977</cx:pt>
          <cx:pt idx="3853">3002</cx:pt>
          <cx:pt idx="3854">2839</cx:pt>
          <cx:pt idx="3855">2851</cx:pt>
          <cx:pt idx="3856">2827</cx:pt>
          <cx:pt idx="3857">2709</cx:pt>
          <cx:pt idx="3858">3066</cx:pt>
          <cx:pt idx="3859">2741</cx:pt>
          <cx:pt idx="3860">3156</cx:pt>
          <cx:pt idx="3861">2768</cx:pt>
          <cx:pt idx="3862">2671</cx:pt>
          <cx:pt idx="3863">2622</cx:pt>
          <cx:pt idx="3864">2513</cx:pt>
          <cx:pt idx="3865">2871</cx:pt>
          <cx:pt idx="3866">2988</cx:pt>
          <cx:pt idx="3867">2675</cx:pt>
          <cx:pt idx="3868">2564</cx:pt>
          <cx:pt idx="3869">2760</cx:pt>
          <cx:pt idx="3870">2754</cx:pt>
          <cx:pt idx="3871">2781</cx:pt>
          <cx:pt idx="3872">2674</cx:pt>
          <cx:pt idx="3873">2630</cx:pt>
          <cx:pt idx="3874">2814</cx:pt>
          <cx:pt idx="3875">2960</cx:pt>
          <cx:pt idx="3876">2844</cx:pt>
          <cx:pt idx="3877">2748</cx:pt>
          <cx:pt idx="3878">2332</cx:pt>
          <cx:pt idx="3879">2602</cx:pt>
          <cx:pt idx="3880">2345</cx:pt>
          <cx:pt idx="3881">2430</cx:pt>
          <cx:pt idx="3882">2312</cx:pt>
          <cx:pt idx="3883">2577</cx:pt>
          <cx:pt idx="3884">2394</cx:pt>
          <cx:pt idx="3885">2558</cx:pt>
          <cx:pt idx="3886">2576</cx:pt>
          <cx:pt idx="3887">2571</cx:pt>
          <cx:pt idx="3888">2913</cx:pt>
          <cx:pt idx="3889">2160</cx:pt>
          <cx:pt idx="3890">2574</cx:pt>
          <cx:pt idx="3891">2752</cx:pt>
          <cx:pt idx="3892">2336</cx:pt>
          <cx:pt idx="3893">2051</cx:pt>
          <cx:pt idx="3894">2466</cx:pt>
          <cx:pt idx="3895">3011</cx:pt>
          <cx:pt idx="3896">2657</cx:pt>
          <cx:pt idx="3897">2341</cx:pt>
          <cx:pt idx="3898">2842</cx:pt>
          <cx:pt idx="3899">2845</cx:pt>
          <cx:pt idx="3900">2661</cx:pt>
          <cx:pt idx="3901">2775</cx:pt>
          <cx:pt idx="3902">3067</cx:pt>
          <cx:pt idx="3903">3265</cx:pt>
          <cx:pt idx="3904">2461</cx:pt>
          <cx:pt idx="3905">2429</cx:pt>
          <cx:pt idx="3906">2394</cx:pt>
          <cx:pt idx="3907">2441</cx:pt>
          <cx:pt idx="3908">3097</cx:pt>
          <cx:pt idx="3909">2519</cx:pt>
          <cx:pt idx="3910">2784</cx:pt>
          <cx:pt idx="3911">2857</cx:pt>
          <cx:pt idx="3912">2931</cx:pt>
          <cx:pt idx="3913">3125</cx:pt>
          <cx:pt idx="3914">3244</cx:pt>
          <cx:pt idx="3915">3199</cx:pt>
          <cx:pt idx="3916">2868</cx:pt>
          <cx:pt idx="3917">2575</cx:pt>
          <cx:pt idx="3918">2452</cx:pt>
          <cx:pt idx="3919">2368</cx:pt>
          <cx:pt idx="3920">2722</cx:pt>
          <cx:pt idx="3921">2790</cx:pt>
          <cx:pt idx="3922">2742</cx:pt>
          <cx:pt idx="3923">2738</cx:pt>
          <cx:pt idx="3924">2820</cx:pt>
          <cx:pt idx="3925">2526</cx:pt>
          <cx:pt idx="3926">2890</cx:pt>
          <cx:pt idx="3927">2385</cx:pt>
          <cx:pt idx="3928">2579</cx:pt>
          <cx:pt idx="3929">3019</cx:pt>
          <cx:pt idx="3930">3268</cx:pt>
          <cx:pt idx="3931">3407</cx:pt>
          <cx:pt idx="3932">2646</cx:pt>
          <cx:pt idx="3933">2986</cx:pt>
          <cx:pt idx="3934">3162</cx:pt>
          <cx:pt idx="3935">2931</cx:pt>
          <cx:pt idx="3936">2817</cx:pt>
          <cx:pt idx="3937">2938</cx:pt>
          <cx:pt idx="3938">3052</cx:pt>
          <cx:pt idx="3939">3110</cx:pt>
          <cx:pt idx="3940">2685</cx:pt>
          <cx:pt idx="3941">3045</cx:pt>
          <cx:pt idx="3942">2966</cx:pt>
          <cx:pt idx="3943">2908</cx:pt>
          <cx:pt idx="3944">2834</cx:pt>
          <cx:pt idx="3945">2789</cx:pt>
          <cx:pt idx="3946">2456</cx:pt>
          <cx:pt idx="3947">2842</cx:pt>
          <cx:pt idx="3948">2677</cx:pt>
          <cx:pt idx="3949">2685</cx:pt>
          <cx:pt idx="3950">2500</cx:pt>
          <cx:pt idx="3951">2243</cx:pt>
          <cx:pt idx="3952">2759</cx:pt>
          <cx:pt idx="3953">2649</cx:pt>
          <cx:pt idx="3954">2435</cx:pt>
          <cx:pt idx="3955">2825</cx:pt>
          <cx:pt idx="3956">2604</cx:pt>
          <cx:pt idx="3957">2725</cx:pt>
          <cx:pt idx="3958">2976</cx:pt>
          <cx:pt idx="3959">2930</cx:pt>
          <cx:pt idx="3960">2891</cx:pt>
          <cx:pt idx="3961">2187</cx:pt>
          <cx:pt idx="3962">2298</cx:pt>
          <cx:pt idx="3963">2463</cx:pt>
          <cx:pt idx="3964">2859</cx:pt>
          <cx:pt idx="3965">2560</cx:pt>
          <cx:pt idx="3966">2221</cx:pt>
          <cx:pt idx="3967">2305</cx:pt>
          <cx:pt idx="3968">2169</cx:pt>
          <cx:pt idx="3969">2812</cx:pt>
          <cx:pt idx="3970">2346</cx:pt>
          <cx:pt idx="3971">2315</cx:pt>
          <cx:pt idx="3972">2690</cx:pt>
          <cx:pt idx="3973">3144</cx:pt>
          <cx:pt idx="3974">2523</cx:pt>
          <cx:pt idx="3975">2478</cx:pt>
          <cx:pt idx="3976">2600</cx:pt>
          <cx:pt idx="3977">2489</cx:pt>
          <cx:pt idx="3978">2605</cx:pt>
          <cx:pt idx="3979">2400</cx:pt>
          <cx:pt idx="3980">2408</cx:pt>
          <cx:pt idx="3981">2534</cx:pt>
          <cx:pt idx="3982">1979</cx:pt>
          <cx:pt idx="3983">2576</cx:pt>
          <cx:pt idx="3984">2816</cx:pt>
          <cx:pt idx="3985">2775</cx:pt>
          <cx:pt idx="3986">2381</cx:pt>
          <cx:pt idx="3987">2186</cx:pt>
          <cx:pt idx="3988">2527</cx:pt>
          <cx:pt idx="3989">2468</cx:pt>
          <cx:pt idx="3990">2314</cx:pt>
          <cx:pt idx="3991">2582</cx:pt>
          <cx:pt idx="3992">2773</cx:pt>
          <cx:pt idx="3993">2771</cx:pt>
          <cx:pt idx="3994">2419</cx:pt>
          <cx:pt idx="3995">2660</cx:pt>
          <cx:pt idx="3996">2281</cx:pt>
          <cx:pt idx="3997">2149</cx:pt>
          <cx:pt idx="3998">2434</cx:pt>
          <cx:pt idx="3999">2168</cx:pt>
          <cx:pt idx="4000">2325</cx:pt>
          <cx:pt idx="4001">2029</cx:pt>
          <cx:pt idx="4002">2439</cx:pt>
          <cx:pt idx="4003">2576</cx:pt>
          <cx:pt idx="4004">2505</cx:pt>
          <cx:pt idx="4005">2600</cx:pt>
          <cx:pt idx="4006">2335</cx:pt>
          <cx:pt idx="4007">2319</cx:pt>
          <cx:pt idx="4008">2457</cx:pt>
          <cx:pt idx="4009">2373</cx:pt>
          <cx:pt idx="4010">1931</cx:pt>
          <cx:pt idx="4011">2222</cx:pt>
          <cx:pt idx="4012">1844</cx:pt>
          <cx:pt idx="4013">2527</cx:pt>
          <cx:pt idx="4014">2247</cx:pt>
          <cx:pt idx="4015">2293</cx:pt>
          <cx:pt idx="4016">2293</cx:pt>
          <cx:pt idx="4017">2416</cx:pt>
          <cx:pt idx="4018">2491</cx:pt>
          <cx:pt idx="4019">2374</cx:pt>
          <cx:pt idx="4020">2411</cx:pt>
          <cx:pt idx="4021">2471</cx:pt>
          <cx:pt idx="4022">1915</cx:pt>
          <cx:pt idx="4023">2512</cx:pt>
          <cx:pt idx="4024">2430</cx:pt>
          <cx:pt idx="4025">2354</cx:pt>
          <cx:pt idx="4026">2443</cx:pt>
          <cx:pt idx="4027">2852</cx:pt>
          <cx:pt idx="4028">2548</cx:pt>
          <cx:pt idx="4029">2606</cx:pt>
          <cx:pt idx="4030">2351</cx:pt>
          <cx:pt idx="4031">2976</cx:pt>
          <cx:pt idx="4032">2544</cx:pt>
          <cx:pt idx="4033">2236</cx:pt>
          <cx:pt idx="4034">2608</cx:pt>
          <cx:pt idx="4035">2188</cx:pt>
          <cx:pt idx="4036">2098</cx:pt>
          <cx:pt idx="4037">2429</cx:pt>
          <cx:pt idx="4038">1999</cx:pt>
          <cx:pt idx="4039">2462</cx:pt>
          <cx:pt idx="4040">2339</cx:pt>
          <cx:pt idx="4041">2275</cx:pt>
          <cx:pt idx="4042">2354</cx:pt>
          <cx:pt idx="4043">2564</cx:pt>
          <cx:pt idx="4044">2827</cx:pt>
          <cx:pt idx="4045">2992</cx:pt>
          <cx:pt idx="4046">2693</cx:pt>
          <cx:pt idx="4047">2773</cx:pt>
          <cx:pt idx="4048">3029</cx:pt>
          <cx:pt idx="4049">2640</cx:pt>
          <cx:pt idx="4050">2684</cx:pt>
          <cx:pt idx="4051">3039</cx:pt>
          <cx:pt idx="4052">2954</cx:pt>
          <cx:pt idx="4053">3265</cx:pt>
          <cx:pt idx="4054">2601</cx:pt>
          <cx:pt idx="4055">2992</cx:pt>
          <cx:pt idx="4056">2896</cx:pt>
          <cx:pt idx="4057">2842</cx:pt>
          <cx:pt idx="4058">2803</cx:pt>
          <cx:pt idx="4059">2744</cx:pt>
          <cx:pt idx="4060">2751</cx:pt>
          <cx:pt idx="4061">2390</cx:pt>
          <cx:pt idx="4062">2677</cx:pt>
          <cx:pt idx="4063">2571</cx:pt>
          <cx:pt idx="4064">2759</cx:pt>
          <cx:pt idx="4065">2686</cx:pt>
          <cx:pt idx="4066">2948</cx:pt>
          <cx:pt idx="4067">3067</cx:pt>
          <cx:pt idx="4068">2358</cx:pt>
          <cx:pt idx="4069">2366</cx:pt>
          <cx:pt idx="4070">2371</cx:pt>
          <cx:pt idx="4071">2657</cx:pt>
          <cx:pt idx="4072">2758</cx:pt>
          <cx:pt idx="4073">2616</cx:pt>
          <cx:pt idx="4074">2507</cx:pt>
          <cx:pt idx="4075">2751</cx:pt>
          <cx:pt idx="4076">2985</cx:pt>
          <cx:pt idx="4077">2280</cx:pt>
          <cx:pt idx="4078">2468</cx:pt>
          <cx:pt idx="4079">2605</cx:pt>
          <cx:pt idx="4080">2562</cx:pt>
          <cx:pt idx="4081">2903</cx:pt>
          <cx:pt idx="4082">2308</cx:pt>
          <cx:pt idx="4083">2473</cx:pt>
          <cx:pt idx="4084">2467</cx:pt>
          <cx:pt idx="4085">2562</cx:pt>
          <cx:pt idx="4086">2804</cx:pt>
          <cx:pt idx="4087">2776</cx:pt>
          <cx:pt idx="4088">2546</cx:pt>
          <cx:pt idx="4089">2713</cx:pt>
          <cx:pt idx="4090">2722</cx:pt>
          <cx:pt idx="4091">2700</cx:pt>
          <cx:pt idx="4092">2823</cx:pt>
          <cx:pt idx="4093">2058</cx:pt>
          <cx:pt idx="4094">2295</cx:pt>
          <cx:pt idx="4095">2601</cx:pt>
          <cx:pt idx="4096">2574</cx:pt>
          <cx:pt idx="4097">2349</cx:pt>
          <cx:pt idx="4098">2868</cx:pt>
          <cx:pt idx="4099">2612</cx:pt>
          <cx:pt idx="4100">2666</cx:pt>
          <cx:pt idx="4101">2782</cx:pt>
          <cx:pt idx="4102">2669</cx:pt>
          <cx:pt idx="4103">2736</cx:pt>
          <cx:pt idx="4104">2641</cx:pt>
          <cx:pt idx="4105">2625</cx:pt>
          <cx:pt idx="4106">2752</cx:pt>
          <cx:pt idx="4107">2240</cx:pt>
          <cx:pt idx="4108">2380</cx:pt>
          <cx:pt idx="4109">2088</cx:pt>
          <cx:pt idx="4110">2416</cx:pt>
          <cx:pt idx="4111">2884</cx:pt>
          <cx:pt idx="4112">2671</cx:pt>
          <cx:pt idx="4113">2507</cx:pt>
          <cx:pt idx="4114">2460</cx:pt>
          <cx:pt idx="4115">2244</cx:pt>
          <cx:pt idx="4116">2304</cx:pt>
          <cx:pt idx="4117">2258</cx:pt>
          <cx:pt idx="4118">2059</cx:pt>
          <cx:pt idx="4119">2436</cx:pt>
          <cx:pt idx="4120">2342</cx:pt>
          <cx:pt idx="4121">2264</cx:pt>
          <cx:pt idx="4122">1889</cx:pt>
          <cx:pt idx="4123">2303</cx:pt>
          <cx:pt idx="4124">2328</cx:pt>
          <cx:pt idx="4125">2070</cx:pt>
          <cx:pt idx="4126">2343</cx:pt>
          <cx:pt idx="4127">2451</cx:pt>
          <cx:pt idx="4128">2482</cx:pt>
          <cx:pt idx="4129">2557</cx:pt>
          <cx:pt idx="4130">2651</cx:pt>
          <cx:pt idx="4131">2187</cx:pt>
          <cx:pt idx="4132">2427</cx:pt>
          <cx:pt idx="4133">2190</cx:pt>
          <cx:pt idx="4134">2326</cx:pt>
          <cx:pt idx="4135">2338</cx:pt>
          <cx:pt idx="4136">2578</cx:pt>
          <cx:pt idx="4137">2086</cx:pt>
          <cx:pt idx="4138">2134</cx:pt>
          <cx:pt idx="4139">2138</cx:pt>
          <cx:pt idx="4140">2554</cx:pt>
          <cx:pt idx="4141">2303</cx:pt>
          <cx:pt idx="4142">2326</cx:pt>
          <cx:pt idx="4143">2379</cx:pt>
          <cx:pt idx="4144">2579</cx:pt>
          <cx:pt idx="4145">2372</cx:pt>
          <cx:pt idx="4146">2428</cx:pt>
          <cx:pt idx="4147">2379</cx:pt>
          <cx:pt idx="4148">2198</cx:pt>
          <cx:pt idx="4149">2381</cx:pt>
          <cx:pt idx="4150">2257</cx:pt>
          <cx:pt idx="4151">2309</cx:pt>
          <cx:pt idx="4152">2636</cx:pt>
          <cx:pt idx="4153">2743</cx:pt>
          <cx:pt idx="4154">2631</cx:pt>
          <cx:pt idx="4155">2327</cx:pt>
          <cx:pt idx="4156">2689</cx:pt>
          <cx:pt idx="4157">2003</cx:pt>
          <cx:pt idx="4158">2680</cx:pt>
          <cx:pt idx="4159">2232</cx:pt>
          <cx:pt idx="4160">2175</cx:pt>
          <cx:pt idx="4161">2265</cx:pt>
          <cx:pt idx="4162">2429</cx:pt>
          <cx:pt idx="4163">2817</cx:pt>
          <cx:pt idx="4164">2796</cx:pt>
          <cx:pt idx="4165">2595</cx:pt>
          <cx:pt idx="4166">2411</cx:pt>
          <cx:pt idx="4167">2357</cx:pt>
          <cx:pt idx="4168">2656</cx:pt>
          <cx:pt idx="4169">2184</cx:pt>
          <cx:pt idx="4170">2336</cx:pt>
          <cx:pt idx="4171">2162</cx:pt>
          <cx:pt idx="4172">2368</cx:pt>
          <cx:pt idx="4173">2652</cx:pt>
          <cx:pt idx="4174">2585</cx:pt>
          <cx:pt idx="4175">2899</cx:pt>
          <cx:pt idx="4176">2092</cx:pt>
          <cx:pt idx="4177">2397</cx:pt>
          <cx:pt idx="4178">2621</cx:pt>
          <cx:pt idx="4179">2483</cx:pt>
          <cx:pt idx="4180">2374</cx:pt>
          <cx:pt idx="4181">2210</cx:pt>
          <cx:pt idx="4182">2678</cx:pt>
          <cx:pt idx="4183">2396</cx:pt>
          <cx:pt idx="4184">2359</cx:pt>
          <cx:pt idx="4185">2695</cx:pt>
          <cx:pt idx="4186">2409</cx:pt>
          <cx:pt idx="4187">2340</cx:pt>
          <cx:pt idx="4188">2296</cx:pt>
          <cx:pt idx="4189">2251</cx:pt>
          <cx:pt idx="4190">2459</cx:pt>
          <cx:pt idx="4191">2937</cx:pt>
          <cx:pt idx="4192">3295</cx:pt>
          <cx:pt idx="4193">2906</cx:pt>
          <cx:pt idx="4194">2793</cx:pt>
          <cx:pt idx="4195">2843</cx:pt>
          <cx:pt idx="4196">2628</cx:pt>
          <cx:pt idx="4197">2381</cx:pt>
          <cx:pt idx="4198">2858</cx:pt>
          <cx:pt idx="4199">2643</cx:pt>
          <cx:pt idx="4200">3068</cx:pt>
          <cx:pt idx="4201">2764</cx:pt>
          <cx:pt idx="4202">2868</cx:pt>
          <cx:pt idx="4203">3291</cx:pt>
          <cx:pt idx="4204">2815</cx:pt>
          <cx:pt idx="4205">2809</cx:pt>
          <cx:pt idx="4206">3120</cx:pt>
          <cx:pt idx="4207">2921</cx:pt>
          <cx:pt idx="4208">2976</cx:pt>
          <cx:pt idx="4209">2937</cx:pt>
          <cx:pt idx="4210">3052</cx:pt>
          <cx:pt idx="4211">2754</cx:pt>
          <cx:pt idx="4212">2760</cx:pt>
          <cx:pt idx="4213">3255</cx:pt>
          <cx:pt idx="4214">2976</cx:pt>
          <cx:pt idx="4215">2693</cx:pt>
          <cx:pt idx="4216">2437</cx:pt>
          <cx:pt idx="4217">2703</cx:pt>
          <cx:pt idx="4218">2934</cx:pt>
          <cx:pt idx="4219">2603</cx:pt>
          <cx:pt idx="4220">2596</cx:pt>
          <cx:pt idx="4221">2896</cx:pt>
          <cx:pt idx="4222">2611</cx:pt>
          <cx:pt idx="4223">2338</cx:pt>
          <cx:pt idx="4224">2352</cx:pt>
          <cx:pt idx="4225">2944</cx:pt>
          <cx:pt idx="4226">2539</cx:pt>
          <cx:pt idx="4227">2444</cx:pt>
          <cx:pt idx="4228">2499</cx:pt>
          <cx:pt idx="4229">2439</cx:pt>
          <cx:pt idx="4230">2686</cx:pt>
          <cx:pt idx="4231">2895</cx:pt>
          <cx:pt idx="4232">2756</cx:pt>
          <cx:pt idx="4233">2351</cx:pt>
          <cx:pt idx="4234">2316</cx:pt>
          <cx:pt idx="4235">2459</cx:pt>
          <cx:pt idx="4236">2477</cx:pt>
          <cx:pt idx="4237">2926</cx:pt>
          <cx:pt idx="4238">2571</cx:pt>
          <cx:pt idx="4239">2749</cx:pt>
          <cx:pt idx="4240">2837</cx:pt>
          <cx:pt idx="4241">2637</cx:pt>
          <cx:pt idx="4242">2653</cx:pt>
          <cx:pt idx="4243">2511</cx:pt>
          <cx:pt idx="4244">2078</cx:pt>
          <cx:pt idx="4245">2777</cx:pt>
          <cx:pt idx="4246">2835</cx:pt>
          <cx:pt idx="4247">2765</cx:pt>
          <cx:pt idx="4248">2723</cx:pt>
          <cx:pt idx="4249">2846</cx:pt>
          <cx:pt idx="4250">3004</cx:pt>
          <cx:pt idx="4251">2361</cx:pt>
          <cx:pt idx="4252">2273</cx:pt>
          <cx:pt idx="4253">2602</cx:pt>
          <cx:pt idx="4254">2904</cx:pt>
          <cx:pt idx="4255">2943</cx:pt>
          <cx:pt idx="4256">2699</cx:pt>
          <cx:pt idx="4257">2676</cx:pt>
          <cx:pt idx="4258">2835</cx:pt>
          <cx:pt idx="4259">2678</cx:pt>
          <cx:pt idx="4260">2473</cx:pt>
          <cx:pt idx="4261">2724</cx:pt>
          <cx:pt idx="4262">2326</cx:pt>
          <cx:pt idx="4263">2348</cx:pt>
          <cx:pt idx="4264">2714</cx:pt>
          <cx:pt idx="4265">2728</cx:pt>
          <cx:pt idx="4266">2662</cx:pt>
          <cx:pt idx="4267">2418</cx:pt>
          <cx:pt idx="4268">2363</cx:pt>
          <cx:pt idx="4269">2701</cx:pt>
          <cx:pt idx="4270">2536</cx:pt>
          <cx:pt idx="4271">2402</cx:pt>
          <cx:pt idx="4272">2487</cx:pt>
          <cx:pt idx="4273">2521</cx:pt>
          <cx:pt idx="4274">2234</cx:pt>
          <cx:pt idx="4275">2726</cx:pt>
          <cx:pt idx="4276">2685</cx:pt>
          <cx:pt idx="4277">2373</cx:pt>
          <cx:pt idx="4278">2569</cx:pt>
          <cx:pt idx="4279">2434</cx:pt>
          <cx:pt idx="4280">2771</cx:pt>
          <cx:pt idx="4281">2349</cx:pt>
          <cx:pt idx="4282">2242</cx:pt>
          <cx:pt idx="4283">2732</cx:pt>
          <cx:pt idx="4284">2341</cx:pt>
          <cx:pt idx="4285">2403</cx:pt>
          <cx:pt idx="4286">2537</cx:pt>
          <cx:pt idx="4287">2342</cx:pt>
          <cx:pt idx="4288">2738</cx:pt>
          <cx:pt idx="4289">2820</cx:pt>
          <cx:pt idx="4290">2782</cx:pt>
          <cx:pt idx="4291">2526</cx:pt>
          <cx:pt idx="4292">2664</cx:pt>
          <cx:pt idx="4293">2048</cx:pt>
          <cx:pt idx="4294">2428</cx:pt>
          <cx:pt idx="4295">2165</cx:pt>
          <cx:pt idx="4296">2222</cx:pt>
          <cx:pt idx="4297">2429</cx:pt>
          <cx:pt idx="4298">2306</cx:pt>
          <cx:pt idx="4299">2214</cx:pt>
          <cx:pt idx="4300">2051</cx:pt>
          <cx:pt idx="4301">2002</cx:pt>
          <cx:pt idx="4302">2527</cx:pt>
          <cx:pt idx="4303">2240</cx:pt>
          <cx:pt idx="4304">2299</cx:pt>
          <cx:pt idx="4305">2480</cx:pt>
          <cx:pt idx="4306">2193</cx:pt>
          <cx:pt idx="4307">2439</cx:pt>
          <cx:pt idx="4308">2757</cx:pt>
          <cx:pt idx="4309">2431</cx:pt>
          <cx:pt idx="4310">2592</cx:pt>
          <cx:pt idx="4311">2484</cx:pt>
          <cx:pt idx="4312">2387</cx:pt>
          <cx:pt idx="4313">2487</cx:pt>
          <cx:pt idx="4314">2333</cx:pt>
          <cx:pt idx="4315">2608</cx:pt>
          <cx:pt idx="4316">2736</cx:pt>
          <cx:pt idx="4317">2332</cx:pt>
          <cx:pt idx="4318">2574</cx:pt>
          <cx:pt idx="4319">2538</cx:pt>
          <cx:pt idx="4320">2134</cx:pt>
          <cx:pt idx="4321">2281</cx:pt>
          <cx:pt idx="4322">2053</cx:pt>
          <cx:pt idx="4323">2476</cx:pt>
          <cx:pt idx="4324">2299</cx:pt>
          <cx:pt idx="4325">2454</cx:pt>
          <cx:pt idx="4326">2073</cx:pt>
          <cx:pt idx="4327">2402</cx:pt>
          <cx:pt idx="4328">2214</cx:pt>
          <cx:pt idx="4329">2045</cx:pt>
          <cx:pt idx="4330">2849</cx:pt>
          <cx:pt idx="4331">2813</cx:pt>
          <cx:pt idx="4332">2505</cx:pt>
          <cx:pt idx="4333">2154</cx:pt>
          <cx:pt idx="4334">2707</cx:pt>
          <cx:pt idx="4335">2580</cx:pt>
          <cx:pt idx="4336">2124</cx:pt>
          <cx:pt idx="4337">2742</cx:pt>
          <cx:pt idx="4338">2441</cx:pt>
          <cx:pt idx="4339">2099</cx:pt>
          <cx:pt idx="4340">2314</cx:pt>
          <cx:pt idx="4341">2136</cx:pt>
          <cx:pt idx="4342">1957</cx:pt>
          <cx:pt idx="4343">2108</cx:pt>
          <cx:pt idx="4344">2131</cx:pt>
          <cx:pt idx="4345">2414</cx:pt>
          <cx:pt idx="4346">2532</cx:pt>
          <cx:pt idx="4347">2268</cx:pt>
          <cx:pt idx="4348">2806</cx:pt>
          <cx:pt idx="4349">2461</cx:pt>
          <cx:pt idx="4350">2844</cx:pt>
          <cx:pt idx="4351">2370</cx:pt>
          <cx:pt idx="4352">2474</cx:pt>
          <cx:pt idx="4353">2623</cx:pt>
          <cx:pt idx="4354">2559</cx:pt>
          <cx:pt idx="4355">2541</cx:pt>
          <cx:pt idx="4356">2527</cx:pt>
          <cx:pt idx="4357">2497</cx:pt>
          <cx:pt idx="4358">2187</cx:pt>
          <cx:pt idx="4359">2229</cx:pt>
          <cx:pt idx="4360">3059</cx:pt>
          <cx:pt idx="4361">2974</cx:pt>
          <cx:pt idx="4362">2616</cx:pt>
          <cx:pt idx="4363">2651</cx:pt>
          <cx:pt idx="4364">2790</cx:pt>
          <cx:pt idx="4365">2762</cx:pt>
          <cx:pt idx="4366">2909</cx:pt>
          <cx:pt idx="4367">3244</cx:pt>
          <cx:pt idx="4368">2412</cx:pt>
          <cx:pt idx="4369">2606</cx:pt>
          <cx:pt idx="4370">2582</cx:pt>
          <cx:pt idx="4371">2582</cx:pt>
          <cx:pt idx="4372">2457</cx:pt>
          <cx:pt idx="4373">3484</cx:pt>
          <cx:pt idx="4374">2913</cx:pt>
          <cx:pt idx="4375">2843</cx:pt>
          <cx:pt idx="4376">2906</cx:pt>
          <cx:pt idx="4377">3097</cx:pt>
          <cx:pt idx="4378">3056</cx:pt>
          <cx:pt idx="4379">2983</cx:pt>
          <cx:pt idx="4380">2961</cx:pt>
          <cx:pt idx="4381">3068</cx:pt>
          <cx:pt idx="4382">2806</cx:pt>
          <cx:pt idx="4383">3008</cx:pt>
          <cx:pt idx="4384">2862</cx:pt>
          <cx:pt idx="4385">2930</cx:pt>
          <cx:pt idx="4386">3137</cx:pt>
          <cx:pt idx="4387">2898</cx:pt>
          <cx:pt idx="4388">2813</cx:pt>
          <cx:pt idx="4389">2995</cx:pt>
          <cx:pt idx="4390">3269</cx:pt>
          <cx:pt idx="4391">3107</cx:pt>
          <cx:pt idx="4392">3062</cx:pt>
          <cx:pt idx="4393">3252</cx:pt>
          <cx:pt idx="4394">2889</cx:pt>
          <cx:pt idx="4395">3073</cx:pt>
          <cx:pt idx="4396">2835</cx:pt>
          <cx:pt idx="4397">2939</cx:pt>
          <cx:pt idx="4398">3369</cx:pt>
          <cx:pt idx="4399">2955</cx:pt>
          <cx:pt idx="4400">2891</cx:pt>
          <cx:pt idx="4401">3138</cx:pt>
          <cx:pt idx="4402">3388</cx:pt>
          <cx:pt idx="4403">3196</cx:pt>
          <cx:pt idx="4404">2805</cx:pt>
          <cx:pt idx="4405">3196</cx:pt>
          <cx:pt idx="4406">2590</cx:pt>
          <cx:pt idx="4407">2756</cx:pt>
          <cx:pt idx="4408">3029</cx:pt>
          <cx:pt idx="4409">2672</cx:pt>
          <cx:pt idx="4410">2886</cx:pt>
          <cx:pt idx="4411">2752</cx:pt>
          <cx:pt idx="4412">2678</cx:pt>
          <cx:pt idx="4413">3028</cx:pt>
          <cx:pt idx="4414">2744</cx:pt>
          <cx:pt idx="4415">2507</cx:pt>
          <cx:pt idx="4416">2755</cx:pt>
          <cx:pt idx="4417">2357</cx:pt>
          <cx:pt idx="4418">2486</cx:pt>
          <cx:pt idx="4419">2495</cx:pt>
          <cx:pt idx="4420">2394</cx:pt>
          <cx:pt idx="4421">2363</cx:pt>
          <cx:pt idx="4422">2388</cx:pt>
          <cx:pt idx="4423">2762</cx:pt>
          <cx:pt idx="4424">2546</cx:pt>
          <cx:pt idx="4425">2480</cx:pt>
          <cx:pt idx="4426">2377</cx:pt>
          <cx:pt idx="4427">2842</cx:pt>
          <cx:pt idx="4428">3023</cx:pt>
          <cx:pt idx="4429">2698</cx:pt>
          <cx:pt idx="4430">2392</cx:pt>
          <cx:pt idx="4431">2624</cx:pt>
          <cx:pt idx="4432">3023</cx:pt>
          <cx:pt idx="4433">3021</cx:pt>
          <cx:pt idx="4434">2938</cx:pt>
          <cx:pt idx="4435">3077</cx:pt>
          <cx:pt idx="4436">2572</cx:pt>
          <cx:pt idx="4437">2764</cx:pt>
          <cx:pt idx="4438">2913</cx:pt>
          <cx:pt idx="4439">3143</cx:pt>
          <cx:pt idx="4440">2915</cx:pt>
          <cx:pt idx="4441">2978</cx:pt>
          <cx:pt idx="4442">2558</cx:pt>
          <cx:pt idx="4443">2822</cx:pt>
          <cx:pt idx="4444">2629</cx:pt>
          <cx:pt idx="4445">2584</cx:pt>
          <cx:pt idx="4446">2698</cx:pt>
          <cx:pt idx="4447">2342</cx:pt>
          <cx:pt idx="4448">2863</cx:pt>
          <cx:pt idx="4449">2645</cx:pt>
          <cx:pt idx="4450">2854</cx:pt>
          <cx:pt idx="4451">2845</cx:pt>
          <cx:pt idx="4452">2620</cx:pt>
          <cx:pt idx="4453">3094</cx:pt>
          <cx:pt idx="4454">2804</cx:pt>
          <cx:pt idx="4455">3236</cx:pt>
          <cx:pt idx="4456">2485</cx:pt>
          <cx:pt idx="4457">3154</cx:pt>
          <cx:pt idx="4458">3118</cx:pt>
          <cx:pt idx="4459">3152</cx:pt>
          <cx:pt idx="4460">2442</cx:pt>
          <cx:pt idx="4461">2710</cx:pt>
          <cx:pt idx="4462">2870</cx:pt>
          <cx:pt idx="4463">2706</cx:pt>
          <cx:pt idx="4464">2665</cx:pt>
          <cx:pt idx="4465">2599</cx:pt>
          <cx:pt idx="4466">2708</cx:pt>
          <cx:pt idx="4467">2109</cx:pt>
          <cx:pt idx="4468">2658</cx:pt>
          <cx:pt idx="4469">1906</cx:pt>
          <cx:pt idx="4470">2485</cx:pt>
          <cx:pt idx="4471">2175</cx:pt>
          <cx:pt idx="4472">2433</cx:pt>
          <cx:pt idx="4473">2293</cx:pt>
          <cx:pt idx="4474">2865</cx:pt>
          <cx:pt idx="4475">2773</cx:pt>
          <cx:pt idx="4476">2660</cx:pt>
          <cx:pt idx="4477">2960</cx:pt>
          <cx:pt idx="4478">2732</cx:pt>
          <cx:pt idx="4479">2644</cx:pt>
          <cx:pt idx="4480">2459</cx:pt>
          <cx:pt idx="4481">2141</cx:pt>
          <cx:pt idx="4482">2124</cx:pt>
          <cx:pt idx="4483">2812</cx:pt>
          <cx:pt idx="4484">2558</cx:pt>
          <cx:pt idx="4485">2584</cx:pt>
          <cx:pt idx="4486">2427</cx:pt>
          <cx:pt idx="4487">2311</cx:pt>
          <cx:pt idx="4488">2202</cx:pt>
          <cx:pt idx="4489">2443</cx:pt>
          <cx:pt idx="4490">2055</cx:pt>
          <cx:pt idx="4491">2905</cx:pt>
          <cx:pt idx="4492">3071</cx:pt>
          <cx:pt idx="4493">2890</cx:pt>
          <cx:pt idx="4494">2320</cx:pt>
          <cx:pt idx="4495">2781</cx:pt>
          <cx:pt idx="4496">2595</cx:pt>
          <cx:pt idx="4497">3083</cx:pt>
          <cx:pt idx="4498">2881</cx:pt>
          <cx:pt idx="4499">2779</cx:pt>
          <cx:pt idx="4500">3059</cx:pt>
          <cx:pt idx="4501">3136</cx:pt>
          <cx:pt idx="4502">2690</cx:pt>
          <cx:pt idx="4503">2577</cx:pt>
          <cx:pt idx="4504">3094</cx:pt>
          <cx:pt idx="4505">2689</cx:pt>
          <cx:pt idx="4506">2687</cx:pt>
          <cx:pt idx="4507">3137</cx:pt>
          <cx:pt idx="4508">3124</cx:pt>
          <cx:pt idx="4509">3052</cx:pt>
          <cx:pt idx="4510">2759</cx:pt>
          <cx:pt idx="4511">2375</cx:pt>
          <cx:pt idx="4512">2399</cx:pt>
          <cx:pt idx="4513">2488</cx:pt>
          <cx:pt idx="4514">2246</cx:pt>
          <cx:pt idx="4515">2619</cx:pt>
          <cx:pt idx="4516">2305</cx:pt>
          <cx:pt idx="4517">3152</cx:pt>
          <cx:pt idx="4518">2904</cx:pt>
          <cx:pt idx="4519">2885</cx:pt>
          <cx:pt idx="4520">2670</cx:pt>
          <cx:pt idx="4521">2582</cx:pt>
          <cx:pt idx="4522">2803</cx:pt>
          <cx:pt idx="4523">2663</cx:pt>
          <cx:pt idx="4524">2737</cx:pt>
          <cx:pt idx="4525">2764</cx:pt>
          <cx:pt idx="4526">2760</cx:pt>
          <cx:pt idx="4527">2337</cx:pt>
          <cx:pt idx="4528">3198</cx:pt>
          <cx:pt idx="4529">2818</cx:pt>
          <cx:pt idx="4530">2732</cx:pt>
          <cx:pt idx="4531">2659</cx:pt>
          <cx:pt idx="4532">2371</cx:pt>
          <cx:pt idx="4533">2880</cx:pt>
          <cx:pt idx="4534">3254</cx:pt>
          <cx:pt idx="4535">2959</cx:pt>
          <cx:pt idx="4536">3048</cx:pt>
          <cx:pt idx="4537">3046</cx:pt>
          <cx:pt idx="4538">2714</cx:pt>
          <cx:pt idx="4539">3208</cx:pt>
          <cx:pt idx="4540">2801</cx:pt>
          <cx:pt idx="4541">2960</cx:pt>
          <cx:pt idx="4542">3407</cx:pt>
          <cx:pt idx="4543">2620</cx:pt>
          <cx:pt idx="4544">2452</cx:pt>
          <cx:pt idx="4545">2843</cx:pt>
          <cx:pt idx="4546">2631</cx:pt>
          <cx:pt idx="4547">2968</cx:pt>
          <cx:pt idx="4548">2596</cx:pt>
          <cx:pt idx="4549">2761</cx:pt>
          <cx:pt idx="4550">2466</cx:pt>
          <cx:pt idx="4551">2346</cx:pt>
          <cx:pt idx="4552">2738</cx:pt>
          <cx:pt idx="4553">2723</cx:pt>
          <cx:pt idx="4554">2758</cx:pt>
          <cx:pt idx="4555">2261</cx:pt>
          <cx:pt idx="4556">2730</cx:pt>
          <cx:pt idx="4557">2988</cx:pt>
          <cx:pt idx="4558">2031</cx:pt>
          <cx:pt idx="4559">2168</cx:pt>
          <cx:pt idx="4560">2536</cx:pt>
          <cx:pt idx="4561">2022</cx:pt>
          <cx:pt idx="4562">2357</cx:pt>
          <cx:pt idx="4563">2113</cx:pt>
          <cx:pt idx="4564">2272</cx:pt>
          <cx:pt idx="4565">2322</cx:pt>
          <cx:pt idx="4566">2246</cx:pt>
          <cx:pt idx="4567">2459</cx:pt>
          <cx:pt idx="4568">2435</cx:pt>
          <cx:pt idx="4569">2113</cx:pt>
          <cx:pt idx="4570">2115</cx:pt>
          <cx:pt idx="4571">2252</cx:pt>
          <cx:pt idx="4572">2691</cx:pt>
          <cx:pt idx="4573">2744</cx:pt>
          <cx:pt idx="4574">2726</cx:pt>
          <cx:pt idx="4575">2784</cx:pt>
          <cx:pt idx="4576">2367</cx:pt>
          <cx:pt idx="4577">2614</cx:pt>
          <cx:pt idx="4578">2763</cx:pt>
          <cx:pt idx="4579">2461</cx:pt>
          <cx:pt idx="4580">2405</cx:pt>
          <cx:pt idx="4581">2847</cx:pt>
          <cx:pt idx="4582">2658</cx:pt>
          <cx:pt idx="4583">2700</cx:pt>
          <cx:pt idx="4584">2459</cx:pt>
          <cx:pt idx="4585">2464</cx:pt>
          <cx:pt idx="4586">2669</cx:pt>
          <cx:pt idx="4587">2675</cx:pt>
          <cx:pt idx="4588">2581</cx:pt>
          <cx:pt idx="4589">2123</cx:pt>
          <cx:pt idx="4590">2234</cx:pt>
          <cx:pt idx="4591">2556</cx:pt>
          <cx:pt idx="4592">2536</cx:pt>
          <cx:pt idx="4593">2224</cx:pt>
          <cx:pt idx="4594">2319</cx:pt>
          <cx:pt idx="4595">2210</cx:pt>
          <cx:pt idx="4596">2026</cx:pt>
          <cx:pt idx="4597">2382</cx:pt>
          <cx:pt idx="4598">3192</cx:pt>
          <cx:pt idx="4599">3389</cx:pt>
          <cx:pt idx="4600">3263</cx:pt>
          <cx:pt idx="4601">3301</cx:pt>
          <cx:pt idx="4602">3059</cx:pt>
          <cx:pt idx="4603">2947</cx:pt>
          <cx:pt idx="4604">2933</cx:pt>
          <cx:pt idx="4605">2377</cx:pt>
          <cx:pt idx="4606">3086</cx:pt>
          <cx:pt idx="4607">2710</cx:pt>
          <cx:pt idx="4608">2542</cx:pt>
          <cx:pt idx="4609">2375</cx:pt>
          <cx:pt idx="4610">2863</cx:pt>
          <cx:pt idx="4611">2675</cx:pt>
          <cx:pt idx="4612">2606</cx:pt>
          <cx:pt idx="4613">2735</cx:pt>
          <cx:pt idx="4614">2910</cx:pt>
          <cx:pt idx="4615">3005</cx:pt>
          <cx:pt idx="4616">2507</cx:pt>
          <cx:pt idx="4617">2543</cx:pt>
          <cx:pt idx="4618">2327</cx:pt>
          <cx:pt idx="4619">2925</cx:pt>
          <cx:pt idx="4620">2525</cx:pt>
          <cx:pt idx="4621">3080</cx:pt>
          <cx:pt idx="4622">3107</cx:pt>
          <cx:pt idx="4623">2525</cx:pt>
          <cx:pt idx="4624">2363</cx:pt>
          <cx:pt idx="4625">2695</cx:pt>
          <cx:pt idx="4626">2575</cx:pt>
          <cx:pt idx="4627">3044</cx:pt>
          <cx:pt idx="4628">2921</cx:pt>
          <cx:pt idx="4629">2693</cx:pt>
          <cx:pt idx="4630">2759</cx:pt>
          <cx:pt idx="4631">2587</cx:pt>
          <cx:pt idx="4632">3041</cx:pt>
          <cx:pt idx="4633">3043</cx:pt>
          <cx:pt idx="4634">3148</cx:pt>
          <cx:pt idx="4635">2631</cx:pt>
          <cx:pt idx="4636">2453</cx:pt>
          <cx:pt idx="4637">3339</cx:pt>
          <cx:pt idx="4638">2971</cx:pt>
          <cx:pt idx="4639">3088</cx:pt>
          <cx:pt idx="4640">3160</cx:pt>
          <cx:pt idx="4641">3036</cx:pt>
          <cx:pt idx="4642">2516</cx:pt>
          <cx:pt idx="4643">3044</cx:pt>
          <cx:pt idx="4644">2526</cx:pt>
          <cx:pt idx="4645">2637</cx:pt>
          <cx:pt idx="4646">2893</cx:pt>
          <cx:pt idx="4647">2867</cx:pt>
          <cx:pt idx="4648">2751</cx:pt>
          <cx:pt idx="4649">2932</cx:pt>
          <cx:pt idx="4650">2758</cx:pt>
          <cx:pt idx="4651">2428</cx:pt>
          <cx:pt idx="4652">2062</cx:pt>
          <cx:pt idx="4653">2284</cx:pt>
          <cx:pt idx="4654">2756</cx:pt>
          <cx:pt idx="4655">2763</cx:pt>
          <cx:pt idx="4656">2862</cx:pt>
          <cx:pt idx="4657">3170</cx:pt>
          <cx:pt idx="4658">3203</cx:pt>
          <cx:pt idx="4659">2999</cx:pt>
          <cx:pt idx="4660">3000</cx:pt>
          <cx:pt idx="4661">3189</cx:pt>
          <cx:pt idx="4662">3091</cx:pt>
          <cx:pt idx="4663">2845</cx:pt>
          <cx:pt idx="4664">3123</cx:pt>
          <cx:pt idx="4665">2920</cx:pt>
          <cx:pt idx="4666">2979</cx:pt>
          <cx:pt idx="4667">3302</cx:pt>
          <cx:pt idx="4668">2610</cx:pt>
          <cx:pt idx="4669">2968</cx:pt>
          <cx:pt idx="4670">2802</cx:pt>
          <cx:pt idx="4671">2736</cx:pt>
          <cx:pt idx="4672">2765</cx:pt>
          <cx:pt idx="4673">2750</cx:pt>
          <cx:pt idx="4674">3334</cx:pt>
          <cx:pt idx="4675">3252</cx:pt>
          <cx:pt idx="4676">2859</cx:pt>
          <cx:pt idx="4677">2636</cx:pt>
          <cx:pt idx="4678">2924</cx:pt>
          <cx:pt idx="4679">2809</cx:pt>
          <cx:pt idx="4680">2809</cx:pt>
          <cx:pt idx="4681">3023</cx:pt>
          <cx:pt idx="4682">2655</cx:pt>
          <cx:pt idx="4683">2737</cx:pt>
          <cx:pt idx="4684">2760</cx:pt>
          <cx:pt idx="4685">2705</cx:pt>
          <cx:pt idx="4686">2921</cx:pt>
          <cx:pt idx="4687">2883</cx:pt>
          <cx:pt idx="4688">2837</cx:pt>
          <cx:pt idx="4689">3128</cx:pt>
          <cx:pt idx="4690">3111</cx:pt>
          <cx:pt idx="4691">2554</cx:pt>
          <cx:pt idx="4692">2691</cx:pt>
          <cx:pt idx="4693">2566</cx:pt>
          <cx:pt idx="4694">2547</cx:pt>
          <cx:pt idx="4695">3067</cx:pt>
          <cx:pt idx="4696">2629</cx:pt>
          <cx:pt idx="4697">2787</cx:pt>
          <cx:pt idx="4698">2616</cx:pt>
          <cx:pt idx="4699">2978</cx:pt>
          <cx:pt idx="4700">2440</cx:pt>
          <cx:pt idx="4701">2854</cx:pt>
          <cx:pt idx="4702">3027</cx:pt>
          <cx:pt idx="4703">2494</cx:pt>
          <cx:pt idx="4704">2759</cx:pt>
          <cx:pt idx="4705">2804</cx:pt>
          <cx:pt idx="4706">2956</cx:pt>
          <cx:pt idx="4707">2870</cx:pt>
          <cx:pt idx="4708">3146</cx:pt>
          <cx:pt idx="4709">2768</cx:pt>
          <cx:pt idx="4710">2827</cx:pt>
          <cx:pt idx="4711">2471</cx:pt>
          <cx:pt idx="4712">2997</cx:pt>
          <cx:pt idx="4713">2536</cx:pt>
          <cx:pt idx="4714">2716</cx:pt>
          <cx:pt idx="4715">2642</cx:pt>
          <cx:pt idx="4716">2521</cx:pt>
          <cx:pt idx="4717">2528</cx:pt>
          <cx:pt idx="4718">2317</cx:pt>
          <cx:pt idx="4719">2836</cx:pt>
          <cx:pt idx="4720">2828</cx:pt>
          <cx:pt idx="4721">2769</cx:pt>
          <cx:pt idx="4722">2508</cx:pt>
          <cx:pt idx="4723">2631</cx:pt>
          <cx:pt idx="4724">2368</cx:pt>
          <cx:pt idx="4725">2446</cx:pt>
          <cx:pt idx="4726">2527</cx:pt>
          <cx:pt idx="4727">2959</cx:pt>
          <cx:pt idx="4728">2654</cx:pt>
          <cx:pt idx="4729">2605</cx:pt>
          <cx:pt idx="4730">2717</cx:pt>
          <cx:pt idx="4731">2613</cx:pt>
          <cx:pt idx="4732">2873</cx:pt>
          <cx:pt idx="4733">2746</cx:pt>
          <cx:pt idx="4734">2611</cx:pt>
          <cx:pt idx="4735">2428</cx:pt>
          <cx:pt idx="4736">2487</cx:pt>
          <cx:pt idx="4737">2226</cx:pt>
          <cx:pt idx="4738">2279</cx:pt>
          <cx:pt idx="4739">2530</cx:pt>
          <cx:pt idx="4740">2102</cx:pt>
          <cx:pt idx="4741">2358</cx:pt>
          <cx:pt idx="4742">2187</cx:pt>
          <cx:pt idx="4743">2011</cx:pt>
          <cx:pt idx="4744">2686</cx:pt>
          <cx:pt idx="4745">2052</cx:pt>
          <cx:pt idx="4746">2133</cx:pt>
          <cx:pt idx="4747">2177</cx:pt>
          <cx:pt idx="4748">2462</cx:pt>
          <cx:pt idx="4749">2283</cx:pt>
          <cx:pt idx="4750">2006</cx:pt>
          <cx:pt idx="4751">1853</cx:pt>
          <cx:pt idx="4752">2402</cx:pt>
          <cx:pt idx="4753">2619</cx:pt>
          <cx:pt idx="4754">2186</cx:pt>
          <cx:pt idx="4755">2426</cx:pt>
          <cx:pt idx="4756">2738</cx:pt>
          <cx:pt idx="4757">2519</cx:pt>
          <cx:pt idx="4758">1857</cx:pt>
          <cx:pt idx="4759">2343</cx:pt>
          <cx:pt idx="4760">2661</cx:pt>
          <cx:pt idx="4761">2705</cx:pt>
          <cx:pt idx="4762">2591</cx:pt>
          <cx:pt idx="4763">2460</cx:pt>
          <cx:pt idx="4764">2311</cx:pt>
          <cx:pt idx="4765">2404</cx:pt>
          <cx:pt idx="4766">2647</cx:pt>
          <cx:pt idx="4767">2060</cx:pt>
          <cx:pt idx="4768">1965</cx:pt>
          <cx:pt idx="4769">2689</cx:pt>
          <cx:pt idx="4770">2327</cx:pt>
          <cx:pt idx="4771">2500</cx:pt>
          <cx:pt idx="4772">2599</cx:pt>
          <cx:pt idx="4773">2653</cx:pt>
          <cx:pt idx="4774">2610</cx:pt>
          <cx:pt idx="4775">2250</cx:pt>
          <cx:pt idx="4776">2092</cx:pt>
          <cx:pt idx="4777">2317</cx:pt>
          <cx:pt idx="4778">2442</cx:pt>
          <cx:pt idx="4779">2816</cx:pt>
          <cx:pt idx="4780">2538</cx:pt>
          <cx:pt idx="4781">2615</cx:pt>
          <cx:pt idx="4782">2755</cx:pt>
          <cx:pt idx="4783">2906</cx:pt>
          <cx:pt idx="4784">2677</cx:pt>
          <cx:pt idx="4785">2159</cx:pt>
          <cx:pt idx="4786">2789</cx:pt>
          <cx:pt idx="4787">2461</cx:pt>
          <cx:pt idx="4788">2790</cx:pt>
          <cx:pt idx="4789">2697</cx:pt>
          <cx:pt idx="4790">2356</cx:pt>
          <cx:pt idx="4791">2922</cx:pt>
          <cx:pt idx="4792">2011</cx:pt>
          <cx:pt idx="4793">2174</cx:pt>
          <cx:pt idx="4794">2594</cx:pt>
          <cx:pt idx="4795">2101</cx:pt>
          <cx:pt idx="4796">2359</cx:pt>
          <cx:pt idx="4797">2831</cx:pt>
          <cx:pt idx="4798">2391</cx:pt>
          <cx:pt idx="4799">2247</cx:pt>
          <cx:pt idx="4800">2320</cx:pt>
          <cx:pt idx="4801">2890</cx:pt>
          <cx:pt idx="4802">2593</cx:pt>
          <cx:pt idx="4803">2999</cx:pt>
          <cx:pt idx="4804">2351</cx:pt>
          <cx:pt idx="4805">2080</cx:pt>
          <cx:pt idx="4806">2250</cx:pt>
          <cx:pt idx="4807">2444</cx:pt>
          <cx:pt idx="4808">2591</cx:pt>
          <cx:pt idx="4809">2493</cx:pt>
          <cx:pt idx="4810">2824</cx:pt>
          <cx:pt idx="4811">2728</cx:pt>
          <cx:pt idx="4812">2837</cx:pt>
          <cx:pt idx="4813">2599</cx:pt>
          <cx:pt idx="4814">2379</cx:pt>
          <cx:pt idx="4815">2802</cx:pt>
          <cx:pt idx="4816">2472</cx:pt>
          <cx:pt idx="4817">2307</cx:pt>
          <cx:pt idx="4818">2479</cx:pt>
          <cx:pt idx="4819">2702</cx:pt>
          <cx:pt idx="4820">2505</cx:pt>
          <cx:pt idx="4821">2878</cx:pt>
          <cx:pt idx="4822">3257</cx:pt>
          <cx:pt idx="4823">2941</cx:pt>
          <cx:pt idx="4824">3044</cx:pt>
          <cx:pt idx="4825">3069</cx:pt>
          <cx:pt idx="4826">2653</cx:pt>
          <cx:pt idx="4827">3097</cx:pt>
          <cx:pt idx="4828">3202</cx:pt>
          <cx:pt idx="4829">2814</cx:pt>
          <cx:pt idx="4830">2706</cx:pt>
          <cx:pt idx="4831">2523</cx:pt>
          <cx:pt idx="4832">2706</cx:pt>
          <cx:pt idx="4833">2386</cx:pt>
          <cx:pt idx="4834">2550</cx:pt>
          <cx:pt idx="4835">2545</cx:pt>
          <cx:pt idx="4836">2939</cx:pt>
          <cx:pt idx="4837">3632</cx:pt>
          <cx:pt idx="4838">2643</cx:pt>
          <cx:pt idx="4839">2566</cx:pt>
          <cx:pt idx="4840">2871</cx:pt>
          <cx:pt idx="4841">3046</cx:pt>
          <cx:pt idx="4842">2922</cx:pt>
          <cx:pt idx="4843">3037</cx:pt>
          <cx:pt idx="4844">2989</cx:pt>
          <cx:pt idx="4845">2882</cx:pt>
          <cx:pt idx="4846">2869</cx:pt>
          <cx:pt idx="4847">2738</cx:pt>
          <cx:pt idx="4848">3145</cx:pt>
          <cx:pt idx="4849">2830</cx:pt>
          <cx:pt idx="4850">2956</cx:pt>
          <cx:pt idx="4851">3132</cx:pt>
          <cx:pt idx="4852">3325</cx:pt>
          <cx:pt idx="4853">3045</cx:pt>
          <cx:pt idx="4854">3161</cx:pt>
          <cx:pt idx="4855">3291</cx:pt>
          <cx:pt idx="4856">2788</cx:pt>
          <cx:pt idx="4857">2911</cx:pt>
          <cx:pt idx="4858">2914</cx:pt>
          <cx:pt idx="4859">2633</cx:pt>
          <cx:pt idx="4860">3174</cx:pt>
          <cx:pt idx="4861">2826</cx:pt>
          <cx:pt idx="4862">2956</cx:pt>
          <cx:pt idx="4863">2997</cx:pt>
          <cx:pt idx="4864">2804</cx:pt>
          <cx:pt idx="4865">2624</cx:pt>
          <cx:pt idx="4866">3098</cx:pt>
          <cx:pt idx="4867">3262</cx:pt>
          <cx:pt idx="4868">3108</cx:pt>
          <cx:pt idx="4869">3201</cx:pt>
          <cx:pt idx="4870">3135</cx:pt>
          <cx:pt idx="4871">2625</cx:pt>
          <cx:pt idx="4872">3223</cx:pt>
          <cx:pt idx="4873">2640</cx:pt>
          <cx:pt idx="4874">2849</cx:pt>
          <cx:pt idx="4875">2609</cx:pt>
          <cx:pt idx="4876">2628</cx:pt>
          <cx:pt idx="4877">2834</cx:pt>
          <cx:pt idx="4878">2263</cx:pt>
          <cx:pt idx="4879">2307</cx:pt>
          <cx:pt idx="4880">2589</cx:pt>
          <cx:pt idx="4881">2977</cx:pt>
          <cx:pt idx="4882">2720</cx:pt>
          <cx:pt idx="4883">2598</cx:pt>
          <cx:pt idx="4884">2640</cx:pt>
          <cx:pt idx="4885">2240</cx:pt>
          <cx:pt idx="4886">3007</cx:pt>
          <cx:pt idx="4887">2359</cx:pt>
          <cx:pt idx="4888">2640</cx:pt>
          <cx:pt idx="4889">2607</cx:pt>
          <cx:pt idx="4890">2577</cx:pt>
          <cx:pt idx="4891">2317</cx:pt>
          <cx:pt idx="4892">2571</cx:pt>
          <cx:pt idx="4893">2672</cx:pt>
          <cx:pt idx="4894">2816</cx:pt>
          <cx:pt idx="4895">2851</cx:pt>
          <cx:pt idx="4896">2636</cx:pt>
          <cx:pt idx="4897">3197</cx:pt>
          <cx:pt idx="4898">2483</cx:pt>
          <cx:pt idx="4899">2361</cx:pt>
          <cx:pt idx="4900">2877</cx:pt>
          <cx:pt idx="4901">3090</cx:pt>
          <cx:pt idx="4902">3048</cx:pt>
          <cx:pt idx="4903">2546</cx:pt>
          <cx:pt idx="4904">3257</cx:pt>
          <cx:pt idx="4905">3035</cx:pt>
          <cx:pt idx="4906">2670</cx:pt>
          <cx:pt idx="4907">2580</cx:pt>
          <cx:pt idx="4908">2652</cx:pt>
          <cx:pt idx="4909">2902</cx:pt>
          <cx:pt idx="4910">2623</cx:pt>
          <cx:pt idx="4911">2473</cx:pt>
          <cx:pt idx="4912">2837</cx:pt>
          <cx:pt idx="4913">2548</cx:pt>
          <cx:pt idx="4914">2897</cx:pt>
          <cx:pt idx="4915">2794</cx:pt>
          <cx:pt idx="4916">2750</cx:pt>
          <cx:pt idx="4917">2623</cx:pt>
          <cx:pt idx="4918">2798</cx:pt>
          <cx:pt idx="4919">2947</cx:pt>
          <cx:pt idx="4920">2526</cx:pt>
          <cx:pt idx="4921">3090</cx:pt>
          <cx:pt idx="4922">2840</cx:pt>
          <cx:pt idx="4923">2508</cx:pt>
          <cx:pt idx="4924">2913</cx:pt>
          <cx:pt idx="4925">2339</cx:pt>
          <cx:pt idx="4926">2763</cx:pt>
          <cx:pt idx="4927">2841</cx:pt>
          <cx:pt idx="4928">2478</cx:pt>
          <cx:pt idx="4929">2634</cx:pt>
          <cx:pt idx="4930">2443</cx:pt>
          <cx:pt idx="4931">2272</cx:pt>
          <cx:pt idx="4932">2250</cx:pt>
          <cx:pt idx="4933">2576</cx:pt>
          <cx:pt idx="4934">2211</cx:pt>
          <cx:pt idx="4935">2371</cx:pt>
          <cx:pt idx="4936">2577</cx:pt>
          <cx:pt idx="4937">2761</cx:pt>
          <cx:pt idx="4938">2211</cx:pt>
          <cx:pt idx="4939">2840</cx:pt>
          <cx:pt idx="4940">2338</cx:pt>
          <cx:pt idx="4941">2315</cx:pt>
          <cx:pt idx="4942">2474</cx:pt>
          <cx:pt idx="4943">2418</cx:pt>
          <cx:pt idx="4944">2597</cx:pt>
          <cx:pt idx="4945">2247</cx:pt>
          <cx:pt idx="4946">2353</cx:pt>
          <cx:pt idx="4947">2705</cx:pt>
          <cx:pt idx="4948">2519</cx:pt>
          <cx:pt idx="4949">2360</cx:pt>
          <cx:pt idx="4950">2689</cx:pt>
          <cx:pt idx="4951">2678</cx:pt>
          <cx:pt idx="4952">2245</cx:pt>
          <cx:pt idx="4953">2690</cx:pt>
          <cx:pt idx="4954">2720</cx:pt>
          <cx:pt idx="4955">2880</cx:pt>
          <cx:pt idx="4956">3075</cx:pt>
          <cx:pt idx="4957">3329</cx:pt>
          <cx:pt idx="4958">2913</cx:pt>
          <cx:pt idx="4959">2536</cx:pt>
          <cx:pt idx="4960">2655</cx:pt>
          <cx:pt idx="4961">2564</cx:pt>
          <cx:pt idx="4962">2638</cx:pt>
          <cx:pt idx="4963">2339</cx:pt>
          <cx:pt idx="4964">2484</cx:pt>
          <cx:pt idx="4965">2594</cx:pt>
          <cx:pt idx="4966">2572</cx:pt>
          <cx:pt idx="4967">2714</cx:pt>
          <cx:pt idx="4968">2869</cx:pt>
          <cx:pt idx="4969">3029</cx:pt>
          <cx:pt idx="4970">2771</cx:pt>
          <cx:pt idx="4971">3011</cx:pt>
          <cx:pt idx="4972">2579</cx:pt>
          <cx:pt idx="4973">2820</cx:pt>
          <cx:pt idx="4974">2802</cx:pt>
          <cx:pt idx="4975">3103</cx:pt>
          <cx:pt idx="4976">2368</cx:pt>
          <cx:pt idx="4977">2639</cx:pt>
          <cx:pt idx="4978">2647</cx:pt>
          <cx:pt idx="4979">2681</cx:pt>
          <cx:pt idx="4980">2660</cx:pt>
          <cx:pt idx="4981">2416</cx:pt>
          <cx:pt idx="4982">2779</cx:pt>
          <cx:pt idx="4983">2526</cx:pt>
          <cx:pt idx="4984">2342</cx:pt>
          <cx:pt idx="4985">2207</cx:pt>
          <cx:pt idx="4986">2225</cx:pt>
          <cx:pt idx="4987">2087</cx:pt>
          <cx:pt idx="4988">2445</cx:pt>
          <cx:pt idx="4989">2306</cx:pt>
          <cx:pt idx="4990">2450</cx:pt>
          <cx:pt idx="4991">2418</cx:pt>
          <cx:pt idx="4992">2285</cx:pt>
          <cx:pt idx="4993">2259</cx:pt>
          <cx:pt idx="4994">2183</cx:pt>
          <cx:pt idx="4995">2725</cx:pt>
          <cx:pt idx="4996">2269</cx:pt>
          <cx:pt idx="4997">2586</cx:pt>
          <cx:pt idx="4998">2453</cx:pt>
          <cx:pt idx="4999">2612</cx:pt>
          <cx:pt idx="5000">2564</cx:pt>
          <cx:pt idx="5001">2646</cx:pt>
          <cx:pt idx="5002">2761</cx:pt>
          <cx:pt idx="5003">3093</cx:pt>
          <cx:pt idx="5004">2902</cx:pt>
          <cx:pt idx="5005">2963</cx:pt>
          <cx:pt idx="5006">3155</cx:pt>
          <cx:pt idx="5007">3115</cx:pt>
          <cx:pt idx="5008">2970</cx:pt>
          <cx:pt idx="5009">2764</cx:pt>
          <cx:pt idx="5010">2917</cx:pt>
          <cx:pt idx="5011">3047</cx:pt>
          <cx:pt idx="5012">2487</cx:pt>
          <cx:pt idx="5013">2969</cx:pt>
          <cx:pt idx="5014">2615</cx:pt>
          <cx:pt idx="5015">2791</cx:pt>
          <cx:pt idx="5016">3204</cx:pt>
          <cx:pt idx="5017">3210</cx:pt>
          <cx:pt idx="5018">3095</cx:pt>
          <cx:pt idx="5019">2927</cx:pt>
          <cx:pt idx="5020">2634</cx:pt>
          <cx:pt idx="5021">2712</cx:pt>
          <cx:pt idx="5022">2532</cx:pt>
          <cx:pt idx="5023">2930</cx:pt>
          <cx:pt idx="5024">2870</cx:pt>
          <cx:pt idx="5025">2777</cx:pt>
          <cx:pt idx="5026">2760</cx:pt>
          <cx:pt idx="5027">2775</cx:pt>
          <cx:pt idx="5028">2730</cx:pt>
          <cx:pt idx="5029">2586</cx:pt>
          <cx:pt idx="5030">2741</cx:pt>
          <cx:pt idx="5031">2618</cx:pt>
          <cx:pt idx="5032">2232</cx:pt>
          <cx:pt idx="5033">2143</cx:pt>
          <cx:pt idx="5034">2216</cx:pt>
          <cx:pt idx="5035">2544</cx:pt>
          <cx:pt idx="5036">2621</cx:pt>
          <cx:pt idx="5037">2466</cx:pt>
          <cx:pt idx="5038">2838</cx:pt>
          <cx:pt idx="5039">2090</cx:pt>
          <cx:pt idx="5040">2614</cx:pt>
          <cx:pt idx="5041">2029</cx:pt>
          <cx:pt idx="5042">2929</cx:pt>
          <cx:pt idx="5043">2248</cx:pt>
          <cx:pt idx="5044">3000</cx:pt>
          <cx:pt idx="5045">2176</cx:pt>
          <cx:pt idx="5046">2664</cx:pt>
          <cx:pt idx="5047">2406</cx:pt>
          <cx:pt idx="5048">2725</cx:pt>
          <cx:pt idx="5049">2733</cx:pt>
          <cx:pt idx="5050">2858</cx:pt>
          <cx:pt idx="5051">2853</cx:pt>
          <cx:pt idx="5052">2612</cx:pt>
          <cx:pt idx="5053">2220</cx:pt>
          <cx:pt idx="5054">2620</cx:pt>
          <cx:pt idx="5055">2996</cx:pt>
          <cx:pt idx="5056">2899</cx:pt>
          <cx:pt idx="5057">2895</cx:pt>
          <cx:pt idx="5058">2673</cx:pt>
          <cx:pt idx="5059">2341</cx:pt>
          <cx:pt idx="5060">2786</cx:pt>
          <cx:pt idx="5061">2479</cx:pt>
          <cx:pt idx="5062">2909</cx:pt>
          <cx:pt idx="5063">3024</cx:pt>
          <cx:pt idx="5064">2775</cx:pt>
          <cx:pt idx="5065">2911</cx:pt>
          <cx:pt idx="5066">2603</cx:pt>
          <cx:pt idx="5067">2952</cx:pt>
          <cx:pt idx="5068">3058</cx:pt>
          <cx:pt idx="5069">3005</cx:pt>
          <cx:pt idx="5070">2708</cx:pt>
          <cx:pt idx="5071">3068</cx:pt>
          <cx:pt idx="5072">2672</cx:pt>
          <cx:pt idx="5073">2985</cx:pt>
          <cx:pt idx="5074">2651</cx:pt>
          <cx:pt idx="5075">2505</cx:pt>
          <cx:pt idx="5076">2963</cx:pt>
          <cx:pt idx="5077">2932</cx:pt>
          <cx:pt idx="5078">2730</cx:pt>
          <cx:pt idx="5079">3123</cx:pt>
          <cx:pt idx="5080">2546</cx:pt>
          <cx:pt idx="5081">2904</cx:pt>
          <cx:pt idx="5082">2841</cx:pt>
          <cx:pt idx="5083">2843</cx:pt>
          <cx:pt idx="5084">2795</cx:pt>
          <cx:pt idx="5085">2210</cx:pt>
          <cx:pt idx="5086">2421</cx:pt>
          <cx:pt idx="5087">2785</cx:pt>
          <cx:pt idx="5088">2199</cx:pt>
          <cx:pt idx="5089">2075</cx:pt>
          <cx:pt idx="5090">2391</cx:pt>
          <cx:pt idx="5091">2355</cx:pt>
          <cx:pt idx="5092">2098</cx:pt>
          <cx:pt idx="5093">2291</cx:pt>
          <cx:pt idx="5094">2702</cx:pt>
          <cx:pt idx="5095">2171</cx:pt>
          <cx:pt idx="5096">2686</cx:pt>
          <cx:pt idx="5097">2733</cx:pt>
          <cx:pt idx="5098">2501</cx:pt>
          <cx:pt idx="5099">2565</cx:pt>
          <cx:pt idx="5100">2615</cx:pt>
          <cx:pt idx="5101">3169</cx:pt>
          <cx:pt idx="5102">2617</cx:pt>
          <cx:pt idx="5103">2859</cx:pt>
          <cx:pt idx="5104">2820</cx:pt>
          <cx:pt idx="5105">3221</cx:pt>
          <cx:pt idx="5106">3229</cx:pt>
          <cx:pt idx="5107">3282</cx:pt>
          <cx:pt idx="5108">3018</cx:pt>
          <cx:pt idx="5109">2743</cx:pt>
          <cx:pt idx="5110">2999</cx:pt>
          <cx:pt idx="5111">3000</cx:pt>
          <cx:pt idx="5112">2867</cx:pt>
          <cx:pt idx="5113">3466</cx:pt>
          <cx:pt idx="5114">3340</cx:pt>
          <cx:pt idx="5115">3110</cx:pt>
          <cx:pt idx="5116">2703</cx:pt>
          <cx:pt idx="5117">2929</cx:pt>
          <cx:pt idx="5118">3083</cx:pt>
          <cx:pt idx="5119">3184</cx:pt>
          <cx:pt idx="5120">3286</cx:pt>
          <cx:pt idx="5121">2883</cx:pt>
          <cx:pt idx="5122">2935</cx:pt>
          <cx:pt idx="5123">3031</cx:pt>
          <cx:pt idx="5124">3185</cx:pt>
          <cx:pt idx="5125">2934</cx:pt>
          <cx:pt idx="5126">2781</cx:pt>
          <cx:pt idx="5127">2821</cx:pt>
          <cx:pt idx="5128">2563</cx:pt>
          <cx:pt idx="5129">3010</cx:pt>
          <cx:pt idx="5130">2991</cx:pt>
          <cx:pt idx="5131">2730</cx:pt>
          <cx:pt idx="5132">2455</cx:pt>
          <cx:pt idx="5133">2401</cx:pt>
          <cx:pt idx="5134">2686</cx:pt>
          <cx:pt idx="5135">2634</cx:pt>
          <cx:pt idx="5136">2421</cx:pt>
          <cx:pt idx="5137">2684</cx:pt>
          <cx:pt idx="5138">2655</cx:pt>
          <cx:pt idx="5139">2382</cx:pt>
          <cx:pt idx="5140">2558</cx:pt>
          <cx:pt idx="5141">2580</cx:pt>
          <cx:pt idx="5142">3011</cx:pt>
          <cx:pt idx="5143">3091</cx:pt>
          <cx:pt idx="5144">2815</cx:pt>
          <cx:pt idx="5145">2826</cx:pt>
          <cx:pt idx="5146">2919</cx:pt>
          <cx:pt idx="5147">2619</cx:pt>
          <cx:pt idx="5148">2699</cx:pt>
          <cx:pt idx="5149">2829</cx:pt>
          <cx:pt idx="5150">3228</cx:pt>
          <cx:pt idx="5151">2974</cx:pt>
          <cx:pt idx="5152">2749</cx:pt>
          <cx:pt idx="5153">2986</cx:pt>
          <cx:pt idx="5154">2780</cx:pt>
          <cx:pt idx="5155">3047</cx:pt>
          <cx:pt idx="5156">2720</cx:pt>
          <cx:pt idx="5157">3140</cx:pt>
          <cx:pt idx="5158">2881</cx:pt>
          <cx:pt idx="5159">2453</cx:pt>
          <cx:pt idx="5160">2888</cx:pt>
          <cx:pt idx="5161">2723</cx:pt>
          <cx:pt idx="5162">2885</cx:pt>
          <cx:pt idx="5163">2507</cx:pt>
          <cx:pt idx="5164">2851</cx:pt>
          <cx:pt idx="5165">2902</cx:pt>
          <cx:pt idx="5166">2405</cx:pt>
          <cx:pt idx="5167">2988</cx:pt>
          <cx:pt idx="5168">2621</cx:pt>
          <cx:pt idx="5169">3011</cx:pt>
          <cx:pt idx="5170">3061</cx:pt>
          <cx:pt idx="5171">2809</cx:pt>
          <cx:pt idx="5172">3259</cx:pt>
          <cx:pt idx="5173">2988</cx:pt>
          <cx:pt idx="5174">2804</cx:pt>
          <cx:pt idx="5175">2918</cx:pt>
          <cx:pt idx="5176">2733</cx:pt>
          <cx:pt idx="5177">2466</cx:pt>
          <cx:pt idx="5178">2840</cx:pt>
          <cx:pt idx="5179">2750</cx:pt>
          <cx:pt idx="5180">2766</cx:pt>
          <cx:pt idx="5181">2392</cx:pt>
          <cx:pt idx="5182">3104</cx:pt>
          <cx:pt idx="5183">2883</cx:pt>
          <cx:pt idx="5184">3161</cx:pt>
          <cx:pt idx="5185">2894</cx:pt>
          <cx:pt idx="5186">3088</cx:pt>
          <cx:pt idx="5187">2570</cx:pt>
          <cx:pt idx="5188">2507</cx:pt>
          <cx:pt idx="5189">3112</cx:pt>
          <cx:pt idx="5190">2429</cx:pt>
          <cx:pt idx="5191">2907</cx:pt>
          <cx:pt idx="5192">2558</cx:pt>
          <cx:pt idx="5193">2771</cx:pt>
          <cx:pt idx="5194">2828</cx:pt>
          <cx:pt idx="5195">3007</cx:pt>
          <cx:pt idx="5196">2863</cx:pt>
          <cx:pt idx="5197">2789</cx:pt>
          <cx:pt idx="5198">2350</cx:pt>
          <cx:pt idx="5199">2617</cx:pt>
          <cx:pt idx="5200">2708</cx:pt>
          <cx:pt idx="5201">2506</cx:pt>
          <cx:pt idx="5202">2632</cx:pt>
          <cx:pt idx="5203">2832</cx:pt>
          <cx:pt idx="5204">2724</cx:pt>
          <cx:pt idx="5205">2603</cx:pt>
          <cx:pt idx="5206">2843</cx:pt>
          <cx:pt idx="5207">2624</cx:pt>
          <cx:pt idx="5208">2592</cx:pt>
          <cx:pt idx="5209">2247</cx:pt>
          <cx:pt idx="5210">2339</cx:pt>
          <cx:pt idx="5211">2240</cx:pt>
          <cx:pt idx="5212">2464</cx:pt>
          <cx:pt idx="5213">2444</cx:pt>
          <cx:pt idx="5214">2489</cx:pt>
          <cx:pt idx="5215">2576</cx:pt>
          <cx:pt idx="5216">2249</cx:pt>
          <cx:pt idx="5217">2289</cx:pt>
          <cx:pt idx="5218">2766</cx:pt>
          <cx:pt idx="5219">2390</cx:pt>
          <cx:pt idx="5220">2774</cx:pt>
          <cx:pt idx="5221">2566</cx:pt>
          <cx:pt idx="5222">2881</cx:pt>
          <cx:pt idx="5223">2410</cx:pt>
          <cx:pt idx="5224">2066</cx:pt>
          <cx:pt idx="5225">2279</cx:pt>
          <cx:pt idx="5226">2761</cx:pt>
          <cx:pt idx="5227">2464</cx:pt>
          <cx:pt idx="5228">2895</cx:pt>
          <cx:pt idx="5229">2398</cx:pt>
          <cx:pt idx="5230">2678</cx:pt>
          <cx:pt idx="5231">2442</cx:pt>
          <cx:pt idx="5232">2467</cx:pt>
          <cx:pt idx="5233">2819</cx:pt>
          <cx:pt idx="5234">2696</cx:pt>
          <cx:pt idx="5235">2582</cx:pt>
          <cx:pt idx="5236">2601</cx:pt>
          <cx:pt idx="5237">2506</cx:pt>
          <cx:pt idx="5238">2357</cx:pt>
          <cx:pt idx="5239">2317</cx:pt>
          <cx:pt idx="5240">2214</cx:pt>
          <cx:pt idx="5241">2359</cx:pt>
          <cx:pt idx="5242">2465</cx:pt>
          <cx:pt idx="5243">2378</cx:pt>
          <cx:pt idx="5244">2715</cx:pt>
          <cx:pt idx="5245">2509</cx:pt>
          <cx:pt idx="5246">2512</cx:pt>
          <cx:pt idx="5247">2695</cx:pt>
          <cx:pt idx="5248">2503</cx:pt>
          <cx:pt idx="5249">2309</cx:pt>
          <cx:pt idx="5250">2516</cx:pt>
          <cx:pt idx="5251">2471</cx:pt>
          <cx:pt idx="5252">2483</cx:pt>
          <cx:pt idx="5253">2118</cx:pt>
          <cx:pt idx="5254">2478</cx:pt>
          <cx:pt idx="5255">2635</cx:pt>
          <cx:pt idx="5256">2358</cx:pt>
          <cx:pt idx="5257">2358</cx:pt>
          <cx:pt idx="5258">2549</cx:pt>
          <cx:pt idx="5259">2549</cx:pt>
          <cx:pt idx="5260">2352</cx:pt>
          <cx:pt idx="5261">2120</cx:pt>
          <cx:pt idx="5262">2278</cx:pt>
          <cx:pt idx="5263">2341</cx:pt>
          <cx:pt idx="5264">2256</cx:pt>
          <cx:pt idx="5265">2241</cx:pt>
          <cx:pt idx="5266">2524</cx:pt>
          <cx:pt idx="5267">2209</cx:pt>
          <cx:pt idx="5268">2237</cx:pt>
          <cx:pt idx="5269">2186</cx:pt>
          <cx:pt idx="5270">2116</cx:pt>
          <cx:pt idx="5271">2618</cx:pt>
          <cx:pt idx="5272">2799</cx:pt>
          <cx:pt idx="5273">2910</cx:pt>
          <cx:pt idx="5274">2556</cx:pt>
          <cx:pt idx="5275">2527</cx:pt>
          <cx:pt idx="5276">2338</cx:pt>
          <cx:pt idx="5277">2651</cx:pt>
          <cx:pt idx="5278">2592</cx:pt>
          <cx:pt idx="5279">2767</cx:pt>
          <cx:pt idx="5280">2195</cx:pt>
          <cx:pt idx="5281">2851</cx:pt>
          <cx:pt idx="5282">2517</cx:pt>
          <cx:pt idx="5283">2228</cx:pt>
          <cx:pt idx="5284">2329</cx:pt>
          <cx:pt idx="5285">2508</cx:pt>
          <cx:pt idx="5286">2017</cx:pt>
          <cx:pt idx="5287">1920</cx:pt>
          <cx:pt idx="5288">2224</cx:pt>
          <cx:pt idx="5289">1889</cx:pt>
          <cx:pt idx="5290">2286</cx:pt>
          <cx:pt idx="5291">2173</cx:pt>
          <cx:pt idx="5292">2325</cx:pt>
          <cx:pt idx="5293">2502</cx:pt>
          <cx:pt idx="5294">2569</cx:pt>
          <cx:pt idx="5295">2287</cx:pt>
          <cx:pt idx="5296">2426</cx:pt>
          <cx:pt idx="5297">2352</cx:pt>
          <cx:pt idx="5298">2380</cx:pt>
          <cx:pt idx="5299">2776</cx:pt>
          <cx:pt idx="5300">2434</cx:pt>
          <cx:pt idx="5301">2390</cx:pt>
          <cx:pt idx="5302">2089</cx:pt>
          <cx:pt idx="5303">2062</cx:pt>
          <cx:pt idx="5304">2227</cx:pt>
          <cx:pt idx="5305">2138</cx:pt>
          <cx:pt idx="5306">2619</cx:pt>
          <cx:pt idx="5307">2117</cx:pt>
          <cx:pt idx="5308">2513</cx:pt>
          <cx:pt idx="5309">2491</cx:pt>
          <cx:pt idx="5310">2368</cx:pt>
          <cx:pt idx="5311">2505</cx:pt>
          <cx:pt idx="5312">2713</cx:pt>
          <cx:pt idx="5313">2231</cx:pt>
          <cx:pt idx="5314">2670</cx:pt>
          <cx:pt idx="5315">2576</cx:pt>
          <cx:pt idx="5316">2446</cx:pt>
          <cx:pt idx="5317">2995</cx:pt>
          <cx:pt idx="5318">3186</cx:pt>
          <cx:pt idx="5319">3020</cx:pt>
          <cx:pt idx="5320">3364</cx:pt>
          <cx:pt idx="5321">2863</cx:pt>
          <cx:pt idx="5322">3188</cx:pt>
          <cx:pt idx="5323">2909</cx:pt>
          <cx:pt idx="5324">2881</cx:pt>
          <cx:pt idx="5325">3431</cx:pt>
          <cx:pt idx="5326">2728</cx:pt>
          <cx:pt idx="5327">2780</cx:pt>
          <cx:pt idx="5328">3044</cx:pt>
          <cx:pt idx="5329">3293</cx:pt>
          <cx:pt idx="5330">2867</cx:pt>
          <cx:pt idx="5331">2876</cx:pt>
          <cx:pt idx="5332">3099</cx:pt>
          <cx:pt idx="5333">3185</cx:pt>
          <cx:pt idx="5334">2864</cx:pt>
          <cx:pt idx="5335">3162</cx:pt>
          <cx:pt idx="5336">2906</cx:pt>
          <cx:pt idx="5337">2821</cx:pt>
          <cx:pt idx="5338">3140</cx:pt>
          <cx:pt idx="5339">3281</cx:pt>
          <cx:pt idx="5340">2796</cx:pt>
          <cx:pt idx="5341">2893</cx:pt>
          <cx:pt idx="5342">3188</cx:pt>
          <cx:pt idx="5343">2993</cx:pt>
          <cx:pt idx="5344">2813</cx:pt>
          <cx:pt idx="5345">2779</cx:pt>
          <cx:pt idx="5346">2988</cx:pt>
          <cx:pt idx="5347">3081</cx:pt>
          <cx:pt idx="5348">3421</cx:pt>
          <cx:pt idx="5349">3299</cx:pt>
          <cx:pt idx="5350">2840</cx:pt>
          <cx:pt idx="5351">3329</cx:pt>
          <cx:pt idx="5352">2833</cx:pt>
          <cx:pt idx="5353">2886</cx:pt>
          <cx:pt idx="5354">3317</cx:pt>
          <cx:pt idx="5355">3083</cx:pt>
          <cx:pt idx="5356">3025</cx:pt>
          <cx:pt idx="5357">2660</cx:pt>
          <cx:pt idx="5358">3028</cx:pt>
          <cx:pt idx="5359">3010</cx:pt>
          <cx:pt idx="5360">3376</cx:pt>
          <cx:pt idx="5361">3111</cx:pt>
          <cx:pt idx="5362">3003</cx:pt>
          <cx:pt idx="5363">2879</cx:pt>
          <cx:pt idx="5364">2780</cx:pt>
          <cx:pt idx="5365">2500</cx:pt>
          <cx:pt idx="5366">2688</cx:pt>
          <cx:pt idx="5367">2494</cx:pt>
          <cx:pt idx="5368">2253</cx:pt>
          <cx:pt idx="5369">2361</cx:pt>
          <cx:pt idx="5370">2912</cx:pt>
          <cx:pt idx="5371">2459</cx:pt>
          <cx:pt idx="5372">2482</cx:pt>
          <cx:pt idx="5373">2788</cx:pt>
          <cx:pt idx="5374">2173</cx:pt>
          <cx:pt idx="5375">3025</cx:pt>
          <cx:pt idx="5376">2564</cx:pt>
          <cx:pt idx="5377">2519</cx:pt>
          <cx:pt idx="5378">2585</cx:pt>
          <cx:pt idx="5379">2666</cx:pt>
          <cx:pt idx="5380">3026</cx:pt>
          <cx:pt idx="5381">2301</cx:pt>
          <cx:pt idx="5382">2875</cx:pt>
          <cx:pt idx="5383">2842</cx:pt>
          <cx:pt idx="5384">3124</cx:pt>
          <cx:pt idx="5385">2521</cx:pt>
          <cx:pt idx="5386">2656</cx:pt>
          <cx:pt idx="5387">2966</cx:pt>
          <cx:pt idx="5388">2945</cx:pt>
          <cx:pt idx="5389">2979</cx:pt>
          <cx:pt idx="5390">2899</cx:pt>
          <cx:pt idx="5391">2782</cx:pt>
          <cx:pt idx="5392">2452</cx:pt>
          <cx:pt idx="5393">2863</cx:pt>
          <cx:pt idx="5394">2460</cx:pt>
          <cx:pt idx="5395">2592</cx:pt>
          <cx:pt idx="5396">2707</cx:pt>
          <cx:pt idx="5397">2671</cx:pt>
          <cx:pt idx="5398">2383</cx:pt>
          <cx:pt idx="5399">2566</cx:pt>
          <cx:pt idx="5400">2117</cx:pt>
          <cx:pt idx="5401">2272</cx:pt>
          <cx:pt idx="5402">2601</cx:pt>
          <cx:pt idx="5403">2304</cx:pt>
          <cx:pt idx="5404">2422</cx:pt>
          <cx:pt idx="5405">2627</cx:pt>
          <cx:pt idx="5406">2605</cx:pt>
          <cx:pt idx="5407">2554</cx:pt>
          <cx:pt idx="5408">2644</cx:pt>
          <cx:pt idx="5409">2711</cx:pt>
          <cx:pt idx="5410">2473</cx:pt>
          <cx:pt idx="5411">2542</cx:pt>
          <cx:pt idx="5412">2740</cx:pt>
          <cx:pt idx="5413">2709</cx:pt>
          <cx:pt idx="5414">2311</cx:pt>
          <cx:pt idx="5415">2384</cx:pt>
          <cx:pt idx="5416">2763</cx:pt>
          <cx:pt idx="5417">2803</cx:pt>
          <cx:pt idx="5418">2371</cx:pt>
          <cx:pt idx="5419">2604</cx:pt>
          <cx:pt idx="5420">2744</cx:pt>
          <cx:pt idx="5421">2528</cx:pt>
          <cx:pt idx="5422">2294</cx:pt>
          <cx:pt idx="5423">2632</cx:pt>
          <cx:pt idx="5424">2678</cx:pt>
          <cx:pt idx="5425">2811</cx:pt>
          <cx:pt idx="5426">2856</cx:pt>
          <cx:pt idx="5427">2613</cx:pt>
          <cx:pt idx="5428">2944</cx:pt>
          <cx:pt idx="5429">3093</cx:pt>
          <cx:pt idx="5430">2486</cx:pt>
          <cx:pt idx="5431">2811</cx:pt>
          <cx:pt idx="5432">2576</cx:pt>
          <cx:pt idx="5433">2423</cx:pt>
          <cx:pt idx="5434">2753</cx:pt>
          <cx:pt idx="5435">2708</cx:pt>
          <cx:pt idx="5436">2674</cx:pt>
          <cx:pt idx="5437">2155</cx:pt>
          <cx:pt idx="5438">2360</cx:pt>
          <cx:pt idx="5439">2171</cx:pt>
          <cx:pt idx="5440">2309</cx:pt>
          <cx:pt idx="5441">2296</cx:pt>
          <cx:pt idx="5442">2717</cx:pt>
          <cx:pt idx="5443">2648</cx:pt>
          <cx:pt idx="5444">2620</cx:pt>
          <cx:pt idx="5445">2813</cx:pt>
          <cx:pt idx="5446">2856</cx:pt>
          <cx:pt idx="5447">2822</cx:pt>
          <cx:pt idx="5448">2505</cx:pt>
          <cx:pt idx="5449">2872</cx:pt>
          <cx:pt idx="5450">3056</cx:pt>
          <cx:pt idx="5451">2952</cx:pt>
          <cx:pt idx="5452">2402</cx:pt>
          <cx:pt idx="5453">2369</cx:pt>
          <cx:pt idx="5454">2601</cx:pt>
          <cx:pt idx="5455">3027</cx:pt>
          <cx:pt idx="5456">2585</cx:pt>
          <cx:pt idx="5457">2745</cx:pt>
          <cx:pt idx="5458">2905</cx:pt>
          <cx:pt idx="5459">2846</cx:pt>
          <cx:pt idx="5460">2325</cx:pt>
          <cx:pt idx="5461">2426</cx:pt>
          <cx:pt idx="5462">2180</cx:pt>
          <cx:pt idx="5463">2883</cx:pt>
          <cx:pt idx="5464">2461</cx:pt>
          <cx:pt idx="5465">2456</cx:pt>
          <cx:pt idx="5466">3046</cx:pt>
          <cx:pt idx="5467">2552</cx:pt>
          <cx:pt idx="5468">2605</cx:pt>
          <cx:pt idx="5469">2778</cx:pt>
          <cx:pt idx="5470">2851</cx:pt>
          <cx:pt idx="5471">2784</cx:pt>
          <cx:pt idx="5472">2484</cx:pt>
          <cx:pt idx="5473">2827</cx:pt>
          <cx:pt idx="5474">2810</cx:pt>
          <cx:pt idx="5475">2826</cx:pt>
          <cx:pt idx="5476">2476</cx:pt>
          <cx:pt idx="5477">3037</cx:pt>
          <cx:pt idx="5478">2584</cx:pt>
          <cx:pt idx="5479">2811</cx:pt>
          <cx:pt idx="5480">2572</cx:pt>
          <cx:pt idx="5481">2587</cx:pt>
          <cx:pt idx="5482">2536</cx:pt>
          <cx:pt idx="5483">2735</cx:pt>
          <cx:pt idx="5484">2976</cx:pt>
          <cx:pt idx="5485">2849</cx:pt>
          <cx:pt idx="5486">2503</cx:pt>
          <cx:pt idx="5487">2536</cx:pt>
          <cx:pt idx="5488">2990</cx:pt>
          <cx:pt idx="5489">2586</cx:pt>
          <cx:pt idx="5490">2550</cx:pt>
          <cx:pt idx="5491">2873</cx:pt>
          <cx:pt idx="5492">2248</cx:pt>
          <cx:pt idx="5493">2859</cx:pt>
          <cx:pt idx="5494">2623</cx:pt>
          <cx:pt idx="5495">2915</cx:pt>
          <cx:pt idx="5496">2806</cx:pt>
          <cx:pt idx="5497">2630</cx:pt>
          <cx:pt idx="5498">3193</cx:pt>
          <cx:pt idx="5499">2540</cx:pt>
          <cx:pt idx="5500">2484</cx:pt>
          <cx:pt idx="5501">2898</cx:pt>
          <cx:pt idx="5502">2913</cx:pt>
          <cx:pt idx="5503">2748</cx:pt>
          <cx:pt idx="5504">2275</cx:pt>
          <cx:pt idx="5505">2452</cx:pt>
          <cx:pt idx="5506">2701</cx:pt>
          <cx:pt idx="5507">2771</cx:pt>
          <cx:pt idx="5508">2365</cx:pt>
          <cx:pt idx="5509">2289</cx:pt>
          <cx:pt idx="5510">2737</cx:pt>
          <cx:pt idx="5511">2572</cx:pt>
          <cx:pt idx="5512">2517</cx:pt>
          <cx:pt idx="5513">2790</cx:pt>
          <cx:pt idx="5514">2620</cx:pt>
          <cx:pt idx="5515">2644</cx:pt>
          <cx:pt idx="5516">2863</cx:pt>
          <cx:pt idx="5517">2681</cx:pt>
          <cx:pt idx="5518">2407</cx:pt>
          <cx:pt idx="5519">2591</cx:pt>
          <cx:pt idx="5520">2577</cx:pt>
          <cx:pt idx="5521">2393</cx:pt>
          <cx:pt idx="5522">2364</cx:pt>
          <cx:pt idx="5523">2589</cx:pt>
          <cx:pt idx="5524">2301</cx:pt>
          <cx:pt idx="5525">2845</cx:pt>
          <cx:pt idx="5526">2347</cx:pt>
          <cx:pt idx="5527">2640</cx:pt>
          <cx:pt idx="5528">2426</cx:pt>
          <cx:pt idx="5529">2572</cx:pt>
          <cx:pt idx="5530">2694</cx:pt>
          <cx:pt idx="5531">2879</cx:pt>
          <cx:pt idx="5532">2235</cx:pt>
          <cx:pt idx="5533">2382</cx:pt>
          <cx:pt idx="5534">2325</cx:pt>
          <cx:pt idx="5535">2529</cx:pt>
          <cx:pt idx="5536">2189</cx:pt>
          <cx:pt idx="5537">2011</cx:pt>
          <cx:pt idx="5538">2290</cx:pt>
          <cx:pt idx="5539">2556</cx:pt>
          <cx:pt idx="5540">2331</cx:pt>
          <cx:pt idx="5541">2436</cx:pt>
          <cx:pt idx="5542">2173</cx:pt>
          <cx:pt idx="5543">2621</cx:pt>
          <cx:pt idx="5544">2230</cx:pt>
          <cx:pt idx="5545">2291</cx:pt>
          <cx:pt idx="5546">2502</cx:pt>
          <cx:pt idx="5547">2906</cx:pt>
          <cx:pt idx="5548">2360</cx:pt>
          <cx:pt idx="5549">2594</cx:pt>
          <cx:pt idx="5550">2191</cx:pt>
          <cx:pt idx="5551">2589</cx:pt>
          <cx:pt idx="5552">2445</cx:pt>
          <cx:pt idx="5553">2200</cx:pt>
          <cx:pt idx="5554">2467</cx:pt>
          <cx:pt idx="5555">2313</cx:pt>
          <cx:pt idx="5556">2217</cx:pt>
          <cx:pt idx="5557">2203</cx:pt>
          <cx:pt idx="5558">2747</cx:pt>
          <cx:pt idx="5559">2428</cx:pt>
          <cx:pt idx="5560">1994</cx:pt>
          <cx:pt idx="5561">1970</cx:pt>
          <cx:pt idx="5562">2203</cx:pt>
          <cx:pt idx="5563">2374</cx:pt>
          <cx:pt idx="5564">2036</cx:pt>
          <cx:pt idx="5565">2858</cx:pt>
          <cx:pt idx="5566">2582</cx:pt>
          <cx:pt idx="5567">1987</cx:pt>
          <cx:pt idx="5568">2434</cx:pt>
          <cx:pt idx="5569">2528</cx:pt>
          <cx:pt idx="5570">2182</cx:pt>
          <cx:pt idx="5571">2131</cx:pt>
          <cx:pt idx="5572">2129</cx:pt>
          <cx:pt idx="5573">2165</cx:pt>
          <cx:pt idx="5574">2518</cx:pt>
          <cx:pt idx="5575">2545</cx:pt>
          <cx:pt idx="5576">2620</cx:pt>
          <cx:pt idx="5577">2435</cx:pt>
          <cx:pt idx="5578">2349</cx:pt>
          <cx:pt idx="5579">2348</cx:pt>
          <cx:pt idx="5580">2545</cx:pt>
          <cx:pt idx="5581">2166</cx:pt>
          <cx:pt idx="5582">2310</cx:pt>
          <cx:pt idx="5583">2240</cx:pt>
          <cx:pt idx="5584">2641</cx:pt>
          <cx:pt idx="5585">2076</cx:pt>
          <cx:pt idx="5586">1927</cx:pt>
          <cx:pt idx="5587">2202</cx:pt>
          <cx:pt idx="5588">1908</cx:pt>
          <cx:pt idx="5589">2348</cx:pt>
          <cx:pt idx="5590">2171</cx:pt>
          <cx:pt idx="5591">2213</cx:pt>
          <cx:pt idx="5592">2242</cx:pt>
          <cx:pt idx="5593">2026</cx:pt>
          <cx:pt idx="5594">2043</cx:pt>
          <cx:pt idx="5595">1960</cx:pt>
          <cx:pt idx="5596">2444</cx:pt>
          <cx:pt idx="5597">2662</cx:pt>
          <cx:pt idx="5598">2592</cx:pt>
          <cx:pt idx="5599">2551</cx:pt>
          <cx:pt idx="5600">2331</cx:pt>
          <cx:pt idx="5601">2392</cx:pt>
          <cx:pt idx="5602">2127</cx:pt>
          <cx:pt idx="5603">2294</cx:pt>
          <cx:pt idx="5604">2184</cx:pt>
          <cx:pt idx="5605">2704</cx:pt>
          <cx:pt idx="5606">2413</cx:pt>
          <cx:pt idx="5607">2263</cx:pt>
          <cx:pt idx="5608">2103</cx:pt>
          <cx:pt idx="5609">2830</cx:pt>
          <cx:pt idx="5610">2509</cx:pt>
          <cx:pt idx="5611">2665</cx:pt>
          <cx:pt idx="5612">2351</cx:pt>
          <cx:pt idx="5613">2065</cx:pt>
          <cx:pt idx="5614">2416</cx:pt>
          <cx:pt idx="5615">2507</cx:pt>
          <cx:pt idx="5616">1989</cx:pt>
          <cx:pt idx="5617">1913</cx:pt>
          <cx:pt idx="5618">2241</cx:pt>
          <cx:pt idx="5619">2265</cx:pt>
          <cx:pt idx="5620">2443</cx:pt>
          <cx:pt idx="5621">2378</cx:pt>
          <cx:pt idx="5622">2083</cx:pt>
          <cx:pt idx="5623">2112</cx:pt>
          <cx:pt idx="5624">1972</cx:pt>
          <cx:pt idx="5625">2850</cx:pt>
          <cx:pt idx="5626">2756</cx:pt>
          <cx:pt idx="5627">2695</cx:pt>
          <cx:pt idx="5628">2950</cx:pt>
          <cx:pt idx="5629">2020</cx:pt>
          <cx:pt idx="5630">2539</cx:pt>
          <cx:pt idx="5631">2192</cx:pt>
          <cx:pt idx="5632">2282</cx:pt>
          <cx:pt idx="5633">2397</cx:pt>
          <cx:pt idx="5634">2358</cx:pt>
          <cx:pt idx="5635">2257</cx:pt>
          <cx:pt idx="5636">2489</cx:pt>
          <cx:pt idx="5637">2280</cx:pt>
          <cx:pt idx="5638">2420</cx:pt>
          <cx:pt idx="5639">2346</cx:pt>
          <cx:pt idx="5640">2150</cx:pt>
          <cx:pt idx="5641">2630</cx:pt>
          <cx:pt idx="5642">2265</cx:pt>
          <cx:pt idx="5643">2445</cx:pt>
          <cx:pt idx="5644">2268</cx:pt>
          <cx:pt idx="5645">2534</cx:pt>
          <cx:pt idx="5646">2049</cx:pt>
          <cx:pt idx="5647">1953</cx:pt>
          <cx:pt idx="5648">2114</cx:pt>
          <cx:pt idx="5649">2445</cx:pt>
          <cx:pt idx="5650">2149</cx:pt>
          <cx:pt idx="5651">1982</cx:pt>
          <cx:pt idx="5652">2700</cx:pt>
          <cx:pt idx="5653">2021</cx:pt>
          <cx:pt idx="5654">2223</cx:pt>
          <cx:pt idx="5655">2094</cx:pt>
          <cx:pt idx="5656">2777</cx:pt>
          <cx:pt idx="5657">2657</cx:pt>
          <cx:pt idx="5658">2061</cx:pt>
          <cx:pt idx="5659">2128</cx:pt>
          <cx:pt idx="5660">2312</cx:pt>
          <cx:pt idx="5661">1994</cx:pt>
          <cx:pt idx="5662">2472</cx:pt>
          <cx:pt idx="5663">2267</cx:pt>
          <cx:pt idx="5664">2365</cx:pt>
          <cx:pt idx="5665">2396</cx:pt>
          <cx:pt idx="5666">2421</cx:pt>
          <cx:pt idx="5667">2269</cx:pt>
          <cx:pt idx="5668">1995</cx:pt>
          <cx:pt idx="5669">2301</cx:pt>
          <cx:pt idx="5670">2097</cx:pt>
          <cx:pt idx="5671">2077</cx:pt>
          <cx:pt idx="5672">2018</cx:pt>
          <cx:pt idx="5673">2620</cx:pt>
          <cx:pt idx="5674">2518</cx:pt>
          <cx:pt idx="5675">2539</cx:pt>
          <cx:pt idx="5676">2051</cx:pt>
          <cx:pt idx="5677">2424</cx:pt>
          <cx:pt idx="5678">2502</cx:pt>
          <cx:pt idx="5679">2198</cx:pt>
          <cx:pt idx="5680">2434</cx:pt>
          <cx:pt idx="5681">2881</cx:pt>
          <cx:pt idx="5682">2904</cx:pt>
          <cx:pt idx="5683">2717</cx:pt>
          <cx:pt idx="5684">2382</cx:pt>
          <cx:pt idx="5685">2512</cx:pt>
          <cx:pt idx="5686">2255</cx:pt>
          <cx:pt idx="5687">2726</cx:pt>
          <cx:pt idx="5688">2373</cx:pt>
          <cx:pt idx="5689">2477</cx:pt>
          <cx:pt idx="5690">2285</cx:pt>
          <cx:pt idx="5691">2252</cx:pt>
          <cx:pt idx="5692">2328</cx:pt>
          <cx:pt idx="5693">2571</cx:pt>
          <cx:pt idx="5694">2738</cx:pt>
          <cx:pt idx="5695">2538</cx:pt>
          <cx:pt idx="5696">2541</cx:pt>
          <cx:pt idx="5697">2478</cx:pt>
          <cx:pt idx="5698">2755</cx:pt>
          <cx:pt idx="5699">2757</cx:pt>
          <cx:pt idx="5700">2522</cx:pt>
          <cx:pt idx="5701">2444</cx:pt>
          <cx:pt idx="5702">2485</cx:pt>
          <cx:pt idx="5703">1994</cx:pt>
          <cx:pt idx="5704">2571</cx:pt>
          <cx:pt idx="5705">2166</cx:pt>
          <cx:pt idx="5706">2727</cx:pt>
          <cx:pt idx="5707">2509</cx:pt>
          <cx:pt idx="5708">2462</cx:pt>
          <cx:pt idx="5709">2075</cx:pt>
          <cx:pt idx="5710">2358</cx:pt>
          <cx:pt idx="5711">2077</cx:pt>
          <cx:pt idx="5712">1977</cx:pt>
          <cx:pt idx="5713">2532</cx:pt>
          <cx:pt idx="5714">1995</cx:pt>
          <cx:pt idx="5715">2406</cx:pt>
          <cx:pt idx="5716">2624</cx:pt>
          <cx:pt idx="5717">2306</cx:pt>
          <cx:pt idx="5718">2207</cx:pt>
          <cx:pt idx="5719">2274</cx:pt>
          <cx:pt idx="5720">2303</cx:pt>
          <cx:pt idx="5721">2795</cx:pt>
          <cx:pt idx="5722">2710</cx:pt>
          <cx:pt idx="5723">2672</cx:pt>
          <cx:pt idx="5724">2224</cx:pt>
          <cx:pt idx="5725">2156</cx:pt>
          <cx:pt idx="5726">2364</cx:pt>
          <cx:pt idx="5727">2653</cx:pt>
          <cx:pt idx="5728">2489</cx:pt>
          <cx:pt idx="5729">3002</cx:pt>
          <cx:pt idx="5730">2840</cx:pt>
          <cx:pt idx="5731">2305</cx:pt>
          <cx:pt idx="5732">2321</cx:pt>
          <cx:pt idx="5733">2715</cx:pt>
          <cx:pt idx="5734">2153</cx:pt>
          <cx:pt idx="5735">2373</cx:pt>
          <cx:pt idx="5736">2546</cx:pt>
          <cx:pt idx="5737">2546</cx:pt>
          <cx:pt idx="5738">2405</cx:pt>
          <cx:pt idx="5739">2544</cx:pt>
          <cx:pt idx="5740">2181</cx:pt>
          <cx:pt idx="5741">2176</cx:pt>
          <cx:pt idx="5742">2315</cx:pt>
          <cx:pt idx="5743">2214</cx:pt>
          <cx:pt idx="5744">2562</cx:pt>
          <cx:pt idx="5745">2548</cx:pt>
          <cx:pt idx="5746">2401</cx:pt>
          <cx:pt idx="5747">2484</cx:pt>
          <cx:pt idx="5748">2398</cx:pt>
          <cx:pt idx="5749">2493</cx:pt>
          <cx:pt idx="5750">2717</cx:pt>
          <cx:pt idx="5751">2517</cx:pt>
          <cx:pt idx="5752">2519</cx:pt>
          <cx:pt idx="5753">2299</cx:pt>
          <cx:pt idx="5754">2730</cx:pt>
          <cx:pt idx="5755">2671</cx:pt>
          <cx:pt idx="5756">2555</cx:pt>
          <cx:pt idx="5757">2260</cx:pt>
          <cx:pt idx="5758">2064</cx:pt>
          <cx:pt idx="5759">2745</cx:pt>
          <cx:pt idx="5760">2750</cx:pt>
          <cx:pt idx="5761">2597</cx:pt>
          <cx:pt idx="5762">2716</cx:pt>
          <cx:pt idx="5763">2405</cx:pt>
          <cx:pt idx="5764">2440</cx:pt>
          <cx:pt idx="5765">2555</cx:pt>
          <cx:pt idx="5766">2420</cx:pt>
          <cx:pt idx="5767">2539</cx:pt>
          <cx:pt idx="5768">2572</cx:pt>
          <cx:pt idx="5769">2305</cx:pt>
          <cx:pt idx="5770">2608</cx:pt>
          <cx:pt idx="5771">2513</cx:pt>
          <cx:pt idx="5772">2353</cx:pt>
          <cx:pt idx="5773">2822</cx:pt>
          <cx:pt idx="5774">2390</cx:pt>
          <cx:pt idx="5775">2072</cx:pt>
          <cx:pt idx="5776">2471</cx:pt>
          <cx:pt idx="5777">2480</cx:pt>
          <cx:pt idx="5778">2453</cx:pt>
          <cx:pt idx="5779">2652</cx:pt>
          <cx:pt idx="5780">2490</cx:pt>
          <cx:pt idx="5781">2060</cx:pt>
          <cx:pt idx="5782">2304</cx:pt>
          <cx:pt idx="5783">2142</cx:pt>
          <cx:pt idx="5784">2390</cx:pt>
          <cx:pt idx="5785">2391</cx:pt>
          <cx:pt idx="5786">2467</cx:pt>
          <cx:pt idx="5787">2723</cx:pt>
          <cx:pt idx="5788">2205</cx:pt>
          <cx:pt idx="5789">2267</cx:pt>
          <cx:pt idx="5790">2149</cx:pt>
          <cx:pt idx="5791">2546</cx:pt>
          <cx:pt idx="5792">1989</cx:pt>
          <cx:pt idx="5793">2551</cx:pt>
          <cx:pt idx="5794">2449</cx:pt>
          <cx:pt idx="5795">2304</cx:pt>
          <cx:pt idx="5796">2100</cx:pt>
          <cx:pt idx="5797">2435</cx:pt>
          <cx:pt idx="5798">2164</cx:pt>
          <cx:pt idx="5799">2689</cx:pt>
          <cx:pt idx="5800">2414</cx:pt>
          <cx:pt idx="5801">2368</cx:pt>
          <cx:pt idx="5802">2560</cx:pt>
          <cx:pt idx="5803">2118</cx:pt>
          <cx:pt idx="5804">2321</cx:pt>
          <cx:pt idx="5805">2338</cx:pt>
          <cx:pt idx="5806">2421</cx:pt>
          <cx:pt idx="5807">2092</cx:pt>
          <cx:pt idx="5808">2523</cx:pt>
          <cx:pt idx="5809">2158</cx:pt>
          <cx:pt idx="5810">2493</cx:pt>
          <cx:pt idx="5811">2406</cx:pt>
          <cx:pt idx="5812">2627</cx:pt>
          <cx:pt idx="5813">2380</cx:pt>
          <cx:pt idx="5814">2662</cx:pt>
          <cx:pt idx="5815">2333</cx:pt>
          <cx:pt idx="5816">2395</cx:pt>
          <cx:pt idx="5817">2283</cx:pt>
          <cx:pt idx="5818">2447</cx:pt>
          <cx:pt idx="5819">2137</cx:pt>
          <cx:pt idx="5820">2791</cx:pt>
          <cx:pt idx="5821">2303</cx:pt>
          <cx:pt idx="5822">2217</cx:pt>
          <cx:pt idx="5823">2559</cx:pt>
          <cx:pt idx="5824">2481</cx:pt>
          <cx:pt idx="5825">2348</cx:pt>
          <cx:pt idx="5826">2827</cx:pt>
          <cx:pt idx="5827">2062</cx:pt>
          <cx:pt idx="5828">2780</cx:pt>
          <cx:pt idx="5829">2616</cx:pt>
          <cx:pt idx="5830">2780</cx:pt>
          <cx:pt idx="5831">2901</cx:pt>
          <cx:pt idx="5832">2540</cx:pt>
          <cx:pt idx="5833">2910</cx:pt>
          <cx:pt idx="5834">2796</cx:pt>
          <cx:pt idx="5835">2565</cx:pt>
          <cx:pt idx="5836">2818</cx:pt>
          <cx:pt idx="5837">2749</cx:pt>
          <cx:pt idx="5838">2376</cx:pt>
          <cx:pt idx="5839">3001</cx:pt>
          <cx:pt idx="5840">3207</cx:pt>
          <cx:pt idx="5841">3275</cx:pt>
          <cx:pt idx="5842">2896</cx:pt>
          <cx:pt idx="5843">3244</cx:pt>
          <cx:pt idx="5844">3304</cx:pt>
          <cx:pt idx="5845">2906</cx:pt>
          <cx:pt idx="5846">3082</cx:pt>
          <cx:pt idx="5847">2961</cx:pt>
          <cx:pt idx="5848">2667</cx:pt>
          <cx:pt idx="5849">3155</cx:pt>
          <cx:pt idx="5850">3147</cx:pt>
          <cx:pt idx="5851">2829</cx:pt>
          <cx:pt idx="5852">3265</cx:pt>
          <cx:pt idx="5853">2724</cx:pt>
          <cx:pt idx="5854">2879</cx:pt>
          <cx:pt idx="5855">2759</cx:pt>
          <cx:pt idx="5856">2793</cx:pt>
          <cx:pt idx="5857">2917</cx:pt>
          <cx:pt idx="5858">2879</cx:pt>
          <cx:pt idx="5859">2664</cx:pt>
          <cx:pt idx="5860">3179</cx:pt>
          <cx:pt idx="5861">2503</cx:pt>
          <cx:pt idx="5862">2975</cx:pt>
          <cx:pt idx="5863">2993</cx:pt>
          <cx:pt idx="5864">2719</cx:pt>
          <cx:pt idx="5865">3094</cx:pt>
          <cx:pt idx="5866">2716</cx:pt>
          <cx:pt idx="5867">3117</cx:pt>
          <cx:pt idx="5868">2839</cx:pt>
          <cx:pt idx="5869">2891</cx:pt>
          <cx:pt idx="5870">3053</cx:pt>
          <cx:pt idx="5871">2656</cx:pt>
          <cx:pt idx="5872">2306</cx:pt>
          <cx:pt idx="5873">2926</cx:pt>
          <cx:pt idx="5874">2481</cx:pt>
          <cx:pt idx="5875">2948</cx:pt>
          <cx:pt idx="5876">2400</cx:pt>
          <cx:pt idx="5877">2739</cx:pt>
          <cx:pt idx="5878">2843</cx:pt>
          <cx:pt idx="5879">2764</cx:pt>
          <cx:pt idx="5880">2704</cx:pt>
          <cx:pt idx="5881">2747</cx:pt>
          <cx:pt idx="5882">2887</cx:pt>
          <cx:pt idx="5883">2401</cx:pt>
          <cx:pt idx="5884">2970</cx:pt>
          <cx:pt idx="5885">2792</cx:pt>
          <cx:pt idx="5886">2365</cx:pt>
          <cx:pt idx="5887">2497</cx:pt>
          <cx:pt idx="5888">2307</cx:pt>
          <cx:pt idx="5889">2465</cx:pt>
          <cx:pt idx="5890">2246</cx:pt>
          <cx:pt idx="5891">2375</cx:pt>
          <cx:pt idx="5892">2604</cx:pt>
          <cx:pt idx="5893">2604</cx:pt>
          <cx:pt idx="5894">2741</cx:pt>
          <cx:pt idx="5895">2801</cx:pt>
          <cx:pt idx="5896">2520</cx:pt>
          <cx:pt idx="5897">2763</cx:pt>
          <cx:pt idx="5898">3049</cx:pt>
          <cx:pt idx="5899">2679</cx:pt>
          <cx:pt idx="5900">3073</cx:pt>
          <cx:pt idx="5901">2443</cx:pt>
          <cx:pt idx="5902">2358</cx:pt>
          <cx:pt idx="5903">2932</cx:pt>
          <cx:pt idx="5904">2291</cx:pt>
          <cx:pt idx="5905">2887</cx:pt>
          <cx:pt idx="5906">2781</cx:pt>
          <cx:pt idx="5907">2759</cx:pt>
          <cx:pt idx="5908">2494</cx:pt>
          <cx:pt idx="5909">2493</cx:pt>
          <cx:pt idx="5910">2921</cx:pt>
          <cx:pt idx="5911">2558</cx:pt>
          <cx:pt idx="5912">2891</cx:pt>
          <cx:pt idx="5913">2920</cx:pt>
          <cx:pt idx="5914">2813</cx:pt>
          <cx:pt idx="5915">2530</cx:pt>
          <cx:pt idx="5916">2458</cx:pt>
          <cx:pt idx="5917">2842</cx:pt>
          <cx:pt idx="5918">2589</cx:pt>
          <cx:pt idx="5919">2304</cx:pt>
          <cx:pt idx="5920">2290</cx:pt>
          <cx:pt idx="5921">2577</cx:pt>
          <cx:pt idx="5922">2332</cx:pt>
          <cx:pt idx="5923">2980</cx:pt>
          <cx:pt idx="5924">2806</cx:pt>
          <cx:pt idx="5925">3008</cx:pt>
          <cx:pt idx="5926">2901</cx:pt>
          <cx:pt idx="5927">2781</cx:pt>
          <cx:pt idx="5928">2467</cx:pt>
          <cx:pt idx="5929">3065</cx:pt>
          <cx:pt idx="5930">2817</cx:pt>
          <cx:pt idx="5931">2631</cx:pt>
          <cx:pt idx="5932">2981</cx:pt>
          <cx:pt idx="5933">2634</cx:pt>
          <cx:pt idx="5934">2779</cx:pt>
          <cx:pt idx="5935">2577</cx:pt>
          <cx:pt idx="5936">2428</cx:pt>
          <cx:pt idx="5937">2771</cx:pt>
          <cx:pt idx="5938">2585</cx:pt>
          <cx:pt idx="5939">2822</cx:pt>
          <cx:pt idx="5940">3007</cx:pt>
          <cx:pt idx="5941">2883</cx:pt>
          <cx:pt idx="5942">2095</cx:pt>
          <cx:pt idx="5943">2778</cx:pt>
          <cx:pt idx="5944">3027</cx:pt>
          <cx:pt idx="5945">3046</cx:pt>
          <cx:pt idx="5946">2835</cx:pt>
          <cx:pt idx="5947">2643</cx:pt>
          <cx:pt idx="5948">2971</cx:pt>
          <cx:pt idx="5949">2922</cx:pt>
          <cx:pt idx="5950">2754</cx:pt>
          <cx:pt idx="5951">2341</cx:pt>
          <cx:pt idx="5952">2812</cx:pt>
          <cx:pt idx="5953">2944</cx:pt>
          <cx:pt idx="5954">2854</cx:pt>
          <cx:pt idx="5955">2911</cx:pt>
          <cx:pt idx="5956">2640</cx:pt>
          <cx:pt idx="5957">2620</cx:pt>
          <cx:pt idx="5958">3026</cx:pt>
          <cx:pt idx="5959">2332</cx:pt>
          <cx:pt idx="5960">2151</cx:pt>
          <cx:pt idx="5961">2352</cx:pt>
          <cx:pt idx="5962">2109</cx:pt>
          <cx:pt idx="5963">2213</cx:pt>
          <cx:pt idx="5964">2388</cx:pt>
          <cx:pt idx="5965">2498</cx:pt>
          <cx:pt idx="5966">2227</cx:pt>
          <cx:pt idx="5967">2218</cx:pt>
          <cx:pt idx="5968">2553</cx:pt>
          <cx:pt idx="5969">2475</cx:pt>
          <cx:pt idx="5970">2170</cx:pt>
          <cx:pt idx="5971">2623</cx:pt>
          <cx:pt idx="5972">2088</cx:pt>
          <cx:pt idx="5973">2414</cx:pt>
          <cx:pt idx="5974">2429</cx:pt>
          <cx:pt idx="5975">2316</cx:pt>
          <cx:pt idx="5976">2464</cx:pt>
          <cx:pt idx="5977">2443</cx:pt>
          <cx:pt idx="5978">2199</cx:pt>
          <cx:pt idx="5979">2126</cx:pt>
          <cx:pt idx="5980">2113</cx:pt>
          <cx:pt idx="5981">1961</cx:pt>
          <cx:pt idx="5982">2798</cx:pt>
          <cx:pt idx="5983">2705</cx:pt>
          <cx:pt idx="5984">2922</cx:pt>
          <cx:pt idx="5985">2691</cx:pt>
          <cx:pt idx="5986">2459</cx:pt>
          <cx:pt idx="5987">2627</cx:pt>
          <cx:pt idx="5988">2147</cx:pt>
          <cx:pt idx="5989">2538</cx:pt>
          <cx:pt idx="5990">2795</cx:pt>
          <cx:pt idx="5991">3009</cx:pt>
          <cx:pt idx="5992">2699</cx:pt>
          <cx:pt idx="5993">2738</cx:pt>
          <cx:pt idx="5994">2546</cx:pt>
          <cx:pt idx="5995">2265</cx:pt>
          <cx:pt idx="5996">2487</cx:pt>
          <cx:pt idx="5997">2191</cx:pt>
          <cx:pt idx="5998">2449</cx:pt>
          <cx:pt idx="5999">2574</cx:pt>
          <cx:pt idx="6000">2486</cx:pt>
          <cx:pt idx="6001">3105</cx:pt>
          <cx:pt idx="6002">3226</cx:pt>
          <cx:pt idx="6003">2509</cx:pt>
          <cx:pt idx="6004">2690</cx:pt>
          <cx:pt idx="6005">2790</cx:pt>
          <cx:pt idx="6006">2997</cx:pt>
          <cx:pt idx="6007">2624</cx:pt>
          <cx:pt idx="6008">2592</cx:pt>
          <cx:pt idx="6009">2745</cx:pt>
          <cx:pt idx="6010">2730</cx:pt>
          <cx:pt idx="6011">2535</cx:pt>
          <cx:pt idx="6012">2506</cx:pt>
          <cx:pt idx="6013">2805</cx:pt>
          <cx:pt idx="6014">2737</cx:pt>
          <cx:pt idx="6015">2633</cx:pt>
          <cx:pt idx="6016">2790</cx:pt>
          <cx:pt idx="6017">2563</cx:pt>
          <cx:pt idx="6018">3223</cx:pt>
          <cx:pt idx="6019">3103</cx:pt>
          <cx:pt idx="6020">3242</cx:pt>
          <cx:pt idx="6021">2709</cx:pt>
          <cx:pt idx="6022">2836</cx:pt>
          <cx:pt idx="6023">2701</cx:pt>
          <cx:pt idx="6024">2810</cx:pt>
          <cx:pt idx="6025">2636</cx:pt>
          <cx:pt idx="6026">2658</cx:pt>
          <cx:pt idx="6027">2967</cx:pt>
          <cx:pt idx="6028">2528</cx:pt>
          <cx:pt idx="6029">2978</cx:pt>
          <cx:pt idx="6030">3069</cx:pt>
          <cx:pt idx="6031">2677</cx:pt>
          <cx:pt idx="6032">2595</cx:pt>
          <cx:pt idx="6033">2607</cx:pt>
          <cx:pt idx="6034">2911</cx:pt>
          <cx:pt idx="6035">2704</cx:pt>
          <cx:pt idx="6036">2847</cx:pt>
          <cx:pt idx="6037">2536</cx:pt>
          <cx:pt idx="6038">3084</cx:pt>
          <cx:pt idx="6039">2825</cx:pt>
          <cx:pt idx="6040">2851</cx:pt>
          <cx:pt idx="6041">3004</cx:pt>
          <cx:pt idx="6042">2463</cx:pt>
          <cx:pt idx="6043">2708</cx:pt>
          <cx:pt idx="6044">2629</cx:pt>
          <cx:pt idx="6045">2572</cx:pt>
          <cx:pt idx="6046">2860</cx:pt>
          <cx:pt idx="6047">2653</cx:pt>
          <cx:pt idx="6048">3012</cx:pt>
          <cx:pt idx="6049">2540</cx:pt>
          <cx:pt idx="6050">2623</cx:pt>
          <cx:pt idx="6051">2566</cx:pt>
          <cx:pt idx="6052">2788</cx:pt>
          <cx:pt idx="6053">2557</cx:pt>
          <cx:pt idx="6054">2617</cx:pt>
          <cx:pt idx="6055">2852</cx:pt>
          <cx:pt idx="6056">2723</cx:pt>
          <cx:pt idx="6057">3013</cx:pt>
          <cx:pt idx="6058">2565</cx:pt>
          <cx:pt idx="6059">3016</cx:pt>
          <cx:pt idx="6060">2426</cx:pt>
          <cx:pt idx="6061">2434</cx:pt>
          <cx:pt idx="6062">3118</cx:pt>
          <cx:pt idx="6063">2997</cx:pt>
          <cx:pt idx="6064">2999</cx:pt>
          <cx:pt idx="6065">2498</cx:pt>
          <cx:pt idx="6066">2359</cx:pt>
          <cx:pt idx="6067">2700</cx:pt>
          <cx:pt idx="6068">3149</cx:pt>
          <cx:pt idx="6069">2795</cx:pt>
          <cx:pt idx="6070">2788</cx:pt>
          <cx:pt idx="6071">3051</cx:pt>
          <cx:pt idx="6072">3025</cx:pt>
          <cx:pt idx="6073">2488</cx:pt>
          <cx:pt idx="6074">2957</cx:pt>
          <cx:pt idx="6075">3308</cx:pt>
          <cx:pt idx="6076">2855</cx:pt>
          <cx:pt idx="6077">2905</cx:pt>
          <cx:pt idx="6078">2835</cx:pt>
          <cx:pt idx="6079">2969</cx:pt>
          <cx:pt idx="6080">3030</cx:pt>
          <cx:pt idx="6081">2611</cx:pt>
          <cx:pt idx="6082">2882</cx:pt>
          <cx:pt idx="6083">2456</cx:pt>
          <cx:pt idx="6084">2638</cx:pt>
          <cx:pt idx="6085">2639</cx:pt>
          <cx:pt idx="6086">2428</cx:pt>
          <cx:pt idx="6087">2515</cx:pt>
          <cx:pt idx="6088">2202</cx:pt>
          <cx:pt idx="6089">2105</cx:pt>
          <cx:pt idx="6090">2249</cx:pt>
          <cx:pt idx="6091">2518</cx:pt>
          <cx:pt idx="6092">2379</cx:pt>
          <cx:pt idx="6093">2142</cx:pt>
          <cx:pt idx="6094">2340</cx:pt>
          <cx:pt idx="6095">2361</cx:pt>
          <cx:pt idx="6096">2948</cx:pt>
          <cx:pt idx="6097">2988</cx:pt>
          <cx:pt idx="6098">2919</cx:pt>
          <cx:pt idx="6099">3002</cx:pt>
          <cx:pt idx="6100">2640</cx:pt>
          <cx:pt idx="6101">2696</cx:pt>
          <cx:pt idx="6102">2446</cx:pt>
          <cx:pt idx="6103">2812</cx:pt>
          <cx:pt idx="6104">2527</cx:pt>
          <cx:pt idx="6105">2868</cx:pt>
          <cx:pt idx="6106">2597</cx:pt>
          <cx:pt idx="6107">3276</cx:pt>
          <cx:pt idx="6108">2961</cx:pt>
          <cx:pt idx="6109">2453</cx:pt>
          <cx:pt idx="6110">2623</cx:pt>
          <cx:pt idx="6111">2901</cx:pt>
          <cx:pt idx="6112">3005</cx:pt>
          <cx:pt idx="6113">2751</cx:pt>
          <cx:pt idx="6114">2351</cx:pt>
          <cx:pt idx="6115">2905</cx:pt>
          <cx:pt idx="6116">2612</cx:pt>
          <cx:pt idx="6117">2743</cx:pt>
          <cx:pt idx="6118">2654</cx:pt>
          <cx:pt idx="6119">2400</cx:pt>
          <cx:pt idx="6120">2529</cx:pt>
          <cx:pt idx="6121">2189</cx:pt>
          <cx:pt idx="6122">2025</cx:pt>
          <cx:pt idx="6123">2586</cx:pt>
          <cx:pt idx="6124">2813</cx:pt>
          <cx:pt idx="6125">2421</cx:pt>
          <cx:pt idx="6126">2477</cx:pt>
          <cx:pt idx="6127">2719</cx:pt>
          <cx:pt idx="6128">2081</cx:pt>
          <cx:pt idx="6129">2394</cx:pt>
          <cx:pt idx="6130">2162</cx:pt>
          <cx:pt idx="6131">2298</cx:pt>
          <cx:pt idx="6132">2429</cx:pt>
          <cx:pt idx="6133">1975</cx:pt>
          <cx:pt idx="6134">2173</cx:pt>
          <cx:pt idx="6135">3224</cx:pt>
          <cx:pt idx="6136">3040</cx:pt>
          <cx:pt idx="6137">3158</cx:pt>
          <cx:pt idx="6138">3409</cx:pt>
          <cx:pt idx="6139">2621</cx:pt>
          <cx:pt idx="6140">2312</cx:pt>
          <cx:pt idx="6141">2409</cx:pt>
          <cx:pt idx="6142">3051</cx:pt>
          <cx:pt idx="6143">2853</cx:pt>
          <cx:pt idx="6144">2581</cx:pt>
          <cx:pt idx="6145">2784</cx:pt>
          <cx:pt idx="6146">2670</cx:pt>
          <cx:pt idx="6147">2856</cx:pt>
          <cx:pt idx="6148">2732</cx:pt>
          <cx:pt idx="6149">2544</cx:pt>
          <cx:pt idx="6150">2593</cx:pt>
          <cx:pt idx="6151">3186</cx:pt>
          <cx:pt idx="6152">2679</cx:pt>
          <cx:pt idx="6153">2808</cx:pt>
          <cx:pt idx="6154">2924</cx:pt>
          <cx:pt idx="6155">2762</cx:pt>
          <cx:pt idx="6156">2663</cx:pt>
          <cx:pt idx="6157">2863</cx:pt>
          <cx:pt idx="6158">2908</cx:pt>
          <cx:pt idx="6159">2993</cx:pt>
          <cx:pt idx="6160">2736</cx:pt>
          <cx:pt idx="6161">3011</cx:pt>
          <cx:pt idx="6162">2973</cx:pt>
          <cx:pt idx="6163">2593</cx:pt>
          <cx:pt idx="6164">2292</cx:pt>
          <cx:pt idx="6165">2780</cx:pt>
          <cx:pt idx="6166">3183</cx:pt>
          <cx:pt idx="6167">2625</cx:pt>
          <cx:pt idx="6168">2951</cx:pt>
          <cx:pt idx="6169">2899</cx:pt>
          <cx:pt idx="6170">2733</cx:pt>
          <cx:pt idx="6171">2840</cx:pt>
          <cx:pt idx="6172">2644</cx:pt>
          <cx:pt idx="6173">2608</cx:pt>
          <cx:pt idx="6174">2759</cx:pt>
          <cx:pt idx="6175">2650</cx:pt>
          <cx:pt idx="6176">2832</cx:pt>
          <cx:pt idx="6177">2341</cx:pt>
          <cx:pt idx="6178">2469</cx:pt>
          <cx:pt idx="6179">2602</cx:pt>
          <cx:pt idx="6180">2438</cx:pt>
          <cx:pt idx="6181">2344</cx:pt>
          <cx:pt idx="6182">2322</cx:pt>
          <cx:pt idx="6183">2133</cx:pt>
          <cx:pt idx="6184">2164</cx:pt>
          <cx:pt idx="6185">2515</cx:pt>
          <cx:pt idx="6186">2377</cx:pt>
          <cx:pt idx="6187">2678</cx:pt>
          <cx:pt idx="6188">2326</cx:pt>
          <cx:pt idx="6189">2162</cx:pt>
          <cx:pt idx="6190">2069</cx:pt>
          <cx:pt idx="6191">2571</cx:pt>
          <cx:pt idx="6192">2265</cx:pt>
          <cx:pt idx="6193">2382</cx:pt>
          <cx:pt idx="6194">1954</cx:pt>
          <cx:pt idx="6195">2802</cx:pt>
          <cx:pt idx="6196">2559</cx:pt>
          <cx:pt idx="6197">2536</cx:pt>
          <cx:pt idx="6198">2605</cx:pt>
          <cx:pt idx="6199">2163</cx:pt>
          <cx:pt idx="6200">2077</cx:pt>
          <cx:pt idx="6201">2555</cx:pt>
          <cx:pt idx="6202">2667</cx:pt>
          <cx:pt idx="6203">3138</cx:pt>
          <cx:pt idx="6204">2293</cx:pt>
          <cx:pt idx="6205">2599</cx:pt>
          <cx:pt idx="6206">2923</cx:pt>
          <cx:pt idx="6207">2491</cx:pt>
          <cx:pt idx="6208">2436</cx:pt>
          <cx:pt idx="6209">2984</cx:pt>
          <cx:pt idx="6210">2538</cx:pt>
          <cx:pt idx="6211">2393</cx:pt>
          <cx:pt idx="6212">2639</cx:pt>
          <cx:pt idx="6213">2646</cx:pt>
          <cx:pt idx="6214">3065</cx:pt>
          <cx:pt idx="6215">2957</cx:pt>
          <cx:pt idx="6216">2223</cx:pt>
          <cx:pt idx="6217">2304</cx:pt>
          <cx:pt idx="6218">2467</cx:pt>
          <cx:pt idx="6219">2234</cx:pt>
          <cx:pt idx="6220">2067</cx:pt>
          <cx:pt idx="6221">2321</cx:pt>
          <cx:pt idx="6222">2713</cx:pt>
          <cx:pt idx="6223">2469</cx:pt>
          <cx:pt idx="6224">2935</cx:pt>
          <cx:pt idx="6225">2231</cx:pt>
          <cx:pt idx="6226">2268</cx:pt>
          <cx:pt idx="6227">2522</cx:pt>
          <cx:pt idx="6228">2423</cx:pt>
          <cx:pt idx="6229">2077</cx:pt>
          <cx:pt idx="6230">3106</cx:pt>
          <cx:pt idx="6231">1996</cx:pt>
          <cx:pt idx="6232">2328</cx:pt>
          <cx:pt idx="6233">2518</cx:pt>
          <cx:pt idx="6234">2501</cx:pt>
          <cx:pt idx="6235">3094</cx:pt>
          <cx:pt idx="6236">2784</cx:pt>
          <cx:pt idx="6237">2134</cx:pt>
          <cx:pt idx="6238">2436</cx:pt>
          <cx:pt idx="6239">2551</cx:pt>
          <cx:pt idx="6240">2468</cx:pt>
          <cx:pt idx="6241">3307</cx:pt>
          <cx:pt idx="6242">3075</cx:pt>
          <cx:pt idx="6243">2805</cx:pt>
          <cx:pt idx="6244">2597</cx:pt>
          <cx:pt idx="6245">3031</cx:pt>
          <cx:pt idx="6246">2899</cx:pt>
          <cx:pt idx="6247">3031</cx:pt>
          <cx:pt idx="6248">3092</cx:pt>
          <cx:pt idx="6249">3003</cx:pt>
          <cx:pt idx="6250">2776</cx:pt>
          <cx:pt idx="6251">3059</cx:pt>
          <cx:pt idx="6252">2689</cx:pt>
          <cx:pt idx="6253">2729</cx:pt>
          <cx:pt idx="6254">2938</cx:pt>
          <cx:pt idx="6255">2656</cx:pt>
          <cx:pt idx="6256">3037</cx:pt>
          <cx:pt idx="6257">2975</cx:pt>
          <cx:pt idx="6258">3119</cx:pt>
          <cx:pt idx="6259">3177</cx:pt>
          <cx:pt idx="6260">3159</cx:pt>
          <cx:pt idx="6261">2793</cx:pt>
          <cx:pt idx="6262">2825</cx:pt>
          <cx:pt idx="6263">2730</cx:pt>
          <cx:pt idx="6264">3271</cx:pt>
          <cx:pt idx="6265">3282</cx:pt>
          <cx:pt idx="6266">2874</cx:pt>
          <cx:pt idx="6267">2789</cx:pt>
          <cx:pt idx="6268">3073</cx:pt>
          <cx:pt idx="6269">3048</cx:pt>
          <cx:pt idx="6270">3132</cx:pt>
          <cx:pt idx="6271">3031</cx:pt>
          <cx:pt idx="6272">2617</cx:pt>
          <cx:pt idx="6273">2681</cx:pt>
          <cx:pt idx="6274">2769</cx:pt>
          <cx:pt idx="6275">2851</cx:pt>
          <cx:pt idx="6276">2553</cx:pt>
          <cx:pt idx="6277">2665</cx:pt>
          <cx:pt idx="6278">2875</cx:pt>
          <cx:pt idx="6279">2801</cx:pt>
          <cx:pt idx="6280">2595</cx:pt>
          <cx:pt idx="6281">2521</cx:pt>
          <cx:pt idx="6282">2490</cx:pt>
          <cx:pt idx="6283">2589</cx:pt>
          <cx:pt idx="6284">2514</cx:pt>
          <cx:pt idx="6285">2285</cx:pt>
          <cx:pt idx="6286">2639</cx:pt>
          <cx:pt idx="6287">2288</cx:pt>
          <cx:pt idx="6288">2945</cx:pt>
          <cx:pt idx="6289">2356</cx:pt>
          <cx:pt idx="6290">2579</cx:pt>
          <cx:pt idx="6291">2312</cx:pt>
          <cx:pt idx="6292">2870</cx:pt>
          <cx:pt idx="6293">2853</cx:pt>
          <cx:pt idx="6294">2840</cx:pt>
          <cx:pt idx="6295">2238</cx:pt>
          <cx:pt idx="6296">2455</cx:pt>
          <cx:pt idx="6297">2247</cx:pt>
          <cx:pt idx="6298">2355</cx:pt>
          <cx:pt idx="6299">2813</cx:pt>
          <cx:pt idx="6300">2424</cx:pt>
          <cx:pt idx="6301">2577</cx:pt>
          <cx:pt idx="6302">2556</cx:pt>
          <cx:pt idx="6303">2675</cx:pt>
          <cx:pt idx="6304">2396</cx:pt>
          <cx:pt idx="6305">2314</cx:pt>
          <cx:pt idx="6306">2280</cx:pt>
          <cx:pt idx="6307">2339</cx:pt>
          <cx:pt idx="6308">2290</cx:pt>
          <cx:pt idx="6309">2532</cx:pt>
          <cx:pt idx="6310">2741</cx:pt>
          <cx:pt idx="6311">2569</cx:pt>
          <cx:pt idx="6312">2394</cx:pt>
          <cx:pt idx="6313">2493</cx:pt>
          <cx:pt idx="6314">2668</cx:pt>
          <cx:pt idx="6315">2421</cx:pt>
          <cx:pt idx="6316">2854</cx:pt>
          <cx:pt idx="6317">2684</cx:pt>
          <cx:pt idx="6318">2755</cx:pt>
          <cx:pt idx="6319">3001</cx:pt>
          <cx:pt idx="6320">2371</cx:pt>
          <cx:pt idx="6321">2817</cx:pt>
          <cx:pt idx="6322">2506</cx:pt>
          <cx:pt idx="6323">2458</cx:pt>
          <cx:pt idx="6324">2921</cx:pt>
          <cx:pt idx="6325">2715</cx:pt>
          <cx:pt idx="6326">3109</cx:pt>
          <cx:pt idx="6327">3044</cx:pt>
          <cx:pt idx="6328">2998</cx:pt>
          <cx:pt idx="6329">3100</cx:pt>
          <cx:pt idx="6330">3021</cx:pt>
          <cx:pt idx="6331">3262</cx:pt>
          <cx:pt idx="6332">2965</cx:pt>
          <cx:pt idx="6333">3003</cx:pt>
          <cx:pt idx="6334">3117</cx:pt>
          <cx:pt idx="6335">3379</cx:pt>
          <cx:pt idx="6336">2979</cx:pt>
          <cx:pt idx="6337">3229</cx:pt>
          <cx:pt idx="6338">3319</cx:pt>
          <cx:pt idx="6339">3190</cx:pt>
          <cx:pt idx="6340">2856</cx:pt>
          <cx:pt idx="6341">2906</cx:pt>
          <cx:pt idx="6342">2992</cx:pt>
          <cx:pt idx="6343">3195</cx:pt>
          <cx:pt idx="6344">3275</cx:pt>
          <cx:pt idx="6345">3084</cx:pt>
          <cx:pt idx="6346">3494</cx:pt>
          <cx:pt idx="6347">3376</cx:pt>
          <cx:pt idx="6348">2933</cx:pt>
          <cx:pt idx="6349">2937</cx:pt>
          <cx:pt idx="6350">2925</cx:pt>
          <cx:pt idx="6351">3411</cx:pt>
          <cx:pt idx="6352">3109</cx:pt>
          <cx:pt idx="6353">3318</cx:pt>
          <cx:pt idx="6354">3144</cx:pt>
          <cx:pt idx="6355">3214</cx:pt>
          <cx:pt idx="6356">3250</cx:pt>
          <cx:pt idx="6357">2956</cx:pt>
          <cx:pt idx="6358">2675</cx:pt>
          <cx:pt idx="6359">3060</cx:pt>
          <cx:pt idx="6360">2987</cx:pt>
          <cx:pt idx="6361">2793</cx:pt>
          <cx:pt idx="6362">2654</cx:pt>
          <cx:pt idx="6363">2754</cx:pt>
          <cx:pt idx="6364">2247</cx:pt>
          <cx:pt idx="6365">2322</cx:pt>
          <cx:pt idx="6366">2618</cx:pt>
          <cx:pt idx="6367">2595</cx:pt>
          <cx:pt idx="6368">2870</cx:pt>
          <cx:pt idx="6369">2499</cx:pt>
          <cx:pt idx="6370">2590</cx:pt>
          <cx:pt idx="6371">2447</cx:pt>
          <cx:pt idx="6372">2485</cx:pt>
          <cx:pt idx="6373">2979</cx:pt>
          <cx:pt idx="6374">2772</cx:pt>
          <cx:pt idx="6375">3170</cx:pt>
          <cx:pt idx="6376">3178</cx:pt>
          <cx:pt idx="6377">2520</cx:pt>
          <cx:pt idx="6378">2869</cx:pt>
          <cx:pt idx="6379">3027</cx:pt>
          <cx:pt idx="6380">2475</cx:pt>
          <cx:pt idx="6381">2681</cx:pt>
          <cx:pt idx="6382">2645</cx:pt>
          <cx:pt idx="6383">2692</cx:pt>
          <cx:pt idx="6384">2312</cx:pt>
          <cx:pt idx="6385">2676</cx:pt>
          <cx:pt idx="6386">2386</cx:pt>
          <cx:pt idx="6387">2909</cx:pt>
          <cx:pt idx="6388">2275</cx:pt>
          <cx:pt idx="6389">2433</cx:pt>
          <cx:pt idx="6390">2707</cx:pt>
          <cx:pt idx="6391">2327</cx:pt>
          <cx:pt idx="6392">2455</cx:pt>
          <cx:pt idx="6393">3065</cx:pt>
          <cx:pt idx="6394">2959</cx:pt>
          <cx:pt idx="6395">2325</cx:pt>
          <cx:pt idx="6396">2850</cx:pt>
          <cx:pt idx="6397">2882</cx:pt>
          <cx:pt idx="6398">2466</cx:pt>
          <cx:pt idx="6399">3002</cx:pt>
          <cx:pt idx="6400">2266</cx:pt>
          <cx:pt idx="6401">2717</cx:pt>
          <cx:pt idx="6402">2858</cx:pt>
          <cx:pt idx="6403">2425</cx:pt>
          <cx:pt idx="6404">2188</cx:pt>
          <cx:pt idx="6405">2380</cx:pt>
          <cx:pt idx="6406">2268</cx:pt>
          <cx:pt idx="6407">2574</cx:pt>
          <cx:pt idx="6408">2612</cx:pt>
          <cx:pt idx="6409">2439</cx:pt>
          <cx:pt idx="6410">2501</cx:pt>
          <cx:pt idx="6411">2554</cx:pt>
          <cx:pt idx="6412">2382</cx:pt>
          <cx:pt idx="6413">2788</cx:pt>
          <cx:pt idx="6414">2560</cx:pt>
          <cx:pt idx="6415">2925</cx:pt>
          <cx:pt idx="6416">2727</cx:pt>
          <cx:pt idx="6417">2270</cx:pt>
          <cx:pt idx="6418">2450</cx:pt>
          <cx:pt idx="6419">2956</cx:pt>
          <cx:pt idx="6420">2253</cx:pt>
          <cx:pt idx="6421">2998</cx:pt>
          <cx:pt idx="6422">2272</cx:pt>
          <cx:pt idx="6423">3017</cx:pt>
          <cx:pt idx="6424">2732</cx:pt>
          <cx:pt idx="6425">2682</cx:pt>
          <cx:pt idx="6426">2648</cx:pt>
          <cx:pt idx="6427">2893</cx:pt>
          <cx:pt idx="6428">2902</cx:pt>
          <cx:pt idx="6429">2952</cx:pt>
          <cx:pt idx="6430">2486</cx:pt>
          <cx:pt idx="6431">3030</cx:pt>
          <cx:pt idx="6432">2804</cx:pt>
          <cx:pt idx="6433">2710</cx:pt>
          <cx:pt idx="6434">2644</cx:pt>
          <cx:pt idx="6435">2781</cx:pt>
          <cx:pt idx="6436">2447</cx:pt>
          <cx:pt idx="6437">2395</cx:pt>
          <cx:pt idx="6438">2854</cx:pt>
          <cx:pt idx="6439">2177</cx:pt>
          <cx:pt idx="6440">2489</cx:pt>
          <cx:pt idx="6441">2246</cx:pt>
          <cx:pt idx="6442">2316</cx:pt>
          <cx:pt idx="6443">2538</cx:pt>
          <cx:pt idx="6444">2172</cx:pt>
        </cx:lvl>
      </cx:numDim>
    </cx:data>
  </cx:chartData>
  <cx:chart>
    <cx:plotArea>
      <cx:plotAreaRegion>
        <cx:series layoutId="boxWhisker" uniqueId="{5A8DFAF4-47AD-4DA4-93B6-1BA5983FCC7F}">
          <cx:tx>
            <cx:txData>
              <cx:f>Sheet1!$C$1</cx:f>
              <cx:v>No. of Metabolites</cx:v>
            </cx:txData>
          </cx:tx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.5"/>
        <cx:tickLabels/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 sz="1200" b="1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 sz="1200" b="1" i="0" u="none" strike="noStrike" baseline="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title>
          <cx:tx>
            <cx:txData>
              <cx:v>Number of Metabolites</cx:v>
            </cx:txData>
          </cx:tx>
          <cx:txPr>
            <a:bodyPr spcFirstLastPara="1" vertOverflow="ellipsis" horzOverflow="overflow" wrap="square" lIns="0" tIns="0" rIns="0" bIns="0" anchor="ctr" anchorCtr="1"/>
            <a:lstStyle/>
            <a:p>
              <a:pPr algn="ctr" rtl="0">
                <a:defRPr/>
              </a:pPr>
              <a:r>
                <a:rPr lang="en-US" sz="1200" b="1" i="0" u="none" strike="noStrike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of Metabolites</a:t>
              </a:r>
            </a:p>
          </cx:txPr>
        </cx:title>
        <cx:majorTickMarks type="out"/>
        <cx:tickLabels/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 sz="1200" b="1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 sz="1200" b="1" i="0" u="none" strike="noStrike" baseline="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  <cx:clrMapOvr bg1="lt1" tx1="dk1" bg2="lt2" tx2="dk2" accent1="accent1" accent2="accent2" accent3="accent3" accent4="accent4" accent5="accent5" accent6="accent6" hlink="hlink" folHlink="folHlink"/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95DA02-761C-D16E-CF12-C76A3DFB77F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1D36BDC-3D03-76F4-CDC1-0A856E8991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B81265-99BB-CFB5-3BAE-26969C3F84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8A426-FA93-401F-AECD-6108713CFA15}" type="datetimeFigureOut">
              <a:rPr lang="en-IN" smtClean="0"/>
              <a:t>26/08/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0C6A87-51BF-5CCA-EEA9-FE016C8AA0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3E38BE-E72C-04D1-84F6-2A453E98DD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78B94-C9E2-47A0-848D-6524A5962C8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72252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3865E9-AA00-FDFA-9491-235423D83C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4E7471-A517-BB4D-8B71-0FE283A008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9CFC01-6E64-3137-17C9-12381ECA79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8A426-FA93-401F-AECD-6108713CFA15}" type="datetimeFigureOut">
              <a:rPr lang="en-IN" smtClean="0"/>
              <a:t>26/08/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5D882C-1BEE-E4E7-A22F-0F2624E18F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713362-F4B1-DD36-EA6F-850B1A7736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78B94-C9E2-47A0-848D-6524A5962C8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776414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739FAF2-86A8-9B84-BB94-2E3E9741B15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7663D4-EB7B-EA69-39BF-157EC3F940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07009F-4572-C22B-5E01-97EA40E253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8A426-FA93-401F-AECD-6108713CFA15}" type="datetimeFigureOut">
              <a:rPr lang="en-IN" smtClean="0"/>
              <a:t>26/08/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E5063A-8876-3DD3-A5DF-ADC7446181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A70E4D-9F93-BFC4-AF4A-D067398CF1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78B94-C9E2-47A0-848D-6524A5962C8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465271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E8830D-1987-B80E-3B2C-D8F274D27D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29FD43-8D86-97D1-6A8D-5A718691636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C20A42-36A1-53F2-721B-55F58696C6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8A426-FA93-401F-AECD-6108713CFA15}" type="datetimeFigureOut">
              <a:rPr lang="en-IN" smtClean="0"/>
              <a:t>26/08/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12C602-5402-FDF7-D747-7A8BD752C9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B88722-4835-7009-99EB-3AFA6A545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78B94-C9E2-47A0-848D-6524A5962C8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27205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325B49-E530-7A68-1BB8-90DBDF81F1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DF3C4F-6CB5-1F38-C1D4-A197E6C08C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310E30-0D69-1074-C753-35C4EA245C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8A426-FA93-401F-AECD-6108713CFA15}" type="datetimeFigureOut">
              <a:rPr lang="en-IN" smtClean="0"/>
              <a:t>26/08/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D17414-1EF5-D2CC-8055-E2F3B4DA03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46A769-1A14-E231-C10D-5E3E730960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78B94-C9E2-47A0-848D-6524A5962C8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766270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ECD88F-313B-C311-A6F4-D85EC81E9C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43E7D8-2BE7-343E-965A-654AC1FCF1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7BF59F-A467-1E97-EF40-2349668324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7F6B71-8273-EB94-3CDE-EB419E689C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8A426-FA93-401F-AECD-6108713CFA15}" type="datetimeFigureOut">
              <a:rPr lang="en-IN" smtClean="0"/>
              <a:t>26/08/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5FEC00-6836-9980-4616-0C49E3322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CE47D7-09A8-2854-2D9E-2A42E6F727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78B94-C9E2-47A0-848D-6524A5962C8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63886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68CA3D-E6BA-2A0A-F0AD-5EB175BF7B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11482F-98E4-DE7F-8081-B763295E55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81280ED-BF18-4477-7139-B9FD67AB62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9BD35D1-3CE6-C2BB-F4D1-376839526CD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CBD71AC-B8F7-A630-EF3B-DD02942F911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80DAE70-4CC1-AC4A-2463-179B717DC0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8A426-FA93-401F-AECD-6108713CFA15}" type="datetimeFigureOut">
              <a:rPr lang="en-IN" smtClean="0"/>
              <a:t>26/08/24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9DFFA3A-B860-6AD0-F070-9DC0C568A6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294EEB8-CE19-94E0-01A5-CAFC2B530E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78B94-C9E2-47A0-848D-6524A5962C8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037359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8AD859-352A-F44B-7357-E0DA9ED856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5B9C0B7-2278-55A8-1A28-84B38AB647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8A426-FA93-401F-AECD-6108713CFA15}" type="datetimeFigureOut">
              <a:rPr lang="en-IN" smtClean="0"/>
              <a:t>26/08/24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39B72B2-31A5-9602-769A-BDAAC0530A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BDECEC4-6D6F-6B49-D9F9-CBEF992717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78B94-C9E2-47A0-848D-6524A5962C8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571989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804F54E-2BE8-3E99-36DB-58F27FE52B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8A426-FA93-401F-AECD-6108713CFA15}" type="datetimeFigureOut">
              <a:rPr lang="en-IN" smtClean="0"/>
              <a:t>26/08/24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0DB8537-DBA1-E6E7-58EA-AFD3E014D3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BF86F2A-2CEC-F3B5-4F62-4EAB6AF807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78B94-C9E2-47A0-848D-6524A5962C8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78184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511753-5D0D-7686-FACF-8C16E0561E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B5D345-8C57-A37D-7ED7-FCD41B5324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C83BD85-5DFE-00E8-D84D-34BA608099C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1F469E-45C9-7FD7-75E0-142E9DCE42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8A426-FA93-401F-AECD-6108713CFA15}" type="datetimeFigureOut">
              <a:rPr lang="en-IN" smtClean="0"/>
              <a:t>26/08/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BACEFD-0249-8176-A8E4-4FB70B2DF5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0E822E-EB57-6160-7DB7-8AA7CF0170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78B94-C9E2-47A0-848D-6524A5962C8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437909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D07130-0CA0-44E4-2E02-7E18C1863F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6886F4D-2020-0A70-6583-0F96B8FB57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60D7989-E137-AED1-73DB-3D2C14E190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9DB5BA-8818-A0BD-1A2E-37DC3A83E6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8A426-FA93-401F-AECD-6108713CFA15}" type="datetimeFigureOut">
              <a:rPr lang="en-IN" smtClean="0"/>
              <a:t>26/08/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C2AFD9-1ABF-9E8D-E867-E900CD7F5F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E348E1-F0C8-2FFC-C88D-4A3D08C218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78B94-C9E2-47A0-848D-6524A5962C8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928205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B9C71EA-675E-C916-0CA9-BE3614D7F2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F38F24-A753-AB81-B568-821AD4EB77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E9B544-CC31-B025-0E9E-AF17C57B7F3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D28A426-FA93-401F-AECD-6108713CFA15}" type="datetimeFigureOut">
              <a:rPr lang="en-IN" smtClean="0"/>
              <a:t>26/08/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3FED91-B9C9-5061-5B7D-4F65A27F87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0FB594-0C8C-9BA7-8762-6CBFF2182E4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FA78B94-C9E2-47A0-848D-6524A5962C8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871705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microsoft.com/office/2014/relationships/chartEx" Target="../charts/chartEx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049351C-A239-9FD2-41A1-A9455B600DD7}"/>
              </a:ext>
            </a:extLst>
          </p:cNvPr>
          <p:cNvSpPr txBox="1"/>
          <p:nvPr/>
        </p:nvSpPr>
        <p:spPr>
          <a:xfrm>
            <a:off x="371061" y="5455593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</a:t>
            </a:r>
            <a:endParaRPr lang="en-IN" dirty="0"/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34" name="Chart 33">
                <a:extLst>
                  <a:ext uri="{FF2B5EF4-FFF2-40B4-BE49-F238E27FC236}">
                    <a16:creationId xmlns:a16="http://schemas.microsoft.com/office/drawing/2014/main" id="{3116415C-C5B9-8040-950B-685D3D22384A}"/>
                  </a:ext>
                </a:extLst>
              </p:cNvPr>
              <p:cNvGraphicFramePr/>
              <p:nvPr/>
            </p:nvGraphicFramePr>
            <p:xfrm>
              <a:off x="278297" y="529396"/>
              <a:ext cx="11781183" cy="423545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"/>
              </a:graphicData>
            </a:graphic>
          </p:graphicFrame>
        </mc:Choice>
        <mc:Fallback xmlns="">
          <p:pic>
            <p:nvPicPr>
              <p:cNvPr id="34" name="Chart 33">
                <a:extLst>
                  <a:ext uri="{FF2B5EF4-FFF2-40B4-BE49-F238E27FC236}">
                    <a16:creationId xmlns:a16="http://schemas.microsoft.com/office/drawing/2014/main" id="{3116415C-C5B9-8040-950B-685D3D22384A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78297" y="529396"/>
                <a:ext cx="11781183" cy="4235450"/>
              </a:xfrm>
              <a:prstGeom prst="rect">
                <a:avLst/>
              </a:prstGeom>
            </p:spPr>
          </p:pic>
        </mc:Fallback>
      </mc:AlternateContent>
    </p:spTree>
    <p:extLst>
      <p:ext uri="{BB962C8B-B14F-4D97-AF65-F5344CB8AC3E}">
        <p14:creationId xmlns:p14="http://schemas.microsoft.com/office/powerpoint/2010/main" val="41010065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DF0C86E-2C15-9856-6D79-CE19D7AFFF0B}"/>
              </a:ext>
            </a:extLst>
          </p:cNvPr>
          <p:cNvGrpSpPr/>
          <p:nvPr/>
        </p:nvGrpSpPr>
        <p:grpSpPr>
          <a:xfrm>
            <a:off x="5644671" y="872488"/>
            <a:ext cx="5919555" cy="3735611"/>
            <a:chOff x="2134925" y="1018390"/>
            <a:chExt cx="6133959" cy="4366956"/>
          </a:xfrm>
        </p:grpSpPr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A130B1D6-BDB6-247B-F2C5-6AA08B417AF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7739340"/>
                </p:ext>
              </p:extLst>
            </p:nvPr>
          </p:nvGraphicFramePr>
          <p:xfrm>
            <a:off x="2134925" y="1018390"/>
            <a:ext cx="5707627" cy="436695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EB2023C1-A8BB-D050-640E-79E6F9F4186D}"/>
                </a:ext>
              </a:extLst>
            </p:cNvPr>
            <p:cNvSpPr txBox="1"/>
            <p:nvPr/>
          </p:nvSpPr>
          <p:spPr>
            <a:xfrm>
              <a:off x="7535991" y="2637020"/>
              <a:ext cx="7328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+1SD</a:t>
              </a:r>
              <a:endParaRPr lang="en-IN" b="1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90B6BF8-4628-DC86-256C-1832199A723E}"/>
                </a:ext>
              </a:extLst>
            </p:cNvPr>
            <p:cNvSpPr txBox="1"/>
            <p:nvPr/>
          </p:nvSpPr>
          <p:spPr>
            <a:xfrm>
              <a:off x="7518592" y="2271268"/>
              <a:ext cx="7328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+2SD</a:t>
              </a:r>
              <a:endParaRPr lang="en-IN" b="1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75A697A-F722-2987-BB6E-21674847CDAC}"/>
                </a:ext>
              </a:extLst>
            </p:cNvPr>
            <p:cNvSpPr txBox="1"/>
            <p:nvPr/>
          </p:nvSpPr>
          <p:spPr>
            <a:xfrm>
              <a:off x="7523514" y="1881559"/>
              <a:ext cx="7328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+3SD</a:t>
              </a:r>
              <a:endParaRPr lang="en-IN" b="1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D2012E9-E853-BFA9-3FE9-1B3F2F34388C}"/>
                </a:ext>
              </a:extLst>
            </p:cNvPr>
            <p:cNvSpPr txBox="1"/>
            <p:nvPr/>
          </p:nvSpPr>
          <p:spPr>
            <a:xfrm>
              <a:off x="7528421" y="1514187"/>
              <a:ext cx="7328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+4SD</a:t>
              </a:r>
              <a:endParaRPr lang="en-IN" b="1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F4F2575-6D4D-3CC9-6BF0-97FA7B278E49}"/>
                </a:ext>
              </a:extLst>
            </p:cNvPr>
            <p:cNvSpPr txBox="1"/>
            <p:nvPr/>
          </p:nvSpPr>
          <p:spPr>
            <a:xfrm>
              <a:off x="7548082" y="3355067"/>
              <a:ext cx="6728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-1SD</a:t>
              </a:r>
              <a:endParaRPr lang="en-IN" b="1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60DDB61-1AEC-3E94-ED0E-E6B783C600E9}"/>
                </a:ext>
              </a:extLst>
            </p:cNvPr>
            <p:cNvSpPr txBox="1"/>
            <p:nvPr/>
          </p:nvSpPr>
          <p:spPr>
            <a:xfrm>
              <a:off x="7538254" y="3693821"/>
              <a:ext cx="6880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-2SD</a:t>
              </a:r>
              <a:endParaRPr lang="en-IN" b="1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B6D02AD-432D-642B-0486-D6066C054B36}"/>
                </a:ext>
              </a:extLst>
            </p:cNvPr>
            <p:cNvSpPr txBox="1"/>
            <p:nvPr/>
          </p:nvSpPr>
          <p:spPr>
            <a:xfrm>
              <a:off x="7553001" y="4077275"/>
              <a:ext cx="6880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-3SD</a:t>
              </a:r>
              <a:endParaRPr lang="en-IN" b="1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17E62B4-D04D-D2F9-67D9-76BEEC76A2DC}"/>
                </a:ext>
              </a:extLst>
            </p:cNvPr>
            <p:cNvSpPr txBox="1"/>
            <p:nvPr/>
          </p:nvSpPr>
          <p:spPr>
            <a:xfrm>
              <a:off x="7557916" y="4465649"/>
              <a:ext cx="6880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-4SD</a:t>
              </a:r>
              <a:endParaRPr lang="en-IN" b="1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69CEEAD-91AD-245D-43BE-68D4CFAD7CF4}"/>
                </a:ext>
              </a:extLst>
            </p:cNvPr>
            <p:cNvSpPr txBox="1"/>
            <p:nvPr/>
          </p:nvSpPr>
          <p:spPr>
            <a:xfrm>
              <a:off x="7617501" y="3003625"/>
              <a:ext cx="449445" cy="3560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Mean</a:t>
              </a:r>
              <a:endParaRPr lang="en-IN" b="1" dirty="0"/>
            </a:p>
          </p:txBody>
        </p:sp>
      </p:grpSp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422BD2D2-90A5-CAA1-E67C-1E36E43313A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27303540"/>
              </p:ext>
            </p:extLst>
          </p:nvPr>
        </p:nvGraphicFramePr>
        <p:xfrm>
          <a:off x="413813" y="879358"/>
          <a:ext cx="5324177" cy="36084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F075DB19-7941-920F-9DDB-B9D274C89F3A}"/>
              </a:ext>
            </a:extLst>
          </p:cNvPr>
          <p:cNvSpPr txBox="1"/>
          <p:nvPr/>
        </p:nvSpPr>
        <p:spPr>
          <a:xfrm>
            <a:off x="1391754" y="606281"/>
            <a:ext cx="33682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Levey-Jennings (LJ chart) of PC</a:t>
            </a:r>
            <a:endParaRPr lang="en-IN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E7BC46E-92C2-40AD-A71D-B6DB1A063B5E}"/>
              </a:ext>
            </a:extLst>
          </p:cNvPr>
          <p:cNvSpPr txBox="1"/>
          <p:nvPr/>
        </p:nvSpPr>
        <p:spPr>
          <a:xfrm>
            <a:off x="6700960" y="630345"/>
            <a:ext cx="33955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Levey-Jennings (LJ chart) of NC</a:t>
            </a:r>
            <a:endParaRPr lang="en-IN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275544F-837F-FB65-95CC-AF92519E8BD8}"/>
              </a:ext>
            </a:extLst>
          </p:cNvPr>
          <p:cNvSpPr txBox="1"/>
          <p:nvPr/>
        </p:nvSpPr>
        <p:spPr>
          <a:xfrm>
            <a:off x="4228611" y="4487779"/>
            <a:ext cx="3383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ontrol Measurement Number</a:t>
            </a:r>
            <a:endParaRPr lang="en-IN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F40D7FE-A258-50B6-A810-9B951DACA4BC}"/>
              </a:ext>
            </a:extLst>
          </p:cNvPr>
          <p:cNvSpPr txBox="1"/>
          <p:nvPr/>
        </p:nvSpPr>
        <p:spPr>
          <a:xfrm rot="16200000">
            <a:off x="-225282" y="2989003"/>
            <a:ext cx="9753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Y-score</a:t>
            </a:r>
            <a:endParaRPr lang="en-IN" b="1" dirty="0"/>
          </a:p>
        </p:txBody>
      </p:sp>
      <p:graphicFrame>
        <p:nvGraphicFramePr>
          <p:cNvPr id="18" name="Table 17">
            <a:extLst>
              <a:ext uri="{FF2B5EF4-FFF2-40B4-BE49-F238E27FC236}">
                <a16:creationId xmlns:a16="http://schemas.microsoft.com/office/drawing/2014/main" id="{C2BC5ED4-247E-EEA1-18AD-D3E1C34DF85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4243995"/>
              </p:ext>
            </p:extLst>
          </p:nvPr>
        </p:nvGraphicFramePr>
        <p:xfrm>
          <a:off x="8050532" y="4857111"/>
          <a:ext cx="2173184" cy="1206720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902525">
                  <a:extLst>
                    <a:ext uri="{9D8B030D-6E8A-4147-A177-3AD203B41FA5}">
                      <a16:colId xmlns:a16="http://schemas.microsoft.com/office/drawing/2014/main" val="1021301641"/>
                    </a:ext>
                  </a:extLst>
                </a:gridCol>
                <a:gridCol w="617517">
                  <a:extLst>
                    <a:ext uri="{9D8B030D-6E8A-4147-A177-3AD203B41FA5}">
                      <a16:colId xmlns:a16="http://schemas.microsoft.com/office/drawing/2014/main" val="350039293"/>
                    </a:ext>
                  </a:extLst>
                </a:gridCol>
                <a:gridCol w="653142">
                  <a:extLst>
                    <a:ext uri="{9D8B030D-6E8A-4147-A177-3AD203B41FA5}">
                      <a16:colId xmlns:a16="http://schemas.microsoft.com/office/drawing/2014/main" val="1269637127"/>
                    </a:ext>
                  </a:extLst>
                </a:gridCol>
              </a:tblGrid>
              <a:tr h="301680">
                <a:tc>
                  <a:txBody>
                    <a:bodyPr/>
                    <a:lstStyle/>
                    <a:p>
                      <a:pPr algn="l" fontAlgn="b"/>
                      <a:r>
                        <a:rPr lang="en-IN" sz="1800" b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  <a:endParaRPr lang="en-IN" sz="18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800" b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PC</a:t>
                      </a:r>
                      <a:endParaRPr lang="en-IN" sz="18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800" b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NC</a:t>
                      </a:r>
                      <a:endParaRPr lang="en-IN" sz="18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83231834"/>
                  </a:ext>
                </a:extLst>
              </a:tr>
              <a:tr h="30168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800" b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Mean</a:t>
                      </a:r>
                      <a:endParaRPr lang="en-IN" sz="18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800" b="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7.49</a:t>
                      </a:r>
                      <a:endParaRPr lang="en-IN" sz="18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800" b="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-7.5</a:t>
                      </a:r>
                      <a:endParaRPr lang="en-IN" sz="18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66651532"/>
                  </a:ext>
                </a:extLst>
              </a:tr>
              <a:tr h="30168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800" b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SD</a:t>
                      </a:r>
                      <a:endParaRPr lang="en-IN" sz="18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800" b="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0.3</a:t>
                      </a:r>
                      <a:endParaRPr lang="en-IN" sz="18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800" b="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0.28</a:t>
                      </a:r>
                      <a:endParaRPr lang="en-IN" sz="18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59302289"/>
                  </a:ext>
                </a:extLst>
              </a:tr>
              <a:tr h="30168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800" b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%CV</a:t>
                      </a:r>
                      <a:endParaRPr lang="en-IN" sz="18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800" b="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4</a:t>
                      </a:r>
                      <a:endParaRPr lang="en-IN" sz="18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800" b="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3.8</a:t>
                      </a:r>
                      <a:endParaRPr lang="en-IN" sz="18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74686393"/>
                  </a:ext>
                </a:extLst>
              </a:tr>
            </a:tbl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AD2A5B3C-CD46-A500-6A71-9CE780E59F65}"/>
              </a:ext>
            </a:extLst>
          </p:cNvPr>
          <p:cNvSpPr txBox="1"/>
          <p:nvPr/>
        </p:nvSpPr>
        <p:spPr>
          <a:xfrm>
            <a:off x="508574" y="5897866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2</a:t>
            </a:r>
            <a:endParaRPr lang="en-IN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45C5BDDF-5F77-CE9F-496E-387D5C2C39E8}"/>
              </a:ext>
            </a:extLst>
          </p:cNvPr>
          <p:cNvSpPr/>
          <p:nvPr/>
        </p:nvSpPr>
        <p:spPr>
          <a:xfrm>
            <a:off x="890336" y="1022684"/>
            <a:ext cx="4605703" cy="30800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BD986265-5ADE-36CF-6FFF-56F0A0875DF2}"/>
              </a:ext>
            </a:extLst>
          </p:cNvPr>
          <p:cNvSpPr/>
          <p:nvPr/>
        </p:nvSpPr>
        <p:spPr>
          <a:xfrm>
            <a:off x="6181276" y="1030669"/>
            <a:ext cx="4691715" cy="30800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39045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D8A111A-37D9-3336-DA92-E8135DA837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0216" y="1202577"/>
            <a:ext cx="5356065" cy="339799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43DC7A4-5B79-0BBB-D79B-699A546B0E5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2367"/>
          <a:stretch/>
        </p:blipFill>
        <p:spPr>
          <a:xfrm>
            <a:off x="7096946" y="1202577"/>
            <a:ext cx="4734771" cy="3397998"/>
          </a:xfrm>
          <a:prstGeom prst="rect">
            <a:avLst/>
          </a:prstGeom>
        </p:spPr>
      </p:pic>
      <p:sp>
        <p:nvSpPr>
          <p:cNvPr id="4" name="Right Arrow 3">
            <a:extLst>
              <a:ext uri="{FF2B5EF4-FFF2-40B4-BE49-F238E27FC236}">
                <a16:creationId xmlns:a16="http://schemas.microsoft.com/office/drawing/2014/main" id="{949AD2CB-9D9A-3026-8011-3D60ED05ECE1}"/>
              </a:ext>
            </a:extLst>
          </p:cNvPr>
          <p:cNvSpPr/>
          <p:nvPr/>
        </p:nvSpPr>
        <p:spPr>
          <a:xfrm>
            <a:off x="5547592" y="2565814"/>
            <a:ext cx="1424708" cy="534568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C52A759-31CF-0C5B-1BDC-4F5FD9CEA188}"/>
              </a:ext>
            </a:extLst>
          </p:cNvPr>
          <p:cNvSpPr txBox="1"/>
          <p:nvPr/>
        </p:nvSpPr>
        <p:spPr>
          <a:xfrm>
            <a:off x="508574" y="5897866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3</a:t>
            </a:r>
            <a:endParaRPr lang="en-IN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1C9BEF5-65A8-9305-7DB4-89D5281D4D96}"/>
              </a:ext>
            </a:extLst>
          </p:cNvPr>
          <p:cNvSpPr txBox="1"/>
          <p:nvPr/>
        </p:nvSpPr>
        <p:spPr>
          <a:xfrm>
            <a:off x="938152" y="98565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6108827-7107-8CEB-BE70-29858F78BE0B}"/>
              </a:ext>
            </a:extLst>
          </p:cNvPr>
          <p:cNvSpPr txBox="1"/>
          <p:nvPr/>
        </p:nvSpPr>
        <p:spPr>
          <a:xfrm>
            <a:off x="7420100" y="107848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277698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63</Words>
  <Application>Microsoft Macintosh PowerPoint</Application>
  <PresentationFormat>Widescreen</PresentationFormat>
  <Paragraphs>3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aved Siddiqui</dc:creator>
  <cp:lastModifiedBy>kanury rao</cp:lastModifiedBy>
  <cp:revision>7</cp:revision>
  <dcterms:created xsi:type="dcterms:W3CDTF">2024-03-14T09:44:07Z</dcterms:created>
  <dcterms:modified xsi:type="dcterms:W3CDTF">2024-08-26T05:57:38Z</dcterms:modified>
</cp:coreProperties>
</file>